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60"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70" d="100"/>
          <a:sy n="70" d="100"/>
        </p:scale>
        <p:origin x="-1144" y="-5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F:\ACTA1%20ir%20dls%20zeta.xlsx" TargetMode="External"/></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1" Type="http://schemas.openxmlformats.org/officeDocument/2006/relationships/oleObject" Target="file:///F:\ACTA1%20ir%20dls%20zet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600"/>
            </a:pPr>
            <a:r>
              <a:rPr lang="en-US" sz="1600" dirty="0"/>
              <a:t>Dynamic Light Scattering</a:t>
            </a:r>
          </a:p>
        </c:rich>
      </c:tx>
      <c:layout/>
      <c:overlay val="0"/>
    </c:title>
    <c:autoTitleDeleted val="0"/>
    <c:plotArea>
      <c:layout/>
      <c:barChart>
        <c:barDir val="col"/>
        <c:grouping val="clustered"/>
        <c:varyColors val="0"/>
        <c:ser>
          <c:idx val="0"/>
          <c:order val="0"/>
          <c:tx>
            <c:strRef>
              <c:f>Zeta!$B$17</c:f>
              <c:strCache>
                <c:ptCount val="1"/>
                <c:pt idx="0">
                  <c:v>ATCA1</c:v>
                </c:pt>
              </c:strCache>
            </c:strRef>
          </c:tx>
          <c:spPr>
            <a:solidFill>
              <a:schemeClr val="tx1"/>
            </a:solidFill>
          </c:spPr>
          <c:invertIfNegative val="0"/>
          <c:cat>
            <c:strRef>
              <c:f>Zeta!$A$18:$A$20</c:f>
              <c:strCache>
                <c:ptCount val="3"/>
                <c:pt idx="0">
                  <c:v>No treatment</c:v>
                </c:pt>
                <c:pt idx="1">
                  <c:v>Vortexed</c:v>
                </c:pt>
                <c:pt idx="2">
                  <c:v>Vortexed and sonicated</c:v>
                </c:pt>
              </c:strCache>
            </c:strRef>
          </c:cat>
          <c:val>
            <c:numRef>
              <c:f>Zeta!$B$18:$B$20</c:f>
              <c:numCache>
                <c:formatCode>General</c:formatCode>
                <c:ptCount val="3"/>
                <c:pt idx="0">
                  <c:v>0.16719999999999999</c:v>
                </c:pt>
                <c:pt idx="1">
                  <c:v>0.1565</c:v>
                </c:pt>
                <c:pt idx="2">
                  <c:v>0.16830000000000001</c:v>
                </c:pt>
              </c:numCache>
            </c:numRef>
          </c:val>
        </c:ser>
        <c:ser>
          <c:idx val="1"/>
          <c:order val="1"/>
          <c:tx>
            <c:strRef>
              <c:f>Zeta!$C$17</c:f>
              <c:strCache>
                <c:ptCount val="1"/>
                <c:pt idx="0">
                  <c:v>control</c:v>
                </c:pt>
              </c:strCache>
            </c:strRef>
          </c:tx>
          <c:spPr>
            <a:solidFill>
              <a:schemeClr val="tx1">
                <a:lumMod val="50000"/>
                <a:lumOff val="50000"/>
              </a:schemeClr>
            </a:solidFill>
          </c:spPr>
          <c:invertIfNegative val="0"/>
          <c:cat>
            <c:strRef>
              <c:f>Zeta!$A$18:$A$20</c:f>
              <c:strCache>
                <c:ptCount val="3"/>
                <c:pt idx="0">
                  <c:v>No treatment</c:v>
                </c:pt>
                <c:pt idx="1">
                  <c:v>Vortexed</c:v>
                </c:pt>
                <c:pt idx="2">
                  <c:v>Vortexed and sonicated</c:v>
                </c:pt>
              </c:strCache>
            </c:strRef>
          </c:cat>
          <c:val>
            <c:numRef>
              <c:f>Zeta!$C$18:$C$20</c:f>
              <c:numCache>
                <c:formatCode>General</c:formatCode>
                <c:ptCount val="3"/>
                <c:pt idx="0">
                  <c:v>0.12509999999999999</c:v>
                </c:pt>
                <c:pt idx="1">
                  <c:v>0.1172</c:v>
                </c:pt>
                <c:pt idx="2">
                  <c:v>0.1178</c:v>
                </c:pt>
              </c:numCache>
            </c:numRef>
          </c:val>
        </c:ser>
        <c:dLbls>
          <c:showLegendKey val="0"/>
          <c:showVal val="0"/>
          <c:showCatName val="0"/>
          <c:showSerName val="0"/>
          <c:showPercent val="0"/>
          <c:showBubbleSize val="0"/>
        </c:dLbls>
        <c:gapWidth val="150"/>
        <c:axId val="74256384"/>
        <c:axId val="74257920"/>
      </c:barChart>
      <c:catAx>
        <c:axId val="74256384"/>
        <c:scaling>
          <c:orientation val="minMax"/>
        </c:scaling>
        <c:delete val="0"/>
        <c:axPos val="b"/>
        <c:majorTickMark val="out"/>
        <c:minorTickMark val="none"/>
        <c:tickLblPos val="nextTo"/>
        <c:crossAx val="74257920"/>
        <c:crosses val="autoZero"/>
        <c:auto val="1"/>
        <c:lblAlgn val="ctr"/>
        <c:lblOffset val="100"/>
        <c:noMultiLvlLbl val="0"/>
      </c:catAx>
      <c:valAx>
        <c:axId val="74257920"/>
        <c:scaling>
          <c:orientation val="minMax"/>
          <c:min val="0"/>
        </c:scaling>
        <c:delete val="0"/>
        <c:axPos val="l"/>
        <c:majorGridlines/>
        <c:title>
          <c:tx>
            <c:rich>
              <a:bodyPr rot="-5400000" vert="horz"/>
              <a:lstStyle/>
              <a:p>
                <a:pPr>
                  <a:defRPr/>
                </a:pPr>
                <a:r>
                  <a:rPr lang="en-US"/>
                  <a:t>Diameter (um)</a:t>
                </a:r>
              </a:p>
            </c:rich>
          </c:tx>
          <c:layout/>
          <c:overlay val="0"/>
        </c:title>
        <c:numFmt formatCode="General" sourceLinked="1"/>
        <c:majorTickMark val="out"/>
        <c:minorTickMark val="none"/>
        <c:tickLblPos val="nextTo"/>
        <c:crossAx val="74256384"/>
        <c:crosses val="autoZero"/>
        <c:crossBetween val="between"/>
      </c:valAx>
    </c:plotArea>
    <c:legend>
      <c:legendPos val="r"/>
      <c:layout/>
      <c:overlay val="0"/>
    </c:legend>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sz="1600"/>
            </a:pPr>
            <a:r>
              <a:rPr lang="en-US" sz="1600" dirty="0"/>
              <a:t>Zeta-potential measurements</a:t>
            </a:r>
          </a:p>
        </c:rich>
      </c:tx>
      <c:layout/>
      <c:overlay val="0"/>
    </c:title>
    <c:autoTitleDeleted val="0"/>
    <c:plotArea>
      <c:layout>
        <c:manualLayout>
          <c:layoutTarget val="inner"/>
          <c:xMode val="edge"/>
          <c:yMode val="edge"/>
          <c:x val="0.15546602508019799"/>
          <c:y val="0.20351399825021901"/>
          <c:w val="0.61027588218139395"/>
          <c:h val="0.58978915135608101"/>
        </c:manualLayout>
      </c:layout>
      <c:barChart>
        <c:barDir val="col"/>
        <c:grouping val="clustered"/>
        <c:varyColors val="0"/>
        <c:ser>
          <c:idx val="0"/>
          <c:order val="0"/>
          <c:tx>
            <c:strRef>
              <c:f>Zeta!$K$2</c:f>
              <c:strCache>
                <c:ptCount val="1"/>
                <c:pt idx="0">
                  <c:v>ATCA1</c:v>
                </c:pt>
              </c:strCache>
            </c:strRef>
          </c:tx>
          <c:spPr>
            <a:solidFill>
              <a:schemeClr val="tx1"/>
            </a:solidFill>
          </c:spPr>
          <c:invertIfNegative val="0"/>
          <c:cat>
            <c:strRef>
              <c:f>Zeta!$J$3:$J$5</c:f>
              <c:strCache>
                <c:ptCount val="3"/>
                <c:pt idx="0">
                  <c:v>No treatment</c:v>
                </c:pt>
                <c:pt idx="1">
                  <c:v>Vortexed</c:v>
                </c:pt>
                <c:pt idx="2">
                  <c:v>Vortexed and sonicated</c:v>
                </c:pt>
              </c:strCache>
            </c:strRef>
          </c:cat>
          <c:val>
            <c:numRef>
              <c:f>Zeta!$K$3:$K$5</c:f>
              <c:numCache>
                <c:formatCode>General</c:formatCode>
                <c:ptCount val="3"/>
                <c:pt idx="0">
                  <c:v>-34.19</c:v>
                </c:pt>
                <c:pt idx="1">
                  <c:v>-39.020000000000003</c:v>
                </c:pt>
                <c:pt idx="2">
                  <c:v>-33.92</c:v>
                </c:pt>
              </c:numCache>
            </c:numRef>
          </c:val>
        </c:ser>
        <c:ser>
          <c:idx val="1"/>
          <c:order val="1"/>
          <c:tx>
            <c:v>Control</c:v>
          </c:tx>
          <c:spPr>
            <a:solidFill>
              <a:schemeClr val="tx1">
                <a:lumMod val="50000"/>
                <a:lumOff val="50000"/>
              </a:schemeClr>
            </a:solidFill>
          </c:spPr>
          <c:invertIfNegative val="0"/>
          <c:val>
            <c:numRef>
              <c:f>Zeta!$L$3:$L$5</c:f>
              <c:numCache>
                <c:formatCode>General</c:formatCode>
                <c:ptCount val="3"/>
                <c:pt idx="0">
                  <c:v>-27.3</c:v>
                </c:pt>
                <c:pt idx="1">
                  <c:v>-25.5</c:v>
                </c:pt>
                <c:pt idx="2">
                  <c:v>-22.5</c:v>
                </c:pt>
              </c:numCache>
            </c:numRef>
          </c:val>
        </c:ser>
        <c:dLbls>
          <c:showLegendKey val="0"/>
          <c:showVal val="0"/>
          <c:showCatName val="0"/>
          <c:showSerName val="0"/>
          <c:showPercent val="0"/>
          <c:showBubbleSize val="0"/>
        </c:dLbls>
        <c:gapWidth val="150"/>
        <c:axId val="74291840"/>
        <c:axId val="74297728"/>
      </c:barChart>
      <c:catAx>
        <c:axId val="74291840"/>
        <c:scaling>
          <c:orientation val="minMax"/>
        </c:scaling>
        <c:delete val="0"/>
        <c:axPos val="b"/>
        <c:majorTickMark val="none"/>
        <c:minorTickMark val="none"/>
        <c:tickLblPos val="low"/>
        <c:crossAx val="74297728"/>
        <c:crosses val="autoZero"/>
        <c:auto val="1"/>
        <c:lblAlgn val="ctr"/>
        <c:lblOffset val="0"/>
        <c:noMultiLvlLbl val="0"/>
      </c:catAx>
      <c:valAx>
        <c:axId val="74297728"/>
        <c:scaling>
          <c:orientation val="minMax"/>
          <c:max val="0"/>
        </c:scaling>
        <c:delete val="0"/>
        <c:axPos val="l"/>
        <c:majorGridlines/>
        <c:title>
          <c:tx>
            <c:rich>
              <a:bodyPr rot="-5400000" vert="horz"/>
              <a:lstStyle/>
              <a:p>
                <a:pPr>
                  <a:defRPr/>
                </a:pPr>
                <a:r>
                  <a:rPr lang="en-US" dirty="0" smtClean="0"/>
                  <a:t>Charge</a:t>
                </a:r>
                <a:r>
                  <a:rPr lang="en-US" baseline="0" dirty="0" smtClean="0"/>
                  <a:t> (mV)</a:t>
                </a:r>
                <a:endParaRPr lang="en-US" dirty="0"/>
              </a:p>
            </c:rich>
          </c:tx>
          <c:layout/>
          <c:overlay val="0"/>
        </c:title>
        <c:numFmt formatCode="General" sourceLinked="1"/>
        <c:majorTickMark val="none"/>
        <c:minorTickMark val="none"/>
        <c:tickLblPos val="nextTo"/>
        <c:crossAx val="74291840"/>
        <c:crosses val="autoZero"/>
        <c:crossBetween val="between"/>
      </c:valAx>
    </c:plotArea>
    <c:legend>
      <c:legendPos val="r"/>
      <c:layout/>
      <c:overlay val="0"/>
    </c:legend>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smoothMarker"/>
        <c:varyColors val="0"/>
        <c:ser>
          <c:idx val="0"/>
          <c:order val="0"/>
          <c:tx>
            <c:v>Liposome</c:v>
          </c:tx>
          <c:spPr>
            <a:ln>
              <a:solidFill>
                <a:srgbClr val="FF0000"/>
              </a:solidFill>
            </a:ln>
          </c:spPr>
          <c:marker>
            <c:symbol val="none"/>
          </c:marker>
          <c:xVal>
            <c:numRef>
              <c:f>IR!$A$1:$A$1744</c:f>
              <c:numCache>
                <c:formatCode>General</c:formatCode>
                <c:ptCount val="1744"/>
                <c:pt idx="0">
                  <c:v>649.90114399999948</c:v>
                </c:pt>
                <c:pt idx="1">
                  <c:v>651.82963400000006</c:v>
                </c:pt>
                <c:pt idx="2">
                  <c:v>653.75812399999938</c:v>
                </c:pt>
                <c:pt idx="3">
                  <c:v>655.68661499999996</c:v>
                </c:pt>
                <c:pt idx="4">
                  <c:v>657.61510499999997</c:v>
                </c:pt>
                <c:pt idx="5">
                  <c:v>659.54359499999998</c:v>
                </c:pt>
                <c:pt idx="6">
                  <c:v>661.47208499999999</c:v>
                </c:pt>
                <c:pt idx="7">
                  <c:v>663.400575</c:v>
                </c:pt>
                <c:pt idx="8">
                  <c:v>665.32906499999945</c:v>
                </c:pt>
                <c:pt idx="9">
                  <c:v>667.25755499999946</c:v>
                </c:pt>
                <c:pt idx="10">
                  <c:v>669.18604500000004</c:v>
                </c:pt>
                <c:pt idx="11">
                  <c:v>671.11453500000005</c:v>
                </c:pt>
                <c:pt idx="12">
                  <c:v>673.04302499999937</c:v>
                </c:pt>
                <c:pt idx="13">
                  <c:v>674.97151499999939</c:v>
                </c:pt>
                <c:pt idx="14">
                  <c:v>676.90000499999996</c:v>
                </c:pt>
                <c:pt idx="15">
                  <c:v>678.82849499999998</c:v>
                </c:pt>
                <c:pt idx="16">
                  <c:v>680.75698499999999</c:v>
                </c:pt>
                <c:pt idx="17">
                  <c:v>682.685475</c:v>
                </c:pt>
                <c:pt idx="18">
                  <c:v>684.61396500000001</c:v>
                </c:pt>
                <c:pt idx="19">
                  <c:v>686.54245499999945</c:v>
                </c:pt>
                <c:pt idx="20">
                  <c:v>688.47094500000003</c:v>
                </c:pt>
                <c:pt idx="21">
                  <c:v>690.39943500000004</c:v>
                </c:pt>
                <c:pt idx="22">
                  <c:v>692.32792499999914</c:v>
                </c:pt>
                <c:pt idx="23">
                  <c:v>694.25641499999938</c:v>
                </c:pt>
                <c:pt idx="24">
                  <c:v>696.18490499999996</c:v>
                </c:pt>
                <c:pt idx="25">
                  <c:v>698.11339499999997</c:v>
                </c:pt>
                <c:pt idx="26">
                  <c:v>700.04188499999998</c:v>
                </c:pt>
                <c:pt idx="27">
                  <c:v>701.97037599999999</c:v>
                </c:pt>
                <c:pt idx="28">
                  <c:v>703.898866</c:v>
                </c:pt>
                <c:pt idx="29">
                  <c:v>705.82735599999944</c:v>
                </c:pt>
                <c:pt idx="30">
                  <c:v>707.75584600000002</c:v>
                </c:pt>
                <c:pt idx="31">
                  <c:v>709.68433600000003</c:v>
                </c:pt>
                <c:pt idx="32">
                  <c:v>711.61282599999947</c:v>
                </c:pt>
                <c:pt idx="33">
                  <c:v>713.54131599999948</c:v>
                </c:pt>
                <c:pt idx="34">
                  <c:v>715.46980599999938</c:v>
                </c:pt>
                <c:pt idx="35">
                  <c:v>717.39829599999996</c:v>
                </c:pt>
                <c:pt idx="36">
                  <c:v>719.32678599999997</c:v>
                </c:pt>
                <c:pt idx="37">
                  <c:v>721.25527599999998</c:v>
                </c:pt>
                <c:pt idx="38">
                  <c:v>723.18376599999999</c:v>
                </c:pt>
                <c:pt idx="39">
                  <c:v>725.11225599999932</c:v>
                </c:pt>
                <c:pt idx="40">
                  <c:v>727.04074600000001</c:v>
                </c:pt>
                <c:pt idx="41">
                  <c:v>728.96923599999946</c:v>
                </c:pt>
                <c:pt idx="42">
                  <c:v>730.89772599999947</c:v>
                </c:pt>
                <c:pt idx="43">
                  <c:v>732.82621599999902</c:v>
                </c:pt>
                <c:pt idx="44">
                  <c:v>734.75470600000006</c:v>
                </c:pt>
                <c:pt idx="45">
                  <c:v>736.68319599999995</c:v>
                </c:pt>
                <c:pt idx="46">
                  <c:v>738.61168599999996</c:v>
                </c:pt>
                <c:pt idx="47">
                  <c:v>740.54017599999997</c:v>
                </c:pt>
                <c:pt idx="48">
                  <c:v>742.4686659999993</c:v>
                </c:pt>
                <c:pt idx="49">
                  <c:v>744.39715599999931</c:v>
                </c:pt>
                <c:pt idx="50">
                  <c:v>746.32564699999932</c:v>
                </c:pt>
                <c:pt idx="51">
                  <c:v>748.25413700000001</c:v>
                </c:pt>
                <c:pt idx="52">
                  <c:v>750.18262699999946</c:v>
                </c:pt>
                <c:pt idx="53">
                  <c:v>752.11111699999947</c:v>
                </c:pt>
                <c:pt idx="54">
                  <c:v>754.03960699999948</c:v>
                </c:pt>
                <c:pt idx="55">
                  <c:v>755.96809699999937</c:v>
                </c:pt>
                <c:pt idx="56">
                  <c:v>757.89658699999939</c:v>
                </c:pt>
                <c:pt idx="57">
                  <c:v>759.82507699999996</c:v>
                </c:pt>
                <c:pt idx="58">
                  <c:v>761.75356699999998</c:v>
                </c:pt>
                <c:pt idx="59">
                  <c:v>763.68205699999999</c:v>
                </c:pt>
                <c:pt idx="60">
                  <c:v>765.610547</c:v>
                </c:pt>
                <c:pt idx="61">
                  <c:v>767.53903700000001</c:v>
                </c:pt>
                <c:pt idx="62">
                  <c:v>769.46752699999888</c:v>
                </c:pt>
                <c:pt idx="63">
                  <c:v>771.39601699999946</c:v>
                </c:pt>
                <c:pt idx="64">
                  <c:v>773.32450699999947</c:v>
                </c:pt>
                <c:pt idx="65">
                  <c:v>775.25299699999948</c:v>
                </c:pt>
                <c:pt idx="66">
                  <c:v>777.18148699999995</c:v>
                </c:pt>
                <c:pt idx="67">
                  <c:v>779.10997699999996</c:v>
                </c:pt>
                <c:pt idx="68">
                  <c:v>781.03846699999997</c:v>
                </c:pt>
                <c:pt idx="69">
                  <c:v>782.9669569999993</c:v>
                </c:pt>
                <c:pt idx="70">
                  <c:v>784.89544699999999</c:v>
                </c:pt>
                <c:pt idx="71">
                  <c:v>786.823937</c:v>
                </c:pt>
                <c:pt idx="72">
                  <c:v>788.75242699999944</c:v>
                </c:pt>
                <c:pt idx="73">
                  <c:v>790.68091800000002</c:v>
                </c:pt>
                <c:pt idx="74">
                  <c:v>792.60940800000003</c:v>
                </c:pt>
                <c:pt idx="75">
                  <c:v>794.53789799999947</c:v>
                </c:pt>
                <c:pt idx="76">
                  <c:v>796.46638799999948</c:v>
                </c:pt>
                <c:pt idx="77">
                  <c:v>798.39487799999995</c:v>
                </c:pt>
                <c:pt idx="78">
                  <c:v>800.32336799999996</c:v>
                </c:pt>
                <c:pt idx="79">
                  <c:v>802.25185799999997</c:v>
                </c:pt>
                <c:pt idx="80">
                  <c:v>804.18034799999998</c:v>
                </c:pt>
                <c:pt idx="81">
                  <c:v>806.10883799999999</c:v>
                </c:pt>
                <c:pt idx="82">
                  <c:v>808.03732799999932</c:v>
                </c:pt>
                <c:pt idx="83">
                  <c:v>809.96581799999944</c:v>
                </c:pt>
                <c:pt idx="84">
                  <c:v>811.89430800000002</c:v>
                </c:pt>
                <c:pt idx="85">
                  <c:v>813.82279799999947</c:v>
                </c:pt>
                <c:pt idx="86">
                  <c:v>815.75128799999948</c:v>
                </c:pt>
                <c:pt idx="87">
                  <c:v>817.67977800000074</c:v>
                </c:pt>
                <c:pt idx="88">
                  <c:v>819.60826799999938</c:v>
                </c:pt>
                <c:pt idx="89">
                  <c:v>821.53675799999996</c:v>
                </c:pt>
                <c:pt idx="90">
                  <c:v>823.46524799999918</c:v>
                </c:pt>
                <c:pt idx="91">
                  <c:v>825.39373799999998</c:v>
                </c:pt>
                <c:pt idx="92">
                  <c:v>827.32222799999874</c:v>
                </c:pt>
                <c:pt idx="93">
                  <c:v>829.25071800000001</c:v>
                </c:pt>
                <c:pt idx="94">
                  <c:v>831.17920800000002</c:v>
                </c:pt>
                <c:pt idx="95">
                  <c:v>833.10769799999946</c:v>
                </c:pt>
                <c:pt idx="96">
                  <c:v>835.03618799999947</c:v>
                </c:pt>
                <c:pt idx="97">
                  <c:v>836.96467899999948</c:v>
                </c:pt>
                <c:pt idx="98">
                  <c:v>838.89316899999938</c:v>
                </c:pt>
                <c:pt idx="99">
                  <c:v>840.82165899999904</c:v>
                </c:pt>
                <c:pt idx="100">
                  <c:v>842.75014899999996</c:v>
                </c:pt>
                <c:pt idx="101">
                  <c:v>844.67863899999998</c:v>
                </c:pt>
                <c:pt idx="102">
                  <c:v>846.6071289999993</c:v>
                </c:pt>
                <c:pt idx="103">
                  <c:v>848.53561899999931</c:v>
                </c:pt>
                <c:pt idx="104">
                  <c:v>850.46410899999944</c:v>
                </c:pt>
                <c:pt idx="105">
                  <c:v>852.39259899999945</c:v>
                </c:pt>
                <c:pt idx="106">
                  <c:v>854.32108899999946</c:v>
                </c:pt>
                <c:pt idx="107">
                  <c:v>856.24957900000004</c:v>
                </c:pt>
                <c:pt idx="108">
                  <c:v>858.17806900000005</c:v>
                </c:pt>
                <c:pt idx="109">
                  <c:v>860.10655899999938</c:v>
                </c:pt>
                <c:pt idx="110">
                  <c:v>862.03504899999996</c:v>
                </c:pt>
                <c:pt idx="111">
                  <c:v>863.96353899999997</c:v>
                </c:pt>
                <c:pt idx="112">
                  <c:v>865.8920289999993</c:v>
                </c:pt>
                <c:pt idx="113">
                  <c:v>867.82051899999931</c:v>
                </c:pt>
                <c:pt idx="114">
                  <c:v>869.749009</c:v>
                </c:pt>
                <c:pt idx="115">
                  <c:v>871.67749900000001</c:v>
                </c:pt>
                <c:pt idx="116">
                  <c:v>873.60598900000002</c:v>
                </c:pt>
                <c:pt idx="117">
                  <c:v>875.53447900000003</c:v>
                </c:pt>
                <c:pt idx="118">
                  <c:v>877.46296899999902</c:v>
                </c:pt>
                <c:pt idx="119">
                  <c:v>879.39145899999949</c:v>
                </c:pt>
                <c:pt idx="120">
                  <c:v>881.31994999999938</c:v>
                </c:pt>
                <c:pt idx="121">
                  <c:v>883.24843999999996</c:v>
                </c:pt>
                <c:pt idx="122">
                  <c:v>885.17692999999997</c:v>
                </c:pt>
                <c:pt idx="123">
                  <c:v>887.10541999999998</c:v>
                </c:pt>
                <c:pt idx="124">
                  <c:v>889.03390999999999</c:v>
                </c:pt>
                <c:pt idx="125">
                  <c:v>890.96239999999932</c:v>
                </c:pt>
                <c:pt idx="126">
                  <c:v>892.89089000000001</c:v>
                </c:pt>
                <c:pt idx="127">
                  <c:v>894.81938000000002</c:v>
                </c:pt>
                <c:pt idx="128">
                  <c:v>896.74787000000003</c:v>
                </c:pt>
                <c:pt idx="129">
                  <c:v>898.67636000000005</c:v>
                </c:pt>
                <c:pt idx="130">
                  <c:v>900.60485000000006</c:v>
                </c:pt>
                <c:pt idx="131">
                  <c:v>902.53333999999995</c:v>
                </c:pt>
                <c:pt idx="132">
                  <c:v>904.46182999999917</c:v>
                </c:pt>
                <c:pt idx="133">
                  <c:v>906.39031999999997</c:v>
                </c:pt>
                <c:pt idx="134">
                  <c:v>908.31880999999998</c:v>
                </c:pt>
                <c:pt idx="135">
                  <c:v>910.2473</c:v>
                </c:pt>
                <c:pt idx="136">
                  <c:v>912.17579000000001</c:v>
                </c:pt>
                <c:pt idx="137">
                  <c:v>914.10428000000002</c:v>
                </c:pt>
                <c:pt idx="138">
                  <c:v>916.03277000000003</c:v>
                </c:pt>
                <c:pt idx="139">
                  <c:v>917.96125999999902</c:v>
                </c:pt>
                <c:pt idx="140">
                  <c:v>919.88975000000005</c:v>
                </c:pt>
                <c:pt idx="141">
                  <c:v>921.81823999999938</c:v>
                </c:pt>
                <c:pt idx="142">
                  <c:v>923.74672999999996</c:v>
                </c:pt>
                <c:pt idx="143">
                  <c:v>925.67521999999997</c:v>
                </c:pt>
                <c:pt idx="144">
                  <c:v>927.60371099999998</c:v>
                </c:pt>
                <c:pt idx="145">
                  <c:v>929.5322009999993</c:v>
                </c:pt>
                <c:pt idx="146">
                  <c:v>931.46069099999931</c:v>
                </c:pt>
                <c:pt idx="147">
                  <c:v>933.38918100000001</c:v>
                </c:pt>
                <c:pt idx="148">
                  <c:v>935.31767099999945</c:v>
                </c:pt>
                <c:pt idx="149">
                  <c:v>937.24616099999946</c:v>
                </c:pt>
                <c:pt idx="150">
                  <c:v>939.17465100000004</c:v>
                </c:pt>
                <c:pt idx="151">
                  <c:v>941.10314100000005</c:v>
                </c:pt>
                <c:pt idx="152">
                  <c:v>943.03163099999938</c:v>
                </c:pt>
                <c:pt idx="153">
                  <c:v>944.96012099999916</c:v>
                </c:pt>
                <c:pt idx="154">
                  <c:v>946.88861099999997</c:v>
                </c:pt>
                <c:pt idx="155">
                  <c:v>948.8171009999993</c:v>
                </c:pt>
                <c:pt idx="156">
                  <c:v>950.74559099999999</c:v>
                </c:pt>
                <c:pt idx="157">
                  <c:v>952.674081</c:v>
                </c:pt>
                <c:pt idx="158">
                  <c:v>954.60257100000001</c:v>
                </c:pt>
                <c:pt idx="159">
                  <c:v>956.53106099999945</c:v>
                </c:pt>
                <c:pt idx="160">
                  <c:v>958.45955099999946</c:v>
                </c:pt>
                <c:pt idx="161">
                  <c:v>960.38804100000004</c:v>
                </c:pt>
                <c:pt idx="162">
                  <c:v>962.31653099999949</c:v>
                </c:pt>
                <c:pt idx="163">
                  <c:v>964.24502099999938</c:v>
                </c:pt>
                <c:pt idx="164">
                  <c:v>966.17351099999996</c:v>
                </c:pt>
                <c:pt idx="165">
                  <c:v>968.10200099999997</c:v>
                </c:pt>
                <c:pt idx="166">
                  <c:v>970.03049099999998</c:v>
                </c:pt>
                <c:pt idx="167">
                  <c:v>971.95898199999999</c:v>
                </c:pt>
                <c:pt idx="168">
                  <c:v>973.887472</c:v>
                </c:pt>
                <c:pt idx="169">
                  <c:v>975.81596199999944</c:v>
                </c:pt>
                <c:pt idx="170">
                  <c:v>977.74445200000002</c:v>
                </c:pt>
                <c:pt idx="171">
                  <c:v>979.67294200000003</c:v>
                </c:pt>
                <c:pt idx="172">
                  <c:v>981.60143200000005</c:v>
                </c:pt>
                <c:pt idx="173">
                  <c:v>983.52992200000006</c:v>
                </c:pt>
                <c:pt idx="174">
                  <c:v>985.45841199999938</c:v>
                </c:pt>
                <c:pt idx="175">
                  <c:v>987.38690199999996</c:v>
                </c:pt>
                <c:pt idx="176">
                  <c:v>989.31539199999997</c:v>
                </c:pt>
                <c:pt idx="177">
                  <c:v>991.24388199999999</c:v>
                </c:pt>
                <c:pt idx="178">
                  <c:v>993.172372</c:v>
                </c:pt>
                <c:pt idx="179">
                  <c:v>995.10086200000001</c:v>
                </c:pt>
                <c:pt idx="180">
                  <c:v>997.02935200000002</c:v>
                </c:pt>
                <c:pt idx="181">
                  <c:v>998.95784199999946</c:v>
                </c:pt>
                <c:pt idx="182">
                  <c:v>1000.886332</c:v>
                </c:pt>
                <c:pt idx="183">
                  <c:v>1002.814822</c:v>
                </c:pt>
                <c:pt idx="184">
                  <c:v>1004.7433119999999</c:v>
                </c:pt>
                <c:pt idx="185">
                  <c:v>1006.671802</c:v>
                </c:pt>
                <c:pt idx="186">
                  <c:v>1008.600292</c:v>
                </c:pt>
                <c:pt idx="187">
                  <c:v>1010.528782</c:v>
                </c:pt>
                <c:pt idx="188">
                  <c:v>1012.457272</c:v>
                </c:pt>
                <c:pt idx="189">
                  <c:v>1014.385762</c:v>
                </c:pt>
                <c:pt idx="190">
                  <c:v>1016.314252</c:v>
                </c:pt>
                <c:pt idx="191">
                  <c:v>1018.242743</c:v>
                </c:pt>
                <c:pt idx="192">
                  <c:v>1020.171233</c:v>
                </c:pt>
                <c:pt idx="193">
                  <c:v>1022.099723</c:v>
                </c:pt>
                <c:pt idx="194">
                  <c:v>1024.0282130000001</c:v>
                </c:pt>
                <c:pt idx="195">
                  <c:v>1025.9567030000001</c:v>
                </c:pt>
                <c:pt idx="196">
                  <c:v>1027.8851930000001</c:v>
                </c:pt>
                <c:pt idx="197">
                  <c:v>1029.8136830000001</c:v>
                </c:pt>
                <c:pt idx="198">
                  <c:v>1031.7421730000001</c:v>
                </c:pt>
                <c:pt idx="199">
                  <c:v>1033.6706630000001</c:v>
                </c:pt>
                <c:pt idx="200">
                  <c:v>1035.5991529999999</c:v>
                </c:pt>
                <c:pt idx="201">
                  <c:v>1037.5276429999999</c:v>
                </c:pt>
                <c:pt idx="202">
                  <c:v>1039.4561329999999</c:v>
                </c:pt>
                <c:pt idx="203">
                  <c:v>1041.3846229999999</c:v>
                </c:pt>
                <c:pt idx="204">
                  <c:v>1043.3131129999999</c:v>
                </c:pt>
                <c:pt idx="205">
                  <c:v>1045.2416029999999</c:v>
                </c:pt>
                <c:pt idx="206">
                  <c:v>1047.170093</c:v>
                </c:pt>
                <c:pt idx="207">
                  <c:v>1049.098583</c:v>
                </c:pt>
                <c:pt idx="208">
                  <c:v>1051.027073</c:v>
                </c:pt>
                <c:pt idx="209">
                  <c:v>1052.955563</c:v>
                </c:pt>
                <c:pt idx="210">
                  <c:v>1054.884053</c:v>
                </c:pt>
                <c:pt idx="211">
                  <c:v>1056.812543</c:v>
                </c:pt>
                <c:pt idx="212">
                  <c:v>1058.741033</c:v>
                </c:pt>
                <c:pt idx="213">
                  <c:v>1060.669523</c:v>
                </c:pt>
                <c:pt idx="214">
                  <c:v>1062.5980139999999</c:v>
                </c:pt>
                <c:pt idx="215">
                  <c:v>1064.5265039999999</c:v>
                </c:pt>
                <c:pt idx="216">
                  <c:v>1066.4549939999999</c:v>
                </c:pt>
                <c:pt idx="217">
                  <c:v>1068.383484</c:v>
                </c:pt>
                <c:pt idx="218">
                  <c:v>1070.311974</c:v>
                </c:pt>
                <c:pt idx="219">
                  <c:v>1072.240464</c:v>
                </c:pt>
                <c:pt idx="220">
                  <c:v>1074.168954</c:v>
                </c:pt>
                <c:pt idx="221">
                  <c:v>1076.097444</c:v>
                </c:pt>
                <c:pt idx="222">
                  <c:v>1078.025934</c:v>
                </c:pt>
                <c:pt idx="223">
                  <c:v>1079.954424</c:v>
                </c:pt>
                <c:pt idx="224">
                  <c:v>1081.882914</c:v>
                </c:pt>
                <c:pt idx="225">
                  <c:v>1083.811404</c:v>
                </c:pt>
                <c:pt idx="226">
                  <c:v>1085.739894</c:v>
                </c:pt>
                <c:pt idx="227">
                  <c:v>1087.6683840000001</c:v>
                </c:pt>
                <c:pt idx="228">
                  <c:v>1089.5968740000001</c:v>
                </c:pt>
                <c:pt idx="229">
                  <c:v>1091.5253640000001</c:v>
                </c:pt>
                <c:pt idx="230">
                  <c:v>1093.4538540000001</c:v>
                </c:pt>
                <c:pt idx="231">
                  <c:v>1095.3823440000001</c:v>
                </c:pt>
                <c:pt idx="232">
                  <c:v>1097.3108340000001</c:v>
                </c:pt>
                <c:pt idx="233">
                  <c:v>1099.2393239999999</c:v>
                </c:pt>
                <c:pt idx="234">
                  <c:v>1101.1678139999999</c:v>
                </c:pt>
                <c:pt idx="235">
                  <c:v>1103.0963039999999</c:v>
                </c:pt>
                <c:pt idx="236">
                  <c:v>1105.0247939999999</c:v>
                </c:pt>
                <c:pt idx="237">
                  <c:v>1106.9532850000001</c:v>
                </c:pt>
                <c:pt idx="238">
                  <c:v>1108.8817750000001</c:v>
                </c:pt>
                <c:pt idx="239">
                  <c:v>1110.8102650000001</c:v>
                </c:pt>
                <c:pt idx="240">
                  <c:v>1112.7387550000001</c:v>
                </c:pt>
                <c:pt idx="241">
                  <c:v>1114.6672450000001</c:v>
                </c:pt>
                <c:pt idx="242">
                  <c:v>1116.5957350000001</c:v>
                </c:pt>
                <c:pt idx="243">
                  <c:v>1118.5242249999999</c:v>
                </c:pt>
                <c:pt idx="244">
                  <c:v>1120.4527149999999</c:v>
                </c:pt>
                <c:pt idx="245">
                  <c:v>1122.3812049999999</c:v>
                </c:pt>
                <c:pt idx="246">
                  <c:v>1124.3096949999999</c:v>
                </c:pt>
                <c:pt idx="247">
                  <c:v>1126.2381849999999</c:v>
                </c:pt>
                <c:pt idx="248">
                  <c:v>1128.1666749999999</c:v>
                </c:pt>
                <c:pt idx="249">
                  <c:v>1130.095165</c:v>
                </c:pt>
                <c:pt idx="250">
                  <c:v>1132.023655</c:v>
                </c:pt>
                <c:pt idx="251">
                  <c:v>1133.952145</c:v>
                </c:pt>
                <c:pt idx="252">
                  <c:v>1135.880635</c:v>
                </c:pt>
                <c:pt idx="253">
                  <c:v>1137.809125</c:v>
                </c:pt>
                <c:pt idx="254">
                  <c:v>1139.737615</c:v>
                </c:pt>
                <c:pt idx="255">
                  <c:v>1141.666105</c:v>
                </c:pt>
                <c:pt idx="256">
                  <c:v>1143.594595</c:v>
                </c:pt>
                <c:pt idx="257">
                  <c:v>1145.523085</c:v>
                </c:pt>
                <c:pt idx="258">
                  <c:v>1147.451575</c:v>
                </c:pt>
                <c:pt idx="259">
                  <c:v>1149.3800650000001</c:v>
                </c:pt>
                <c:pt idx="260">
                  <c:v>1151.3085550000001</c:v>
                </c:pt>
                <c:pt idx="261">
                  <c:v>1153.237046</c:v>
                </c:pt>
                <c:pt idx="262">
                  <c:v>1155.165536</c:v>
                </c:pt>
                <c:pt idx="263">
                  <c:v>1157.094026</c:v>
                </c:pt>
                <c:pt idx="264">
                  <c:v>1159.022516</c:v>
                </c:pt>
                <c:pt idx="265">
                  <c:v>1160.951006</c:v>
                </c:pt>
                <c:pt idx="266">
                  <c:v>1162.879496</c:v>
                </c:pt>
                <c:pt idx="267">
                  <c:v>1164.807986</c:v>
                </c:pt>
                <c:pt idx="268">
                  <c:v>1166.736476</c:v>
                </c:pt>
                <c:pt idx="269">
                  <c:v>1168.664966</c:v>
                </c:pt>
                <c:pt idx="270">
                  <c:v>1170.5934560000001</c:v>
                </c:pt>
                <c:pt idx="271">
                  <c:v>1172.5219460000001</c:v>
                </c:pt>
                <c:pt idx="272">
                  <c:v>1174.4504360000001</c:v>
                </c:pt>
                <c:pt idx="273">
                  <c:v>1176.3789260000001</c:v>
                </c:pt>
                <c:pt idx="274">
                  <c:v>1178.3074160000001</c:v>
                </c:pt>
                <c:pt idx="275">
                  <c:v>1180.2359060000001</c:v>
                </c:pt>
                <c:pt idx="276">
                  <c:v>1182.1643959999999</c:v>
                </c:pt>
                <c:pt idx="277">
                  <c:v>1184.0928859999999</c:v>
                </c:pt>
                <c:pt idx="278">
                  <c:v>1186.0213759999999</c:v>
                </c:pt>
                <c:pt idx="279">
                  <c:v>1187.9498659999999</c:v>
                </c:pt>
                <c:pt idx="280">
                  <c:v>1189.8783559999999</c:v>
                </c:pt>
                <c:pt idx="281">
                  <c:v>1191.806846</c:v>
                </c:pt>
                <c:pt idx="282">
                  <c:v>1193.735336</c:v>
                </c:pt>
                <c:pt idx="283">
                  <c:v>1195.663826</c:v>
                </c:pt>
                <c:pt idx="284">
                  <c:v>1197.5923170000001</c:v>
                </c:pt>
                <c:pt idx="285">
                  <c:v>1199.5208070000001</c:v>
                </c:pt>
                <c:pt idx="286">
                  <c:v>1201.4492969999999</c:v>
                </c:pt>
                <c:pt idx="287">
                  <c:v>1203.3777869999999</c:v>
                </c:pt>
                <c:pt idx="288">
                  <c:v>1205.3062769999999</c:v>
                </c:pt>
                <c:pt idx="289">
                  <c:v>1207.2347669999999</c:v>
                </c:pt>
                <c:pt idx="290">
                  <c:v>1209.1632569999999</c:v>
                </c:pt>
                <c:pt idx="291">
                  <c:v>1211.0917469999999</c:v>
                </c:pt>
                <c:pt idx="292">
                  <c:v>1213.020237</c:v>
                </c:pt>
                <c:pt idx="293">
                  <c:v>1214.948727</c:v>
                </c:pt>
                <c:pt idx="294">
                  <c:v>1216.877217</c:v>
                </c:pt>
                <c:pt idx="295">
                  <c:v>1218.805707</c:v>
                </c:pt>
                <c:pt idx="296">
                  <c:v>1220.734197</c:v>
                </c:pt>
                <c:pt idx="297">
                  <c:v>1222.662687</c:v>
                </c:pt>
                <c:pt idx="298">
                  <c:v>1224.591177</c:v>
                </c:pt>
                <c:pt idx="299">
                  <c:v>1226.519667</c:v>
                </c:pt>
                <c:pt idx="300">
                  <c:v>1228.448157</c:v>
                </c:pt>
                <c:pt idx="301">
                  <c:v>1230.376647</c:v>
                </c:pt>
                <c:pt idx="302">
                  <c:v>1232.3051370000001</c:v>
                </c:pt>
                <c:pt idx="303">
                  <c:v>1234.2336270000001</c:v>
                </c:pt>
                <c:pt idx="304">
                  <c:v>1236.1621170000001</c:v>
                </c:pt>
                <c:pt idx="305">
                  <c:v>1238.0906070000001</c:v>
                </c:pt>
                <c:pt idx="306">
                  <c:v>1240.0190970000001</c:v>
                </c:pt>
                <c:pt idx="307">
                  <c:v>1241.9475870000001</c:v>
                </c:pt>
                <c:pt idx="308">
                  <c:v>1243.876078</c:v>
                </c:pt>
                <c:pt idx="309">
                  <c:v>1245.804568</c:v>
                </c:pt>
                <c:pt idx="310">
                  <c:v>1247.733058</c:v>
                </c:pt>
                <c:pt idx="311">
                  <c:v>1249.661548</c:v>
                </c:pt>
                <c:pt idx="312">
                  <c:v>1251.590038</c:v>
                </c:pt>
                <c:pt idx="313">
                  <c:v>1253.5185280000001</c:v>
                </c:pt>
                <c:pt idx="314">
                  <c:v>1255.4470180000001</c:v>
                </c:pt>
                <c:pt idx="315">
                  <c:v>1257.3755080000001</c:v>
                </c:pt>
                <c:pt idx="316">
                  <c:v>1259.3039980000001</c:v>
                </c:pt>
                <c:pt idx="317">
                  <c:v>1261.2324880000001</c:v>
                </c:pt>
                <c:pt idx="318">
                  <c:v>1263.1609779999999</c:v>
                </c:pt>
                <c:pt idx="319">
                  <c:v>1265.0894679999999</c:v>
                </c:pt>
                <c:pt idx="320">
                  <c:v>1267.0179579999999</c:v>
                </c:pt>
                <c:pt idx="321">
                  <c:v>1268.9464479999999</c:v>
                </c:pt>
                <c:pt idx="322">
                  <c:v>1270.8749379999999</c:v>
                </c:pt>
                <c:pt idx="323">
                  <c:v>1272.8034279999999</c:v>
                </c:pt>
                <c:pt idx="324">
                  <c:v>1274.731918</c:v>
                </c:pt>
                <c:pt idx="325">
                  <c:v>1276.660408</c:v>
                </c:pt>
                <c:pt idx="326">
                  <c:v>1278.588898</c:v>
                </c:pt>
                <c:pt idx="327">
                  <c:v>1280.517388</c:v>
                </c:pt>
                <c:pt idx="328">
                  <c:v>1282.445878</c:v>
                </c:pt>
                <c:pt idx="329">
                  <c:v>1284.374368</c:v>
                </c:pt>
                <c:pt idx="330">
                  <c:v>1286.302858</c:v>
                </c:pt>
                <c:pt idx="331">
                  <c:v>1288.2313489999999</c:v>
                </c:pt>
                <c:pt idx="332">
                  <c:v>1290.1598389999999</c:v>
                </c:pt>
                <c:pt idx="333">
                  <c:v>1292.0883289999999</c:v>
                </c:pt>
                <c:pt idx="334">
                  <c:v>1294.0168189999999</c:v>
                </c:pt>
                <c:pt idx="335">
                  <c:v>1295.945309</c:v>
                </c:pt>
                <c:pt idx="336">
                  <c:v>1297.873799</c:v>
                </c:pt>
                <c:pt idx="337">
                  <c:v>1299.802289</c:v>
                </c:pt>
                <c:pt idx="338">
                  <c:v>1301.730779</c:v>
                </c:pt>
                <c:pt idx="339">
                  <c:v>1303.659269</c:v>
                </c:pt>
                <c:pt idx="340">
                  <c:v>1305.587759</c:v>
                </c:pt>
                <c:pt idx="341">
                  <c:v>1307.516249</c:v>
                </c:pt>
                <c:pt idx="342">
                  <c:v>1309.444739</c:v>
                </c:pt>
                <c:pt idx="343">
                  <c:v>1311.373229</c:v>
                </c:pt>
                <c:pt idx="344">
                  <c:v>1313.301719</c:v>
                </c:pt>
                <c:pt idx="345">
                  <c:v>1315.2302090000001</c:v>
                </c:pt>
                <c:pt idx="346">
                  <c:v>1317.1586990000001</c:v>
                </c:pt>
                <c:pt idx="347">
                  <c:v>1319.0871890000001</c:v>
                </c:pt>
                <c:pt idx="348">
                  <c:v>1321.0156790000001</c:v>
                </c:pt>
                <c:pt idx="349">
                  <c:v>1322.9441690000001</c:v>
                </c:pt>
                <c:pt idx="350">
                  <c:v>1324.8726590000001</c:v>
                </c:pt>
                <c:pt idx="351">
                  <c:v>1326.8011489999999</c:v>
                </c:pt>
                <c:pt idx="352">
                  <c:v>1328.7296389999999</c:v>
                </c:pt>
                <c:pt idx="353">
                  <c:v>1330.6581289999999</c:v>
                </c:pt>
                <c:pt idx="354">
                  <c:v>1332.5866189999999</c:v>
                </c:pt>
                <c:pt idx="355">
                  <c:v>1334.51511</c:v>
                </c:pt>
                <c:pt idx="356">
                  <c:v>1336.4436000000001</c:v>
                </c:pt>
                <c:pt idx="357">
                  <c:v>1338.3720900000001</c:v>
                </c:pt>
                <c:pt idx="358">
                  <c:v>1340.3005800000001</c:v>
                </c:pt>
                <c:pt idx="359">
                  <c:v>1342.2290700000001</c:v>
                </c:pt>
                <c:pt idx="360">
                  <c:v>1344.1575600000001</c:v>
                </c:pt>
                <c:pt idx="361">
                  <c:v>1346.0860499999999</c:v>
                </c:pt>
                <c:pt idx="362">
                  <c:v>1348.0145399999999</c:v>
                </c:pt>
                <c:pt idx="363">
                  <c:v>1349.9430299999999</c:v>
                </c:pt>
                <c:pt idx="364">
                  <c:v>1351.8715199999999</c:v>
                </c:pt>
                <c:pt idx="365">
                  <c:v>1353.8000099999999</c:v>
                </c:pt>
                <c:pt idx="366">
                  <c:v>1355.7284999999999</c:v>
                </c:pt>
                <c:pt idx="367">
                  <c:v>1357.65699</c:v>
                </c:pt>
                <c:pt idx="368">
                  <c:v>1359.58548</c:v>
                </c:pt>
                <c:pt idx="369">
                  <c:v>1361.51397</c:v>
                </c:pt>
                <c:pt idx="370">
                  <c:v>1363.44246</c:v>
                </c:pt>
                <c:pt idx="371">
                  <c:v>1365.37095</c:v>
                </c:pt>
                <c:pt idx="372">
                  <c:v>1367.29944</c:v>
                </c:pt>
                <c:pt idx="373">
                  <c:v>1369.22793</c:v>
                </c:pt>
                <c:pt idx="374">
                  <c:v>1371.15642</c:v>
                </c:pt>
                <c:pt idx="375">
                  <c:v>1373.08491</c:v>
                </c:pt>
                <c:pt idx="376">
                  <c:v>1375.0134</c:v>
                </c:pt>
                <c:pt idx="377">
                  <c:v>1376.9418900000001</c:v>
                </c:pt>
                <c:pt idx="378">
                  <c:v>1378.870381</c:v>
                </c:pt>
                <c:pt idx="379">
                  <c:v>1380.798871</c:v>
                </c:pt>
                <c:pt idx="380">
                  <c:v>1382.727361</c:v>
                </c:pt>
                <c:pt idx="381">
                  <c:v>1384.655851</c:v>
                </c:pt>
                <c:pt idx="382">
                  <c:v>1386.584341</c:v>
                </c:pt>
                <c:pt idx="383">
                  <c:v>1388.512831</c:v>
                </c:pt>
                <c:pt idx="384">
                  <c:v>1390.441321</c:v>
                </c:pt>
                <c:pt idx="385">
                  <c:v>1392.369811</c:v>
                </c:pt>
                <c:pt idx="386">
                  <c:v>1394.298301</c:v>
                </c:pt>
                <c:pt idx="387">
                  <c:v>1396.226791</c:v>
                </c:pt>
                <c:pt idx="388">
                  <c:v>1398.1552810000001</c:v>
                </c:pt>
                <c:pt idx="389">
                  <c:v>1400.0837710000001</c:v>
                </c:pt>
                <c:pt idx="390">
                  <c:v>1402.0122610000001</c:v>
                </c:pt>
                <c:pt idx="391">
                  <c:v>1403.9407510000001</c:v>
                </c:pt>
                <c:pt idx="392">
                  <c:v>1405.8692410000001</c:v>
                </c:pt>
                <c:pt idx="393">
                  <c:v>1407.7977310000001</c:v>
                </c:pt>
                <c:pt idx="394">
                  <c:v>1409.7262209999999</c:v>
                </c:pt>
                <c:pt idx="395">
                  <c:v>1411.6547109999999</c:v>
                </c:pt>
                <c:pt idx="396">
                  <c:v>1413.5832009999999</c:v>
                </c:pt>
                <c:pt idx="397">
                  <c:v>1415.5116909999999</c:v>
                </c:pt>
                <c:pt idx="398">
                  <c:v>1417.4401809999999</c:v>
                </c:pt>
                <c:pt idx="399">
                  <c:v>1419.3686709999999</c:v>
                </c:pt>
                <c:pt idx="400">
                  <c:v>1421.297161</c:v>
                </c:pt>
                <c:pt idx="401">
                  <c:v>1423.2256520000001</c:v>
                </c:pt>
                <c:pt idx="402">
                  <c:v>1425.1541420000001</c:v>
                </c:pt>
                <c:pt idx="403">
                  <c:v>1427.0826320000001</c:v>
                </c:pt>
                <c:pt idx="404">
                  <c:v>1429.0111219999999</c:v>
                </c:pt>
                <c:pt idx="405">
                  <c:v>1430.9396119999999</c:v>
                </c:pt>
                <c:pt idx="406">
                  <c:v>1432.8681019999999</c:v>
                </c:pt>
                <c:pt idx="407">
                  <c:v>1434.7965919999999</c:v>
                </c:pt>
                <c:pt idx="408">
                  <c:v>1436.7250819999999</c:v>
                </c:pt>
                <c:pt idx="409">
                  <c:v>1438.6535719999999</c:v>
                </c:pt>
                <c:pt idx="410">
                  <c:v>1440.582062</c:v>
                </c:pt>
                <c:pt idx="411">
                  <c:v>1442.510552</c:v>
                </c:pt>
                <c:pt idx="412">
                  <c:v>1444.439042</c:v>
                </c:pt>
                <c:pt idx="413">
                  <c:v>1446.367532</c:v>
                </c:pt>
                <c:pt idx="414">
                  <c:v>1448.296022</c:v>
                </c:pt>
                <c:pt idx="415">
                  <c:v>1450.224512</c:v>
                </c:pt>
                <c:pt idx="416">
                  <c:v>1452.153002</c:v>
                </c:pt>
                <c:pt idx="417">
                  <c:v>1454.081492</c:v>
                </c:pt>
                <c:pt idx="418">
                  <c:v>1456.009982</c:v>
                </c:pt>
                <c:pt idx="419">
                  <c:v>1457.938472</c:v>
                </c:pt>
                <c:pt idx="420">
                  <c:v>1459.8669620000001</c:v>
                </c:pt>
                <c:pt idx="421">
                  <c:v>1461.7954520000001</c:v>
                </c:pt>
                <c:pt idx="422">
                  <c:v>1463.7239420000001</c:v>
                </c:pt>
                <c:pt idx="423">
                  <c:v>1465.6524320000001</c:v>
                </c:pt>
                <c:pt idx="424">
                  <c:v>1467.5809220000001</c:v>
                </c:pt>
                <c:pt idx="425">
                  <c:v>1469.509413</c:v>
                </c:pt>
                <c:pt idx="426">
                  <c:v>1471.437903</c:v>
                </c:pt>
                <c:pt idx="427">
                  <c:v>1473.366393</c:v>
                </c:pt>
                <c:pt idx="428">
                  <c:v>1475.294883</c:v>
                </c:pt>
                <c:pt idx="429">
                  <c:v>1477.223373</c:v>
                </c:pt>
                <c:pt idx="430">
                  <c:v>1479.151863</c:v>
                </c:pt>
                <c:pt idx="431">
                  <c:v>1481.0803530000001</c:v>
                </c:pt>
                <c:pt idx="432">
                  <c:v>1483.0088430000001</c:v>
                </c:pt>
                <c:pt idx="433">
                  <c:v>1484.9373330000001</c:v>
                </c:pt>
                <c:pt idx="434">
                  <c:v>1486.8658230000001</c:v>
                </c:pt>
                <c:pt idx="435">
                  <c:v>1488.7943130000001</c:v>
                </c:pt>
                <c:pt idx="436">
                  <c:v>1490.7228030000001</c:v>
                </c:pt>
                <c:pt idx="437">
                  <c:v>1492.6512929999999</c:v>
                </c:pt>
                <c:pt idx="438">
                  <c:v>1494.5797829999999</c:v>
                </c:pt>
                <c:pt idx="439">
                  <c:v>1496.5082729999999</c:v>
                </c:pt>
                <c:pt idx="440">
                  <c:v>1498.4367629999999</c:v>
                </c:pt>
                <c:pt idx="441">
                  <c:v>1500.3652529999999</c:v>
                </c:pt>
                <c:pt idx="442">
                  <c:v>1502.2937429999999</c:v>
                </c:pt>
                <c:pt idx="443">
                  <c:v>1504.222233</c:v>
                </c:pt>
                <c:pt idx="444">
                  <c:v>1506.150723</c:v>
                </c:pt>
                <c:pt idx="445">
                  <c:v>1508.079213</c:v>
                </c:pt>
                <c:pt idx="446">
                  <c:v>1510.007703</c:v>
                </c:pt>
                <c:pt idx="447">
                  <c:v>1511.936193</c:v>
                </c:pt>
                <c:pt idx="448">
                  <c:v>1513.8646839999999</c:v>
                </c:pt>
                <c:pt idx="449">
                  <c:v>1515.7931739999999</c:v>
                </c:pt>
                <c:pt idx="450">
                  <c:v>1517.7216639999999</c:v>
                </c:pt>
                <c:pt idx="451">
                  <c:v>1519.6501539999999</c:v>
                </c:pt>
                <c:pt idx="452">
                  <c:v>1521.5786439999999</c:v>
                </c:pt>
                <c:pt idx="453">
                  <c:v>1523.507134</c:v>
                </c:pt>
                <c:pt idx="454">
                  <c:v>1525.435624</c:v>
                </c:pt>
                <c:pt idx="455">
                  <c:v>1527.364114</c:v>
                </c:pt>
                <c:pt idx="456">
                  <c:v>1529.292604</c:v>
                </c:pt>
                <c:pt idx="457">
                  <c:v>1531.221094</c:v>
                </c:pt>
                <c:pt idx="458">
                  <c:v>1533.149584</c:v>
                </c:pt>
                <c:pt idx="459">
                  <c:v>1535.078074</c:v>
                </c:pt>
                <c:pt idx="460">
                  <c:v>1537.006564</c:v>
                </c:pt>
                <c:pt idx="461">
                  <c:v>1538.935054</c:v>
                </c:pt>
                <c:pt idx="462">
                  <c:v>1540.863544</c:v>
                </c:pt>
                <c:pt idx="463">
                  <c:v>1542.7920340000001</c:v>
                </c:pt>
                <c:pt idx="464">
                  <c:v>1544.7205240000001</c:v>
                </c:pt>
                <c:pt idx="465">
                  <c:v>1546.6490140000001</c:v>
                </c:pt>
                <c:pt idx="466">
                  <c:v>1548.5775040000001</c:v>
                </c:pt>
                <c:pt idx="467">
                  <c:v>1550.5059940000001</c:v>
                </c:pt>
                <c:pt idx="468">
                  <c:v>1552.4344840000001</c:v>
                </c:pt>
                <c:pt idx="469">
                  <c:v>1554.3629739999999</c:v>
                </c:pt>
                <c:pt idx="470">
                  <c:v>1556.2914639999999</c:v>
                </c:pt>
                <c:pt idx="471">
                  <c:v>1558.2199539999999</c:v>
                </c:pt>
                <c:pt idx="472">
                  <c:v>1560.148445</c:v>
                </c:pt>
                <c:pt idx="473">
                  <c:v>1562.076935</c:v>
                </c:pt>
                <c:pt idx="474">
                  <c:v>1564.0054250000001</c:v>
                </c:pt>
                <c:pt idx="475">
                  <c:v>1565.9339150000001</c:v>
                </c:pt>
                <c:pt idx="476">
                  <c:v>1567.8624050000001</c:v>
                </c:pt>
                <c:pt idx="477">
                  <c:v>1569.7908950000001</c:v>
                </c:pt>
                <c:pt idx="478">
                  <c:v>1571.7193850000001</c:v>
                </c:pt>
                <c:pt idx="479">
                  <c:v>1573.6478750000001</c:v>
                </c:pt>
                <c:pt idx="480">
                  <c:v>1575.5763649999999</c:v>
                </c:pt>
                <c:pt idx="481">
                  <c:v>1577.5048549999999</c:v>
                </c:pt>
                <c:pt idx="482">
                  <c:v>1579.4333449999999</c:v>
                </c:pt>
                <c:pt idx="483">
                  <c:v>1581.3618349999999</c:v>
                </c:pt>
                <c:pt idx="484">
                  <c:v>1583.2903249999999</c:v>
                </c:pt>
                <c:pt idx="485">
                  <c:v>1585.2188149999999</c:v>
                </c:pt>
                <c:pt idx="486">
                  <c:v>1587.147305</c:v>
                </c:pt>
                <c:pt idx="487">
                  <c:v>1589.075795</c:v>
                </c:pt>
                <c:pt idx="488">
                  <c:v>1591.004285</c:v>
                </c:pt>
                <c:pt idx="489">
                  <c:v>1592.932775</c:v>
                </c:pt>
                <c:pt idx="490">
                  <c:v>1594.861265</c:v>
                </c:pt>
                <c:pt idx="491">
                  <c:v>1596.789755</c:v>
                </c:pt>
                <c:pt idx="492">
                  <c:v>1598.718245</c:v>
                </c:pt>
                <c:pt idx="493">
                  <c:v>1600.646735</c:v>
                </c:pt>
                <c:pt idx="494">
                  <c:v>1602.575225</c:v>
                </c:pt>
                <c:pt idx="495">
                  <c:v>1604.5037159999999</c:v>
                </c:pt>
                <c:pt idx="496">
                  <c:v>1606.432206</c:v>
                </c:pt>
                <c:pt idx="497">
                  <c:v>1608.360696</c:v>
                </c:pt>
                <c:pt idx="498">
                  <c:v>1610.289186</c:v>
                </c:pt>
                <c:pt idx="499">
                  <c:v>1612.217676</c:v>
                </c:pt>
                <c:pt idx="500">
                  <c:v>1614.146166</c:v>
                </c:pt>
                <c:pt idx="501">
                  <c:v>1616.074656</c:v>
                </c:pt>
                <c:pt idx="502">
                  <c:v>1618.003146</c:v>
                </c:pt>
                <c:pt idx="503">
                  <c:v>1619.931636</c:v>
                </c:pt>
                <c:pt idx="504">
                  <c:v>1621.860126</c:v>
                </c:pt>
                <c:pt idx="505">
                  <c:v>1623.788616</c:v>
                </c:pt>
                <c:pt idx="506">
                  <c:v>1625.7171060000001</c:v>
                </c:pt>
                <c:pt idx="507">
                  <c:v>1627.6455960000001</c:v>
                </c:pt>
                <c:pt idx="508">
                  <c:v>1629.5740860000001</c:v>
                </c:pt>
                <c:pt idx="509">
                  <c:v>1631.5025760000001</c:v>
                </c:pt>
                <c:pt idx="510">
                  <c:v>1633.4310660000001</c:v>
                </c:pt>
                <c:pt idx="511">
                  <c:v>1635.3595560000001</c:v>
                </c:pt>
                <c:pt idx="512">
                  <c:v>1637.2880459999999</c:v>
                </c:pt>
                <c:pt idx="513">
                  <c:v>1639.2165359999999</c:v>
                </c:pt>
                <c:pt idx="514">
                  <c:v>1641.1450259999999</c:v>
                </c:pt>
                <c:pt idx="515">
                  <c:v>1643.0735159999999</c:v>
                </c:pt>
                <c:pt idx="516">
                  <c:v>1645.0020059999999</c:v>
                </c:pt>
                <c:pt idx="517">
                  <c:v>1646.9304959999999</c:v>
                </c:pt>
                <c:pt idx="518">
                  <c:v>1648.858986</c:v>
                </c:pt>
                <c:pt idx="519">
                  <c:v>1650.7874770000001</c:v>
                </c:pt>
                <c:pt idx="520">
                  <c:v>1652.7159670000001</c:v>
                </c:pt>
                <c:pt idx="521">
                  <c:v>1654.6444570000001</c:v>
                </c:pt>
                <c:pt idx="522">
                  <c:v>1656.5729470000001</c:v>
                </c:pt>
                <c:pt idx="523">
                  <c:v>1658.5014369999999</c:v>
                </c:pt>
                <c:pt idx="524">
                  <c:v>1660.4299269999999</c:v>
                </c:pt>
                <c:pt idx="525">
                  <c:v>1662.3584169999999</c:v>
                </c:pt>
                <c:pt idx="526">
                  <c:v>1664.2869069999999</c:v>
                </c:pt>
                <c:pt idx="527">
                  <c:v>1666.2153969999999</c:v>
                </c:pt>
                <c:pt idx="528">
                  <c:v>1668.1438869999999</c:v>
                </c:pt>
                <c:pt idx="529">
                  <c:v>1670.072377</c:v>
                </c:pt>
                <c:pt idx="530">
                  <c:v>1672.000867</c:v>
                </c:pt>
                <c:pt idx="531">
                  <c:v>1673.929357</c:v>
                </c:pt>
                <c:pt idx="532">
                  <c:v>1675.857847</c:v>
                </c:pt>
                <c:pt idx="533">
                  <c:v>1677.786337</c:v>
                </c:pt>
                <c:pt idx="534">
                  <c:v>1679.714827</c:v>
                </c:pt>
                <c:pt idx="535">
                  <c:v>1681.643317</c:v>
                </c:pt>
                <c:pt idx="536">
                  <c:v>1683.571807</c:v>
                </c:pt>
                <c:pt idx="537">
                  <c:v>1685.500297</c:v>
                </c:pt>
                <c:pt idx="538">
                  <c:v>1687.4287870000001</c:v>
                </c:pt>
                <c:pt idx="539">
                  <c:v>1689.3572770000001</c:v>
                </c:pt>
                <c:pt idx="540">
                  <c:v>1691.2857670000001</c:v>
                </c:pt>
                <c:pt idx="541">
                  <c:v>1693.2142570000001</c:v>
                </c:pt>
                <c:pt idx="542">
                  <c:v>1695.142748</c:v>
                </c:pt>
                <c:pt idx="543">
                  <c:v>1697.071238</c:v>
                </c:pt>
                <c:pt idx="544">
                  <c:v>1698.999728</c:v>
                </c:pt>
                <c:pt idx="545">
                  <c:v>1700.928218</c:v>
                </c:pt>
                <c:pt idx="546">
                  <c:v>1702.856708</c:v>
                </c:pt>
                <c:pt idx="547">
                  <c:v>1704.785198</c:v>
                </c:pt>
                <c:pt idx="548">
                  <c:v>1706.713688</c:v>
                </c:pt>
                <c:pt idx="549">
                  <c:v>1708.6421780000001</c:v>
                </c:pt>
                <c:pt idx="550">
                  <c:v>1710.5706680000001</c:v>
                </c:pt>
                <c:pt idx="551">
                  <c:v>1712.4991580000001</c:v>
                </c:pt>
                <c:pt idx="552">
                  <c:v>1714.4276480000001</c:v>
                </c:pt>
                <c:pt idx="553">
                  <c:v>1716.3561380000001</c:v>
                </c:pt>
                <c:pt idx="554">
                  <c:v>1718.2846280000001</c:v>
                </c:pt>
                <c:pt idx="555">
                  <c:v>1720.2131179999999</c:v>
                </c:pt>
                <c:pt idx="556">
                  <c:v>1722.1416079999999</c:v>
                </c:pt>
                <c:pt idx="557">
                  <c:v>1724.0700979999999</c:v>
                </c:pt>
                <c:pt idx="558">
                  <c:v>1725.9985879999999</c:v>
                </c:pt>
                <c:pt idx="559">
                  <c:v>1727.9270779999999</c:v>
                </c:pt>
                <c:pt idx="560">
                  <c:v>1729.8555679999999</c:v>
                </c:pt>
                <c:pt idx="561">
                  <c:v>1731.784058</c:v>
                </c:pt>
                <c:pt idx="562">
                  <c:v>1733.712548</c:v>
                </c:pt>
                <c:pt idx="563">
                  <c:v>1735.641038</c:v>
                </c:pt>
                <c:pt idx="564">
                  <c:v>1737.569528</c:v>
                </c:pt>
                <c:pt idx="565">
                  <c:v>1739.4980190000001</c:v>
                </c:pt>
                <c:pt idx="566">
                  <c:v>1741.4265089999999</c:v>
                </c:pt>
                <c:pt idx="567">
                  <c:v>1743.3549989999999</c:v>
                </c:pt>
                <c:pt idx="568">
                  <c:v>1745.2834889999999</c:v>
                </c:pt>
                <c:pt idx="569">
                  <c:v>1747.2119789999999</c:v>
                </c:pt>
                <c:pt idx="570">
                  <c:v>1749.1404689999999</c:v>
                </c:pt>
                <c:pt idx="571">
                  <c:v>1751.0689589999999</c:v>
                </c:pt>
                <c:pt idx="572">
                  <c:v>1752.997449</c:v>
                </c:pt>
                <c:pt idx="573">
                  <c:v>1754.925939</c:v>
                </c:pt>
                <c:pt idx="574">
                  <c:v>1756.854429</c:v>
                </c:pt>
                <c:pt idx="575">
                  <c:v>1758.782919</c:v>
                </c:pt>
                <c:pt idx="576">
                  <c:v>1760.711409</c:v>
                </c:pt>
                <c:pt idx="577">
                  <c:v>1762.639899</c:v>
                </c:pt>
                <c:pt idx="578">
                  <c:v>1764.568389</c:v>
                </c:pt>
                <c:pt idx="579">
                  <c:v>1766.496879</c:v>
                </c:pt>
                <c:pt idx="580">
                  <c:v>1768.425369</c:v>
                </c:pt>
                <c:pt idx="581">
                  <c:v>1770.3538590000001</c:v>
                </c:pt>
                <c:pt idx="582">
                  <c:v>1772.2823490000001</c:v>
                </c:pt>
                <c:pt idx="583">
                  <c:v>1774.2108390000001</c:v>
                </c:pt>
                <c:pt idx="584">
                  <c:v>1776.1393290000001</c:v>
                </c:pt>
                <c:pt idx="585">
                  <c:v>1778.0678190000001</c:v>
                </c:pt>
                <c:pt idx="586">
                  <c:v>1779.9963090000001</c:v>
                </c:pt>
                <c:pt idx="587">
                  <c:v>1781.9247989999999</c:v>
                </c:pt>
                <c:pt idx="588">
                  <c:v>1783.8532889999999</c:v>
                </c:pt>
                <c:pt idx="589">
                  <c:v>1785.78178</c:v>
                </c:pt>
                <c:pt idx="590">
                  <c:v>1787.71027</c:v>
                </c:pt>
                <c:pt idx="591">
                  <c:v>1789.63876</c:v>
                </c:pt>
                <c:pt idx="592">
                  <c:v>1791.5672500000001</c:v>
                </c:pt>
                <c:pt idx="593">
                  <c:v>1793.4957400000001</c:v>
                </c:pt>
                <c:pt idx="594">
                  <c:v>1795.4242300000001</c:v>
                </c:pt>
                <c:pt idx="595">
                  <c:v>1797.3527200000001</c:v>
                </c:pt>
                <c:pt idx="596">
                  <c:v>1799.2812100000001</c:v>
                </c:pt>
                <c:pt idx="597">
                  <c:v>1801.2097000000001</c:v>
                </c:pt>
                <c:pt idx="598">
                  <c:v>1803.1381899999999</c:v>
                </c:pt>
                <c:pt idx="599">
                  <c:v>1805.0666799999999</c:v>
                </c:pt>
                <c:pt idx="600">
                  <c:v>1806.9951699999999</c:v>
                </c:pt>
                <c:pt idx="601">
                  <c:v>1808.9236599999999</c:v>
                </c:pt>
                <c:pt idx="602">
                  <c:v>1810.8521499999999</c:v>
                </c:pt>
                <c:pt idx="603">
                  <c:v>1812.7806399999999</c:v>
                </c:pt>
                <c:pt idx="604">
                  <c:v>1814.70913</c:v>
                </c:pt>
                <c:pt idx="605">
                  <c:v>1816.63762</c:v>
                </c:pt>
                <c:pt idx="606">
                  <c:v>1818.56611</c:v>
                </c:pt>
                <c:pt idx="607">
                  <c:v>1820.4946</c:v>
                </c:pt>
                <c:pt idx="608">
                  <c:v>1822.42309</c:v>
                </c:pt>
                <c:pt idx="609">
                  <c:v>1824.35158</c:v>
                </c:pt>
                <c:pt idx="610">
                  <c:v>1826.28007</c:v>
                </c:pt>
                <c:pt idx="611">
                  <c:v>1828.20856</c:v>
                </c:pt>
                <c:pt idx="612">
                  <c:v>1830.1370509999999</c:v>
                </c:pt>
                <c:pt idx="613">
                  <c:v>1832.0655409999999</c:v>
                </c:pt>
                <c:pt idx="614">
                  <c:v>1833.9940309999999</c:v>
                </c:pt>
                <c:pt idx="615">
                  <c:v>1835.922521</c:v>
                </c:pt>
                <c:pt idx="616">
                  <c:v>1837.851011</c:v>
                </c:pt>
                <c:pt idx="617">
                  <c:v>1839.779501</c:v>
                </c:pt>
                <c:pt idx="618">
                  <c:v>1841.707991</c:v>
                </c:pt>
                <c:pt idx="619">
                  <c:v>1843.636481</c:v>
                </c:pt>
                <c:pt idx="620">
                  <c:v>1845.564971</c:v>
                </c:pt>
                <c:pt idx="621">
                  <c:v>1847.493461</c:v>
                </c:pt>
                <c:pt idx="622">
                  <c:v>1849.421951</c:v>
                </c:pt>
                <c:pt idx="623">
                  <c:v>1851.350441</c:v>
                </c:pt>
                <c:pt idx="624">
                  <c:v>1853.2789310000001</c:v>
                </c:pt>
                <c:pt idx="625">
                  <c:v>1855.2074210000001</c:v>
                </c:pt>
                <c:pt idx="626">
                  <c:v>1857.1359110000001</c:v>
                </c:pt>
                <c:pt idx="627">
                  <c:v>1859.0644010000001</c:v>
                </c:pt>
                <c:pt idx="628">
                  <c:v>1860.9928910000001</c:v>
                </c:pt>
                <c:pt idx="629">
                  <c:v>1862.9213810000001</c:v>
                </c:pt>
                <c:pt idx="630">
                  <c:v>1864.8498709999999</c:v>
                </c:pt>
                <c:pt idx="631">
                  <c:v>1866.7783609999999</c:v>
                </c:pt>
                <c:pt idx="632">
                  <c:v>1868.7068509999999</c:v>
                </c:pt>
                <c:pt idx="633">
                  <c:v>1870.6353409999999</c:v>
                </c:pt>
                <c:pt idx="634">
                  <c:v>1872.5638309999999</c:v>
                </c:pt>
                <c:pt idx="635">
                  <c:v>1874.4923209999999</c:v>
                </c:pt>
                <c:pt idx="636">
                  <c:v>1876.4208120000001</c:v>
                </c:pt>
                <c:pt idx="637">
                  <c:v>1878.3493020000001</c:v>
                </c:pt>
                <c:pt idx="638">
                  <c:v>1880.2777920000001</c:v>
                </c:pt>
                <c:pt idx="639">
                  <c:v>1882.2062820000001</c:v>
                </c:pt>
                <c:pt idx="640">
                  <c:v>1884.1347720000001</c:v>
                </c:pt>
                <c:pt idx="641">
                  <c:v>1886.0632619999999</c:v>
                </c:pt>
                <c:pt idx="642">
                  <c:v>1887.9917519999999</c:v>
                </c:pt>
                <c:pt idx="643">
                  <c:v>1889.9202419999999</c:v>
                </c:pt>
                <c:pt idx="644">
                  <c:v>1891.8487319999999</c:v>
                </c:pt>
                <c:pt idx="645">
                  <c:v>1893.7772219999999</c:v>
                </c:pt>
                <c:pt idx="646">
                  <c:v>1895.7057119999999</c:v>
                </c:pt>
                <c:pt idx="647">
                  <c:v>1897.634202</c:v>
                </c:pt>
                <c:pt idx="648">
                  <c:v>1899.562692</c:v>
                </c:pt>
                <c:pt idx="649">
                  <c:v>1901.491182</c:v>
                </c:pt>
                <c:pt idx="650">
                  <c:v>1903.419672</c:v>
                </c:pt>
                <c:pt idx="651">
                  <c:v>1905.348162</c:v>
                </c:pt>
                <c:pt idx="652">
                  <c:v>1907.276652</c:v>
                </c:pt>
                <c:pt idx="653">
                  <c:v>1909.205142</c:v>
                </c:pt>
                <c:pt idx="654">
                  <c:v>1911.133632</c:v>
                </c:pt>
                <c:pt idx="655">
                  <c:v>1913.062122</c:v>
                </c:pt>
                <c:pt idx="656">
                  <c:v>1914.9906120000001</c:v>
                </c:pt>
                <c:pt idx="657">
                  <c:v>1916.9191020000001</c:v>
                </c:pt>
                <c:pt idx="658">
                  <c:v>1918.8475920000001</c:v>
                </c:pt>
                <c:pt idx="659">
                  <c:v>1920.776083</c:v>
                </c:pt>
                <c:pt idx="660">
                  <c:v>1922.704573</c:v>
                </c:pt>
                <c:pt idx="661">
                  <c:v>1924.633063</c:v>
                </c:pt>
                <c:pt idx="662">
                  <c:v>1926.561553</c:v>
                </c:pt>
                <c:pt idx="663">
                  <c:v>1928.490043</c:v>
                </c:pt>
                <c:pt idx="664">
                  <c:v>1930.418533</c:v>
                </c:pt>
                <c:pt idx="665">
                  <c:v>1932.347023</c:v>
                </c:pt>
                <c:pt idx="666">
                  <c:v>1934.275513</c:v>
                </c:pt>
                <c:pt idx="667">
                  <c:v>1936.2040030000001</c:v>
                </c:pt>
                <c:pt idx="668">
                  <c:v>1938.1324930000001</c:v>
                </c:pt>
                <c:pt idx="669">
                  <c:v>1940.0609830000001</c:v>
                </c:pt>
                <c:pt idx="670">
                  <c:v>1941.9894730000001</c:v>
                </c:pt>
                <c:pt idx="671">
                  <c:v>1943.9179630000001</c:v>
                </c:pt>
                <c:pt idx="672">
                  <c:v>1945.8464530000001</c:v>
                </c:pt>
                <c:pt idx="673">
                  <c:v>1947.7749429999999</c:v>
                </c:pt>
                <c:pt idx="674">
                  <c:v>1949.7034329999999</c:v>
                </c:pt>
                <c:pt idx="675">
                  <c:v>1951.6319229999999</c:v>
                </c:pt>
                <c:pt idx="676">
                  <c:v>1953.5604129999999</c:v>
                </c:pt>
                <c:pt idx="677">
                  <c:v>1955.4889029999999</c:v>
                </c:pt>
                <c:pt idx="678">
                  <c:v>1957.4173929999999</c:v>
                </c:pt>
                <c:pt idx="679">
                  <c:v>1959.345883</c:v>
                </c:pt>
                <c:pt idx="680">
                  <c:v>1961.274373</c:v>
                </c:pt>
                <c:pt idx="681">
                  <c:v>1963.202863</c:v>
                </c:pt>
                <c:pt idx="682">
                  <c:v>1965.131353</c:v>
                </c:pt>
                <c:pt idx="683">
                  <c:v>1967.0598440000001</c:v>
                </c:pt>
                <c:pt idx="684">
                  <c:v>1968.9883339999999</c:v>
                </c:pt>
                <c:pt idx="685">
                  <c:v>1970.9168239999999</c:v>
                </c:pt>
                <c:pt idx="686">
                  <c:v>1972.8453139999999</c:v>
                </c:pt>
                <c:pt idx="687">
                  <c:v>1974.7738039999999</c:v>
                </c:pt>
                <c:pt idx="688">
                  <c:v>1976.7022939999999</c:v>
                </c:pt>
                <c:pt idx="689">
                  <c:v>1978.6307839999999</c:v>
                </c:pt>
                <c:pt idx="690">
                  <c:v>1980.559274</c:v>
                </c:pt>
                <c:pt idx="691">
                  <c:v>1982.487764</c:v>
                </c:pt>
                <c:pt idx="692">
                  <c:v>1984.416254</c:v>
                </c:pt>
                <c:pt idx="693">
                  <c:v>1986.344744</c:v>
                </c:pt>
                <c:pt idx="694">
                  <c:v>1988.273234</c:v>
                </c:pt>
                <c:pt idx="695">
                  <c:v>1990.201724</c:v>
                </c:pt>
                <c:pt idx="696">
                  <c:v>1992.130214</c:v>
                </c:pt>
                <c:pt idx="697">
                  <c:v>1994.058704</c:v>
                </c:pt>
                <c:pt idx="698">
                  <c:v>1995.987194</c:v>
                </c:pt>
                <c:pt idx="699">
                  <c:v>1997.9156840000001</c:v>
                </c:pt>
                <c:pt idx="700">
                  <c:v>1999.8441740000001</c:v>
                </c:pt>
                <c:pt idx="701">
                  <c:v>2001.7726640000001</c:v>
                </c:pt>
                <c:pt idx="702">
                  <c:v>2003.7011540000001</c:v>
                </c:pt>
                <c:pt idx="703">
                  <c:v>2005.6296440000001</c:v>
                </c:pt>
                <c:pt idx="704">
                  <c:v>2007.5581340000001</c:v>
                </c:pt>
                <c:pt idx="705">
                  <c:v>2009.4866239999999</c:v>
                </c:pt>
                <c:pt idx="706">
                  <c:v>2011.415115</c:v>
                </c:pt>
                <c:pt idx="707">
                  <c:v>2013.343605</c:v>
                </c:pt>
                <c:pt idx="708">
                  <c:v>2015.272095</c:v>
                </c:pt>
                <c:pt idx="709">
                  <c:v>2017.200585</c:v>
                </c:pt>
                <c:pt idx="710">
                  <c:v>2019.1290750000001</c:v>
                </c:pt>
                <c:pt idx="711">
                  <c:v>2021.0575650000001</c:v>
                </c:pt>
                <c:pt idx="712">
                  <c:v>2022.9860550000001</c:v>
                </c:pt>
                <c:pt idx="713">
                  <c:v>2024.9145450000001</c:v>
                </c:pt>
                <c:pt idx="714">
                  <c:v>2026.8430350000001</c:v>
                </c:pt>
                <c:pt idx="715">
                  <c:v>2028.7715250000001</c:v>
                </c:pt>
                <c:pt idx="716">
                  <c:v>2030.7000149999999</c:v>
                </c:pt>
                <c:pt idx="717">
                  <c:v>2032.6285049999999</c:v>
                </c:pt>
                <c:pt idx="718">
                  <c:v>2034.5569949999999</c:v>
                </c:pt>
                <c:pt idx="719">
                  <c:v>2036.4854849999999</c:v>
                </c:pt>
                <c:pt idx="720">
                  <c:v>2038.4139749999999</c:v>
                </c:pt>
                <c:pt idx="721">
                  <c:v>2040.3424649999999</c:v>
                </c:pt>
                <c:pt idx="722">
                  <c:v>2042.270955</c:v>
                </c:pt>
                <c:pt idx="723">
                  <c:v>2044.199445</c:v>
                </c:pt>
                <c:pt idx="724">
                  <c:v>2046.127935</c:v>
                </c:pt>
                <c:pt idx="725">
                  <c:v>2048.0564250000002</c:v>
                </c:pt>
                <c:pt idx="726">
                  <c:v>2049.984915</c:v>
                </c:pt>
                <c:pt idx="727">
                  <c:v>2051.9134049999998</c:v>
                </c:pt>
                <c:pt idx="728">
                  <c:v>2053.841895</c:v>
                </c:pt>
                <c:pt idx="729">
                  <c:v>2055.7703860000001</c:v>
                </c:pt>
                <c:pt idx="730">
                  <c:v>2057.698875999999</c:v>
                </c:pt>
                <c:pt idx="731">
                  <c:v>2059.6273660000002</c:v>
                </c:pt>
                <c:pt idx="732">
                  <c:v>2061.5558559999999</c:v>
                </c:pt>
                <c:pt idx="733">
                  <c:v>2063.4843460000002</c:v>
                </c:pt>
                <c:pt idx="734">
                  <c:v>2065.412836</c:v>
                </c:pt>
                <c:pt idx="735">
                  <c:v>2067.3413260000002</c:v>
                </c:pt>
                <c:pt idx="736">
                  <c:v>2069.269816</c:v>
                </c:pt>
                <c:pt idx="737">
                  <c:v>2071.1983059999998</c:v>
                </c:pt>
                <c:pt idx="738">
                  <c:v>2073.126796</c:v>
                </c:pt>
                <c:pt idx="739">
                  <c:v>2075.0552859999998</c:v>
                </c:pt>
                <c:pt idx="740">
                  <c:v>2076.983776</c:v>
                </c:pt>
                <c:pt idx="741">
                  <c:v>2078.9122659999998</c:v>
                </c:pt>
                <c:pt idx="742">
                  <c:v>2080.8407560000001</c:v>
                </c:pt>
                <c:pt idx="743">
                  <c:v>2082.769245999998</c:v>
                </c:pt>
                <c:pt idx="744">
                  <c:v>2084.6977360000001</c:v>
                </c:pt>
                <c:pt idx="745">
                  <c:v>2086.626225999998</c:v>
                </c:pt>
                <c:pt idx="746">
                  <c:v>2088.5547160000001</c:v>
                </c:pt>
                <c:pt idx="747">
                  <c:v>2090.4832059999999</c:v>
                </c:pt>
                <c:pt idx="748">
                  <c:v>2092.4116960000001</c:v>
                </c:pt>
                <c:pt idx="749">
                  <c:v>2094.3401859999999</c:v>
                </c:pt>
                <c:pt idx="750">
                  <c:v>2096.2686760000001</c:v>
                </c:pt>
                <c:pt idx="751">
                  <c:v>2098.1971659999999</c:v>
                </c:pt>
                <c:pt idx="752">
                  <c:v>2100.1256560000002</c:v>
                </c:pt>
                <c:pt idx="753">
                  <c:v>2102.0541469999998</c:v>
                </c:pt>
                <c:pt idx="754">
                  <c:v>2103.9826370000001</c:v>
                </c:pt>
                <c:pt idx="755">
                  <c:v>2105.9111269999999</c:v>
                </c:pt>
                <c:pt idx="756">
                  <c:v>2107.8396170000001</c:v>
                </c:pt>
                <c:pt idx="757">
                  <c:v>2109.7681069999999</c:v>
                </c:pt>
                <c:pt idx="758">
                  <c:v>2111.6965970000001</c:v>
                </c:pt>
                <c:pt idx="759">
                  <c:v>2113.6250869999999</c:v>
                </c:pt>
                <c:pt idx="760">
                  <c:v>2115.5535770000001</c:v>
                </c:pt>
                <c:pt idx="761">
                  <c:v>2117.4820669999999</c:v>
                </c:pt>
                <c:pt idx="762">
                  <c:v>2119.4105570000002</c:v>
                </c:pt>
                <c:pt idx="763">
                  <c:v>2121.3390469999999</c:v>
                </c:pt>
                <c:pt idx="764">
                  <c:v>2123.2675370000002</c:v>
                </c:pt>
                <c:pt idx="765">
                  <c:v>2125.196027</c:v>
                </c:pt>
                <c:pt idx="766">
                  <c:v>2127.1245170000002</c:v>
                </c:pt>
                <c:pt idx="767">
                  <c:v>2129.053007</c:v>
                </c:pt>
                <c:pt idx="768">
                  <c:v>2130.9814970000002</c:v>
                </c:pt>
                <c:pt idx="769">
                  <c:v>2132.909987</c:v>
                </c:pt>
                <c:pt idx="770">
                  <c:v>2134.8384769999998</c:v>
                </c:pt>
                <c:pt idx="771">
                  <c:v>2136.766967</c:v>
                </c:pt>
                <c:pt idx="772">
                  <c:v>2138.6954569999998</c:v>
                </c:pt>
                <c:pt idx="773">
                  <c:v>2140.623947</c:v>
                </c:pt>
                <c:pt idx="774">
                  <c:v>2142.5524369999998</c:v>
                </c:pt>
                <c:pt idx="775">
                  <c:v>2144.4809270000001</c:v>
                </c:pt>
                <c:pt idx="776">
                  <c:v>2146.4094180000002</c:v>
                </c:pt>
                <c:pt idx="777">
                  <c:v>2148.337908</c:v>
                </c:pt>
                <c:pt idx="778">
                  <c:v>2150.2663980000002</c:v>
                </c:pt>
                <c:pt idx="779">
                  <c:v>2152.194888</c:v>
                </c:pt>
                <c:pt idx="780">
                  <c:v>2154.1233779999998</c:v>
                </c:pt>
                <c:pt idx="781">
                  <c:v>2156.051868</c:v>
                </c:pt>
                <c:pt idx="782">
                  <c:v>2157.9803579999998</c:v>
                </c:pt>
                <c:pt idx="783">
                  <c:v>2159.908848</c:v>
                </c:pt>
                <c:pt idx="784">
                  <c:v>2161.8373379999998</c:v>
                </c:pt>
                <c:pt idx="785">
                  <c:v>2163.7658280000001</c:v>
                </c:pt>
                <c:pt idx="786">
                  <c:v>2165.6943179999998</c:v>
                </c:pt>
                <c:pt idx="787">
                  <c:v>2167.6228080000001</c:v>
                </c:pt>
                <c:pt idx="788">
                  <c:v>2169.5512979999999</c:v>
                </c:pt>
                <c:pt idx="789">
                  <c:v>2171.4797880000001</c:v>
                </c:pt>
                <c:pt idx="790">
                  <c:v>2173.4082779999999</c:v>
                </c:pt>
                <c:pt idx="791">
                  <c:v>2175.3367680000001</c:v>
                </c:pt>
                <c:pt idx="792">
                  <c:v>2177.2652579999999</c:v>
                </c:pt>
                <c:pt idx="793">
                  <c:v>2179.1937480000001</c:v>
                </c:pt>
                <c:pt idx="794">
                  <c:v>2181.1222379999999</c:v>
                </c:pt>
                <c:pt idx="795">
                  <c:v>2183.0507280000002</c:v>
                </c:pt>
                <c:pt idx="796">
                  <c:v>2184.9792179999999</c:v>
                </c:pt>
                <c:pt idx="797">
                  <c:v>2186.9077080000002</c:v>
                </c:pt>
                <c:pt idx="798">
                  <c:v>2188.836198</c:v>
                </c:pt>
                <c:pt idx="799">
                  <c:v>2190.7646879999952</c:v>
                </c:pt>
                <c:pt idx="800">
                  <c:v>2192.6931789999999</c:v>
                </c:pt>
                <c:pt idx="801">
                  <c:v>2194.6216690000001</c:v>
                </c:pt>
                <c:pt idx="802">
                  <c:v>2196.5501589999999</c:v>
                </c:pt>
                <c:pt idx="803">
                  <c:v>2198.4786490000001</c:v>
                </c:pt>
                <c:pt idx="804">
                  <c:v>2200.4071389999999</c:v>
                </c:pt>
                <c:pt idx="805">
                  <c:v>2202.3356290000002</c:v>
                </c:pt>
                <c:pt idx="806">
                  <c:v>2204.2641189999999</c:v>
                </c:pt>
                <c:pt idx="807">
                  <c:v>2206.1926090000002</c:v>
                </c:pt>
                <c:pt idx="808">
                  <c:v>2208.121099</c:v>
                </c:pt>
                <c:pt idx="809">
                  <c:v>2210.0495890000002</c:v>
                </c:pt>
                <c:pt idx="810">
                  <c:v>2211.978079</c:v>
                </c:pt>
                <c:pt idx="811">
                  <c:v>2213.9065690000002</c:v>
                </c:pt>
                <c:pt idx="812">
                  <c:v>2215.835059</c:v>
                </c:pt>
                <c:pt idx="813">
                  <c:v>2217.7635489999998</c:v>
                </c:pt>
                <c:pt idx="814">
                  <c:v>2219.692039</c:v>
                </c:pt>
                <c:pt idx="815">
                  <c:v>2221.6205289999998</c:v>
                </c:pt>
                <c:pt idx="816">
                  <c:v>2223.549019</c:v>
                </c:pt>
                <c:pt idx="817">
                  <c:v>2225.4775089999998</c:v>
                </c:pt>
                <c:pt idx="818">
                  <c:v>2227.4059990000001</c:v>
                </c:pt>
                <c:pt idx="819">
                  <c:v>2229.3344889999998</c:v>
                </c:pt>
                <c:pt idx="820">
                  <c:v>2231.2629790000001</c:v>
                </c:pt>
                <c:pt idx="821">
                  <c:v>2233.1914689999999</c:v>
                </c:pt>
                <c:pt idx="822">
                  <c:v>2235.1199590000001</c:v>
                </c:pt>
                <c:pt idx="823">
                  <c:v>2237.048449999998</c:v>
                </c:pt>
                <c:pt idx="824">
                  <c:v>2238.97694</c:v>
                </c:pt>
                <c:pt idx="825">
                  <c:v>2240.9054299999998</c:v>
                </c:pt>
                <c:pt idx="826">
                  <c:v>2242.83392</c:v>
                </c:pt>
                <c:pt idx="827">
                  <c:v>2244.762409999998</c:v>
                </c:pt>
                <c:pt idx="828">
                  <c:v>2246.6909000000001</c:v>
                </c:pt>
                <c:pt idx="829">
                  <c:v>2248.6193899999998</c:v>
                </c:pt>
                <c:pt idx="830">
                  <c:v>2250.5478800000001</c:v>
                </c:pt>
                <c:pt idx="831">
                  <c:v>2252.4763699999999</c:v>
                </c:pt>
                <c:pt idx="832">
                  <c:v>2254.4048600000001</c:v>
                </c:pt>
                <c:pt idx="833">
                  <c:v>2256.3333499999999</c:v>
                </c:pt>
                <c:pt idx="834">
                  <c:v>2258.2618400000001</c:v>
                </c:pt>
                <c:pt idx="835">
                  <c:v>2260.1903299999999</c:v>
                </c:pt>
                <c:pt idx="836">
                  <c:v>2262.1188200000001</c:v>
                </c:pt>
                <c:pt idx="837">
                  <c:v>2264.0473099999999</c:v>
                </c:pt>
                <c:pt idx="838">
                  <c:v>2265.9758000000002</c:v>
                </c:pt>
                <c:pt idx="839">
                  <c:v>2267.904289999999</c:v>
                </c:pt>
                <c:pt idx="840">
                  <c:v>2269.8327800000002</c:v>
                </c:pt>
                <c:pt idx="841">
                  <c:v>2271.76127</c:v>
                </c:pt>
                <c:pt idx="842">
                  <c:v>2273.6897600000002</c:v>
                </c:pt>
                <c:pt idx="843">
                  <c:v>2275.61825</c:v>
                </c:pt>
                <c:pt idx="844">
                  <c:v>2277.5467400000002</c:v>
                </c:pt>
                <c:pt idx="845">
                  <c:v>2279.47523</c:v>
                </c:pt>
                <c:pt idx="846">
                  <c:v>2281.4037199999998</c:v>
                </c:pt>
                <c:pt idx="847">
                  <c:v>2283.3322109999999</c:v>
                </c:pt>
                <c:pt idx="848">
                  <c:v>2285.2607010000002</c:v>
                </c:pt>
                <c:pt idx="849">
                  <c:v>2287.1891909999999</c:v>
                </c:pt>
                <c:pt idx="850">
                  <c:v>2289.1176810000002</c:v>
                </c:pt>
                <c:pt idx="851">
                  <c:v>2291.046171</c:v>
                </c:pt>
                <c:pt idx="852">
                  <c:v>2292.9746610000002</c:v>
                </c:pt>
                <c:pt idx="853">
                  <c:v>2294.903151</c:v>
                </c:pt>
                <c:pt idx="854">
                  <c:v>2296.8316410000002</c:v>
                </c:pt>
                <c:pt idx="855">
                  <c:v>2298.760131</c:v>
                </c:pt>
                <c:pt idx="856">
                  <c:v>2300.688620999998</c:v>
                </c:pt>
                <c:pt idx="857">
                  <c:v>2302.617111</c:v>
                </c:pt>
                <c:pt idx="858">
                  <c:v>2304.5456009999998</c:v>
                </c:pt>
                <c:pt idx="859">
                  <c:v>2306.474091</c:v>
                </c:pt>
                <c:pt idx="860">
                  <c:v>2308.4025809999998</c:v>
                </c:pt>
                <c:pt idx="861">
                  <c:v>2310.3310710000001</c:v>
                </c:pt>
                <c:pt idx="862">
                  <c:v>2312.2595609999998</c:v>
                </c:pt>
                <c:pt idx="863">
                  <c:v>2314.1880510000001</c:v>
                </c:pt>
                <c:pt idx="864">
                  <c:v>2316.1165409999999</c:v>
                </c:pt>
                <c:pt idx="865">
                  <c:v>2318.0450310000001</c:v>
                </c:pt>
                <c:pt idx="866">
                  <c:v>2319.9735209999999</c:v>
                </c:pt>
                <c:pt idx="867">
                  <c:v>2321.9020110000001</c:v>
                </c:pt>
                <c:pt idx="868">
                  <c:v>2323.8305009999999</c:v>
                </c:pt>
                <c:pt idx="869">
                  <c:v>2325.7589910000002</c:v>
                </c:pt>
                <c:pt idx="870">
                  <c:v>2327.687481999998</c:v>
                </c:pt>
                <c:pt idx="871">
                  <c:v>2329.6159720000001</c:v>
                </c:pt>
                <c:pt idx="872">
                  <c:v>2331.544461999998</c:v>
                </c:pt>
                <c:pt idx="873">
                  <c:v>2333.4729520000001</c:v>
                </c:pt>
                <c:pt idx="874">
                  <c:v>2335.4014419999999</c:v>
                </c:pt>
                <c:pt idx="875">
                  <c:v>2337.3299320000001</c:v>
                </c:pt>
                <c:pt idx="876">
                  <c:v>2339.258421999999</c:v>
                </c:pt>
                <c:pt idx="877">
                  <c:v>2341.1869120000001</c:v>
                </c:pt>
                <c:pt idx="878">
                  <c:v>2343.1154019999999</c:v>
                </c:pt>
                <c:pt idx="879">
                  <c:v>2345.0438920000001</c:v>
                </c:pt>
                <c:pt idx="880">
                  <c:v>2346.9723819999999</c:v>
                </c:pt>
                <c:pt idx="881">
                  <c:v>2348.9008720000002</c:v>
                </c:pt>
                <c:pt idx="882">
                  <c:v>2350.8293619999999</c:v>
                </c:pt>
                <c:pt idx="883">
                  <c:v>2352.7578520000002</c:v>
                </c:pt>
                <c:pt idx="884">
                  <c:v>2354.686342</c:v>
                </c:pt>
                <c:pt idx="885">
                  <c:v>2356.6148320000002</c:v>
                </c:pt>
                <c:pt idx="886">
                  <c:v>2358.543322</c:v>
                </c:pt>
                <c:pt idx="887">
                  <c:v>2360.4718120000002</c:v>
                </c:pt>
                <c:pt idx="888">
                  <c:v>2362.400302</c:v>
                </c:pt>
                <c:pt idx="889">
                  <c:v>2364.3287919999998</c:v>
                </c:pt>
                <c:pt idx="890">
                  <c:v>2366.257282</c:v>
                </c:pt>
                <c:pt idx="891">
                  <c:v>2368.1857719999998</c:v>
                </c:pt>
                <c:pt idx="892">
                  <c:v>2370.1142620000001</c:v>
                </c:pt>
                <c:pt idx="893">
                  <c:v>2372.0427530000002</c:v>
                </c:pt>
                <c:pt idx="894">
                  <c:v>2373.971243</c:v>
                </c:pt>
                <c:pt idx="895">
                  <c:v>2375.8997330000002</c:v>
                </c:pt>
                <c:pt idx="896">
                  <c:v>2377.828223</c:v>
                </c:pt>
                <c:pt idx="897">
                  <c:v>2379.7567130000002</c:v>
                </c:pt>
                <c:pt idx="898">
                  <c:v>2381.685203</c:v>
                </c:pt>
                <c:pt idx="899">
                  <c:v>2383.6136929999998</c:v>
                </c:pt>
                <c:pt idx="900">
                  <c:v>2385.542183</c:v>
                </c:pt>
                <c:pt idx="901">
                  <c:v>2387.4706729999998</c:v>
                </c:pt>
                <c:pt idx="902">
                  <c:v>2389.399163</c:v>
                </c:pt>
                <c:pt idx="903">
                  <c:v>2391.3276529999998</c:v>
                </c:pt>
                <c:pt idx="904">
                  <c:v>2393.2561430000001</c:v>
                </c:pt>
                <c:pt idx="905">
                  <c:v>2395.1846329999998</c:v>
                </c:pt>
                <c:pt idx="906">
                  <c:v>2397.1131230000001</c:v>
                </c:pt>
                <c:pt idx="907">
                  <c:v>2399.0416129999999</c:v>
                </c:pt>
                <c:pt idx="908">
                  <c:v>2400.9701030000001</c:v>
                </c:pt>
                <c:pt idx="909">
                  <c:v>2402.8985929999999</c:v>
                </c:pt>
                <c:pt idx="910">
                  <c:v>2404.8270830000001</c:v>
                </c:pt>
                <c:pt idx="911">
                  <c:v>2406.7555729999999</c:v>
                </c:pt>
                <c:pt idx="912">
                  <c:v>2408.6840630000002</c:v>
                </c:pt>
                <c:pt idx="913">
                  <c:v>2410.6125529999999</c:v>
                </c:pt>
                <c:pt idx="914">
                  <c:v>2412.5410430000002</c:v>
                </c:pt>
                <c:pt idx="915">
                  <c:v>2414.469533</c:v>
                </c:pt>
                <c:pt idx="916">
                  <c:v>2416.3980230000002</c:v>
                </c:pt>
                <c:pt idx="917">
                  <c:v>2418.3265139999999</c:v>
                </c:pt>
                <c:pt idx="918">
                  <c:v>2420.2550040000001</c:v>
                </c:pt>
                <c:pt idx="919">
                  <c:v>2422.1834939999999</c:v>
                </c:pt>
                <c:pt idx="920">
                  <c:v>2424.1119840000001</c:v>
                </c:pt>
                <c:pt idx="921">
                  <c:v>2426.0404739999999</c:v>
                </c:pt>
                <c:pt idx="922">
                  <c:v>2427.9689640000001</c:v>
                </c:pt>
                <c:pt idx="923">
                  <c:v>2429.8974539999999</c:v>
                </c:pt>
                <c:pt idx="924">
                  <c:v>2431.8259440000002</c:v>
                </c:pt>
                <c:pt idx="925">
                  <c:v>2433.7544339999999</c:v>
                </c:pt>
                <c:pt idx="926">
                  <c:v>2435.6829240000002</c:v>
                </c:pt>
                <c:pt idx="927">
                  <c:v>2437.611414</c:v>
                </c:pt>
                <c:pt idx="928">
                  <c:v>2439.5399040000002</c:v>
                </c:pt>
                <c:pt idx="929">
                  <c:v>2441.468394</c:v>
                </c:pt>
                <c:pt idx="930">
                  <c:v>2443.3968839999998</c:v>
                </c:pt>
                <c:pt idx="931">
                  <c:v>2445.325374</c:v>
                </c:pt>
                <c:pt idx="932">
                  <c:v>2447.2538639999998</c:v>
                </c:pt>
                <c:pt idx="933">
                  <c:v>2449.182354</c:v>
                </c:pt>
                <c:pt idx="934">
                  <c:v>2451.1108439999998</c:v>
                </c:pt>
                <c:pt idx="935">
                  <c:v>2453.0393340000001</c:v>
                </c:pt>
                <c:pt idx="936">
                  <c:v>2454.9678239999998</c:v>
                </c:pt>
                <c:pt idx="937">
                  <c:v>2456.8963140000001</c:v>
                </c:pt>
                <c:pt idx="938">
                  <c:v>2458.8248039999999</c:v>
                </c:pt>
                <c:pt idx="939">
                  <c:v>2460.7532940000001</c:v>
                </c:pt>
                <c:pt idx="940">
                  <c:v>2462.6817850000002</c:v>
                </c:pt>
                <c:pt idx="941">
                  <c:v>2464.610275</c:v>
                </c:pt>
                <c:pt idx="942">
                  <c:v>2466.5387649999998</c:v>
                </c:pt>
                <c:pt idx="943">
                  <c:v>2468.467255</c:v>
                </c:pt>
                <c:pt idx="944">
                  <c:v>2470.3957449999998</c:v>
                </c:pt>
                <c:pt idx="945">
                  <c:v>2472.324235</c:v>
                </c:pt>
                <c:pt idx="946">
                  <c:v>2474.2527249999998</c:v>
                </c:pt>
                <c:pt idx="947">
                  <c:v>2476.1812150000001</c:v>
                </c:pt>
                <c:pt idx="948">
                  <c:v>2478.1097049999998</c:v>
                </c:pt>
                <c:pt idx="949">
                  <c:v>2480.0381950000001</c:v>
                </c:pt>
                <c:pt idx="950">
                  <c:v>2481.966684999999</c:v>
                </c:pt>
                <c:pt idx="951">
                  <c:v>2483.8951750000001</c:v>
                </c:pt>
                <c:pt idx="952">
                  <c:v>2485.8236649999999</c:v>
                </c:pt>
                <c:pt idx="953">
                  <c:v>2487.7521550000001</c:v>
                </c:pt>
                <c:pt idx="954">
                  <c:v>2489.680644999999</c:v>
                </c:pt>
                <c:pt idx="955">
                  <c:v>2491.6091350000002</c:v>
                </c:pt>
                <c:pt idx="956">
                  <c:v>2493.5376249999999</c:v>
                </c:pt>
                <c:pt idx="957">
                  <c:v>2495.4661150000002</c:v>
                </c:pt>
                <c:pt idx="958">
                  <c:v>2497.394605</c:v>
                </c:pt>
                <c:pt idx="959">
                  <c:v>2499.3230950000002</c:v>
                </c:pt>
                <c:pt idx="960">
                  <c:v>2501.251585</c:v>
                </c:pt>
                <c:pt idx="961">
                  <c:v>2503.1800750000002</c:v>
                </c:pt>
                <c:pt idx="962">
                  <c:v>2505.108565</c:v>
                </c:pt>
                <c:pt idx="963">
                  <c:v>2507.0370549999998</c:v>
                </c:pt>
                <c:pt idx="964">
                  <c:v>2508.9655459999999</c:v>
                </c:pt>
                <c:pt idx="965">
                  <c:v>2510.8940360000001</c:v>
                </c:pt>
                <c:pt idx="966">
                  <c:v>2512.8225259999999</c:v>
                </c:pt>
                <c:pt idx="967">
                  <c:v>2514.7510160000002</c:v>
                </c:pt>
                <c:pt idx="968">
                  <c:v>2516.6795059999999</c:v>
                </c:pt>
                <c:pt idx="969">
                  <c:v>2518.6079960000002</c:v>
                </c:pt>
                <c:pt idx="970">
                  <c:v>2520.536486</c:v>
                </c:pt>
                <c:pt idx="971">
                  <c:v>2522.4649760000002</c:v>
                </c:pt>
                <c:pt idx="972">
                  <c:v>2524.393466</c:v>
                </c:pt>
                <c:pt idx="973">
                  <c:v>2526.3219559999998</c:v>
                </c:pt>
                <c:pt idx="974">
                  <c:v>2528.250446</c:v>
                </c:pt>
                <c:pt idx="975">
                  <c:v>2530.1789359999998</c:v>
                </c:pt>
                <c:pt idx="976">
                  <c:v>2532.107426</c:v>
                </c:pt>
                <c:pt idx="977">
                  <c:v>2534.0359159999998</c:v>
                </c:pt>
                <c:pt idx="978">
                  <c:v>2535.9644060000001</c:v>
                </c:pt>
                <c:pt idx="979">
                  <c:v>2537.8928959999998</c:v>
                </c:pt>
                <c:pt idx="980">
                  <c:v>2539.8213860000001</c:v>
                </c:pt>
                <c:pt idx="981">
                  <c:v>2541.749875999998</c:v>
                </c:pt>
                <c:pt idx="982">
                  <c:v>2543.6783660000001</c:v>
                </c:pt>
                <c:pt idx="983">
                  <c:v>2545.606855999999</c:v>
                </c:pt>
                <c:pt idx="984">
                  <c:v>2547.5353460000001</c:v>
                </c:pt>
                <c:pt idx="985">
                  <c:v>2549.4638359999999</c:v>
                </c:pt>
                <c:pt idx="986">
                  <c:v>2551.3923260000001</c:v>
                </c:pt>
                <c:pt idx="987">
                  <c:v>2553.3208169999998</c:v>
                </c:pt>
                <c:pt idx="988">
                  <c:v>2555.249307</c:v>
                </c:pt>
                <c:pt idx="989">
                  <c:v>2557.1777969999998</c:v>
                </c:pt>
                <c:pt idx="990">
                  <c:v>2559.1062870000001</c:v>
                </c:pt>
                <c:pt idx="991">
                  <c:v>2561.0347769999998</c:v>
                </c:pt>
                <c:pt idx="992">
                  <c:v>2562.9632670000001</c:v>
                </c:pt>
                <c:pt idx="993">
                  <c:v>2564.8917569999999</c:v>
                </c:pt>
                <c:pt idx="994">
                  <c:v>2566.8202470000001</c:v>
                </c:pt>
                <c:pt idx="995">
                  <c:v>2568.7487369999999</c:v>
                </c:pt>
                <c:pt idx="996">
                  <c:v>2570.6772270000001</c:v>
                </c:pt>
                <c:pt idx="997">
                  <c:v>2572.6057169999999</c:v>
                </c:pt>
                <c:pt idx="998">
                  <c:v>2574.5342070000002</c:v>
                </c:pt>
                <c:pt idx="999">
                  <c:v>2576.4626969999999</c:v>
                </c:pt>
                <c:pt idx="1000">
                  <c:v>2578.3911870000002</c:v>
                </c:pt>
                <c:pt idx="1001">
                  <c:v>2580.319677</c:v>
                </c:pt>
                <c:pt idx="1002">
                  <c:v>2582.2481670000002</c:v>
                </c:pt>
                <c:pt idx="1003">
                  <c:v>2584.176657</c:v>
                </c:pt>
                <c:pt idx="1004">
                  <c:v>2586.1051470000002</c:v>
                </c:pt>
                <c:pt idx="1005">
                  <c:v>2588.033637</c:v>
                </c:pt>
                <c:pt idx="1006">
                  <c:v>2589.9621269999998</c:v>
                </c:pt>
                <c:pt idx="1007">
                  <c:v>2591.890617</c:v>
                </c:pt>
                <c:pt idx="1008">
                  <c:v>2593.8191069999998</c:v>
                </c:pt>
                <c:pt idx="1009">
                  <c:v>2595.747597</c:v>
                </c:pt>
                <c:pt idx="1010">
                  <c:v>2597.6760869999998</c:v>
                </c:pt>
                <c:pt idx="1011">
                  <c:v>2599.6045779999999</c:v>
                </c:pt>
                <c:pt idx="1012">
                  <c:v>2601.5330680000002</c:v>
                </c:pt>
                <c:pt idx="1013">
                  <c:v>2603.461558</c:v>
                </c:pt>
                <c:pt idx="1014">
                  <c:v>2605.3900480000002</c:v>
                </c:pt>
                <c:pt idx="1015">
                  <c:v>2607.318538</c:v>
                </c:pt>
                <c:pt idx="1016">
                  <c:v>2609.2470279999998</c:v>
                </c:pt>
                <c:pt idx="1017">
                  <c:v>2611.175518</c:v>
                </c:pt>
                <c:pt idx="1018">
                  <c:v>2613.1040079999998</c:v>
                </c:pt>
                <c:pt idx="1019">
                  <c:v>2615.032498</c:v>
                </c:pt>
                <c:pt idx="1020">
                  <c:v>2616.9609879999998</c:v>
                </c:pt>
                <c:pt idx="1021">
                  <c:v>2618.8894780000001</c:v>
                </c:pt>
                <c:pt idx="1022">
                  <c:v>2620.8179679999998</c:v>
                </c:pt>
                <c:pt idx="1023">
                  <c:v>2622.7464580000001</c:v>
                </c:pt>
                <c:pt idx="1024">
                  <c:v>2624.6749479999999</c:v>
                </c:pt>
                <c:pt idx="1025">
                  <c:v>2626.6034380000001</c:v>
                </c:pt>
                <c:pt idx="1026">
                  <c:v>2628.5319279999999</c:v>
                </c:pt>
                <c:pt idx="1027">
                  <c:v>2630.4604180000001</c:v>
                </c:pt>
                <c:pt idx="1028">
                  <c:v>2632.3889079999999</c:v>
                </c:pt>
                <c:pt idx="1029">
                  <c:v>2634.3173980000001</c:v>
                </c:pt>
                <c:pt idx="1030">
                  <c:v>2636.245887999999</c:v>
                </c:pt>
                <c:pt idx="1031">
                  <c:v>2638.1743780000002</c:v>
                </c:pt>
                <c:pt idx="1032">
                  <c:v>2640.102867999999</c:v>
                </c:pt>
                <c:pt idx="1033">
                  <c:v>2642.0313580000002</c:v>
                </c:pt>
                <c:pt idx="1034">
                  <c:v>2643.9598489999998</c:v>
                </c:pt>
                <c:pt idx="1035">
                  <c:v>2645.8883390000001</c:v>
                </c:pt>
                <c:pt idx="1036">
                  <c:v>2647.8168289999999</c:v>
                </c:pt>
                <c:pt idx="1037">
                  <c:v>2649.7453190000001</c:v>
                </c:pt>
                <c:pt idx="1038">
                  <c:v>2651.6738089999999</c:v>
                </c:pt>
                <c:pt idx="1039">
                  <c:v>2653.6022990000001</c:v>
                </c:pt>
                <c:pt idx="1040">
                  <c:v>2655.5307889999999</c:v>
                </c:pt>
                <c:pt idx="1041">
                  <c:v>2657.4592790000002</c:v>
                </c:pt>
                <c:pt idx="1042">
                  <c:v>2659.3877689999999</c:v>
                </c:pt>
                <c:pt idx="1043">
                  <c:v>2661.3162590000002</c:v>
                </c:pt>
                <c:pt idx="1044">
                  <c:v>2663.244749</c:v>
                </c:pt>
                <c:pt idx="1045">
                  <c:v>2665.1732390000002</c:v>
                </c:pt>
                <c:pt idx="1046">
                  <c:v>2667.101729</c:v>
                </c:pt>
                <c:pt idx="1047">
                  <c:v>2669.0302190000002</c:v>
                </c:pt>
                <c:pt idx="1048">
                  <c:v>2670.958709</c:v>
                </c:pt>
                <c:pt idx="1049">
                  <c:v>2672.8871989999998</c:v>
                </c:pt>
                <c:pt idx="1050">
                  <c:v>2674.815689</c:v>
                </c:pt>
                <c:pt idx="1051">
                  <c:v>2676.7441789999998</c:v>
                </c:pt>
                <c:pt idx="1052">
                  <c:v>2678.672669</c:v>
                </c:pt>
                <c:pt idx="1053">
                  <c:v>2680.6011589999998</c:v>
                </c:pt>
                <c:pt idx="1054">
                  <c:v>2682.5296490000001</c:v>
                </c:pt>
                <c:pt idx="1055">
                  <c:v>2684.4581389999998</c:v>
                </c:pt>
                <c:pt idx="1056">
                  <c:v>2686.3866290000001</c:v>
                </c:pt>
                <c:pt idx="1057">
                  <c:v>2688.3151200000002</c:v>
                </c:pt>
                <c:pt idx="1058">
                  <c:v>2690.24361</c:v>
                </c:pt>
                <c:pt idx="1059">
                  <c:v>2692.1720999999998</c:v>
                </c:pt>
                <c:pt idx="1060">
                  <c:v>2694.10059</c:v>
                </c:pt>
                <c:pt idx="1061">
                  <c:v>2696.0290799999998</c:v>
                </c:pt>
                <c:pt idx="1062">
                  <c:v>2697.95757</c:v>
                </c:pt>
                <c:pt idx="1063">
                  <c:v>2699.8860599999998</c:v>
                </c:pt>
                <c:pt idx="1064">
                  <c:v>2701.8145500000001</c:v>
                </c:pt>
                <c:pt idx="1065">
                  <c:v>2703.7430399999998</c:v>
                </c:pt>
                <c:pt idx="1066">
                  <c:v>2705.6715300000001</c:v>
                </c:pt>
                <c:pt idx="1067">
                  <c:v>2707.6000199999999</c:v>
                </c:pt>
                <c:pt idx="1068">
                  <c:v>2709.5285100000001</c:v>
                </c:pt>
                <c:pt idx="1069">
                  <c:v>2711.4569999999999</c:v>
                </c:pt>
                <c:pt idx="1070">
                  <c:v>2713.3854900000001</c:v>
                </c:pt>
                <c:pt idx="1071">
                  <c:v>2715.3139799999999</c:v>
                </c:pt>
                <c:pt idx="1072">
                  <c:v>2717.2424700000001</c:v>
                </c:pt>
                <c:pt idx="1073">
                  <c:v>2719.1709599999999</c:v>
                </c:pt>
                <c:pt idx="1074">
                  <c:v>2721.0994500000002</c:v>
                </c:pt>
                <c:pt idx="1075">
                  <c:v>2723.0279399999999</c:v>
                </c:pt>
                <c:pt idx="1076">
                  <c:v>2724.9564300000002</c:v>
                </c:pt>
                <c:pt idx="1077">
                  <c:v>2726.88492</c:v>
                </c:pt>
                <c:pt idx="1078">
                  <c:v>2728.8134100000002</c:v>
                </c:pt>
                <c:pt idx="1079">
                  <c:v>2730.7419</c:v>
                </c:pt>
                <c:pt idx="1080">
                  <c:v>2732.6703900000002</c:v>
                </c:pt>
                <c:pt idx="1081">
                  <c:v>2734.598880999999</c:v>
                </c:pt>
                <c:pt idx="1082">
                  <c:v>2736.5273710000001</c:v>
                </c:pt>
                <c:pt idx="1083">
                  <c:v>2738.4558609999999</c:v>
                </c:pt>
                <c:pt idx="1084">
                  <c:v>2740.3843510000002</c:v>
                </c:pt>
                <c:pt idx="1085">
                  <c:v>2742.3128409999999</c:v>
                </c:pt>
                <c:pt idx="1086">
                  <c:v>2744.2413310000002</c:v>
                </c:pt>
                <c:pt idx="1087">
                  <c:v>2746.169821</c:v>
                </c:pt>
                <c:pt idx="1088">
                  <c:v>2748.0983110000002</c:v>
                </c:pt>
                <c:pt idx="1089">
                  <c:v>2750.026801</c:v>
                </c:pt>
                <c:pt idx="1090">
                  <c:v>2751.9552910000002</c:v>
                </c:pt>
                <c:pt idx="1091">
                  <c:v>2753.883781</c:v>
                </c:pt>
                <c:pt idx="1092">
                  <c:v>2755.8122709999998</c:v>
                </c:pt>
                <c:pt idx="1093">
                  <c:v>2757.740761</c:v>
                </c:pt>
                <c:pt idx="1094">
                  <c:v>2759.6692509999998</c:v>
                </c:pt>
                <c:pt idx="1095">
                  <c:v>2761.597741</c:v>
                </c:pt>
                <c:pt idx="1096">
                  <c:v>2763.5262309999998</c:v>
                </c:pt>
                <c:pt idx="1097">
                  <c:v>2765.4547210000001</c:v>
                </c:pt>
                <c:pt idx="1098">
                  <c:v>2767.3832109999998</c:v>
                </c:pt>
                <c:pt idx="1099">
                  <c:v>2769.3117010000001</c:v>
                </c:pt>
                <c:pt idx="1100">
                  <c:v>2771.2401909999999</c:v>
                </c:pt>
                <c:pt idx="1101">
                  <c:v>2773.1686809999951</c:v>
                </c:pt>
                <c:pt idx="1102">
                  <c:v>2775.0971709999999</c:v>
                </c:pt>
                <c:pt idx="1103">
                  <c:v>2777.0256610000001</c:v>
                </c:pt>
                <c:pt idx="1104">
                  <c:v>2778.9541519999998</c:v>
                </c:pt>
                <c:pt idx="1105">
                  <c:v>2780.882642</c:v>
                </c:pt>
                <c:pt idx="1106">
                  <c:v>2782.8111319999998</c:v>
                </c:pt>
                <c:pt idx="1107">
                  <c:v>2784.7396220000001</c:v>
                </c:pt>
                <c:pt idx="1108">
                  <c:v>2786.6681119999998</c:v>
                </c:pt>
                <c:pt idx="1109">
                  <c:v>2788.5966020000001</c:v>
                </c:pt>
                <c:pt idx="1110">
                  <c:v>2790.5250919999999</c:v>
                </c:pt>
                <c:pt idx="1111">
                  <c:v>2792.4535820000001</c:v>
                </c:pt>
                <c:pt idx="1112">
                  <c:v>2794.3820719999999</c:v>
                </c:pt>
                <c:pt idx="1113">
                  <c:v>2796.3105620000001</c:v>
                </c:pt>
                <c:pt idx="1114">
                  <c:v>2798.2390519999999</c:v>
                </c:pt>
                <c:pt idx="1115">
                  <c:v>2800.1675420000001</c:v>
                </c:pt>
                <c:pt idx="1116">
                  <c:v>2802.0960319999999</c:v>
                </c:pt>
                <c:pt idx="1117">
                  <c:v>2804.0245220000002</c:v>
                </c:pt>
                <c:pt idx="1118">
                  <c:v>2805.9530119999999</c:v>
                </c:pt>
                <c:pt idx="1119">
                  <c:v>2807.8815020000002</c:v>
                </c:pt>
                <c:pt idx="1120">
                  <c:v>2809.809992</c:v>
                </c:pt>
                <c:pt idx="1121">
                  <c:v>2811.7384820000002</c:v>
                </c:pt>
                <c:pt idx="1122">
                  <c:v>2813.666972</c:v>
                </c:pt>
                <c:pt idx="1123">
                  <c:v>2815.5954620000002</c:v>
                </c:pt>
                <c:pt idx="1124">
                  <c:v>2817.523952</c:v>
                </c:pt>
                <c:pt idx="1125">
                  <c:v>2819.4524419999998</c:v>
                </c:pt>
                <c:pt idx="1126">
                  <c:v>2821.380932</c:v>
                </c:pt>
                <c:pt idx="1127">
                  <c:v>2823.3094219999998</c:v>
                </c:pt>
                <c:pt idx="1128">
                  <c:v>2825.2379129999999</c:v>
                </c:pt>
                <c:pt idx="1129">
                  <c:v>2827.1664030000002</c:v>
                </c:pt>
                <c:pt idx="1130">
                  <c:v>2829.094893</c:v>
                </c:pt>
                <c:pt idx="1131">
                  <c:v>2831.0233830000002</c:v>
                </c:pt>
                <c:pt idx="1132">
                  <c:v>2832.951873</c:v>
                </c:pt>
                <c:pt idx="1133">
                  <c:v>2834.8803630000002</c:v>
                </c:pt>
                <c:pt idx="1134">
                  <c:v>2836.808853</c:v>
                </c:pt>
                <c:pt idx="1135">
                  <c:v>2838.7373429999998</c:v>
                </c:pt>
                <c:pt idx="1136">
                  <c:v>2840.665833</c:v>
                </c:pt>
                <c:pt idx="1137">
                  <c:v>2842.5943229999998</c:v>
                </c:pt>
                <c:pt idx="1138">
                  <c:v>2844.522813</c:v>
                </c:pt>
                <c:pt idx="1139">
                  <c:v>2846.4513029999998</c:v>
                </c:pt>
                <c:pt idx="1140">
                  <c:v>2848.3797930000001</c:v>
                </c:pt>
                <c:pt idx="1141">
                  <c:v>2850.3082829999998</c:v>
                </c:pt>
                <c:pt idx="1142">
                  <c:v>2852.2367730000001</c:v>
                </c:pt>
                <c:pt idx="1143">
                  <c:v>2854.1652629999999</c:v>
                </c:pt>
                <c:pt idx="1144">
                  <c:v>2856.0937530000001</c:v>
                </c:pt>
                <c:pt idx="1145">
                  <c:v>2858.0222429999999</c:v>
                </c:pt>
                <c:pt idx="1146">
                  <c:v>2859.9507330000001</c:v>
                </c:pt>
                <c:pt idx="1147">
                  <c:v>2861.8792229999999</c:v>
                </c:pt>
                <c:pt idx="1148">
                  <c:v>2863.8077130000001</c:v>
                </c:pt>
                <c:pt idx="1149">
                  <c:v>2865.7362029999999</c:v>
                </c:pt>
                <c:pt idx="1150">
                  <c:v>2867.6646930000002</c:v>
                </c:pt>
                <c:pt idx="1151">
                  <c:v>2869.5931839999998</c:v>
                </c:pt>
                <c:pt idx="1152">
                  <c:v>2871.5216740000001</c:v>
                </c:pt>
                <c:pt idx="1153">
                  <c:v>2873.4501639999999</c:v>
                </c:pt>
                <c:pt idx="1154">
                  <c:v>2875.3786540000001</c:v>
                </c:pt>
                <c:pt idx="1155">
                  <c:v>2877.3071439999999</c:v>
                </c:pt>
                <c:pt idx="1156">
                  <c:v>2879.2356340000001</c:v>
                </c:pt>
                <c:pt idx="1157">
                  <c:v>2881.1641239999999</c:v>
                </c:pt>
                <c:pt idx="1158">
                  <c:v>2883.0926140000001</c:v>
                </c:pt>
                <c:pt idx="1159">
                  <c:v>2885.0211039999999</c:v>
                </c:pt>
                <c:pt idx="1160">
                  <c:v>2886.9495940000002</c:v>
                </c:pt>
                <c:pt idx="1161">
                  <c:v>2888.8780839999999</c:v>
                </c:pt>
                <c:pt idx="1162">
                  <c:v>2890.8065740000002</c:v>
                </c:pt>
                <c:pt idx="1163">
                  <c:v>2892.735064</c:v>
                </c:pt>
                <c:pt idx="1164">
                  <c:v>2894.6635540000002</c:v>
                </c:pt>
                <c:pt idx="1165">
                  <c:v>2896.592044</c:v>
                </c:pt>
                <c:pt idx="1166">
                  <c:v>2898.5205340000002</c:v>
                </c:pt>
                <c:pt idx="1167">
                  <c:v>2900.449024</c:v>
                </c:pt>
                <c:pt idx="1168">
                  <c:v>2902.3775139999998</c:v>
                </c:pt>
                <c:pt idx="1169">
                  <c:v>2904.306004</c:v>
                </c:pt>
                <c:pt idx="1170">
                  <c:v>2906.2344939999998</c:v>
                </c:pt>
                <c:pt idx="1171">
                  <c:v>2908.1629840000001</c:v>
                </c:pt>
                <c:pt idx="1172">
                  <c:v>2910.0914739999998</c:v>
                </c:pt>
                <c:pt idx="1173">
                  <c:v>2912.0199640000001</c:v>
                </c:pt>
                <c:pt idx="1174">
                  <c:v>2913.9484539999999</c:v>
                </c:pt>
                <c:pt idx="1175">
                  <c:v>2915.876945</c:v>
                </c:pt>
                <c:pt idx="1176">
                  <c:v>2917.8054350000002</c:v>
                </c:pt>
                <c:pt idx="1177">
                  <c:v>2919.733925</c:v>
                </c:pt>
                <c:pt idx="1178">
                  <c:v>2921.6624149999998</c:v>
                </c:pt>
                <c:pt idx="1179">
                  <c:v>2923.590905</c:v>
                </c:pt>
                <c:pt idx="1180">
                  <c:v>2925.5193949999998</c:v>
                </c:pt>
                <c:pt idx="1181">
                  <c:v>2927.447885</c:v>
                </c:pt>
                <c:pt idx="1182">
                  <c:v>2929.3763749999998</c:v>
                </c:pt>
                <c:pt idx="1183">
                  <c:v>2931.3048650000001</c:v>
                </c:pt>
                <c:pt idx="1184">
                  <c:v>2933.2333549999998</c:v>
                </c:pt>
                <c:pt idx="1185">
                  <c:v>2935.1618450000001</c:v>
                </c:pt>
                <c:pt idx="1186">
                  <c:v>2937.0903349999999</c:v>
                </c:pt>
                <c:pt idx="1187">
                  <c:v>2939.0188250000001</c:v>
                </c:pt>
                <c:pt idx="1188">
                  <c:v>2940.9473149999999</c:v>
                </c:pt>
                <c:pt idx="1189">
                  <c:v>2942.8758050000001</c:v>
                </c:pt>
                <c:pt idx="1190">
                  <c:v>2944.8042949999999</c:v>
                </c:pt>
                <c:pt idx="1191">
                  <c:v>2946.7327850000001</c:v>
                </c:pt>
                <c:pt idx="1192">
                  <c:v>2948.6612749999999</c:v>
                </c:pt>
                <c:pt idx="1193">
                  <c:v>2950.5897650000002</c:v>
                </c:pt>
                <c:pt idx="1194">
                  <c:v>2952.518255</c:v>
                </c:pt>
                <c:pt idx="1195">
                  <c:v>2954.4467450000002</c:v>
                </c:pt>
                <c:pt idx="1196">
                  <c:v>2956.375235</c:v>
                </c:pt>
                <c:pt idx="1197">
                  <c:v>2958.3037250000002</c:v>
                </c:pt>
                <c:pt idx="1198">
                  <c:v>2960.2322159999999</c:v>
                </c:pt>
                <c:pt idx="1199">
                  <c:v>2962.1607060000001</c:v>
                </c:pt>
                <c:pt idx="1200">
                  <c:v>2964.0891959999999</c:v>
                </c:pt>
                <c:pt idx="1201">
                  <c:v>2966.0176860000001</c:v>
                </c:pt>
                <c:pt idx="1202">
                  <c:v>2967.9461759999999</c:v>
                </c:pt>
                <c:pt idx="1203">
                  <c:v>2969.8746660000002</c:v>
                </c:pt>
                <c:pt idx="1204">
                  <c:v>2971.8031559999999</c:v>
                </c:pt>
                <c:pt idx="1205">
                  <c:v>2973.7316460000002</c:v>
                </c:pt>
                <c:pt idx="1206">
                  <c:v>2975.660136</c:v>
                </c:pt>
                <c:pt idx="1207">
                  <c:v>2977.5886260000002</c:v>
                </c:pt>
                <c:pt idx="1208">
                  <c:v>2979.517116</c:v>
                </c:pt>
                <c:pt idx="1209">
                  <c:v>2981.4456060000002</c:v>
                </c:pt>
                <c:pt idx="1210">
                  <c:v>2983.374096</c:v>
                </c:pt>
                <c:pt idx="1211">
                  <c:v>2985.3025859999998</c:v>
                </c:pt>
                <c:pt idx="1212">
                  <c:v>2987.231076</c:v>
                </c:pt>
                <c:pt idx="1213">
                  <c:v>2989.1595659999998</c:v>
                </c:pt>
                <c:pt idx="1214">
                  <c:v>2991.0880560000001</c:v>
                </c:pt>
                <c:pt idx="1215">
                  <c:v>2993.0165459999998</c:v>
                </c:pt>
                <c:pt idx="1216">
                  <c:v>2994.9450360000001</c:v>
                </c:pt>
                <c:pt idx="1217">
                  <c:v>2996.8735259999999</c:v>
                </c:pt>
                <c:pt idx="1218">
                  <c:v>2998.8020160000001</c:v>
                </c:pt>
                <c:pt idx="1219">
                  <c:v>3000.7305059999999</c:v>
                </c:pt>
                <c:pt idx="1220">
                  <c:v>3002.6589960000001</c:v>
                </c:pt>
                <c:pt idx="1221">
                  <c:v>3004.5874869999998</c:v>
                </c:pt>
                <c:pt idx="1222">
                  <c:v>3006.515977</c:v>
                </c:pt>
                <c:pt idx="1223">
                  <c:v>3008.4444669999998</c:v>
                </c:pt>
                <c:pt idx="1224">
                  <c:v>3010.372957</c:v>
                </c:pt>
                <c:pt idx="1225">
                  <c:v>3012.3014469999998</c:v>
                </c:pt>
                <c:pt idx="1226">
                  <c:v>3014.2299370000001</c:v>
                </c:pt>
                <c:pt idx="1227">
                  <c:v>3016.1584269999998</c:v>
                </c:pt>
                <c:pt idx="1228">
                  <c:v>3018.0869170000001</c:v>
                </c:pt>
                <c:pt idx="1229">
                  <c:v>3020.0154069999999</c:v>
                </c:pt>
                <c:pt idx="1230">
                  <c:v>3021.9438970000001</c:v>
                </c:pt>
                <c:pt idx="1231">
                  <c:v>3023.8723869999999</c:v>
                </c:pt>
                <c:pt idx="1232">
                  <c:v>3025.8008770000001</c:v>
                </c:pt>
                <c:pt idx="1233">
                  <c:v>3027.7293669999999</c:v>
                </c:pt>
                <c:pt idx="1234">
                  <c:v>3029.6578570000001</c:v>
                </c:pt>
                <c:pt idx="1235">
                  <c:v>3031.5863469999999</c:v>
                </c:pt>
                <c:pt idx="1236">
                  <c:v>3033.5148370000002</c:v>
                </c:pt>
                <c:pt idx="1237">
                  <c:v>3035.443327</c:v>
                </c:pt>
                <c:pt idx="1238">
                  <c:v>3037.3718170000002</c:v>
                </c:pt>
                <c:pt idx="1239">
                  <c:v>3039.300307</c:v>
                </c:pt>
                <c:pt idx="1240">
                  <c:v>3041.2287970000002</c:v>
                </c:pt>
                <c:pt idx="1241">
                  <c:v>3043.157287</c:v>
                </c:pt>
                <c:pt idx="1242">
                  <c:v>3045.0857769999998</c:v>
                </c:pt>
                <c:pt idx="1243">
                  <c:v>3047.014267</c:v>
                </c:pt>
                <c:pt idx="1244">
                  <c:v>3048.9427569999998</c:v>
                </c:pt>
                <c:pt idx="1245">
                  <c:v>3050.8712479999999</c:v>
                </c:pt>
                <c:pt idx="1246">
                  <c:v>3052.7997380000002</c:v>
                </c:pt>
                <c:pt idx="1247">
                  <c:v>3054.728227999999</c:v>
                </c:pt>
                <c:pt idx="1248">
                  <c:v>3056.6567180000002</c:v>
                </c:pt>
                <c:pt idx="1249">
                  <c:v>3058.585208</c:v>
                </c:pt>
                <c:pt idx="1250">
                  <c:v>3060.5136980000002</c:v>
                </c:pt>
                <c:pt idx="1251">
                  <c:v>3062.442188</c:v>
                </c:pt>
                <c:pt idx="1252">
                  <c:v>3064.3706780000002</c:v>
                </c:pt>
                <c:pt idx="1253">
                  <c:v>3066.299168</c:v>
                </c:pt>
                <c:pt idx="1254">
                  <c:v>3068.2276579999998</c:v>
                </c:pt>
                <c:pt idx="1255">
                  <c:v>3070.156148</c:v>
                </c:pt>
                <c:pt idx="1256">
                  <c:v>3072.0846379999998</c:v>
                </c:pt>
                <c:pt idx="1257">
                  <c:v>3074.0131280000001</c:v>
                </c:pt>
                <c:pt idx="1258">
                  <c:v>3075.9416179999998</c:v>
                </c:pt>
                <c:pt idx="1259">
                  <c:v>3077.8701080000001</c:v>
                </c:pt>
                <c:pt idx="1260">
                  <c:v>3079.7985979999999</c:v>
                </c:pt>
                <c:pt idx="1261">
                  <c:v>3081.7270880000001</c:v>
                </c:pt>
                <c:pt idx="1262">
                  <c:v>3083.6555779999999</c:v>
                </c:pt>
                <c:pt idx="1263">
                  <c:v>3085.5840680000001</c:v>
                </c:pt>
                <c:pt idx="1264">
                  <c:v>3087.5125579999999</c:v>
                </c:pt>
                <c:pt idx="1265">
                  <c:v>3089.4410480000001</c:v>
                </c:pt>
                <c:pt idx="1266">
                  <c:v>3091.3695379999999</c:v>
                </c:pt>
                <c:pt idx="1267">
                  <c:v>3093.2980280000002</c:v>
                </c:pt>
                <c:pt idx="1268">
                  <c:v>3095.2265189999998</c:v>
                </c:pt>
                <c:pt idx="1269">
                  <c:v>3097.1550090000001</c:v>
                </c:pt>
                <c:pt idx="1270">
                  <c:v>3099.0834989999998</c:v>
                </c:pt>
                <c:pt idx="1271">
                  <c:v>3101.0119890000001</c:v>
                </c:pt>
                <c:pt idx="1272">
                  <c:v>3102.9404789999999</c:v>
                </c:pt>
                <c:pt idx="1273">
                  <c:v>3104.8689690000001</c:v>
                </c:pt>
                <c:pt idx="1274">
                  <c:v>3106.7974589999999</c:v>
                </c:pt>
                <c:pt idx="1275">
                  <c:v>3108.7259490000001</c:v>
                </c:pt>
                <c:pt idx="1276">
                  <c:v>3110.6544389999999</c:v>
                </c:pt>
                <c:pt idx="1277">
                  <c:v>3112.5829290000001</c:v>
                </c:pt>
                <c:pt idx="1278">
                  <c:v>3114.5114189999999</c:v>
                </c:pt>
                <c:pt idx="1279">
                  <c:v>3116.4399090000002</c:v>
                </c:pt>
                <c:pt idx="1280">
                  <c:v>3118.368399</c:v>
                </c:pt>
                <c:pt idx="1281">
                  <c:v>3120.2968889999952</c:v>
                </c:pt>
                <c:pt idx="1282">
                  <c:v>3122.225379</c:v>
                </c:pt>
                <c:pt idx="1283">
                  <c:v>3124.1538690000002</c:v>
                </c:pt>
                <c:pt idx="1284">
                  <c:v>3126.082359</c:v>
                </c:pt>
                <c:pt idx="1285">
                  <c:v>3128.0108489999998</c:v>
                </c:pt>
                <c:pt idx="1286">
                  <c:v>3129.939339</c:v>
                </c:pt>
                <c:pt idx="1287">
                  <c:v>3131.8678289999998</c:v>
                </c:pt>
                <c:pt idx="1288">
                  <c:v>3133.796319</c:v>
                </c:pt>
                <c:pt idx="1289">
                  <c:v>3135.724808999998</c:v>
                </c:pt>
                <c:pt idx="1290">
                  <c:v>3137.6532990000001</c:v>
                </c:pt>
                <c:pt idx="1291">
                  <c:v>3139.5817889999998</c:v>
                </c:pt>
                <c:pt idx="1292">
                  <c:v>3141.51028</c:v>
                </c:pt>
                <c:pt idx="1293">
                  <c:v>3143.4387700000002</c:v>
                </c:pt>
                <c:pt idx="1294">
                  <c:v>3145.36726</c:v>
                </c:pt>
                <c:pt idx="1295">
                  <c:v>3147.2957500000002</c:v>
                </c:pt>
                <c:pt idx="1296">
                  <c:v>3149.22424</c:v>
                </c:pt>
                <c:pt idx="1297">
                  <c:v>3151.1527299999998</c:v>
                </c:pt>
                <c:pt idx="1298">
                  <c:v>3153.08122</c:v>
                </c:pt>
                <c:pt idx="1299">
                  <c:v>3155.0097099999998</c:v>
                </c:pt>
                <c:pt idx="1300">
                  <c:v>3156.9382000000001</c:v>
                </c:pt>
                <c:pt idx="1301">
                  <c:v>3158.866689999998</c:v>
                </c:pt>
                <c:pt idx="1302">
                  <c:v>3160.7951800000001</c:v>
                </c:pt>
                <c:pt idx="1303">
                  <c:v>3162.723669999998</c:v>
                </c:pt>
                <c:pt idx="1304">
                  <c:v>3164.6521600000001</c:v>
                </c:pt>
                <c:pt idx="1305">
                  <c:v>3166.580649999999</c:v>
                </c:pt>
                <c:pt idx="1306">
                  <c:v>3168.5091400000001</c:v>
                </c:pt>
                <c:pt idx="1307">
                  <c:v>3170.4376299999999</c:v>
                </c:pt>
                <c:pt idx="1308">
                  <c:v>3172.3661200000001</c:v>
                </c:pt>
                <c:pt idx="1309">
                  <c:v>3174.294609999999</c:v>
                </c:pt>
                <c:pt idx="1310">
                  <c:v>3176.2231000000002</c:v>
                </c:pt>
                <c:pt idx="1311">
                  <c:v>3178.1515899999999</c:v>
                </c:pt>
                <c:pt idx="1312">
                  <c:v>3180.0800800000002</c:v>
                </c:pt>
                <c:pt idx="1313">
                  <c:v>3182.00857</c:v>
                </c:pt>
                <c:pt idx="1314">
                  <c:v>3183.9370600000002</c:v>
                </c:pt>
                <c:pt idx="1315">
                  <c:v>3185.8655509999999</c:v>
                </c:pt>
                <c:pt idx="1316">
                  <c:v>3187.7940410000001</c:v>
                </c:pt>
                <c:pt idx="1317">
                  <c:v>3189.7225309999999</c:v>
                </c:pt>
                <c:pt idx="1318">
                  <c:v>3191.6510210000001</c:v>
                </c:pt>
                <c:pt idx="1319">
                  <c:v>3193.5795109999999</c:v>
                </c:pt>
                <c:pt idx="1320">
                  <c:v>3195.5080010000001</c:v>
                </c:pt>
                <c:pt idx="1321">
                  <c:v>3197.4364909999999</c:v>
                </c:pt>
                <c:pt idx="1322">
                  <c:v>3199.3649810000002</c:v>
                </c:pt>
                <c:pt idx="1323">
                  <c:v>3201.293471</c:v>
                </c:pt>
                <c:pt idx="1324">
                  <c:v>3203.2219610000002</c:v>
                </c:pt>
                <c:pt idx="1325">
                  <c:v>3205.150451</c:v>
                </c:pt>
                <c:pt idx="1326">
                  <c:v>3207.0789410000002</c:v>
                </c:pt>
                <c:pt idx="1327">
                  <c:v>3209.007431</c:v>
                </c:pt>
                <c:pt idx="1328">
                  <c:v>3210.9359209999998</c:v>
                </c:pt>
                <c:pt idx="1329">
                  <c:v>3212.864411</c:v>
                </c:pt>
                <c:pt idx="1330">
                  <c:v>3214.7929009999998</c:v>
                </c:pt>
                <c:pt idx="1331">
                  <c:v>3216.721391</c:v>
                </c:pt>
                <c:pt idx="1332">
                  <c:v>3218.649880999998</c:v>
                </c:pt>
                <c:pt idx="1333">
                  <c:v>3220.5783710000001</c:v>
                </c:pt>
                <c:pt idx="1334">
                  <c:v>3222.506860999998</c:v>
                </c:pt>
                <c:pt idx="1335">
                  <c:v>3224.4353510000001</c:v>
                </c:pt>
                <c:pt idx="1336">
                  <c:v>3226.3638409999999</c:v>
                </c:pt>
                <c:pt idx="1337">
                  <c:v>3228.2923310000001</c:v>
                </c:pt>
                <c:pt idx="1338">
                  <c:v>3230.220820999999</c:v>
                </c:pt>
                <c:pt idx="1339">
                  <c:v>3232.149312</c:v>
                </c:pt>
                <c:pt idx="1340">
                  <c:v>3234.0778019999998</c:v>
                </c:pt>
                <c:pt idx="1341">
                  <c:v>3236.006292</c:v>
                </c:pt>
                <c:pt idx="1342">
                  <c:v>3237.9347819999998</c:v>
                </c:pt>
                <c:pt idx="1343">
                  <c:v>3239.8632720000001</c:v>
                </c:pt>
                <c:pt idx="1344">
                  <c:v>3241.7917619999998</c:v>
                </c:pt>
                <c:pt idx="1345">
                  <c:v>3243.7202520000001</c:v>
                </c:pt>
                <c:pt idx="1346">
                  <c:v>3245.648741999998</c:v>
                </c:pt>
                <c:pt idx="1347">
                  <c:v>3247.5772320000001</c:v>
                </c:pt>
                <c:pt idx="1348">
                  <c:v>3249.5057219999999</c:v>
                </c:pt>
                <c:pt idx="1349">
                  <c:v>3251.4342120000001</c:v>
                </c:pt>
                <c:pt idx="1350">
                  <c:v>3253.3627019999999</c:v>
                </c:pt>
                <c:pt idx="1351">
                  <c:v>3255.2911920000001</c:v>
                </c:pt>
                <c:pt idx="1352">
                  <c:v>3257.219681999999</c:v>
                </c:pt>
                <c:pt idx="1353">
                  <c:v>3259.1481720000002</c:v>
                </c:pt>
                <c:pt idx="1354">
                  <c:v>3261.076661999999</c:v>
                </c:pt>
                <c:pt idx="1355">
                  <c:v>3263.0051520000002</c:v>
                </c:pt>
                <c:pt idx="1356">
                  <c:v>3264.933642</c:v>
                </c:pt>
                <c:pt idx="1357">
                  <c:v>3266.8621320000002</c:v>
                </c:pt>
                <c:pt idx="1358">
                  <c:v>3268.790622</c:v>
                </c:pt>
                <c:pt idx="1359">
                  <c:v>3270.7191120000002</c:v>
                </c:pt>
                <c:pt idx="1360">
                  <c:v>3272.647602</c:v>
                </c:pt>
                <c:pt idx="1361">
                  <c:v>3274.5760919999998</c:v>
                </c:pt>
                <c:pt idx="1362">
                  <c:v>3276.5045829999999</c:v>
                </c:pt>
                <c:pt idx="1363">
                  <c:v>3278.4330730000001</c:v>
                </c:pt>
                <c:pt idx="1364">
                  <c:v>3280.3615629999999</c:v>
                </c:pt>
                <c:pt idx="1365">
                  <c:v>3282.2900530000002</c:v>
                </c:pt>
                <c:pt idx="1366">
                  <c:v>3284.218543</c:v>
                </c:pt>
                <c:pt idx="1367">
                  <c:v>3286.1470330000002</c:v>
                </c:pt>
                <c:pt idx="1368">
                  <c:v>3288.075523</c:v>
                </c:pt>
                <c:pt idx="1369">
                  <c:v>3290.0040130000002</c:v>
                </c:pt>
                <c:pt idx="1370">
                  <c:v>3291.932503</c:v>
                </c:pt>
                <c:pt idx="1371">
                  <c:v>3293.8609929999998</c:v>
                </c:pt>
                <c:pt idx="1372">
                  <c:v>3295.789483</c:v>
                </c:pt>
                <c:pt idx="1373">
                  <c:v>3297.7179729999998</c:v>
                </c:pt>
                <c:pt idx="1374">
                  <c:v>3299.646463</c:v>
                </c:pt>
                <c:pt idx="1375">
                  <c:v>3301.5749529999998</c:v>
                </c:pt>
                <c:pt idx="1376">
                  <c:v>3303.5034430000001</c:v>
                </c:pt>
                <c:pt idx="1377">
                  <c:v>3305.4319329999998</c:v>
                </c:pt>
                <c:pt idx="1378">
                  <c:v>3307.3604230000001</c:v>
                </c:pt>
                <c:pt idx="1379">
                  <c:v>3309.2889129999999</c:v>
                </c:pt>
                <c:pt idx="1380">
                  <c:v>3311.2174030000001</c:v>
                </c:pt>
                <c:pt idx="1381">
                  <c:v>3313.1458929999999</c:v>
                </c:pt>
                <c:pt idx="1382">
                  <c:v>3315.0743830000001</c:v>
                </c:pt>
                <c:pt idx="1383">
                  <c:v>3317.0028729999999</c:v>
                </c:pt>
                <c:pt idx="1384">
                  <c:v>3318.9313630000001</c:v>
                </c:pt>
                <c:pt idx="1385">
                  <c:v>3320.8598539999998</c:v>
                </c:pt>
                <c:pt idx="1386">
                  <c:v>3322.7883440000001</c:v>
                </c:pt>
                <c:pt idx="1387">
                  <c:v>3324.7168339999998</c:v>
                </c:pt>
                <c:pt idx="1388">
                  <c:v>3326.6453240000001</c:v>
                </c:pt>
                <c:pt idx="1389">
                  <c:v>3328.5738139999999</c:v>
                </c:pt>
                <c:pt idx="1390">
                  <c:v>3330.5023040000001</c:v>
                </c:pt>
                <c:pt idx="1391">
                  <c:v>3332.4307939999999</c:v>
                </c:pt>
                <c:pt idx="1392">
                  <c:v>3334.3592840000001</c:v>
                </c:pt>
                <c:pt idx="1393">
                  <c:v>3336.2877739999999</c:v>
                </c:pt>
                <c:pt idx="1394">
                  <c:v>3338.2162640000001</c:v>
                </c:pt>
                <c:pt idx="1395">
                  <c:v>3340.1447539999999</c:v>
                </c:pt>
                <c:pt idx="1396">
                  <c:v>3342.0732440000002</c:v>
                </c:pt>
                <c:pt idx="1397">
                  <c:v>3344.0017339999999</c:v>
                </c:pt>
                <c:pt idx="1398">
                  <c:v>3345.9302240000002</c:v>
                </c:pt>
                <c:pt idx="1399">
                  <c:v>3347.858714</c:v>
                </c:pt>
                <c:pt idx="1400">
                  <c:v>3349.7872040000002</c:v>
                </c:pt>
                <c:pt idx="1401">
                  <c:v>3351.715694</c:v>
                </c:pt>
                <c:pt idx="1402">
                  <c:v>3353.6441840000002</c:v>
                </c:pt>
                <c:pt idx="1403">
                  <c:v>3355.572674</c:v>
                </c:pt>
                <c:pt idx="1404">
                  <c:v>3357.5011639999998</c:v>
                </c:pt>
                <c:pt idx="1405">
                  <c:v>3359.429654</c:v>
                </c:pt>
                <c:pt idx="1406">
                  <c:v>3361.3581439999998</c:v>
                </c:pt>
                <c:pt idx="1407">
                  <c:v>3363.286634</c:v>
                </c:pt>
                <c:pt idx="1408">
                  <c:v>3365.2151239999998</c:v>
                </c:pt>
                <c:pt idx="1409">
                  <c:v>3367.143615</c:v>
                </c:pt>
                <c:pt idx="1410">
                  <c:v>3369.0721050000002</c:v>
                </c:pt>
                <c:pt idx="1411">
                  <c:v>3371.000595</c:v>
                </c:pt>
                <c:pt idx="1412">
                  <c:v>3372.9290850000002</c:v>
                </c:pt>
                <c:pt idx="1413">
                  <c:v>3374.857575</c:v>
                </c:pt>
                <c:pt idx="1414">
                  <c:v>3376.786064999998</c:v>
                </c:pt>
                <c:pt idx="1415">
                  <c:v>3378.714555</c:v>
                </c:pt>
                <c:pt idx="1416">
                  <c:v>3380.6430449999998</c:v>
                </c:pt>
                <c:pt idx="1417">
                  <c:v>3382.571535</c:v>
                </c:pt>
                <c:pt idx="1418">
                  <c:v>3384.5000249999998</c:v>
                </c:pt>
                <c:pt idx="1419">
                  <c:v>3386.4285150000001</c:v>
                </c:pt>
                <c:pt idx="1420">
                  <c:v>3388.3570049999998</c:v>
                </c:pt>
                <c:pt idx="1421">
                  <c:v>3390.2854950000001</c:v>
                </c:pt>
                <c:pt idx="1422">
                  <c:v>3392.2139849999999</c:v>
                </c:pt>
                <c:pt idx="1423">
                  <c:v>3394.1424750000001</c:v>
                </c:pt>
                <c:pt idx="1424">
                  <c:v>3396.0709649999999</c:v>
                </c:pt>
                <c:pt idx="1425">
                  <c:v>3397.9994550000001</c:v>
                </c:pt>
                <c:pt idx="1426">
                  <c:v>3399.9279449999999</c:v>
                </c:pt>
                <c:pt idx="1427">
                  <c:v>3401.8564350000001</c:v>
                </c:pt>
                <c:pt idx="1428">
                  <c:v>3403.784924999999</c:v>
                </c:pt>
                <c:pt idx="1429">
                  <c:v>3405.7134150000002</c:v>
                </c:pt>
                <c:pt idx="1430">
                  <c:v>3407.641905</c:v>
                </c:pt>
                <c:pt idx="1431">
                  <c:v>3409.5703950000002</c:v>
                </c:pt>
                <c:pt idx="1432">
                  <c:v>3411.498885999998</c:v>
                </c:pt>
                <c:pt idx="1433">
                  <c:v>3413.4273760000001</c:v>
                </c:pt>
                <c:pt idx="1434">
                  <c:v>3415.3558659999999</c:v>
                </c:pt>
                <c:pt idx="1435">
                  <c:v>3417.2843560000001</c:v>
                </c:pt>
                <c:pt idx="1436">
                  <c:v>3419.212845999999</c:v>
                </c:pt>
                <c:pt idx="1437">
                  <c:v>3421.1413360000001</c:v>
                </c:pt>
                <c:pt idx="1438">
                  <c:v>3423.069825999999</c:v>
                </c:pt>
                <c:pt idx="1439">
                  <c:v>3424.9983160000002</c:v>
                </c:pt>
                <c:pt idx="1440">
                  <c:v>3426.926805999999</c:v>
                </c:pt>
                <c:pt idx="1441">
                  <c:v>3428.8552960000002</c:v>
                </c:pt>
                <c:pt idx="1442">
                  <c:v>3430.783786</c:v>
                </c:pt>
                <c:pt idx="1443">
                  <c:v>3432.7122760000002</c:v>
                </c:pt>
                <c:pt idx="1444">
                  <c:v>3434.640766</c:v>
                </c:pt>
                <c:pt idx="1445">
                  <c:v>3436.5692560000002</c:v>
                </c:pt>
                <c:pt idx="1446">
                  <c:v>3438.497746</c:v>
                </c:pt>
                <c:pt idx="1447">
                  <c:v>3440.4262359999998</c:v>
                </c:pt>
                <c:pt idx="1448">
                  <c:v>3442.354726</c:v>
                </c:pt>
                <c:pt idx="1449">
                  <c:v>3444.2832159999998</c:v>
                </c:pt>
                <c:pt idx="1450">
                  <c:v>3446.211706</c:v>
                </c:pt>
                <c:pt idx="1451">
                  <c:v>3448.1401959999998</c:v>
                </c:pt>
                <c:pt idx="1452">
                  <c:v>3450.0686860000001</c:v>
                </c:pt>
                <c:pt idx="1453">
                  <c:v>3451.9971759999999</c:v>
                </c:pt>
                <c:pt idx="1454">
                  <c:v>3453.9256660000001</c:v>
                </c:pt>
                <c:pt idx="1455">
                  <c:v>3455.8541559999999</c:v>
                </c:pt>
                <c:pt idx="1456">
                  <c:v>3457.782647</c:v>
                </c:pt>
                <c:pt idx="1457">
                  <c:v>3459.7111369999998</c:v>
                </c:pt>
                <c:pt idx="1458">
                  <c:v>3461.639627</c:v>
                </c:pt>
                <c:pt idx="1459">
                  <c:v>3463.5681169999998</c:v>
                </c:pt>
                <c:pt idx="1460">
                  <c:v>3465.496607</c:v>
                </c:pt>
                <c:pt idx="1461">
                  <c:v>3467.4250969999998</c:v>
                </c:pt>
                <c:pt idx="1462">
                  <c:v>3469.3535870000001</c:v>
                </c:pt>
                <c:pt idx="1463">
                  <c:v>3471.2820769999998</c:v>
                </c:pt>
                <c:pt idx="1464">
                  <c:v>3473.2105670000001</c:v>
                </c:pt>
                <c:pt idx="1465">
                  <c:v>3475.1390569999999</c:v>
                </c:pt>
                <c:pt idx="1466">
                  <c:v>3477.0675470000001</c:v>
                </c:pt>
                <c:pt idx="1467">
                  <c:v>3478.9960369999999</c:v>
                </c:pt>
                <c:pt idx="1468">
                  <c:v>3480.9245270000001</c:v>
                </c:pt>
                <c:pt idx="1469">
                  <c:v>3482.8530169999999</c:v>
                </c:pt>
                <c:pt idx="1470">
                  <c:v>3484.7815070000001</c:v>
                </c:pt>
                <c:pt idx="1471">
                  <c:v>3486.7099969999999</c:v>
                </c:pt>
                <c:pt idx="1472">
                  <c:v>3488.6384870000002</c:v>
                </c:pt>
                <c:pt idx="1473">
                  <c:v>3490.566977</c:v>
                </c:pt>
                <c:pt idx="1474">
                  <c:v>3492.4954670000002</c:v>
                </c:pt>
                <c:pt idx="1475">
                  <c:v>3494.423957</c:v>
                </c:pt>
                <c:pt idx="1476">
                  <c:v>3496.3524470000002</c:v>
                </c:pt>
                <c:pt idx="1477">
                  <c:v>3498.280937</c:v>
                </c:pt>
                <c:pt idx="1478">
                  <c:v>3500.2094269999998</c:v>
                </c:pt>
                <c:pt idx="1479">
                  <c:v>3502.1379179999999</c:v>
                </c:pt>
                <c:pt idx="1480">
                  <c:v>3504.0664080000001</c:v>
                </c:pt>
                <c:pt idx="1481">
                  <c:v>3505.9948979999999</c:v>
                </c:pt>
                <c:pt idx="1482">
                  <c:v>3507.9233880000002</c:v>
                </c:pt>
                <c:pt idx="1483">
                  <c:v>3509.8518779999999</c:v>
                </c:pt>
                <c:pt idx="1484">
                  <c:v>3511.7803680000002</c:v>
                </c:pt>
                <c:pt idx="1485">
                  <c:v>3513.708858</c:v>
                </c:pt>
                <c:pt idx="1486">
                  <c:v>3515.6373480000002</c:v>
                </c:pt>
                <c:pt idx="1487">
                  <c:v>3517.565838</c:v>
                </c:pt>
                <c:pt idx="1488">
                  <c:v>3519.4943280000002</c:v>
                </c:pt>
                <c:pt idx="1489">
                  <c:v>3521.422818</c:v>
                </c:pt>
                <c:pt idx="1490">
                  <c:v>3523.3513079999998</c:v>
                </c:pt>
                <c:pt idx="1491">
                  <c:v>3525.279798</c:v>
                </c:pt>
                <c:pt idx="1492">
                  <c:v>3527.208287999998</c:v>
                </c:pt>
                <c:pt idx="1493">
                  <c:v>3529.136778</c:v>
                </c:pt>
                <c:pt idx="1494">
                  <c:v>3531.0652679999998</c:v>
                </c:pt>
                <c:pt idx="1495">
                  <c:v>3532.9937580000001</c:v>
                </c:pt>
                <c:pt idx="1496">
                  <c:v>3534.9222479999999</c:v>
                </c:pt>
                <c:pt idx="1497">
                  <c:v>3536.8507380000001</c:v>
                </c:pt>
                <c:pt idx="1498">
                  <c:v>3538.7792279999999</c:v>
                </c:pt>
                <c:pt idx="1499">
                  <c:v>3540.7077180000001</c:v>
                </c:pt>
                <c:pt idx="1500">
                  <c:v>3542.6362079999999</c:v>
                </c:pt>
                <c:pt idx="1501">
                  <c:v>3544.5646980000001</c:v>
                </c:pt>
                <c:pt idx="1502">
                  <c:v>3546.4931889999998</c:v>
                </c:pt>
                <c:pt idx="1503">
                  <c:v>3548.421679</c:v>
                </c:pt>
                <c:pt idx="1504">
                  <c:v>3550.3501689999998</c:v>
                </c:pt>
                <c:pt idx="1505">
                  <c:v>3552.2786590000001</c:v>
                </c:pt>
                <c:pt idx="1506">
                  <c:v>3554.2071489999998</c:v>
                </c:pt>
                <c:pt idx="1507">
                  <c:v>3556.1356390000001</c:v>
                </c:pt>
                <c:pt idx="1508">
                  <c:v>3558.0641289999999</c:v>
                </c:pt>
                <c:pt idx="1509">
                  <c:v>3559.9926190000001</c:v>
                </c:pt>
                <c:pt idx="1510">
                  <c:v>3561.9211089999999</c:v>
                </c:pt>
                <c:pt idx="1511">
                  <c:v>3563.8495990000001</c:v>
                </c:pt>
                <c:pt idx="1512">
                  <c:v>3565.778088999999</c:v>
                </c:pt>
                <c:pt idx="1513">
                  <c:v>3567.7065790000001</c:v>
                </c:pt>
                <c:pt idx="1514">
                  <c:v>3569.6350689999999</c:v>
                </c:pt>
                <c:pt idx="1515">
                  <c:v>3571.5635590000002</c:v>
                </c:pt>
                <c:pt idx="1516">
                  <c:v>3573.492049</c:v>
                </c:pt>
                <c:pt idx="1517">
                  <c:v>3575.4205390000002</c:v>
                </c:pt>
                <c:pt idx="1518">
                  <c:v>3577.349029</c:v>
                </c:pt>
                <c:pt idx="1519">
                  <c:v>3579.2775190000002</c:v>
                </c:pt>
                <c:pt idx="1520">
                  <c:v>3581.206009</c:v>
                </c:pt>
                <c:pt idx="1521">
                  <c:v>3583.1344989999998</c:v>
                </c:pt>
                <c:pt idx="1522">
                  <c:v>3585.062989</c:v>
                </c:pt>
                <c:pt idx="1523">
                  <c:v>3586.9914789999998</c:v>
                </c:pt>
                <c:pt idx="1524">
                  <c:v>3588.919969</c:v>
                </c:pt>
                <c:pt idx="1525">
                  <c:v>3590.8484589999998</c:v>
                </c:pt>
                <c:pt idx="1526">
                  <c:v>3592.776949999999</c:v>
                </c:pt>
                <c:pt idx="1527">
                  <c:v>3594.7054400000002</c:v>
                </c:pt>
                <c:pt idx="1528">
                  <c:v>3596.63393</c:v>
                </c:pt>
                <c:pt idx="1529">
                  <c:v>3598.5624200000002</c:v>
                </c:pt>
                <c:pt idx="1530">
                  <c:v>3600.49091</c:v>
                </c:pt>
                <c:pt idx="1531">
                  <c:v>3602.4194000000002</c:v>
                </c:pt>
                <c:pt idx="1532">
                  <c:v>3604.34789</c:v>
                </c:pt>
                <c:pt idx="1533">
                  <c:v>3606.2763799999998</c:v>
                </c:pt>
                <c:pt idx="1534">
                  <c:v>3608.20487</c:v>
                </c:pt>
                <c:pt idx="1535">
                  <c:v>3610.1333599999998</c:v>
                </c:pt>
                <c:pt idx="1536">
                  <c:v>3612.06185</c:v>
                </c:pt>
                <c:pt idx="1537">
                  <c:v>3613.9903399999998</c:v>
                </c:pt>
                <c:pt idx="1538">
                  <c:v>3615.9188300000001</c:v>
                </c:pt>
                <c:pt idx="1539">
                  <c:v>3617.8473199999999</c:v>
                </c:pt>
                <c:pt idx="1540">
                  <c:v>3619.7758100000001</c:v>
                </c:pt>
                <c:pt idx="1541">
                  <c:v>3621.704299999999</c:v>
                </c:pt>
                <c:pt idx="1542">
                  <c:v>3623.6327900000001</c:v>
                </c:pt>
                <c:pt idx="1543">
                  <c:v>3625.5612799999999</c:v>
                </c:pt>
                <c:pt idx="1544">
                  <c:v>3627.4897700000001</c:v>
                </c:pt>
                <c:pt idx="1545">
                  <c:v>3629.4182599999999</c:v>
                </c:pt>
                <c:pt idx="1546">
                  <c:v>3631.3467500000002</c:v>
                </c:pt>
                <c:pt idx="1547">
                  <c:v>3633.2752399999999</c:v>
                </c:pt>
                <c:pt idx="1548">
                  <c:v>3635.2037300000002</c:v>
                </c:pt>
                <c:pt idx="1549">
                  <c:v>3637.1322209999998</c:v>
                </c:pt>
                <c:pt idx="1550">
                  <c:v>3639.0607110000001</c:v>
                </c:pt>
                <c:pt idx="1551">
                  <c:v>3640.9892009999999</c:v>
                </c:pt>
                <c:pt idx="1552">
                  <c:v>3642.9176910000001</c:v>
                </c:pt>
                <c:pt idx="1553">
                  <c:v>3644.8461809999999</c:v>
                </c:pt>
                <c:pt idx="1554">
                  <c:v>3646.7746710000001</c:v>
                </c:pt>
                <c:pt idx="1555">
                  <c:v>3648.7031609999999</c:v>
                </c:pt>
                <c:pt idx="1556">
                  <c:v>3650.6316510000001</c:v>
                </c:pt>
                <c:pt idx="1557">
                  <c:v>3652.5601409999999</c:v>
                </c:pt>
                <c:pt idx="1558">
                  <c:v>3654.4886310000002</c:v>
                </c:pt>
                <c:pt idx="1559">
                  <c:v>3656.417121</c:v>
                </c:pt>
                <c:pt idx="1560">
                  <c:v>3658.3456110000002</c:v>
                </c:pt>
                <c:pt idx="1561">
                  <c:v>3660.274101</c:v>
                </c:pt>
                <c:pt idx="1562">
                  <c:v>3662.2025910000002</c:v>
                </c:pt>
                <c:pt idx="1563">
                  <c:v>3664.131081</c:v>
                </c:pt>
                <c:pt idx="1564">
                  <c:v>3666.0595709999998</c:v>
                </c:pt>
                <c:pt idx="1565">
                  <c:v>3667.988061</c:v>
                </c:pt>
                <c:pt idx="1566">
                  <c:v>3669.9165509999998</c:v>
                </c:pt>
                <c:pt idx="1567">
                  <c:v>3671.845041</c:v>
                </c:pt>
                <c:pt idx="1568">
                  <c:v>3673.7735309999998</c:v>
                </c:pt>
                <c:pt idx="1569">
                  <c:v>3675.7020210000001</c:v>
                </c:pt>
                <c:pt idx="1570">
                  <c:v>3677.6305109999998</c:v>
                </c:pt>
                <c:pt idx="1571">
                  <c:v>3679.5590010000001</c:v>
                </c:pt>
                <c:pt idx="1572">
                  <c:v>3681.4874909999999</c:v>
                </c:pt>
                <c:pt idx="1573">
                  <c:v>3683.415982</c:v>
                </c:pt>
                <c:pt idx="1574">
                  <c:v>3685.3444720000002</c:v>
                </c:pt>
                <c:pt idx="1575">
                  <c:v>3687.272962</c:v>
                </c:pt>
                <c:pt idx="1576">
                  <c:v>3689.2014519999998</c:v>
                </c:pt>
                <c:pt idx="1577">
                  <c:v>3691.129942</c:v>
                </c:pt>
                <c:pt idx="1578">
                  <c:v>3693.0584319999998</c:v>
                </c:pt>
                <c:pt idx="1579">
                  <c:v>3694.986922</c:v>
                </c:pt>
                <c:pt idx="1580">
                  <c:v>3696.9154119999998</c:v>
                </c:pt>
                <c:pt idx="1581">
                  <c:v>3698.8439020000001</c:v>
                </c:pt>
                <c:pt idx="1582">
                  <c:v>3700.7723919999999</c:v>
                </c:pt>
                <c:pt idx="1583">
                  <c:v>3702.7008820000001</c:v>
                </c:pt>
                <c:pt idx="1584">
                  <c:v>3704.6293719999999</c:v>
                </c:pt>
                <c:pt idx="1585">
                  <c:v>3706.5578620000001</c:v>
                </c:pt>
                <c:pt idx="1586">
                  <c:v>3708.4863519999999</c:v>
                </c:pt>
                <c:pt idx="1587">
                  <c:v>3710.4148420000001</c:v>
                </c:pt>
                <c:pt idx="1588">
                  <c:v>3712.3433319999999</c:v>
                </c:pt>
                <c:pt idx="1589">
                  <c:v>3714.2718220000002</c:v>
                </c:pt>
                <c:pt idx="1590">
                  <c:v>3716.2003119999999</c:v>
                </c:pt>
                <c:pt idx="1591">
                  <c:v>3718.1288020000002</c:v>
                </c:pt>
                <c:pt idx="1592">
                  <c:v>3720.057292</c:v>
                </c:pt>
                <c:pt idx="1593">
                  <c:v>3721.9857820000002</c:v>
                </c:pt>
                <c:pt idx="1594">
                  <c:v>3723.914272</c:v>
                </c:pt>
                <c:pt idx="1595">
                  <c:v>3725.8427620000002</c:v>
                </c:pt>
                <c:pt idx="1596">
                  <c:v>3727.7712529999999</c:v>
                </c:pt>
                <c:pt idx="1597">
                  <c:v>3729.6997430000001</c:v>
                </c:pt>
                <c:pt idx="1598">
                  <c:v>3731.6282329999999</c:v>
                </c:pt>
                <c:pt idx="1599">
                  <c:v>3733.5567230000001</c:v>
                </c:pt>
                <c:pt idx="1600">
                  <c:v>3735.4852129999999</c:v>
                </c:pt>
                <c:pt idx="1601">
                  <c:v>3737.4137030000002</c:v>
                </c:pt>
                <c:pt idx="1602">
                  <c:v>3739.342193</c:v>
                </c:pt>
                <c:pt idx="1603">
                  <c:v>3741.2706830000002</c:v>
                </c:pt>
                <c:pt idx="1604">
                  <c:v>3743.199173</c:v>
                </c:pt>
                <c:pt idx="1605">
                  <c:v>3745.1276630000002</c:v>
                </c:pt>
                <c:pt idx="1606">
                  <c:v>3747.056153</c:v>
                </c:pt>
                <c:pt idx="1607">
                  <c:v>3748.9846429999998</c:v>
                </c:pt>
                <c:pt idx="1608">
                  <c:v>3750.913133</c:v>
                </c:pt>
                <c:pt idx="1609">
                  <c:v>3752.8416229999998</c:v>
                </c:pt>
                <c:pt idx="1610">
                  <c:v>3754.770113</c:v>
                </c:pt>
                <c:pt idx="1611">
                  <c:v>3756.6986029999998</c:v>
                </c:pt>
                <c:pt idx="1612">
                  <c:v>3758.6270930000001</c:v>
                </c:pt>
                <c:pt idx="1613">
                  <c:v>3760.5555829999998</c:v>
                </c:pt>
                <c:pt idx="1614">
                  <c:v>3762.4840730000001</c:v>
                </c:pt>
                <c:pt idx="1615">
                  <c:v>3764.4125629999999</c:v>
                </c:pt>
                <c:pt idx="1616">
                  <c:v>3766.3410530000001</c:v>
                </c:pt>
                <c:pt idx="1617">
                  <c:v>3768.2695429999999</c:v>
                </c:pt>
                <c:pt idx="1618">
                  <c:v>3770.1980330000001</c:v>
                </c:pt>
                <c:pt idx="1619">
                  <c:v>3772.1265229999999</c:v>
                </c:pt>
                <c:pt idx="1620">
                  <c:v>3774.055014</c:v>
                </c:pt>
                <c:pt idx="1621">
                  <c:v>3775.9835039999998</c:v>
                </c:pt>
                <c:pt idx="1622">
                  <c:v>3777.911994</c:v>
                </c:pt>
                <c:pt idx="1623">
                  <c:v>3779.8404839999998</c:v>
                </c:pt>
                <c:pt idx="1624">
                  <c:v>3781.7689740000001</c:v>
                </c:pt>
                <c:pt idx="1625">
                  <c:v>3783.6974639999999</c:v>
                </c:pt>
                <c:pt idx="1626">
                  <c:v>3785.6259540000001</c:v>
                </c:pt>
                <c:pt idx="1627">
                  <c:v>3787.5544439999999</c:v>
                </c:pt>
                <c:pt idx="1628">
                  <c:v>3789.4829340000001</c:v>
                </c:pt>
                <c:pt idx="1629">
                  <c:v>3791.4114239999999</c:v>
                </c:pt>
                <c:pt idx="1630">
                  <c:v>3793.3399140000001</c:v>
                </c:pt>
                <c:pt idx="1631">
                  <c:v>3795.268403999999</c:v>
                </c:pt>
                <c:pt idx="1632">
                  <c:v>3797.1968940000002</c:v>
                </c:pt>
                <c:pt idx="1633">
                  <c:v>3799.1253839999999</c:v>
                </c:pt>
                <c:pt idx="1634">
                  <c:v>3801.0538740000002</c:v>
                </c:pt>
                <c:pt idx="1635">
                  <c:v>3802.982364</c:v>
                </c:pt>
                <c:pt idx="1636">
                  <c:v>3804.9108540000002</c:v>
                </c:pt>
                <c:pt idx="1637">
                  <c:v>3806.839344</c:v>
                </c:pt>
                <c:pt idx="1638">
                  <c:v>3808.7678340000002</c:v>
                </c:pt>
                <c:pt idx="1639">
                  <c:v>3810.696324</c:v>
                </c:pt>
                <c:pt idx="1640">
                  <c:v>3812.6248139999998</c:v>
                </c:pt>
                <c:pt idx="1641">
                  <c:v>3814.553304</c:v>
                </c:pt>
                <c:pt idx="1642">
                  <c:v>3816.4817939999998</c:v>
                </c:pt>
                <c:pt idx="1643">
                  <c:v>3818.4102849999999</c:v>
                </c:pt>
                <c:pt idx="1644">
                  <c:v>3820.3387750000002</c:v>
                </c:pt>
                <c:pt idx="1645">
                  <c:v>3822.267264999999</c:v>
                </c:pt>
                <c:pt idx="1646">
                  <c:v>3824.1957550000002</c:v>
                </c:pt>
                <c:pt idx="1647">
                  <c:v>3826.124245</c:v>
                </c:pt>
                <c:pt idx="1648">
                  <c:v>3828.0527350000002</c:v>
                </c:pt>
                <c:pt idx="1649">
                  <c:v>3829.981225</c:v>
                </c:pt>
                <c:pt idx="1650">
                  <c:v>3831.9097149999998</c:v>
                </c:pt>
                <c:pt idx="1651">
                  <c:v>3833.838205</c:v>
                </c:pt>
                <c:pt idx="1652">
                  <c:v>3835.766694999998</c:v>
                </c:pt>
                <c:pt idx="1653">
                  <c:v>3837.695185</c:v>
                </c:pt>
                <c:pt idx="1654">
                  <c:v>3839.6236749999998</c:v>
                </c:pt>
                <c:pt idx="1655">
                  <c:v>3841.5521650000001</c:v>
                </c:pt>
                <c:pt idx="1656">
                  <c:v>3843.4806549999998</c:v>
                </c:pt>
                <c:pt idx="1657">
                  <c:v>3845.4091450000001</c:v>
                </c:pt>
                <c:pt idx="1658">
                  <c:v>3847.3376349999999</c:v>
                </c:pt>
                <c:pt idx="1659">
                  <c:v>3849.2661250000001</c:v>
                </c:pt>
                <c:pt idx="1660">
                  <c:v>3851.1946149999999</c:v>
                </c:pt>
                <c:pt idx="1661">
                  <c:v>3853.1231050000001</c:v>
                </c:pt>
                <c:pt idx="1662">
                  <c:v>3855.0515949999999</c:v>
                </c:pt>
                <c:pt idx="1663">
                  <c:v>3856.9800850000001</c:v>
                </c:pt>
                <c:pt idx="1664">
                  <c:v>3858.9085749999999</c:v>
                </c:pt>
                <c:pt idx="1665">
                  <c:v>3860.8370650000002</c:v>
                </c:pt>
                <c:pt idx="1666">
                  <c:v>3862.7655559999998</c:v>
                </c:pt>
                <c:pt idx="1667">
                  <c:v>3864.6940460000001</c:v>
                </c:pt>
                <c:pt idx="1668">
                  <c:v>3866.6225359999999</c:v>
                </c:pt>
                <c:pt idx="1669">
                  <c:v>3868.5510260000001</c:v>
                </c:pt>
                <c:pt idx="1670">
                  <c:v>3870.4795159999999</c:v>
                </c:pt>
                <c:pt idx="1671">
                  <c:v>3872.4080060000001</c:v>
                </c:pt>
                <c:pt idx="1672">
                  <c:v>3874.3364959999999</c:v>
                </c:pt>
                <c:pt idx="1673">
                  <c:v>3876.2649860000001</c:v>
                </c:pt>
                <c:pt idx="1674">
                  <c:v>3878.1934759999999</c:v>
                </c:pt>
                <c:pt idx="1675">
                  <c:v>3880.1219660000002</c:v>
                </c:pt>
                <c:pt idx="1676">
                  <c:v>3882.0504559999999</c:v>
                </c:pt>
                <c:pt idx="1677">
                  <c:v>3883.9789460000002</c:v>
                </c:pt>
                <c:pt idx="1678">
                  <c:v>3885.907436</c:v>
                </c:pt>
                <c:pt idx="1679">
                  <c:v>3887.8359260000002</c:v>
                </c:pt>
                <c:pt idx="1680">
                  <c:v>3889.764416</c:v>
                </c:pt>
                <c:pt idx="1681">
                  <c:v>3891.6929060000002</c:v>
                </c:pt>
                <c:pt idx="1682">
                  <c:v>3893.621396</c:v>
                </c:pt>
                <c:pt idx="1683">
                  <c:v>3895.549885999998</c:v>
                </c:pt>
                <c:pt idx="1684">
                  <c:v>3897.478376</c:v>
                </c:pt>
                <c:pt idx="1685">
                  <c:v>3899.406865999998</c:v>
                </c:pt>
                <c:pt idx="1686">
                  <c:v>3901.335356</c:v>
                </c:pt>
                <c:pt idx="1687">
                  <c:v>3903.263845999998</c:v>
                </c:pt>
                <c:pt idx="1688">
                  <c:v>3905.1923360000001</c:v>
                </c:pt>
                <c:pt idx="1689">
                  <c:v>3907.120825999998</c:v>
                </c:pt>
                <c:pt idx="1690">
                  <c:v>3909.049317</c:v>
                </c:pt>
                <c:pt idx="1691">
                  <c:v>3910.9778070000002</c:v>
                </c:pt>
                <c:pt idx="1692">
                  <c:v>3912.906297</c:v>
                </c:pt>
                <c:pt idx="1693">
                  <c:v>3914.8347869999998</c:v>
                </c:pt>
                <c:pt idx="1694">
                  <c:v>3916.763277</c:v>
                </c:pt>
                <c:pt idx="1695">
                  <c:v>3918.6917669999998</c:v>
                </c:pt>
                <c:pt idx="1696">
                  <c:v>3920.620257</c:v>
                </c:pt>
                <c:pt idx="1697">
                  <c:v>3922.5487469999998</c:v>
                </c:pt>
                <c:pt idx="1698">
                  <c:v>3924.4772370000001</c:v>
                </c:pt>
                <c:pt idx="1699">
                  <c:v>3926.4057269999998</c:v>
                </c:pt>
                <c:pt idx="1700">
                  <c:v>3928.3342170000001</c:v>
                </c:pt>
                <c:pt idx="1701">
                  <c:v>3930.2627069999999</c:v>
                </c:pt>
                <c:pt idx="1702">
                  <c:v>3932.1911970000001</c:v>
                </c:pt>
                <c:pt idx="1703">
                  <c:v>3934.1196869999999</c:v>
                </c:pt>
                <c:pt idx="1704">
                  <c:v>3936.0481770000001</c:v>
                </c:pt>
                <c:pt idx="1705">
                  <c:v>3937.9766669999999</c:v>
                </c:pt>
                <c:pt idx="1706">
                  <c:v>3939.9051570000001</c:v>
                </c:pt>
                <c:pt idx="1707">
                  <c:v>3941.8336469999999</c:v>
                </c:pt>
                <c:pt idx="1708">
                  <c:v>3943.7621370000002</c:v>
                </c:pt>
                <c:pt idx="1709">
                  <c:v>3945.6906269999999</c:v>
                </c:pt>
                <c:pt idx="1710">
                  <c:v>3947.6191170000002</c:v>
                </c:pt>
                <c:pt idx="1711">
                  <c:v>3949.547607</c:v>
                </c:pt>
                <c:pt idx="1712">
                  <c:v>3951.4760970000002</c:v>
                </c:pt>
                <c:pt idx="1713">
                  <c:v>3953.4045879999999</c:v>
                </c:pt>
                <c:pt idx="1714">
                  <c:v>3955.3330780000001</c:v>
                </c:pt>
                <c:pt idx="1715">
                  <c:v>3957.2615679999999</c:v>
                </c:pt>
                <c:pt idx="1716">
                  <c:v>3959.1900580000001</c:v>
                </c:pt>
                <c:pt idx="1717">
                  <c:v>3961.1185479999999</c:v>
                </c:pt>
                <c:pt idx="1718">
                  <c:v>3963.0470380000002</c:v>
                </c:pt>
                <c:pt idx="1719">
                  <c:v>3964.9755279999999</c:v>
                </c:pt>
                <c:pt idx="1720">
                  <c:v>3966.9040180000002</c:v>
                </c:pt>
                <c:pt idx="1721">
                  <c:v>3968.832508</c:v>
                </c:pt>
                <c:pt idx="1722">
                  <c:v>3970.7609980000002</c:v>
                </c:pt>
                <c:pt idx="1723">
                  <c:v>3972.689488</c:v>
                </c:pt>
                <c:pt idx="1724">
                  <c:v>3974.6179780000002</c:v>
                </c:pt>
                <c:pt idx="1725">
                  <c:v>3976.546468</c:v>
                </c:pt>
                <c:pt idx="1726">
                  <c:v>3978.4749579999998</c:v>
                </c:pt>
                <c:pt idx="1727">
                  <c:v>3980.403448</c:v>
                </c:pt>
                <c:pt idx="1728">
                  <c:v>3982.3319379999998</c:v>
                </c:pt>
                <c:pt idx="1729">
                  <c:v>3984.260428</c:v>
                </c:pt>
                <c:pt idx="1730">
                  <c:v>3986.1889179999998</c:v>
                </c:pt>
                <c:pt idx="1731">
                  <c:v>3988.1174080000001</c:v>
                </c:pt>
                <c:pt idx="1732">
                  <c:v>3990.0458979999999</c:v>
                </c:pt>
                <c:pt idx="1733">
                  <c:v>3991.9743880000001</c:v>
                </c:pt>
                <c:pt idx="1734">
                  <c:v>3993.9028779999999</c:v>
                </c:pt>
                <c:pt idx="1735">
                  <c:v>3995.8313680000001</c:v>
                </c:pt>
                <c:pt idx="1736">
                  <c:v>3997.7598579999999</c:v>
                </c:pt>
                <c:pt idx="1737">
                  <c:v>3999.688349</c:v>
                </c:pt>
                <c:pt idx="1738">
                  <c:v>4001.6168389999998</c:v>
                </c:pt>
              </c:numCache>
            </c:numRef>
          </c:xVal>
          <c:yVal>
            <c:numRef>
              <c:f>IR!$B$1:$B$1744</c:f>
              <c:numCache>
                <c:formatCode>General</c:formatCode>
                <c:ptCount val="1744"/>
                <c:pt idx="0">
                  <c:v>95.385534999999976</c:v>
                </c:pt>
                <c:pt idx="1">
                  <c:v>95.324851999999979</c:v>
                </c:pt>
                <c:pt idx="2">
                  <c:v>95.255597999999978</c:v>
                </c:pt>
                <c:pt idx="3">
                  <c:v>95.185598999999911</c:v>
                </c:pt>
                <c:pt idx="4">
                  <c:v>95.114068000000003</c:v>
                </c:pt>
                <c:pt idx="5">
                  <c:v>95.037379999999999</c:v>
                </c:pt>
                <c:pt idx="6">
                  <c:v>94.961696000000003</c:v>
                </c:pt>
                <c:pt idx="7">
                  <c:v>94.899716999999981</c:v>
                </c:pt>
                <c:pt idx="8">
                  <c:v>94.854057999999981</c:v>
                </c:pt>
                <c:pt idx="9">
                  <c:v>94.80986799999998</c:v>
                </c:pt>
                <c:pt idx="10">
                  <c:v>94.754294999999999</c:v>
                </c:pt>
                <c:pt idx="11">
                  <c:v>94.695976999999928</c:v>
                </c:pt>
                <c:pt idx="12">
                  <c:v>94.651575999999977</c:v>
                </c:pt>
                <c:pt idx="13">
                  <c:v>94.628368999999893</c:v>
                </c:pt>
                <c:pt idx="14">
                  <c:v>94.627049999999983</c:v>
                </c:pt>
                <c:pt idx="15">
                  <c:v>94.646499000000006</c:v>
                </c:pt>
                <c:pt idx="16">
                  <c:v>94.684612000000001</c:v>
                </c:pt>
                <c:pt idx="17">
                  <c:v>94.741150000000005</c:v>
                </c:pt>
                <c:pt idx="18">
                  <c:v>94.819952999999998</c:v>
                </c:pt>
                <c:pt idx="19">
                  <c:v>94.923647000000003</c:v>
                </c:pt>
                <c:pt idx="20">
                  <c:v>95.044313000000002</c:v>
                </c:pt>
                <c:pt idx="21">
                  <c:v>95.165372999999875</c:v>
                </c:pt>
                <c:pt idx="22">
                  <c:v>95.272455999999977</c:v>
                </c:pt>
                <c:pt idx="23">
                  <c:v>95.358677999999927</c:v>
                </c:pt>
                <c:pt idx="24">
                  <c:v>95.42550199999998</c:v>
                </c:pt>
                <c:pt idx="25">
                  <c:v>95.477722</c:v>
                </c:pt>
                <c:pt idx="26">
                  <c:v>95.515259999999998</c:v>
                </c:pt>
                <c:pt idx="27">
                  <c:v>95.537317999999999</c:v>
                </c:pt>
                <c:pt idx="28">
                  <c:v>95.550930999999977</c:v>
                </c:pt>
                <c:pt idx="29">
                  <c:v>95.564559000000003</c:v>
                </c:pt>
                <c:pt idx="30">
                  <c:v>95.577577999999946</c:v>
                </c:pt>
                <c:pt idx="31">
                  <c:v>95.580719000000002</c:v>
                </c:pt>
                <c:pt idx="32">
                  <c:v>95.565347999999929</c:v>
                </c:pt>
                <c:pt idx="33">
                  <c:v>95.530105000000006</c:v>
                </c:pt>
                <c:pt idx="34">
                  <c:v>95.476692</c:v>
                </c:pt>
                <c:pt idx="35">
                  <c:v>95.408775999999946</c:v>
                </c:pt>
                <c:pt idx="36">
                  <c:v>95.341330999999983</c:v>
                </c:pt>
                <c:pt idx="37">
                  <c:v>95.296324999999996</c:v>
                </c:pt>
                <c:pt idx="38">
                  <c:v>95.279097999999976</c:v>
                </c:pt>
                <c:pt idx="39">
                  <c:v>95.269248000000005</c:v>
                </c:pt>
                <c:pt idx="40">
                  <c:v>95.23850299999998</c:v>
                </c:pt>
                <c:pt idx="41">
                  <c:v>95.163216000000006</c:v>
                </c:pt>
                <c:pt idx="42">
                  <c:v>95.012134000000003</c:v>
                </c:pt>
                <c:pt idx="43">
                  <c:v>94.737047000000004</c:v>
                </c:pt>
                <c:pt idx="44">
                  <c:v>94.321791999999945</c:v>
                </c:pt>
                <c:pt idx="45">
                  <c:v>93.898463000000007</c:v>
                </c:pt>
                <c:pt idx="46">
                  <c:v>93.752187999999975</c:v>
                </c:pt>
                <c:pt idx="47">
                  <c:v>94.044923999999995</c:v>
                </c:pt>
                <c:pt idx="48">
                  <c:v>94.593643</c:v>
                </c:pt>
                <c:pt idx="49">
                  <c:v>95.087130000000002</c:v>
                </c:pt>
                <c:pt idx="50">
                  <c:v>95.392923999999994</c:v>
                </c:pt>
                <c:pt idx="51">
                  <c:v>95.557990000000004</c:v>
                </c:pt>
                <c:pt idx="52">
                  <c:v>95.658976999999865</c:v>
                </c:pt>
                <c:pt idx="53">
                  <c:v>95.730331999999976</c:v>
                </c:pt>
                <c:pt idx="54">
                  <c:v>95.777060000000006</c:v>
                </c:pt>
                <c:pt idx="55">
                  <c:v>95.802701999999911</c:v>
                </c:pt>
                <c:pt idx="56">
                  <c:v>95.817969000000005</c:v>
                </c:pt>
                <c:pt idx="57">
                  <c:v>95.831166999999994</c:v>
                </c:pt>
                <c:pt idx="58">
                  <c:v>95.840986999999998</c:v>
                </c:pt>
                <c:pt idx="59">
                  <c:v>95.842815000000002</c:v>
                </c:pt>
                <c:pt idx="60">
                  <c:v>95.838571999999928</c:v>
                </c:pt>
                <c:pt idx="61">
                  <c:v>95.834138999999979</c:v>
                </c:pt>
                <c:pt idx="62">
                  <c:v>95.829250999999999</c:v>
                </c:pt>
                <c:pt idx="63">
                  <c:v>95.817355000000006</c:v>
                </c:pt>
                <c:pt idx="64">
                  <c:v>95.792114999999995</c:v>
                </c:pt>
                <c:pt idx="65">
                  <c:v>95.746459000000002</c:v>
                </c:pt>
                <c:pt idx="66">
                  <c:v>95.668593000000001</c:v>
                </c:pt>
                <c:pt idx="67">
                  <c:v>95.543818999999999</c:v>
                </c:pt>
                <c:pt idx="68">
                  <c:v>95.364375999999979</c:v>
                </c:pt>
                <c:pt idx="69">
                  <c:v>95.157724000000002</c:v>
                </c:pt>
                <c:pt idx="70">
                  <c:v>95.007508999999999</c:v>
                </c:pt>
                <c:pt idx="71">
                  <c:v>94.998417000000003</c:v>
                </c:pt>
                <c:pt idx="72">
                  <c:v>95.121549999999999</c:v>
                </c:pt>
                <c:pt idx="73">
                  <c:v>95.280026000000007</c:v>
                </c:pt>
                <c:pt idx="74">
                  <c:v>95.390285000000006</c:v>
                </c:pt>
                <c:pt idx="75">
                  <c:v>95.435930999999982</c:v>
                </c:pt>
                <c:pt idx="76">
                  <c:v>95.437415999999999</c:v>
                </c:pt>
                <c:pt idx="77">
                  <c:v>95.412469000000002</c:v>
                </c:pt>
                <c:pt idx="78">
                  <c:v>95.363248999999982</c:v>
                </c:pt>
                <c:pt idx="79">
                  <c:v>95.271833000000001</c:v>
                </c:pt>
                <c:pt idx="80">
                  <c:v>95.101217000000005</c:v>
                </c:pt>
                <c:pt idx="81">
                  <c:v>94.841087999999999</c:v>
                </c:pt>
                <c:pt idx="82">
                  <c:v>94.598951999999983</c:v>
                </c:pt>
                <c:pt idx="83">
                  <c:v>94.576681999999977</c:v>
                </c:pt>
                <c:pt idx="84">
                  <c:v>94.844924000000006</c:v>
                </c:pt>
                <c:pt idx="85">
                  <c:v>95.231691999999995</c:v>
                </c:pt>
                <c:pt idx="86">
                  <c:v>95.531606999999994</c:v>
                </c:pt>
                <c:pt idx="87">
                  <c:v>95.694495000000003</c:v>
                </c:pt>
                <c:pt idx="88">
                  <c:v>95.773225999999994</c:v>
                </c:pt>
                <c:pt idx="89">
                  <c:v>95.815973999999983</c:v>
                </c:pt>
                <c:pt idx="90">
                  <c:v>95.843680000000006</c:v>
                </c:pt>
                <c:pt idx="91">
                  <c:v>95.865869000000004</c:v>
                </c:pt>
                <c:pt idx="92">
                  <c:v>95.885400999999931</c:v>
                </c:pt>
                <c:pt idx="93">
                  <c:v>95.901050999999995</c:v>
                </c:pt>
                <c:pt idx="94">
                  <c:v>95.918105999999995</c:v>
                </c:pt>
                <c:pt idx="95">
                  <c:v>95.950111000000007</c:v>
                </c:pt>
                <c:pt idx="96">
                  <c:v>96.004596000000006</c:v>
                </c:pt>
                <c:pt idx="97">
                  <c:v>96.074223000000003</c:v>
                </c:pt>
                <c:pt idx="98">
                  <c:v>96.144892999999982</c:v>
                </c:pt>
                <c:pt idx="99">
                  <c:v>96.206322</c:v>
                </c:pt>
                <c:pt idx="100">
                  <c:v>96.254611999999995</c:v>
                </c:pt>
                <c:pt idx="101">
                  <c:v>96.290308999999979</c:v>
                </c:pt>
                <c:pt idx="102">
                  <c:v>96.311310000000006</c:v>
                </c:pt>
                <c:pt idx="103">
                  <c:v>96.303967999999998</c:v>
                </c:pt>
                <c:pt idx="104">
                  <c:v>96.240616000000003</c:v>
                </c:pt>
                <c:pt idx="105">
                  <c:v>96.085676999999976</c:v>
                </c:pt>
                <c:pt idx="106">
                  <c:v>95.802051999999946</c:v>
                </c:pt>
                <c:pt idx="107">
                  <c:v>95.369224000000003</c:v>
                </c:pt>
                <c:pt idx="108">
                  <c:v>94.916904000000002</c:v>
                </c:pt>
                <c:pt idx="109">
                  <c:v>94.821680000000001</c:v>
                </c:pt>
                <c:pt idx="110">
                  <c:v>95.309700999999976</c:v>
                </c:pt>
                <c:pt idx="111">
                  <c:v>96.036068999999998</c:v>
                </c:pt>
                <c:pt idx="112">
                  <c:v>96.50681299999998</c:v>
                </c:pt>
                <c:pt idx="113">
                  <c:v>96.629432999999892</c:v>
                </c:pt>
                <c:pt idx="114">
                  <c:v>96.607831999999931</c:v>
                </c:pt>
                <c:pt idx="115">
                  <c:v>96.611242000000004</c:v>
                </c:pt>
                <c:pt idx="116">
                  <c:v>96.674596999999977</c:v>
                </c:pt>
                <c:pt idx="117">
                  <c:v>96.769593999999998</c:v>
                </c:pt>
                <c:pt idx="118">
                  <c:v>96.874587999999946</c:v>
                </c:pt>
                <c:pt idx="119">
                  <c:v>96.979157999999998</c:v>
                </c:pt>
                <c:pt idx="120">
                  <c:v>97.068725000000001</c:v>
                </c:pt>
                <c:pt idx="121">
                  <c:v>97.130443999999983</c:v>
                </c:pt>
                <c:pt idx="122">
                  <c:v>97.161034999999998</c:v>
                </c:pt>
                <c:pt idx="123">
                  <c:v>97.164840999999981</c:v>
                </c:pt>
                <c:pt idx="124">
                  <c:v>97.149219000000002</c:v>
                </c:pt>
                <c:pt idx="125">
                  <c:v>97.118709999999979</c:v>
                </c:pt>
                <c:pt idx="126">
                  <c:v>97.069416000000004</c:v>
                </c:pt>
                <c:pt idx="127">
                  <c:v>96.995912000000004</c:v>
                </c:pt>
                <c:pt idx="128">
                  <c:v>96.908033000000003</c:v>
                </c:pt>
                <c:pt idx="129">
                  <c:v>96.833791999999946</c:v>
                </c:pt>
                <c:pt idx="130">
                  <c:v>96.796825999999996</c:v>
                </c:pt>
                <c:pt idx="131">
                  <c:v>96.788337999999897</c:v>
                </c:pt>
                <c:pt idx="132">
                  <c:v>96.770330999999928</c:v>
                </c:pt>
                <c:pt idx="133">
                  <c:v>96.703437999999977</c:v>
                </c:pt>
                <c:pt idx="134">
                  <c:v>96.551743000000002</c:v>
                </c:pt>
                <c:pt idx="135">
                  <c:v>96.266294000000002</c:v>
                </c:pt>
                <c:pt idx="136">
                  <c:v>95.830065000000005</c:v>
                </c:pt>
                <c:pt idx="137">
                  <c:v>95.34247199999993</c:v>
                </c:pt>
                <c:pt idx="138">
                  <c:v>94.961325000000002</c:v>
                </c:pt>
                <c:pt idx="139">
                  <c:v>94.788222000000005</c:v>
                </c:pt>
                <c:pt idx="140">
                  <c:v>94.903655000000001</c:v>
                </c:pt>
                <c:pt idx="141">
                  <c:v>95.304716999999982</c:v>
                </c:pt>
                <c:pt idx="142">
                  <c:v>95.771992999999981</c:v>
                </c:pt>
                <c:pt idx="143">
                  <c:v>96.064801000000003</c:v>
                </c:pt>
                <c:pt idx="144">
                  <c:v>96.151885999999976</c:v>
                </c:pt>
                <c:pt idx="145">
                  <c:v>96.111913999999999</c:v>
                </c:pt>
                <c:pt idx="146">
                  <c:v>95.962967000000006</c:v>
                </c:pt>
                <c:pt idx="147">
                  <c:v>95.633584999999982</c:v>
                </c:pt>
                <c:pt idx="148">
                  <c:v>95.055622999999983</c:v>
                </c:pt>
                <c:pt idx="149">
                  <c:v>94.389465999999999</c:v>
                </c:pt>
                <c:pt idx="150">
                  <c:v>94.102351999999911</c:v>
                </c:pt>
                <c:pt idx="151">
                  <c:v>94.494320000000002</c:v>
                </c:pt>
                <c:pt idx="152">
                  <c:v>95.251186000000004</c:v>
                </c:pt>
                <c:pt idx="153">
                  <c:v>95.847380000000001</c:v>
                </c:pt>
                <c:pt idx="154">
                  <c:v>96.098708999999928</c:v>
                </c:pt>
                <c:pt idx="155">
                  <c:v>96.115253999999993</c:v>
                </c:pt>
                <c:pt idx="156">
                  <c:v>96.034976999999998</c:v>
                </c:pt>
                <c:pt idx="157">
                  <c:v>95.935147999999998</c:v>
                </c:pt>
                <c:pt idx="158">
                  <c:v>95.848287999999982</c:v>
                </c:pt>
                <c:pt idx="159">
                  <c:v>95.771000999999998</c:v>
                </c:pt>
                <c:pt idx="160">
                  <c:v>95.67200399999993</c:v>
                </c:pt>
                <c:pt idx="161">
                  <c:v>95.517786999999998</c:v>
                </c:pt>
                <c:pt idx="162">
                  <c:v>95.303433999999982</c:v>
                </c:pt>
                <c:pt idx="163">
                  <c:v>95.062194000000005</c:v>
                </c:pt>
                <c:pt idx="164">
                  <c:v>94.846304000000003</c:v>
                </c:pt>
                <c:pt idx="165">
                  <c:v>94.699970999999977</c:v>
                </c:pt>
                <c:pt idx="166">
                  <c:v>94.647497000000001</c:v>
                </c:pt>
                <c:pt idx="167">
                  <c:v>94.694550000000007</c:v>
                </c:pt>
                <c:pt idx="168">
                  <c:v>94.829306999999929</c:v>
                </c:pt>
                <c:pt idx="169">
                  <c:v>95.022905999999978</c:v>
                </c:pt>
                <c:pt idx="170">
                  <c:v>95.236236000000005</c:v>
                </c:pt>
                <c:pt idx="171">
                  <c:v>95.433237000000005</c:v>
                </c:pt>
                <c:pt idx="172">
                  <c:v>95.592748999999927</c:v>
                </c:pt>
                <c:pt idx="173">
                  <c:v>95.708562999999998</c:v>
                </c:pt>
                <c:pt idx="174">
                  <c:v>95.783857999999981</c:v>
                </c:pt>
                <c:pt idx="175">
                  <c:v>95.830750999999978</c:v>
                </c:pt>
                <c:pt idx="176">
                  <c:v>95.863922000000002</c:v>
                </c:pt>
                <c:pt idx="177">
                  <c:v>95.887544000000005</c:v>
                </c:pt>
                <c:pt idx="178">
                  <c:v>95.896279000000007</c:v>
                </c:pt>
                <c:pt idx="179">
                  <c:v>95.88570499999993</c:v>
                </c:pt>
                <c:pt idx="180">
                  <c:v>95.853704999999977</c:v>
                </c:pt>
                <c:pt idx="181">
                  <c:v>95.798221999999996</c:v>
                </c:pt>
                <c:pt idx="182">
                  <c:v>95.717642999999995</c:v>
                </c:pt>
                <c:pt idx="183">
                  <c:v>95.607383999999982</c:v>
                </c:pt>
                <c:pt idx="184">
                  <c:v>95.463750000000005</c:v>
                </c:pt>
                <c:pt idx="185">
                  <c:v>95.302606999999981</c:v>
                </c:pt>
                <c:pt idx="186">
                  <c:v>95.155985999999928</c:v>
                </c:pt>
                <c:pt idx="187">
                  <c:v>95.02881799999993</c:v>
                </c:pt>
                <c:pt idx="188">
                  <c:v>94.870773999999912</c:v>
                </c:pt>
                <c:pt idx="189">
                  <c:v>94.600954999999999</c:v>
                </c:pt>
                <c:pt idx="190">
                  <c:v>94.15510399999998</c:v>
                </c:pt>
                <c:pt idx="191">
                  <c:v>93.586357999999976</c:v>
                </c:pt>
                <c:pt idx="192">
                  <c:v>93.177278999999928</c:v>
                </c:pt>
                <c:pt idx="193">
                  <c:v>93.237015999999997</c:v>
                </c:pt>
                <c:pt idx="194">
                  <c:v>93.655788999999857</c:v>
                </c:pt>
                <c:pt idx="195">
                  <c:v>93.982855999999998</c:v>
                </c:pt>
                <c:pt idx="196">
                  <c:v>93.991400999999996</c:v>
                </c:pt>
                <c:pt idx="197">
                  <c:v>93.83213499999998</c:v>
                </c:pt>
                <c:pt idx="198">
                  <c:v>93.658261999999979</c:v>
                </c:pt>
                <c:pt idx="199">
                  <c:v>93.384697000000003</c:v>
                </c:pt>
                <c:pt idx="200">
                  <c:v>92.816292000000004</c:v>
                </c:pt>
                <c:pt idx="201">
                  <c:v>91.777610999999993</c:v>
                </c:pt>
                <c:pt idx="202">
                  <c:v>90.222691999999981</c:v>
                </c:pt>
                <c:pt idx="203">
                  <c:v>88.602329999999981</c:v>
                </c:pt>
                <c:pt idx="204">
                  <c:v>87.915052000000003</c:v>
                </c:pt>
                <c:pt idx="205">
                  <c:v>88.624581999999975</c:v>
                </c:pt>
                <c:pt idx="206">
                  <c:v>89.886989</c:v>
                </c:pt>
                <c:pt idx="207">
                  <c:v>90.594159000000005</c:v>
                </c:pt>
                <c:pt idx="208">
                  <c:v>90.426899000000006</c:v>
                </c:pt>
                <c:pt idx="209">
                  <c:v>89.807241000000005</c:v>
                </c:pt>
                <c:pt idx="210">
                  <c:v>89.431708999999998</c:v>
                </c:pt>
                <c:pt idx="211">
                  <c:v>89.739572999999979</c:v>
                </c:pt>
                <c:pt idx="212">
                  <c:v>90.565254999999993</c:v>
                </c:pt>
                <c:pt idx="213">
                  <c:v>91.38282599999998</c:v>
                </c:pt>
                <c:pt idx="214">
                  <c:v>91.827078999999927</c:v>
                </c:pt>
                <c:pt idx="215">
                  <c:v>91.884044000000003</c:v>
                </c:pt>
                <c:pt idx="216">
                  <c:v>91.739519999999999</c:v>
                </c:pt>
                <c:pt idx="217">
                  <c:v>91.589581999999979</c:v>
                </c:pt>
                <c:pt idx="218">
                  <c:v>91.545225000000002</c:v>
                </c:pt>
                <c:pt idx="219">
                  <c:v>91.632591999999946</c:v>
                </c:pt>
                <c:pt idx="220">
                  <c:v>91.839789999999979</c:v>
                </c:pt>
                <c:pt idx="221">
                  <c:v>92.10960799999998</c:v>
                </c:pt>
                <c:pt idx="222">
                  <c:v>92.331367999999998</c:v>
                </c:pt>
                <c:pt idx="223">
                  <c:v>92.412572999999981</c:v>
                </c:pt>
                <c:pt idx="224">
                  <c:v>92.336897999999977</c:v>
                </c:pt>
                <c:pt idx="225">
                  <c:v>92.154454999999999</c:v>
                </c:pt>
                <c:pt idx="226">
                  <c:v>91.944535999999999</c:v>
                </c:pt>
                <c:pt idx="227">
                  <c:v>91.775254000000004</c:v>
                </c:pt>
                <c:pt idx="228">
                  <c:v>91.683534999999978</c:v>
                </c:pt>
                <c:pt idx="229">
                  <c:v>91.677029999999974</c:v>
                </c:pt>
                <c:pt idx="230">
                  <c:v>91.739957000000004</c:v>
                </c:pt>
                <c:pt idx="231">
                  <c:v>91.84358899999998</c:v>
                </c:pt>
                <c:pt idx="232">
                  <c:v>91.958209999999994</c:v>
                </c:pt>
                <c:pt idx="233">
                  <c:v>92.051146000000003</c:v>
                </c:pt>
                <c:pt idx="234">
                  <c:v>92.073274999999981</c:v>
                </c:pt>
                <c:pt idx="235">
                  <c:v>91.947119999999998</c:v>
                </c:pt>
                <c:pt idx="236">
                  <c:v>91.550745999999975</c:v>
                </c:pt>
                <c:pt idx="237">
                  <c:v>90.759996000000001</c:v>
                </c:pt>
                <c:pt idx="238">
                  <c:v>89.726669000000001</c:v>
                </c:pt>
                <c:pt idx="239">
                  <c:v>89.135119000000003</c:v>
                </c:pt>
                <c:pt idx="240">
                  <c:v>89.649979000000002</c:v>
                </c:pt>
                <c:pt idx="241">
                  <c:v>91.009281000000001</c:v>
                </c:pt>
                <c:pt idx="242">
                  <c:v>92.372117999999929</c:v>
                </c:pt>
                <c:pt idx="243">
                  <c:v>93.287312</c:v>
                </c:pt>
                <c:pt idx="244">
                  <c:v>93.785026000000002</c:v>
                </c:pt>
                <c:pt idx="245">
                  <c:v>93.981509000000003</c:v>
                </c:pt>
                <c:pt idx="246">
                  <c:v>93.976107999999982</c:v>
                </c:pt>
                <c:pt idx="247">
                  <c:v>93.937551999999997</c:v>
                </c:pt>
                <c:pt idx="248">
                  <c:v>94.023643000000007</c:v>
                </c:pt>
                <c:pt idx="249">
                  <c:v>94.200124000000002</c:v>
                </c:pt>
                <c:pt idx="250">
                  <c:v>94.280598999999981</c:v>
                </c:pt>
                <c:pt idx="251">
                  <c:v>94.15196899999998</c:v>
                </c:pt>
                <c:pt idx="252">
                  <c:v>93.849194999999995</c:v>
                </c:pt>
                <c:pt idx="253">
                  <c:v>93.479799999999983</c:v>
                </c:pt>
                <c:pt idx="254">
                  <c:v>93.202568999999983</c:v>
                </c:pt>
                <c:pt idx="255">
                  <c:v>93.181420000000003</c:v>
                </c:pt>
                <c:pt idx="256">
                  <c:v>93.421899999999994</c:v>
                </c:pt>
                <c:pt idx="257">
                  <c:v>93.732890999999981</c:v>
                </c:pt>
                <c:pt idx="258">
                  <c:v>93.922839999999979</c:v>
                </c:pt>
                <c:pt idx="259">
                  <c:v>93.946568999999997</c:v>
                </c:pt>
                <c:pt idx="260">
                  <c:v>93.852987999999911</c:v>
                </c:pt>
                <c:pt idx="261">
                  <c:v>93.689877999999865</c:v>
                </c:pt>
                <c:pt idx="262">
                  <c:v>93.477174000000005</c:v>
                </c:pt>
                <c:pt idx="263">
                  <c:v>93.214810999999997</c:v>
                </c:pt>
                <c:pt idx="264">
                  <c:v>92.891740999999982</c:v>
                </c:pt>
                <c:pt idx="265">
                  <c:v>92.497929999999997</c:v>
                </c:pt>
                <c:pt idx="266">
                  <c:v>92.031799000000007</c:v>
                </c:pt>
                <c:pt idx="267">
                  <c:v>91.493347999999983</c:v>
                </c:pt>
                <c:pt idx="268">
                  <c:v>90.878773999999893</c:v>
                </c:pt>
                <c:pt idx="269">
                  <c:v>90.201824000000002</c:v>
                </c:pt>
                <c:pt idx="270">
                  <c:v>89.530381999999946</c:v>
                </c:pt>
                <c:pt idx="271">
                  <c:v>88.988298</c:v>
                </c:pt>
                <c:pt idx="272">
                  <c:v>88.696996999999982</c:v>
                </c:pt>
                <c:pt idx="273">
                  <c:v>88.694373999999982</c:v>
                </c:pt>
                <c:pt idx="274">
                  <c:v>88.898615000000007</c:v>
                </c:pt>
                <c:pt idx="275">
                  <c:v>89.151671999999976</c:v>
                </c:pt>
                <c:pt idx="276">
                  <c:v>89.309799999999981</c:v>
                </c:pt>
                <c:pt idx="277">
                  <c:v>89.310016000000005</c:v>
                </c:pt>
                <c:pt idx="278">
                  <c:v>89.181547999999978</c:v>
                </c:pt>
                <c:pt idx="279">
                  <c:v>89.038222000000005</c:v>
                </c:pt>
                <c:pt idx="280">
                  <c:v>89.058837999999895</c:v>
                </c:pt>
                <c:pt idx="281">
                  <c:v>89.368454999999983</c:v>
                </c:pt>
                <c:pt idx="282">
                  <c:v>89.848652000000001</c:v>
                </c:pt>
                <c:pt idx="283">
                  <c:v>90.184152999999981</c:v>
                </c:pt>
                <c:pt idx="284">
                  <c:v>90.243313999999998</c:v>
                </c:pt>
                <c:pt idx="285">
                  <c:v>90.296969000000004</c:v>
                </c:pt>
                <c:pt idx="286">
                  <c:v>90.687061</c:v>
                </c:pt>
                <c:pt idx="287">
                  <c:v>91.384966000000006</c:v>
                </c:pt>
                <c:pt idx="288">
                  <c:v>92.059599000000006</c:v>
                </c:pt>
                <c:pt idx="289">
                  <c:v>92.443529999999996</c:v>
                </c:pt>
                <c:pt idx="290">
                  <c:v>92.502787999999896</c:v>
                </c:pt>
                <c:pt idx="291">
                  <c:v>92.361186000000004</c:v>
                </c:pt>
                <c:pt idx="292">
                  <c:v>92.113411999999983</c:v>
                </c:pt>
                <c:pt idx="293">
                  <c:v>91.698667</c:v>
                </c:pt>
                <c:pt idx="294">
                  <c:v>90.979428999999982</c:v>
                </c:pt>
                <c:pt idx="295">
                  <c:v>89.921182000000002</c:v>
                </c:pt>
                <c:pt idx="296">
                  <c:v>88.718063999999998</c:v>
                </c:pt>
                <c:pt idx="297">
                  <c:v>87.821264999999997</c:v>
                </c:pt>
                <c:pt idx="298">
                  <c:v>87.722797999999912</c:v>
                </c:pt>
                <c:pt idx="299">
                  <c:v>88.497403000000006</c:v>
                </c:pt>
                <c:pt idx="300">
                  <c:v>89.65701199999998</c:v>
                </c:pt>
                <c:pt idx="301">
                  <c:v>90.570423000000005</c:v>
                </c:pt>
                <c:pt idx="302">
                  <c:v>90.86932299999998</c:v>
                </c:pt>
                <c:pt idx="303">
                  <c:v>90.480562000000006</c:v>
                </c:pt>
                <c:pt idx="304">
                  <c:v>89.567847999999998</c:v>
                </c:pt>
                <c:pt idx="305">
                  <c:v>88.610264000000001</c:v>
                </c:pt>
                <c:pt idx="306">
                  <c:v>88.306529999999995</c:v>
                </c:pt>
                <c:pt idx="307">
                  <c:v>89.023962999999981</c:v>
                </c:pt>
                <c:pt idx="308">
                  <c:v>90.423772999999912</c:v>
                </c:pt>
                <c:pt idx="309">
                  <c:v>91.868903000000003</c:v>
                </c:pt>
                <c:pt idx="310">
                  <c:v>92.976459000000006</c:v>
                </c:pt>
                <c:pt idx="311">
                  <c:v>93.68606699999998</c:v>
                </c:pt>
                <c:pt idx="312">
                  <c:v>94.047599000000005</c:v>
                </c:pt>
                <c:pt idx="313">
                  <c:v>94.082855999999978</c:v>
                </c:pt>
                <c:pt idx="314">
                  <c:v>93.860324000000006</c:v>
                </c:pt>
                <c:pt idx="315">
                  <c:v>93.634603999999996</c:v>
                </c:pt>
                <c:pt idx="316">
                  <c:v>93.719328000000004</c:v>
                </c:pt>
                <c:pt idx="317">
                  <c:v>94.163822999999979</c:v>
                </c:pt>
                <c:pt idx="318">
                  <c:v>94.727349000000004</c:v>
                </c:pt>
                <c:pt idx="319">
                  <c:v>95.174772999999874</c:v>
                </c:pt>
                <c:pt idx="320">
                  <c:v>95.444591000000003</c:v>
                </c:pt>
                <c:pt idx="321">
                  <c:v>95.559950000000001</c:v>
                </c:pt>
                <c:pt idx="322">
                  <c:v>95.496397999999999</c:v>
                </c:pt>
                <c:pt idx="323">
                  <c:v>95.189337999999893</c:v>
                </c:pt>
                <c:pt idx="324">
                  <c:v>94.724402999999981</c:v>
                </c:pt>
                <c:pt idx="325">
                  <c:v>94.466989999999996</c:v>
                </c:pt>
                <c:pt idx="326">
                  <c:v>94.741973999999999</c:v>
                </c:pt>
                <c:pt idx="327">
                  <c:v>95.396028999999999</c:v>
                </c:pt>
                <c:pt idx="328">
                  <c:v>95.998521999999994</c:v>
                </c:pt>
                <c:pt idx="329">
                  <c:v>96.333748999999912</c:v>
                </c:pt>
                <c:pt idx="330">
                  <c:v>96.450074000000001</c:v>
                </c:pt>
                <c:pt idx="331">
                  <c:v>96.450395999999998</c:v>
                </c:pt>
                <c:pt idx="332">
                  <c:v>96.414472000000004</c:v>
                </c:pt>
                <c:pt idx="333">
                  <c:v>96.401278000000005</c:v>
                </c:pt>
                <c:pt idx="334">
                  <c:v>96.426124999999999</c:v>
                </c:pt>
                <c:pt idx="335">
                  <c:v>96.459777999999929</c:v>
                </c:pt>
                <c:pt idx="336">
                  <c:v>96.467371</c:v>
                </c:pt>
                <c:pt idx="337">
                  <c:v>96.438576999999981</c:v>
                </c:pt>
                <c:pt idx="338">
                  <c:v>96.39354299999998</c:v>
                </c:pt>
                <c:pt idx="339">
                  <c:v>96.373049999999978</c:v>
                </c:pt>
                <c:pt idx="340">
                  <c:v>96.405213000000003</c:v>
                </c:pt>
                <c:pt idx="341">
                  <c:v>96.475504000000001</c:v>
                </c:pt>
                <c:pt idx="342">
                  <c:v>96.544865999999999</c:v>
                </c:pt>
                <c:pt idx="343">
                  <c:v>96.590975</c:v>
                </c:pt>
                <c:pt idx="344">
                  <c:v>96.619171999999978</c:v>
                </c:pt>
                <c:pt idx="345">
                  <c:v>96.646112000000002</c:v>
                </c:pt>
                <c:pt idx="346">
                  <c:v>96.681769000000003</c:v>
                </c:pt>
                <c:pt idx="347">
                  <c:v>96.720864000000006</c:v>
                </c:pt>
                <c:pt idx="348">
                  <c:v>96.750844999999998</c:v>
                </c:pt>
                <c:pt idx="349">
                  <c:v>96.764852000000005</c:v>
                </c:pt>
                <c:pt idx="350">
                  <c:v>96.762774999999976</c:v>
                </c:pt>
                <c:pt idx="351">
                  <c:v>96.746898000000002</c:v>
                </c:pt>
                <c:pt idx="352">
                  <c:v>96.717573999999999</c:v>
                </c:pt>
                <c:pt idx="353">
                  <c:v>96.665153000000004</c:v>
                </c:pt>
                <c:pt idx="354">
                  <c:v>96.576409999999981</c:v>
                </c:pt>
                <c:pt idx="355">
                  <c:v>96.467033000000001</c:v>
                </c:pt>
                <c:pt idx="356">
                  <c:v>96.388044999999977</c:v>
                </c:pt>
                <c:pt idx="357">
                  <c:v>96.372918999999897</c:v>
                </c:pt>
                <c:pt idx="358">
                  <c:v>96.398922999999982</c:v>
                </c:pt>
                <c:pt idx="359">
                  <c:v>96.415929000000006</c:v>
                </c:pt>
                <c:pt idx="360">
                  <c:v>96.389071999999928</c:v>
                </c:pt>
                <c:pt idx="361">
                  <c:v>96.309217000000004</c:v>
                </c:pt>
                <c:pt idx="362">
                  <c:v>96.184550999999999</c:v>
                </c:pt>
                <c:pt idx="363">
                  <c:v>96.028961999999979</c:v>
                </c:pt>
                <c:pt idx="364">
                  <c:v>95.853027999999981</c:v>
                </c:pt>
                <c:pt idx="365">
                  <c:v>95.672565999999946</c:v>
                </c:pt>
                <c:pt idx="366">
                  <c:v>95.538941999999977</c:v>
                </c:pt>
                <c:pt idx="367">
                  <c:v>95.540379999999999</c:v>
                </c:pt>
                <c:pt idx="368">
                  <c:v>95.717800999999994</c:v>
                </c:pt>
                <c:pt idx="369">
                  <c:v>95.984435000000005</c:v>
                </c:pt>
                <c:pt idx="370">
                  <c:v>96.198618999999979</c:v>
                </c:pt>
                <c:pt idx="371">
                  <c:v>96.302228999999983</c:v>
                </c:pt>
                <c:pt idx="372">
                  <c:v>96.327416999999983</c:v>
                </c:pt>
                <c:pt idx="373">
                  <c:v>96.317179999999993</c:v>
                </c:pt>
                <c:pt idx="374">
                  <c:v>96.295563999999999</c:v>
                </c:pt>
                <c:pt idx="375">
                  <c:v>96.270653999999993</c:v>
                </c:pt>
                <c:pt idx="376">
                  <c:v>96.242456000000004</c:v>
                </c:pt>
                <c:pt idx="377">
                  <c:v>96.226713000000004</c:v>
                </c:pt>
                <c:pt idx="378">
                  <c:v>96.250692999999998</c:v>
                </c:pt>
                <c:pt idx="379">
                  <c:v>96.315340999999975</c:v>
                </c:pt>
                <c:pt idx="380">
                  <c:v>96.39283099999993</c:v>
                </c:pt>
                <c:pt idx="381">
                  <c:v>96.458619999999996</c:v>
                </c:pt>
                <c:pt idx="382">
                  <c:v>96.499994000000001</c:v>
                </c:pt>
                <c:pt idx="383">
                  <c:v>96.512259999999998</c:v>
                </c:pt>
                <c:pt idx="384">
                  <c:v>96.510149999999996</c:v>
                </c:pt>
                <c:pt idx="385">
                  <c:v>96.516803999999993</c:v>
                </c:pt>
                <c:pt idx="386">
                  <c:v>96.52909099999998</c:v>
                </c:pt>
                <c:pt idx="387">
                  <c:v>96.519192000000004</c:v>
                </c:pt>
                <c:pt idx="388">
                  <c:v>96.468079000000003</c:v>
                </c:pt>
                <c:pt idx="389">
                  <c:v>96.390429999999995</c:v>
                </c:pt>
                <c:pt idx="390">
                  <c:v>96.34227199999998</c:v>
                </c:pt>
                <c:pt idx="391">
                  <c:v>96.378651999999946</c:v>
                </c:pt>
                <c:pt idx="392">
                  <c:v>96.486694</c:v>
                </c:pt>
                <c:pt idx="393">
                  <c:v>96.597468000000006</c:v>
                </c:pt>
                <c:pt idx="394">
                  <c:v>96.656191999999976</c:v>
                </c:pt>
                <c:pt idx="395">
                  <c:v>96.646780999999976</c:v>
                </c:pt>
                <c:pt idx="396">
                  <c:v>96.581390999999982</c:v>
                </c:pt>
                <c:pt idx="397">
                  <c:v>96.50503999999998</c:v>
                </c:pt>
                <c:pt idx="398">
                  <c:v>96.483350999999999</c:v>
                </c:pt>
                <c:pt idx="399">
                  <c:v>96.54854899999998</c:v>
                </c:pt>
                <c:pt idx="400">
                  <c:v>96.668352999999911</c:v>
                </c:pt>
                <c:pt idx="401">
                  <c:v>96.784493999999995</c:v>
                </c:pt>
                <c:pt idx="402">
                  <c:v>96.86045799999998</c:v>
                </c:pt>
                <c:pt idx="403">
                  <c:v>96.89041899999998</c:v>
                </c:pt>
                <c:pt idx="404">
                  <c:v>96.883925000000005</c:v>
                </c:pt>
                <c:pt idx="405">
                  <c:v>96.851784999999978</c:v>
                </c:pt>
                <c:pt idx="406">
                  <c:v>96.803837999999928</c:v>
                </c:pt>
                <c:pt idx="407">
                  <c:v>96.728311999999946</c:v>
                </c:pt>
                <c:pt idx="408">
                  <c:v>96.580123999999998</c:v>
                </c:pt>
                <c:pt idx="409">
                  <c:v>96.35045599999998</c:v>
                </c:pt>
                <c:pt idx="410">
                  <c:v>96.10481799999998</c:v>
                </c:pt>
                <c:pt idx="411">
                  <c:v>95.897019999999998</c:v>
                </c:pt>
                <c:pt idx="412">
                  <c:v>95.751270000000005</c:v>
                </c:pt>
                <c:pt idx="413">
                  <c:v>95.716926999999998</c:v>
                </c:pt>
                <c:pt idx="414">
                  <c:v>95.789371999999929</c:v>
                </c:pt>
                <c:pt idx="415">
                  <c:v>95.845061999999999</c:v>
                </c:pt>
                <c:pt idx="416">
                  <c:v>95.767380000000003</c:v>
                </c:pt>
                <c:pt idx="417">
                  <c:v>95.537963000000005</c:v>
                </c:pt>
                <c:pt idx="418">
                  <c:v>95.214839999999995</c:v>
                </c:pt>
                <c:pt idx="419">
                  <c:v>94.939685999999995</c:v>
                </c:pt>
                <c:pt idx="420">
                  <c:v>94.861637999999999</c:v>
                </c:pt>
                <c:pt idx="421">
                  <c:v>94.975813000000002</c:v>
                </c:pt>
                <c:pt idx="422">
                  <c:v>95.156413000000001</c:v>
                </c:pt>
                <c:pt idx="423">
                  <c:v>95.330155000000005</c:v>
                </c:pt>
                <c:pt idx="424">
                  <c:v>95.539895000000001</c:v>
                </c:pt>
                <c:pt idx="425">
                  <c:v>95.839111000000003</c:v>
                </c:pt>
                <c:pt idx="426">
                  <c:v>96.172282999999865</c:v>
                </c:pt>
                <c:pt idx="427">
                  <c:v>96.415001000000004</c:v>
                </c:pt>
                <c:pt idx="428">
                  <c:v>96.518428</c:v>
                </c:pt>
                <c:pt idx="429">
                  <c:v>96.53889599999998</c:v>
                </c:pt>
                <c:pt idx="430">
                  <c:v>96.545199999999994</c:v>
                </c:pt>
                <c:pt idx="431">
                  <c:v>96.566765000000004</c:v>
                </c:pt>
                <c:pt idx="432">
                  <c:v>96.605498999999895</c:v>
                </c:pt>
                <c:pt idx="433">
                  <c:v>96.655108999999896</c:v>
                </c:pt>
                <c:pt idx="434">
                  <c:v>96.708181999999979</c:v>
                </c:pt>
                <c:pt idx="435">
                  <c:v>96.758745999999945</c:v>
                </c:pt>
                <c:pt idx="436">
                  <c:v>96.815367999999978</c:v>
                </c:pt>
                <c:pt idx="437">
                  <c:v>96.909502000000003</c:v>
                </c:pt>
                <c:pt idx="438">
                  <c:v>97.061688000000004</c:v>
                </c:pt>
                <c:pt idx="439">
                  <c:v>97.241536999999994</c:v>
                </c:pt>
                <c:pt idx="440">
                  <c:v>97.39676799999998</c:v>
                </c:pt>
                <c:pt idx="441">
                  <c:v>97.516396</c:v>
                </c:pt>
                <c:pt idx="442">
                  <c:v>97.63284599999993</c:v>
                </c:pt>
                <c:pt idx="443">
                  <c:v>97.761161000000001</c:v>
                </c:pt>
                <c:pt idx="444">
                  <c:v>97.855959999999982</c:v>
                </c:pt>
                <c:pt idx="445">
                  <c:v>97.86950299999998</c:v>
                </c:pt>
                <c:pt idx="446">
                  <c:v>97.832583999999983</c:v>
                </c:pt>
                <c:pt idx="447">
                  <c:v>97.806245000000004</c:v>
                </c:pt>
                <c:pt idx="448">
                  <c:v>97.809033999999983</c:v>
                </c:pt>
                <c:pt idx="449">
                  <c:v>97.830378999999894</c:v>
                </c:pt>
                <c:pt idx="450">
                  <c:v>97.861525999999998</c:v>
                </c:pt>
                <c:pt idx="451">
                  <c:v>97.891412000000003</c:v>
                </c:pt>
                <c:pt idx="452">
                  <c:v>97.897760000000005</c:v>
                </c:pt>
                <c:pt idx="453">
                  <c:v>97.87280999999993</c:v>
                </c:pt>
                <c:pt idx="454">
                  <c:v>97.836474999999979</c:v>
                </c:pt>
                <c:pt idx="455">
                  <c:v>97.805261999999999</c:v>
                </c:pt>
                <c:pt idx="456">
                  <c:v>97.785526000000004</c:v>
                </c:pt>
                <c:pt idx="457">
                  <c:v>97.781996000000007</c:v>
                </c:pt>
                <c:pt idx="458">
                  <c:v>97.786539000000005</c:v>
                </c:pt>
                <c:pt idx="459">
                  <c:v>97.798939000000004</c:v>
                </c:pt>
                <c:pt idx="460">
                  <c:v>97.839217000000005</c:v>
                </c:pt>
                <c:pt idx="461">
                  <c:v>97.889173</c:v>
                </c:pt>
                <c:pt idx="462">
                  <c:v>97.888155999999981</c:v>
                </c:pt>
                <c:pt idx="463">
                  <c:v>97.824101999999982</c:v>
                </c:pt>
                <c:pt idx="464">
                  <c:v>97.743347</c:v>
                </c:pt>
                <c:pt idx="465">
                  <c:v>97.680915999999982</c:v>
                </c:pt>
                <c:pt idx="466">
                  <c:v>97.642464000000004</c:v>
                </c:pt>
                <c:pt idx="467">
                  <c:v>97.624004999999983</c:v>
                </c:pt>
                <c:pt idx="468">
                  <c:v>97.62562699999998</c:v>
                </c:pt>
                <c:pt idx="469">
                  <c:v>97.654724000000002</c:v>
                </c:pt>
                <c:pt idx="470">
                  <c:v>97.708994000000004</c:v>
                </c:pt>
                <c:pt idx="471">
                  <c:v>97.741336000000004</c:v>
                </c:pt>
                <c:pt idx="472">
                  <c:v>97.691941</c:v>
                </c:pt>
                <c:pt idx="473">
                  <c:v>97.585949999999983</c:v>
                </c:pt>
                <c:pt idx="474">
                  <c:v>97.503937999999977</c:v>
                </c:pt>
                <c:pt idx="475">
                  <c:v>97.475290000000001</c:v>
                </c:pt>
                <c:pt idx="476">
                  <c:v>97.473816999999983</c:v>
                </c:pt>
                <c:pt idx="477">
                  <c:v>97.468394000000004</c:v>
                </c:pt>
                <c:pt idx="478">
                  <c:v>97.460448</c:v>
                </c:pt>
                <c:pt idx="479">
                  <c:v>97.471920999999995</c:v>
                </c:pt>
                <c:pt idx="480">
                  <c:v>97.486130000000003</c:v>
                </c:pt>
                <c:pt idx="481">
                  <c:v>97.462414999999993</c:v>
                </c:pt>
                <c:pt idx="482">
                  <c:v>97.411371000000003</c:v>
                </c:pt>
                <c:pt idx="483">
                  <c:v>97.372259</c:v>
                </c:pt>
                <c:pt idx="484">
                  <c:v>97.352226000000002</c:v>
                </c:pt>
                <c:pt idx="485">
                  <c:v>97.33871199999993</c:v>
                </c:pt>
                <c:pt idx="486">
                  <c:v>97.325293000000002</c:v>
                </c:pt>
                <c:pt idx="487">
                  <c:v>97.310467000000003</c:v>
                </c:pt>
                <c:pt idx="488">
                  <c:v>97.294769000000002</c:v>
                </c:pt>
                <c:pt idx="489">
                  <c:v>97.279605000000004</c:v>
                </c:pt>
                <c:pt idx="490">
                  <c:v>97.264448999999999</c:v>
                </c:pt>
                <c:pt idx="491">
                  <c:v>97.247842000000006</c:v>
                </c:pt>
                <c:pt idx="492">
                  <c:v>97.230179000000007</c:v>
                </c:pt>
                <c:pt idx="493">
                  <c:v>97.211718000000005</c:v>
                </c:pt>
                <c:pt idx="494">
                  <c:v>97.190171999999976</c:v>
                </c:pt>
                <c:pt idx="495">
                  <c:v>97.164405000000002</c:v>
                </c:pt>
                <c:pt idx="496">
                  <c:v>97.135553000000002</c:v>
                </c:pt>
                <c:pt idx="497">
                  <c:v>97.102556999999976</c:v>
                </c:pt>
                <c:pt idx="498">
                  <c:v>97.065455</c:v>
                </c:pt>
                <c:pt idx="499">
                  <c:v>97.036176999999981</c:v>
                </c:pt>
                <c:pt idx="500">
                  <c:v>97.024271999999982</c:v>
                </c:pt>
                <c:pt idx="501">
                  <c:v>97.004367999999999</c:v>
                </c:pt>
                <c:pt idx="502">
                  <c:v>96.944738000000001</c:v>
                </c:pt>
                <c:pt idx="503">
                  <c:v>96.866014000000007</c:v>
                </c:pt>
                <c:pt idx="504">
                  <c:v>96.803297999999998</c:v>
                </c:pt>
                <c:pt idx="505">
                  <c:v>96.749184</c:v>
                </c:pt>
                <c:pt idx="506">
                  <c:v>96.68509599999993</c:v>
                </c:pt>
                <c:pt idx="507">
                  <c:v>96.613873999999981</c:v>
                </c:pt>
                <c:pt idx="508">
                  <c:v>96.549156999999994</c:v>
                </c:pt>
                <c:pt idx="509">
                  <c:v>96.510982999999982</c:v>
                </c:pt>
                <c:pt idx="510">
                  <c:v>96.502980999999977</c:v>
                </c:pt>
                <c:pt idx="511">
                  <c:v>96.484566000000001</c:v>
                </c:pt>
                <c:pt idx="512">
                  <c:v>96.418919000000002</c:v>
                </c:pt>
                <c:pt idx="513">
                  <c:v>96.330470999999946</c:v>
                </c:pt>
                <c:pt idx="514">
                  <c:v>96.266384000000002</c:v>
                </c:pt>
                <c:pt idx="515">
                  <c:v>96.242276000000004</c:v>
                </c:pt>
                <c:pt idx="516">
                  <c:v>96.234019000000004</c:v>
                </c:pt>
                <c:pt idx="517">
                  <c:v>96.209113000000002</c:v>
                </c:pt>
                <c:pt idx="518">
                  <c:v>96.186009999999982</c:v>
                </c:pt>
                <c:pt idx="519">
                  <c:v>96.197989000000007</c:v>
                </c:pt>
                <c:pt idx="520">
                  <c:v>96.189679999999981</c:v>
                </c:pt>
                <c:pt idx="521">
                  <c:v>96.085699000000005</c:v>
                </c:pt>
                <c:pt idx="522">
                  <c:v>95.932436999999979</c:v>
                </c:pt>
                <c:pt idx="523">
                  <c:v>95.818202999999983</c:v>
                </c:pt>
                <c:pt idx="524">
                  <c:v>95.753056999999998</c:v>
                </c:pt>
                <c:pt idx="525">
                  <c:v>95.697391999999979</c:v>
                </c:pt>
                <c:pt idx="526">
                  <c:v>95.633347999999927</c:v>
                </c:pt>
                <c:pt idx="527">
                  <c:v>95.583356999999978</c:v>
                </c:pt>
                <c:pt idx="528">
                  <c:v>95.569092999999981</c:v>
                </c:pt>
                <c:pt idx="529">
                  <c:v>95.589301999999975</c:v>
                </c:pt>
                <c:pt idx="530">
                  <c:v>95.649411999999998</c:v>
                </c:pt>
                <c:pt idx="531">
                  <c:v>95.756225999999998</c:v>
                </c:pt>
                <c:pt idx="532">
                  <c:v>95.887659999999997</c:v>
                </c:pt>
                <c:pt idx="533">
                  <c:v>96.023097999999976</c:v>
                </c:pt>
                <c:pt idx="534">
                  <c:v>96.176665</c:v>
                </c:pt>
                <c:pt idx="535">
                  <c:v>96.35816699999998</c:v>
                </c:pt>
                <c:pt idx="536">
                  <c:v>96.521283999999994</c:v>
                </c:pt>
                <c:pt idx="537">
                  <c:v>96.601201000000003</c:v>
                </c:pt>
                <c:pt idx="538">
                  <c:v>96.610306999999978</c:v>
                </c:pt>
                <c:pt idx="539">
                  <c:v>96.618089999999981</c:v>
                </c:pt>
                <c:pt idx="540">
                  <c:v>96.665805999999947</c:v>
                </c:pt>
                <c:pt idx="541">
                  <c:v>96.754611999999995</c:v>
                </c:pt>
                <c:pt idx="542">
                  <c:v>96.854990999999998</c:v>
                </c:pt>
                <c:pt idx="543">
                  <c:v>96.929908999999981</c:v>
                </c:pt>
                <c:pt idx="544">
                  <c:v>96.963234</c:v>
                </c:pt>
                <c:pt idx="545">
                  <c:v>96.944874999999996</c:v>
                </c:pt>
                <c:pt idx="546">
                  <c:v>96.882335999999896</c:v>
                </c:pt>
                <c:pt idx="547">
                  <c:v>96.806131999999977</c:v>
                </c:pt>
                <c:pt idx="548">
                  <c:v>96.721756999999982</c:v>
                </c:pt>
                <c:pt idx="549">
                  <c:v>96.61438099999998</c:v>
                </c:pt>
                <c:pt idx="550">
                  <c:v>96.486177999999981</c:v>
                </c:pt>
                <c:pt idx="551">
                  <c:v>96.348596999999998</c:v>
                </c:pt>
                <c:pt idx="552">
                  <c:v>96.195589999999982</c:v>
                </c:pt>
                <c:pt idx="553">
                  <c:v>95.987509000000003</c:v>
                </c:pt>
                <c:pt idx="554">
                  <c:v>95.686304999999976</c:v>
                </c:pt>
                <c:pt idx="555">
                  <c:v>95.318128999999999</c:v>
                </c:pt>
                <c:pt idx="556">
                  <c:v>94.945511999999994</c:v>
                </c:pt>
                <c:pt idx="557">
                  <c:v>94.598788999999911</c:v>
                </c:pt>
                <c:pt idx="558">
                  <c:v>94.283384999999981</c:v>
                </c:pt>
                <c:pt idx="559">
                  <c:v>94.013565999999997</c:v>
                </c:pt>
                <c:pt idx="560">
                  <c:v>93.811875000000001</c:v>
                </c:pt>
                <c:pt idx="561">
                  <c:v>93.681090999999981</c:v>
                </c:pt>
                <c:pt idx="562">
                  <c:v>93.586410999999998</c:v>
                </c:pt>
                <c:pt idx="563">
                  <c:v>93.508369000000002</c:v>
                </c:pt>
                <c:pt idx="564">
                  <c:v>93.490442999999999</c:v>
                </c:pt>
                <c:pt idx="565">
                  <c:v>93.579079999999976</c:v>
                </c:pt>
                <c:pt idx="566">
                  <c:v>93.777524999999997</c:v>
                </c:pt>
                <c:pt idx="567">
                  <c:v>94.079814999999982</c:v>
                </c:pt>
                <c:pt idx="568">
                  <c:v>94.485197999999983</c:v>
                </c:pt>
                <c:pt idx="569">
                  <c:v>94.976078999999928</c:v>
                </c:pt>
                <c:pt idx="570">
                  <c:v>95.509304</c:v>
                </c:pt>
                <c:pt idx="571">
                  <c:v>96.023975999999976</c:v>
                </c:pt>
                <c:pt idx="572">
                  <c:v>96.474622999999994</c:v>
                </c:pt>
                <c:pt idx="573">
                  <c:v>96.854846999999978</c:v>
                </c:pt>
                <c:pt idx="574">
                  <c:v>97.170624000000004</c:v>
                </c:pt>
                <c:pt idx="575">
                  <c:v>97.421358999999981</c:v>
                </c:pt>
                <c:pt idx="576">
                  <c:v>97.608174999999946</c:v>
                </c:pt>
                <c:pt idx="577">
                  <c:v>97.736747999999977</c:v>
                </c:pt>
                <c:pt idx="578">
                  <c:v>97.825374999999894</c:v>
                </c:pt>
                <c:pt idx="579">
                  <c:v>97.900047999999998</c:v>
                </c:pt>
                <c:pt idx="580">
                  <c:v>97.971974000000003</c:v>
                </c:pt>
                <c:pt idx="581">
                  <c:v>98.033861000000002</c:v>
                </c:pt>
                <c:pt idx="582">
                  <c:v>98.067325999999994</c:v>
                </c:pt>
                <c:pt idx="583">
                  <c:v>98.065275</c:v>
                </c:pt>
                <c:pt idx="584">
                  <c:v>98.052259000000006</c:v>
                </c:pt>
                <c:pt idx="585">
                  <c:v>98.05408199999998</c:v>
                </c:pt>
                <c:pt idx="586">
                  <c:v>98.06846299999998</c:v>
                </c:pt>
                <c:pt idx="587">
                  <c:v>98.084023999999999</c:v>
                </c:pt>
                <c:pt idx="588">
                  <c:v>98.096545000000006</c:v>
                </c:pt>
                <c:pt idx="589">
                  <c:v>98.105164000000002</c:v>
                </c:pt>
                <c:pt idx="590">
                  <c:v>98.116967000000002</c:v>
                </c:pt>
                <c:pt idx="591">
                  <c:v>98.140697000000003</c:v>
                </c:pt>
                <c:pt idx="592">
                  <c:v>98.163208999999981</c:v>
                </c:pt>
                <c:pt idx="593">
                  <c:v>98.16282099999998</c:v>
                </c:pt>
                <c:pt idx="594">
                  <c:v>98.147428000000005</c:v>
                </c:pt>
                <c:pt idx="595">
                  <c:v>98.141401000000002</c:v>
                </c:pt>
                <c:pt idx="596">
                  <c:v>98.147073000000006</c:v>
                </c:pt>
                <c:pt idx="597">
                  <c:v>98.149514999999994</c:v>
                </c:pt>
                <c:pt idx="598">
                  <c:v>98.143725000000003</c:v>
                </c:pt>
                <c:pt idx="599">
                  <c:v>98.138020999999981</c:v>
                </c:pt>
                <c:pt idx="600">
                  <c:v>98.139082999999928</c:v>
                </c:pt>
                <c:pt idx="601">
                  <c:v>98.144261</c:v>
                </c:pt>
                <c:pt idx="602">
                  <c:v>98.14676</c:v>
                </c:pt>
                <c:pt idx="603">
                  <c:v>98.144429000000002</c:v>
                </c:pt>
                <c:pt idx="604">
                  <c:v>98.140990000000002</c:v>
                </c:pt>
                <c:pt idx="605">
                  <c:v>98.13943399999998</c:v>
                </c:pt>
                <c:pt idx="606">
                  <c:v>98.139837999999912</c:v>
                </c:pt>
                <c:pt idx="607">
                  <c:v>98.143568000000002</c:v>
                </c:pt>
                <c:pt idx="608">
                  <c:v>98.151850999999979</c:v>
                </c:pt>
                <c:pt idx="609">
                  <c:v>98.160846999999976</c:v>
                </c:pt>
                <c:pt idx="610">
                  <c:v>98.167163000000002</c:v>
                </c:pt>
                <c:pt idx="611">
                  <c:v>98.171374999999927</c:v>
                </c:pt>
                <c:pt idx="612">
                  <c:v>98.170129000000003</c:v>
                </c:pt>
                <c:pt idx="613">
                  <c:v>98.161013999999994</c:v>
                </c:pt>
                <c:pt idx="614">
                  <c:v>98.151206000000002</c:v>
                </c:pt>
                <c:pt idx="615">
                  <c:v>98.146223000000006</c:v>
                </c:pt>
                <c:pt idx="616">
                  <c:v>98.146179000000004</c:v>
                </c:pt>
                <c:pt idx="617">
                  <c:v>98.157622000000003</c:v>
                </c:pt>
                <c:pt idx="618">
                  <c:v>98.184000999999981</c:v>
                </c:pt>
                <c:pt idx="619">
                  <c:v>98.205917999999983</c:v>
                </c:pt>
                <c:pt idx="620">
                  <c:v>98.201400000000007</c:v>
                </c:pt>
                <c:pt idx="621">
                  <c:v>98.178620999999978</c:v>
                </c:pt>
                <c:pt idx="622">
                  <c:v>98.159154000000001</c:v>
                </c:pt>
                <c:pt idx="623">
                  <c:v>98.14893499999998</c:v>
                </c:pt>
                <c:pt idx="624">
                  <c:v>98.143635000000003</c:v>
                </c:pt>
                <c:pt idx="625">
                  <c:v>98.140709000000001</c:v>
                </c:pt>
                <c:pt idx="626">
                  <c:v>98.139415999999983</c:v>
                </c:pt>
                <c:pt idx="627">
                  <c:v>98.138857999999928</c:v>
                </c:pt>
                <c:pt idx="628">
                  <c:v>98.13811699999998</c:v>
                </c:pt>
                <c:pt idx="629">
                  <c:v>98.138666999999998</c:v>
                </c:pt>
                <c:pt idx="630">
                  <c:v>98.144698000000005</c:v>
                </c:pt>
                <c:pt idx="631">
                  <c:v>98.154570000000007</c:v>
                </c:pt>
                <c:pt idx="632">
                  <c:v>98.155591999999928</c:v>
                </c:pt>
                <c:pt idx="633">
                  <c:v>98.13969299999998</c:v>
                </c:pt>
                <c:pt idx="634">
                  <c:v>98.11687199999993</c:v>
                </c:pt>
                <c:pt idx="635">
                  <c:v>98.10084999999998</c:v>
                </c:pt>
                <c:pt idx="636">
                  <c:v>98.094370999999981</c:v>
                </c:pt>
                <c:pt idx="637">
                  <c:v>98.094560000000001</c:v>
                </c:pt>
                <c:pt idx="638">
                  <c:v>98.099553</c:v>
                </c:pt>
                <c:pt idx="639">
                  <c:v>98.107127000000006</c:v>
                </c:pt>
                <c:pt idx="640">
                  <c:v>98.114301999999981</c:v>
                </c:pt>
                <c:pt idx="641">
                  <c:v>98.120132999999896</c:v>
                </c:pt>
                <c:pt idx="642">
                  <c:v>98.124448999999927</c:v>
                </c:pt>
                <c:pt idx="643">
                  <c:v>98.124984999999981</c:v>
                </c:pt>
                <c:pt idx="644">
                  <c:v>98.121308999999911</c:v>
                </c:pt>
                <c:pt idx="645">
                  <c:v>98.116030999999978</c:v>
                </c:pt>
                <c:pt idx="646">
                  <c:v>98.109504000000001</c:v>
                </c:pt>
                <c:pt idx="647">
                  <c:v>98.101287999999983</c:v>
                </c:pt>
                <c:pt idx="648">
                  <c:v>98.093981999999983</c:v>
                </c:pt>
                <c:pt idx="649">
                  <c:v>98.089912999999981</c:v>
                </c:pt>
                <c:pt idx="650">
                  <c:v>98.088501999999977</c:v>
                </c:pt>
                <c:pt idx="651">
                  <c:v>98.08839399999998</c:v>
                </c:pt>
                <c:pt idx="652">
                  <c:v>98.088472999999865</c:v>
                </c:pt>
                <c:pt idx="653">
                  <c:v>98.086922000000001</c:v>
                </c:pt>
                <c:pt idx="654">
                  <c:v>98.083348999999927</c:v>
                </c:pt>
                <c:pt idx="655">
                  <c:v>98.082083999999981</c:v>
                </c:pt>
                <c:pt idx="656">
                  <c:v>98.087173000000007</c:v>
                </c:pt>
                <c:pt idx="657">
                  <c:v>98.093271000000001</c:v>
                </c:pt>
                <c:pt idx="658">
                  <c:v>98.091396000000003</c:v>
                </c:pt>
                <c:pt idx="659">
                  <c:v>98.082437999999911</c:v>
                </c:pt>
                <c:pt idx="660">
                  <c:v>98.072426999999976</c:v>
                </c:pt>
                <c:pt idx="661">
                  <c:v>98.062218999999999</c:v>
                </c:pt>
                <c:pt idx="662">
                  <c:v>98.051980999999998</c:v>
                </c:pt>
                <c:pt idx="663">
                  <c:v>98.044802000000004</c:v>
                </c:pt>
                <c:pt idx="664">
                  <c:v>98.042027000000004</c:v>
                </c:pt>
                <c:pt idx="665">
                  <c:v>98.041882999999999</c:v>
                </c:pt>
                <c:pt idx="666">
                  <c:v>98.042299</c:v>
                </c:pt>
                <c:pt idx="667">
                  <c:v>98.043564000000003</c:v>
                </c:pt>
                <c:pt idx="668">
                  <c:v>98.048316</c:v>
                </c:pt>
                <c:pt idx="669">
                  <c:v>98.056783999999979</c:v>
                </c:pt>
                <c:pt idx="670">
                  <c:v>98.063165999999995</c:v>
                </c:pt>
                <c:pt idx="671">
                  <c:v>98.061977999999982</c:v>
                </c:pt>
                <c:pt idx="672">
                  <c:v>98.055802999999912</c:v>
                </c:pt>
                <c:pt idx="673">
                  <c:v>98.050841999999946</c:v>
                </c:pt>
                <c:pt idx="674">
                  <c:v>98.049216000000001</c:v>
                </c:pt>
                <c:pt idx="675">
                  <c:v>98.049476999999982</c:v>
                </c:pt>
                <c:pt idx="676">
                  <c:v>98.049694000000002</c:v>
                </c:pt>
                <c:pt idx="677">
                  <c:v>98.048007999999982</c:v>
                </c:pt>
                <c:pt idx="678">
                  <c:v>98.043152000000006</c:v>
                </c:pt>
                <c:pt idx="679">
                  <c:v>98.035101999999981</c:v>
                </c:pt>
                <c:pt idx="680">
                  <c:v>98.024280000000005</c:v>
                </c:pt>
                <c:pt idx="681">
                  <c:v>98.011643000000007</c:v>
                </c:pt>
                <c:pt idx="682">
                  <c:v>97.999986000000007</c:v>
                </c:pt>
                <c:pt idx="683">
                  <c:v>97.992873000000003</c:v>
                </c:pt>
                <c:pt idx="684">
                  <c:v>97.992336999999978</c:v>
                </c:pt>
                <c:pt idx="685">
                  <c:v>97.997928000000002</c:v>
                </c:pt>
                <c:pt idx="686">
                  <c:v>98.00667799999998</c:v>
                </c:pt>
                <c:pt idx="687">
                  <c:v>98.014883999999995</c:v>
                </c:pt>
                <c:pt idx="688">
                  <c:v>98.020641999999981</c:v>
                </c:pt>
                <c:pt idx="689">
                  <c:v>98.023829000000006</c:v>
                </c:pt>
                <c:pt idx="690">
                  <c:v>98.024887999999976</c:v>
                </c:pt>
                <c:pt idx="691">
                  <c:v>98.024952999999982</c:v>
                </c:pt>
                <c:pt idx="692">
                  <c:v>98.025815999999978</c:v>
                </c:pt>
                <c:pt idx="693">
                  <c:v>98.028603000000004</c:v>
                </c:pt>
                <c:pt idx="694">
                  <c:v>98.032690000000002</c:v>
                </c:pt>
                <c:pt idx="695">
                  <c:v>98.035772999999892</c:v>
                </c:pt>
                <c:pt idx="696">
                  <c:v>98.035494999999983</c:v>
                </c:pt>
                <c:pt idx="697">
                  <c:v>98.032218999999998</c:v>
                </c:pt>
                <c:pt idx="698">
                  <c:v>98.028553000000002</c:v>
                </c:pt>
                <c:pt idx="699">
                  <c:v>98.025690999999981</c:v>
                </c:pt>
                <c:pt idx="700">
                  <c:v>98.023340999999945</c:v>
                </c:pt>
                <c:pt idx="701">
                  <c:v>98.021833000000001</c:v>
                </c:pt>
                <c:pt idx="702">
                  <c:v>98.020957999999979</c:v>
                </c:pt>
                <c:pt idx="703">
                  <c:v>98.018941999999981</c:v>
                </c:pt>
                <c:pt idx="704">
                  <c:v>98.014888999999982</c:v>
                </c:pt>
                <c:pt idx="705">
                  <c:v>98.010226000000003</c:v>
                </c:pt>
                <c:pt idx="706">
                  <c:v>98.006336999999945</c:v>
                </c:pt>
                <c:pt idx="707">
                  <c:v>98.002769000000001</c:v>
                </c:pt>
                <c:pt idx="708">
                  <c:v>97.998786999999979</c:v>
                </c:pt>
                <c:pt idx="709">
                  <c:v>97.994800999999995</c:v>
                </c:pt>
                <c:pt idx="710">
                  <c:v>97.991365999999999</c:v>
                </c:pt>
                <c:pt idx="711">
                  <c:v>97.987650000000002</c:v>
                </c:pt>
                <c:pt idx="712">
                  <c:v>97.982258000000002</c:v>
                </c:pt>
                <c:pt idx="713">
                  <c:v>97.975782999999893</c:v>
                </c:pt>
                <c:pt idx="714">
                  <c:v>97.970230000000001</c:v>
                </c:pt>
                <c:pt idx="715">
                  <c:v>97.965948999999981</c:v>
                </c:pt>
                <c:pt idx="716">
                  <c:v>97.961546999999996</c:v>
                </c:pt>
                <c:pt idx="717">
                  <c:v>97.955885999999978</c:v>
                </c:pt>
                <c:pt idx="718">
                  <c:v>97.948881999999998</c:v>
                </c:pt>
                <c:pt idx="719">
                  <c:v>97.941519</c:v>
                </c:pt>
                <c:pt idx="720">
                  <c:v>97.935193999999996</c:v>
                </c:pt>
                <c:pt idx="721">
                  <c:v>97.930858999999998</c:v>
                </c:pt>
                <c:pt idx="722">
                  <c:v>97.929418999999982</c:v>
                </c:pt>
                <c:pt idx="723">
                  <c:v>97.931482000000003</c:v>
                </c:pt>
                <c:pt idx="724">
                  <c:v>97.935136</c:v>
                </c:pt>
                <c:pt idx="725">
                  <c:v>97.936462000000006</c:v>
                </c:pt>
                <c:pt idx="726">
                  <c:v>97.933761000000004</c:v>
                </c:pt>
                <c:pt idx="727">
                  <c:v>97.928705999999977</c:v>
                </c:pt>
                <c:pt idx="728">
                  <c:v>97.923367999999982</c:v>
                </c:pt>
                <c:pt idx="729">
                  <c:v>97.918877999999978</c:v>
                </c:pt>
                <c:pt idx="730">
                  <c:v>97.915991000000005</c:v>
                </c:pt>
                <c:pt idx="731">
                  <c:v>97.914882000000006</c:v>
                </c:pt>
                <c:pt idx="732">
                  <c:v>97.914724000000007</c:v>
                </c:pt>
                <c:pt idx="733">
                  <c:v>97.913781</c:v>
                </c:pt>
                <c:pt idx="734">
                  <c:v>97.910113999999993</c:v>
                </c:pt>
                <c:pt idx="735">
                  <c:v>97.903439000000006</c:v>
                </c:pt>
                <c:pt idx="736">
                  <c:v>97.895840999999976</c:v>
                </c:pt>
                <c:pt idx="737">
                  <c:v>97.889028999999979</c:v>
                </c:pt>
                <c:pt idx="738">
                  <c:v>97.881826000000004</c:v>
                </c:pt>
                <c:pt idx="739">
                  <c:v>97.871825999999999</c:v>
                </c:pt>
                <c:pt idx="740">
                  <c:v>97.858505999999977</c:v>
                </c:pt>
                <c:pt idx="741">
                  <c:v>97.843587999999983</c:v>
                </c:pt>
                <c:pt idx="742">
                  <c:v>97.829093</c:v>
                </c:pt>
                <c:pt idx="743">
                  <c:v>97.816870999999978</c:v>
                </c:pt>
                <c:pt idx="744">
                  <c:v>97.809674999999999</c:v>
                </c:pt>
                <c:pt idx="745">
                  <c:v>97.810077999999976</c:v>
                </c:pt>
                <c:pt idx="746">
                  <c:v>97.817583999999997</c:v>
                </c:pt>
                <c:pt idx="747">
                  <c:v>97.828029999999984</c:v>
                </c:pt>
                <c:pt idx="748">
                  <c:v>97.83643799999993</c:v>
                </c:pt>
                <c:pt idx="749">
                  <c:v>97.83999</c:v>
                </c:pt>
                <c:pt idx="750">
                  <c:v>97.838520000000003</c:v>
                </c:pt>
                <c:pt idx="751">
                  <c:v>97.833444</c:v>
                </c:pt>
                <c:pt idx="752">
                  <c:v>97.826255000000003</c:v>
                </c:pt>
                <c:pt idx="753">
                  <c:v>97.817637000000005</c:v>
                </c:pt>
                <c:pt idx="754">
                  <c:v>97.808438999999893</c:v>
                </c:pt>
                <c:pt idx="755">
                  <c:v>97.800396999999975</c:v>
                </c:pt>
                <c:pt idx="756">
                  <c:v>97.794731999999982</c:v>
                </c:pt>
                <c:pt idx="757">
                  <c:v>97.791274000000001</c:v>
                </c:pt>
                <c:pt idx="758">
                  <c:v>97.789833000000002</c:v>
                </c:pt>
                <c:pt idx="759">
                  <c:v>97.791062999999994</c:v>
                </c:pt>
                <c:pt idx="760">
                  <c:v>97.794983999999999</c:v>
                </c:pt>
                <c:pt idx="761">
                  <c:v>97.799864999999997</c:v>
                </c:pt>
                <c:pt idx="762">
                  <c:v>97.803511999999998</c:v>
                </c:pt>
                <c:pt idx="763">
                  <c:v>97.804677999999981</c:v>
                </c:pt>
                <c:pt idx="764">
                  <c:v>97.803000999999981</c:v>
                </c:pt>
                <c:pt idx="765">
                  <c:v>97.798598999999982</c:v>
                </c:pt>
                <c:pt idx="766">
                  <c:v>97.792248000000001</c:v>
                </c:pt>
                <c:pt idx="767">
                  <c:v>97.78546799999998</c:v>
                </c:pt>
                <c:pt idx="768">
                  <c:v>97.779526000000004</c:v>
                </c:pt>
                <c:pt idx="769">
                  <c:v>97.774467000000001</c:v>
                </c:pt>
                <c:pt idx="770">
                  <c:v>97.769661999999997</c:v>
                </c:pt>
                <c:pt idx="771">
                  <c:v>97.764653999999993</c:v>
                </c:pt>
                <c:pt idx="772">
                  <c:v>97.75943599999998</c:v>
                </c:pt>
                <c:pt idx="773">
                  <c:v>97.754433000000006</c:v>
                </c:pt>
                <c:pt idx="774">
                  <c:v>97.749810999999994</c:v>
                </c:pt>
                <c:pt idx="775">
                  <c:v>97.745334</c:v>
                </c:pt>
                <c:pt idx="776">
                  <c:v>97.741133000000005</c:v>
                </c:pt>
                <c:pt idx="777">
                  <c:v>97.737345000000005</c:v>
                </c:pt>
                <c:pt idx="778">
                  <c:v>97.733259000000004</c:v>
                </c:pt>
                <c:pt idx="779">
                  <c:v>97.727718999999979</c:v>
                </c:pt>
                <c:pt idx="780">
                  <c:v>97.720252000000002</c:v>
                </c:pt>
                <c:pt idx="781">
                  <c:v>97.711887000000004</c:v>
                </c:pt>
                <c:pt idx="782">
                  <c:v>97.704221000000004</c:v>
                </c:pt>
                <c:pt idx="783">
                  <c:v>97.697298000000004</c:v>
                </c:pt>
                <c:pt idx="784">
                  <c:v>97.689768999999927</c:v>
                </c:pt>
                <c:pt idx="785">
                  <c:v>97.680816999999976</c:v>
                </c:pt>
                <c:pt idx="786">
                  <c:v>97.670791999999892</c:v>
                </c:pt>
                <c:pt idx="787">
                  <c:v>97.660874999999976</c:v>
                </c:pt>
                <c:pt idx="788">
                  <c:v>97.652229999999975</c:v>
                </c:pt>
                <c:pt idx="789">
                  <c:v>97.644771999999946</c:v>
                </c:pt>
                <c:pt idx="790">
                  <c:v>97.637327999999982</c:v>
                </c:pt>
                <c:pt idx="791">
                  <c:v>97.629019999999983</c:v>
                </c:pt>
                <c:pt idx="792">
                  <c:v>97.619878999999912</c:v>
                </c:pt>
                <c:pt idx="793">
                  <c:v>97.610292000000001</c:v>
                </c:pt>
                <c:pt idx="794">
                  <c:v>97.600376999999895</c:v>
                </c:pt>
                <c:pt idx="795">
                  <c:v>97.590062000000003</c:v>
                </c:pt>
                <c:pt idx="796">
                  <c:v>97.57957399999998</c:v>
                </c:pt>
                <c:pt idx="797">
                  <c:v>97.569452999999982</c:v>
                </c:pt>
                <c:pt idx="798">
                  <c:v>97.55981199999998</c:v>
                </c:pt>
                <c:pt idx="799">
                  <c:v>97.549966999999995</c:v>
                </c:pt>
                <c:pt idx="800">
                  <c:v>97.539353000000006</c:v>
                </c:pt>
                <c:pt idx="801">
                  <c:v>97.528604000000001</c:v>
                </c:pt>
                <c:pt idx="802">
                  <c:v>97.518856999999983</c:v>
                </c:pt>
                <c:pt idx="803">
                  <c:v>97.510125000000002</c:v>
                </c:pt>
                <c:pt idx="804">
                  <c:v>97.501615999999999</c:v>
                </c:pt>
                <c:pt idx="805">
                  <c:v>97.493493999999998</c:v>
                </c:pt>
                <c:pt idx="806">
                  <c:v>97.486440999999999</c:v>
                </c:pt>
                <c:pt idx="807">
                  <c:v>97.479779999999977</c:v>
                </c:pt>
                <c:pt idx="808">
                  <c:v>97.472252999999981</c:v>
                </c:pt>
                <c:pt idx="809">
                  <c:v>97.464281</c:v>
                </c:pt>
                <c:pt idx="810">
                  <c:v>97.457199000000003</c:v>
                </c:pt>
                <c:pt idx="811">
                  <c:v>97.450879999999998</c:v>
                </c:pt>
                <c:pt idx="812">
                  <c:v>97.444013999999996</c:v>
                </c:pt>
                <c:pt idx="813">
                  <c:v>97.436311000000003</c:v>
                </c:pt>
                <c:pt idx="814">
                  <c:v>97.429962000000003</c:v>
                </c:pt>
                <c:pt idx="815">
                  <c:v>97.429053999999994</c:v>
                </c:pt>
                <c:pt idx="816">
                  <c:v>97.436249000000004</c:v>
                </c:pt>
                <c:pt idx="817">
                  <c:v>97.450199999999995</c:v>
                </c:pt>
                <c:pt idx="818">
                  <c:v>97.467529999999996</c:v>
                </c:pt>
                <c:pt idx="819">
                  <c:v>97.485385999999977</c:v>
                </c:pt>
                <c:pt idx="820">
                  <c:v>97.501326000000006</c:v>
                </c:pt>
                <c:pt idx="821">
                  <c:v>97.513581000000002</c:v>
                </c:pt>
                <c:pt idx="822">
                  <c:v>97.522144999999981</c:v>
                </c:pt>
                <c:pt idx="823">
                  <c:v>97.528380999999897</c:v>
                </c:pt>
                <c:pt idx="824">
                  <c:v>97.533913999999996</c:v>
                </c:pt>
                <c:pt idx="825">
                  <c:v>97.539862999999983</c:v>
                </c:pt>
                <c:pt idx="826">
                  <c:v>97.546299000000005</c:v>
                </c:pt>
                <c:pt idx="827">
                  <c:v>97.552389999999946</c:v>
                </c:pt>
                <c:pt idx="828">
                  <c:v>97.557320000000004</c:v>
                </c:pt>
                <c:pt idx="829">
                  <c:v>97.561042</c:v>
                </c:pt>
                <c:pt idx="830">
                  <c:v>97.564178999999982</c:v>
                </c:pt>
                <c:pt idx="831">
                  <c:v>97.567800000000005</c:v>
                </c:pt>
                <c:pt idx="832">
                  <c:v>97.573164000000006</c:v>
                </c:pt>
                <c:pt idx="833">
                  <c:v>97.580285000000003</c:v>
                </c:pt>
                <c:pt idx="834">
                  <c:v>97.587249</c:v>
                </c:pt>
                <c:pt idx="835">
                  <c:v>97.592721999999981</c:v>
                </c:pt>
                <c:pt idx="836">
                  <c:v>97.597517999999994</c:v>
                </c:pt>
                <c:pt idx="837">
                  <c:v>97.602069999999983</c:v>
                </c:pt>
                <c:pt idx="838">
                  <c:v>97.604996999999983</c:v>
                </c:pt>
                <c:pt idx="839">
                  <c:v>97.605529000000004</c:v>
                </c:pt>
                <c:pt idx="840">
                  <c:v>97.604793999999998</c:v>
                </c:pt>
                <c:pt idx="841">
                  <c:v>97.60404699999998</c:v>
                </c:pt>
                <c:pt idx="842">
                  <c:v>97.603440999999975</c:v>
                </c:pt>
                <c:pt idx="843">
                  <c:v>97.602724999999978</c:v>
                </c:pt>
                <c:pt idx="844">
                  <c:v>97.602438999999876</c:v>
                </c:pt>
                <c:pt idx="845">
                  <c:v>97.604090999999983</c:v>
                </c:pt>
                <c:pt idx="846">
                  <c:v>97.608790999999911</c:v>
                </c:pt>
                <c:pt idx="847">
                  <c:v>97.616148999999979</c:v>
                </c:pt>
                <c:pt idx="848">
                  <c:v>97.624652999999981</c:v>
                </c:pt>
                <c:pt idx="849">
                  <c:v>97.632664000000005</c:v>
                </c:pt>
                <c:pt idx="850">
                  <c:v>97.639445999999978</c:v>
                </c:pt>
                <c:pt idx="851">
                  <c:v>97.645276999999979</c:v>
                </c:pt>
                <c:pt idx="852">
                  <c:v>97.650376999999892</c:v>
                </c:pt>
                <c:pt idx="853">
                  <c:v>97.654623999999998</c:v>
                </c:pt>
                <c:pt idx="854">
                  <c:v>97.658192999999912</c:v>
                </c:pt>
                <c:pt idx="855">
                  <c:v>97.661277999999982</c:v>
                </c:pt>
                <c:pt idx="856">
                  <c:v>97.663633000000004</c:v>
                </c:pt>
                <c:pt idx="857">
                  <c:v>97.665137999999928</c:v>
                </c:pt>
                <c:pt idx="858">
                  <c:v>97.666353999999998</c:v>
                </c:pt>
                <c:pt idx="859">
                  <c:v>97.668348999999893</c:v>
                </c:pt>
                <c:pt idx="860">
                  <c:v>97.672215999999977</c:v>
                </c:pt>
                <c:pt idx="861">
                  <c:v>97.678385999999875</c:v>
                </c:pt>
                <c:pt idx="862">
                  <c:v>97.686249000000004</c:v>
                </c:pt>
                <c:pt idx="863">
                  <c:v>97.694703000000004</c:v>
                </c:pt>
                <c:pt idx="864">
                  <c:v>97.703055000000006</c:v>
                </c:pt>
                <c:pt idx="865">
                  <c:v>97.711562999999998</c:v>
                </c:pt>
                <c:pt idx="866">
                  <c:v>97.721098999999981</c:v>
                </c:pt>
                <c:pt idx="867">
                  <c:v>97.732000999999983</c:v>
                </c:pt>
                <c:pt idx="868">
                  <c:v>97.743617999999998</c:v>
                </c:pt>
                <c:pt idx="869">
                  <c:v>97.75515799999998</c:v>
                </c:pt>
                <c:pt idx="870">
                  <c:v>97.766075000000001</c:v>
                </c:pt>
                <c:pt idx="871">
                  <c:v>97.775143999999983</c:v>
                </c:pt>
                <c:pt idx="872">
                  <c:v>97.780319000000006</c:v>
                </c:pt>
                <c:pt idx="873">
                  <c:v>97.780540999999999</c:v>
                </c:pt>
                <c:pt idx="874">
                  <c:v>97.776929999999993</c:v>
                </c:pt>
                <c:pt idx="875">
                  <c:v>97.771214000000001</c:v>
                </c:pt>
                <c:pt idx="876">
                  <c:v>97.763289</c:v>
                </c:pt>
                <c:pt idx="877">
                  <c:v>97.751170000000002</c:v>
                </c:pt>
                <c:pt idx="878">
                  <c:v>97.733153000000001</c:v>
                </c:pt>
                <c:pt idx="879">
                  <c:v>97.710307999999998</c:v>
                </c:pt>
                <c:pt idx="880">
                  <c:v>97.689500999999979</c:v>
                </c:pt>
                <c:pt idx="881">
                  <c:v>97.682710999999927</c:v>
                </c:pt>
                <c:pt idx="882">
                  <c:v>97.697486999999981</c:v>
                </c:pt>
                <c:pt idx="883">
                  <c:v>97.729007999999979</c:v>
                </c:pt>
                <c:pt idx="884">
                  <c:v>97.765500000000003</c:v>
                </c:pt>
                <c:pt idx="885">
                  <c:v>97.797794999999994</c:v>
                </c:pt>
                <c:pt idx="886">
                  <c:v>97.821139000000002</c:v>
                </c:pt>
                <c:pt idx="887">
                  <c:v>97.833309</c:v>
                </c:pt>
                <c:pt idx="888">
                  <c:v>97.834074000000001</c:v>
                </c:pt>
                <c:pt idx="889">
                  <c:v>97.824406999999979</c:v>
                </c:pt>
                <c:pt idx="890">
                  <c:v>97.805746999999911</c:v>
                </c:pt>
                <c:pt idx="891">
                  <c:v>97.78033199999993</c:v>
                </c:pt>
                <c:pt idx="892">
                  <c:v>97.751154</c:v>
                </c:pt>
                <c:pt idx="893">
                  <c:v>97.721037999999979</c:v>
                </c:pt>
                <c:pt idx="894">
                  <c:v>97.692164000000005</c:v>
                </c:pt>
                <c:pt idx="895">
                  <c:v>97.666576999999975</c:v>
                </c:pt>
                <c:pt idx="896">
                  <c:v>97.646253999999999</c:v>
                </c:pt>
                <c:pt idx="897">
                  <c:v>97.632094999999978</c:v>
                </c:pt>
                <c:pt idx="898">
                  <c:v>97.623761999999928</c:v>
                </c:pt>
                <c:pt idx="899">
                  <c:v>97.620550999999978</c:v>
                </c:pt>
                <c:pt idx="900">
                  <c:v>97.621355999999977</c:v>
                </c:pt>
                <c:pt idx="901">
                  <c:v>97.624218999999982</c:v>
                </c:pt>
                <c:pt idx="902">
                  <c:v>97.626719999999978</c:v>
                </c:pt>
                <c:pt idx="903">
                  <c:v>97.626905999999977</c:v>
                </c:pt>
                <c:pt idx="904">
                  <c:v>97.624234000000001</c:v>
                </c:pt>
                <c:pt idx="905">
                  <c:v>97.619945000000001</c:v>
                </c:pt>
                <c:pt idx="906">
                  <c:v>97.616465000000005</c:v>
                </c:pt>
                <c:pt idx="907">
                  <c:v>97.615970999999931</c:v>
                </c:pt>
                <c:pt idx="908">
                  <c:v>97.619096999999982</c:v>
                </c:pt>
                <c:pt idx="909">
                  <c:v>97.624933999999982</c:v>
                </c:pt>
                <c:pt idx="910">
                  <c:v>97.632053999999982</c:v>
                </c:pt>
                <c:pt idx="911">
                  <c:v>97.639060000000001</c:v>
                </c:pt>
                <c:pt idx="912">
                  <c:v>97.644700999999998</c:v>
                </c:pt>
                <c:pt idx="913">
                  <c:v>97.648572999999928</c:v>
                </c:pt>
                <c:pt idx="914">
                  <c:v>97.651075999999946</c:v>
                </c:pt>
                <c:pt idx="915">
                  <c:v>97.651879999999977</c:v>
                </c:pt>
                <c:pt idx="916">
                  <c:v>97.650045999999946</c:v>
                </c:pt>
                <c:pt idx="917">
                  <c:v>97.645888999999912</c:v>
                </c:pt>
                <c:pt idx="918">
                  <c:v>97.641146000000006</c:v>
                </c:pt>
                <c:pt idx="919">
                  <c:v>97.637694999999994</c:v>
                </c:pt>
                <c:pt idx="920">
                  <c:v>97.636431999999928</c:v>
                </c:pt>
                <c:pt idx="921">
                  <c:v>97.636575999999977</c:v>
                </c:pt>
                <c:pt idx="922">
                  <c:v>97.636105000000001</c:v>
                </c:pt>
                <c:pt idx="923">
                  <c:v>97.633246999999983</c:v>
                </c:pt>
                <c:pt idx="924">
                  <c:v>97.627544999999998</c:v>
                </c:pt>
                <c:pt idx="925">
                  <c:v>97.61953699999998</c:v>
                </c:pt>
                <c:pt idx="926">
                  <c:v>97.609879999999976</c:v>
                </c:pt>
                <c:pt idx="927">
                  <c:v>97.599232000000001</c:v>
                </c:pt>
                <c:pt idx="928">
                  <c:v>97.58846699999998</c:v>
                </c:pt>
                <c:pt idx="929">
                  <c:v>97.578539999999975</c:v>
                </c:pt>
                <c:pt idx="930">
                  <c:v>97.570495999999977</c:v>
                </c:pt>
                <c:pt idx="931">
                  <c:v>97.565455999999998</c:v>
                </c:pt>
                <c:pt idx="932">
                  <c:v>97.56438799999998</c:v>
                </c:pt>
                <c:pt idx="933">
                  <c:v>97.567903000000001</c:v>
                </c:pt>
                <c:pt idx="934">
                  <c:v>97.575712999999865</c:v>
                </c:pt>
                <c:pt idx="935">
                  <c:v>97.586220999999995</c:v>
                </c:pt>
                <c:pt idx="936">
                  <c:v>97.597290999999998</c:v>
                </c:pt>
                <c:pt idx="937">
                  <c:v>97.607162000000002</c:v>
                </c:pt>
                <c:pt idx="938">
                  <c:v>97.614310000000003</c:v>
                </c:pt>
                <c:pt idx="939">
                  <c:v>97.617477999999977</c:v>
                </c:pt>
                <c:pt idx="940">
                  <c:v>97.616422</c:v>
                </c:pt>
                <c:pt idx="941">
                  <c:v>97.612001999999976</c:v>
                </c:pt>
                <c:pt idx="942">
                  <c:v>97.605316999999928</c:v>
                </c:pt>
                <c:pt idx="943">
                  <c:v>97.596786999999978</c:v>
                </c:pt>
                <c:pt idx="944">
                  <c:v>97.585920000000002</c:v>
                </c:pt>
                <c:pt idx="945">
                  <c:v>97.572435999999911</c:v>
                </c:pt>
                <c:pt idx="946">
                  <c:v>97.557595000000006</c:v>
                </c:pt>
                <c:pt idx="947">
                  <c:v>97.544195999999999</c:v>
                </c:pt>
                <c:pt idx="948">
                  <c:v>97.535543000000004</c:v>
                </c:pt>
                <c:pt idx="949">
                  <c:v>97.533826000000005</c:v>
                </c:pt>
                <c:pt idx="950">
                  <c:v>97.538723000000005</c:v>
                </c:pt>
                <c:pt idx="951">
                  <c:v>97.548124000000001</c:v>
                </c:pt>
                <c:pt idx="952">
                  <c:v>97.560140000000004</c:v>
                </c:pt>
                <c:pt idx="953">
                  <c:v>97.573549</c:v>
                </c:pt>
                <c:pt idx="954">
                  <c:v>97.586984999999999</c:v>
                </c:pt>
                <c:pt idx="955">
                  <c:v>97.599071999999978</c:v>
                </c:pt>
                <c:pt idx="956">
                  <c:v>97.609233000000003</c:v>
                </c:pt>
                <c:pt idx="957">
                  <c:v>97.617569000000003</c:v>
                </c:pt>
                <c:pt idx="958">
                  <c:v>97.624128999999982</c:v>
                </c:pt>
                <c:pt idx="959">
                  <c:v>97.628858999999892</c:v>
                </c:pt>
                <c:pt idx="960">
                  <c:v>97.631963999999996</c:v>
                </c:pt>
                <c:pt idx="961">
                  <c:v>97.63387599999993</c:v>
                </c:pt>
                <c:pt idx="962">
                  <c:v>97.634545000000003</c:v>
                </c:pt>
                <c:pt idx="963">
                  <c:v>97.633020999999999</c:v>
                </c:pt>
                <c:pt idx="964">
                  <c:v>97.628470999999891</c:v>
                </c:pt>
                <c:pt idx="965">
                  <c:v>97.621245000000002</c:v>
                </c:pt>
                <c:pt idx="966">
                  <c:v>97.612869999999987</c:v>
                </c:pt>
                <c:pt idx="967">
                  <c:v>97.606201999999982</c:v>
                </c:pt>
                <c:pt idx="968">
                  <c:v>97.604324000000005</c:v>
                </c:pt>
                <c:pt idx="969">
                  <c:v>97.607732999999897</c:v>
                </c:pt>
                <c:pt idx="970">
                  <c:v>97.614198000000002</c:v>
                </c:pt>
                <c:pt idx="971">
                  <c:v>97.621491999999947</c:v>
                </c:pt>
                <c:pt idx="972">
                  <c:v>97.628284999999977</c:v>
                </c:pt>
                <c:pt idx="973">
                  <c:v>97.633327999999977</c:v>
                </c:pt>
                <c:pt idx="974">
                  <c:v>97.635788999999875</c:v>
                </c:pt>
                <c:pt idx="975">
                  <c:v>97.63614699999998</c:v>
                </c:pt>
                <c:pt idx="976">
                  <c:v>97.63576399999998</c:v>
                </c:pt>
                <c:pt idx="977">
                  <c:v>97.635508999999928</c:v>
                </c:pt>
                <c:pt idx="978">
                  <c:v>97.635333999999929</c:v>
                </c:pt>
                <c:pt idx="979">
                  <c:v>97.634836999999976</c:v>
                </c:pt>
                <c:pt idx="980">
                  <c:v>97.633324000000002</c:v>
                </c:pt>
                <c:pt idx="981">
                  <c:v>97.629854999999978</c:v>
                </c:pt>
                <c:pt idx="982">
                  <c:v>97.623935999999929</c:v>
                </c:pt>
                <c:pt idx="983">
                  <c:v>97.615893</c:v>
                </c:pt>
                <c:pt idx="984">
                  <c:v>97.606244000000004</c:v>
                </c:pt>
                <c:pt idx="985">
                  <c:v>97.595160000000007</c:v>
                </c:pt>
                <c:pt idx="986">
                  <c:v>97.58378399999998</c:v>
                </c:pt>
                <c:pt idx="987">
                  <c:v>97.575766999999928</c:v>
                </c:pt>
                <c:pt idx="988">
                  <c:v>97.574867999999981</c:v>
                </c:pt>
                <c:pt idx="989">
                  <c:v>97.580465000000004</c:v>
                </c:pt>
                <c:pt idx="990">
                  <c:v>97.587592000000001</c:v>
                </c:pt>
                <c:pt idx="991">
                  <c:v>97.591728000000003</c:v>
                </c:pt>
                <c:pt idx="992">
                  <c:v>97.591814999999997</c:v>
                </c:pt>
                <c:pt idx="993">
                  <c:v>97.589087999999975</c:v>
                </c:pt>
                <c:pt idx="994">
                  <c:v>97.585445999999976</c:v>
                </c:pt>
                <c:pt idx="995">
                  <c:v>97.582925000000003</c:v>
                </c:pt>
                <c:pt idx="996">
                  <c:v>97.582369</c:v>
                </c:pt>
                <c:pt idx="997">
                  <c:v>97.582479999999975</c:v>
                </c:pt>
                <c:pt idx="998">
                  <c:v>97.581513000000001</c:v>
                </c:pt>
                <c:pt idx="999">
                  <c:v>97.579132999999928</c:v>
                </c:pt>
                <c:pt idx="1000">
                  <c:v>97.575944999999976</c:v>
                </c:pt>
                <c:pt idx="1001">
                  <c:v>97.572908999999896</c:v>
                </c:pt>
                <c:pt idx="1002">
                  <c:v>97.57143499999998</c:v>
                </c:pt>
                <c:pt idx="1003">
                  <c:v>97.572104999999979</c:v>
                </c:pt>
                <c:pt idx="1004">
                  <c:v>97.573693000000006</c:v>
                </c:pt>
                <c:pt idx="1005">
                  <c:v>97.574566000000004</c:v>
                </c:pt>
                <c:pt idx="1006">
                  <c:v>97.573967999999979</c:v>
                </c:pt>
                <c:pt idx="1007">
                  <c:v>97.571939</c:v>
                </c:pt>
                <c:pt idx="1008">
                  <c:v>97.569136999999998</c:v>
                </c:pt>
                <c:pt idx="1009">
                  <c:v>97.566080999999983</c:v>
                </c:pt>
                <c:pt idx="1010">
                  <c:v>97.562465000000003</c:v>
                </c:pt>
                <c:pt idx="1011">
                  <c:v>97.55827799999993</c:v>
                </c:pt>
                <c:pt idx="1012">
                  <c:v>97.554242000000002</c:v>
                </c:pt>
                <c:pt idx="1013">
                  <c:v>97.550446999999977</c:v>
                </c:pt>
                <c:pt idx="1014">
                  <c:v>97.546633999999997</c:v>
                </c:pt>
                <c:pt idx="1015">
                  <c:v>97.543204000000003</c:v>
                </c:pt>
                <c:pt idx="1016">
                  <c:v>97.540346999999983</c:v>
                </c:pt>
                <c:pt idx="1017">
                  <c:v>97.537690999999995</c:v>
                </c:pt>
                <c:pt idx="1018">
                  <c:v>97.534979000000007</c:v>
                </c:pt>
                <c:pt idx="1019">
                  <c:v>97.531713999999994</c:v>
                </c:pt>
                <c:pt idx="1020">
                  <c:v>97.527107999999998</c:v>
                </c:pt>
                <c:pt idx="1021">
                  <c:v>97.521219000000002</c:v>
                </c:pt>
                <c:pt idx="1022">
                  <c:v>97.514799999999994</c:v>
                </c:pt>
                <c:pt idx="1023">
                  <c:v>97.508099999999999</c:v>
                </c:pt>
                <c:pt idx="1024">
                  <c:v>97.501047</c:v>
                </c:pt>
                <c:pt idx="1025">
                  <c:v>97.493983</c:v>
                </c:pt>
                <c:pt idx="1026">
                  <c:v>97.487587000000005</c:v>
                </c:pt>
                <c:pt idx="1027">
                  <c:v>97.482553999999993</c:v>
                </c:pt>
                <c:pt idx="1028">
                  <c:v>97.479043000000004</c:v>
                </c:pt>
                <c:pt idx="1029">
                  <c:v>97.476057999999981</c:v>
                </c:pt>
                <c:pt idx="1030">
                  <c:v>97.471716000000001</c:v>
                </c:pt>
                <c:pt idx="1031">
                  <c:v>97.464924999999994</c:v>
                </c:pt>
                <c:pt idx="1032">
                  <c:v>97.456765000000004</c:v>
                </c:pt>
                <c:pt idx="1033">
                  <c:v>97.449383999999995</c:v>
                </c:pt>
                <c:pt idx="1034">
                  <c:v>97.443888999999999</c:v>
                </c:pt>
                <c:pt idx="1035">
                  <c:v>97.439705000000004</c:v>
                </c:pt>
                <c:pt idx="1036">
                  <c:v>97.435457</c:v>
                </c:pt>
                <c:pt idx="1037">
                  <c:v>97.430323000000001</c:v>
                </c:pt>
                <c:pt idx="1038">
                  <c:v>97.424079000000006</c:v>
                </c:pt>
                <c:pt idx="1039">
                  <c:v>97.416255000000007</c:v>
                </c:pt>
                <c:pt idx="1040">
                  <c:v>97.406610000000001</c:v>
                </c:pt>
                <c:pt idx="1041">
                  <c:v>97.395612999999983</c:v>
                </c:pt>
                <c:pt idx="1042">
                  <c:v>97.383204000000006</c:v>
                </c:pt>
                <c:pt idx="1043">
                  <c:v>97.368211000000002</c:v>
                </c:pt>
                <c:pt idx="1044">
                  <c:v>97.349970000000013</c:v>
                </c:pt>
                <c:pt idx="1045">
                  <c:v>97.330987999999977</c:v>
                </c:pt>
                <c:pt idx="1046">
                  <c:v>97.317853999999997</c:v>
                </c:pt>
                <c:pt idx="1047">
                  <c:v>97.316265999999999</c:v>
                </c:pt>
                <c:pt idx="1048">
                  <c:v>97.323983999999982</c:v>
                </c:pt>
                <c:pt idx="1049">
                  <c:v>97.332245999999998</c:v>
                </c:pt>
                <c:pt idx="1050">
                  <c:v>97.334084000000004</c:v>
                </c:pt>
                <c:pt idx="1051">
                  <c:v>97.327945</c:v>
                </c:pt>
                <c:pt idx="1052">
                  <c:v>97.314543999999998</c:v>
                </c:pt>
                <c:pt idx="1053">
                  <c:v>97.293502000000004</c:v>
                </c:pt>
                <c:pt idx="1054">
                  <c:v>97.263159000000002</c:v>
                </c:pt>
                <c:pt idx="1055">
                  <c:v>97.222876999999912</c:v>
                </c:pt>
                <c:pt idx="1056">
                  <c:v>97.175710999999893</c:v>
                </c:pt>
                <c:pt idx="1057">
                  <c:v>97.129739999999927</c:v>
                </c:pt>
                <c:pt idx="1058">
                  <c:v>97.097618999999995</c:v>
                </c:pt>
                <c:pt idx="1059">
                  <c:v>97.090395999999998</c:v>
                </c:pt>
                <c:pt idx="1060">
                  <c:v>97.105824999999982</c:v>
                </c:pt>
                <c:pt idx="1061">
                  <c:v>97.127621000000005</c:v>
                </c:pt>
                <c:pt idx="1062">
                  <c:v>97.142325999999983</c:v>
                </c:pt>
                <c:pt idx="1063">
                  <c:v>97.151311999999976</c:v>
                </c:pt>
                <c:pt idx="1064">
                  <c:v>97.162776999999892</c:v>
                </c:pt>
                <c:pt idx="1065">
                  <c:v>97.178338999999823</c:v>
                </c:pt>
                <c:pt idx="1066">
                  <c:v>97.191535000000002</c:v>
                </c:pt>
                <c:pt idx="1067">
                  <c:v>97.196277999999978</c:v>
                </c:pt>
                <c:pt idx="1068">
                  <c:v>97.191543999999993</c:v>
                </c:pt>
                <c:pt idx="1069">
                  <c:v>97.178040999999865</c:v>
                </c:pt>
                <c:pt idx="1070">
                  <c:v>97.155844999999928</c:v>
                </c:pt>
                <c:pt idx="1071">
                  <c:v>97.126874999999927</c:v>
                </c:pt>
                <c:pt idx="1072">
                  <c:v>97.097313999999997</c:v>
                </c:pt>
                <c:pt idx="1073">
                  <c:v>97.075561999999977</c:v>
                </c:pt>
                <c:pt idx="1074">
                  <c:v>97.065618000000001</c:v>
                </c:pt>
                <c:pt idx="1075">
                  <c:v>97.063101000000003</c:v>
                </c:pt>
                <c:pt idx="1076">
                  <c:v>97.059771999999896</c:v>
                </c:pt>
                <c:pt idx="1077">
                  <c:v>97.050537999999946</c:v>
                </c:pt>
                <c:pt idx="1078">
                  <c:v>97.034487999999982</c:v>
                </c:pt>
                <c:pt idx="1079">
                  <c:v>97.011709999999994</c:v>
                </c:pt>
                <c:pt idx="1080">
                  <c:v>96.983998</c:v>
                </c:pt>
                <c:pt idx="1081">
                  <c:v>96.95913299999998</c:v>
                </c:pt>
                <c:pt idx="1082">
                  <c:v>96.947982999999994</c:v>
                </c:pt>
                <c:pt idx="1083">
                  <c:v>96.954013000000003</c:v>
                </c:pt>
                <c:pt idx="1084">
                  <c:v>96.97010299999998</c:v>
                </c:pt>
                <c:pt idx="1085">
                  <c:v>96.987082000000001</c:v>
                </c:pt>
                <c:pt idx="1086">
                  <c:v>97.000230999999999</c:v>
                </c:pt>
                <c:pt idx="1087">
                  <c:v>97.006957999999983</c:v>
                </c:pt>
                <c:pt idx="1088">
                  <c:v>97.00376799999998</c:v>
                </c:pt>
                <c:pt idx="1089">
                  <c:v>96.987999000000002</c:v>
                </c:pt>
                <c:pt idx="1090">
                  <c:v>96.959684999999993</c:v>
                </c:pt>
                <c:pt idx="1091">
                  <c:v>96.920168000000004</c:v>
                </c:pt>
                <c:pt idx="1092">
                  <c:v>96.870756999999927</c:v>
                </c:pt>
                <c:pt idx="1093">
                  <c:v>96.812821999999983</c:v>
                </c:pt>
                <c:pt idx="1094">
                  <c:v>96.748143999999996</c:v>
                </c:pt>
                <c:pt idx="1095">
                  <c:v>96.681309999999982</c:v>
                </c:pt>
                <c:pt idx="1096">
                  <c:v>96.621904000000001</c:v>
                </c:pt>
                <c:pt idx="1097">
                  <c:v>96.580530999999979</c:v>
                </c:pt>
                <c:pt idx="1098">
                  <c:v>96.560377999999929</c:v>
                </c:pt>
                <c:pt idx="1099">
                  <c:v>96.552699999999973</c:v>
                </c:pt>
                <c:pt idx="1100">
                  <c:v>96.540877999999978</c:v>
                </c:pt>
                <c:pt idx="1101">
                  <c:v>96.509344999999982</c:v>
                </c:pt>
                <c:pt idx="1102">
                  <c:v>96.450429999999997</c:v>
                </c:pt>
                <c:pt idx="1103">
                  <c:v>96.368445999999977</c:v>
                </c:pt>
                <c:pt idx="1104">
                  <c:v>96.282625999999993</c:v>
                </c:pt>
                <c:pt idx="1105">
                  <c:v>96.222639999999998</c:v>
                </c:pt>
                <c:pt idx="1106">
                  <c:v>96.209953999999996</c:v>
                </c:pt>
                <c:pt idx="1107">
                  <c:v>96.238303999999999</c:v>
                </c:pt>
                <c:pt idx="1108">
                  <c:v>96.276927000000001</c:v>
                </c:pt>
                <c:pt idx="1109">
                  <c:v>96.294704999999993</c:v>
                </c:pt>
                <c:pt idx="1110">
                  <c:v>96.279365999999982</c:v>
                </c:pt>
                <c:pt idx="1111">
                  <c:v>96.236960999999994</c:v>
                </c:pt>
                <c:pt idx="1112">
                  <c:v>96.177759999999978</c:v>
                </c:pt>
                <c:pt idx="1113">
                  <c:v>96.104097999999979</c:v>
                </c:pt>
                <c:pt idx="1114">
                  <c:v>96.010879000000003</c:v>
                </c:pt>
                <c:pt idx="1115">
                  <c:v>95.892750999999976</c:v>
                </c:pt>
                <c:pt idx="1116">
                  <c:v>95.742951000000005</c:v>
                </c:pt>
                <c:pt idx="1117">
                  <c:v>95.545575999999983</c:v>
                </c:pt>
                <c:pt idx="1118">
                  <c:v>95.281976</c:v>
                </c:pt>
                <c:pt idx="1119">
                  <c:v>94.960539999999995</c:v>
                </c:pt>
                <c:pt idx="1120">
                  <c:v>94.645478999999895</c:v>
                </c:pt>
                <c:pt idx="1121">
                  <c:v>94.441601000000006</c:v>
                </c:pt>
                <c:pt idx="1122">
                  <c:v>94.422179999999983</c:v>
                </c:pt>
                <c:pt idx="1123">
                  <c:v>94.561751999999998</c:v>
                </c:pt>
                <c:pt idx="1124">
                  <c:v>94.753493000000006</c:v>
                </c:pt>
                <c:pt idx="1125">
                  <c:v>94.891705000000002</c:v>
                </c:pt>
                <c:pt idx="1126">
                  <c:v>94.923365000000004</c:v>
                </c:pt>
                <c:pt idx="1127">
                  <c:v>94.836459000000005</c:v>
                </c:pt>
                <c:pt idx="1128">
                  <c:v>94.636300000000006</c:v>
                </c:pt>
                <c:pt idx="1129">
                  <c:v>94.343064999999996</c:v>
                </c:pt>
                <c:pt idx="1130">
                  <c:v>93.989805000000004</c:v>
                </c:pt>
                <c:pt idx="1131">
                  <c:v>93.608851999999928</c:v>
                </c:pt>
                <c:pt idx="1132">
                  <c:v>93.225907999999976</c:v>
                </c:pt>
                <c:pt idx="1133">
                  <c:v>92.861371999999946</c:v>
                </c:pt>
                <c:pt idx="1134">
                  <c:v>92.516709000000006</c:v>
                </c:pt>
                <c:pt idx="1135">
                  <c:v>92.157758999999928</c:v>
                </c:pt>
                <c:pt idx="1136">
                  <c:v>91.726224000000002</c:v>
                </c:pt>
                <c:pt idx="1137">
                  <c:v>91.185736999999875</c:v>
                </c:pt>
                <c:pt idx="1138">
                  <c:v>90.563780999999977</c:v>
                </c:pt>
                <c:pt idx="1139">
                  <c:v>89.940545999999998</c:v>
                </c:pt>
                <c:pt idx="1140">
                  <c:v>89.406516999999994</c:v>
                </c:pt>
                <c:pt idx="1141">
                  <c:v>89.064193000000003</c:v>
                </c:pt>
                <c:pt idx="1142">
                  <c:v>89.034216000000001</c:v>
                </c:pt>
                <c:pt idx="1143">
                  <c:v>89.381679000000005</c:v>
                </c:pt>
                <c:pt idx="1144">
                  <c:v>90.039951000000002</c:v>
                </c:pt>
                <c:pt idx="1145">
                  <c:v>90.844983999999997</c:v>
                </c:pt>
                <c:pt idx="1146">
                  <c:v>91.634676999999982</c:v>
                </c:pt>
                <c:pt idx="1147">
                  <c:v>92.301212000000007</c:v>
                </c:pt>
                <c:pt idx="1148">
                  <c:v>92.785354999999981</c:v>
                </c:pt>
                <c:pt idx="1149">
                  <c:v>93.066474999999983</c:v>
                </c:pt>
                <c:pt idx="1150">
                  <c:v>93.174869999999984</c:v>
                </c:pt>
                <c:pt idx="1151">
                  <c:v>93.196730999999929</c:v>
                </c:pt>
                <c:pt idx="1152">
                  <c:v>93.22823099999998</c:v>
                </c:pt>
                <c:pt idx="1153">
                  <c:v>93.305221000000003</c:v>
                </c:pt>
                <c:pt idx="1154">
                  <c:v>93.393445999999983</c:v>
                </c:pt>
                <c:pt idx="1155">
                  <c:v>93.449802000000005</c:v>
                </c:pt>
                <c:pt idx="1156">
                  <c:v>93.470528999999999</c:v>
                </c:pt>
                <c:pt idx="1157">
                  <c:v>93.476137999999978</c:v>
                </c:pt>
                <c:pt idx="1158">
                  <c:v>93.468834999999999</c:v>
                </c:pt>
                <c:pt idx="1159">
                  <c:v>93.418008</c:v>
                </c:pt>
                <c:pt idx="1160">
                  <c:v>93.290470000000013</c:v>
                </c:pt>
                <c:pt idx="1161">
                  <c:v>93.088199000000003</c:v>
                </c:pt>
                <c:pt idx="1162">
                  <c:v>92.847505999999996</c:v>
                </c:pt>
                <c:pt idx="1163">
                  <c:v>92.610023999999996</c:v>
                </c:pt>
                <c:pt idx="1164">
                  <c:v>92.401404999999997</c:v>
                </c:pt>
                <c:pt idx="1165">
                  <c:v>92.221258000000006</c:v>
                </c:pt>
                <c:pt idx="1166">
                  <c:v>92.044055</c:v>
                </c:pt>
                <c:pt idx="1167">
                  <c:v>91.837717999999981</c:v>
                </c:pt>
                <c:pt idx="1168">
                  <c:v>91.580849000000001</c:v>
                </c:pt>
                <c:pt idx="1169">
                  <c:v>91.261516</c:v>
                </c:pt>
                <c:pt idx="1170">
                  <c:v>90.865504000000001</c:v>
                </c:pt>
                <c:pt idx="1171">
                  <c:v>90.370591999999945</c:v>
                </c:pt>
                <c:pt idx="1172">
                  <c:v>89.748041000000001</c:v>
                </c:pt>
                <c:pt idx="1173">
                  <c:v>88.971919</c:v>
                </c:pt>
                <c:pt idx="1174">
                  <c:v>88.040490000000005</c:v>
                </c:pt>
                <c:pt idx="1175">
                  <c:v>87.004760000000005</c:v>
                </c:pt>
                <c:pt idx="1176">
                  <c:v>85.980636000000004</c:v>
                </c:pt>
                <c:pt idx="1177">
                  <c:v>85.131575999999981</c:v>
                </c:pt>
                <c:pt idx="1178">
                  <c:v>84.612578999999911</c:v>
                </c:pt>
                <c:pt idx="1179">
                  <c:v>84.511720999999994</c:v>
                </c:pt>
                <c:pt idx="1180">
                  <c:v>84.816659999999999</c:v>
                </c:pt>
                <c:pt idx="1181">
                  <c:v>85.431912999999994</c:v>
                </c:pt>
                <c:pt idx="1182">
                  <c:v>86.232315</c:v>
                </c:pt>
                <c:pt idx="1183">
                  <c:v>87.117450000000005</c:v>
                </c:pt>
                <c:pt idx="1184">
                  <c:v>88.03305899999998</c:v>
                </c:pt>
                <c:pt idx="1185">
                  <c:v>88.937910000000002</c:v>
                </c:pt>
                <c:pt idx="1186">
                  <c:v>89.760664000000006</c:v>
                </c:pt>
                <c:pt idx="1187">
                  <c:v>90.409857000000002</c:v>
                </c:pt>
                <c:pt idx="1188">
                  <c:v>90.82864499999998</c:v>
                </c:pt>
                <c:pt idx="1189">
                  <c:v>91.035245000000003</c:v>
                </c:pt>
                <c:pt idx="1190">
                  <c:v>91.107175999999981</c:v>
                </c:pt>
                <c:pt idx="1191">
                  <c:v>91.108888999999891</c:v>
                </c:pt>
                <c:pt idx="1192">
                  <c:v>91.041407000000007</c:v>
                </c:pt>
                <c:pt idx="1193">
                  <c:v>90.892032999999927</c:v>
                </c:pt>
                <c:pt idx="1194">
                  <c:v>90.752589999999998</c:v>
                </c:pt>
                <c:pt idx="1195">
                  <c:v>90.839746999999946</c:v>
                </c:pt>
                <c:pt idx="1196">
                  <c:v>91.286717999999979</c:v>
                </c:pt>
                <c:pt idx="1197">
                  <c:v>91.952403000000004</c:v>
                </c:pt>
                <c:pt idx="1198">
                  <c:v>92.581406999999999</c:v>
                </c:pt>
                <c:pt idx="1199">
                  <c:v>93.070670999999976</c:v>
                </c:pt>
                <c:pt idx="1200">
                  <c:v>93.465371999999945</c:v>
                </c:pt>
                <c:pt idx="1201">
                  <c:v>93.813937999999979</c:v>
                </c:pt>
                <c:pt idx="1202">
                  <c:v>94.113004000000004</c:v>
                </c:pt>
                <c:pt idx="1203">
                  <c:v>94.324788999999896</c:v>
                </c:pt>
                <c:pt idx="1204">
                  <c:v>94.427301999999983</c:v>
                </c:pt>
                <c:pt idx="1205">
                  <c:v>94.483924000000002</c:v>
                </c:pt>
                <c:pt idx="1206">
                  <c:v>94.618718999999928</c:v>
                </c:pt>
                <c:pt idx="1207">
                  <c:v>94.873259000000004</c:v>
                </c:pt>
                <c:pt idx="1208">
                  <c:v>95.159324999999981</c:v>
                </c:pt>
                <c:pt idx="1209">
                  <c:v>95.382437999999865</c:v>
                </c:pt>
                <c:pt idx="1210">
                  <c:v>95.527574999999999</c:v>
                </c:pt>
                <c:pt idx="1211">
                  <c:v>95.621710999999976</c:v>
                </c:pt>
                <c:pt idx="1212">
                  <c:v>95.685633999999979</c:v>
                </c:pt>
                <c:pt idx="1213">
                  <c:v>95.727553999999998</c:v>
                </c:pt>
                <c:pt idx="1214">
                  <c:v>95.749075000000005</c:v>
                </c:pt>
                <c:pt idx="1215">
                  <c:v>95.749100999999996</c:v>
                </c:pt>
                <c:pt idx="1216">
                  <c:v>95.727710999999999</c:v>
                </c:pt>
                <c:pt idx="1217">
                  <c:v>95.686676999999946</c:v>
                </c:pt>
                <c:pt idx="1218">
                  <c:v>95.627901999999978</c:v>
                </c:pt>
                <c:pt idx="1219">
                  <c:v>95.554924999999997</c:v>
                </c:pt>
                <c:pt idx="1220">
                  <c:v>95.474692000000005</c:v>
                </c:pt>
                <c:pt idx="1221">
                  <c:v>95.397419999999997</c:v>
                </c:pt>
                <c:pt idx="1222">
                  <c:v>95.336097999999978</c:v>
                </c:pt>
                <c:pt idx="1223">
                  <c:v>95.302684999999983</c:v>
                </c:pt>
                <c:pt idx="1224">
                  <c:v>95.301682</c:v>
                </c:pt>
                <c:pt idx="1225">
                  <c:v>95.328705999999912</c:v>
                </c:pt>
                <c:pt idx="1226">
                  <c:v>95.375037999999876</c:v>
                </c:pt>
                <c:pt idx="1227">
                  <c:v>95.431211000000005</c:v>
                </c:pt>
                <c:pt idx="1228">
                  <c:v>95.487701999999999</c:v>
                </c:pt>
                <c:pt idx="1229">
                  <c:v>95.536513999999997</c:v>
                </c:pt>
                <c:pt idx="1230">
                  <c:v>95.572970999999896</c:v>
                </c:pt>
                <c:pt idx="1231">
                  <c:v>95.594961999999995</c:v>
                </c:pt>
                <c:pt idx="1232">
                  <c:v>95.60248499999993</c:v>
                </c:pt>
                <c:pt idx="1233">
                  <c:v>95.598725999999999</c:v>
                </c:pt>
                <c:pt idx="1234">
                  <c:v>95.588415999999981</c:v>
                </c:pt>
                <c:pt idx="1235">
                  <c:v>95.574157999999983</c:v>
                </c:pt>
                <c:pt idx="1236">
                  <c:v>95.55642899999998</c:v>
                </c:pt>
                <c:pt idx="1237">
                  <c:v>95.536822999999998</c:v>
                </c:pt>
                <c:pt idx="1238">
                  <c:v>95.518901</c:v>
                </c:pt>
                <c:pt idx="1239">
                  <c:v>95.504630000000006</c:v>
                </c:pt>
                <c:pt idx="1240">
                  <c:v>95.491973000000002</c:v>
                </c:pt>
                <c:pt idx="1241">
                  <c:v>95.477926999999994</c:v>
                </c:pt>
                <c:pt idx="1242">
                  <c:v>95.462162000000006</c:v>
                </c:pt>
                <c:pt idx="1243">
                  <c:v>95.446231999999995</c:v>
                </c:pt>
                <c:pt idx="1244">
                  <c:v>95.430683000000002</c:v>
                </c:pt>
                <c:pt idx="1245">
                  <c:v>95.414552999999998</c:v>
                </c:pt>
                <c:pt idx="1246">
                  <c:v>95.397322000000003</c:v>
                </c:pt>
                <c:pt idx="1247">
                  <c:v>95.378990999999928</c:v>
                </c:pt>
                <c:pt idx="1248">
                  <c:v>95.358854999999977</c:v>
                </c:pt>
                <c:pt idx="1249">
                  <c:v>95.33683199999993</c:v>
                </c:pt>
                <c:pt idx="1250">
                  <c:v>95.31438</c:v>
                </c:pt>
                <c:pt idx="1251">
                  <c:v>95.292751999999979</c:v>
                </c:pt>
                <c:pt idx="1252">
                  <c:v>95.271638999999979</c:v>
                </c:pt>
                <c:pt idx="1253">
                  <c:v>95.248953999999998</c:v>
                </c:pt>
                <c:pt idx="1254">
                  <c:v>95.222578999999911</c:v>
                </c:pt>
                <c:pt idx="1255">
                  <c:v>95.193366999999981</c:v>
                </c:pt>
                <c:pt idx="1256">
                  <c:v>95.164364000000006</c:v>
                </c:pt>
                <c:pt idx="1257">
                  <c:v>95.137512999999998</c:v>
                </c:pt>
                <c:pt idx="1258">
                  <c:v>95.112195999999983</c:v>
                </c:pt>
                <c:pt idx="1259">
                  <c:v>95.085315999999978</c:v>
                </c:pt>
                <c:pt idx="1260">
                  <c:v>95.053989000000001</c:v>
                </c:pt>
                <c:pt idx="1261">
                  <c:v>95.018568000000002</c:v>
                </c:pt>
                <c:pt idx="1262">
                  <c:v>94.980846999999983</c:v>
                </c:pt>
                <c:pt idx="1263">
                  <c:v>94.941924999999998</c:v>
                </c:pt>
                <c:pt idx="1264">
                  <c:v>94.902750999999981</c:v>
                </c:pt>
                <c:pt idx="1265">
                  <c:v>94.863303000000002</c:v>
                </c:pt>
                <c:pt idx="1266">
                  <c:v>94.822482999999892</c:v>
                </c:pt>
                <c:pt idx="1267">
                  <c:v>94.780400999999998</c:v>
                </c:pt>
                <c:pt idx="1268">
                  <c:v>94.738280000000003</c:v>
                </c:pt>
                <c:pt idx="1269">
                  <c:v>94.696421000000001</c:v>
                </c:pt>
                <c:pt idx="1270">
                  <c:v>94.653713999999979</c:v>
                </c:pt>
                <c:pt idx="1271">
                  <c:v>94.608762999999911</c:v>
                </c:pt>
                <c:pt idx="1272">
                  <c:v>94.561960999999997</c:v>
                </c:pt>
                <c:pt idx="1273">
                  <c:v>94.515646000000004</c:v>
                </c:pt>
                <c:pt idx="1274">
                  <c:v>94.470081999999977</c:v>
                </c:pt>
                <c:pt idx="1275">
                  <c:v>94.42227699999998</c:v>
                </c:pt>
                <c:pt idx="1276">
                  <c:v>94.371735999999927</c:v>
                </c:pt>
                <c:pt idx="1277">
                  <c:v>94.322322999999912</c:v>
                </c:pt>
                <c:pt idx="1278">
                  <c:v>94.275318999999911</c:v>
                </c:pt>
                <c:pt idx="1279">
                  <c:v>94.226857999999979</c:v>
                </c:pt>
                <c:pt idx="1280">
                  <c:v>94.173648999999912</c:v>
                </c:pt>
                <c:pt idx="1281">
                  <c:v>94.115959000000004</c:v>
                </c:pt>
                <c:pt idx="1282">
                  <c:v>94.055907999999945</c:v>
                </c:pt>
                <c:pt idx="1283">
                  <c:v>93.996217999999999</c:v>
                </c:pt>
                <c:pt idx="1284">
                  <c:v>93.938509999999994</c:v>
                </c:pt>
                <c:pt idx="1285">
                  <c:v>93.882317999999927</c:v>
                </c:pt>
                <c:pt idx="1286">
                  <c:v>93.826782999999892</c:v>
                </c:pt>
                <c:pt idx="1287">
                  <c:v>93.771377999999928</c:v>
                </c:pt>
                <c:pt idx="1288">
                  <c:v>93.715159999999997</c:v>
                </c:pt>
                <c:pt idx="1289">
                  <c:v>93.657601</c:v>
                </c:pt>
                <c:pt idx="1290">
                  <c:v>93.598751999999976</c:v>
                </c:pt>
                <c:pt idx="1291">
                  <c:v>93.538285999999999</c:v>
                </c:pt>
                <c:pt idx="1292">
                  <c:v>93.476254999999995</c:v>
                </c:pt>
                <c:pt idx="1293">
                  <c:v>93.413877999999983</c:v>
                </c:pt>
                <c:pt idx="1294">
                  <c:v>93.352440999999928</c:v>
                </c:pt>
                <c:pt idx="1295">
                  <c:v>93.292715999999999</c:v>
                </c:pt>
                <c:pt idx="1296">
                  <c:v>93.234313</c:v>
                </c:pt>
                <c:pt idx="1297">
                  <c:v>93.174335999999911</c:v>
                </c:pt>
                <c:pt idx="1298">
                  <c:v>93.109943999999999</c:v>
                </c:pt>
                <c:pt idx="1299">
                  <c:v>93.043301999999983</c:v>
                </c:pt>
                <c:pt idx="1300">
                  <c:v>92.979184000000004</c:v>
                </c:pt>
                <c:pt idx="1301">
                  <c:v>92.918800000000005</c:v>
                </c:pt>
                <c:pt idx="1302">
                  <c:v>92.860394999999983</c:v>
                </c:pt>
                <c:pt idx="1303">
                  <c:v>92.803050999999982</c:v>
                </c:pt>
                <c:pt idx="1304">
                  <c:v>92.746521999999999</c:v>
                </c:pt>
                <c:pt idx="1305">
                  <c:v>92.690256000000005</c:v>
                </c:pt>
                <c:pt idx="1306">
                  <c:v>92.634428</c:v>
                </c:pt>
                <c:pt idx="1307">
                  <c:v>92.580366999999981</c:v>
                </c:pt>
                <c:pt idx="1308">
                  <c:v>92.528993999999983</c:v>
                </c:pt>
                <c:pt idx="1309">
                  <c:v>92.480440999999999</c:v>
                </c:pt>
                <c:pt idx="1310">
                  <c:v>92.434624999999997</c:v>
                </c:pt>
                <c:pt idx="1311">
                  <c:v>92.390738999999911</c:v>
                </c:pt>
                <c:pt idx="1312">
                  <c:v>92.347961999999995</c:v>
                </c:pt>
                <c:pt idx="1313">
                  <c:v>92.307124999999999</c:v>
                </c:pt>
                <c:pt idx="1314">
                  <c:v>92.269289999999998</c:v>
                </c:pt>
                <c:pt idx="1315">
                  <c:v>92.234380000000002</c:v>
                </c:pt>
                <c:pt idx="1316">
                  <c:v>92.202202999999983</c:v>
                </c:pt>
                <c:pt idx="1317">
                  <c:v>92.17265699999993</c:v>
                </c:pt>
                <c:pt idx="1318">
                  <c:v>92.145122000000001</c:v>
                </c:pt>
                <c:pt idx="1319">
                  <c:v>92.119183000000007</c:v>
                </c:pt>
                <c:pt idx="1320">
                  <c:v>92.094891000000004</c:v>
                </c:pt>
                <c:pt idx="1321">
                  <c:v>92.07187699999993</c:v>
                </c:pt>
                <c:pt idx="1322">
                  <c:v>92.049340000000001</c:v>
                </c:pt>
                <c:pt idx="1323">
                  <c:v>92.027384999999981</c:v>
                </c:pt>
                <c:pt idx="1324">
                  <c:v>92.006749999999982</c:v>
                </c:pt>
                <c:pt idx="1325">
                  <c:v>91.987370999999982</c:v>
                </c:pt>
                <c:pt idx="1326">
                  <c:v>91.968541999999999</c:v>
                </c:pt>
                <c:pt idx="1327">
                  <c:v>91.949691000000001</c:v>
                </c:pt>
                <c:pt idx="1328">
                  <c:v>91.930250999999998</c:v>
                </c:pt>
                <c:pt idx="1329">
                  <c:v>91.910030000000006</c:v>
                </c:pt>
                <c:pt idx="1330">
                  <c:v>91.889446999999976</c:v>
                </c:pt>
                <c:pt idx="1331">
                  <c:v>91.868769</c:v>
                </c:pt>
                <c:pt idx="1332">
                  <c:v>91.847494999999995</c:v>
                </c:pt>
                <c:pt idx="1333">
                  <c:v>91.825261999999981</c:v>
                </c:pt>
                <c:pt idx="1334">
                  <c:v>91.802925000000002</c:v>
                </c:pt>
                <c:pt idx="1335">
                  <c:v>91.781718999999981</c:v>
                </c:pt>
                <c:pt idx="1336">
                  <c:v>91.761686999999995</c:v>
                </c:pt>
                <c:pt idx="1337">
                  <c:v>91.742570999999998</c:v>
                </c:pt>
                <c:pt idx="1338">
                  <c:v>91.724219000000005</c:v>
                </c:pt>
                <c:pt idx="1339">
                  <c:v>91.704310000000007</c:v>
                </c:pt>
                <c:pt idx="1340">
                  <c:v>91.680204000000003</c:v>
                </c:pt>
                <c:pt idx="1341">
                  <c:v>91.653946999999945</c:v>
                </c:pt>
                <c:pt idx="1342">
                  <c:v>91.629469999999984</c:v>
                </c:pt>
                <c:pt idx="1343">
                  <c:v>91.607254999999995</c:v>
                </c:pt>
                <c:pt idx="1344">
                  <c:v>91.58607499999998</c:v>
                </c:pt>
                <c:pt idx="1345">
                  <c:v>91.565010999999998</c:v>
                </c:pt>
                <c:pt idx="1346">
                  <c:v>91.541905999999997</c:v>
                </c:pt>
                <c:pt idx="1347">
                  <c:v>91.515274000000005</c:v>
                </c:pt>
                <c:pt idx="1348">
                  <c:v>91.487120000000004</c:v>
                </c:pt>
                <c:pt idx="1349">
                  <c:v>91.460149999999999</c:v>
                </c:pt>
                <c:pt idx="1350">
                  <c:v>91.434032999999999</c:v>
                </c:pt>
                <c:pt idx="1351">
                  <c:v>91.406761000000003</c:v>
                </c:pt>
                <c:pt idx="1352">
                  <c:v>91.377745999999945</c:v>
                </c:pt>
                <c:pt idx="1353">
                  <c:v>91.347847000000002</c:v>
                </c:pt>
                <c:pt idx="1354">
                  <c:v>91.317418000000004</c:v>
                </c:pt>
                <c:pt idx="1355">
                  <c:v>91.286004000000005</c:v>
                </c:pt>
                <c:pt idx="1356">
                  <c:v>91.253483000000003</c:v>
                </c:pt>
                <c:pt idx="1357">
                  <c:v>91.220707999999945</c:v>
                </c:pt>
                <c:pt idx="1358">
                  <c:v>91.187885999999978</c:v>
                </c:pt>
                <c:pt idx="1359">
                  <c:v>91.152461999999929</c:v>
                </c:pt>
                <c:pt idx="1360">
                  <c:v>91.111427000000006</c:v>
                </c:pt>
                <c:pt idx="1361">
                  <c:v>91.065129999999996</c:v>
                </c:pt>
                <c:pt idx="1362">
                  <c:v>91.01608899999998</c:v>
                </c:pt>
                <c:pt idx="1363">
                  <c:v>90.965675000000005</c:v>
                </c:pt>
                <c:pt idx="1364">
                  <c:v>90.913556</c:v>
                </c:pt>
                <c:pt idx="1365">
                  <c:v>90.85901699999998</c:v>
                </c:pt>
                <c:pt idx="1366">
                  <c:v>90.801551000000003</c:v>
                </c:pt>
                <c:pt idx="1367">
                  <c:v>90.741147999999995</c:v>
                </c:pt>
                <c:pt idx="1368">
                  <c:v>90.678700999999876</c:v>
                </c:pt>
                <c:pt idx="1369">
                  <c:v>90.614277999999999</c:v>
                </c:pt>
                <c:pt idx="1370">
                  <c:v>90.545447999999979</c:v>
                </c:pt>
                <c:pt idx="1371">
                  <c:v>90.470066000000003</c:v>
                </c:pt>
                <c:pt idx="1372">
                  <c:v>90.388893999999979</c:v>
                </c:pt>
                <c:pt idx="1373">
                  <c:v>90.303821999999982</c:v>
                </c:pt>
                <c:pt idx="1374">
                  <c:v>90.216364999999996</c:v>
                </c:pt>
                <c:pt idx="1375">
                  <c:v>90.127520000000004</c:v>
                </c:pt>
                <c:pt idx="1376">
                  <c:v>90.034993999999998</c:v>
                </c:pt>
                <c:pt idx="1377">
                  <c:v>89.932626999999997</c:v>
                </c:pt>
                <c:pt idx="1378">
                  <c:v>89.817111999999995</c:v>
                </c:pt>
                <c:pt idx="1379">
                  <c:v>89.692135999999977</c:v>
                </c:pt>
                <c:pt idx="1380">
                  <c:v>89.562791999999931</c:v>
                </c:pt>
                <c:pt idx="1381">
                  <c:v>89.43033699999998</c:v>
                </c:pt>
                <c:pt idx="1382">
                  <c:v>89.294363000000004</c:v>
                </c:pt>
                <c:pt idx="1383">
                  <c:v>89.155944999999946</c:v>
                </c:pt>
                <c:pt idx="1384">
                  <c:v>89.016678999999982</c:v>
                </c:pt>
                <c:pt idx="1385">
                  <c:v>88.877555999999998</c:v>
                </c:pt>
                <c:pt idx="1386">
                  <c:v>88.740206999999998</c:v>
                </c:pt>
                <c:pt idx="1387">
                  <c:v>88.606369999999984</c:v>
                </c:pt>
                <c:pt idx="1388">
                  <c:v>88.476693999999995</c:v>
                </c:pt>
                <c:pt idx="1389">
                  <c:v>88.352888999999891</c:v>
                </c:pt>
                <c:pt idx="1390">
                  <c:v>88.238390999999979</c:v>
                </c:pt>
                <c:pt idx="1391">
                  <c:v>88.13542099999998</c:v>
                </c:pt>
                <c:pt idx="1392">
                  <c:v>88.044195000000002</c:v>
                </c:pt>
                <c:pt idx="1393">
                  <c:v>87.963776999999979</c:v>
                </c:pt>
                <c:pt idx="1394">
                  <c:v>87.892956999999981</c:v>
                </c:pt>
                <c:pt idx="1395">
                  <c:v>87.832006999999976</c:v>
                </c:pt>
                <c:pt idx="1396">
                  <c:v>87.782054000000002</c:v>
                </c:pt>
                <c:pt idx="1397">
                  <c:v>87.742752999999979</c:v>
                </c:pt>
                <c:pt idx="1398">
                  <c:v>87.713395000000006</c:v>
                </c:pt>
                <c:pt idx="1399">
                  <c:v>87.693579</c:v>
                </c:pt>
                <c:pt idx="1400">
                  <c:v>87.680569000000006</c:v>
                </c:pt>
                <c:pt idx="1401">
                  <c:v>87.670423</c:v>
                </c:pt>
                <c:pt idx="1402">
                  <c:v>87.661843000000005</c:v>
                </c:pt>
                <c:pt idx="1403">
                  <c:v>87.654925000000006</c:v>
                </c:pt>
                <c:pt idx="1404">
                  <c:v>87.648923999999994</c:v>
                </c:pt>
                <c:pt idx="1405">
                  <c:v>87.643320000000003</c:v>
                </c:pt>
                <c:pt idx="1406">
                  <c:v>87.637597999999983</c:v>
                </c:pt>
                <c:pt idx="1407">
                  <c:v>87.630465000000001</c:v>
                </c:pt>
                <c:pt idx="1408">
                  <c:v>87.620590999999976</c:v>
                </c:pt>
                <c:pt idx="1409">
                  <c:v>87.606224999999995</c:v>
                </c:pt>
                <c:pt idx="1410">
                  <c:v>87.585374999999928</c:v>
                </c:pt>
                <c:pt idx="1411">
                  <c:v>87.55876799999993</c:v>
                </c:pt>
                <c:pt idx="1412">
                  <c:v>87.530000999999999</c:v>
                </c:pt>
                <c:pt idx="1413">
                  <c:v>87.501180000000005</c:v>
                </c:pt>
                <c:pt idx="1414">
                  <c:v>87.471256999999994</c:v>
                </c:pt>
                <c:pt idx="1415">
                  <c:v>87.438941999999983</c:v>
                </c:pt>
                <c:pt idx="1416">
                  <c:v>87.404495999999995</c:v>
                </c:pt>
                <c:pt idx="1417">
                  <c:v>87.368671999999975</c:v>
                </c:pt>
                <c:pt idx="1418">
                  <c:v>87.331800000000001</c:v>
                </c:pt>
                <c:pt idx="1419">
                  <c:v>87.294707000000002</c:v>
                </c:pt>
                <c:pt idx="1420">
                  <c:v>87.258199000000005</c:v>
                </c:pt>
                <c:pt idx="1421">
                  <c:v>87.219509000000002</c:v>
                </c:pt>
                <c:pt idx="1422">
                  <c:v>87.173291999999975</c:v>
                </c:pt>
                <c:pt idx="1423">
                  <c:v>87.118530000000007</c:v>
                </c:pt>
                <c:pt idx="1424">
                  <c:v>87.058171999999928</c:v>
                </c:pt>
                <c:pt idx="1425">
                  <c:v>86.991474999999994</c:v>
                </c:pt>
                <c:pt idx="1426">
                  <c:v>86.914309000000003</c:v>
                </c:pt>
                <c:pt idx="1427">
                  <c:v>86.826196999999979</c:v>
                </c:pt>
                <c:pt idx="1428">
                  <c:v>86.73278999999998</c:v>
                </c:pt>
                <c:pt idx="1429">
                  <c:v>86.64367799999998</c:v>
                </c:pt>
                <c:pt idx="1430">
                  <c:v>86.570464999999999</c:v>
                </c:pt>
                <c:pt idx="1431">
                  <c:v>86.525075999999927</c:v>
                </c:pt>
                <c:pt idx="1432">
                  <c:v>86.517895999999993</c:v>
                </c:pt>
                <c:pt idx="1433">
                  <c:v>86.556863000000007</c:v>
                </c:pt>
                <c:pt idx="1434">
                  <c:v>86.646528000000004</c:v>
                </c:pt>
                <c:pt idx="1435">
                  <c:v>86.784585000000007</c:v>
                </c:pt>
                <c:pt idx="1436">
                  <c:v>86.960825999999997</c:v>
                </c:pt>
                <c:pt idx="1437">
                  <c:v>87.162478999999891</c:v>
                </c:pt>
                <c:pt idx="1438">
                  <c:v>87.379427999999976</c:v>
                </c:pt>
                <c:pt idx="1439">
                  <c:v>87.603721999999976</c:v>
                </c:pt>
                <c:pt idx="1440">
                  <c:v>87.828103999999982</c:v>
                </c:pt>
                <c:pt idx="1441">
                  <c:v>88.047127000000003</c:v>
                </c:pt>
                <c:pt idx="1442">
                  <c:v>88.258405999999979</c:v>
                </c:pt>
                <c:pt idx="1443">
                  <c:v>88.461629000000002</c:v>
                </c:pt>
                <c:pt idx="1444">
                  <c:v>88.655449999999931</c:v>
                </c:pt>
                <c:pt idx="1445">
                  <c:v>88.83817999999998</c:v>
                </c:pt>
                <c:pt idx="1446">
                  <c:v>89.012270000000001</c:v>
                </c:pt>
                <c:pt idx="1447">
                  <c:v>89.182497999999896</c:v>
                </c:pt>
                <c:pt idx="1448">
                  <c:v>89.350694000000004</c:v>
                </c:pt>
                <c:pt idx="1449">
                  <c:v>89.516220000000004</c:v>
                </c:pt>
                <c:pt idx="1450">
                  <c:v>89.676848999999876</c:v>
                </c:pt>
                <c:pt idx="1451">
                  <c:v>89.829501999999977</c:v>
                </c:pt>
                <c:pt idx="1452">
                  <c:v>89.974897999999982</c:v>
                </c:pt>
                <c:pt idx="1453">
                  <c:v>90.117126999999996</c:v>
                </c:pt>
                <c:pt idx="1454">
                  <c:v>90.258310999999978</c:v>
                </c:pt>
                <c:pt idx="1455">
                  <c:v>90.397893999999994</c:v>
                </c:pt>
                <c:pt idx="1456">
                  <c:v>90.534537999999998</c:v>
                </c:pt>
                <c:pt idx="1457">
                  <c:v>90.667816999999999</c:v>
                </c:pt>
                <c:pt idx="1458">
                  <c:v>90.799492000000001</c:v>
                </c:pt>
                <c:pt idx="1459">
                  <c:v>90.931376</c:v>
                </c:pt>
                <c:pt idx="1460">
                  <c:v>91.061177999999998</c:v>
                </c:pt>
                <c:pt idx="1461">
                  <c:v>91.182682999999912</c:v>
                </c:pt>
                <c:pt idx="1462">
                  <c:v>91.293063000000004</c:v>
                </c:pt>
                <c:pt idx="1463">
                  <c:v>91.397357999999983</c:v>
                </c:pt>
                <c:pt idx="1464">
                  <c:v>91.502421999999981</c:v>
                </c:pt>
                <c:pt idx="1465">
                  <c:v>91.611017000000004</c:v>
                </c:pt>
                <c:pt idx="1466">
                  <c:v>91.722119000000006</c:v>
                </c:pt>
                <c:pt idx="1467">
                  <c:v>91.831866000000005</c:v>
                </c:pt>
                <c:pt idx="1468">
                  <c:v>91.936548000000002</c:v>
                </c:pt>
                <c:pt idx="1469">
                  <c:v>92.036964999999995</c:v>
                </c:pt>
                <c:pt idx="1470">
                  <c:v>92.136207999999982</c:v>
                </c:pt>
                <c:pt idx="1471">
                  <c:v>92.234487999999999</c:v>
                </c:pt>
                <c:pt idx="1472">
                  <c:v>92.330460000000002</c:v>
                </c:pt>
                <c:pt idx="1473">
                  <c:v>92.425234000000003</c:v>
                </c:pt>
                <c:pt idx="1474">
                  <c:v>92.520782999999895</c:v>
                </c:pt>
                <c:pt idx="1475">
                  <c:v>92.616263000000004</c:v>
                </c:pt>
                <c:pt idx="1476">
                  <c:v>92.709613000000004</c:v>
                </c:pt>
                <c:pt idx="1477">
                  <c:v>92.802302999999895</c:v>
                </c:pt>
                <c:pt idx="1478">
                  <c:v>92.896614999999997</c:v>
                </c:pt>
                <c:pt idx="1479">
                  <c:v>92.988417999999982</c:v>
                </c:pt>
                <c:pt idx="1480">
                  <c:v>93.072473999999929</c:v>
                </c:pt>
                <c:pt idx="1481">
                  <c:v>93.151745999999946</c:v>
                </c:pt>
                <c:pt idx="1482">
                  <c:v>93.230615</c:v>
                </c:pt>
                <c:pt idx="1483">
                  <c:v>93.307404000000005</c:v>
                </c:pt>
                <c:pt idx="1484">
                  <c:v>93.380332999999865</c:v>
                </c:pt>
                <c:pt idx="1485">
                  <c:v>93.451665000000006</c:v>
                </c:pt>
                <c:pt idx="1486">
                  <c:v>93.524034</c:v>
                </c:pt>
                <c:pt idx="1487">
                  <c:v>93.597820999999996</c:v>
                </c:pt>
                <c:pt idx="1488">
                  <c:v>93.672374999999874</c:v>
                </c:pt>
                <c:pt idx="1489">
                  <c:v>93.746910999999997</c:v>
                </c:pt>
                <c:pt idx="1490">
                  <c:v>93.819056000000003</c:v>
                </c:pt>
                <c:pt idx="1491">
                  <c:v>93.886004999999983</c:v>
                </c:pt>
                <c:pt idx="1492">
                  <c:v>93.947619000000003</c:v>
                </c:pt>
                <c:pt idx="1493">
                  <c:v>94.006012999999982</c:v>
                </c:pt>
                <c:pt idx="1494">
                  <c:v>94.064609000000004</c:v>
                </c:pt>
                <c:pt idx="1495">
                  <c:v>94.126387999999892</c:v>
                </c:pt>
                <c:pt idx="1496">
                  <c:v>94.189194000000001</c:v>
                </c:pt>
                <c:pt idx="1497">
                  <c:v>94.247853000000006</c:v>
                </c:pt>
                <c:pt idx="1498">
                  <c:v>94.303596999999982</c:v>
                </c:pt>
                <c:pt idx="1499">
                  <c:v>94.364011000000005</c:v>
                </c:pt>
                <c:pt idx="1500">
                  <c:v>94.431610000000006</c:v>
                </c:pt>
                <c:pt idx="1501">
                  <c:v>94.497641000000002</c:v>
                </c:pt>
                <c:pt idx="1502">
                  <c:v>94.551953999999995</c:v>
                </c:pt>
                <c:pt idx="1503">
                  <c:v>94.597229999999996</c:v>
                </c:pt>
                <c:pt idx="1504">
                  <c:v>94.643478999999928</c:v>
                </c:pt>
                <c:pt idx="1505">
                  <c:v>94.692204000000004</c:v>
                </c:pt>
                <c:pt idx="1506">
                  <c:v>94.740189999999998</c:v>
                </c:pt>
                <c:pt idx="1507">
                  <c:v>94.789922000000004</c:v>
                </c:pt>
                <c:pt idx="1508">
                  <c:v>94.843992</c:v>
                </c:pt>
                <c:pt idx="1509">
                  <c:v>94.901050999999995</c:v>
                </c:pt>
                <c:pt idx="1510">
                  <c:v>94.964409000000003</c:v>
                </c:pt>
                <c:pt idx="1511">
                  <c:v>95.039100000000005</c:v>
                </c:pt>
                <c:pt idx="1512">
                  <c:v>95.111714000000006</c:v>
                </c:pt>
                <c:pt idx="1513">
                  <c:v>95.155372999999841</c:v>
                </c:pt>
                <c:pt idx="1514">
                  <c:v>95.168769999999981</c:v>
                </c:pt>
                <c:pt idx="1515">
                  <c:v>95.181298999999981</c:v>
                </c:pt>
                <c:pt idx="1516">
                  <c:v>95.21239199999998</c:v>
                </c:pt>
                <c:pt idx="1517">
                  <c:v>95.256292000000002</c:v>
                </c:pt>
                <c:pt idx="1518">
                  <c:v>95.302626000000004</c:v>
                </c:pt>
                <c:pt idx="1519">
                  <c:v>95.349089000000006</c:v>
                </c:pt>
                <c:pt idx="1520">
                  <c:v>95.401184999999998</c:v>
                </c:pt>
                <c:pt idx="1521">
                  <c:v>95.468523000000005</c:v>
                </c:pt>
                <c:pt idx="1522">
                  <c:v>95.548242999999999</c:v>
                </c:pt>
                <c:pt idx="1523">
                  <c:v>95.613215999999994</c:v>
                </c:pt>
                <c:pt idx="1524">
                  <c:v>95.643286000000003</c:v>
                </c:pt>
                <c:pt idx="1525">
                  <c:v>95.659092999999928</c:v>
                </c:pt>
                <c:pt idx="1526">
                  <c:v>95.690083000000001</c:v>
                </c:pt>
                <c:pt idx="1527">
                  <c:v>95.733842999999979</c:v>
                </c:pt>
                <c:pt idx="1528">
                  <c:v>95.775695999999982</c:v>
                </c:pt>
                <c:pt idx="1529">
                  <c:v>95.814245999999997</c:v>
                </c:pt>
                <c:pt idx="1530">
                  <c:v>95.852764999999977</c:v>
                </c:pt>
                <c:pt idx="1531">
                  <c:v>95.896254999999996</c:v>
                </c:pt>
                <c:pt idx="1532">
                  <c:v>95.957930000000005</c:v>
                </c:pt>
                <c:pt idx="1533">
                  <c:v>96.041286999999997</c:v>
                </c:pt>
                <c:pt idx="1534">
                  <c:v>96.123285999999979</c:v>
                </c:pt>
                <c:pt idx="1535">
                  <c:v>96.180466999999979</c:v>
                </c:pt>
                <c:pt idx="1536">
                  <c:v>96.217011999999997</c:v>
                </c:pt>
                <c:pt idx="1537">
                  <c:v>96.254481999999982</c:v>
                </c:pt>
                <c:pt idx="1538">
                  <c:v>96.310064999999994</c:v>
                </c:pt>
                <c:pt idx="1539">
                  <c:v>96.37321</c:v>
                </c:pt>
                <c:pt idx="1540">
                  <c:v>96.410939999999997</c:v>
                </c:pt>
                <c:pt idx="1541">
                  <c:v>96.423899000000006</c:v>
                </c:pt>
                <c:pt idx="1542">
                  <c:v>96.465851999999998</c:v>
                </c:pt>
                <c:pt idx="1543">
                  <c:v>96.576526999999999</c:v>
                </c:pt>
                <c:pt idx="1544">
                  <c:v>96.708696000000003</c:v>
                </c:pt>
                <c:pt idx="1545">
                  <c:v>96.767877999999982</c:v>
                </c:pt>
                <c:pt idx="1546">
                  <c:v>96.744139000000004</c:v>
                </c:pt>
                <c:pt idx="1547">
                  <c:v>96.714416</c:v>
                </c:pt>
                <c:pt idx="1548">
                  <c:v>96.721620000000001</c:v>
                </c:pt>
                <c:pt idx="1549">
                  <c:v>96.753962999999999</c:v>
                </c:pt>
                <c:pt idx="1550">
                  <c:v>96.797076000000004</c:v>
                </c:pt>
                <c:pt idx="1551">
                  <c:v>96.848801999999978</c:v>
                </c:pt>
                <c:pt idx="1552">
                  <c:v>96.922015000000002</c:v>
                </c:pt>
                <c:pt idx="1553">
                  <c:v>97.038611000000003</c:v>
                </c:pt>
                <c:pt idx="1554">
                  <c:v>97.183636999999976</c:v>
                </c:pt>
                <c:pt idx="1555">
                  <c:v>97.282005999999981</c:v>
                </c:pt>
                <c:pt idx="1556">
                  <c:v>97.284167999999994</c:v>
                </c:pt>
                <c:pt idx="1557">
                  <c:v>97.246866999999995</c:v>
                </c:pt>
                <c:pt idx="1558">
                  <c:v>97.241533000000004</c:v>
                </c:pt>
                <c:pt idx="1559">
                  <c:v>97.253826000000004</c:v>
                </c:pt>
                <c:pt idx="1560">
                  <c:v>97.248687000000004</c:v>
                </c:pt>
                <c:pt idx="1561">
                  <c:v>97.240682000000007</c:v>
                </c:pt>
                <c:pt idx="1562">
                  <c:v>97.254140000000007</c:v>
                </c:pt>
                <c:pt idx="1563">
                  <c:v>97.298596000000003</c:v>
                </c:pt>
                <c:pt idx="1564">
                  <c:v>97.386904000000001</c:v>
                </c:pt>
                <c:pt idx="1565">
                  <c:v>97.506041999999979</c:v>
                </c:pt>
                <c:pt idx="1566">
                  <c:v>97.601653999999996</c:v>
                </c:pt>
                <c:pt idx="1567">
                  <c:v>97.656243000000003</c:v>
                </c:pt>
                <c:pt idx="1568">
                  <c:v>97.695713999999981</c:v>
                </c:pt>
                <c:pt idx="1569">
                  <c:v>97.695656</c:v>
                </c:pt>
                <c:pt idx="1570">
                  <c:v>97.628499999999946</c:v>
                </c:pt>
                <c:pt idx="1571">
                  <c:v>97.547927999999999</c:v>
                </c:pt>
                <c:pt idx="1572">
                  <c:v>97.513319999999993</c:v>
                </c:pt>
                <c:pt idx="1573">
                  <c:v>97.541481000000005</c:v>
                </c:pt>
                <c:pt idx="1574">
                  <c:v>97.632413</c:v>
                </c:pt>
                <c:pt idx="1575">
                  <c:v>97.736534000000006</c:v>
                </c:pt>
                <c:pt idx="1576">
                  <c:v>97.765321</c:v>
                </c:pt>
                <c:pt idx="1577">
                  <c:v>97.703873000000002</c:v>
                </c:pt>
                <c:pt idx="1578">
                  <c:v>97.624382999999895</c:v>
                </c:pt>
                <c:pt idx="1579">
                  <c:v>97.581486999999981</c:v>
                </c:pt>
                <c:pt idx="1580">
                  <c:v>97.578384999999912</c:v>
                </c:pt>
                <c:pt idx="1581">
                  <c:v>97.599744000000001</c:v>
                </c:pt>
                <c:pt idx="1582">
                  <c:v>97.621353999999982</c:v>
                </c:pt>
                <c:pt idx="1583">
                  <c:v>97.623693000000003</c:v>
                </c:pt>
                <c:pt idx="1584">
                  <c:v>97.622503999999978</c:v>
                </c:pt>
                <c:pt idx="1585">
                  <c:v>97.653914</c:v>
                </c:pt>
                <c:pt idx="1586">
                  <c:v>97.721834000000001</c:v>
                </c:pt>
                <c:pt idx="1587">
                  <c:v>97.777225999999999</c:v>
                </c:pt>
                <c:pt idx="1588">
                  <c:v>97.76584099999998</c:v>
                </c:pt>
                <c:pt idx="1589">
                  <c:v>97.701396000000003</c:v>
                </c:pt>
                <c:pt idx="1590">
                  <c:v>97.648884999999979</c:v>
                </c:pt>
                <c:pt idx="1591">
                  <c:v>97.639607999999981</c:v>
                </c:pt>
                <c:pt idx="1592">
                  <c:v>97.655530999999911</c:v>
                </c:pt>
                <c:pt idx="1593">
                  <c:v>97.674315999999976</c:v>
                </c:pt>
                <c:pt idx="1594">
                  <c:v>97.685992999999911</c:v>
                </c:pt>
                <c:pt idx="1595">
                  <c:v>97.687404999999998</c:v>
                </c:pt>
                <c:pt idx="1596">
                  <c:v>97.694884000000002</c:v>
                </c:pt>
                <c:pt idx="1597">
                  <c:v>97.736523000000005</c:v>
                </c:pt>
                <c:pt idx="1598">
                  <c:v>97.806894</c:v>
                </c:pt>
                <c:pt idx="1599">
                  <c:v>97.861345</c:v>
                </c:pt>
                <c:pt idx="1600">
                  <c:v>97.859217000000001</c:v>
                </c:pt>
                <c:pt idx="1601">
                  <c:v>97.805661000000001</c:v>
                </c:pt>
                <c:pt idx="1602">
                  <c:v>97.777692000000002</c:v>
                </c:pt>
                <c:pt idx="1603">
                  <c:v>97.853610000000003</c:v>
                </c:pt>
                <c:pt idx="1604">
                  <c:v>97.978299000000007</c:v>
                </c:pt>
                <c:pt idx="1605">
                  <c:v>98.026994999999999</c:v>
                </c:pt>
                <c:pt idx="1606">
                  <c:v>98.012407999999979</c:v>
                </c:pt>
                <c:pt idx="1607">
                  <c:v>98.014269999999996</c:v>
                </c:pt>
                <c:pt idx="1608">
                  <c:v>97.992726000000005</c:v>
                </c:pt>
                <c:pt idx="1609">
                  <c:v>97.889348999999896</c:v>
                </c:pt>
                <c:pt idx="1610">
                  <c:v>97.765912999999998</c:v>
                </c:pt>
                <c:pt idx="1611">
                  <c:v>97.700912000000002</c:v>
                </c:pt>
                <c:pt idx="1612">
                  <c:v>97.682243</c:v>
                </c:pt>
                <c:pt idx="1613">
                  <c:v>97.665191999999976</c:v>
                </c:pt>
                <c:pt idx="1614">
                  <c:v>97.648670999999979</c:v>
                </c:pt>
                <c:pt idx="1615">
                  <c:v>97.650797999999895</c:v>
                </c:pt>
                <c:pt idx="1616">
                  <c:v>97.667783</c:v>
                </c:pt>
                <c:pt idx="1617">
                  <c:v>97.679496999999927</c:v>
                </c:pt>
                <c:pt idx="1618">
                  <c:v>97.666293999999994</c:v>
                </c:pt>
                <c:pt idx="1619">
                  <c:v>97.63175099999998</c:v>
                </c:pt>
                <c:pt idx="1620">
                  <c:v>97.606707999999927</c:v>
                </c:pt>
                <c:pt idx="1621">
                  <c:v>97.611452</c:v>
                </c:pt>
                <c:pt idx="1622">
                  <c:v>97.629966999999979</c:v>
                </c:pt>
                <c:pt idx="1623">
                  <c:v>97.633880999999946</c:v>
                </c:pt>
                <c:pt idx="1624">
                  <c:v>97.62023499999998</c:v>
                </c:pt>
                <c:pt idx="1625">
                  <c:v>97.605774999999895</c:v>
                </c:pt>
                <c:pt idx="1626">
                  <c:v>97.595838999999927</c:v>
                </c:pt>
                <c:pt idx="1627">
                  <c:v>97.586457999999979</c:v>
                </c:pt>
                <c:pt idx="1628">
                  <c:v>97.580268000000004</c:v>
                </c:pt>
                <c:pt idx="1629">
                  <c:v>97.585526000000002</c:v>
                </c:pt>
                <c:pt idx="1630">
                  <c:v>97.607793999999998</c:v>
                </c:pt>
                <c:pt idx="1631">
                  <c:v>97.644543999999996</c:v>
                </c:pt>
                <c:pt idx="1632">
                  <c:v>97.700111000000007</c:v>
                </c:pt>
                <c:pt idx="1633">
                  <c:v>97.772374999999911</c:v>
                </c:pt>
                <c:pt idx="1634">
                  <c:v>97.813220999999999</c:v>
                </c:pt>
                <c:pt idx="1635">
                  <c:v>97.793674999999993</c:v>
                </c:pt>
                <c:pt idx="1636">
                  <c:v>97.757375999999979</c:v>
                </c:pt>
                <c:pt idx="1637">
                  <c:v>97.722350999999946</c:v>
                </c:pt>
                <c:pt idx="1638">
                  <c:v>97.668679999999981</c:v>
                </c:pt>
                <c:pt idx="1639">
                  <c:v>97.635058999999927</c:v>
                </c:pt>
                <c:pt idx="1640">
                  <c:v>97.676776999999859</c:v>
                </c:pt>
                <c:pt idx="1641">
                  <c:v>97.759074999999982</c:v>
                </c:pt>
                <c:pt idx="1642">
                  <c:v>97.802768999999927</c:v>
                </c:pt>
                <c:pt idx="1643">
                  <c:v>97.801698999999999</c:v>
                </c:pt>
                <c:pt idx="1644">
                  <c:v>97.784161999999995</c:v>
                </c:pt>
                <c:pt idx="1645">
                  <c:v>97.738570999999979</c:v>
                </c:pt>
                <c:pt idx="1646">
                  <c:v>97.673808999999892</c:v>
                </c:pt>
                <c:pt idx="1647">
                  <c:v>97.631889999999999</c:v>
                </c:pt>
                <c:pt idx="1648">
                  <c:v>97.625467999999927</c:v>
                </c:pt>
                <c:pt idx="1649">
                  <c:v>97.643666999999994</c:v>
                </c:pt>
                <c:pt idx="1650">
                  <c:v>97.682040999999927</c:v>
                </c:pt>
                <c:pt idx="1651">
                  <c:v>97.745833000000005</c:v>
                </c:pt>
                <c:pt idx="1652">
                  <c:v>97.819480999999982</c:v>
                </c:pt>
                <c:pt idx="1653">
                  <c:v>97.844286999999994</c:v>
                </c:pt>
                <c:pt idx="1654">
                  <c:v>97.791017999999994</c:v>
                </c:pt>
                <c:pt idx="1655">
                  <c:v>97.707808</c:v>
                </c:pt>
                <c:pt idx="1656">
                  <c:v>97.641814999999994</c:v>
                </c:pt>
                <c:pt idx="1657">
                  <c:v>97.603706999999929</c:v>
                </c:pt>
                <c:pt idx="1658">
                  <c:v>97.622758999999874</c:v>
                </c:pt>
                <c:pt idx="1659">
                  <c:v>97.746981000000005</c:v>
                </c:pt>
                <c:pt idx="1660">
                  <c:v>97.942237000000006</c:v>
                </c:pt>
                <c:pt idx="1661">
                  <c:v>98.043315000000007</c:v>
                </c:pt>
                <c:pt idx="1662">
                  <c:v>97.939756000000003</c:v>
                </c:pt>
                <c:pt idx="1663">
                  <c:v>97.749495999999994</c:v>
                </c:pt>
                <c:pt idx="1664">
                  <c:v>97.639565000000005</c:v>
                </c:pt>
                <c:pt idx="1665">
                  <c:v>97.63289099999993</c:v>
                </c:pt>
                <c:pt idx="1666">
                  <c:v>97.66286599999998</c:v>
                </c:pt>
                <c:pt idx="1667">
                  <c:v>97.685490999999928</c:v>
                </c:pt>
                <c:pt idx="1668">
                  <c:v>97.707571000000002</c:v>
                </c:pt>
                <c:pt idx="1669">
                  <c:v>97.730772999999928</c:v>
                </c:pt>
                <c:pt idx="1670">
                  <c:v>97.719776999999979</c:v>
                </c:pt>
                <c:pt idx="1671">
                  <c:v>97.665895999999975</c:v>
                </c:pt>
                <c:pt idx="1672">
                  <c:v>97.609555999999998</c:v>
                </c:pt>
                <c:pt idx="1673">
                  <c:v>97.585829999999973</c:v>
                </c:pt>
                <c:pt idx="1674">
                  <c:v>97.597173999999995</c:v>
                </c:pt>
                <c:pt idx="1675">
                  <c:v>97.620893999999979</c:v>
                </c:pt>
                <c:pt idx="1676">
                  <c:v>97.642593000000005</c:v>
                </c:pt>
                <c:pt idx="1677">
                  <c:v>97.660040999999978</c:v>
                </c:pt>
                <c:pt idx="1678">
                  <c:v>97.656099999999981</c:v>
                </c:pt>
                <c:pt idx="1679">
                  <c:v>97.633369000000002</c:v>
                </c:pt>
                <c:pt idx="1680">
                  <c:v>97.617847999999981</c:v>
                </c:pt>
                <c:pt idx="1681">
                  <c:v>97.600937999999928</c:v>
                </c:pt>
                <c:pt idx="1682">
                  <c:v>97.572199999999981</c:v>
                </c:pt>
                <c:pt idx="1683">
                  <c:v>97.566034999999999</c:v>
                </c:pt>
                <c:pt idx="1684">
                  <c:v>97.604495</c:v>
                </c:pt>
                <c:pt idx="1685">
                  <c:v>97.658801999999895</c:v>
                </c:pt>
                <c:pt idx="1686">
                  <c:v>97.688095999999931</c:v>
                </c:pt>
                <c:pt idx="1687">
                  <c:v>97.671389999999946</c:v>
                </c:pt>
                <c:pt idx="1688">
                  <c:v>97.614370999999977</c:v>
                </c:pt>
                <c:pt idx="1689">
                  <c:v>97.549284</c:v>
                </c:pt>
                <c:pt idx="1690">
                  <c:v>97.507399000000007</c:v>
                </c:pt>
                <c:pt idx="1691">
                  <c:v>97.493521999999999</c:v>
                </c:pt>
                <c:pt idx="1692">
                  <c:v>97.500485999999981</c:v>
                </c:pt>
                <c:pt idx="1693">
                  <c:v>97.520755999999977</c:v>
                </c:pt>
                <c:pt idx="1694">
                  <c:v>97.537074000000004</c:v>
                </c:pt>
                <c:pt idx="1695">
                  <c:v>97.534428000000005</c:v>
                </c:pt>
                <c:pt idx="1696">
                  <c:v>97.520380999999929</c:v>
                </c:pt>
                <c:pt idx="1697">
                  <c:v>97.510058000000001</c:v>
                </c:pt>
                <c:pt idx="1698">
                  <c:v>97.503552999999982</c:v>
                </c:pt>
                <c:pt idx="1699">
                  <c:v>97.496644000000003</c:v>
                </c:pt>
                <c:pt idx="1700">
                  <c:v>97.495016000000007</c:v>
                </c:pt>
                <c:pt idx="1701">
                  <c:v>97.500355999999982</c:v>
                </c:pt>
                <c:pt idx="1702">
                  <c:v>97.500635000000003</c:v>
                </c:pt>
                <c:pt idx="1703">
                  <c:v>97.488343999999998</c:v>
                </c:pt>
                <c:pt idx="1704">
                  <c:v>97.472750999999946</c:v>
                </c:pt>
                <c:pt idx="1705">
                  <c:v>97.466586000000007</c:v>
                </c:pt>
                <c:pt idx="1706">
                  <c:v>97.471665999999999</c:v>
                </c:pt>
                <c:pt idx="1707">
                  <c:v>97.478556999999981</c:v>
                </c:pt>
                <c:pt idx="1708">
                  <c:v>97.478630999999979</c:v>
                </c:pt>
                <c:pt idx="1709">
                  <c:v>97.474357999999981</c:v>
                </c:pt>
                <c:pt idx="1710">
                  <c:v>97.470476999999946</c:v>
                </c:pt>
                <c:pt idx="1711">
                  <c:v>97.464561000000003</c:v>
                </c:pt>
                <c:pt idx="1712">
                  <c:v>97.454806000000005</c:v>
                </c:pt>
                <c:pt idx="1713">
                  <c:v>97.445024000000004</c:v>
                </c:pt>
                <c:pt idx="1714">
                  <c:v>97.438749000000001</c:v>
                </c:pt>
                <c:pt idx="1715">
                  <c:v>97.435776999999931</c:v>
                </c:pt>
                <c:pt idx="1716">
                  <c:v>97.433760000000007</c:v>
                </c:pt>
                <c:pt idx="1717">
                  <c:v>97.430755000000005</c:v>
                </c:pt>
                <c:pt idx="1718">
                  <c:v>97.426288</c:v>
                </c:pt>
                <c:pt idx="1719">
                  <c:v>97.420840999999982</c:v>
                </c:pt>
                <c:pt idx="1720">
                  <c:v>97.415546000000006</c:v>
                </c:pt>
                <c:pt idx="1721">
                  <c:v>97.411876000000007</c:v>
                </c:pt>
                <c:pt idx="1722">
                  <c:v>97.410365999999996</c:v>
                </c:pt>
                <c:pt idx="1723">
                  <c:v>97.409210000000002</c:v>
                </c:pt>
                <c:pt idx="1724">
                  <c:v>97.405445</c:v>
                </c:pt>
                <c:pt idx="1725">
                  <c:v>97.39932899999998</c:v>
                </c:pt>
                <c:pt idx="1726">
                  <c:v>97.394962000000007</c:v>
                </c:pt>
                <c:pt idx="1727">
                  <c:v>97.394458</c:v>
                </c:pt>
                <c:pt idx="1728">
                  <c:v>97.395535999999979</c:v>
                </c:pt>
                <c:pt idx="1729">
                  <c:v>97.395887999999928</c:v>
                </c:pt>
                <c:pt idx="1730">
                  <c:v>97.396156000000005</c:v>
                </c:pt>
                <c:pt idx="1731">
                  <c:v>97.397390000000001</c:v>
                </c:pt>
                <c:pt idx="1732">
                  <c:v>97.397959999999998</c:v>
                </c:pt>
                <c:pt idx="1733">
                  <c:v>97.396161000000006</c:v>
                </c:pt>
                <c:pt idx="1734">
                  <c:v>97.393571999999978</c:v>
                </c:pt>
                <c:pt idx="1735">
                  <c:v>97.392067999999981</c:v>
                </c:pt>
                <c:pt idx="1736">
                  <c:v>97.390896999999981</c:v>
                </c:pt>
                <c:pt idx="1737">
                  <c:v>97.389093000000003</c:v>
                </c:pt>
                <c:pt idx="1738">
                  <c:v>97.387657000000004</c:v>
                </c:pt>
              </c:numCache>
            </c:numRef>
          </c:yVal>
          <c:smooth val="1"/>
        </c:ser>
        <c:ser>
          <c:idx val="1"/>
          <c:order val="1"/>
          <c:tx>
            <c:v>ATCA1</c:v>
          </c:tx>
          <c:spPr>
            <a:ln>
              <a:solidFill>
                <a:schemeClr val="tx1"/>
              </a:solidFill>
            </a:ln>
          </c:spPr>
          <c:marker>
            <c:symbol val="none"/>
          </c:marker>
          <c:xVal>
            <c:numRef>
              <c:f>IR!$A$1:$A$1744</c:f>
              <c:numCache>
                <c:formatCode>General</c:formatCode>
                <c:ptCount val="1744"/>
                <c:pt idx="0">
                  <c:v>649.90114399999948</c:v>
                </c:pt>
                <c:pt idx="1">
                  <c:v>651.82963400000006</c:v>
                </c:pt>
                <c:pt idx="2">
                  <c:v>653.75812399999938</c:v>
                </c:pt>
                <c:pt idx="3">
                  <c:v>655.68661499999996</c:v>
                </c:pt>
                <c:pt idx="4">
                  <c:v>657.61510499999997</c:v>
                </c:pt>
                <c:pt idx="5">
                  <c:v>659.54359499999998</c:v>
                </c:pt>
                <c:pt idx="6">
                  <c:v>661.47208499999999</c:v>
                </c:pt>
                <c:pt idx="7">
                  <c:v>663.400575</c:v>
                </c:pt>
                <c:pt idx="8">
                  <c:v>665.32906499999945</c:v>
                </c:pt>
                <c:pt idx="9">
                  <c:v>667.25755499999946</c:v>
                </c:pt>
                <c:pt idx="10">
                  <c:v>669.18604500000004</c:v>
                </c:pt>
                <c:pt idx="11">
                  <c:v>671.11453500000005</c:v>
                </c:pt>
                <c:pt idx="12">
                  <c:v>673.04302499999937</c:v>
                </c:pt>
                <c:pt idx="13">
                  <c:v>674.97151499999939</c:v>
                </c:pt>
                <c:pt idx="14">
                  <c:v>676.90000499999996</c:v>
                </c:pt>
                <c:pt idx="15">
                  <c:v>678.82849499999998</c:v>
                </c:pt>
                <c:pt idx="16">
                  <c:v>680.75698499999999</c:v>
                </c:pt>
                <c:pt idx="17">
                  <c:v>682.685475</c:v>
                </c:pt>
                <c:pt idx="18">
                  <c:v>684.61396500000001</c:v>
                </c:pt>
                <c:pt idx="19">
                  <c:v>686.54245499999945</c:v>
                </c:pt>
                <c:pt idx="20">
                  <c:v>688.47094500000003</c:v>
                </c:pt>
                <c:pt idx="21">
                  <c:v>690.39943500000004</c:v>
                </c:pt>
                <c:pt idx="22">
                  <c:v>692.32792499999914</c:v>
                </c:pt>
                <c:pt idx="23">
                  <c:v>694.25641499999938</c:v>
                </c:pt>
                <c:pt idx="24">
                  <c:v>696.18490499999996</c:v>
                </c:pt>
                <c:pt idx="25">
                  <c:v>698.11339499999997</c:v>
                </c:pt>
                <c:pt idx="26">
                  <c:v>700.04188499999998</c:v>
                </c:pt>
                <c:pt idx="27">
                  <c:v>701.97037599999999</c:v>
                </c:pt>
                <c:pt idx="28">
                  <c:v>703.898866</c:v>
                </c:pt>
                <c:pt idx="29">
                  <c:v>705.82735599999944</c:v>
                </c:pt>
                <c:pt idx="30">
                  <c:v>707.75584600000002</c:v>
                </c:pt>
                <c:pt idx="31">
                  <c:v>709.68433600000003</c:v>
                </c:pt>
                <c:pt idx="32">
                  <c:v>711.61282599999947</c:v>
                </c:pt>
                <c:pt idx="33">
                  <c:v>713.54131599999948</c:v>
                </c:pt>
                <c:pt idx="34">
                  <c:v>715.46980599999938</c:v>
                </c:pt>
                <c:pt idx="35">
                  <c:v>717.39829599999996</c:v>
                </c:pt>
                <c:pt idx="36">
                  <c:v>719.32678599999997</c:v>
                </c:pt>
                <c:pt idx="37">
                  <c:v>721.25527599999998</c:v>
                </c:pt>
                <c:pt idx="38">
                  <c:v>723.18376599999999</c:v>
                </c:pt>
                <c:pt idx="39">
                  <c:v>725.11225599999932</c:v>
                </c:pt>
                <c:pt idx="40">
                  <c:v>727.04074600000001</c:v>
                </c:pt>
                <c:pt idx="41">
                  <c:v>728.96923599999946</c:v>
                </c:pt>
                <c:pt idx="42">
                  <c:v>730.89772599999947</c:v>
                </c:pt>
                <c:pt idx="43">
                  <c:v>732.82621599999902</c:v>
                </c:pt>
                <c:pt idx="44">
                  <c:v>734.75470600000006</c:v>
                </c:pt>
                <c:pt idx="45">
                  <c:v>736.68319599999995</c:v>
                </c:pt>
                <c:pt idx="46">
                  <c:v>738.61168599999996</c:v>
                </c:pt>
                <c:pt idx="47">
                  <c:v>740.54017599999997</c:v>
                </c:pt>
                <c:pt idx="48">
                  <c:v>742.4686659999993</c:v>
                </c:pt>
                <c:pt idx="49">
                  <c:v>744.39715599999931</c:v>
                </c:pt>
                <c:pt idx="50">
                  <c:v>746.32564699999932</c:v>
                </c:pt>
                <c:pt idx="51">
                  <c:v>748.25413700000001</c:v>
                </c:pt>
                <c:pt idx="52">
                  <c:v>750.18262699999946</c:v>
                </c:pt>
                <c:pt idx="53">
                  <c:v>752.11111699999947</c:v>
                </c:pt>
                <c:pt idx="54">
                  <c:v>754.03960699999948</c:v>
                </c:pt>
                <c:pt idx="55">
                  <c:v>755.96809699999937</c:v>
                </c:pt>
                <c:pt idx="56">
                  <c:v>757.89658699999939</c:v>
                </c:pt>
                <c:pt idx="57">
                  <c:v>759.82507699999996</c:v>
                </c:pt>
                <c:pt idx="58">
                  <c:v>761.75356699999998</c:v>
                </c:pt>
                <c:pt idx="59">
                  <c:v>763.68205699999999</c:v>
                </c:pt>
                <c:pt idx="60">
                  <c:v>765.610547</c:v>
                </c:pt>
                <c:pt idx="61">
                  <c:v>767.53903700000001</c:v>
                </c:pt>
                <c:pt idx="62">
                  <c:v>769.46752699999888</c:v>
                </c:pt>
                <c:pt idx="63">
                  <c:v>771.39601699999946</c:v>
                </c:pt>
                <c:pt idx="64">
                  <c:v>773.32450699999947</c:v>
                </c:pt>
                <c:pt idx="65">
                  <c:v>775.25299699999948</c:v>
                </c:pt>
                <c:pt idx="66">
                  <c:v>777.18148699999995</c:v>
                </c:pt>
                <c:pt idx="67">
                  <c:v>779.10997699999996</c:v>
                </c:pt>
                <c:pt idx="68">
                  <c:v>781.03846699999997</c:v>
                </c:pt>
                <c:pt idx="69">
                  <c:v>782.9669569999993</c:v>
                </c:pt>
                <c:pt idx="70">
                  <c:v>784.89544699999999</c:v>
                </c:pt>
                <c:pt idx="71">
                  <c:v>786.823937</c:v>
                </c:pt>
                <c:pt idx="72">
                  <c:v>788.75242699999944</c:v>
                </c:pt>
                <c:pt idx="73">
                  <c:v>790.68091800000002</c:v>
                </c:pt>
                <c:pt idx="74">
                  <c:v>792.60940800000003</c:v>
                </c:pt>
                <c:pt idx="75">
                  <c:v>794.53789799999947</c:v>
                </c:pt>
                <c:pt idx="76">
                  <c:v>796.46638799999948</c:v>
                </c:pt>
                <c:pt idx="77">
                  <c:v>798.39487799999995</c:v>
                </c:pt>
                <c:pt idx="78">
                  <c:v>800.32336799999996</c:v>
                </c:pt>
                <c:pt idx="79">
                  <c:v>802.25185799999997</c:v>
                </c:pt>
                <c:pt idx="80">
                  <c:v>804.18034799999998</c:v>
                </c:pt>
                <c:pt idx="81">
                  <c:v>806.10883799999999</c:v>
                </c:pt>
                <c:pt idx="82">
                  <c:v>808.03732799999932</c:v>
                </c:pt>
                <c:pt idx="83">
                  <c:v>809.96581799999944</c:v>
                </c:pt>
                <c:pt idx="84">
                  <c:v>811.89430800000002</c:v>
                </c:pt>
                <c:pt idx="85">
                  <c:v>813.82279799999947</c:v>
                </c:pt>
                <c:pt idx="86">
                  <c:v>815.75128799999948</c:v>
                </c:pt>
                <c:pt idx="87">
                  <c:v>817.67977800000074</c:v>
                </c:pt>
                <c:pt idx="88">
                  <c:v>819.60826799999938</c:v>
                </c:pt>
                <c:pt idx="89">
                  <c:v>821.53675799999996</c:v>
                </c:pt>
                <c:pt idx="90">
                  <c:v>823.46524799999918</c:v>
                </c:pt>
                <c:pt idx="91">
                  <c:v>825.39373799999998</c:v>
                </c:pt>
                <c:pt idx="92">
                  <c:v>827.32222799999874</c:v>
                </c:pt>
                <c:pt idx="93">
                  <c:v>829.25071800000001</c:v>
                </c:pt>
                <c:pt idx="94">
                  <c:v>831.17920800000002</c:v>
                </c:pt>
                <c:pt idx="95">
                  <c:v>833.10769799999946</c:v>
                </c:pt>
                <c:pt idx="96">
                  <c:v>835.03618799999947</c:v>
                </c:pt>
                <c:pt idx="97">
                  <c:v>836.96467899999948</c:v>
                </c:pt>
                <c:pt idx="98">
                  <c:v>838.89316899999938</c:v>
                </c:pt>
                <c:pt idx="99">
                  <c:v>840.82165899999904</c:v>
                </c:pt>
                <c:pt idx="100">
                  <c:v>842.75014899999996</c:v>
                </c:pt>
                <c:pt idx="101">
                  <c:v>844.67863899999998</c:v>
                </c:pt>
                <c:pt idx="102">
                  <c:v>846.6071289999993</c:v>
                </c:pt>
                <c:pt idx="103">
                  <c:v>848.53561899999931</c:v>
                </c:pt>
                <c:pt idx="104">
                  <c:v>850.46410899999944</c:v>
                </c:pt>
                <c:pt idx="105">
                  <c:v>852.39259899999945</c:v>
                </c:pt>
                <c:pt idx="106">
                  <c:v>854.32108899999946</c:v>
                </c:pt>
                <c:pt idx="107">
                  <c:v>856.24957900000004</c:v>
                </c:pt>
                <c:pt idx="108">
                  <c:v>858.17806900000005</c:v>
                </c:pt>
                <c:pt idx="109">
                  <c:v>860.10655899999938</c:v>
                </c:pt>
                <c:pt idx="110">
                  <c:v>862.03504899999996</c:v>
                </c:pt>
                <c:pt idx="111">
                  <c:v>863.96353899999997</c:v>
                </c:pt>
                <c:pt idx="112">
                  <c:v>865.8920289999993</c:v>
                </c:pt>
                <c:pt idx="113">
                  <c:v>867.82051899999931</c:v>
                </c:pt>
                <c:pt idx="114">
                  <c:v>869.749009</c:v>
                </c:pt>
                <c:pt idx="115">
                  <c:v>871.67749900000001</c:v>
                </c:pt>
                <c:pt idx="116">
                  <c:v>873.60598900000002</c:v>
                </c:pt>
                <c:pt idx="117">
                  <c:v>875.53447900000003</c:v>
                </c:pt>
                <c:pt idx="118">
                  <c:v>877.46296899999902</c:v>
                </c:pt>
                <c:pt idx="119">
                  <c:v>879.39145899999949</c:v>
                </c:pt>
                <c:pt idx="120">
                  <c:v>881.31994999999938</c:v>
                </c:pt>
                <c:pt idx="121">
                  <c:v>883.24843999999996</c:v>
                </c:pt>
                <c:pt idx="122">
                  <c:v>885.17692999999997</c:v>
                </c:pt>
                <c:pt idx="123">
                  <c:v>887.10541999999998</c:v>
                </c:pt>
                <c:pt idx="124">
                  <c:v>889.03390999999999</c:v>
                </c:pt>
                <c:pt idx="125">
                  <c:v>890.96239999999932</c:v>
                </c:pt>
                <c:pt idx="126">
                  <c:v>892.89089000000001</c:v>
                </c:pt>
                <c:pt idx="127">
                  <c:v>894.81938000000002</c:v>
                </c:pt>
                <c:pt idx="128">
                  <c:v>896.74787000000003</c:v>
                </c:pt>
                <c:pt idx="129">
                  <c:v>898.67636000000005</c:v>
                </c:pt>
                <c:pt idx="130">
                  <c:v>900.60485000000006</c:v>
                </c:pt>
                <c:pt idx="131">
                  <c:v>902.53333999999995</c:v>
                </c:pt>
                <c:pt idx="132">
                  <c:v>904.46182999999917</c:v>
                </c:pt>
                <c:pt idx="133">
                  <c:v>906.39031999999997</c:v>
                </c:pt>
                <c:pt idx="134">
                  <c:v>908.31880999999998</c:v>
                </c:pt>
                <c:pt idx="135">
                  <c:v>910.2473</c:v>
                </c:pt>
                <c:pt idx="136">
                  <c:v>912.17579000000001</c:v>
                </c:pt>
                <c:pt idx="137">
                  <c:v>914.10428000000002</c:v>
                </c:pt>
                <c:pt idx="138">
                  <c:v>916.03277000000003</c:v>
                </c:pt>
                <c:pt idx="139">
                  <c:v>917.96125999999902</c:v>
                </c:pt>
                <c:pt idx="140">
                  <c:v>919.88975000000005</c:v>
                </c:pt>
                <c:pt idx="141">
                  <c:v>921.81823999999938</c:v>
                </c:pt>
                <c:pt idx="142">
                  <c:v>923.74672999999996</c:v>
                </c:pt>
                <c:pt idx="143">
                  <c:v>925.67521999999997</c:v>
                </c:pt>
                <c:pt idx="144">
                  <c:v>927.60371099999998</c:v>
                </c:pt>
                <c:pt idx="145">
                  <c:v>929.5322009999993</c:v>
                </c:pt>
                <c:pt idx="146">
                  <c:v>931.46069099999931</c:v>
                </c:pt>
                <c:pt idx="147">
                  <c:v>933.38918100000001</c:v>
                </c:pt>
                <c:pt idx="148">
                  <c:v>935.31767099999945</c:v>
                </c:pt>
                <c:pt idx="149">
                  <c:v>937.24616099999946</c:v>
                </c:pt>
                <c:pt idx="150">
                  <c:v>939.17465100000004</c:v>
                </c:pt>
                <c:pt idx="151">
                  <c:v>941.10314100000005</c:v>
                </c:pt>
                <c:pt idx="152">
                  <c:v>943.03163099999938</c:v>
                </c:pt>
                <c:pt idx="153">
                  <c:v>944.96012099999916</c:v>
                </c:pt>
                <c:pt idx="154">
                  <c:v>946.88861099999997</c:v>
                </c:pt>
                <c:pt idx="155">
                  <c:v>948.8171009999993</c:v>
                </c:pt>
                <c:pt idx="156">
                  <c:v>950.74559099999999</c:v>
                </c:pt>
                <c:pt idx="157">
                  <c:v>952.674081</c:v>
                </c:pt>
                <c:pt idx="158">
                  <c:v>954.60257100000001</c:v>
                </c:pt>
                <c:pt idx="159">
                  <c:v>956.53106099999945</c:v>
                </c:pt>
                <c:pt idx="160">
                  <c:v>958.45955099999946</c:v>
                </c:pt>
                <c:pt idx="161">
                  <c:v>960.38804100000004</c:v>
                </c:pt>
                <c:pt idx="162">
                  <c:v>962.31653099999949</c:v>
                </c:pt>
                <c:pt idx="163">
                  <c:v>964.24502099999938</c:v>
                </c:pt>
                <c:pt idx="164">
                  <c:v>966.17351099999996</c:v>
                </c:pt>
                <c:pt idx="165">
                  <c:v>968.10200099999997</c:v>
                </c:pt>
                <c:pt idx="166">
                  <c:v>970.03049099999998</c:v>
                </c:pt>
                <c:pt idx="167">
                  <c:v>971.95898199999999</c:v>
                </c:pt>
                <c:pt idx="168">
                  <c:v>973.887472</c:v>
                </c:pt>
                <c:pt idx="169">
                  <c:v>975.81596199999944</c:v>
                </c:pt>
                <c:pt idx="170">
                  <c:v>977.74445200000002</c:v>
                </c:pt>
                <c:pt idx="171">
                  <c:v>979.67294200000003</c:v>
                </c:pt>
                <c:pt idx="172">
                  <c:v>981.60143200000005</c:v>
                </c:pt>
                <c:pt idx="173">
                  <c:v>983.52992200000006</c:v>
                </c:pt>
                <c:pt idx="174">
                  <c:v>985.45841199999938</c:v>
                </c:pt>
                <c:pt idx="175">
                  <c:v>987.38690199999996</c:v>
                </c:pt>
                <c:pt idx="176">
                  <c:v>989.31539199999997</c:v>
                </c:pt>
                <c:pt idx="177">
                  <c:v>991.24388199999999</c:v>
                </c:pt>
                <c:pt idx="178">
                  <c:v>993.172372</c:v>
                </c:pt>
                <c:pt idx="179">
                  <c:v>995.10086200000001</c:v>
                </c:pt>
                <c:pt idx="180">
                  <c:v>997.02935200000002</c:v>
                </c:pt>
                <c:pt idx="181">
                  <c:v>998.95784199999946</c:v>
                </c:pt>
                <c:pt idx="182">
                  <c:v>1000.886332</c:v>
                </c:pt>
                <c:pt idx="183">
                  <c:v>1002.814822</c:v>
                </c:pt>
                <c:pt idx="184">
                  <c:v>1004.7433119999999</c:v>
                </c:pt>
                <c:pt idx="185">
                  <c:v>1006.671802</c:v>
                </c:pt>
                <c:pt idx="186">
                  <c:v>1008.600292</c:v>
                </c:pt>
                <c:pt idx="187">
                  <c:v>1010.528782</c:v>
                </c:pt>
                <c:pt idx="188">
                  <c:v>1012.457272</c:v>
                </c:pt>
                <c:pt idx="189">
                  <c:v>1014.385762</c:v>
                </c:pt>
                <c:pt idx="190">
                  <c:v>1016.314252</c:v>
                </c:pt>
                <c:pt idx="191">
                  <c:v>1018.242743</c:v>
                </c:pt>
                <c:pt idx="192">
                  <c:v>1020.171233</c:v>
                </c:pt>
                <c:pt idx="193">
                  <c:v>1022.099723</c:v>
                </c:pt>
                <c:pt idx="194">
                  <c:v>1024.0282130000001</c:v>
                </c:pt>
                <c:pt idx="195">
                  <c:v>1025.9567030000001</c:v>
                </c:pt>
                <c:pt idx="196">
                  <c:v>1027.8851930000001</c:v>
                </c:pt>
                <c:pt idx="197">
                  <c:v>1029.8136830000001</c:v>
                </c:pt>
                <c:pt idx="198">
                  <c:v>1031.7421730000001</c:v>
                </c:pt>
                <c:pt idx="199">
                  <c:v>1033.6706630000001</c:v>
                </c:pt>
                <c:pt idx="200">
                  <c:v>1035.5991529999999</c:v>
                </c:pt>
                <c:pt idx="201">
                  <c:v>1037.5276429999999</c:v>
                </c:pt>
                <c:pt idx="202">
                  <c:v>1039.4561329999999</c:v>
                </c:pt>
                <c:pt idx="203">
                  <c:v>1041.3846229999999</c:v>
                </c:pt>
                <c:pt idx="204">
                  <c:v>1043.3131129999999</c:v>
                </c:pt>
                <c:pt idx="205">
                  <c:v>1045.2416029999999</c:v>
                </c:pt>
                <c:pt idx="206">
                  <c:v>1047.170093</c:v>
                </c:pt>
                <c:pt idx="207">
                  <c:v>1049.098583</c:v>
                </c:pt>
                <c:pt idx="208">
                  <c:v>1051.027073</c:v>
                </c:pt>
                <c:pt idx="209">
                  <c:v>1052.955563</c:v>
                </c:pt>
                <c:pt idx="210">
                  <c:v>1054.884053</c:v>
                </c:pt>
                <c:pt idx="211">
                  <c:v>1056.812543</c:v>
                </c:pt>
                <c:pt idx="212">
                  <c:v>1058.741033</c:v>
                </c:pt>
                <c:pt idx="213">
                  <c:v>1060.669523</c:v>
                </c:pt>
                <c:pt idx="214">
                  <c:v>1062.5980139999999</c:v>
                </c:pt>
                <c:pt idx="215">
                  <c:v>1064.5265039999999</c:v>
                </c:pt>
                <c:pt idx="216">
                  <c:v>1066.4549939999999</c:v>
                </c:pt>
                <c:pt idx="217">
                  <c:v>1068.383484</c:v>
                </c:pt>
                <c:pt idx="218">
                  <c:v>1070.311974</c:v>
                </c:pt>
                <c:pt idx="219">
                  <c:v>1072.240464</c:v>
                </c:pt>
                <c:pt idx="220">
                  <c:v>1074.168954</c:v>
                </c:pt>
                <c:pt idx="221">
                  <c:v>1076.097444</c:v>
                </c:pt>
                <c:pt idx="222">
                  <c:v>1078.025934</c:v>
                </c:pt>
                <c:pt idx="223">
                  <c:v>1079.954424</c:v>
                </c:pt>
                <c:pt idx="224">
                  <c:v>1081.882914</c:v>
                </c:pt>
                <c:pt idx="225">
                  <c:v>1083.811404</c:v>
                </c:pt>
                <c:pt idx="226">
                  <c:v>1085.739894</c:v>
                </c:pt>
                <c:pt idx="227">
                  <c:v>1087.6683840000001</c:v>
                </c:pt>
                <c:pt idx="228">
                  <c:v>1089.5968740000001</c:v>
                </c:pt>
                <c:pt idx="229">
                  <c:v>1091.5253640000001</c:v>
                </c:pt>
                <c:pt idx="230">
                  <c:v>1093.4538540000001</c:v>
                </c:pt>
                <c:pt idx="231">
                  <c:v>1095.3823440000001</c:v>
                </c:pt>
                <c:pt idx="232">
                  <c:v>1097.3108340000001</c:v>
                </c:pt>
                <c:pt idx="233">
                  <c:v>1099.2393239999999</c:v>
                </c:pt>
                <c:pt idx="234">
                  <c:v>1101.1678139999999</c:v>
                </c:pt>
                <c:pt idx="235">
                  <c:v>1103.0963039999999</c:v>
                </c:pt>
                <c:pt idx="236">
                  <c:v>1105.0247939999999</c:v>
                </c:pt>
                <c:pt idx="237">
                  <c:v>1106.9532850000001</c:v>
                </c:pt>
                <c:pt idx="238">
                  <c:v>1108.8817750000001</c:v>
                </c:pt>
                <c:pt idx="239">
                  <c:v>1110.8102650000001</c:v>
                </c:pt>
                <c:pt idx="240">
                  <c:v>1112.7387550000001</c:v>
                </c:pt>
                <c:pt idx="241">
                  <c:v>1114.6672450000001</c:v>
                </c:pt>
                <c:pt idx="242">
                  <c:v>1116.5957350000001</c:v>
                </c:pt>
                <c:pt idx="243">
                  <c:v>1118.5242249999999</c:v>
                </c:pt>
                <c:pt idx="244">
                  <c:v>1120.4527149999999</c:v>
                </c:pt>
                <c:pt idx="245">
                  <c:v>1122.3812049999999</c:v>
                </c:pt>
                <c:pt idx="246">
                  <c:v>1124.3096949999999</c:v>
                </c:pt>
                <c:pt idx="247">
                  <c:v>1126.2381849999999</c:v>
                </c:pt>
                <c:pt idx="248">
                  <c:v>1128.1666749999999</c:v>
                </c:pt>
                <c:pt idx="249">
                  <c:v>1130.095165</c:v>
                </c:pt>
                <c:pt idx="250">
                  <c:v>1132.023655</c:v>
                </c:pt>
                <c:pt idx="251">
                  <c:v>1133.952145</c:v>
                </c:pt>
                <c:pt idx="252">
                  <c:v>1135.880635</c:v>
                </c:pt>
                <c:pt idx="253">
                  <c:v>1137.809125</c:v>
                </c:pt>
                <c:pt idx="254">
                  <c:v>1139.737615</c:v>
                </c:pt>
                <c:pt idx="255">
                  <c:v>1141.666105</c:v>
                </c:pt>
                <c:pt idx="256">
                  <c:v>1143.594595</c:v>
                </c:pt>
                <c:pt idx="257">
                  <c:v>1145.523085</c:v>
                </c:pt>
                <c:pt idx="258">
                  <c:v>1147.451575</c:v>
                </c:pt>
                <c:pt idx="259">
                  <c:v>1149.3800650000001</c:v>
                </c:pt>
                <c:pt idx="260">
                  <c:v>1151.3085550000001</c:v>
                </c:pt>
                <c:pt idx="261">
                  <c:v>1153.237046</c:v>
                </c:pt>
                <c:pt idx="262">
                  <c:v>1155.165536</c:v>
                </c:pt>
                <c:pt idx="263">
                  <c:v>1157.094026</c:v>
                </c:pt>
                <c:pt idx="264">
                  <c:v>1159.022516</c:v>
                </c:pt>
                <c:pt idx="265">
                  <c:v>1160.951006</c:v>
                </c:pt>
                <c:pt idx="266">
                  <c:v>1162.879496</c:v>
                </c:pt>
                <c:pt idx="267">
                  <c:v>1164.807986</c:v>
                </c:pt>
                <c:pt idx="268">
                  <c:v>1166.736476</c:v>
                </c:pt>
                <c:pt idx="269">
                  <c:v>1168.664966</c:v>
                </c:pt>
                <c:pt idx="270">
                  <c:v>1170.5934560000001</c:v>
                </c:pt>
                <c:pt idx="271">
                  <c:v>1172.5219460000001</c:v>
                </c:pt>
                <c:pt idx="272">
                  <c:v>1174.4504360000001</c:v>
                </c:pt>
                <c:pt idx="273">
                  <c:v>1176.3789260000001</c:v>
                </c:pt>
                <c:pt idx="274">
                  <c:v>1178.3074160000001</c:v>
                </c:pt>
                <c:pt idx="275">
                  <c:v>1180.2359060000001</c:v>
                </c:pt>
                <c:pt idx="276">
                  <c:v>1182.1643959999999</c:v>
                </c:pt>
                <c:pt idx="277">
                  <c:v>1184.0928859999999</c:v>
                </c:pt>
                <c:pt idx="278">
                  <c:v>1186.0213759999999</c:v>
                </c:pt>
                <c:pt idx="279">
                  <c:v>1187.9498659999999</c:v>
                </c:pt>
                <c:pt idx="280">
                  <c:v>1189.8783559999999</c:v>
                </c:pt>
                <c:pt idx="281">
                  <c:v>1191.806846</c:v>
                </c:pt>
                <c:pt idx="282">
                  <c:v>1193.735336</c:v>
                </c:pt>
                <c:pt idx="283">
                  <c:v>1195.663826</c:v>
                </c:pt>
                <c:pt idx="284">
                  <c:v>1197.5923170000001</c:v>
                </c:pt>
                <c:pt idx="285">
                  <c:v>1199.5208070000001</c:v>
                </c:pt>
                <c:pt idx="286">
                  <c:v>1201.4492969999999</c:v>
                </c:pt>
                <c:pt idx="287">
                  <c:v>1203.3777869999999</c:v>
                </c:pt>
                <c:pt idx="288">
                  <c:v>1205.3062769999999</c:v>
                </c:pt>
                <c:pt idx="289">
                  <c:v>1207.2347669999999</c:v>
                </c:pt>
                <c:pt idx="290">
                  <c:v>1209.1632569999999</c:v>
                </c:pt>
                <c:pt idx="291">
                  <c:v>1211.0917469999999</c:v>
                </c:pt>
                <c:pt idx="292">
                  <c:v>1213.020237</c:v>
                </c:pt>
                <c:pt idx="293">
                  <c:v>1214.948727</c:v>
                </c:pt>
                <c:pt idx="294">
                  <c:v>1216.877217</c:v>
                </c:pt>
                <c:pt idx="295">
                  <c:v>1218.805707</c:v>
                </c:pt>
                <c:pt idx="296">
                  <c:v>1220.734197</c:v>
                </c:pt>
                <c:pt idx="297">
                  <c:v>1222.662687</c:v>
                </c:pt>
                <c:pt idx="298">
                  <c:v>1224.591177</c:v>
                </c:pt>
                <c:pt idx="299">
                  <c:v>1226.519667</c:v>
                </c:pt>
                <c:pt idx="300">
                  <c:v>1228.448157</c:v>
                </c:pt>
                <c:pt idx="301">
                  <c:v>1230.376647</c:v>
                </c:pt>
                <c:pt idx="302">
                  <c:v>1232.3051370000001</c:v>
                </c:pt>
                <c:pt idx="303">
                  <c:v>1234.2336270000001</c:v>
                </c:pt>
                <c:pt idx="304">
                  <c:v>1236.1621170000001</c:v>
                </c:pt>
                <c:pt idx="305">
                  <c:v>1238.0906070000001</c:v>
                </c:pt>
                <c:pt idx="306">
                  <c:v>1240.0190970000001</c:v>
                </c:pt>
                <c:pt idx="307">
                  <c:v>1241.9475870000001</c:v>
                </c:pt>
                <c:pt idx="308">
                  <c:v>1243.876078</c:v>
                </c:pt>
                <c:pt idx="309">
                  <c:v>1245.804568</c:v>
                </c:pt>
                <c:pt idx="310">
                  <c:v>1247.733058</c:v>
                </c:pt>
                <c:pt idx="311">
                  <c:v>1249.661548</c:v>
                </c:pt>
                <c:pt idx="312">
                  <c:v>1251.590038</c:v>
                </c:pt>
                <c:pt idx="313">
                  <c:v>1253.5185280000001</c:v>
                </c:pt>
                <c:pt idx="314">
                  <c:v>1255.4470180000001</c:v>
                </c:pt>
                <c:pt idx="315">
                  <c:v>1257.3755080000001</c:v>
                </c:pt>
                <c:pt idx="316">
                  <c:v>1259.3039980000001</c:v>
                </c:pt>
                <c:pt idx="317">
                  <c:v>1261.2324880000001</c:v>
                </c:pt>
                <c:pt idx="318">
                  <c:v>1263.1609779999999</c:v>
                </c:pt>
                <c:pt idx="319">
                  <c:v>1265.0894679999999</c:v>
                </c:pt>
                <c:pt idx="320">
                  <c:v>1267.0179579999999</c:v>
                </c:pt>
                <c:pt idx="321">
                  <c:v>1268.9464479999999</c:v>
                </c:pt>
                <c:pt idx="322">
                  <c:v>1270.8749379999999</c:v>
                </c:pt>
                <c:pt idx="323">
                  <c:v>1272.8034279999999</c:v>
                </c:pt>
                <c:pt idx="324">
                  <c:v>1274.731918</c:v>
                </c:pt>
                <c:pt idx="325">
                  <c:v>1276.660408</c:v>
                </c:pt>
                <c:pt idx="326">
                  <c:v>1278.588898</c:v>
                </c:pt>
                <c:pt idx="327">
                  <c:v>1280.517388</c:v>
                </c:pt>
                <c:pt idx="328">
                  <c:v>1282.445878</c:v>
                </c:pt>
                <c:pt idx="329">
                  <c:v>1284.374368</c:v>
                </c:pt>
                <c:pt idx="330">
                  <c:v>1286.302858</c:v>
                </c:pt>
                <c:pt idx="331">
                  <c:v>1288.2313489999999</c:v>
                </c:pt>
                <c:pt idx="332">
                  <c:v>1290.1598389999999</c:v>
                </c:pt>
                <c:pt idx="333">
                  <c:v>1292.0883289999999</c:v>
                </c:pt>
                <c:pt idx="334">
                  <c:v>1294.0168189999999</c:v>
                </c:pt>
                <c:pt idx="335">
                  <c:v>1295.945309</c:v>
                </c:pt>
                <c:pt idx="336">
                  <c:v>1297.873799</c:v>
                </c:pt>
                <c:pt idx="337">
                  <c:v>1299.802289</c:v>
                </c:pt>
                <c:pt idx="338">
                  <c:v>1301.730779</c:v>
                </c:pt>
                <c:pt idx="339">
                  <c:v>1303.659269</c:v>
                </c:pt>
                <c:pt idx="340">
                  <c:v>1305.587759</c:v>
                </c:pt>
                <c:pt idx="341">
                  <c:v>1307.516249</c:v>
                </c:pt>
                <c:pt idx="342">
                  <c:v>1309.444739</c:v>
                </c:pt>
                <c:pt idx="343">
                  <c:v>1311.373229</c:v>
                </c:pt>
                <c:pt idx="344">
                  <c:v>1313.301719</c:v>
                </c:pt>
                <c:pt idx="345">
                  <c:v>1315.2302090000001</c:v>
                </c:pt>
                <c:pt idx="346">
                  <c:v>1317.1586990000001</c:v>
                </c:pt>
                <c:pt idx="347">
                  <c:v>1319.0871890000001</c:v>
                </c:pt>
                <c:pt idx="348">
                  <c:v>1321.0156790000001</c:v>
                </c:pt>
                <c:pt idx="349">
                  <c:v>1322.9441690000001</c:v>
                </c:pt>
                <c:pt idx="350">
                  <c:v>1324.8726590000001</c:v>
                </c:pt>
                <c:pt idx="351">
                  <c:v>1326.8011489999999</c:v>
                </c:pt>
                <c:pt idx="352">
                  <c:v>1328.7296389999999</c:v>
                </c:pt>
                <c:pt idx="353">
                  <c:v>1330.6581289999999</c:v>
                </c:pt>
                <c:pt idx="354">
                  <c:v>1332.5866189999999</c:v>
                </c:pt>
                <c:pt idx="355">
                  <c:v>1334.51511</c:v>
                </c:pt>
                <c:pt idx="356">
                  <c:v>1336.4436000000001</c:v>
                </c:pt>
                <c:pt idx="357">
                  <c:v>1338.3720900000001</c:v>
                </c:pt>
                <c:pt idx="358">
                  <c:v>1340.3005800000001</c:v>
                </c:pt>
                <c:pt idx="359">
                  <c:v>1342.2290700000001</c:v>
                </c:pt>
                <c:pt idx="360">
                  <c:v>1344.1575600000001</c:v>
                </c:pt>
                <c:pt idx="361">
                  <c:v>1346.0860499999999</c:v>
                </c:pt>
                <c:pt idx="362">
                  <c:v>1348.0145399999999</c:v>
                </c:pt>
                <c:pt idx="363">
                  <c:v>1349.9430299999999</c:v>
                </c:pt>
                <c:pt idx="364">
                  <c:v>1351.8715199999999</c:v>
                </c:pt>
                <c:pt idx="365">
                  <c:v>1353.8000099999999</c:v>
                </c:pt>
                <c:pt idx="366">
                  <c:v>1355.7284999999999</c:v>
                </c:pt>
                <c:pt idx="367">
                  <c:v>1357.65699</c:v>
                </c:pt>
                <c:pt idx="368">
                  <c:v>1359.58548</c:v>
                </c:pt>
                <c:pt idx="369">
                  <c:v>1361.51397</c:v>
                </c:pt>
                <c:pt idx="370">
                  <c:v>1363.44246</c:v>
                </c:pt>
                <c:pt idx="371">
                  <c:v>1365.37095</c:v>
                </c:pt>
                <c:pt idx="372">
                  <c:v>1367.29944</c:v>
                </c:pt>
                <c:pt idx="373">
                  <c:v>1369.22793</c:v>
                </c:pt>
                <c:pt idx="374">
                  <c:v>1371.15642</c:v>
                </c:pt>
                <c:pt idx="375">
                  <c:v>1373.08491</c:v>
                </c:pt>
                <c:pt idx="376">
                  <c:v>1375.0134</c:v>
                </c:pt>
                <c:pt idx="377">
                  <c:v>1376.9418900000001</c:v>
                </c:pt>
                <c:pt idx="378">
                  <c:v>1378.870381</c:v>
                </c:pt>
                <c:pt idx="379">
                  <c:v>1380.798871</c:v>
                </c:pt>
                <c:pt idx="380">
                  <c:v>1382.727361</c:v>
                </c:pt>
                <c:pt idx="381">
                  <c:v>1384.655851</c:v>
                </c:pt>
                <c:pt idx="382">
                  <c:v>1386.584341</c:v>
                </c:pt>
                <c:pt idx="383">
                  <c:v>1388.512831</c:v>
                </c:pt>
                <c:pt idx="384">
                  <c:v>1390.441321</c:v>
                </c:pt>
                <c:pt idx="385">
                  <c:v>1392.369811</c:v>
                </c:pt>
                <c:pt idx="386">
                  <c:v>1394.298301</c:v>
                </c:pt>
                <c:pt idx="387">
                  <c:v>1396.226791</c:v>
                </c:pt>
                <c:pt idx="388">
                  <c:v>1398.1552810000001</c:v>
                </c:pt>
                <c:pt idx="389">
                  <c:v>1400.0837710000001</c:v>
                </c:pt>
                <c:pt idx="390">
                  <c:v>1402.0122610000001</c:v>
                </c:pt>
                <c:pt idx="391">
                  <c:v>1403.9407510000001</c:v>
                </c:pt>
                <c:pt idx="392">
                  <c:v>1405.8692410000001</c:v>
                </c:pt>
                <c:pt idx="393">
                  <c:v>1407.7977310000001</c:v>
                </c:pt>
                <c:pt idx="394">
                  <c:v>1409.7262209999999</c:v>
                </c:pt>
                <c:pt idx="395">
                  <c:v>1411.6547109999999</c:v>
                </c:pt>
                <c:pt idx="396">
                  <c:v>1413.5832009999999</c:v>
                </c:pt>
                <c:pt idx="397">
                  <c:v>1415.5116909999999</c:v>
                </c:pt>
                <c:pt idx="398">
                  <c:v>1417.4401809999999</c:v>
                </c:pt>
                <c:pt idx="399">
                  <c:v>1419.3686709999999</c:v>
                </c:pt>
                <c:pt idx="400">
                  <c:v>1421.297161</c:v>
                </c:pt>
                <c:pt idx="401">
                  <c:v>1423.2256520000001</c:v>
                </c:pt>
                <c:pt idx="402">
                  <c:v>1425.1541420000001</c:v>
                </c:pt>
                <c:pt idx="403">
                  <c:v>1427.0826320000001</c:v>
                </c:pt>
                <c:pt idx="404">
                  <c:v>1429.0111219999999</c:v>
                </c:pt>
                <c:pt idx="405">
                  <c:v>1430.9396119999999</c:v>
                </c:pt>
                <c:pt idx="406">
                  <c:v>1432.8681019999999</c:v>
                </c:pt>
                <c:pt idx="407">
                  <c:v>1434.7965919999999</c:v>
                </c:pt>
                <c:pt idx="408">
                  <c:v>1436.7250819999999</c:v>
                </c:pt>
                <c:pt idx="409">
                  <c:v>1438.6535719999999</c:v>
                </c:pt>
                <c:pt idx="410">
                  <c:v>1440.582062</c:v>
                </c:pt>
                <c:pt idx="411">
                  <c:v>1442.510552</c:v>
                </c:pt>
                <c:pt idx="412">
                  <c:v>1444.439042</c:v>
                </c:pt>
                <c:pt idx="413">
                  <c:v>1446.367532</c:v>
                </c:pt>
                <c:pt idx="414">
                  <c:v>1448.296022</c:v>
                </c:pt>
                <c:pt idx="415">
                  <c:v>1450.224512</c:v>
                </c:pt>
                <c:pt idx="416">
                  <c:v>1452.153002</c:v>
                </c:pt>
                <c:pt idx="417">
                  <c:v>1454.081492</c:v>
                </c:pt>
                <c:pt idx="418">
                  <c:v>1456.009982</c:v>
                </c:pt>
                <c:pt idx="419">
                  <c:v>1457.938472</c:v>
                </c:pt>
                <c:pt idx="420">
                  <c:v>1459.8669620000001</c:v>
                </c:pt>
                <c:pt idx="421">
                  <c:v>1461.7954520000001</c:v>
                </c:pt>
                <c:pt idx="422">
                  <c:v>1463.7239420000001</c:v>
                </c:pt>
                <c:pt idx="423">
                  <c:v>1465.6524320000001</c:v>
                </c:pt>
                <c:pt idx="424">
                  <c:v>1467.5809220000001</c:v>
                </c:pt>
                <c:pt idx="425">
                  <c:v>1469.509413</c:v>
                </c:pt>
                <c:pt idx="426">
                  <c:v>1471.437903</c:v>
                </c:pt>
                <c:pt idx="427">
                  <c:v>1473.366393</c:v>
                </c:pt>
                <c:pt idx="428">
                  <c:v>1475.294883</c:v>
                </c:pt>
                <c:pt idx="429">
                  <c:v>1477.223373</c:v>
                </c:pt>
                <c:pt idx="430">
                  <c:v>1479.151863</c:v>
                </c:pt>
                <c:pt idx="431">
                  <c:v>1481.0803530000001</c:v>
                </c:pt>
                <c:pt idx="432">
                  <c:v>1483.0088430000001</c:v>
                </c:pt>
                <c:pt idx="433">
                  <c:v>1484.9373330000001</c:v>
                </c:pt>
                <c:pt idx="434">
                  <c:v>1486.8658230000001</c:v>
                </c:pt>
                <c:pt idx="435">
                  <c:v>1488.7943130000001</c:v>
                </c:pt>
                <c:pt idx="436">
                  <c:v>1490.7228030000001</c:v>
                </c:pt>
                <c:pt idx="437">
                  <c:v>1492.6512929999999</c:v>
                </c:pt>
                <c:pt idx="438">
                  <c:v>1494.5797829999999</c:v>
                </c:pt>
                <c:pt idx="439">
                  <c:v>1496.5082729999999</c:v>
                </c:pt>
                <c:pt idx="440">
                  <c:v>1498.4367629999999</c:v>
                </c:pt>
                <c:pt idx="441">
                  <c:v>1500.3652529999999</c:v>
                </c:pt>
                <c:pt idx="442">
                  <c:v>1502.2937429999999</c:v>
                </c:pt>
                <c:pt idx="443">
                  <c:v>1504.222233</c:v>
                </c:pt>
                <c:pt idx="444">
                  <c:v>1506.150723</c:v>
                </c:pt>
                <c:pt idx="445">
                  <c:v>1508.079213</c:v>
                </c:pt>
                <c:pt idx="446">
                  <c:v>1510.007703</c:v>
                </c:pt>
                <c:pt idx="447">
                  <c:v>1511.936193</c:v>
                </c:pt>
                <c:pt idx="448">
                  <c:v>1513.8646839999999</c:v>
                </c:pt>
                <c:pt idx="449">
                  <c:v>1515.7931739999999</c:v>
                </c:pt>
                <c:pt idx="450">
                  <c:v>1517.7216639999999</c:v>
                </c:pt>
                <c:pt idx="451">
                  <c:v>1519.6501539999999</c:v>
                </c:pt>
                <c:pt idx="452">
                  <c:v>1521.5786439999999</c:v>
                </c:pt>
                <c:pt idx="453">
                  <c:v>1523.507134</c:v>
                </c:pt>
                <c:pt idx="454">
                  <c:v>1525.435624</c:v>
                </c:pt>
                <c:pt idx="455">
                  <c:v>1527.364114</c:v>
                </c:pt>
                <c:pt idx="456">
                  <c:v>1529.292604</c:v>
                </c:pt>
                <c:pt idx="457">
                  <c:v>1531.221094</c:v>
                </c:pt>
                <c:pt idx="458">
                  <c:v>1533.149584</c:v>
                </c:pt>
                <c:pt idx="459">
                  <c:v>1535.078074</c:v>
                </c:pt>
                <c:pt idx="460">
                  <c:v>1537.006564</c:v>
                </c:pt>
                <c:pt idx="461">
                  <c:v>1538.935054</c:v>
                </c:pt>
                <c:pt idx="462">
                  <c:v>1540.863544</c:v>
                </c:pt>
                <c:pt idx="463">
                  <c:v>1542.7920340000001</c:v>
                </c:pt>
                <c:pt idx="464">
                  <c:v>1544.7205240000001</c:v>
                </c:pt>
                <c:pt idx="465">
                  <c:v>1546.6490140000001</c:v>
                </c:pt>
                <c:pt idx="466">
                  <c:v>1548.5775040000001</c:v>
                </c:pt>
                <c:pt idx="467">
                  <c:v>1550.5059940000001</c:v>
                </c:pt>
                <c:pt idx="468">
                  <c:v>1552.4344840000001</c:v>
                </c:pt>
                <c:pt idx="469">
                  <c:v>1554.3629739999999</c:v>
                </c:pt>
                <c:pt idx="470">
                  <c:v>1556.2914639999999</c:v>
                </c:pt>
                <c:pt idx="471">
                  <c:v>1558.2199539999999</c:v>
                </c:pt>
                <c:pt idx="472">
                  <c:v>1560.148445</c:v>
                </c:pt>
                <c:pt idx="473">
                  <c:v>1562.076935</c:v>
                </c:pt>
                <c:pt idx="474">
                  <c:v>1564.0054250000001</c:v>
                </c:pt>
                <c:pt idx="475">
                  <c:v>1565.9339150000001</c:v>
                </c:pt>
                <c:pt idx="476">
                  <c:v>1567.8624050000001</c:v>
                </c:pt>
                <c:pt idx="477">
                  <c:v>1569.7908950000001</c:v>
                </c:pt>
                <c:pt idx="478">
                  <c:v>1571.7193850000001</c:v>
                </c:pt>
                <c:pt idx="479">
                  <c:v>1573.6478750000001</c:v>
                </c:pt>
                <c:pt idx="480">
                  <c:v>1575.5763649999999</c:v>
                </c:pt>
                <c:pt idx="481">
                  <c:v>1577.5048549999999</c:v>
                </c:pt>
                <c:pt idx="482">
                  <c:v>1579.4333449999999</c:v>
                </c:pt>
                <c:pt idx="483">
                  <c:v>1581.3618349999999</c:v>
                </c:pt>
                <c:pt idx="484">
                  <c:v>1583.2903249999999</c:v>
                </c:pt>
                <c:pt idx="485">
                  <c:v>1585.2188149999999</c:v>
                </c:pt>
                <c:pt idx="486">
                  <c:v>1587.147305</c:v>
                </c:pt>
                <c:pt idx="487">
                  <c:v>1589.075795</c:v>
                </c:pt>
                <c:pt idx="488">
                  <c:v>1591.004285</c:v>
                </c:pt>
                <c:pt idx="489">
                  <c:v>1592.932775</c:v>
                </c:pt>
                <c:pt idx="490">
                  <c:v>1594.861265</c:v>
                </c:pt>
                <c:pt idx="491">
                  <c:v>1596.789755</c:v>
                </c:pt>
                <c:pt idx="492">
                  <c:v>1598.718245</c:v>
                </c:pt>
                <c:pt idx="493">
                  <c:v>1600.646735</c:v>
                </c:pt>
                <c:pt idx="494">
                  <c:v>1602.575225</c:v>
                </c:pt>
                <c:pt idx="495">
                  <c:v>1604.5037159999999</c:v>
                </c:pt>
                <c:pt idx="496">
                  <c:v>1606.432206</c:v>
                </c:pt>
                <c:pt idx="497">
                  <c:v>1608.360696</c:v>
                </c:pt>
                <c:pt idx="498">
                  <c:v>1610.289186</c:v>
                </c:pt>
                <c:pt idx="499">
                  <c:v>1612.217676</c:v>
                </c:pt>
                <c:pt idx="500">
                  <c:v>1614.146166</c:v>
                </c:pt>
                <c:pt idx="501">
                  <c:v>1616.074656</c:v>
                </c:pt>
                <c:pt idx="502">
                  <c:v>1618.003146</c:v>
                </c:pt>
                <c:pt idx="503">
                  <c:v>1619.931636</c:v>
                </c:pt>
                <c:pt idx="504">
                  <c:v>1621.860126</c:v>
                </c:pt>
                <c:pt idx="505">
                  <c:v>1623.788616</c:v>
                </c:pt>
                <c:pt idx="506">
                  <c:v>1625.7171060000001</c:v>
                </c:pt>
                <c:pt idx="507">
                  <c:v>1627.6455960000001</c:v>
                </c:pt>
                <c:pt idx="508">
                  <c:v>1629.5740860000001</c:v>
                </c:pt>
                <c:pt idx="509">
                  <c:v>1631.5025760000001</c:v>
                </c:pt>
                <c:pt idx="510">
                  <c:v>1633.4310660000001</c:v>
                </c:pt>
                <c:pt idx="511">
                  <c:v>1635.3595560000001</c:v>
                </c:pt>
                <c:pt idx="512">
                  <c:v>1637.2880459999999</c:v>
                </c:pt>
                <c:pt idx="513">
                  <c:v>1639.2165359999999</c:v>
                </c:pt>
                <c:pt idx="514">
                  <c:v>1641.1450259999999</c:v>
                </c:pt>
                <c:pt idx="515">
                  <c:v>1643.0735159999999</c:v>
                </c:pt>
                <c:pt idx="516">
                  <c:v>1645.0020059999999</c:v>
                </c:pt>
                <c:pt idx="517">
                  <c:v>1646.9304959999999</c:v>
                </c:pt>
                <c:pt idx="518">
                  <c:v>1648.858986</c:v>
                </c:pt>
                <c:pt idx="519">
                  <c:v>1650.7874770000001</c:v>
                </c:pt>
                <c:pt idx="520">
                  <c:v>1652.7159670000001</c:v>
                </c:pt>
                <c:pt idx="521">
                  <c:v>1654.6444570000001</c:v>
                </c:pt>
                <c:pt idx="522">
                  <c:v>1656.5729470000001</c:v>
                </c:pt>
                <c:pt idx="523">
                  <c:v>1658.5014369999999</c:v>
                </c:pt>
                <c:pt idx="524">
                  <c:v>1660.4299269999999</c:v>
                </c:pt>
                <c:pt idx="525">
                  <c:v>1662.3584169999999</c:v>
                </c:pt>
                <c:pt idx="526">
                  <c:v>1664.2869069999999</c:v>
                </c:pt>
                <c:pt idx="527">
                  <c:v>1666.2153969999999</c:v>
                </c:pt>
                <c:pt idx="528">
                  <c:v>1668.1438869999999</c:v>
                </c:pt>
                <c:pt idx="529">
                  <c:v>1670.072377</c:v>
                </c:pt>
                <c:pt idx="530">
                  <c:v>1672.000867</c:v>
                </c:pt>
                <c:pt idx="531">
                  <c:v>1673.929357</c:v>
                </c:pt>
                <c:pt idx="532">
                  <c:v>1675.857847</c:v>
                </c:pt>
                <c:pt idx="533">
                  <c:v>1677.786337</c:v>
                </c:pt>
                <c:pt idx="534">
                  <c:v>1679.714827</c:v>
                </c:pt>
                <c:pt idx="535">
                  <c:v>1681.643317</c:v>
                </c:pt>
                <c:pt idx="536">
                  <c:v>1683.571807</c:v>
                </c:pt>
                <c:pt idx="537">
                  <c:v>1685.500297</c:v>
                </c:pt>
                <c:pt idx="538">
                  <c:v>1687.4287870000001</c:v>
                </c:pt>
                <c:pt idx="539">
                  <c:v>1689.3572770000001</c:v>
                </c:pt>
                <c:pt idx="540">
                  <c:v>1691.2857670000001</c:v>
                </c:pt>
                <c:pt idx="541">
                  <c:v>1693.2142570000001</c:v>
                </c:pt>
                <c:pt idx="542">
                  <c:v>1695.142748</c:v>
                </c:pt>
                <c:pt idx="543">
                  <c:v>1697.071238</c:v>
                </c:pt>
                <c:pt idx="544">
                  <c:v>1698.999728</c:v>
                </c:pt>
                <c:pt idx="545">
                  <c:v>1700.928218</c:v>
                </c:pt>
                <c:pt idx="546">
                  <c:v>1702.856708</c:v>
                </c:pt>
                <c:pt idx="547">
                  <c:v>1704.785198</c:v>
                </c:pt>
                <c:pt idx="548">
                  <c:v>1706.713688</c:v>
                </c:pt>
                <c:pt idx="549">
                  <c:v>1708.6421780000001</c:v>
                </c:pt>
                <c:pt idx="550">
                  <c:v>1710.5706680000001</c:v>
                </c:pt>
                <c:pt idx="551">
                  <c:v>1712.4991580000001</c:v>
                </c:pt>
                <c:pt idx="552">
                  <c:v>1714.4276480000001</c:v>
                </c:pt>
                <c:pt idx="553">
                  <c:v>1716.3561380000001</c:v>
                </c:pt>
                <c:pt idx="554">
                  <c:v>1718.2846280000001</c:v>
                </c:pt>
                <c:pt idx="555">
                  <c:v>1720.2131179999999</c:v>
                </c:pt>
                <c:pt idx="556">
                  <c:v>1722.1416079999999</c:v>
                </c:pt>
                <c:pt idx="557">
                  <c:v>1724.0700979999999</c:v>
                </c:pt>
                <c:pt idx="558">
                  <c:v>1725.9985879999999</c:v>
                </c:pt>
                <c:pt idx="559">
                  <c:v>1727.9270779999999</c:v>
                </c:pt>
                <c:pt idx="560">
                  <c:v>1729.8555679999999</c:v>
                </c:pt>
                <c:pt idx="561">
                  <c:v>1731.784058</c:v>
                </c:pt>
                <c:pt idx="562">
                  <c:v>1733.712548</c:v>
                </c:pt>
                <c:pt idx="563">
                  <c:v>1735.641038</c:v>
                </c:pt>
                <c:pt idx="564">
                  <c:v>1737.569528</c:v>
                </c:pt>
                <c:pt idx="565">
                  <c:v>1739.4980190000001</c:v>
                </c:pt>
                <c:pt idx="566">
                  <c:v>1741.4265089999999</c:v>
                </c:pt>
                <c:pt idx="567">
                  <c:v>1743.3549989999999</c:v>
                </c:pt>
                <c:pt idx="568">
                  <c:v>1745.2834889999999</c:v>
                </c:pt>
                <c:pt idx="569">
                  <c:v>1747.2119789999999</c:v>
                </c:pt>
                <c:pt idx="570">
                  <c:v>1749.1404689999999</c:v>
                </c:pt>
                <c:pt idx="571">
                  <c:v>1751.0689589999999</c:v>
                </c:pt>
                <c:pt idx="572">
                  <c:v>1752.997449</c:v>
                </c:pt>
                <c:pt idx="573">
                  <c:v>1754.925939</c:v>
                </c:pt>
                <c:pt idx="574">
                  <c:v>1756.854429</c:v>
                </c:pt>
                <c:pt idx="575">
                  <c:v>1758.782919</c:v>
                </c:pt>
                <c:pt idx="576">
                  <c:v>1760.711409</c:v>
                </c:pt>
                <c:pt idx="577">
                  <c:v>1762.639899</c:v>
                </c:pt>
                <c:pt idx="578">
                  <c:v>1764.568389</c:v>
                </c:pt>
                <c:pt idx="579">
                  <c:v>1766.496879</c:v>
                </c:pt>
                <c:pt idx="580">
                  <c:v>1768.425369</c:v>
                </c:pt>
                <c:pt idx="581">
                  <c:v>1770.3538590000001</c:v>
                </c:pt>
                <c:pt idx="582">
                  <c:v>1772.2823490000001</c:v>
                </c:pt>
                <c:pt idx="583">
                  <c:v>1774.2108390000001</c:v>
                </c:pt>
                <c:pt idx="584">
                  <c:v>1776.1393290000001</c:v>
                </c:pt>
                <c:pt idx="585">
                  <c:v>1778.0678190000001</c:v>
                </c:pt>
                <c:pt idx="586">
                  <c:v>1779.9963090000001</c:v>
                </c:pt>
                <c:pt idx="587">
                  <c:v>1781.9247989999999</c:v>
                </c:pt>
                <c:pt idx="588">
                  <c:v>1783.8532889999999</c:v>
                </c:pt>
                <c:pt idx="589">
                  <c:v>1785.78178</c:v>
                </c:pt>
                <c:pt idx="590">
                  <c:v>1787.71027</c:v>
                </c:pt>
                <c:pt idx="591">
                  <c:v>1789.63876</c:v>
                </c:pt>
                <c:pt idx="592">
                  <c:v>1791.5672500000001</c:v>
                </c:pt>
                <c:pt idx="593">
                  <c:v>1793.4957400000001</c:v>
                </c:pt>
                <c:pt idx="594">
                  <c:v>1795.4242300000001</c:v>
                </c:pt>
                <c:pt idx="595">
                  <c:v>1797.3527200000001</c:v>
                </c:pt>
                <c:pt idx="596">
                  <c:v>1799.2812100000001</c:v>
                </c:pt>
                <c:pt idx="597">
                  <c:v>1801.2097000000001</c:v>
                </c:pt>
                <c:pt idx="598">
                  <c:v>1803.1381899999999</c:v>
                </c:pt>
                <c:pt idx="599">
                  <c:v>1805.0666799999999</c:v>
                </c:pt>
                <c:pt idx="600">
                  <c:v>1806.9951699999999</c:v>
                </c:pt>
                <c:pt idx="601">
                  <c:v>1808.9236599999999</c:v>
                </c:pt>
                <c:pt idx="602">
                  <c:v>1810.8521499999999</c:v>
                </c:pt>
                <c:pt idx="603">
                  <c:v>1812.7806399999999</c:v>
                </c:pt>
                <c:pt idx="604">
                  <c:v>1814.70913</c:v>
                </c:pt>
                <c:pt idx="605">
                  <c:v>1816.63762</c:v>
                </c:pt>
                <c:pt idx="606">
                  <c:v>1818.56611</c:v>
                </c:pt>
                <c:pt idx="607">
                  <c:v>1820.4946</c:v>
                </c:pt>
                <c:pt idx="608">
                  <c:v>1822.42309</c:v>
                </c:pt>
                <c:pt idx="609">
                  <c:v>1824.35158</c:v>
                </c:pt>
                <c:pt idx="610">
                  <c:v>1826.28007</c:v>
                </c:pt>
                <c:pt idx="611">
                  <c:v>1828.20856</c:v>
                </c:pt>
                <c:pt idx="612">
                  <c:v>1830.1370509999999</c:v>
                </c:pt>
                <c:pt idx="613">
                  <c:v>1832.0655409999999</c:v>
                </c:pt>
                <c:pt idx="614">
                  <c:v>1833.9940309999999</c:v>
                </c:pt>
                <c:pt idx="615">
                  <c:v>1835.922521</c:v>
                </c:pt>
                <c:pt idx="616">
                  <c:v>1837.851011</c:v>
                </c:pt>
                <c:pt idx="617">
                  <c:v>1839.779501</c:v>
                </c:pt>
                <c:pt idx="618">
                  <c:v>1841.707991</c:v>
                </c:pt>
                <c:pt idx="619">
                  <c:v>1843.636481</c:v>
                </c:pt>
                <c:pt idx="620">
                  <c:v>1845.564971</c:v>
                </c:pt>
                <c:pt idx="621">
                  <c:v>1847.493461</c:v>
                </c:pt>
                <c:pt idx="622">
                  <c:v>1849.421951</c:v>
                </c:pt>
                <c:pt idx="623">
                  <c:v>1851.350441</c:v>
                </c:pt>
                <c:pt idx="624">
                  <c:v>1853.2789310000001</c:v>
                </c:pt>
                <c:pt idx="625">
                  <c:v>1855.2074210000001</c:v>
                </c:pt>
                <c:pt idx="626">
                  <c:v>1857.1359110000001</c:v>
                </c:pt>
                <c:pt idx="627">
                  <c:v>1859.0644010000001</c:v>
                </c:pt>
                <c:pt idx="628">
                  <c:v>1860.9928910000001</c:v>
                </c:pt>
                <c:pt idx="629">
                  <c:v>1862.9213810000001</c:v>
                </c:pt>
                <c:pt idx="630">
                  <c:v>1864.8498709999999</c:v>
                </c:pt>
                <c:pt idx="631">
                  <c:v>1866.7783609999999</c:v>
                </c:pt>
                <c:pt idx="632">
                  <c:v>1868.7068509999999</c:v>
                </c:pt>
                <c:pt idx="633">
                  <c:v>1870.6353409999999</c:v>
                </c:pt>
                <c:pt idx="634">
                  <c:v>1872.5638309999999</c:v>
                </c:pt>
                <c:pt idx="635">
                  <c:v>1874.4923209999999</c:v>
                </c:pt>
                <c:pt idx="636">
                  <c:v>1876.4208120000001</c:v>
                </c:pt>
                <c:pt idx="637">
                  <c:v>1878.3493020000001</c:v>
                </c:pt>
                <c:pt idx="638">
                  <c:v>1880.2777920000001</c:v>
                </c:pt>
                <c:pt idx="639">
                  <c:v>1882.2062820000001</c:v>
                </c:pt>
                <c:pt idx="640">
                  <c:v>1884.1347720000001</c:v>
                </c:pt>
                <c:pt idx="641">
                  <c:v>1886.0632619999999</c:v>
                </c:pt>
                <c:pt idx="642">
                  <c:v>1887.9917519999999</c:v>
                </c:pt>
                <c:pt idx="643">
                  <c:v>1889.9202419999999</c:v>
                </c:pt>
                <c:pt idx="644">
                  <c:v>1891.8487319999999</c:v>
                </c:pt>
                <c:pt idx="645">
                  <c:v>1893.7772219999999</c:v>
                </c:pt>
                <c:pt idx="646">
                  <c:v>1895.7057119999999</c:v>
                </c:pt>
                <c:pt idx="647">
                  <c:v>1897.634202</c:v>
                </c:pt>
                <c:pt idx="648">
                  <c:v>1899.562692</c:v>
                </c:pt>
                <c:pt idx="649">
                  <c:v>1901.491182</c:v>
                </c:pt>
                <c:pt idx="650">
                  <c:v>1903.419672</c:v>
                </c:pt>
                <c:pt idx="651">
                  <c:v>1905.348162</c:v>
                </c:pt>
                <c:pt idx="652">
                  <c:v>1907.276652</c:v>
                </c:pt>
                <c:pt idx="653">
                  <c:v>1909.205142</c:v>
                </c:pt>
                <c:pt idx="654">
                  <c:v>1911.133632</c:v>
                </c:pt>
                <c:pt idx="655">
                  <c:v>1913.062122</c:v>
                </c:pt>
                <c:pt idx="656">
                  <c:v>1914.9906120000001</c:v>
                </c:pt>
                <c:pt idx="657">
                  <c:v>1916.9191020000001</c:v>
                </c:pt>
                <c:pt idx="658">
                  <c:v>1918.8475920000001</c:v>
                </c:pt>
                <c:pt idx="659">
                  <c:v>1920.776083</c:v>
                </c:pt>
                <c:pt idx="660">
                  <c:v>1922.704573</c:v>
                </c:pt>
                <c:pt idx="661">
                  <c:v>1924.633063</c:v>
                </c:pt>
                <c:pt idx="662">
                  <c:v>1926.561553</c:v>
                </c:pt>
                <c:pt idx="663">
                  <c:v>1928.490043</c:v>
                </c:pt>
                <c:pt idx="664">
                  <c:v>1930.418533</c:v>
                </c:pt>
                <c:pt idx="665">
                  <c:v>1932.347023</c:v>
                </c:pt>
                <c:pt idx="666">
                  <c:v>1934.275513</c:v>
                </c:pt>
                <c:pt idx="667">
                  <c:v>1936.2040030000001</c:v>
                </c:pt>
                <c:pt idx="668">
                  <c:v>1938.1324930000001</c:v>
                </c:pt>
                <c:pt idx="669">
                  <c:v>1940.0609830000001</c:v>
                </c:pt>
                <c:pt idx="670">
                  <c:v>1941.9894730000001</c:v>
                </c:pt>
                <c:pt idx="671">
                  <c:v>1943.9179630000001</c:v>
                </c:pt>
                <c:pt idx="672">
                  <c:v>1945.8464530000001</c:v>
                </c:pt>
                <c:pt idx="673">
                  <c:v>1947.7749429999999</c:v>
                </c:pt>
                <c:pt idx="674">
                  <c:v>1949.7034329999999</c:v>
                </c:pt>
                <c:pt idx="675">
                  <c:v>1951.6319229999999</c:v>
                </c:pt>
                <c:pt idx="676">
                  <c:v>1953.5604129999999</c:v>
                </c:pt>
                <c:pt idx="677">
                  <c:v>1955.4889029999999</c:v>
                </c:pt>
                <c:pt idx="678">
                  <c:v>1957.4173929999999</c:v>
                </c:pt>
                <c:pt idx="679">
                  <c:v>1959.345883</c:v>
                </c:pt>
                <c:pt idx="680">
                  <c:v>1961.274373</c:v>
                </c:pt>
                <c:pt idx="681">
                  <c:v>1963.202863</c:v>
                </c:pt>
                <c:pt idx="682">
                  <c:v>1965.131353</c:v>
                </c:pt>
                <c:pt idx="683">
                  <c:v>1967.0598440000001</c:v>
                </c:pt>
                <c:pt idx="684">
                  <c:v>1968.9883339999999</c:v>
                </c:pt>
                <c:pt idx="685">
                  <c:v>1970.9168239999999</c:v>
                </c:pt>
                <c:pt idx="686">
                  <c:v>1972.8453139999999</c:v>
                </c:pt>
                <c:pt idx="687">
                  <c:v>1974.7738039999999</c:v>
                </c:pt>
                <c:pt idx="688">
                  <c:v>1976.7022939999999</c:v>
                </c:pt>
                <c:pt idx="689">
                  <c:v>1978.6307839999999</c:v>
                </c:pt>
                <c:pt idx="690">
                  <c:v>1980.559274</c:v>
                </c:pt>
                <c:pt idx="691">
                  <c:v>1982.487764</c:v>
                </c:pt>
                <c:pt idx="692">
                  <c:v>1984.416254</c:v>
                </c:pt>
                <c:pt idx="693">
                  <c:v>1986.344744</c:v>
                </c:pt>
                <c:pt idx="694">
                  <c:v>1988.273234</c:v>
                </c:pt>
                <c:pt idx="695">
                  <c:v>1990.201724</c:v>
                </c:pt>
                <c:pt idx="696">
                  <c:v>1992.130214</c:v>
                </c:pt>
                <c:pt idx="697">
                  <c:v>1994.058704</c:v>
                </c:pt>
                <c:pt idx="698">
                  <c:v>1995.987194</c:v>
                </c:pt>
                <c:pt idx="699">
                  <c:v>1997.9156840000001</c:v>
                </c:pt>
                <c:pt idx="700">
                  <c:v>1999.8441740000001</c:v>
                </c:pt>
                <c:pt idx="701">
                  <c:v>2001.7726640000001</c:v>
                </c:pt>
                <c:pt idx="702">
                  <c:v>2003.7011540000001</c:v>
                </c:pt>
                <c:pt idx="703">
                  <c:v>2005.6296440000001</c:v>
                </c:pt>
                <c:pt idx="704">
                  <c:v>2007.5581340000001</c:v>
                </c:pt>
                <c:pt idx="705">
                  <c:v>2009.4866239999999</c:v>
                </c:pt>
                <c:pt idx="706">
                  <c:v>2011.415115</c:v>
                </c:pt>
                <c:pt idx="707">
                  <c:v>2013.343605</c:v>
                </c:pt>
                <c:pt idx="708">
                  <c:v>2015.272095</c:v>
                </c:pt>
                <c:pt idx="709">
                  <c:v>2017.200585</c:v>
                </c:pt>
                <c:pt idx="710">
                  <c:v>2019.1290750000001</c:v>
                </c:pt>
                <c:pt idx="711">
                  <c:v>2021.0575650000001</c:v>
                </c:pt>
                <c:pt idx="712">
                  <c:v>2022.9860550000001</c:v>
                </c:pt>
                <c:pt idx="713">
                  <c:v>2024.9145450000001</c:v>
                </c:pt>
                <c:pt idx="714">
                  <c:v>2026.8430350000001</c:v>
                </c:pt>
                <c:pt idx="715">
                  <c:v>2028.7715250000001</c:v>
                </c:pt>
                <c:pt idx="716">
                  <c:v>2030.7000149999999</c:v>
                </c:pt>
                <c:pt idx="717">
                  <c:v>2032.6285049999999</c:v>
                </c:pt>
                <c:pt idx="718">
                  <c:v>2034.5569949999999</c:v>
                </c:pt>
                <c:pt idx="719">
                  <c:v>2036.4854849999999</c:v>
                </c:pt>
                <c:pt idx="720">
                  <c:v>2038.4139749999999</c:v>
                </c:pt>
                <c:pt idx="721">
                  <c:v>2040.3424649999999</c:v>
                </c:pt>
                <c:pt idx="722">
                  <c:v>2042.270955</c:v>
                </c:pt>
                <c:pt idx="723">
                  <c:v>2044.199445</c:v>
                </c:pt>
                <c:pt idx="724">
                  <c:v>2046.127935</c:v>
                </c:pt>
                <c:pt idx="725">
                  <c:v>2048.0564250000002</c:v>
                </c:pt>
                <c:pt idx="726">
                  <c:v>2049.984915</c:v>
                </c:pt>
                <c:pt idx="727">
                  <c:v>2051.9134049999998</c:v>
                </c:pt>
                <c:pt idx="728">
                  <c:v>2053.841895</c:v>
                </c:pt>
                <c:pt idx="729">
                  <c:v>2055.7703860000001</c:v>
                </c:pt>
                <c:pt idx="730">
                  <c:v>2057.698875999999</c:v>
                </c:pt>
                <c:pt idx="731">
                  <c:v>2059.6273660000002</c:v>
                </c:pt>
                <c:pt idx="732">
                  <c:v>2061.5558559999999</c:v>
                </c:pt>
                <c:pt idx="733">
                  <c:v>2063.4843460000002</c:v>
                </c:pt>
                <c:pt idx="734">
                  <c:v>2065.412836</c:v>
                </c:pt>
                <c:pt idx="735">
                  <c:v>2067.3413260000002</c:v>
                </c:pt>
                <c:pt idx="736">
                  <c:v>2069.269816</c:v>
                </c:pt>
                <c:pt idx="737">
                  <c:v>2071.1983059999998</c:v>
                </c:pt>
                <c:pt idx="738">
                  <c:v>2073.126796</c:v>
                </c:pt>
                <c:pt idx="739">
                  <c:v>2075.0552859999998</c:v>
                </c:pt>
                <c:pt idx="740">
                  <c:v>2076.983776</c:v>
                </c:pt>
                <c:pt idx="741">
                  <c:v>2078.9122659999998</c:v>
                </c:pt>
                <c:pt idx="742">
                  <c:v>2080.8407560000001</c:v>
                </c:pt>
                <c:pt idx="743">
                  <c:v>2082.769245999998</c:v>
                </c:pt>
                <c:pt idx="744">
                  <c:v>2084.6977360000001</c:v>
                </c:pt>
                <c:pt idx="745">
                  <c:v>2086.626225999998</c:v>
                </c:pt>
                <c:pt idx="746">
                  <c:v>2088.5547160000001</c:v>
                </c:pt>
                <c:pt idx="747">
                  <c:v>2090.4832059999999</c:v>
                </c:pt>
                <c:pt idx="748">
                  <c:v>2092.4116960000001</c:v>
                </c:pt>
                <c:pt idx="749">
                  <c:v>2094.3401859999999</c:v>
                </c:pt>
                <c:pt idx="750">
                  <c:v>2096.2686760000001</c:v>
                </c:pt>
                <c:pt idx="751">
                  <c:v>2098.1971659999999</c:v>
                </c:pt>
                <c:pt idx="752">
                  <c:v>2100.1256560000002</c:v>
                </c:pt>
                <c:pt idx="753">
                  <c:v>2102.0541469999998</c:v>
                </c:pt>
                <c:pt idx="754">
                  <c:v>2103.9826370000001</c:v>
                </c:pt>
                <c:pt idx="755">
                  <c:v>2105.9111269999999</c:v>
                </c:pt>
                <c:pt idx="756">
                  <c:v>2107.8396170000001</c:v>
                </c:pt>
                <c:pt idx="757">
                  <c:v>2109.7681069999999</c:v>
                </c:pt>
                <c:pt idx="758">
                  <c:v>2111.6965970000001</c:v>
                </c:pt>
                <c:pt idx="759">
                  <c:v>2113.6250869999999</c:v>
                </c:pt>
                <c:pt idx="760">
                  <c:v>2115.5535770000001</c:v>
                </c:pt>
                <c:pt idx="761">
                  <c:v>2117.4820669999999</c:v>
                </c:pt>
                <c:pt idx="762">
                  <c:v>2119.4105570000002</c:v>
                </c:pt>
                <c:pt idx="763">
                  <c:v>2121.3390469999999</c:v>
                </c:pt>
                <c:pt idx="764">
                  <c:v>2123.2675370000002</c:v>
                </c:pt>
                <c:pt idx="765">
                  <c:v>2125.196027</c:v>
                </c:pt>
                <c:pt idx="766">
                  <c:v>2127.1245170000002</c:v>
                </c:pt>
                <c:pt idx="767">
                  <c:v>2129.053007</c:v>
                </c:pt>
                <c:pt idx="768">
                  <c:v>2130.9814970000002</c:v>
                </c:pt>
                <c:pt idx="769">
                  <c:v>2132.909987</c:v>
                </c:pt>
                <c:pt idx="770">
                  <c:v>2134.8384769999998</c:v>
                </c:pt>
                <c:pt idx="771">
                  <c:v>2136.766967</c:v>
                </c:pt>
                <c:pt idx="772">
                  <c:v>2138.6954569999998</c:v>
                </c:pt>
                <c:pt idx="773">
                  <c:v>2140.623947</c:v>
                </c:pt>
                <c:pt idx="774">
                  <c:v>2142.5524369999998</c:v>
                </c:pt>
                <c:pt idx="775">
                  <c:v>2144.4809270000001</c:v>
                </c:pt>
                <c:pt idx="776">
                  <c:v>2146.4094180000002</c:v>
                </c:pt>
                <c:pt idx="777">
                  <c:v>2148.337908</c:v>
                </c:pt>
                <c:pt idx="778">
                  <c:v>2150.2663980000002</c:v>
                </c:pt>
                <c:pt idx="779">
                  <c:v>2152.194888</c:v>
                </c:pt>
                <c:pt idx="780">
                  <c:v>2154.1233779999998</c:v>
                </c:pt>
                <c:pt idx="781">
                  <c:v>2156.051868</c:v>
                </c:pt>
                <c:pt idx="782">
                  <c:v>2157.9803579999998</c:v>
                </c:pt>
                <c:pt idx="783">
                  <c:v>2159.908848</c:v>
                </c:pt>
                <c:pt idx="784">
                  <c:v>2161.8373379999998</c:v>
                </c:pt>
                <c:pt idx="785">
                  <c:v>2163.7658280000001</c:v>
                </c:pt>
                <c:pt idx="786">
                  <c:v>2165.6943179999998</c:v>
                </c:pt>
                <c:pt idx="787">
                  <c:v>2167.6228080000001</c:v>
                </c:pt>
                <c:pt idx="788">
                  <c:v>2169.5512979999999</c:v>
                </c:pt>
                <c:pt idx="789">
                  <c:v>2171.4797880000001</c:v>
                </c:pt>
                <c:pt idx="790">
                  <c:v>2173.4082779999999</c:v>
                </c:pt>
                <c:pt idx="791">
                  <c:v>2175.3367680000001</c:v>
                </c:pt>
                <c:pt idx="792">
                  <c:v>2177.2652579999999</c:v>
                </c:pt>
                <c:pt idx="793">
                  <c:v>2179.1937480000001</c:v>
                </c:pt>
                <c:pt idx="794">
                  <c:v>2181.1222379999999</c:v>
                </c:pt>
                <c:pt idx="795">
                  <c:v>2183.0507280000002</c:v>
                </c:pt>
                <c:pt idx="796">
                  <c:v>2184.9792179999999</c:v>
                </c:pt>
                <c:pt idx="797">
                  <c:v>2186.9077080000002</c:v>
                </c:pt>
                <c:pt idx="798">
                  <c:v>2188.836198</c:v>
                </c:pt>
                <c:pt idx="799">
                  <c:v>2190.7646879999952</c:v>
                </c:pt>
                <c:pt idx="800">
                  <c:v>2192.6931789999999</c:v>
                </c:pt>
                <c:pt idx="801">
                  <c:v>2194.6216690000001</c:v>
                </c:pt>
                <c:pt idx="802">
                  <c:v>2196.5501589999999</c:v>
                </c:pt>
                <c:pt idx="803">
                  <c:v>2198.4786490000001</c:v>
                </c:pt>
                <c:pt idx="804">
                  <c:v>2200.4071389999999</c:v>
                </c:pt>
                <c:pt idx="805">
                  <c:v>2202.3356290000002</c:v>
                </c:pt>
                <c:pt idx="806">
                  <c:v>2204.2641189999999</c:v>
                </c:pt>
                <c:pt idx="807">
                  <c:v>2206.1926090000002</c:v>
                </c:pt>
                <c:pt idx="808">
                  <c:v>2208.121099</c:v>
                </c:pt>
                <c:pt idx="809">
                  <c:v>2210.0495890000002</c:v>
                </c:pt>
                <c:pt idx="810">
                  <c:v>2211.978079</c:v>
                </c:pt>
                <c:pt idx="811">
                  <c:v>2213.9065690000002</c:v>
                </c:pt>
                <c:pt idx="812">
                  <c:v>2215.835059</c:v>
                </c:pt>
                <c:pt idx="813">
                  <c:v>2217.7635489999998</c:v>
                </c:pt>
                <c:pt idx="814">
                  <c:v>2219.692039</c:v>
                </c:pt>
                <c:pt idx="815">
                  <c:v>2221.6205289999998</c:v>
                </c:pt>
                <c:pt idx="816">
                  <c:v>2223.549019</c:v>
                </c:pt>
                <c:pt idx="817">
                  <c:v>2225.4775089999998</c:v>
                </c:pt>
                <c:pt idx="818">
                  <c:v>2227.4059990000001</c:v>
                </c:pt>
                <c:pt idx="819">
                  <c:v>2229.3344889999998</c:v>
                </c:pt>
                <c:pt idx="820">
                  <c:v>2231.2629790000001</c:v>
                </c:pt>
                <c:pt idx="821">
                  <c:v>2233.1914689999999</c:v>
                </c:pt>
                <c:pt idx="822">
                  <c:v>2235.1199590000001</c:v>
                </c:pt>
                <c:pt idx="823">
                  <c:v>2237.048449999998</c:v>
                </c:pt>
                <c:pt idx="824">
                  <c:v>2238.97694</c:v>
                </c:pt>
                <c:pt idx="825">
                  <c:v>2240.9054299999998</c:v>
                </c:pt>
                <c:pt idx="826">
                  <c:v>2242.83392</c:v>
                </c:pt>
                <c:pt idx="827">
                  <c:v>2244.762409999998</c:v>
                </c:pt>
                <c:pt idx="828">
                  <c:v>2246.6909000000001</c:v>
                </c:pt>
                <c:pt idx="829">
                  <c:v>2248.6193899999998</c:v>
                </c:pt>
                <c:pt idx="830">
                  <c:v>2250.5478800000001</c:v>
                </c:pt>
                <c:pt idx="831">
                  <c:v>2252.4763699999999</c:v>
                </c:pt>
                <c:pt idx="832">
                  <c:v>2254.4048600000001</c:v>
                </c:pt>
                <c:pt idx="833">
                  <c:v>2256.3333499999999</c:v>
                </c:pt>
                <c:pt idx="834">
                  <c:v>2258.2618400000001</c:v>
                </c:pt>
                <c:pt idx="835">
                  <c:v>2260.1903299999999</c:v>
                </c:pt>
                <c:pt idx="836">
                  <c:v>2262.1188200000001</c:v>
                </c:pt>
                <c:pt idx="837">
                  <c:v>2264.0473099999999</c:v>
                </c:pt>
                <c:pt idx="838">
                  <c:v>2265.9758000000002</c:v>
                </c:pt>
                <c:pt idx="839">
                  <c:v>2267.904289999999</c:v>
                </c:pt>
                <c:pt idx="840">
                  <c:v>2269.8327800000002</c:v>
                </c:pt>
                <c:pt idx="841">
                  <c:v>2271.76127</c:v>
                </c:pt>
                <c:pt idx="842">
                  <c:v>2273.6897600000002</c:v>
                </c:pt>
                <c:pt idx="843">
                  <c:v>2275.61825</c:v>
                </c:pt>
                <c:pt idx="844">
                  <c:v>2277.5467400000002</c:v>
                </c:pt>
                <c:pt idx="845">
                  <c:v>2279.47523</c:v>
                </c:pt>
                <c:pt idx="846">
                  <c:v>2281.4037199999998</c:v>
                </c:pt>
                <c:pt idx="847">
                  <c:v>2283.3322109999999</c:v>
                </c:pt>
                <c:pt idx="848">
                  <c:v>2285.2607010000002</c:v>
                </c:pt>
                <c:pt idx="849">
                  <c:v>2287.1891909999999</c:v>
                </c:pt>
                <c:pt idx="850">
                  <c:v>2289.1176810000002</c:v>
                </c:pt>
                <c:pt idx="851">
                  <c:v>2291.046171</c:v>
                </c:pt>
                <c:pt idx="852">
                  <c:v>2292.9746610000002</c:v>
                </c:pt>
                <c:pt idx="853">
                  <c:v>2294.903151</c:v>
                </c:pt>
                <c:pt idx="854">
                  <c:v>2296.8316410000002</c:v>
                </c:pt>
                <c:pt idx="855">
                  <c:v>2298.760131</c:v>
                </c:pt>
                <c:pt idx="856">
                  <c:v>2300.688620999998</c:v>
                </c:pt>
                <c:pt idx="857">
                  <c:v>2302.617111</c:v>
                </c:pt>
                <c:pt idx="858">
                  <c:v>2304.5456009999998</c:v>
                </c:pt>
                <c:pt idx="859">
                  <c:v>2306.474091</c:v>
                </c:pt>
                <c:pt idx="860">
                  <c:v>2308.4025809999998</c:v>
                </c:pt>
                <c:pt idx="861">
                  <c:v>2310.3310710000001</c:v>
                </c:pt>
                <c:pt idx="862">
                  <c:v>2312.2595609999998</c:v>
                </c:pt>
                <c:pt idx="863">
                  <c:v>2314.1880510000001</c:v>
                </c:pt>
                <c:pt idx="864">
                  <c:v>2316.1165409999999</c:v>
                </c:pt>
                <c:pt idx="865">
                  <c:v>2318.0450310000001</c:v>
                </c:pt>
                <c:pt idx="866">
                  <c:v>2319.9735209999999</c:v>
                </c:pt>
                <c:pt idx="867">
                  <c:v>2321.9020110000001</c:v>
                </c:pt>
                <c:pt idx="868">
                  <c:v>2323.8305009999999</c:v>
                </c:pt>
                <c:pt idx="869">
                  <c:v>2325.7589910000002</c:v>
                </c:pt>
                <c:pt idx="870">
                  <c:v>2327.687481999998</c:v>
                </c:pt>
                <c:pt idx="871">
                  <c:v>2329.6159720000001</c:v>
                </c:pt>
                <c:pt idx="872">
                  <c:v>2331.544461999998</c:v>
                </c:pt>
                <c:pt idx="873">
                  <c:v>2333.4729520000001</c:v>
                </c:pt>
                <c:pt idx="874">
                  <c:v>2335.4014419999999</c:v>
                </c:pt>
                <c:pt idx="875">
                  <c:v>2337.3299320000001</c:v>
                </c:pt>
                <c:pt idx="876">
                  <c:v>2339.258421999999</c:v>
                </c:pt>
                <c:pt idx="877">
                  <c:v>2341.1869120000001</c:v>
                </c:pt>
                <c:pt idx="878">
                  <c:v>2343.1154019999999</c:v>
                </c:pt>
                <c:pt idx="879">
                  <c:v>2345.0438920000001</c:v>
                </c:pt>
                <c:pt idx="880">
                  <c:v>2346.9723819999999</c:v>
                </c:pt>
                <c:pt idx="881">
                  <c:v>2348.9008720000002</c:v>
                </c:pt>
                <c:pt idx="882">
                  <c:v>2350.8293619999999</c:v>
                </c:pt>
                <c:pt idx="883">
                  <c:v>2352.7578520000002</c:v>
                </c:pt>
                <c:pt idx="884">
                  <c:v>2354.686342</c:v>
                </c:pt>
                <c:pt idx="885">
                  <c:v>2356.6148320000002</c:v>
                </c:pt>
                <c:pt idx="886">
                  <c:v>2358.543322</c:v>
                </c:pt>
                <c:pt idx="887">
                  <c:v>2360.4718120000002</c:v>
                </c:pt>
                <c:pt idx="888">
                  <c:v>2362.400302</c:v>
                </c:pt>
                <c:pt idx="889">
                  <c:v>2364.3287919999998</c:v>
                </c:pt>
                <c:pt idx="890">
                  <c:v>2366.257282</c:v>
                </c:pt>
                <c:pt idx="891">
                  <c:v>2368.1857719999998</c:v>
                </c:pt>
                <c:pt idx="892">
                  <c:v>2370.1142620000001</c:v>
                </c:pt>
                <c:pt idx="893">
                  <c:v>2372.0427530000002</c:v>
                </c:pt>
                <c:pt idx="894">
                  <c:v>2373.971243</c:v>
                </c:pt>
                <c:pt idx="895">
                  <c:v>2375.8997330000002</c:v>
                </c:pt>
                <c:pt idx="896">
                  <c:v>2377.828223</c:v>
                </c:pt>
                <c:pt idx="897">
                  <c:v>2379.7567130000002</c:v>
                </c:pt>
                <c:pt idx="898">
                  <c:v>2381.685203</c:v>
                </c:pt>
                <c:pt idx="899">
                  <c:v>2383.6136929999998</c:v>
                </c:pt>
                <c:pt idx="900">
                  <c:v>2385.542183</c:v>
                </c:pt>
                <c:pt idx="901">
                  <c:v>2387.4706729999998</c:v>
                </c:pt>
                <c:pt idx="902">
                  <c:v>2389.399163</c:v>
                </c:pt>
                <c:pt idx="903">
                  <c:v>2391.3276529999998</c:v>
                </c:pt>
                <c:pt idx="904">
                  <c:v>2393.2561430000001</c:v>
                </c:pt>
                <c:pt idx="905">
                  <c:v>2395.1846329999998</c:v>
                </c:pt>
                <c:pt idx="906">
                  <c:v>2397.1131230000001</c:v>
                </c:pt>
                <c:pt idx="907">
                  <c:v>2399.0416129999999</c:v>
                </c:pt>
                <c:pt idx="908">
                  <c:v>2400.9701030000001</c:v>
                </c:pt>
                <c:pt idx="909">
                  <c:v>2402.8985929999999</c:v>
                </c:pt>
                <c:pt idx="910">
                  <c:v>2404.8270830000001</c:v>
                </c:pt>
                <c:pt idx="911">
                  <c:v>2406.7555729999999</c:v>
                </c:pt>
                <c:pt idx="912">
                  <c:v>2408.6840630000002</c:v>
                </c:pt>
                <c:pt idx="913">
                  <c:v>2410.6125529999999</c:v>
                </c:pt>
                <c:pt idx="914">
                  <c:v>2412.5410430000002</c:v>
                </c:pt>
                <c:pt idx="915">
                  <c:v>2414.469533</c:v>
                </c:pt>
                <c:pt idx="916">
                  <c:v>2416.3980230000002</c:v>
                </c:pt>
                <c:pt idx="917">
                  <c:v>2418.3265139999999</c:v>
                </c:pt>
                <c:pt idx="918">
                  <c:v>2420.2550040000001</c:v>
                </c:pt>
                <c:pt idx="919">
                  <c:v>2422.1834939999999</c:v>
                </c:pt>
                <c:pt idx="920">
                  <c:v>2424.1119840000001</c:v>
                </c:pt>
                <c:pt idx="921">
                  <c:v>2426.0404739999999</c:v>
                </c:pt>
                <c:pt idx="922">
                  <c:v>2427.9689640000001</c:v>
                </c:pt>
                <c:pt idx="923">
                  <c:v>2429.8974539999999</c:v>
                </c:pt>
                <c:pt idx="924">
                  <c:v>2431.8259440000002</c:v>
                </c:pt>
                <c:pt idx="925">
                  <c:v>2433.7544339999999</c:v>
                </c:pt>
                <c:pt idx="926">
                  <c:v>2435.6829240000002</c:v>
                </c:pt>
                <c:pt idx="927">
                  <c:v>2437.611414</c:v>
                </c:pt>
                <c:pt idx="928">
                  <c:v>2439.5399040000002</c:v>
                </c:pt>
                <c:pt idx="929">
                  <c:v>2441.468394</c:v>
                </c:pt>
                <c:pt idx="930">
                  <c:v>2443.3968839999998</c:v>
                </c:pt>
                <c:pt idx="931">
                  <c:v>2445.325374</c:v>
                </c:pt>
                <c:pt idx="932">
                  <c:v>2447.2538639999998</c:v>
                </c:pt>
                <c:pt idx="933">
                  <c:v>2449.182354</c:v>
                </c:pt>
                <c:pt idx="934">
                  <c:v>2451.1108439999998</c:v>
                </c:pt>
                <c:pt idx="935">
                  <c:v>2453.0393340000001</c:v>
                </c:pt>
                <c:pt idx="936">
                  <c:v>2454.9678239999998</c:v>
                </c:pt>
                <c:pt idx="937">
                  <c:v>2456.8963140000001</c:v>
                </c:pt>
                <c:pt idx="938">
                  <c:v>2458.8248039999999</c:v>
                </c:pt>
                <c:pt idx="939">
                  <c:v>2460.7532940000001</c:v>
                </c:pt>
                <c:pt idx="940">
                  <c:v>2462.6817850000002</c:v>
                </c:pt>
                <c:pt idx="941">
                  <c:v>2464.610275</c:v>
                </c:pt>
                <c:pt idx="942">
                  <c:v>2466.5387649999998</c:v>
                </c:pt>
                <c:pt idx="943">
                  <c:v>2468.467255</c:v>
                </c:pt>
                <c:pt idx="944">
                  <c:v>2470.3957449999998</c:v>
                </c:pt>
                <c:pt idx="945">
                  <c:v>2472.324235</c:v>
                </c:pt>
                <c:pt idx="946">
                  <c:v>2474.2527249999998</c:v>
                </c:pt>
                <c:pt idx="947">
                  <c:v>2476.1812150000001</c:v>
                </c:pt>
                <c:pt idx="948">
                  <c:v>2478.1097049999998</c:v>
                </c:pt>
                <c:pt idx="949">
                  <c:v>2480.0381950000001</c:v>
                </c:pt>
                <c:pt idx="950">
                  <c:v>2481.966684999999</c:v>
                </c:pt>
                <c:pt idx="951">
                  <c:v>2483.8951750000001</c:v>
                </c:pt>
                <c:pt idx="952">
                  <c:v>2485.8236649999999</c:v>
                </c:pt>
                <c:pt idx="953">
                  <c:v>2487.7521550000001</c:v>
                </c:pt>
                <c:pt idx="954">
                  <c:v>2489.680644999999</c:v>
                </c:pt>
                <c:pt idx="955">
                  <c:v>2491.6091350000002</c:v>
                </c:pt>
                <c:pt idx="956">
                  <c:v>2493.5376249999999</c:v>
                </c:pt>
                <c:pt idx="957">
                  <c:v>2495.4661150000002</c:v>
                </c:pt>
                <c:pt idx="958">
                  <c:v>2497.394605</c:v>
                </c:pt>
                <c:pt idx="959">
                  <c:v>2499.3230950000002</c:v>
                </c:pt>
                <c:pt idx="960">
                  <c:v>2501.251585</c:v>
                </c:pt>
                <c:pt idx="961">
                  <c:v>2503.1800750000002</c:v>
                </c:pt>
                <c:pt idx="962">
                  <c:v>2505.108565</c:v>
                </c:pt>
                <c:pt idx="963">
                  <c:v>2507.0370549999998</c:v>
                </c:pt>
                <c:pt idx="964">
                  <c:v>2508.9655459999999</c:v>
                </c:pt>
                <c:pt idx="965">
                  <c:v>2510.8940360000001</c:v>
                </c:pt>
                <c:pt idx="966">
                  <c:v>2512.8225259999999</c:v>
                </c:pt>
                <c:pt idx="967">
                  <c:v>2514.7510160000002</c:v>
                </c:pt>
                <c:pt idx="968">
                  <c:v>2516.6795059999999</c:v>
                </c:pt>
                <c:pt idx="969">
                  <c:v>2518.6079960000002</c:v>
                </c:pt>
                <c:pt idx="970">
                  <c:v>2520.536486</c:v>
                </c:pt>
                <c:pt idx="971">
                  <c:v>2522.4649760000002</c:v>
                </c:pt>
                <c:pt idx="972">
                  <c:v>2524.393466</c:v>
                </c:pt>
                <c:pt idx="973">
                  <c:v>2526.3219559999998</c:v>
                </c:pt>
                <c:pt idx="974">
                  <c:v>2528.250446</c:v>
                </c:pt>
                <c:pt idx="975">
                  <c:v>2530.1789359999998</c:v>
                </c:pt>
                <c:pt idx="976">
                  <c:v>2532.107426</c:v>
                </c:pt>
                <c:pt idx="977">
                  <c:v>2534.0359159999998</c:v>
                </c:pt>
                <c:pt idx="978">
                  <c:v>2535.9644060000001</c:v>
                </c:pt>
                <c:pt idx="979">
                  <c:v>2537.8928959999998</c:v>
                </c:pt>
                <c:pt idx="980">
                  <c:v>2539.8213860000001</c:v>
                </c:pt>
                <c:pt idx="981">
                  <c:v>2541.749875999998</c:v>
                </c:pt>
                <c:pt idx="982">
                  <c:v>2543.6783660000001</c:v>
                </c:pt>
                <c:pt idx="983">
                  <c:v>2545.606855999999</c:v>
                </c:pt>
                <c:pt idx="984">
                  <c:v>2547.5353460000001</c:v>
                </c:pt>
                <c:pt idx="985">
                  <c:v>2549.4638359999999</c:v>
                </c:pt>
                <c:pt idx="986">
                  <c:v>2551.3923260000001</c:v>
                </c:pt>
                <c:pt idx="987">
                  <c:v>2553.3208169999998</c:v>
                </c:pt>
                <c:pt idx="988">
                  <c:v>2555.249307</c:v>
                </c:pt>
                <c:pt idx="989">
                  <c:v>2557.1777969999998</c:v>
                </c:pt>
                <c:pt idx="990">
                  <c:v>2559.1062870000001</c:v>
                </c:pt>
                <c:pt idx="991">
                  <c:v>2561.0347769999998</c:v>
                </c:pt>
                <c:pt idx="992">
                  <c:v>2562.9632670000001</c:v>
                </c:pt>
                <c:pt idx="993">
                  <c:v>2564.8917569999999</c:v>
                </c:pt>
                <c:pt idx="994">
                  <c:v>2566.8202470000001</c:v>
                </c:pt>
                <c:pt idx="995">
                  <c:v>2568.7487369999999</c:v>
                </c:pt>
                <c:pt idx="996">
                  <c:v>2570.6772270000001</c:v>
                </c:pt>
                <c:pt idx="997">
                  <c:v>2572.6057169999999</c:v>
                </c:pt>
                <c:pt idx="998">
                  <c:v>2574.5342070000002</c:v>
                </c:pt>
                <c:pt idx="999">
                  <c:v>2576.4626969999999</c:v>
                </c:pt>
                <c:pt idx="1000">
                  <c:v>2578.3911870000002</c:v>
                </c:pt>
                <c:pt idx="1001">
                  <c:v>2580.319677</c:v>
                </c:pt>
                <c:pt idx="1002">
                  <c:v>2582.2481670000002</c:v>
                </c:pt>
                <c:pt idx="1003">
                  <c:v>2584.176657</c:v>
                </c:pt>
                <c:pt idx="1004">
                  <c:v>2586.1051470000002</c:v>
                </c:pt>
                <c:pt idx="1005">
                  <c:v>2588.033637</c:v>
                </c:pt>
                <c:pt idx="1006">
                  <c:v>2589.9621269999998</c:v>
                </c:pt>
                <c:pt idx="1007">
                  <c:v>2591.890617</c:v>
                </c:pt>
                <c:pt idx="1008">
                  <c:v>2593.8191069999998</c:v>
                </c:pt>
                <c:pt idx="1009">
                  <c:v>2595.747597</c:v>
                </c:pt>
                <c:pt idx="1010">
                  <c:v>2597.6760869999998</c:v>
                </c:pt>
                <c:pt idx="1011">
                  <c:v>2599.6045779999999</c:v>
                </c:pt>
                <c:pt idx="1012">
                  <c:v>2601.5330680000002</c:v>
                </c:pt>
                <c:pt idx="1013">
                  <c:v>2603.461558</c:v>
                </c:pt>
                <c:pt idx="1014">
                  <c:v>2605.3900480000002</c:v>
                </c:pt>
                <c:pt idx="1015">
                  <c:v>2607.318538</c:v>
                </c:pt>
                <c:pt idx="1016">
                  <c:v>2609.2470279999998</c:v>
                </c:pt>
                <c:pt idx="1017">
                  <c:v>2611.175518</c:v>
                </c:pt>
                <c:pt idx="1018">
                  <c:v>2613.1040079999998</c:v>
                </c:pt>
                <c:pt idx="1019">
                  <c:v>2615.032498</c:v>
                </c:pt>
                <c:pt idx="1020">
                  <c:v>2616.9609879999998</c:v>
                </c:pt>
                <c:pt idx="1021">
                  <c:v>2618.8894780000001</c:v>
                </c:pt>
                <c:pt idx="1022">
                  <c:v>2620.8179679999998</c:v>
                </c:pt>
                <c:pt idx="1023">
                  <c:v>2622.7464580000001</c:v>
                </c:pt>
                <c:pt idx="1024">
                  <c:v>2624.6749479999999</c:v>
                </c:pt>
                <c:pt idx="1025">
                  <c:v>2626.6034380000001</c:v>
                </c:pt>
                <c:pt idx="1026">
                  <c:v>2628.5319279999999</c:v>
                </c:pt>
                <c:pt idx="1027">
                  <c:v>2630.4604180000001</c:v>
                </c:pt>
                <c:pt idx="1028">
                  <c:v>2632.3889079999999</c:v>
                </c:pt>
                <c:pt idx="1029">
                  <c:v>2634.3173980000001</c:v>
                </c:pt>
                <c:pt idx="1030">
                  <c:v>2636.245887999999</c:v>
                </c:pt>
                <c:pt idx="1031">
                  <c:v>2638.1743780000002</c:v>
                </c:pt>
                <c:pt idx="1032">
                  <c:v>2640.102867999999</c:v>
                </c:pt>
                <c:pt idx="1033">
                  <c:v>2642.0313580000002</c:v>
                </c:pt>
                <c:pt idx="1034">
                  <c:v>2643.9598489999998</c:v>
                </c:pt>
                <c:pt idx="1035">
                  <c:v>2645.8883390000001</c:v>
                </c:pt>
                <c:pt idx="1036">
                  <c:v>2647.8168289999999</c:v>
                </c:pt>
                <c:pt idx="1037">
                  <c:v>2649.7453190000001</c:v>
                </c:pt>
                <c:pt idx="1038">
                  <c:v>2651.6738089999999</c:v>
                </c:pt>
                <c:pt idx="1039">
                  <c:v>2653.6022990000001</c:v>
                </c:pt>
                <c:pt idx="1040">
                  <c:v>2655.5307889999999</c:v>
                </c:pt>
                <c:pt idx="1041">
                  <c:v>2657.4592790000002</c:v>
                </c:pt>
                <c:pt idx="1042">
                  <c:v>2659.3877689999999</c:v>
                </c:pt>
                <c:pt idx="1043">
                  <c:v>2661.3162590000002</c:v>
                </c:pt>
                <c:pt idx="1044">
                  <c:v>2663.244749</c:v>
                </c:pt>
                <c:pt idx="1045">
                  <c:v>2665.1732390000002</c:v>
                </c:pt>
                <c:pt idx="1046">
                  <c:v>2667.101729</c:v>
                </c:pt>
                <c:pt idx="1047">
                  <c:v>2669.0302190000002</c:v>
                </c:pt>
                <c:pt idx="1048">
                  <c:v>2670.958709</c:v>
                </c:pt>
                <c:pt idx="1049">
                  <c:v>2672.8871989999998</c:v>
                </c:pt>
                <c:pt idx="1050">
                  <c:v>2674.815689</c:v>
                </c:pt>
                <c:pt idx="1051">
                  <c:v>2676.7441789999998</c:v>
                </c:pt>
                <c:pt idx="1052">
                  <c:v>2678.672669</c:v>
                </c:pt>
                <c:pt idx="1053">
                  <c:v>2680.6011589999998</c:v>
                </c:pt>
                <c:pt idx="1054">
                  <c:v>2682.5296490000001</c:v>
                </c:pt>
                <c:pt idx="1055">
                  <c:v>2684.4581389999998</c:v>
                </c:pt>
                <c:pt idx="1056">
                  <c:v>2686.3866290000001</c:v>
                </c:pt>
                <c:pt idx="1057">
                  <c:v>2688.3151200000002</c:v>
                </c:pt>
                <c:pt idx="1058">
                  <c:v>2690.24361</c:v>
                </c:pt>
                <c:pt idx="1059">
                  <c:v>2692.1720999999998</c:v>
                </c:pt>
                <c:pt idx="1060">
                  <c:v>2694.10059</c:v>
                </c:pt>
                <c:pt idx="1061">
                  <c:v>2696.0290799999998</c:v>
                </c:pt>
                <c:pt idx="1062">
                  <c:v>2697.95757</c:v>
                </c:pt>
                <c:pt idx="1063">
                  <c:v>2699.8860599999998</c:v>
                </c:pt>
                <c:pt idx="1064">
                  <c:v>2701.8145500000001</c:v>
                </c:pt>
                <c:pt idx="1065">
                  <c:v>2703.7430399999998</c:v>
                </c:pt>
                <c:pt idx="1066">
                  <c:v>2705.6715300000001</c:v>
                </c:pt>
                <c:pt idx="1067">
                  <c:v>2707.6000199999999</c:v>
                </c:pt>
                <c:pt idx="1068">
                  <c:v>2709.5285100000001</c:v>
                </c:pt>
                <c:pt idx="1069">
                  <c:v>2711.4569999999999</c:v>
                </c:pt>
                <c:pt idx="1070">
                  <c:v>2713.3854900000001</c:v>
                </c:pt>
                <c:pt idx="1071">
                  <c:v>2715.3139799999999</c:v>
                </c:pt>
                <c:pt idx="1072">
                  <c:v>2717.2424700000001</c:v>
                </c:pt>
                <c:pt idx="1073">
                  <c:v>2719.1709599999999</c:v>
                </c:pt>
                <c:pt idx="1074">
                  <c:v>2721.0994500000002</c:v>
                </c:pt>
                <c:pt idx="1075">
                  <c:v>2723.0279399999999</c:v>
                </c:pt>
                <c:pt idx="1076">
                  <c:v>2724.9564300000002</c:v>
                </c:pt>
                <c:pt idx="1077">
                  <c:v>2726.88492</c:v>
                </c:pt>
                <c:pt idx="1078">
                  <c:v>2728.8134100000002</c:v>
                </c:pt>
                <c:pt idx="1079">
                  <c:v>2730.7419</c:v>
                </c:pt>
                <c:pt idx="1080">
                  <c:v>2732.6703900000002</c:v>
                </c:pt>
                <c:pt idx="1081">
                  <c:v>2734.598880999999</c:v>
                </c:pt>
                <c:pt idx="1082">
                  <c:v>2736.5273710000001</c:v>
                </c:pt>
                <c:pt idx="1083">
                  <c:v>2738.4558609999999</c:v>
                </c:pt>
                <c:pt idx="1084">
                  <c:v>2740.3843510000002</c:v>
                </c:pt>
                <c:pt idx="1085">
                  <c:v>2742.3128409999999</c:v>
                </c:pt>
                <c:pt idx="1086">
                  <c:v>2744.2413310000002</c:v>
                </c:pt>
                <c:pt idx="1087">
                  <c:v>2746.169821</c:v>
                </c:pt>
                <c:pt idx="1088">
                  <c:v>2748.0983110000002</c:v>
                </c:pt>
                <c:pt idx="1089">
                  <c:v>2750.026801</c:v>
                </c:pt>
                <c:pt idx="1090">
                  <c:v>2751.9552910000002</c:v>
                </c:pt>
                <c:pt idx="1091">
                  <c:v>2753.883781</c:v>
                </c:pt>
                <c:pt idx="1092">
                  <c:v>2755.8122709999998</c:v>
                </c:pt>
                <c:pt idx="1093">
                  <c:v>2757.740761</c:v>
                </c:pt>
                <c:pt idx="1094">
                  <c:v>2759.6692509999998</c:v>
                </c:pt>
                <c:pt idx="1095">
                  <c:v>2761.597741</c:v>
                </c:pt>
                <c:pt idx="1096">
                  <c:v>2763.5262309999998</c:v>
                </c:pt>
                <c:pt idx="1097">
                  <c:v>2765.4547210000001</c:v>
                </c:pt>
                <c:pt idx="1098">
                  <c:v>2767.3832109999998</c:v>
                </c:pt>
                <c:pt idx="1099">
                  <c:v>2769.3117010000001</c:v>
                </c:pt>
                <c:pt idx="1100">
                  <c:v>2771.2401909999999</c:v>
                </c:pt>
                <c:pt idx="1101">
                  <c:v>2773.1686809999951</c:v>
                </c:pt>
                <c:pt idx="1102">
                  <c:v>2775.0971709999999</c:v>
                </c:pt>
                <c:pt idx="1103">
                  <c:v>2777.0256610000001</c:v>
                </c:pt>
                <c:pt idx="1104">
                  <c:v>2778.9541519999998</c:v>
                </c:pt>
                <c:pt idx="1105">
                  <c:v>2780.882642</c:v>
                </c:pt>
                <c:pt idx="1106">
                  <c:v>2782.8111319999998</c:v>
                </c:pt>
                <c:pt idx="1107">
                  <c:v>2784.7396220000001</c:v>
                </c:pt>
                <c:pt idx="1108">
                  <c:v>2786.6681119999998</c:v>
                </c:pt>
                <c:pt idx="1109">
                  <c:v>2788.5966020000001</c:v>
                </c:pt>
                <c:pt idx="1110">
                  <c:v>2790.5250919999999</c:v>
                </c:pt>
                <c:pt idx="1111">
                  <c:v>2792.4535820000001</c:v>
                </c:pt>
                <c:pt idx="1112">
                  <c:v>2794.3820719999999</c:v>
                </c:pt>
                <c:pt idx="1113">
                  <c:v>2796.3105620000001</c:v>
                </c:pt>
                <c:pt idx="1114">
                  <c:v>2798.2390519999999</c:v>
                </c:pt>
                <c:pt idx="1115">
                  <c:v>2800.1675420000001</c:v>
                </c:pt>
                <c:pt idx="1116">
                  <c:v>2802.0960319999999</c:v>
                </c:pt>
                <c:pt idx="1117">
                  <c:v>2804.0245220000002</c:v>
                </c:pt>
                <c:pt idx="1118">
                  <c:v>2805.9530119999999</c:v>
                </c:pt>
                <c:pt idx="1119">
                  <c:v>2807.8815020000002</c:v>
                </c:pt>
                <c:pt idx="1120">
                  <c:v>2809.809992</c:v>
                </c:pt>
                <c:pt idx="1121">
                  <c:v>2811.7384820000002</c:v>
                </c:pt>
                <c:pt idx="1122">
                  <c:v>2813.666972</c:v>
                </c:pt>
                <c:pt idx="1123">
                  <c:v>2815.5954620000002</c:v>
                </c:pt>
                <c:pt idx="1124">
                  <c:v>2817.523952</c:v>
                </c:pt>
                <c:pt idx="1125">
                  <c:v>2819.4524419999998</c:v>
                </c:pt>
                <c:pt idx="1126">
                  <c:v>2821.380932</c:v>
                </c:pt>
                <c:pt idx="1127">
                  <c:v>2823.3094219999998</c:v>
                </c:pt>
                <c:pt idx="1128">
                  <c:v>2825.2379129999999</c:v>
                </c:pt>
                <c:pt idx="1129">
                  <c:v>2827.1664030000002</c:v>
                </c:pt>
                <c:pt idx="1130">
                  <c:v>2829.094893</c:v>
                </c:pt>
                <c:pt idx="1131">
                  <c:v>2831.0233830000002</c:v>
                </c:pt>
                <c:pt idx="1132">
                  <c:v>2832.951873</c:v>
                </c:pt>
                <c:pt idx="1133">
                  <c:v>2834.8803630000002</c:v>
                </c:pt>
                <c:pt idx="1134">
                  <c:v>2836.808853</c:v>
                </c:pt>
                <c:pt idx="1135">
                  <c:v>2838.7373429999998</c:v>
                </c:pt>
                <c:pt idx="1136">
                  <c:v>2840.665833</c:v>
                </c:pt>
                <c:pt idx="1137">
                  <c:v>2842.5943229999998</c:v>
                </c:pt>
                <c:pt idx="1138">
                  <c:v>2844.522813</c:v>
                </c:pt>
                <c:pt idx="1139">
                  <c:v>2846.4513029999998</c:v>
                </c:pt>
                <c:pt idx="1140">
                  <c:v>2848.3797930000001</c:v>
                </c:pt>
                <c:pt idx="1141">
                  <c:v>2850.3082829999998</c:v>
                </c:pt>
                <c:pt idx="1142">
                  <c:v>2852.2367730000001</c:v>
                </c:pt>
                <c:pt idx="1143">
                  <c:v>2854.1652629999999</c:v>
                </c:pt>
                <c:pt idx="1144">
                  <c:v>2856.0937530000001</c:v>
                </c:pt>
                <c:pt idx="1145">
                  <c:v>2858.0222429999999</c:v>
                </c:pt>
                <c:pt idx="1146">
                  <c:v>2859.9507330000001</c:v>
                </c:pt>
                <c:pt idx="1147">
                  <c:v>2861.8792229999999</c:v>
                </c:pt>
                <c:pt idx="1148">
                  <c:v>2863.8077130000001</c:v>
                </c:pt>
                <c:pt idx="1149">
                  <c:v>2865.7362029999999</c:v>
                </c:pt>
                <c:pt idx="1150">
                  <c:v>2867.6646930000002</c:v>
                </c:pt>
                <c:pt idx="1151">
                  <c:v>2869.5931839999998</c:v>
                </c:pt>
                <c:pt idx="1152">
                  <c:v>2871.5216740000001</c:v>
                </c:pt>
                <c:pt idx="1153">
                  <c:v>2873.4501639999999</c:v>
                </c:pt>
                <c:pt idx="1154">
                  <c:v>2875.3786540000001</c:v>
                </c:pt>
                <c:pt idx="1155">
                  <c:v>2877.3071439999999</c:v>
                </c:pt>
                <c:pt idx="1156">
                  <c:v>2879.2356340000001</c:v>
                </c:pt>
                <c:pt idx="1157">
                  <c:v>2881.1641239999999</c:v>
                </c:pt>
                <c:pt idx="1158">
                  <c:v>2883.0926140000001</c:v>
                </c:pt>
                <c:pt idx="1159">
                  <c:v>2885.0211039999999</c:v>
                </c:pt>
                <c:pt idx="1160">
                  <c:v>2886.9495940000002</c:v>
                </c:pt>
                <c:pt idx="1161">
                  <c:v>2888.8780839999999</c:v>
                </c:pt>
                <c:pt idx="1162">
                  <c:v>2890.8065740000002</c:v>
                </c:pt>
                <c:pt idx="1163">
                  <c:v>2892.735064</c:v>
                </c:pt>
                <c:pt idx="1164">
                  <c:v>2894.6635540000002</c:v>
                </c:pt>
                <c:pt idx="1165">
                  <c:v>2896.592044</c:v>
                </c:pt>
                <c:pt idx="1166">
                  <c:v>2898.5205340000002</c:v>
                </c:pt>
                <c:pt idx="1167">
                  <c:v>2900.449024</c:v>
                </c:pt>
                <c:pt idx="1168">
                  <c:v>2902.3775139999998</c:v>
                </c:pt>
                <c:pt idx="1169">
                  <c:v>2904.306004</c:v>
                </c:pt>
                <c:pt idx="1170">
                  <c:v>2906.2344939999998</c:v>
                </c:pt>
                <c:pt idx="1171">
                  <c:v>2908.1629840000001</c:v>
                </c:pt>
                <c:pt idx="1172">
                  <c:v>2910.0914739999998</c:v>
                </c:pt>
                <c:pt idx="1173">
                  <c:v>2912.0199640000001</c:v>
                </c:pt>
                <c:pt idx="1174">
                  <c:v>2913.9484539999999</c:v>
                </c:pt>
                <c:pt idx="1175">
                  <c:v>2915.876945</c:v>
                </c:pt>
                <c:pt idx="1176">
                  <c:v>2917.8054350000002</c:v>
                </c:pt>
                <c:pt idx="1177">
                  <c:v>2919.733925</c:v>
                </c:pt>
                <c:pt idx="1178">
                  <c:v>2921.6624149999998</c:v>
                </c:pt>
                <c:pt idx="1179">
                  <c:v>2923.590905</c:v>
                </c:pt>
                <c:pt idx="1180">
                  <c:v>2925.5193949999998</c:v>
                </c:pt>
                <c:pt idx="1181">
                  <c:v>2927.447885</c:v>
                </c:pt>
                <c:pt idx="1182">
                  <c:v>2929.3763749999998</c:v>
                </c:pt>
                <c:pt idx="1183">
                  <c:v>2931.3048650000001</c:v>
                </c:pt>
                <c:pt idx="1184">
                  <c:v>2933.2333549999998</c:v>
                </c:pt>
                <c:pt idx="1185">
                  <c:v>2935.1618450000001</c:v>
                </c:pt>
                <c:pt idx="1186">
                  <c:v>2937.0903349999999</c:v>
                </c:pt>
                <c:pt idx="1187">
                  <c:v>2939.0188250000001</c:v>
                </c:pt>
                <c:pt idx="1188">
                  <c:v>2940.9473149999999</c:v>
                </c:pt>
                <c:pt idx="1189">
                  <c:v>2942.8758050000001</c:v>
                </c:pt>
                <c:pt idx="1190">
                  <c:v>2944.8042949999999</c:v>
                </c:pt>
                <c:pt idx="1191">
                  <c:v>2946.7327850000001</c:v>
                </c:pt>
                <c:pt idx="1192">
                  <c:v>2948.6612749999999</c:v>
                </c:pt>
                <c:pt idx="1193">
                  <c:v>2950.5897650000002</c:v>
                </c:pt>
                <c:pt idx="1194">
                  <c:v>2952.518255</c:v>
                </c:pt>
                <c:pt idx="1195">
                  <c:v>2954.4467450000002</c:v>
                </c:pt>
                <c:pt idx="1196">
                  <c:v>2956.375235</c:v>
                </c:pt>
                <c:pt idx="1197">
                  <c:v>2958.3037250000002</c:v>
                </c:pt>
                <c:pt idx="1198">
                  <c:v>2960.2322159999999</c:v>
                </c:pt>
                <c:pt idx="1199">
                  <c:v>2962.1607060000001</c:v>
                </c:pt>
                <c:pt idx="1200">
                  <c:v>2964.0891959999999</c:v>
                </c:pt>
                <c:pt idx="1201">
                  <c:v>2966.0176860000001</c:v>
                </c:pt>
                <c:pt idx="1202">
                  <c:v>2967.9461759999999</c:v>
                </c:pt>
                <c:pt idx="1203">
                  <c:v>2969.8746660000002</c:v>
                </c:pt>
                <c:pt idx="1204">
                  <c:v>2971.8031559999999</c:v>
                </c:pt>
                <c:pt idx="1205">
                  <c:v>2973.7316460000002</c:v>
                </c:pt>
                <c:pt idx="1206">
                  <c:v>2975.660136</c:v>
                </c:pt>
                <c:pt idx="1207">
                  <c:v>2977.5886260000002</c:v>
                </c:pt>
                <c:pt idx="1208">
                  <c:v>2979.517116</c:v>
                </c:pt>
                <c:pt idx="1209">
                  <c:v>2981.4456060000002</c:v>
                </c:pt>
                <c:pt idx="1210">
                  <c:v>2983.374096</c:v>
                </c:pt>
                <c:pt idx="1211">
                  <c:v>2985.3025859999998</c:v>
                </c:pt>
                <c:pt idx="1212">
                  <c:v>2987.231076</c:v>
                </c:pt>
                <c:pt idx="1213">
                  <c:v>2989.1595659999998</c:v>
                </c:pt>
                <c:pt idx="1214">
                  <c:v>2991.0880560000001</c:v>
                </c:pt>
                <c:pt idx="1215">
                  <c:v>2993.0165459999998</c:v>
                </c:pt>
                <c:pt idx="1216">
                  <c:v>2994.9450360000001</c:v>
                </c:pt>
                <c:pt idx="1217">
                  <c:v>2996.8735259999999</c:v>
                </c:pt>
                <c:pt idx="1218">
                  <c:v>2998.8020160000001</c:v>
                </c:pt>
                <c:pt idx="1219">
                  <c:v>3000.7305059999999</c:v>
                </c:pt>
                <c:pt idx="1220">
                  <c:v>3002.6589960000001</c:v>
                </c:pt>
                <c:pt idx="1221">
                  <c:v>3004.5874869999998</c:v>
                </c:pt>
                <c:pt idx="1222">
                  <c:v>3006.515977</c:v>
                </c:pt>
                <c:pt idx="1223">
                  <c:v>3008.4444669999998</c:v>
                </c:pt>
                <c:pt idx="1224">
                  <c:v>3010.372957</c:v>
                </c:pt>
                <c:pt idx="1225">
                  <c:v>3012.3014469999998</c:v>
                </c:pt>
                <c:pt idx="1226">
                  <c:v>3014.2299370000001</c:v>
                </c:pt>
                <c:pt idx="1227">
                  <c:v>3016.1584269999998</c:v>
                </c:pt>
                <c:pt idx="1228">
                  <c:v>3018.0869170000001</c:v>
                </c:pt>
                <c:pt idx="1229">
                  <c:v>3020.0154069999999</c:v>
                </c:pt>
                <c:pt idx="1230">
                  <c:v>3021.9438970000001</c:v>
                </c:pt>
                <c:pt idx="1231">
                  <c:v>3023.8723869999999</c:v>
                </c:pt>
                <c:pt idx="1232">
                  <c:v>3025.8008770000001</c:v>
                </c:pt>
                <c:pt idx="1233">
                  <c:v>3027.7293669999999</c:v>
                </c:pt>
                <c:pt idx="1234">
                  <c:v>3029.6578570000001</c:v>
                </c:pt>
                <c:pt idx="1235">
                  <c:v>3031.5863469999999</c:v>
                </c:pt>
                <c:pt idx="1236">
                  <c:v>3033.5148370000002</c:v>
                </c:pt>
                <c:pt idx="1237">
                  <c:v>3035.443327</c:v>
                </c:pt>
                <c:pt idx="1238">
                  <c:v>3037.3718170000002</c:v>
                </c:pt>
                <c:pt idx="1239">
                  <c:v>3039.300307</c:v>
                </c:pt>
                <c:pt idx="1240">
                  <c:v>3041.2287970000002</c:v>
                </c:pt>
                <c:pt idx="1241">
                  <c:v>3043.157287</c:v>
                </c:pt>
                <c:pt idx="1242">
                  <c:v>3045.0857769999998</c:v>
                </c:pt>
                <c:pt idx="1243">
                  <c:v>3047.014267</c:v>
                </c:pt>
                <c:pt idx="1244">
                  <c:v>3048.9427569999998</c:v>
                </c:pt>
                <c:pt idx="1245">
                  <c:v>3050.8712479999999</c:v>
                </c:pt>
                <c:pt idx="1246">
                  <c:v>3052.7997380000002</c:v>
                </c:pt>
                <c:pt idx="1247">
                  <c:v>3054.728227999999</c:v>
                </c:pt>
                <c:pt idx="1248">
                  <c:v>3056.6567180000002</c:v>
                </c:pt>
                <c:pt idx="1249">
                  <c:v>3058.585208</c:v>
                </c:pt>
                <c:pt idx="1250">
                  <c:v>3060.5136980000002</c:v>
                </c:pt>
                <c:pt idx="1251">
                  <c:v>3062.442188</c:v>
                </c:pt>
                <c:pt idx="1252">
                  <c:v>3064.3706780000002</c:v>
                </c:pt>
                <c:pt idx="1253">
                  <c:v>3066.299168</c:v>
                </c:pt>
                <c:pt idx="1254">
                  <c:v>3068.2276579999998</c:v>
                </c:pt>
                <c:pt idx="1255">
                  <c:v>3070.156148</c:v>
                </c:pt>
                <c:pt idx="1256">
                  <c:v>3072.0846379999998</c:v>
                </c:pt>
                <c:pt idx="1257">
                  <c:v>3074.0131280000001</c:v>
                </c:pt>
                <c:pt idx="1258">
                  <c:v>3075.9416179999998</c:v>
                </c:pt>
                <c:pt idx="1259">
                  <c:v>3077.8701080000001</c:v>
                </c:pt>
                <c:pt idx="1260">
                  <c:v>3079.7985979999999</c:v>
                </c:pt>
                <c:pt idx="1261">
                  <c:v>3081.7270880000001</c:v>
                </c:pt>
                <c:pt idx="1262">
                  <c:v>3083.6555779999999</c:v>
                </c:pt>
                <c:pt idx="1263">
                  <c:v>3085.5840680000001</c:v>
                </c:pt>
                <c:pt idx="1264">
                  <c:v>3087.5125579999999</c:v>
                </c:pt>
                <c:pt idx="1265">
                  <c:v>3089.4410480000001</c:v>
                </c:pt>
                <c:pt idx="1266">
                  <c:v>3091.3695379999999</c:v>
                </c:pt>
                <c:pt idx="1267">
                  <c:v>3093.2980280000002</c:v>
                </c:pt>
                <c:pt idx="1268">
                  <c:v>3095.2265189999998</c:v>
                </c:pt>
                <c:pt idx="1269">
                  <c:v>3097.1550090000001</c:v>
                </c:pt>
                <c:pt idx="1270">
                  <c:v>3099.0834989999998</c:v>
                </c:pt>
                <c:pt idx="1271">
                  <c:v>3101.0119890000001</c:v>
                </c:pt>
                <c:pt idx="1272">
                  <c:v>3102.9404789999999</c:v>
                </c:pt>
                <c:pt idx="1273">
                  <c:v>3104.8689690000001</c:v>
                </c:pt>
                <c:pt idx="1274">
                  <c:v>3106.7974589999999</c:v>
                </c:pt>
                <c:pt idx="1275">
                  <c:v>3108.7259490000001</c:v>
                </c:pt>
                <c:pt idx="1276">
                  <c:v>3110.6544389999999</c:v>
                </c:pt>
                <c:pt idx="1277">
                  <c:v>3112.5829290000001</c:v>
                </c:pt>
                <c:pt idx="1278">
                  <c:v>3114.5114189999999</c:v>
                </c:pt>
                <c:pt idx="1279">
                  <c:v>3116.4399090000002</c:v>
                </c:pt>
                <c:pt idx="1280">
                  <c:v>3118.368399</c:v>
                </c:pt>
                <c:pt idx="1281">
                  <c:v>3120.2968889999952</c:v>
                </c:pt>
                <c:pt idx="1282">
                  <c:v>3122.225379</c:v>
                </c:pt>
                <c:pt idx="1283">
                  <c:v>3124.1538690000002</c:v>
                </c:pt>
                <c:pt idx="1284">
                  <c:v>3126.082359</c:v>
                </c:pt>
                <c:pt idx="1285">
                  <c:v>3128.0108489999998</c:v>
                </c:pt>
                <c:pt idx="1286">
                  <c:v>3129.939339</c:v>
                </c:pt>
                <c:pt idx="1287">
                  <c:v>3131.8678289999998</c:v>
                </c:pt>
                <c:pt idx="1288">
                  <c:v>3133.796319</c:v>
                </c:pt>
                <c:pt idx="1289">
                  <c:v>3135.724808999998</c:v>
                </c:pt>
                <c:pt idx="1290">
                  <c:v>3137.6532990000001</c:v>
                </c:pt>
                <c:pt idx="1291">
                  <c:v>3139.5817889999998</c:v>
                </c:pt>
                <c:pt idx="1292">
                  <c:v>3141.51028</c:v>
                </c:pt>
                <c:pt idx="1293">
                  <c:v>3143.4387700000002</c:v>
                </c:pt>
                <c:pt idx="1294">
                  <c:v>3145.36726</c:v>
                </c:pt>
                <c:pt idx="1295">
                  <c:v>3147.2957500000002</c:v>
                </c:pt>
                <c:pt idx="1296">
                  <c:v>3149.22424</c:v>
                </c:pt>
                <c:pt idx="1297">
                  <c:v>3151.1527299999998</c:v>
                </c:pt>
                <c:pt idx="1298">
                  <c:v>3153.08122</c:v>
                </c:pt>
                <c:pt idx="1299">
                  <c:v>3155.0097099999998</c:v>
                </c:pt>
                <c:pt idx="1300">
                  <c:v>3156.9382000000001</c:v>
                </c:pt>
                <c:pt idx="1301">
                  <c:v>3158.866689999998</c:v>
                </c:pt>
                <c:pt idx="1302">
                  <c:v>3160.7951800000001</c:v>
                </c:pt>
                <c:pt idx="1303">
                  <c:v>3162.723669999998</c:v>
                </c:pt>
                <c:pt idx="1304">
                  <c:v>3164.6521600000001</c:v>
                </c:pt>
                <c:pt idx="1305">
                  <c:v>3166.580649999999</c:v>
                </c:pt>
                <c:pt idx="1306">
                  <c:v>3168.5091400000001</c:v>
                </c:pt>
                <c:pt idx="1307">
                  <c:v>3170.4376299999999</c:v>
                </c:pt>
                <c:pt idx="1308">
                  <c:v>3172.3661200000001</c:v>
                </c:pt>
                <c:pt idx="1309">
                  <c:v>3174.294609999999</c:v>
                </c:pt>
                <c:pt idx="1310">
                  <c:v>3176.2231000000002</c:v>
                </c:pt>
                <c:pt idx="1311">
                  <c:v>3178.1515899999999</c:v>
                </c:pt>
                <c:pt idx="1312">
                  <c:v>3180.0800800000002</c:v>
                </c:pt>
                <c:pt idx="1313">
                  <c:v>3182.00857</c:v>
                </c:pt>
                <c:pt idx="1314">
                  <c:v>3183.9370600000002</c:v>
                </c:pt>
                <c:pt idx="1315">
                  <c:v>3185.8655509999999</c:v>
                </c:pt>
                <c:pt idx="1316">
                  <c:v>3187.7940410000001</c:v>
                </c:pt>
                <c:pt idx="1317">
                  <c:v>3189.7225309999999</c:v>
                </c:pt>
                <c:pt idx="1318">
                  <c:v>3191.6510210000001</c:v>
                </c:pt>
                <c:pt idx="1319">
                  <c:v>3193.5795109999999</c:v>
                </c:pt>
                <c:pt idx="1320">
                  <c:v>3195.5080010000001</c:v>
                </c:pt>
                <c:pt idx="1321">
                  <c:v>3197.4364909999999</c:v>
                </c:pt>
                <c:pt idx="1322">
                  <c:v>3199.3649810000002</c:v>
                </c:pt>
                <c:pt idx="1323">
                  <c:v>3201.293471</c:v>
                </c:pt>
                <c:pt idx="1324">
                  <c:v>3203.2219610000002</c:v>
                </c:pt>
                <c:pt idx="1325">
                  <c:v>3205.150451</c:v>
                </c:pt>
                <c:pt idx="1326">
                  <c:v>3207.0789410000002</c:v>
                </c:pt>
                <c:pt idx="1327">
                  <c:v>3209.007431</c:v>
                </c:pt>
                <c:pt idx="1328">
                  <c:v>3210.9359209999998</c:v>
                </c:pt>
                <c:pt idx="1329">
                  <c:v>3212.864411</c:v>
                </c:pt>
                <c:pt idx="1330">
                  <c:v>3214.7929009999998</c:v>
                </c:pt>
                <c:pt idx="1331">
                  <c:v>3216.721391</c:v>
                </c:pt>
                <c:pt idx="1332">
                  <c:v>3218.649880999998</c:v>
                </c:pt>
                <c:pt idx="1333">
                  <c:v>3220.5783710000001</c:v>
                </c:pt>
                <c:pt idx="1334">
                  <c:v>3222.506860999998</c:v>
                </c:pt>
                <c:pt idx="1335">
                  <c:v>3224.4353510000001</c:v>
                </c:pt>
                <c:pt idx="1336">
                  <c:v>3226.3638409999999</c:v>
                </c:pt>
                <c:pt idx="1337">
                  <c:v>3228.2923310000001</c:v>
                </c:pt>
                <c:pt idx="1338">
                  <c:v>3230.220820999999</c:v>
                </c:pt>
                <c:pt idx="1339">
                  <c:v>3232.149312</c:v>
                </c:pt>
                <c:pt idx="1340">
                  <c:v>3234.0778019999998</c:v>
                </c:pt>
                <c:pt idx="1341">
                  <c:v>3236.006292</c:v>
                </c:pt>
                <c:pt idx="1342">
                  <c:v>3237.9347819999998</c:v>
                </c:pt>
                <c:pt idx="1343">
                  <c:v>3239.8632720000001</c:v>
                </c:pt>
                <c:pt idx="1344">
                  <c:v>3241.7917619999998</c:v>
                </c:pt>
                <c:pt idx="1345">
                  <c:v>3243.7202520000001</c:v>
                </c:pt>
                <c:pt idx="1346">
                  <c:v>3245.648741999998</c:v>
                </c:pt>
                <c:pt idx="1347">
                  <c:v>3247.5772320000001</c:v>
                </c:pt>
                <c:pt idx="1348">
                  <c:v>3249.5057219999999</c:v>
                </c:pt>
                <c:pt idx="1349">
                  <c:v>3251.4342120000001</c:v>
                </c:pt>
                <c:pt idx="1350">
                  <c:v>3253.3627019999999</c:v>
                </c:pt>
                <c:pt idx="1351">
                  <c:v>3255.2911920000001</c:v>
                </c:pt>
                <c:pt idx="1352">
                  <c:v>3257.219681999999</c:v>
                </c:pt>
                <c:pt idx="1353">
                  <c:v>3259.1481720000002</c:v>
                </c:pt>
                <c:pt idx="1354">
                  <c:v>3261.076661999999</c:v>
                </c:pt>
                <c:pt idx="1355">
                  <c:v>3263.0051520000002</c:v>
                </c:pt>
                <c:pt idx="1356">
                  <c:v>3264.933642</c:v>
                </c:pt>
                <c:pt idx="1357">
                  <c:v>3266.8621320000002</c:v>
                </c:pt>
                <c:pt idx="1358">
                  <c:v>3268.790622</c:v>
                </c:pt>
                <c:pt idx="1359">
                  <c:v>3270.7191120000002</c:v>
                </c:pt>
                <c:pt idx="1360">
                  <c:v>3272.647602</c:v>
                </c:pt>
                <c:pt idx="1361">
                  <c:v>3274.5760919999998</c:v>
                </c:pt>
                <c:pt idx="1362">
                  <c:v>3276.5045829999999</c:v>
                </c:pt>
                <c:pt idx="1363">
                  <c:v>3278.4330730000001</c:v>
                </c:pt>
                <c:pt idx="1364">
                  <c:v>3280.3615629999999</c:v>
                </c:pt>
                <c:pt idx="1365">
                  <c:v>3282.2900530000002</c:v>
                </c:pt>
                <c:pt idx="1366">
                  <c:v>3284.218543</c:v>
                </c:pt>
                <c:pt idx="1367">
                  <c:v>3286.1470330000002</c:v>
                </c:pt>
                <c:pt idx="1368">
                  <c:v>3288.075523</c:v>
                </c:pt>
                <c:pt idx="1369">
                  <c:v>3290.0040130000002</c:v>
                </c:pt>
                <c:pt idx="1370">
                  <c:v>3291.932503</c:v>
                </c:pt>
                <c:pt idx="1371">
                  <c:v>3293.8609929999998</c:v>
                </c:pt>
                <c:pt idx="1372">
                  <c:v>3295.789483</c:v>
                </c:pt>
                <c:pt idx="1373">
                  <c:v>3297.7179729999998</c:v>
                </c:pt>
                <c:pt idx="1374">
                  <c:v>3299.646463</c:v>
                </c:pt>
                <c:pt idx="1375">
                  <c:v>3301.5749529999998</c:v>
                </c:pt>
                <c:pt idx="1376">
                  <c:v>3303.5034430000001</c:v>
                </c:pt>
                <c:pt idx="1377">
                  <c:v>3305.4319329999998</c:v>
                </c:pt>
                <c:pt idx="1378">
                  <c:v>3307.3604230000001</c:v>
                </c:pt>
                <c:pt idx="1379">
                  <c:v>3309.2889129999999</c:v>
                </c:pt>
                <c:pt idx="1380">
                  <c:v>3311.2174030000001</c:v>
                </c:pt>
                <c:pt idx="1381">
                  <c:v>3313.1458929999999</c:v>
                </c:pt>
                <c:pt idx="1382">
                  <c:v>3315.0743830000001</c:v>
                </c:pt>
                <c:pt idx="1383">
                  <c:v>3317.0028729999999</c:v>
                </c:pt>
                <c:pt idx="1384">
                  <c:v>3318.9313630000001</c:v>
                </c:pt>
                <c:pt idx="1385">
                  <c:v>3320.8598539999998</c:v>
                </c:pt>
                <c:pt idx="1386">
                  <c:v>3322.7883440000001</c:v>
                </c:pt>
                <c:pt idx="1387">
                  <c:v>3324.7168339999998</c:v>
                </c:pt>
                <c:pt idx="1388">
                  <c:v>3326.6453240000001</c:v>
                </c:pt>
                <c:pt idx="1389">
                  <c:v>3328.5738139999999</c:v>
                </c:pt>
                <c:pt idx="1390">
                  <c:v>3330.5023040000001</c:v>
                </c:pt>
                <c:pt idx="1391">
                  <c:v>3332.4307939999999</c:v>
                </c:pt>
                <c:pt idx="1392">
                  <c:v>3334.3592840000001</c:v>
                </c:pt>
                <c:pt idx="1393">
                  <c:v>3336.2877739999999</c:v>
                </c:pt>
                <c:pt idx="1394">
                  <c:v>3338.2162640000001</c:v>
                </c:pt>
                <c:pt idx="1395">
                  <c:v>3340.1447539999999</c:v>
                </c:pt>
                <c:pt idx="1396">
                  <c:v>3342.0732440000002</c:v>
                </c:pt>
                <c:pt idx="1397">
                  <c:v>3344.0017339999999</c:v>
                </c:pt>
                <c:pt idx="1398">
                  <c:v>3345.9302240000002</c:v>
                </c:pt>
                <c:pt idx="1399">
                  <c:v>3347.858714</c:v>
                </c:pt>
                <c:pt idx="1400">
                  <c:v>3349.7872040000002</c:v>
                </c:pt>
                <c:pt idx="1401">
                  <c:v>3351.715694</c:v>
                </c:pt>
                <c:pt idx="1402">
                  <c:v>3353.6441840000002</c:v>
                </c:pt>
                <c:pt idx="1403">
                  <c:v>3355.572674</c:v>
                </c:pt>
                <c:pt idx="1404">
                  <c:v>3357.5011639999998</c:v>
                </c:pt>
                <c:pt idx="1405">
                  <c:v>3359.429654</c:v>
                </c:pt>
                <c:pt idx="1406">
                  <c:v>3361.3581439999998</c:v>
                </c:pt>
                <c:pt idx="1407">
                  <c:v>3363.286634</c:v>
                </c:pt>
                <c:pt idx="1408">
                  <c:v>3365.2151239999998</c:v>
                </c:pt>
                <c:pt idx="1409">
                  <c:v>3367.143615</c:v>
                </c:pt>
                <c:pt idx="1410">
                  <c:v>3369.0721050000002</c:v>
                </c:pt>
                <c:pt idx="1411">
                  <c:v>3371.000595</c:v>
                </c:pt>
                <c:pt idx="1412">
                  <c:v>3372.9290850000002</c:v>
                </c:pt>
                <c:pt idx="1413">
                  <c:v>3374.857575</c:v>
                </c:pt>
                <c:pt idx="1414">
                  <c:v>3376.786064999998</c:v>
                </c:pt>
                <c:pt idx="1415">
                  <c:v>3378.714555</c:v>
                </c:pt>
                <c:pt idx="1416">
                  <c:v>3380.6430449999998</c:v>
                </c:pt>
                <c:pt idx="1417">
                  <c:v>3382.571535</c:v>
                </c:pt>
                <c:pt idx="1418">
                  <c:v>3384.5000249999998</c:v>
                </c:pt>
                <c:pt idx="1419">
                  <c:v>3386.4285150000001</c:v>
                </c:pt>
                <c:pt idx="1420">
                  <c:v>3388.3570049999998</c:v>
                </c:pt>
                <c:pt idx="1421">
                  <c:v>3390.2854950000001</c:v>
                </c:pt>
                <c:pt idx="1422">
                  <c:v>3392.2139849999999</c:v>
                </c:pt>
                <c:pt idx="1423">
                  <c:v>3394.1424750000001</c:v>
                </c:pt>
                <c:pt idx="1424">
                  <c:v>3396.0709649999999</c:v>
                </c:pt>
                <c:pt idx="1425">
                  <c:v>3397.9994550000001</c:v>
                </c:pt>
                <c:pt idx="1426">
                  <c:v>3399.9279449999999</c:v>
                </c:pt>
                <c:pt idx="1427">
                  <c:v>3401.8564350000001</c:v>
                </c:pt>
                <c:pt idx="1428">
                  <c:v>3403.784924999999</c:v>
                </c:pt>
                <c:pt idx="1429">
                  <c:v>3405.7134150000002</c:v>
                </c:pt>
                <c:pt idx="1430">
                  <c:v>3407.641905</c:v>
                </c:pt>
                <c:pt idx="1431">
                  <c:v>3409.5703950000002</c:v>
                </c:pt>
                <c:pt idx="1432">
                  <c:v>3411.498885999998</c:v>
                </c:pt>
                <c:pt idx="1433">
                  <c:v>3413.4273760000001</c:v>
                </c:pt>
                <c:pt idx="1434">
                  <c:v>3415.3558659999999</c:v>
                </c:pt>
                <c:pt idx="1435">
                  <c:v>3417.2843560000001</c:v>
                </c:pt>
                <c:pt idx="1436">
                  <c:v>3419.212845999999</c:v>
                </c:pt>
                <c:pt idx="1437">
                  <c:v>3421.1413360000001</c:v>
                </c:pt>
                <c:pt idx="1438">
                  <c:v>3423.069825999999</c:v>
                </c:pt>
                <c:pt idx="1439">
                  <c:v>3424.9983160000002</c:v>
                </c:pt>
                <c:pt idx="1440">
                  <c:v>3426.926805999999</c:v>
                </c:pt>
                <c:pt idx="1441">
                  <c:v>3428.8552960000002</c:v>
                </c:pt>
                <c:pt idx="1442">
                  <c:v>3430.783786</c:v>
                </c:pt>
                <c:pt idx="1443">
                  <c:v>3432.7122760000002</c:v>
                </c:pt>
                <c:pt idx="1444">
                  <c:v>3434.640766</c:v>
                </c:pt>
                <c:pt idx="1445">
                  <c:v>3436.5692560000002</c:v>
                </c:pt>
                <c:pt idx="1446">
                  <c:v>3438.497746</c:v>
                </c:pt>
                <c:pt idx="1447">
                  <c:v>3440.4262359999998</c:v>
                </c:pt>
                <c:pt idx="1448">
                  <c:v>3442.354726</c:v>
                </c:pt>
                <c:pt idx="1449">
                  <c:v>3444.2832159999998</c:v>
                </c:pt>
                <c:pt idx="1450">
                  <c:v>3446.211706</c:v>
                </c:pt>
                <c:pt idx="1451">
                  <c:v>3448.1401959999998</c:v>
                </c:pt>
                <c:pt idx="1452">
                  <c:v>3450.0686860000001</c:v>
                </c:pt>
                <c:pt idx="1453">
                  <c:v>3451.9971759999999</c:v>
                </c:pt>
                <c:pt idx="1454">
                  <c:v>3453.9256660000001</c:v>
                </c:pt>
                <c:pt idx="1455">
                  <c:v>3455.8541559999999</c:v>
                </c:pt>
                <c:pt idx="1456">
                  <c:v>3457.782647</c:v>
                </c:pt>
                <c:pt idx="1457">
                  <c:v>3459.7111369999998</c:v>
                </c:pt>
                <c:pt idx="1458">
                  <c:v>3461.639627</c:v>
                </c:pt>
                <c:pt idx="1459">
                  <c:v>3463.5681169999998</c:v>
                </c:pt>
                <c:pt idx="1460">
                  <c:v>3465.496607</c:v>
                </c:pt>
                <c:pt idx="1461">
                  <c:v>3467.4250969999998</c:v>
                </c:pt>
                <c:pt idx="1462">
                  <c:v>3469.3535870000001</c:v>
                </c:pt>
                <c:pt idx="1463">
                  <c:v>3471.2820769999998</c:v>
                </c:pt>
                <c:pt idx="1464">
                  <c:v>3473.2105670000001</c:v>
                </c:pt>
                <c:pt idx="1465">
                  <c:v>3475.1390569999999</c:v>
                </c:pt>
                <c:pt idx="1466">
                  <c:v>3477.0675470000001</c:v>
                </c:pt>
                <c:pt idx="1467">
                  <c:v>3478.9960369999999</c:v>
                </c:pt>
                <c:pt idx="1468">
                  <c:v>3480.9245270000001</c:v>
                </c:pt>
                <c:pt idx="1469">
                  <c:v>3482.8530169999999</c:v>
                </c:pt>
                <c:pt idx="1470">
                  <c:v>3484.7815070000001</c:v>
                </c:pt>
                <c:pt idx="1471">
                  <c:v>3486.7099969999999</c:v>
                </c:pt>
                <c:pt idx="1472">
                  <c:v>3488.6384870000002</c:v>
                </c:pt>
                <c:pt idx="1473">
                  <c:v>3490.566977</c:v>
                </c:pt>
                <c:pt idx="1474">
                  <c:v>3492.4954670000002</c:v>
                </c:pt>
                <c:pt idx="1475">
                  <c:v>3494.423957</c:v>
                </c:pt>
                <c:pt idx="1476">
                  <c:v>3496.3524470000002</c:v>
                </c:pt>
                <c:pt idx="1477">
                  <c:v>3498.280937</c:v>
                </c:pt>
                <c:pt idx="1478">
                  <c:v>3500.2094269999998</c:v>
                </c:pt>
                <c:pt idx="1479">
                  <c:v>3502.1379179999999</c:v>
                </c:pt>
                <c:pt idx="1480">
                  <c:v>3504.0664080000001</c:v>
                </c:pt>
                <c:pt idx="1481">
                  <c:v>3505.9948979999999</c:v>
                </c:pt>
                <c:pt idx="1482">
                  <c:v>3507.9233880000002</c:v>
                </c:pt>
                <c:pt idx="1483">
                  <c:v>3509.8518779999999</c:v>
                </c:pt>
                <c:pt idx="1484">
                  <c:v>3511.7803680000002</c:v>
                </c:pt>
                <c:pt idx="1485">
                  <c:v>3513.708858</c:v>
                </c:pt>
                <c:pt idx="1486">
                  <c:v>3515.6373480000002</c:v>
                </c:pt>
                <c:pt idx="1487">
                  <c:v>3517.565838</c:v>
                </c:pt>
                <c:pt idx="1488">
                  <c:v>3519.4943280000002</c:v>
                </c:pt>
                <c:pt idx="1489">
                  <c:v>3521.422818</c:v>
                </c:pt>
                <c:pt idx="1490">
                  <c:v>3523.3513079999998</c:v>
                </c:pt>
                <c:pt idx="1491">
                  <c:v>3525.279798</c:v>
                </c:pt>
                <c:pt idx="1492">
                  <c:v>3527.208287999998</c:v>
                </c:pt>
                <c:pt idx="1493">
                  <c:v>3529.136778</c:v>
                </c:pt>
                <c:pt idx="1494">
                  <c:v>3531.0652679999998</c:v>
                </c:pt>
                <c:pt idx="1495">
                  <c:v>3532.9937580000001</c:v>
                </c:pt>
                <c:pt idx="1496">
                  <c:v>3534.9222479999999</c:v>
                </c:pt>
                <c:pt idx="1497">
                  <c:v>3536.8507380000001</c:v>
                </c:pt>
                <c:pt idx="1498">
                  <c:v>3538.7792279999999</c:v>
                </c:pt>
                <c:pt idx="1499">
                  <c:v>3540.7077180000001</c:v>
                </c:pt>
                <c:pt idx="1500">
                  <c:v>3542.6362079999999</c:v>
                </c:pt>
                <c:pt idx="1501">
                  <c:v>3544.5646980000001</c:v>
                </c:pt>
                <c:pt idx="1502">
                  <c:v>3546.4931889999998</c:v>
                </c:pt>
                <c:pt idx="1503">
                  <c:v>3548.421679</c:v>
                </c:pt>
                <c:pt idx="1504">
                  <c:v>3550.3501689999998</c:v>
                </c:pt>
                <c:pt idx="1505">
                  <c:v>3552.2786590000001</c:v>
                </c:pt>
                <c:pt idx="1506">
                  <c:v>3554.2071489999998</c:v>
                </c:pt>
                <c:pt idx="1507">
                  <c:v>3556.1356390000001</c:v>
                </c:pt>
                <c:pt idx="1508">
                  <c:v>3558.0641289999999</c:v>
                </c:pt>
                <c:pt idx="1509">
                  <c:v>3559.9926190000001</c:v>
                </c:pt>
                <c:pt idx="1510">
                  <c:v>3561.9211089999999</c:v>
                </c:pt>
                <c:pt idx="1511">
                  <c:v>3563.8495990000001</c:v>
                </c:pt>
                <c:pt idx="1512">
                  <c:v>3565.778088999999</c:v>
                </c:pt>
                <c:pt idx="1513">
                  <c:v>3567.7065790000001</c:v>
                </c:pt>
                <c:pt idx="1514">
                  <c:v>3569.6350689999999</c:v>
                </c:pt>
                <c:pt idx="1515">
                  <c:v>3571.5635590000002</c:v>
                </c:pt>
                <c:pt idx="1516">
                  <c:v>3573.492049</c:v>
                </c:pt>
                <c:pt idx="1517">
                  <c:v>3575.4205390000002</c:v>
                </c:pt>
                <c:pt idx="1518">
                  <c:v>3577.349029</c:v>
                </c:pt>
                <c:pt idx="1519">
                  <c:v>3579.2775190000002</c:v>
                </c:pt>
                <c:pt idx="1520">
                  <c:v>3581.206009</c:v>
                </c:pt>
                <c:pt idx="1521">
                  <c:v>3583.1344989999998</c:v>
                </c:pt>
                <c:pt idx="1522">
                  <c:v>3585.062989</c:v>
                </c:pt>
                <c:pt idx="1523">
                  <c:v>3586.9914789999998</c:v>
                </c:pt>
                <c:pt idx="1524">
                  <c:v>3588.919969</c:v>
                </c:pt>
                <c:pt idx="1525">
                  <c:v>3590.8484589999998</c:v>
                </c:pt>
                <c:pt idx="1526">
                  <c:v>3592.776949999999</c:v>
                </c:pt>
                <c:pt idx="1527">
                  <c:v>3594.7054400000002</c:v>
                </c:pt>
                <c:pt idx="1528">
                  <c:v>3596.63393</c:v>
                </c:pt>
                <c:pt idx="1529">
                  <c:v>3598.5624200000002</c:v>
                </c:pt>
                <c:pt idx="1530">
                  <c:v>3600.49091</c:v>
                </c:pt>
                <c:pt idx="1531">
                  <c:v>3602.4194000000002</c:v>
                </c:pt>
                <c:pt idx="1532">
                  <c:v>3604.34789</c:v>
                </c:pt>
                <c:pt idx="1533">
                  <c:v>3606.2763799999998</c:v>
                </c:pt>
                <c:pt idx="1534">
                  <c:v>3608.20487</c:v>
                </c:pt>
                <c:pt idx="1535">
                  <c:v>3610.1333599999998</c:v>
                </c:pt>
                <c:pt idx="1536">
                  <c:v>3612.06185</c:v>
                </c:pt>
                <c:pt idx="1537">
                  <c:v>3613.9903399999998</c:v>
                </c:pt>
                <c:pt idx="1538">
                  <c:v>3615.9188300000001</c:v>
                </c:pt>
                <c:pt idx="1539">
                  <c:v>3617.8473199999999</c:v>
                </c:pt>
                <c:pt idx="1540">
                  <c:v>3619.7758100000001</c:v>
                </c:pt>
                <c:pt idx="1541">
                  <c:v>3621.704299999999</c:v>
                </c:pt>
                <c:pt idx="1542">
                  <c:v>3623.6327900000001</c:v>
                </c:pt>
                <c:pt idx="1543">
                  <c:v>3625.5612799999999</c:v>
                </c:pt>
                <c:pt idx="1544">
                  <c:v>3627.4897700000001</c:v>
                </c:pt>
                <c:pt idx="1545">
                  <c:v>3629.4182599999999</c:v>
                </c:pt>
                <c:pt idx="1546">
                  <c:v>3631.3467500000002</c:v>
                </c:pt>
                <c:pt idx="1547">
                  <c:v>3633.2752399999999</c:v>
                </c:pt>
                <c:pt idx="1548">
                  <c:v>3635.2037300000002</c:v>
                </c:pt>
                <c:pt idx="1549">
                  <c:v>3637.1322209999998</c:v>
                </c:pt>
                <c:pt idx="1550">
                  <c:v>3639.0607110000001</c:v>
                </c:pt>
                <c:pt idx="1551">
                  <c:v>3640.9892009999999</c:v>
                </c:pt>
                <c:pt idx="1552">
                  <c:v>3642.9176910000001</c:v>
                </c:pt>
                <c:pt idx="1553">
                  <c:v>3644.8461809999999</c:v>
                </c:pt>
                <c:pt idx="1554">
                  <c:v>3646.7746710000001</c:v>
                </c:pt>
                <c:pt idx="1555">
                  <c:v>3648.7031609999999</c:v>
                </c:pt>
                <c:pt idx="1556">
                  <c:v>3650.6316510000001</c:v>
                </c:pt>
                <c:pt idx="1557">
                  <c:v>3652.5601409999999</c:v>
                </c:pt>
                <c:pt idx="1558">
                  <c:v>3654.4886310000002</c:v>
                </c:pt>
                <c:pt idx="1559">
                  <c:v>3656.417121</c:v>
                </c:pt>
                <c:pt idx="1560">
                  <c:v>3658.3456110000002</c:v>
                </c:pt>
                <c:pt idx="1561">
                  <c:v>3660.274101</c:v>
                </c:pt>
                <c:pt idx="1562">
                  <c:v>3662.2025910000002</c:v>
                </c:pt>
                <c:pt idx="1563">
                  <c:v>3664.131081</c:v>
                </c:pt>
                <c:pt idx="1564">
                  <c:v>3666.0595709999998</c:v>
                </c:pt>
                <c:pt idx="1565">
                  <c:v>3667.988061</c:v>
                </c:pt>
                <c:pt idx="1566">
                  <c:v>3669.9165509999998</c:v>
                </c:pt>
                <c:pt idx="1567">
                  <c:v>3671.845041</c:v>
                </c:pt>
                <c:pt idx="1568">
                  <c:v>3673.7735309999998</c:v>
                </c:pt>
                <c:pt idx="1569">
                  <c:v>3675.7020210000001</c:v>
                </c:pt>
                <c:pt idx="1570">
                  <c:v>3677.6305109999998</c:v>
                </c:pt>
                <c:pt idx="1571">
                  <c:v>3679.5590010000001</c:v>
                </c:pt>
                <c:pt idx="1572">
                  <c:v>3681.4874909999999</c:v>
                </c:pt>
                <c:pt idx="1573">
                  <c:v>3683.415982</c:v>
                </c:pt>
                <c:pt idx="1574">
                  <c:v>3685.3444720000002</c:v>
                </c:pt>
                <c:pt idx="1575">
                  <c:v>3687.272962</c:v>
                </c:pt>
                <c:pt idx="1576">
                  <c:v>3689.2014519999998</c:v>
                </c:pt>
                <c:pt idx="1577">
                  <c:v>3691.129942</c:v>
                </c:pt>
                <c:pt idx="1578">
                  <c:v>3693.0584319999998</c:v>
                </c:pt>
                <c:pt idx="1579">
                  <c:v>3694.986922</c:v>
                </c:pt>
                <c:pt idx="1580">
                  <c:v>3696.9154119999998</c:v>
                </c:pt>
                <c:pt idx="1581">
                  <c:v>3698.8439020000001</c:v>
                </c:pt>
                <c:pt idx="1582">
                  <c:v>3700.7723919999999</c:v>
                </c:pt>
                <c:pt idx="1583">
                  <c:v>3702.7008820000001</c:v>
                </c:pt>
                <c:pt idx="1584">
                  <c:v>3704.6293719999999</c:v>
                </c:pt>
                <c:pt idx="1585">
                  <c:v>3706.5578620000001</c:v>
                </c:pt>
                <c:pt idx="1586">
                  <c:v>3708.4863519999999</c:v>
                </c:pt>
                <c:pt idx="1587">
                  <c:v>3710.4148420000001</c:v>
                </c:pt>
                <c:pt idx="1588">
                  <c:v>3712.3433319999999</c:v>
                </c:pt>
                <c:pt idx="1589">
                  <c:v>3714.2718220000002</c:v>
                </c:pt>
                <c:pt idx="1590">
                  <c:v>3716.2003119999999</c:v>
                </c:pt>
                <c:pt idx="1591">
                  <c:v>3718.1288020000002</c:v>
                </c:pt>
                <c:pt idx="1592">
                  <c:v>3720.057292</c:v>
                </c:pt>
                <c:pt idx="1593">
                  <c:v>3721.9857820000002</c:v>
                </c:pt>
                <c:pt idx="1594">
                  <c:v>3723.914272</c:v>
                </c:pt>
                <c:pt idx="1595">
                  <c:v>3725.8427620000002</c:v>
                </c:pt>
                <c:pt idx="1596">
                  <c:v>3727.7712529999999</c:v>
                </c:pt>
                <c:pt idx="1597">
                  <c:v>3729.6997430000001</c:v>
                </c:pt>
                <c:pt idx="1598">
                  <c:v>3731.6282329999999</c:v>
                </c:pt>
                <c:pt idx="1599">
                  <c:v>3733.5567230000001</c:v>
                </c:pt>
                <c:pt idx="1600">
                  <c:v>3735.4852129999999</c:v>
                </c:pt>
                <c:pt idx="1601">
                  <c:v>3737.4137030000002</c:v>
                </c:pt>
                <c:pt idx="1602">
                  <c:v>3739.342193</c:v>
                </c:pt>
                <c:pt idx="1603">
                  <c:v>3741.2706830000002</c:v>
                </c:pt>
                <c:pt idx="1604">
                  <c:v>3743.199173</c:v>
                </c:pt>
                <c:pt idx="1605">
                  <c:v>3745.1276630000002</c:v>
                </c:pt>
                <c:pt idx="1606">
                  <c:v>3747.056153</c:v>
                </c:pt>
                <c:pt idx="1607">
                  <c:v>3748.9846429999998</c:v>
                </c:pt>
                <c:pt idx="1608">
                  <c:v>3750.913133</c:v>
                </c:pt>
                <c:pt idx="1609">
                  <c:v>3752.8416229999998</c:v>
                </c:pt>
                <c:pt idx="1610">
                  <c:v>3754.770113</c:v>
                </c:pt>
                <c:pt idx="1611">
                  <c:v>3756.6986029999998</c:v>
                </c:pt>
                <c:pt idx="1612">
                  <c:v>3758.6270930000001</c:v>
                </c:pt>
                <c:pt idx="1613">
                  <c:v>3760.5555829999998</c:v>
                </c:pt>
                <c:pt idx="1614">
                  <c:v>3762.4840730000001</c:v>
                </c:pt>
                <c:pt idx="1615">
                  <c:v>3764.4125629999999</c:v>
                </c:pt>
                <c:pt idx="1616">
                  <c:v>3766.3410530000001</c:v>
                </c:pt>
                <c:pt idx="1617">
                  <c:v>3768.2695429999999</c:v>
                </c:pt>
                <c:pt idx="1618">
                  <c:v>3770.1980330000001</c:v>
                </c:pt>
                <c:pt idx="1619">
                  <c:v>3772.1265229999999</c:v>
                </c:pt>
                <c:pt idx="1620">
                  <c:v>3774.055014</c:v>
                </c:pt>
                <c:pt idx="1621">
                  <c:v>3775.9835039999998</c:v>
                </c:pt>
                <c:pt idx="1622">
                  <c:v>3777.911994</c:v>
                </c:pt>
                <c:pt idx="1623">
                  <c:v>3779.8404839999998</c:v>
                </c:pt>
                <c:pt idx="1624">
                  <c:v>3781.7689740000001</c:v>
                </c:pt>
                <c:pt idx="1625">
                  <c:v>3783.6974639999999</c:v>
                </c:pt>
                <c:pt idx="1626">
                  <c:v>3785.6259540000001</c:v>
                </c:pt>
                <c:pt idx="1627">
                  <c:v>3787.5544439999999</c:v>
                </c:pt>
                <c:pt idx="1628">
                  <c:v>3789.4829340000001</c:v>
                </c:pt>
                <c:pt idx="1629">
                  <c:v>3791.4114239999999</c:v>
                </c:pt>
                <c:pt idx="1630">
                  <c:v>3793.3399140000001</c:v>
                </c:pt>
                <c:pt idx="1631">
                  <c:v>3795.268403999999</c:v>
                </c:pt>
                <c:pt idx="1632">
                  <c:v>3797.1968940000002</c:v>
                </c:pt>
                <c:pt idx="1633">
                  <c:v>3799.1253839999999</c:v>
                </c:pt>
                <c:pt idx="1634">
                  <c:v>3801.0538740000002</c:v>
                </c:pt>
                <c:pt idx="1635">
                  <c:v>3802.982364</c:v>
                </c:pt>
                <c:pt idx="1636">
                  <c:v>3804.9108540000002</c:v>
                </c:pt>
                <c:pt idx="1637">
                  <c:v>3806.839344</c:v>
                </c:pt>
                <c:pt idx="1638">
                  <c:v>3808.7678340000002</c:v>
                </c:pt>
                <c:pt idx="1639">
                  <c:v>3810.696324</c:v>
                </c:pt>
                <c:pt idx="1640">
                  <c:v>3812.6248139999998</c:v>
                </c:pt>
                <c:pt idx="1641">
                  <c:v>3814.553304</c:v>
                </c:pt>
                <c:pt idx="1642">
                  <c:v>3816.4817939999998</c:v>
                </c:pt>
                <c:pt idx="1643">
                  <c:v>3818.4102849999999</c:v>
                </c:pt>
                <c:pt idx="1644">
                  <c:v>3820.3387750000002</c:v>
                </c:pt>
                <c:pt idx="1645">
                  <c:v>3822.267264999999</c:v>
                </c:pt>
                <c:pt idx="1646">
                  <c:v>3824.1957550000002</c:v>
                </c:pt>
                <c:pt idx="1647">
                  <c:v>3826.124245</c:v>
                </c:pt>
                <c:pt idx="1648">
                  <c:v>3828.0527350000002</c:v>
                </c:pt>
                <c:pt idx="1649">
                  <c:v>3829.981225</c:v>
                </c:pt>
                <c:pt idx="1650">
                  <c:v>3831.9097149999998</c:v>
                </c:pt>
                <c:pt idx="1651">
                  <c:v>3833.838205</c:v>
                </c:pt>
                <c:pt idx="1652">
                  <c:v>3835.766694999998</c:v>
                </c:pt>
                <c:pt idx="1653">
                  <c:v>3837.695185</c:v>
                </c:pt>
                <c:pt idx="1654">
                  <c:v>3839.6236749999998</c:v>
                </c:pt>
                <c:pt idx="1655">
                  <c:v>3841.5521650000001</c:v>
                </c:pt>
                <c:pt idx="1656">
                  <c:v>3843.4806549999998</c:v>
                </c:pt>
                <c:pt idx="1657">
                  <c:v>3845.4091450000001</c:v>
                </c:pt>
                <c:pt idx="1658">
                  <c:v>3847.3376349999999</c:v>
                </c:pt>
                <c:pt idx="1659">
                  <c:v>3849.2661250000001</c:v>
                </c:pt>
                <c:pt idx="1660">
                  <c:v>3851.1946149999999</c:v>
                </c:pt>
                <c:pt idx="1661">
                  <c:v>3853.1231050000001</c:v>
                </c:pt>
                <c:pt idx="1662">
                  <c:v>3855.0515949999999</c:v>
                </c:pt>
                <c:pt idx="1663">
                  <c:v>3856.9800850000001</c:v>
                </c:pt>
                <c:pt idx="1664">
                  <c:v>3858.9085749999999</c:v>
                </c:pt>
                <c:pt idx="1665">
                  <c:v>3860.8370650000002</c:v>
                </c:pt>
                <c:pt idx="1666">
                  <c:v>3862.7655559999998</c:v>
                </c:pt>
                <c:pt idx="1667">
                  <c:v>3864.6940460000001</c:v>
                </c:pt>
                <c:pt idx="1668">
                  <c:v>3866.6225359999999</c:v>
                </c:pt>
                <c:pt idx="1669">
                  <c:v>3868.5510260000001</c:v>
                </c:pt>
                <c:pt idx="1670">
                  <c:v>3870.4795159999999</c:v>
                </c:pt>
                <c:pt idx="1671">
                  <c:v>3872.4080060000001</c:v>
                </c:pt>
                <c:pt idx="1672">
                  <c:v>3874.3364959999999</c:v>
                </c:pt>
                <c:pt idx="1673">
                  <c:v>3876.2649860000001</c:v>
                </c:pt>
                <c:pt idx="1674">
                  <c:v>3878.1934759999999</c:v>
                </c:pt>
                <c:pt idx="1675">
                  <c:v>3880.1219660000002</c:v>
                </c:pt>
                <c:pt idx="1676">
                  <c:v>3882.0504559999999</c:v>
                </c:pt>
                <c:pt idx="1677">
                  <c:v>3883.9789460000002</c:v>
                </c:pt>
                <c:pt idx="1678">
                  <c:v>3885.907436</c:v>
                </c:pt>
                <c:pt idx="1679">
                  <c:v>3887.8359260000002</c:v>
                </c:pt>
                <c:pt idx="1680">
                  <c:v>3889.764416</c:v>
                </c:pt>
                <c:pt idx="1681">
                  <c:v>3891.6929060000002</c:v>
                </c:pt>
                <c:pt idx="1682">
                  <c:v>3893.621396</c:v>
                </c:pt>
                <c:pt idx="1683">
                  <c:v>3895.549885999998</c:v>
                </c:pt>
                <c:pt idx="1684">
                  <c:v>3897.478376</c:v>
                </c:pt>
                <c:pt idx="1685">
                  <c:v>3899.406865999998</c:v>
                </c:pt>
                <c:pt idx="1686">
                  <c:v>3901.335356</c:v>
                </c:pt>
                <c:pt idx="1687">
                  <c:v>3903.263845999998</c:v>
                </c:pt>
                <c:pt idx="1688">
                  <c:v>3905.1923360000001</c:v>
                </c:pt>
                <c:pt idx="1689">
                  <c:v>3907.120825999998</c:v>
                </c:pt>
                <c:pt idx="1690">
                  <c:v>3909.049317</c:v>
                </c:pt>
                <c:pt idx="1691">
                  <c:v>3910.9778070000002</c:v>
                </c:pt>
                <c:pt idx="1692">
                  <c:v>3912.906297</c:v>
                </c:pt>
                <c:pt idx="1693">
                  <c:v>3914.8347869999998</c:v>
                </c:pt>
                <c:pt idx="1694">
                  <c:v>3916.763277</c:v>
                </c:pt>
                <c:pt idx="1695">
                  <c:v>3918.6917669999998</c:v>
                </c:pt>
                <c:pt idx="1696">
                  <c:v>3920.620257</c:v>
                </c:pt>
                <c:pt idx="1697">
                  <c:v>3922.5487469999998</c:v>
                </c:pt>
                <c:pt idx="1698">
                  <c:v>3924.4772370000001</c:v>
                </c:pt>
                <c:pt idx="1699">
                  <c:v>3926.4057269999998</c:v>
                </c:pt>
                <c:pt idx="1700">
                  <c:v>3928.3342170000001</c:v>
                </c:pt>
                <c:pt idx="1701">
                  <c:v>3930.2627069999999</c:v>
                </c:pt>
                <c:pt idx="1702">
                  <c:v>3932.1911970000001</c:v>
                </c:pt>
                <c:pt idx="1703">
                  <c:v>3934.1196869999999</c:v>
                </c:pt>
                <c:pt idx="1704">
                  <c:v>3936.0481770000001</c:v>
                </c:pt>
                <c:pt idx="1705">
                  <c:v>3937.9766669999999</c:v>
                </c:pt>
                <c:pt idx="1706">
                  <c:v>3939.9051570000001</c:v>
                </c:pt>
                <c:pt idx="1707">
                  <c:v>3941.8336469999999</c:v>
                </c:pt>
                <c:pt idx="1708">
                  <c:v>3943.7621370000002</c:v>
                </c:pt>
                <c:pt idx="1709">
                  <c:v>3945.6906269999999</c:v>
                </c:pt>
                <c:pt idx="1710">
                  <c:v>3947.6191170000002</c:v>
                </c:pt>
                <c:pt idx="1711">
                  <c:v>3949.547607</c:v>
                </c:pt>
                <c:pt idx="1712">
                  <c:v>3951.4760970000002</c:v>
                </c:pt>
                <c:pt idx="1713">
                  <c:v>3953.4045879999999</c:v>
                </c:pt>
                <c:pt idx="1714">
                  <c:v>3955.3330780000001</c:v>
                </c:pt>
                <c:pt idx="1715">
                  <c:v>3957.2615679999999</c:v>
                </c:pt>
                <c:pt idx="1716">
                  <c:v>3959.1900580000001</c:v>
                </c:pt>
                <c:pt idx="1717">
                  <c:v>3961.1185479999999</c:v>
                </c:pt>
                <c:pt idx="1718">
                  <c:v>3963.0470380000002</c:v>
                </c:pt>
                <c:pt idx="1719">
                  <c:v>3964.9755279999999</c:v>
                </c:pt>
                <c:pt idx="1720">
                  <c:v>3966.9040180000002</c:v>
                </c:pt>
                <c:pt idx="1721">
                  <c:v>3968.832508</c:v>
                </c:pt>
                <c:pt idx="1722">
                  <c:v>3970.7609980000002</c:v>
                </c:pt>
                <c:pt idx="1723">
                  <c:v>3972.689488</c:v>
                </c:pt>
                <c:pt idx="1724">
                  <c:v>3974.6179780000002</c:v>
                </c:pt>
                <c:pt idx="1725">
                  <c:v>3976.546468</c:v>
                </c:pt>
                <c:pt idx="1726">
                  <c:v>3978.4749579999998</c:v>
                </c:pt>
                <c:pt idx="1727">
                  <c:v>3980.403448</c:v>
                </c:pt>
                <c:pt idx="1728">
                  <c:v>3982.3319379999998</c:v>
                </c:pt>
                <c:pt idx="1729">
                  <c:v>3984.260428</c:v>
                </c:pt>
                <c:pt idx="1730">
                  <c:v>3986.1889179999998</c:v>
                </c:pt>
                <c:pt idx="1731">
                  <c:v>3988.1174080000001</c:v>
                </c:pt>
                <c:pt idx="1732">
                  <c:v>3990.0458979999999</c:v>
                </c:pt>
                <c:pt idx="1733">
                  <c:v>3991.9743880000001</c:v>
                </c:pt>
                <c:pt idx="1734">
                  <c:v>3993.9028779999999</c:v>
                </c:pt>
                <c:pt idx="1735">
                  <c:v>3995.8313680000001</c:v>
                </c:pt>
                <c:pt idx="1736">
                  <c:v>3997.7598579999999</c:v>
                </c:pt>
                <c:pt idx="1737">
                  <c:v>3999.688349</c:v>
                </c:pt>
                <c:pt idx="1738">
                  <c:v>4001.6168389999998</c:v>
                </c:pt>
              </c:numCache>
            </c:numRef>
          </c:xVal>
          <c:yVal>
            <c:numRef>
              <c:f>IR!$C$1:$C$1744</c:f>
              <c:numCache>
                <c:formatCode>General</c:formatCode>
                <c:ptCount val="1744"/>
                <c:pt idx="0">
                  <c:v>96.955911</c:v>
                </c:pt>
                <c:pt idx="1">
                  <c:v>96.969413000000003</c:v>
                </c:pt>
                <c:pt idx="2">
                  <c:v>96.972577999999928</c:v>
                </c:pt>
                <c:pt idx="3">
                  <c:v>96.955126000000007</c:v>
                </c:pt>
                <c:pt idx="4">
                  <c:v>96.925434999999979</c:v>
                </c:pt>
                <c:pt idx="5">
                  <c:v>96.893555000000006</c:v>
                </c:pt>
                <c:pt idx="6">
                  <c:v>96.866907999999981</c:v>
                </c:pt>
                <c:pt idx="7">
                  <c:v>96.851281999999998</c:v>
                </c:pt>
                <c:pt idx="8">
                  <c:v>96.846654999999998</c:v>
                </c:pt>
                <c:pt idx="9">
                  <c:v>96.845433999999983</c:v>
                </c:pt>
                <c:pt idx="10">
                  <c:v>96.838684000000001</c:v>
                </c:pt>
                <c:pt idx="11">
                  <c:v>96.825581999999912</c:v>
                </c:pt>
                <c:pt idx="12">
                  <c:v>96.813267999999994</c:v>
                </c:pt>
                <c:pt idx="13">
                  <c:v>96.808000000000007</c:v>
                </c:pt>
                <c:pt idx="14">
                  <c:v>96.809681999999981</c:v>
                </c:pt>
                <c:pt idx="15">
                  <c:v>96.812124999999995</c:v>
                </c:pt>
                <c:pt idx="16">
                  <c:v>96.809190999999998</c:v>
                </c:pt>
                <c:pt idx="17">
                  <c:v>96.802293000000006</c:v>
                </c:pt>
                <c:pt idx="18">
                  <c:v>96.798141999999999</c:v>
                </c:pt>
                <c:pt idx="19">
                  <c:v>96.798041999999981</c:v>
                </c:pt>
                <c:pt idx="20">
                  <c:v>96.795575999999983</c:v>
                </c:pt>
                <c:pt idx="21">
                  <c:v>96.78734</c:v>
                </c:pt>
                <c:pt idx="22">
                  <c:v>96.777023999999997</c:v>
                </c:pt>
                <c:pt idx="23">
                  <c:v>96.765856999999983</c:v>
                </c:pt>
                <c:pt idx="24">
                  <c:v>96.750986999999981</c:v>
                </c:pt>
                <c:pt idx="25">
                  <c:v>96.734637000000006</c:v>
                </c:pt>
                <c:pt idx="26">
                  <c:v>96.723039999999983</c:v>
                </c:pt>
                <c:pt idx="27">
                  <c:v>96.715504999999993</c:v>
                </c:pt>
                <c:pt idx="28">
                  <c:v>96.703327999999999</c:v>
                </c:pt>
                <c:pt idx="29">
                  <c:v>96.681234000000003</c:v>
                </c:pt>
                <c:pt idx="30">
                  <c:v>96.652189999999976</c:v>
                </c:pt>
                <c:pt idx="31">
                  <c:v>96.619174000000001</c:v>
                </c:pt>
                <c:pt idx="32">
                  <c:v>96.581213000000005</c:v>
                </c:pt>
                <c:pt idx="33">
                  <c:v>96.536236000000002</c:v>
                </c:pt>
                <c:pt idx="34">
                  <c:v>96.478442999999928</c:v>
                </c:pt>
                <c:pt idx="35">
                  <c:v>96.406397999999982</c:v>
                </c:pt>
                <c:pt idx="36">
                  <c:v>96.344049999999996</c:v>
                </c:pt>
                <c:pt idx="37">
                  <c:v>96.330053000000007</c:v>
                </c:pt>
                <c:pt idx="38">
                  <c:v>96.375965999999977</c:v>
                </c:pt>
                <c:pt idx="39">
                  <c:v>96.455030999999977</c:v>
                </c:pt>
                <c:pt idx="40">
                  <c:v>96.534818000000001</c:v>
                </c:pt>
                <c:pt idx="41">
                  <c:v>96.604944000000003</c:v>
                </c:pt>
                <c:pt idx="42">
                  <c:v>96.669224</c:v>
                </c:pt>
                <c:pt idx="43">
                  <c:v>96.724823000000001</c:v>
                </c:pt>
                <c:pt idx="44">
                  <c:v>96.764201</c:v>
                </c:pt>
                <c:pt idx="45">
                  <c:v>96.789446999999981</c:v>
                </c:pt>
                <c:pt idx="46">
                  <c:v>96.811144999999996</c:v>
                </c:pt>
                <c:pt idx="47">
                  <c:v>96.835909999999998</c:v>
                </c:pt>
                <c:pt idx="48">
                  <c:v>96.861717999999982</c:v>
                </c:pt>
                <c:pt idx="49">
                  <c:v>96.882813999999982</c:v>
                </c:pt>
                <c:pt idx="50">
                  <c:v>96.894918000000004</c:v>
                </c:pt>
                <c:pt idx="51">
                  <c:v>96.898674</c:v>
                </c:pt>
                <c:pt idx="52">
                  <c:v>96.899863999999994</c:v>
                </c:pt>
                <c:pt idx="53">
                  <c:v>96.904013000000006</c:v>
                </c:pt>
                <c:pt idx="54">
                  <c:v>96.911544000000006</c:v>
                </c:pt>
                <c:pt idx="55">
                  <c:v>96.916895999999994</c:v>
                </c:pt>
                <c:pt idx="56">
                  <c:v>96.913915000000003</c:v>
                </c:pt>
                <c:pt idx="57">
                  <c:v>96.904842000000002</c:v>
                </c:pt>
                <c:pt idx="58">
                  <c:v>96.896569</c:v>
                </c:pt>
                <c:pt idx="59">
                  <c:v>96.890100000000004</c:v>
                </c:pt>
                <c:pt idx="60">
                  <c:v>96.885657999999978</c:v>
                </c:pt>
                <c:pt idx="61">
                  <c:v>96.889083999999983</c:v>
                </c:pt>
                <c:pt idx="62">
                  <c:v>96.903972999999979</c:v>
                </c:pt>
                <c:pt idx="63">
                  <c:v>96.928361999999979</c:v>
                </c:pt>
                <c:pt idx="64">
                  <c:v>96.958869000000007</c:v>
                </c:pt>
                <c:pt idx="65">
                  <c:v>96.990852000000004</c:v>
                </c:pt>
                <c:pt idx="66">
                  <c:v>97.020729999999986</c:v>
                </c:pt>
                <c:pt idx="67">
                  <c:v>97.047936000000007</c:v>
                </c:pt>
                <c:pt idx="68">
                  <c:v>97.071853000000004</c:v>
                </c:pt>
                <c:pt idx="69">
                  <c:v>97.092003000000005</c:v>
                </c:pt>
                <c:pt idx="70">
                  <c:v>97.109020999999998</c:v>
                </c:pt>
                <c:pt idx="71">
                  <c:v>97.121365999999981</c:v>
                </c:pt>
                <c:pt idx="72">
                  <c:v>97.125850999999912</c:v>
                </c:pt>
                <c:pt idx="73">
                  <c:v>97.120680999999976</c:v>
                </c:pt>
                <c:pt idx="74">
                  <c:v>97.104596000000001</c:v>
                </c:pt>
                <c:pt idx="75">
                  <c:v>97.077373999999978</c:v>
                </c:pt>
                <c:pt idx="76">
                  <c:v>97.041127000000003</c:v>
                </c:pt>
                <c:pt idx="77">
                  <c:v>96.998643000000001</c:v>
                </c:pt>
                <c:pt idx="78">
                  <c:v>96.954377999999977</c:v>
                </c:pt>
                <c:pt idx="79">
                  <c:v>96.913805999999994</c:v>
                </c:pt>
                <c:pt idx="80">
                  <c:v>96.877544999999998</c:v>
                </c:pt>
                <c:pt idx="81">
                  <c:v>96.843535000000003</c:v>
                </c:pt>
                <c:pt idx="82">
                  <c:v>96.814040000000006</c:v>
                </c:pt>
                <c:pt idx="83">
                  <c:v>96.79240799999998</c:v>
                </c:pt>
                <c:pt idx="84">
                  <c:v>96.777849000000003</c:v>
                </c:pt>
                <c:pt idx="85">
                  <c:v>96.765592999999981</c:v>
                </c:pt>
                <c:pt idx="86">
                  <c:v>96.748525999999998</c:v>
                </c:pt>
                <c:pt idx="87">
                  <c:v>96.724027000000007</c:v>
                </c:pt>
                <c:pt idx="88">
                  <c:v>96.698668999999981</c:v>
                </c:pt>
                <c:pt idx="89">
                  <c:v>96.680910999999981</c:v>
                </c:pt>
                <c:pt idx="90">
                  <c:v>96.673862999999912</c:v>
                </c:pt>
                <c:pt idx="91">
                  <c:v>96.676104999999978</c:v>
                </c:pt>
                <c:pt idx="92">
                  <c:v>96.684730999999928</c:v>
                </c:pt>
                <c:pt idx="93">
                  <c:v>96.697934000000004</c:v>
                </c:pt>
                <c:pt idx="94">
                  <c:v>96.716437999999982</c:v>
                </c:pt>
                <c:pt idx="95">
                  <c:v>96.741257000000004</c:v>
                </c:pt>
                <c:pt idx="96">
                  <c:v>96.769284999999996</c:v>
                </c:pt>
                <c:pt idx="97">
                  <c:v>96.792295999999993</c:v>
                </c:pt>
                <c:pt idx="98">
                  <c:v>96.802532999999912</c:v>
                </c:pt>
                <c:pt idx="99">
                  <c:v>96.80145899999998</c:v>
                </c:pt>
                <c:pt idx="100">
                  <c:v>96.80001</c:v>
                </c:pt>
                <c:pt idx="101">
                  <c:v>96.807102999999998</c:v>
                </c:pt>
                <c:pt idx="102">
                  <c:v>96.82306699999998</c:v>
                </c:pt>
                <c:pt idx="103">
                  <c:v>96.844605999999999</c:v>
                </c:pt>
                <c:pt idx="104">
                  <c:v>96.869643999999994</c:v>
                </c:pt>
                <c:pt idx="105">
                  <c:v>96.897054999999995</c:v>
                </c:pt>
                <c:pt idx="106">
                  <c:v>96.925160000000005</c:v>
                </c:pt>
                <c:pt idx="107">
                  <c:v>96.952016</c:v>
                </c:pt>
                <c:pt idx="108">
                  <c:v>96.976085999999981</c:v>
                </c:pt>
                <c:pt idx="109">
                  <c:v>96.995856000000003</c:v>
                </c:pt>
                <c:pt idx="110">
                  <c:v>97.009791999999976</c:v>
                </c:pt>
                <c:pt idx="111">
                  <c:v>97.016631000000004</c:v>
                </c:pt>
                <c:pt idx="112">
                  <c:v>97.016694000000001</c:v>
                </c:pt>
                <c:pt idx="113">
                  <c:v>97.012975999999981</c:v>
                </c:pt>
                <c:pt idx="114">
                  <c:v>97.010046000000003</c:v>
                </c:pt>
                <c:pt idx="115">
                  <c:v>97.014442000000003</c:v>
                </c:pt>
                <c:pt idx="116">
                  <c:v>97.034897999999998</c:v>
                </c:pt>
                <c:pt idx="117">
                  <c:v>97.076979999999978</c:v>
                </c:pt>
                <c:pt idx="118">
                  <c:v>97.13758799999998</c:v>
                </c:pt>
                <c:pt idx="119">
                  <c:v>97.205692999999982</c:v>
                </c:pt>
                <c:pt idx="120">
                  <c:v>97.267510000000001</c:v>
                </c:pt>
                <c:pt idx="121">
                  <c:v>97.312864000000005</c:v>
                </c:pt>
                <c:pt idx="122">
                  <c:v>97.340336999999977</c:v>
                </c:pt>
                <c:pt idx="123">
                  <c:v>97.356017999999978</c:v>
                </c:pt>
                <c:pt idx="124">
                  <c:v>97.36571499999998</c:v>
                </c:pt>
                <c:pt idx="125">
                  <c:v>97.372105999999945</c:v>
                </c:pt>
                <c:pt idx="126">
                  <c:v>97.376911999999976</c:v>
                </c:pt>
                <c:pt idx="127">
                  <c:v>97.379266999999999</c:v>
                </c:pt>
                <c:pt idx="128">
                  <c:v>97.374420999999998</c:v>
                </c:pt>
                <c:pt idx="129">
                  <c:v>97.356589</c:v>
                </c:pt>
                <c:pt idx="130">
                  <c:v>97.324212000000003</c:v>
                </c:pt>
                <c:pt idx="131">
                  <c:v>97.282122000000001</c:v>
                </c:pt>
                <c:pt idx="132">
                  <c:v>97.234371999999979</c:v>
                </c:pt>
                <c:pt idx="133">
                  <c:v>97.179773999999895</c:v>
                </c:pt>
                <c:pt idx="134">
                  <c:v>97.119117000000003</c:v>
                </c:pt>
                <c:pt idx="135">
                  <c:v>97.058655999999999</c:v>
                </c:pt>
                <c:pt idx="136">
                  <c:v>97.003215999999995</c:v>
                </c:pt>
                <c:pt idx="137">
                  <c:v>96.953188999999981</c:v>
                </c:pt>
                <c:pt idx="138">
                  <c:v>96.908831999999975</c:v>
                </c:pt>
                <c:pt idx="139">
                  <c:v>96.869041999999979</c:v>
                </c:pt>
                <c:pt idx="140">
                  <c:v>96.828991999999928</c:v>
                </c:pt>
                <c:pt idx="141">
                  <c:v>96.787006000000005</c:v>
                </c:pt>
                <c:pt idx="142">
                  <c:v>96.748523000000006</c:v>
                </c:pt>
                <c:pt idx="143">
                  <c:v>96.72043799999993</c:v>
                </c:pt>
                <c:pt idx="144">
                  <c:v>96.706777999999929</c:v>
                </c:pt>
                <c:pt idx="145">
                  <c:v>96.708748999999912</c:v>
                </c:pt>
                <c:pt idx="146">
                  <c:v>96.724508999999998</c:v>
                </c:pt>
                <c:pt idx="147">
                  <c:v>96.747646000000003</c:v>
                </c:pt>
                <c:pt idx="148">
                  <c:v>96.766852999999998</c:v>
                </c:pt>
                <c:pt idx="149">
                  <c:v>96.768369000000007</c:v>
                </c:pt>
                <c:pt idx="150">
                  <c:v>96.740401000000006</c:v>
                </c:pt>
                <c:pt idx="151">
                  <c:v>96.675335999999859</c:v>
                </c:pt>
                <c:pt idx="152">
                  <c:v>96.566933000000006</c:v>
                </c:pt>
                <c:pt idx="153">
                  <c:v>96.412709000000007</c:v>
                </c:pt>
                <c:pt idx="154">
                  <c:v>96.223590999999999</c:v>
                </c:pt>
                <c:pt idx="155">
                  <c:v>96.024769000000006</c:v>
                </c:pt>
                <c:pt idx="156">
                  <c:v>95.846483000000006</c:v>
                </c:pt>
                <c:pt idx="157">
                  <c:v>95.711607999999998</c:v>
                </c:pt>
                <c:pt idx="158">
                  <c:v>95.622523999999999</c:v>
                </c:pt>
                <c:pt idx="159">
                  <c:v>95.561214000000007</c:v>
                </c:pt>
                <c:pt idx="160">
                  <c:v>95.501631000000003</c:v>
                </c:pt>
                <c:pt idx="161">
                  <c:v>95.420224000000005</c:v>
                </c:pt>
                <c:pt idx="162">
                  <c:v>95.309041999999977</c:v>
                </c:pt>
                <c:pt idx="163">
                  <c:v>95.184832999999927</c:v>
                </c:pt>
                <c:pt idx="164">
                  <c:v>95.078145999999975</c:v>
                </c:pt>
                <c:pt idx="165">
                  <c:v>95.016953000000001</c:v>
                </c:pt>
                <c:pt idx="166">
                  <c:v>95.017645000000002</c:v>
                </c:pt>
                <c:pt idx="167">
                  <c:v>95.081720000000004</c:v>
                </c:pt>
                <c:pt idx="168">
                  <c:v>95.200655999999995</c:v>
                </c:pt>
                <c:pt idx="169">
                  <c:v>95.359054</c:v>
                </c:pt>
                <c:pt idx="170">
                  <c:v>95.532110000000003</c:v>
                </c:pt>
                <c:pt idx="171">
                  <c:v>95.691771999999929</c:v>
                </c:pt>
                <c:pt idx="172">
                  <c:v>95.818755999999979</c:v>
                </c:pt>
                <c:pt idx="173">
                  <c:v>95.905836999999977</c:v>
                </c:pt>
                <c:pt idx="174">
                  <c:v>95.954891000000003</c:v>
                </c:pt>
                <c:pt idx="175">
                  <c:v>95.973830999999976</c:v>
                </c:pt>
                <c:pt idx="176">
                  <c:v>95.971941999999999</c:v>
                </c:pt>
                <c:pt idx="177">
                  <c:v>95.955291000000003</c:v>
                </c:pt>
                <c:pt idx="178">
                  <c:v>95.926401999999982</c:v>
                </c:pt>
                <c:pt idx="179">
                  <c:v>95.887315000000001</c:v>
                </c:pt>
                <c:pt idx="180">
                  <c:v>95.842522000000002</c:v>
                </c:pt>
                <c:pt idx="181">
                  <c:v>95.794390000000007</c:v>
                </c:pt>
                <c:pt idx="182">
                  <c:v>95.736700999999982</c:v>
                </c:pt>
                <c:pt idx="183">
                  <c:v>95.663797999999929</c:v>
                </c:pt>
                <c:pt idx="184">
                  <c:v>95.581136999999998</c:v>
                </c:pt>
                <c:pt idx="185">
                  <c:v>95.498328000000001</c:v>
                </c:pt>
                <c:pt idx="186">
                  <c:v>95.421394000000006</c:v>
                </c:pt>
                <c:pt idx="187">
                  <c:v>95.352779999999896</c:v>
                </c:pt>
                <c:pt idx="188">
                  <c:v>95.291460999999998</c:v>
                </c:pt>
                <c:pt idx="189">
                  <c:v>95.235576999999978</c:v>
                </c:pt>
                <c:pt idx="190">
                  <c:v>95.182842999999892</c:v>
                </c:pt>
                <c:pt idx="191">
                  <c:v>95.125654999999981</c:v>
                </c:pt>
                <c:pt idx="192">
                  <c:v>95.052794999999946</c:v>
                </c:pt>
                <c:pt idx="193">
                  <c:v>94.959007</c:v>
                </c:pt>
                <c:pt idx="194">
                  <c:v>94.845423999999994</c:v>
                </c:pt>
                <c:pt idx="195">
                  <c:v>94.710217</c:v>
                </c:pt>
                <c:pt idx="196">
                  <c:v>94.548787999999931</c:v>
                </c:pt>
                <c:pt idx="197">
                  <c:v>94.362146999999979</c:v>
                </c:pt>
                <c:pt idx="198">
                  <c:v>94.153630000000007</c:v>
                </c:pt>
                <c:pt idx="199">
                  <c:v>93.921644000000001</c:v>
                </c:pt>
                <c:pt idx="200">
                  <c:v>93.664307999999977</c:v>
                </c:pt>
                <c:pt idx="201">
                  <c:v>93.387043000000006</c:v>
                </c:pt>
                <c:pt idx="202">
                  <c:v>93.100065999999998</c:v>
                </c:pt>
                <c:pt idx="203">
                  <c:v>92.812262000000004</c:v>
                </c:pt>
                <c:pt idx="204">
                  <c:v>92.530551000000003</c:v>
                </c:pt>
                <c:pt idx="205">
                  <c:v>92.264571000000004</c:v>
                </c:pt>
                <c:pt idx="206">
                  <c:v>92.026022999999981</c:v>
                </c:pt>
                <c:pt idx="207">
                  <c:v>91.824115000000006</c:v>
                </c:pt>
                <c:pt idx="208">
                  <c:v>91.663713000000001</c:v>
                </c:pt>
                <c:pt idx="209">
                  <c:v>91.543075000000002</c:v>
                </c:pt>
                <c:pt idx="210">
                  <c:v>91.451397</c:v>
                </c:pt>
                <c:pt idx="211">
                  <c:v>91.376025999999982</c:v>
                </c:pt>
                <c:pt idx="212">
                  <c:v>91.312943000000004</c:v>
                </c:pt>
                <c:pt idx="213">
                  <c:v>91.267895999999993</c:v>
                </c:pt>
                <c:pt idx="214">
                  <c:v>91.246295000000003</c:v>
                </c:pt>
                <c:pt idx="215">
                  <c:v>91.246217000000001</c:v>
                </c:pt>
                <c:pt idx="216">
                  <c:v>91.264662000000001</c:v>
                </c:pt>
                <c:pt idx="217">
                  <c:v>91.303555000000003</c:v>
                </c:pt>
                <c:pt idx="218">
                  <c:v>91.362183999999999</c:v>
                </c:pt>
                <c:pt idx="219">
                  <c:v>91.429805000000002</c:v>
                </c:pt>
                <c:pt idx="220">
                  <c:v>91.489902999999998</c:v>
                </c:pt>
                <c:pt idx="221">
                  <c:v>91.525221999999999</c:v>
                </c:pt>
                <c:pt idx="222">
                  <c:v>91.519673999999995</c:v>
                </c:pt>
                <c:pt idx="223">
                  <c:v>91.464183000000006</c:v>
                </c:pt>
                <c:pt idx="224">
                  <c:v>91.362409</c:v>
                </c:pt>
                <c:pt idx="225">
                  <c:v>91.231476999999998</c:v>
                </c:pt>
                <c:pt idx="226">
                  <c:v>91.099445000000003</c:v>
                </c:pt>
                <c:pt idx="227">
                  <c:v>90.995497</c:v>
                </c:pt>
                <c:pt idx="228">
                  <c:v>90.937974999999994</c:v>
                </c:pt>
                <c:pt idx="229">
                  <c:v>90.932490999999999</c:v>
                </c:pt>
                <c:pt idx="230">
                  <c:v>90.975969999999975</c:v>
                </c:pt>
                <c:pt idx="231">
                  <c:v>91.059309999999982</c:v>
                </c:pt>
                <c:pt idx="232">
                  <c:v>91.170438999999874</c:v>
                </c:pt>
                <c:pt idx="233">
                  <c:v>91.297116000000003</c:v>
                </c:pt>
                <c:pt idx="234">
                  <c:v>91.42868</c:v>
                </c:pt>
                <c:pt idx="235">
                  <c:v>91.555382999999892</c:v>
                </c:pt>
                <c:pt idx="236">
                  <c:v>91.668160999999998</c:v>
                </c:pt>
                <c:pt idx="237">
                  <c:v>91.763181000000003</c:v>
                </c:pt>
                <c:pt idx="238">
                  <c:v>91.847289000000004</c:v>
                </c:pt>
                <c:pt idx="239">
                  <c:v>91.937970000000007</c:v>
                </c:pt>
                <c:pt idx="240">
                  <c:v>92.057930000000013</c:v>
                </c:pt>
                <c:pt idx="241">
                  <c:v>92.226713000000004</c:v>
                </c:pt>
                <c:pt idx="242">
                  <c:v>92.451567999999995</c:v>
                </c:pt>
                <c:pt idx="243">
                  <c:v>92.722284999999999</c:v>
                </c:pt>
                <c:pt idx="244">
                  <c:v>93.015375999999947</c:v>
                </c:pt>
                <c:pt idx="245">
                  <c:v>93.30335599999998</c:v>
                </c:pt>
                <c:pt idx="246">
                  <c:v>93.563716999999983</c:v>
                </c:pt>
                <c:pt idx="247">
                  <c:v>93.784400000000005</c:v>
                </c:pt>
                <c:pt idx="248">
                  <c:v>93.960667000000001</c:v>
                </c:pt>
                <c:pt idx="249">
                  <c:v>94.087620000000001</c:v>
                </c:pt>
                <c:pt idx="250">
                  <c:v>94.161259999999999</c:v>
                </c:pt>
                <c:pt idx="251">
                  <c:v>94.187407999999976</c:v>
                </c:pt>
                <c:pt idx="252">
                  <c:v>94.182590999999945</c:v>
                </c:pt>
                <c:pt idx="253">
                  <c:v>94.163846999999976</c:v>
                </c:pt>
                <c:pt idx="254">
                  <c:v>94.143023999999997</c:v>
                </c:pt>
                <c:pt idx="255">
                  <c:v>94.12985699999993</c:v>
                </c:pt>
                <c:pt idx="256">
                  <c:v>94.134271999999982</c:v>
                </c:pt>
                <c:pt idx="257">
                  <c:v>94.166253999999995</c:v>
                </c:pt>
                <c:pt idx="258">
                  <c:v>94.23424</c:v>
                </c:pt>
                <c:pt idx="259">
                  <c:v>94.339743999999982</c:v>
                </c:pt>
                <c:pt idx="260">
                  <c:v>94.475190999999981</c:v>
                </c:pt>
                <c:pt idx="261">
                  <c:v>94.628630999999928</c:v>
                </c:pt>
                <c:pt idx="262">
                  <c:v>94.787659000000005</c:v>
                </c:pt>
                <c:pt idx="263">
                  <c:v>94.940438999999998</c:v>
                </c:pt>
                <c:pt idx="264">
                  <c:v>95.076875999999928</c:v>
                </c:pt>
                <c:pt idx="265">
                  <c:v>95.189369999999982</c:v>
                </c:pt>
                <c:pt idx="266">
                  <c:v>95.274636000000001</c:v>
                </c:pt>
                <c:pt idx="267">
                  <c:v>95.336030999999977</c:v>
                </c:pt>
                <c:pt idx="268">
                  <c:v>95.380987999999945</c:v>
                </c:pt>
                <c:pt idx="269">
                  <c:v>95.415560999999997</c:v>
                </c:pt>
                <c:pt idx="270">
                  <c:v>95.443815000000001</c:v>
                </c:pt>
                <c:pt idx="271">
                  <c:v>95.470827999999983</c:v>
                </c:pt>
                <c:pt idx="272">
                  <c:v>95.501249000000001</c:v>
                </c:pt>
                <c:pt idx="273">
                  <c:v>95.535373999999976</c:v>
                </c:pt>
                <c:pt idx="274">
                  <c:v>95.571331999999927</c:v>
                </c:pt>
                <c:pt idx="275">
                  <c:v>95.609431999999927</c:v>
                </c:pt>
                <c:pt idx="276">
                  <c:v>95.64989199999998</c:v>
                </c:pt>
                <c:pt idx="277">
                  <c:v>95.689256999999998</c:v>
                </c:pt>
                <c:pt idx="278">
                  <c:v>95.723957999999982</c:v>
                </c:pt>
                <c:pt idx="279">
                  <c:v>95.754803999999993</c:v>
                </c:pt>
                <c:pt idx="280">
                  <c:v>95.783126999999993</c:v>
                </c:pt>
                <c:pt idx="281">
                  <c:v>95.805299999999974</c:v>
                </c:pt>
                <c:pt idx="282">
                  <c:v>95.817014</c:v>
                </c:pt>
                <c:pt idx="283">
                  <c:v>95.820338999999876</c:v>
                </c:pt>
                <c:pt idx="284">
                  <c:v>95.819928000000004</c:v>
                </c:pt>
                <c:pt idx="285">
                  <c:v>95.814952000000005</c:v>
                </c:pt>
                <c:pt idx="286">
                  <c:v>95.800407999999976</c:v>
                </c:pt>
                <c:pt idx="287">
                  <c:v>95.77302899999998</c:v>
                </c:pt>
                <c:pt idx="288">
                  <c:v>95.730104999999995</c:v>
                </c:pt>
                <c:pt idx="289">
                  <c:v>95.666176999999976</c:v>
                </c:pt>
                <c:pt idx="290">
                  <c:v>95.578175999999928</c:v>
                </c:pt>
                <c:pt idx="291">
                  <c:v>95.471635000000006</c:v>
                </c:pt>
                <c:pt idx="292">
                  <c:v>95.356568999999979</c:v>
                </c:pt>
                <c:pt idx="293">
                  <c:v>95.241071000000005</c:v>
                </c:pt>
                <c:pt idx="294">
                  <c:v>95.130150999999998</c:v>
                </c:pt>
                <c:pt idx="295">
                  <c:v>95.02502699999998</c:v>
                </c:pt>
                <c:pt idx="296">
                  <c:v>94.92271599999998</c:v>
                </c:pt>
                <c:pt idx="297">
                  <c:v>94.818382999999912</c:v>
                </c:pt>
                <c:pt idx="298">
                  <c:v>94.707746</c:v>
                </c:pt>
                <c:pt idx="299">
                  <c:v>94.588706999999928</c:v>
                </c:pt>
                <c:pt idx="300">
                  <c:v>94.462711999999982</c:v>
                </c:pt>
                <c:pt idx="301">
                  <c:v>94.334912000000003</c:v>
                </c:pt>
                <c:pt idx="302">
                  <c:v>94.215101000000004</c:v>
                </c:pt>
                <c:pt idx="303">
                  <c:v>94.116917999999998</c:v>
                </c:pt>
                <c:pt idx="304">
                  <c:v>94.049087999999998</c:v>
                </c:pt>
                <c:pt idx="305">
                  <c:v>94.009652000000003</c:v>
                </c:pt>
                <c:pt idx="306">
                  <c:v>93.994766999999996</c:v>
                </c:pt>
                <c:pt idx="307">
                  <c:v>94.006189000000006</c:v>
                </c:pt>
                <c:pt idx="308">
                  <c:v>94.045682999999983</c:v>
                </c:pt>
                <c:pt idx="309">
                  <c:v>94.110281999999998</c:v>
                </c:pt>
                <c:pt idx="310">
                  <c:v>94.196180999999982</c:v>
                </c:pt>
                <c:pt idx="311">
                  <c:v>94.301349000000002</c:v>
                </c:pt>
                <c:pt idx="312">
                  <c:v>94.422883999999982</c:v>
                </c:pt>
                <c:pt idx="313">
                  <c:v>94.556891999999976</c:v>
                </c:pt>
                <c:pt idx="314">
                  <c:v>94.703090000000003</c:v>
                </c:pt>
                <c:pt idx="315">
                  <c:v>94.864157000000006</c:v>
                </c:pt>
                <c:pt idx="316">
                  <c:v>95.038392999999928</c:v>
                </c:pt>
                <c:pt idx="317">
                  <c:v>95.216330000000013</c:v>
                </c:pt>
                <c:pt idx="318">
                  <c:v>95.385540999999947</c:v>
                </c:pt>
                <c:pt idx="319">
                  <c:v>95.536395999999982</c:v>
                </c:pt>
                <c:pt idx="320">
                  <c:v>95.664664999999999</c:v>
                </c:pt>
                <c:pt idx="321">
                  <c:v>95.770597999999978</c:v>
                </c:pt>
                <c:pt idx="322">
                  <c:v>95.85544599999993</c:v>
                </c:pt>
                <c:pt idx="323">
                  <c:v>95.920849000000004</c:v>
                </c:pt>
                <c:pt idx="324">
                  <c:v>95.971924000000001</c:v>
                </c:pt>
                <c:pt idx="325">
                  <c:v>96.017555000000002</c:v>
                </c:pt>
                <c:pt idx="326">
                  <c:v>96.067153000000005</c:v>
                </c:pt>
                <c:pt idx="327">
                  <c:v>96.124981999999946</c:v>
                </c:pt>
                <c:pt idx="328">
                  <c:v>96.186096999999975</c:v>
                </c:pt>
                <c:pt idx="329">
                  <c:v>96.241617000000005</c:v>
                </c:pt>
                <c:pt idx="330">
                  <c:v>96.287898999999982</c:v>
                </c:pt>
                <c:pt idx="331">
                  <c:v>96.326724999999982</c:v>
                </c:pt>
                <c:pt idx="332">
                  <c:v>96.358903999999981</c:v>
                </c:pt>
                <c:pt idx="333">
                  <c:v>96.381525999999994</c:v>
                </c:pt>
                <c:pt idx="334">
                  <c:v>96.391480000000001</c:v>
                </c:pt>
                <c:pt idx="335">
                  <c:v>96.391229999999993</c:v>
                </c:pt>
                <c:pt idx="336">
                  <c:v>96.389950999999982</c:v>
                </c:pt>
                <c:pt idx="337">
                  <c:v>96.397492</c:v>
                </c:pt>
                <c:pt idx="338">
                  <c:v>96.418226000000004</c:v>
                </c:pt>
                <c:pt idx="339">
                  <c:v>96.448876999999982</c:v>
                </c:pt>
                <c:pt idx="340">
                  <c:v>96.480018000000001</c:v>
                </c:pt>
                <c:pt idx="341">
                  <c:v>96.503380999999976</c:v>
                </c:pt>
                <c:pt idx="342">
                  <c:v>96.517540999999994</c:v>
                </c:pt>
                <c:pt idx="343">
                  <c:v>96.522847999999911</c:v>
                </c:pt>
                <c:pt idx="344">
                  <c:v>96.517016999999996</c:v>
                </c:pt>
                <c:pt idx="345">
                  <c:v>96.500821000000002</c:v>
                </c:pt>
                <c:pt idx="346">
                  <c:v>96.481266000000005</c:v>
                </c:pt>
                <c:pt idx="347">
                  <c:v>96.465934000000004</c:v>
                </c:pt>
                <c:pt idx="348">
                  <c:v>96.45828299999998</c:v>
                </c:pt>
                <c:pt idx="349">
                  <c:v>96.457787999999979</c:v>
                </c:pt>
                <c:pt idx="350">
                  <c:v>96.461961000000002</c:v>
                </c:pt>
                <c:pt idx="351">
                  <c:v>96.468401999999998</c:v>
                </c:pt>
                <c:pt idx="352">
                  <c:v>96.474575000000002</c:v>
                </c:pt>
                <c:pt idx="353">
                  <c:v>96.476669000000001</c:v>
                </c:pt>
                <c:pt idx="354">
                  <c:v>96.471270000000004</c:v>
                </c:pt>
                <c:pt idx="355">
                  <c:v>96.457756000000003</c:v>
                </c:pt>
                <c:pt idx="356">
                  <c:v>96.434299999999993</c:v>
                </c:pt>
                <c:pt idx="357">
                  <c:v>96.38861</c:v>
                </c:pt>
                <c:pt idx="358">
                  <c:v>96.302880999999928</c:v>
                </c:pt>
                <c:pt idx="359">
                  <c:v>96.183386999999911</c:v>
                </c:pt>
                <c:pt idx="360">
                  <c:v>96.073621000000003</c:v>
                </c:pt>
                <c:pt idx="361">
                  <c:v>96.014075000000005</c:v>
                </c:pt>
                <c:pt idx="362">
                  <c:v>96.002253999999994</c:v>
                </c:pt>
                <c:pt idx="363">
                  <c:v>96.012585000000001</c:v>
                </c:pt>
                <c:pt idx="364">
                  <c:v>96.031007000000002</c:v>
                </c:pt>
                <c:pt idx="365">
                  <c:v>96.052286999999978</c:v>
                </c:pt>
                <c:pt idx="366">
                  <c:v>96.069252000000006</c:v>
                </c:pt>
                <c:pt idx="367">
                  <c:v>96.079063000000005</c:v>
                </c:pt>
                <c:pt idx="368">
                  <c:v>96.084871999999976</c:v>
                </c:pt>
                <c:pt idx="369">
                  <c:v>96.082953000000003</c:v>
                </c:pt>
                <c:pt idx="370">
                  <c:v>96.061623999999995</c:v>
                </c:pt>
                <c:pt idx="371">
                  <c:v>96.019774999999981</c:v>
                </c:pt>
                <c:pt idx="372">
                  <c:v>95.969595999999996</c:v>
                </c:pt>
                <c:pt idx="373">
                  <c:v>95.920232999999982</c:v>
                </c:pt>
                <c:pt idx="374">
                  <c:v>95.870710999999929</c:v>
                </c:pt>
                <c:pt idx="375">
                  <c:v>95.810806999999983</c:v>
                </c:pt>
                <c:pt idx="376">
                  <c:v>95.737072999999981</c:v>
                </c:pt>
                <c:pt idx="377">
                  <c:v>95.679494999999946</c:v>
                </c:pt>
                <c:pt idx="378">
                  <c:v>95.681601999999998</c:v>
                </c:pt>
                <c:pt idx="379">
                  <c:v>95.747291000000004</c:v>
                </c:pt>
                <c:pt idx="380">
                  <c:v>95.839956999999998</c:v>
                </c:pt>
                <c:pt idx="381">
                  <c:v>95.923169000000001</c:v>
                </c:pt>
                <c:pt idx="382">
                  <c:v>95.97319899999998</c:v>
                </c:pt>
                <c:pt idx="383">
                  <c:v>95.980592999999999</c:v>
                </c:pt>
                <c:pt idx="384">
                  <c:v>95.965280000000007</c:v>
                </c:pt>
                <c:pt idx="385">
                  <c:v>95.95473699999998</c:v>
                </c:pt>
                <c:pt idx="386">
                  <c:v>95.944937999999993</c:v>
                </c:pt>
                <c:pt idx="387">
                  <c:v>95.918327000000005</c:v>
                </c:pt>
                <c:pt idx="388">
                  <c:v>95.876716999999928</c:v>
                </c:pt>
                <c:pt idx="389">
                  <c:v>95.832389999999975</c:v>
                </c:pt>
                <c:pt idx="390">
                  <c:v>95.795850000000002</c:v>
                </c:pt>
                <c:pt idx="391">
                  <c:v>95.769784999999999</c:v>
                </c:pt>
                <c:pt idx="392">
                  <c:v>95.744026000000005</c:v>
                </c:pt>
                <c:pt idx="393">
                  <c:v>95.710424000000003</c:v>
                </c:pt>
                <c:pt idx="394">
                  <c:v>95.670472999999873</c:v>
                </c:pt>
                <c:pt idx="395">
                  <c:v>95.624833999999979</c:v>
                </c:pt>
                <c:pt idx="396">
                  <c:v>95.581577999999979</c:v>
                </c:pt>
                <c:pt idx="397">
                  <c:v>95.565796999999975</c:v>
                </c:pt>
                <c:pt idx="398">
                  <c:v>95.584615999999997</c:v>
                </c:pt>
                <c:pt idx="399">
                  <c:v>95.605399999999946</c:v>
                </c:pt>
                <c:pt idx="400">
                  <c:v>95.612985999999978</c:v>
                </c:pt>
                <c:pt idx="401">
                  <c:v>95.635190999999978</c:v>
                </c:pt>
                <c:pt idx="402">
                  <c:v>95.679755999999927</c:v>
                </c:pt>
                <c:pt idx="403">
                  <c:v>95.715801999999982</c:v>
                </c:pt>
                <c:pt idx="404">
                  <c:v>95.713364999999996</c:v>
                </c:pt>
                <c:pt idx="405">
                  <c:v>95.670620999999983</c:v>
                </c:pt>
                <c:pt idx="406">
                  <c:v>95.624547999999976</c:v>
                </c:pt>
                <c:pt idx="407">
                  <c:v>95.608002999999911</c:v>
                </c:pt>
                <c:pt idx="408">
                  <c:v>95.594205000000002</c:v>
                </c:pt>
                <c:pt idx="409">
                  <c:v>95.548685000000006</c:v>
                </c:pt>
                <c:pt idx="410">
                  <c:v>95.495221999999998</c:v>
                </c:pt>
                <c:pt idx="411">
                  <c:v>95.465919</c:v>
                </c:pt>
                <c:pt idx="412">
                  <c:v>95.453908999999982</c:v>
                </c:pt>
                <c:pt idx="413">
                  <c:v>95.432407999999981</c:v>
                </c:pt>
                <c:pt idx="414">
                  <c:v>95.374364999999983</c:v>
                </c:pt>
                <c:pt idx="415">
                  <c:v>95.272850999999946</c:v>
                </c:pt>
                <c:pt idx="416">
                  <c:v>95.164644999999993</c:v>
                </c:pt>
                <c:pt idx="417">
                  <c:v>95.097806000000006</c:v>
                </c:pt>
                <c:pt idx="418">
                  <c:v>95.046569000000005</c:v>
                </c:pt>
                <c:pt idx="419">
                  <c:v>94.920719000000005</c:v>
                </c:pt>
                <c:pt idx="420">
                  <c:v>94.709130999999999</c:v>
                </c:pt>
                <c:pt idx="421">
                  <c:v>94.495474999999999</c:v>
                </c:pt>
                <c:pt idx="422">
                  <c:v>94.331327999999999</c:v>
                </c:pt>
                <c:pt idx="423">
                  <c:v>94.237198000000006</c:v>
                </c:pt>
                <c:pt idx="424">
                  <c:v>94.278371999999891</c:v>
                </c:pt>
                <c:pt idx="425">
                  <c:v>94.505697999999981</c:v>
                </c:pt>
                <c:pt idx="426">
                  <c:v>94.846602000000004</c:v>
                </c:pt>
                <c:pt idx="427">
                  <c:v>95.154921999999999</c:v>
                </c:pt>
                <c:pt idx="428">
                  <c:v>95.367311999999998</c:v>
                </c:pt>
                <c:pt idx="429">
                  <c:v>95.533043000000006</c:v>
                </c:pt>
                <c:pt idx="430">
                  <c:v>95.710144</c:v>
                </c:pt>
                <c:pt idx="431">
                  <c:v>95.907677000000007</c:v>
                </c:pt>
                <c:pt idx="432">
                  <c:v>96.107405</c:v>
                </c:pt>
                <c:pt idx="433">
                  <c:v>96.295840999999982</c:v>
                </c:pt>
                <c:pt idx="434">
                  <c:v>96.463413000000003</c:v>
                </c:pt>
                <c:pt idx="435">
                  <c:v>96.593005000000005</c:v>
                </c:pt>
                <c:pt idx="436">
                  <c:v>96.687450999999982</c:v>
                </c:pt>
                <c:pt idx="437">
                  <c:v>96.800815</c:v>
                </c:pt>
                <c:pt idx="438">
                  <c:v>96.980029000000002</c:v>
                </c:pt>
                <c:pt idx="439">
                  <c:v>97.185302999999891</c:v>
                </c:pt>
                <c:pt idx="440">
                  <c:v>97.343033000000005</c:v>
                </c:pt>
                <c:pt idx="441">
                  <c:v>97.459850000000003</c:v>
                </c:pt>
                <c:pt idx="442">
                  <c:v>97.611165</c:v>
                </c:pt>
                <c:pt idx="443">
                  <c:v>97.819474</c:v>
                </c:pt>
                <c:pt idx="444">
                  <c:v>97.979962999999998</c:v>
                </c:pt>
                <c:pt idx="445">
                  <c:v>97.983092999999982</c:v>
                </c:pt>
                <c:pt idx="446">
                  <c:v>97.882864999999981</c:v>
                </c:pt>
                <c:pt idx="447">
                  <c:v>97.799437999999981</c:v>
                </c:pt>
                <c:pt idx="448">
                  <c:v>97.772219000000007</c:v>
                </c:pt>
                <c:pt idx="449">
                  <c:v>97.783220999999998</c:v>
                </c:pt>
                <c:pt idx="450">
                  <c:v>97.814397999999983</c:v>
                </c:pt>
                <c:pt idx="451">
                  <c:v>97.839177999999976</c:v>
                </c:pt>
                <c:pt idx="452">
                  <c:v>97.804259999999999</c:v>
                </c:pt>
                <c:pt idx="453">
                  <c:v>97.684771999999896</c:v>
                </c:pt>
                <c:pt idx="454">
                  <c:v>97.516934000000006</c:v>
                </c:pt>
                <c:pt idx="455">
                  <c:v>97.335247999999979</c:v>
                </c:pt>
                <c:pt idx="456">
                  <c:v>97.150429999999986</c:v>
                </c:pt>
                <c:pt idx="457">
                  <c:v>96.958790999999977</c:v>
                </c:pt>
                <c:pt idx="458">
                  <c:v>96.734773000000004</c:v>
                </c:pt>
                <c:pt idx="459">
                  <c:v>96.499572999999998</c:v>
                </c:pt>
                <c:pt idx="460">
                  <c:v>96.347570000000005</c:v>
                </c:pt>
                <c:pt idx="461">
                  <c:v>96.310053999999994</c:v>
                </c:pt>
                <c:pt idx="462">
                  <c:v>96.309472999999912</c:v>
                </c:pt>
                <c:pt idx="463">
                  <c:v>96.300175999999979</c:v>
                </c:pt>
                <c:pt idx="464">
                  <c:v>96.306304999999981</c:v>
                </c:pt>
                <c:pt idx="465">
                  <c:v>96.33613099999998</c:v>
                </c:pt>
                <c:pt idx="466">
                  <c:v>96.372706999999892</c:v>
                </c:pt>
                <c:pt idx="467">
                  <c:v>96.405253000000002</c:v>
                </c:pt>
                <c:pt idx="468">
                  <c:v>96.437291000000002</c:v>
                </c:pt>
                <c:pt idx="469">
                  <c:v>96.489301999999981</c:v>
                </c:pt>
                <c:pt idx="470">
                  <c:v>96.567280999999994</c:v>
                </c:pt>
                <c:pt idx="471">
                  <c:v>96.582156999999981</c:v>
                </c:pt>
                <c:pt idx="472">
                  <c:v>96.409953000000002</c:v>
                </c:pt>
                <c:pt idx="473">
                  <c:v>96.103429000000006</c:v>
                </c:pt>
                <c:pt idx="474">
                  <c:v>95.827365999999998</c:v>
                </c:pt>
                <c:pt idx="475">
                  <c:v>95.637242000000001</c:v>
                </c:pt>
                <c:pt idx="476">
                  <c:v>95.478729999999985</c:v>
                </c:pt>
                <c:pt idx="477">
                  <c:v>95.295940000000002</c:v>
                </c:pt>
                <c:pt idx="478">
                  <c:v>95.113455999999999</c:v>
                </c:pt>
                <c:pt idx="479">
                  <c:v>95.008456999999979</c:v>
                </c:pt>
                <c:pt idx="480">
                  <c:v>94.985951</c:v>
                </c:pt>
                <c:pt idx="481">
                  <c:v>94.993257999999997</c:v>
                </c:pt>
                <c:pt idx="482">
                  <c:v>95.042995000000005</c:v>
                </c:pt>
                <c:pt idx="483">
                  <c:v>95.170764999999946</c:v>
                </c:pt>
                <c:pt idx="484">
                  <c:v>95.342931999999976</c:v>
                </c:pt>
                <c:pt idx="485">
                  <c:v>95.501722000000001</c:v>
                </c:pt>
                <c:pt idx="486">
                  <c:v>95.624817999999976</c:v>
                </c:pt>
                <c:pt idx="487">
                  <c:v>95.716673</c:v>
                </c:pt>
                <c:pt idx="488">
                  <c:v>95.78819799999998</c:v>
                </c:pt>
                <c:pt idx="489">
                  <c:v>95.845263000000003</c:v>
                </c:pt>
                <c:pt idx="490">
                  <c:v>95.883944999999983</c:v>
                </c:pt>
                <c:pt idx="491">
                  <c:v>95.900182999999998</c:v>
                </c:pt>
                <c:pt idx="492">
                  <c:v>95.899928000000003</c:v>
                </c:pt>
                <c:pt idx="493">
                  <c:v>95.893057999999982</c:v>
                </c:pt>
                <c:pt idx="494">
                  <c:v>95.884234000000006</c:v>
                </c:pt>
                <c:pt idx="495">
                  <c:v>95.875120999999979</c:v>
                </c:pt>
                <c:pt idx="496">
                  <c:v>95.866162000000003</c:v>
                </c:pt>
                <c:pt idx="497">
                  <c:v>95.85325899999998</c:v>
                </c:pt>
                <c:pt idx="498">
                  <c:v>95.837119999999999</c:v>
                </c:pt>
                <c:pt idx="499">
                  <c:v>95.842374999999976</c:v>
                </c:pt>
                <c:pt idx="500">
                  <c:v>95.887206000000006</c:v>
                </c:pt>
                <c:pt idx="501">
                  <c:v>95.919775999999999</c:v>
                </c:pt>
                <c:pt idx="502">
                  <c:v>95.876469999999983</c:v>
                </c:pt>
                <c:pt idx="503">
                  <c:v>95.799131000000003</c:v>
                </c:pt>
                <c:pt idx="504">
                  <c:v>95.758011999999979</c:v>
                </c:pt>
                <c:pt idx="505">
                  <c:v>95.739920999999995</c:v>
                </c:pt>
                <c:pt idx="506">
                  <c:v>95.711241000000001</c:v>
                </c:pt>
                <c:pt idx="507">
                  <c:v>95.678973999999911</c:v>
                </c:pt>
                <c:pt idx="508">
                  <c:v>95.664755999999983</c:v>
                </c:pt>
                <c:pt idx="509">
                  <c:v>95.699017999999981</c:v>
                </c:pt>
                <c:pt idx="510">
                  <c:v>95.784516999999994</c:v>
                </c:pt>
                <c:pt idx="511">
                  <c:v>95.839607000000001</c:v>
                </c:pt>
                <c:pt idx="512">
                  <c:v>95.789468999999983</c:v>
                </c:pt>
                <c:pt idx="513">
                  <c:v>95.685836999999893</c:v>
                </c:pt>
                <c:pt idx="514">
                  <c:v>95.627216000000004</c:v>
                </c:pt>
                <c:pt idx="515">
                  <c:v>95.648618999999982</c:v>
                </c:pt>
                <c:pt idx="516">
                  <c:v>95.707542000000004</c:v>
                </c:pt>
                <c:pt idx="517">
                  <c:v>95.740359999999995</c:v>
                </c:pt>
                <c:pt idx="518">
                  <c:v>95.781567999999993</c:v>
                </c:pt>
                <c:pt idx="519">
                  <c:v>95.904290000000003</c:v>
                </c:pt>
                <c:pt idx="520">
                  <c:v>96.006839999999983</c:v>
                </c:pt>
                <c:pt idx="521">
                  <c:v>95.931827999999996</c:v>
                </c:pt>
                <c:pt idx="522">
                  <c:v>95.767154000000005</c:v>
                </c:pt>
                <c:pt idx="523">
                  <c:v>95.692802999999927</c:v>
                </c:pt>
                <c:pt idx="524">
                  <c:v>95.731046000000006</c:v>
                </c:pt>
                <c:pt idx="525">
                  <c:v>95.801824999999994</c:v>
                </c:pt>
                <c:pt idx="526">
                  <c:v>95.863612000000003</c:v>
                </c:pt>
                <c:pt idx="527">
                  <c:v>95.944496000000001</c:v>
                </c:pt>
                <c:pt idx="528">
                  <c:v>96.057077999999976</c:v>
                </c:pt>
                <c:pt idx="529">
                  <c:v>96.162886999999927</c:v>
                </c:pt>
                <c:pt idx="530">
                  <c:v>96.251868999999999</c:v>
                </c:pt>
                <c:pt idx="531">
                  <c:v>96.34380299999998</c:v>
                </c:pt>
                <c:pt idx="532">
                  <c:v>96.421888999999979</c:v>
                </c:pt>
                <c:pt idx="533">
                  <c:v>96.484302</c:v>
                </c:pt>
                <c:pt idx="534">
                  <c:v>96.595112999999998</c:v>
                </c:pt>
                <c:pt idx="535">
                  <c:v>96.790751</c:v>
                </c:pt>
                <c:pt idx="536">
                  <c:v>96.978736999999896</c:v>
                </c:pt>
                <c:pt idx="537">
                  <c:v>97.026083</c:v>
                </c:pt>
                <c:pt idx="538">
                  <c:v>96.957564000000005</c:v>
                </c:pt>
                <c:pt idx="539">
                  <c:v>96.904632000000007</c:v>
                </c:pt>
                <c:pt idx="540">
                  <c:v>96.937078999999983</c:v>
                </c:pt>
                <c:pt idx="541">
                  <c:v>97.051856000000001</c:v>
                </c:pt>
                <c:pt idx="542">
                  <c:v>97.191770999999946</c:v>
                </c:pt>
                <c:pt idx="543">
                  <c:v>97.286037999999976</c:v>
                </c:pt>
                <c:pt idx="544">
                  <c:v>97.303330999999929</c:v>
                </c:pt>
                <c:pt idx="545">
                  <c:v>97.225374999999929</c:v>
                </c:pt>
                <c:pt idx="546">
                  <c:v>97.077701999999945</c:v>
                </c:pt>
                <c:pt idx="547">
                  <c:v>96.934442000000004</c:v>
                </c:pt>
                <c:pt idx="548">
                  <c:v>96.814966999999996</c:v>
                </c:pt>
                <c:pt idx="549">
                  <c:v>96.697727</c:v>
                </c:pt>
                <c:pt idx="550">
                  <c:v>96.594256999999999</c:v>
                </c:pt>
                <c:pt idx="551">
                  <c:v>96.52909099999998</c:v>
                </c:pt>
                <c:pt idx="552">
                  <c:v>96.490969000000007</c:v>
                </c:pt>
                <c:pt idx="553">
                  <c:v>96.404329000000004</c:v>
                </c:pt>
                <c:pt idx="554">
                  <c:v>96.184414000000004</c:v>
                </c:pt>
                <c:pt idx="555">
                  <c:v>95.858013999999983</c:v>
                </c:pt>
                <c:pt idx="556">
                  <c:v>95.526854999999998</c:v>
                </c:pt>
                <c:pt idx="557">
                  <c:v>95.235197999999983</c:v>
                </c:pt>
                <c:pt idx="558">
                  <c:v>94.973010000000002</c:v>
                </c:pt>
                <c:pt idx="559">
                  <c:v>94.745728</c:v>
                </c:pt>
                <c:pt idx="560">
                  <c:v>94.585171999999929</c:v>
                </c:pt>
                <c:pt idx="561">
                  <c:v>94.495023000000003</c:v>
                </c:pt>
                <c:pt idx="562">
                  <c:v>94.406092999999998</c:v>
                </c:pt>
                <c:pt idx="563">
                  <c:v>94.278467999999975</c:v>
                </c:pt>
                <c:pt idx="564">
                  <c:v>94.19958699999998</c:v>
                </c:pt>
                <c:pt idx="565">
                  <c:v>94.256561000000005</c:v>
                </c:pt>
                <c:pt idx="566">
                  <c:v>94.444001999999998</c:v>
                </c:pt>
                <c:pt idx="567">
                  <c:v>94.743157999999994</c:v>
                </c:pt>
                <c:pt idx="568">
                  <c:v>95.159078999999892</c:v>
                </c:pt>
                <c:pt idx="569">
                  <c:v>95.677441999999928</c:v>
                </c:pt>
                <c:pt idx="570">
                  <c:v>96.242704000000003</c:v>
                </c:pt>
                <c:pt idx="571">
                  <c:v>96.772514000000001</c:v>
                </c:pt>
                <c:pt idx="572">
                  <c:v>97.218311</c:v>
                </c:pt>
                <c:pt idx="573">
                  <c:v>97.593508999999983</c:v>
                </c:pt>
                <c:pt idx="574">
                  <c:v>97.914681000000002</c:v>
                </c:pt>
                <c:pt idx="575">
                  <c:v>98.177117999999979</c:v>
                </c:pt>
                <c:pt idx="576">
                  <c:v>98.375141999999911</c:v>
                </c:pt>
                <c:pt idx="577">
                  <c:v>98.506665999999996</c:v>
                </c:pt>
                <c:pt idx="578">
                  <c:v>98.595434999999981</c:v>
                </c:pt>
                <c:pt idx="579">
                  <c:v>98.684130999999979</c:v>
                </c:pt>
                <c:pt idx="580">
                  <c:v>98.788451999999978</c:v>
                </c:pt>
                <c:pt idx="581">
                  <c:v>98.888784999999928</c:v>
                </c:pt>
                <c:pt idx="582">
                  <c:v>98.942064000000002</c:v>
                </c:pt>
                <c:pt idx="583">
                  <c:v>98.926487999999978</c:v>
                </c:pt>
                <c:pt idx="584">
                  <c:v>98.888067999999976</c:v>
                </c:pt>
                <c:pt idx="585">
                  <c:v>98.881833999999998</c:v>
                </c:pt>
                <c:pt idx="586">
                  <c:v>98.907308</c:v>
                </c:pt>
                <c:pt idx="587">
                  <c:v>98.939657999999994</c:v>
                </c:pt>
                <c:pt idx="588">
                  <c:v>98.965935000000002</c:v>
                </c:pt>
                <c:pt idx="589">
                  <c:v>98.985436999999976</c:v>
                </c:pt>
                <c:pt idx="590">
                  <c:v>99.016171999999983</c:v>
                </c:pt>
                <c:pt idx="591">
                  <c:v>99.075217999999978</c:v>
                </c:pt>
                <c:pt idx="592">
                  <c:v>99.132332999999875</c:v>
                </c:pt>
                <c:pt idx="593">
                  <c:v>99.140970999999979</c:v>
                </c:pt>
                <c:pt idx="594">
                  <c:v>99.116365999999999</c:v>
                </c:pt>
                <c:pt idx="595">
                  <c:v>99.10806599999998</c:v>
                </c:pt>
                <c:pt idx="596">
                  <c:v>99.12217399999993</c:v>
                </c:pt>
                <c:pt idx="597">
                  <c:v>99.130228000000002</c:v>
                </c:pt>
                <c:pt idx="598">
                  <c:v>99.121932999999927</c:v>
                </c:pt>
                <c:pt idx="599">
                  <c:v>99.112997999999976</c:v>
                </c:pt>
                <c:pt idx="600">
                  <c:v>99.117350000000002</c:v>
                </c:pt>
                <c:pt idx="601">
                  <c:v>99.130397999999929</c:v>
                </c:pt>
                <c:pt idx="602">
                  <c:v>99.137880999999979</c:v>
                </c:pt>
                <c:pt idx="603">
                  <c:v>99.135530999999929</c:v>
                </c:pt>
                <c:pt idx="604">
                  <c:v>99.131890999999982</c:v>
                </c:pt>
                <c:pt idx="605">
                  <c:v>99.132383999999931</c:v>
                </c:pt>
                <c:pt idx="606">
                  <c:v>99.135649999999998</c:v>
                </c:pt>
                <c:pt idx="607">
                  <c:v>99.145625999999993</c:v>
                </c:pt>
                <c:pt idx="608">
                  <c:v>99.167494000000005</c:v>
                </c:pt>
                <c:pt idx="609">
                  <c:v>99.193281999999982</c:v>
                </c:pt>
                <c:pt idx="610">
                  <c:v>99.213449999999995</c:v>
                </c:pt>
                <c:pt idx="611">
                  <c:v>99.226769000000004</c:v>
                </c:pt>
                <c:pt idx="612">
                  <c:v>99.22430199999998</c:v>
                </c:pt>
                <c:pt idx="613">
                  <c:v>99.201498000000001</c:v>
                </c:pt>
                <c:pt idx="614">
                  <c:v>99.178129999999982</c:v>
                </c:pt>
                <c:pt idx="615">
                  <c:v>99.169663</c:v>
                </c:pt>
                <c:pt idx="616">
                  <c:v>99.172815999999912</c:v>
                </c:pt>
                <c:pt idx="617">
                  <c:v>99.193993000000006</c:v>
                </c:pt>
                <c:pt idx="618">
                  <c:v>99.23983699999998</c:v>
                </c:pt>
                <c:pt idx="619">
                  <c:v>99.277023999999997</c:v>
                </c:pt>
                <c:pt idx="620">
                  <c:v>99.265315999999999</c:v>
                </c:pt>
                <c:pt idx="621">
                  <c:v>99.221383000000003</c:v>
                </c:pt>
                <c:pt idx="622">
                  <c:v>99.187167000000002</c:v>
                </c:pt>
                <c:pt idx="623">
                  <c:v>99.173123000000004</c:v>
                </c:pt>
                <c:pt idx="624">
                  <c:v>99.169536999999977</c:v>
                </c:pt>
                <c:pt idx="625">
                  <c:v>99.170213000000004</c:v>
                </c:pt>
                <c:pt idx="626">
                  <c:v>99.172207999999927</c:v>
                </c:pt>
                <c:pt idx="627">
                  <c:v>99.172988999999873</c:v>
                </c:pt>
                <c:pt idx="628">
                  <c:v>99.172756999999876</c:v>
                </c:pt>
                <c:pt idx="629">
                  <c:v>99.178298999999896</c:v>
                </c:pt>
                <c:pt idx="630">
                  <c:v>99.198970999999929</c:v>
                </c:pt>
                <c:pt idx="631">
                  <c:v>99.228910999999982</c:v>
                </c:pt>
                <c:pt idx="632">
                  <c:v>99.241359000000003</c:v>
                </c:pt>
                <c:pt idx="633">
                  <c:v>99.221834000000001</c:v>
                </c:pt>
                <c:pt idx="634">
                  <c:v>99.191237999999998</c:v>
                </c:pt>
                <c:pt idx="635">
                  <c:v>99.173533999999975</c:v>
                </c:pt>
                <c:pt idx="636">
                  <c:v>99.168323000000001</c:v>
                </c:pt>
                <c:pt idx="637">
                  <c:v>99.166371999999896</c:v>
                </c:pt>
                <c:pt idx="638">
                  <c:v>99.164977999999977</c:v>
                </c:pt>
                <c:pt idx="639">
                  <c:v>99.164623000000006</c:v>
                </c:pt>
                <c:pt idx="640">
                  <c:v>99.166690000000003</c:v>
                </c:pt>
                <c:pt idx="641">
                  <c:v>99.174440999999931</c:v>
                </c:pt>
                <c:pt idx="642">
                  <c:v>99.18500599999993</c:v>
                </c:pt>
                <c:pt idx="643">
                  <c:v>99.187011999999982</c:v>
                </c:pt>
                <c:pt idx="644">
                  <c:v>99.178210999999976</c:v>
                </c:pt>
                <c:pt idx="645">
                  <c:v>99.168646999999979</c:v>
                </c:pt>
                <c:pt idx="646">
                  <c:v>99.162032999999894</c:v>
                </c:pt>
                <c:pt idx="647">
                  <c:v>99.155473999999927</c:v>
                </c:pt>
                <c:pt idx="648">
                  <c:v>99.149987999999979</c:v>
                </c:pt>
                <c:pt idx="649">
                  <c:v>99.147470999999982</c:v>
                </c:pt>
                <c:pt idx="650">
                  <c:v>99.147700999999998</c:v>
                </c:pt>
                <c:pt idx="651">
                  <c:v>99.150687999999946</c:v>
                </c:pt>
                <c:pt idx="652">
                  <c:v>99.155046999999911</c:v>
                </c:pt>
                <c:pt idx="653">
                  <c:v>99.156372999999874</c:v>
                </c:pt>
                <c:pt idx="654">
                  <c:v>99.152918999999912</c:v>
                </c:pt>
                <c:pt idx="655">
                  <c:v>99.152644999999978</c:v>
                </c:pt>
                <c:pt idx="656">
                  <c:v>99.164812999999981</c:v>
                </c:pt>
                <c:pt idx="657">
                  <c:v>99.180887999999896</c:v>
                </c:pt>
                <c:pt idx="658">
                  <c:v>99.182665999999998</c:v>
                </c:pt>
                <c:pt idx="659">
                  <c:v>99.17042799999993</c:v>
                </c:pt>
                <c:pt idx="660">
                  <c:v>99.156730999999894</c:v>
                </c:pt>
                <c:pt idx="661">
                  <c:v>99.144685999999993</c:v>
                </c:pt>
                <c:pt idx="662">
                  <c:v>99.133763999999999</c:v>
                </c:pt>
                <c:pt idx="663">
                  <c:v>99.126806999999928</c:v>
                </c:pt>
                <c:pt idx="664">
                  <c:v>99.124035999999975</c:v>
                </c:pt>
                <c:pt idx="665">
                  <c:v>99.122918999999897</c:v>
                </c:pt>
                <c:pt idx="666">
                  <c:v>99.121980999999977</c:v>
                </c:pt>
                <c:pt idx="667">
                  <c:v>99.121999999999986</c:v>
                </c:pt>
                <c:pt idx="668">
                  <c:v>99.126345999999927</c:v>
                </c:pt>
                <c:pt idx="669">
                  <c:v>99.136329000000003</c:v>
                </c:pt>
                <c:pt idx="670">
                  <c:v>99.144047</c:v>
                </c:pt>
                <c:pt idx="671">
                  <c:v>99.140394000000001</c:v>
                </c:pt>
                <c:pt idx="672">
                  <c:v>99.129532999999896</c:v>
                </c:pt>
                <c:pt idx="673">
                  <c:v>99.121809999999982</c:v>
                </c:pt>
                <c:pt idx="674">
                  <c:v>99.11971699999998</c:v>
                </c:pt>
                <c:pt idx="675">
                  <c:v>99.120297999999977</c:v>
                </c:pt>
                <c:pt idx="676">
                  <c:v>99.121520000000004</c:v>
                </c:pt>
                <c:pt idx="677">
                  <c:v>99.122477999999859</c:v>
                </c:pt>
                <c:pt idx="678">
                  <c:v>99.122993999999977</c:v>
                </c:pt>
                <c:pt idx="679">
                  <c:v>99.123449999999977</c:v>
                </c:pt>
                <c:pt idx="680">
                  <c:v>99.124114000000006</c:v>
                </c:pt>
                <c:pt idx="681">
                  <c:v>99.126013999999998</c:v>
                </c:pt>
                <c:pt idx="682">
                  <c:v>99.129604999999998</c:v>
                </c:pt>
                <c:pt idx="683">
                  <c:v>99.131716999999981</c:v>
                </c:pt>
                <c:pt idx="684">
                  <c:v>99.129615000000001</c:v>
                </c:pt>
                <c:pt idx="685">
                  <c:v>99.125794999999911</c:v>
                </c:pt>
                <c:pt idx="686">
                  <c:v>99.123609000000002</c:v>
                </c:pt>
                <c:pt idx="687">
                  <c:v>99.123424</c:v>
                </c:pt>
                <c:pt idx="688">
                  <c:v>99.124775999999912</c:v>
                </c:pt>
                <c:pt idx="689">
                  <c:v>99.126879999999929</c:v>
                </c:pt>
                <c:pt idx="690">
                  <c:v>99.127838999999895</c:v>
                </c:pt>
                <c:pt idx="691">
                  <c:v>99.127144000000001</c:v>
                </c:pt>
                <c:pt idx="692">
                  <c:v>99.127237999999977</c:v>
                </c:pt>
                <c:pt idx="693">
                  <c:v>99.130406999999977</c:v>
                </c:pt>
                <c:pt idx="694">
                  <c:v>99.13628199999998</c:v>
                </c:pt>
                <c:pt idx="695">
                  <c:v>99.141693000000004</c:v>
                </c:pt>
                <c:pt idx="696">
                  <c:v>99.141873000000004</c:v>
                </c:pt>
                <c:pt idx="697">
                  <c:v>99.13615799999998</c:v>
                </c:pt>
                <c:pt idx="698">
                  <c:v>99.13003699999993</c:v>
                </c:pt>
                <c:pt idx="699">
                  <c:v>99.127264999999994</c:v>
                </c:pt>
                <c:pt idx="700">
                  <c:v>99.126215000000002</c:v>
                </c:pt>
                <c:pt idx="701">
                  <c:v>99.125141999999911</c:v>
                </c:pt>
                <c:pt idx="702">
                  <c:v>99.124510000000001</c:v>
                </c:pt>
                <c:pt idx="703">
                  <c:v>99.124324999999999</c:v>
                </c:pt>
                <c:pt idx="704">
                  <c:v>99.12314499999998</c:v>
                </c:pt>
                <c:pt idx="705">
                  <c:v>99.120609999999999</c:v>
                </c:pt>
                <c:pt idx="706">
                  <c:v>99.118825000000001</c:v>
                </c:pt>
                <c:pt idx="707">
                  <c:v>99.119414000000006</c:v>
                </c:pt>
                <c:pt idx="708">
                  <c:v>99.120699000000002</c:v>
                </c:pt>
                <c:pt idx="709">
                  <c:v>99.119631999999982</c:v>
                </c:pt>
                <c:pt idx="710">
                  <c:v>99.115994000000001</c:v>
                </c:pt>
                <c:pt idx="711">
                  <c:v>99.112586999999976</c:v>
                </c:pt>
                <c:pt idx="712">
                  <c:v>99.111199999999997</c:v>
                </c:pt>
                <c:pt idx="713">
                  <c:v>99.110889999999998</c:v>
                </c:pt>
                <c:pt idx="714">
                  <c:v>99.110201000000004</c:v>
                </c:pt>
                <c:pt idx="715">
                  <c:v>99.108800999999929</c:v>
                </c:pt>
                <c:pt idx="716">
                  <c:v>99.107024999999993</c:v>
                </c:pt>
                <c:pt idx="717">
                  <c:v>99.105454999999978</c:v>
                </c:pt>
                <c:pt idx="718">
                  <c:v>99.104913999999994</c:v>
                </c:pt>
                <c:pt idx="719">
                  <c:v>99.105788999999874</c:v>
                </c:pt>
                <c:pt idx="720">
                  <c:v>99.107439999999983</c:v>
                </c:pt>
                <c:pt idx="721">
                  <c:v>99.108123000000006</c:v>
                </c:pt>
                <c:pt idx="722">
                  <c:v>99.106059999999999</c:v>
                </c:pt>
                <c:pt idx="723">
                  <c:v>99.102037999999865</c:v>
                </c:pt>
                <c:pt idx="724">
                  <c:v>99.098806999999979</c:v>
                </c:pt>
                <c:pt idx="725">
                  <c:v>99.097070000000002</c:v>
                </c:pt>
                <c:pt idx="726">
                  <c:v>99.095656000000005</c:v>
                </c:pt>
                <c:pt idx="727">
                  <c:v>99.094367000000005</c:v>
                </c:pt>
                <c:pt idx="728">
                  <c:v>99.093276000000003</c:v>
                </c:pt>
                <c:pt idx="729">
                  <c:v>99.091823000000005</c:v>
                </c:pt>
                <c:pt idx="730">
                  <c:v>99.089770999999928</c:v>
                </c:pt>
                <c:pt idx="731">
                  <c:v>99.087267999999995</c:v>
                </c:pt>
                <c:pt idx="732">
                  <c:v>99.084874999999982</c:v>
                </c:pt>
                <c:pt idx="733">
                  <c:v>99.08307199999993</c:v>
                </c:pt>
                <c:pt idx="734">
                  <c:v>99.081062000000003</c:v>
                </c:pt>
                <c:pt idx="735">
                  <c:v>99.078244999999981</c:v>
                </c:pt>
                <c:pt idx="736">
                  <c:v>99.075439999999929</c:v>
                </c:pt>
                <c:pt idx="737">
                  <c:v>99.07282799999993</c:v>
                </c:pt>
                <c:pt idx="738">
                  <c:v>99.06976299999998</c:v>
                </c:pt>
                <c:pt idx="739">
                  <c:v>99.066339999999983</c:v>
                </c:pt>
                <c:pt idx="740">
                  <c:v>99.062686999999983</c:v>
                </c:pt>
                <c:pt idx="741">
                  <c:v>99.058661999999998</c:v>
                </c:pt>
                <c:pt idx="742">
                  <c:v>99.054750999999982</c:v>
                </c:pt>
                <c:pt idx="743">
                  <c:v>99.051609999999997</c:v>
                </c:pt>
                <c:pt idx="744">
                  <c:v>99.049476999999982</c:v>
                </c:pt>
                <c:pt idx="745">
                  <c:v>99.048125999999996</c:v>
                </c:pt>
                <c:pt idx="746">
                  <c:v>99.046535000000006</c:v>
                </c:pt>
                <c:pt idx="747">
                  <c:v>99.043602000000007</c:v>
                </c:pt>
                <c:pt idx="748">
                  <c:v>99.039612000000005</c:v>
                </c:pt>
                <c:pt idx="749">
                  <c:v>99.035965000000004</c:v>
                </c:pt>
                <c:pt idx="750">
                  <c:v>99.03353199999998</c:v>
                </c:pt>
                <c:pt idx="751">
                  <c:v>99.032106999999982</c:v>
                </c:pt>
                <c:pt idx="752">
                  <c:v>99.031042999999983</c:v>
                </c:pt>
                <c:pt idx="753">
                  <c:v>99.029909000000004</c:v>
                </c:pt>
                <c:pt idx="754">
                  <c:v>99.028699999999986</c:v>
                </c:pt>
                <c:pt idx="755">
                  <c:v>99.027355</c:v>
                </c:pt>
                <c:pt idx="756">
                  <c:v>99.025622999999982</c:v>
                </c:pt>
                <c:pt idx="757">
                  <c:v>99.023755999999977</c:v>
                </c:pt>
                <c:pt idx="758">
                  <c:v>99.022141999999945</c:v>
                </c:pt>
                <c:pt idx="759">
                  <c:v>99.020491999999976</c:v>
                </c:pt>
                <c:pt idx="760">
                  <c:v>99.018630999999999</c:v>
                </c:pt>
                <c:pt idx="761">
                  <c:v>99.017055999999997</c:v>
                </c:pt>
                <c:pt idx="762">
                  <c:v>99.016058999999998</c:v>
                </c:pt>
                <c:pt idx="763">
                  <c:v>99.01537399999998</c:v>
                </c:pt>
                <c:pt idx="764">
                  <c:v>99.014672000000004</c:v>
                </c:pt>
                <c:pt idx="765">
                  <c:v>99.013859999999994</c:v>
                </c:pt>
                <c:pt idx="766">
                  <c:v>99.013105999999993</c:v>
                </c:pt>
                <c:pt idx="767">
                  <c:v>99.012470999999977</c:v>
                </c:pt>
                <c:pt idx="768">
                  <c:v>99.011628000000002</c:v>
                </c:pt>
                <c:pt idx="769">
                  <c:v>99.01034199999998</c:v>
                </c:pt>
                <c:pt idx="770">
                  <c:v>99.008989</c:v>
                </c:pt>
                <c:pt idx="771">
                  <c:v>99.007928000000007</c:v>
                </c:pt>
                <c:pt idx="772">
                  <c:v>99.006827999999999</c:v>
                </c:pt>
                <c:pt idx="773">
                  <c:v>99.005472999999895</c:v>
                </c:pt>
                <c:pt idx="774">
                  <c:v>99.004310000000004</c:v>
                </c:pt>
                <c:pt idx="775">
                  <c:v>99.003541999999982</c:v>
                </c:pt>
                <c:pt idx="776">
                  <c:v>99.00279699999993</c:v>
                </c:pt>
                <c:pt idx="777">
                  <c:v>99.001902999999999</c:v>
                </c:pt>
                <c:pt idx="778">
                  <c:v>99.001126999999997</c:v>
                </c:pt>
                <c:pt idx="779">
                  <c:v>99.000547999999981</c:v>
                </c:pt>
                <c:pt idx="780">
                  <c:v>98.999944999999997</c:v>
                </c:pt>
                <c:pt idx="781">
                  <c:v>98.999441000000004</c:v>
                </c:pt>
                <c:pt idx="782">
                  <c:v>98.999350000000007</c:v>
                </c:pt>
                <c:pt idx="783">
                  <c:v>98.999301000000003</c:v>
                </c:pt>
                <c:pt idx="784">
                  <c:v>98.998427000000007</c:v>
                </c:pt>
                <c:pt idx="785">
                  <c:v>98.996415999999996</c:v>
                </c:pt>
                <c:pt idx="786">
                  <c:v>98.993936000000005</c:v>
                </c:pt>
                <c:pt idx="787">
                  <c:v>98.991966000000005</c:v>
                </c:pt>
                <c:pt idx="788">
                  <c:v>98.990716000000006</c:v>
                </c:pt>
                <c:pt idx="789">
                  <c:v>98.989628999999994</c:v>
                </c:pt>
                <c:pt idx="790">
                  <c:v>98.988522000000003</c:v>
                </c:pt>
                <c:pt idx="791">
                  <c:v>98.987799999999993</c:v>
                </c:pt>
                <c:pt idx="792">
                  <c:v>98.987554000000003</c:v>
                </c:pt>
                <c:pt idx="793">
                  <c:v>98.987561999999997</c:v>
                </c:pt>
                <c:pt idx="794">
                  <c:v>98.987620000000007</c:v>
                </c:pt>
                <c:pt idx="795">
                  <c:v>98.987412000000006</c:v>
                </c:pt>
                <c:pt idx="796">
                  <c:v>98.987129999999993</c:v>
                </c:pt>
                <c:pt idx="797">
                  <c:v>98.987444999999994</c:v>
                </c:pt>
                <c:pt idx="798">
                  <c:v>98.988331999999929</c:v>
                </c:pt>
                <c:pt idx="799">
                  <c:v>98.989226000000002</c:v>
                </c:pt>
                <c:pt idx="800">
                  <c:v>98.989824999999996</c:v>
                </c:pt>
                <c:pt idx="801">
                  <c:v>98.990043</c:v>
                </c:pt>
                <c:pt idx="802">
                  <c:v>98.990081000000004</c:v>
                </c:pt>
                <c:pt idx="803">
                  <c:v>98.990314999999995</c:v>
                </c:pt>
                <c:pt idx="804">
                  <c:v>98.990803999999997</c:v>
                </c:pt>
                <c:pt idx="805">
                  <c:v>98.991440999999995</c:v>
                </c:pt>
                <c:pt idx="806">
                  <c:v>98.992158000000003</c:v>
                </c:pt>
                <c:pt idx="807">
                  <c:v>98.992637000000002</c:v>
                </c:pt>
                <c:pt idx="808">
                  <c:v>98.992597000000004</c:v>
                </c:pt>
                <c:pt idx="809">
                  <c:v>98.992234999999994</c:v>
                </c:pt>
                <c:pt idx="810">
                  <c:v>98.991871000000003</c:v>
                </c:pt>
                <c:pt idx="811">
                  <c:v>98.991709999999998</c:v>
                </c:pt>
                <c:pt idx="812">
                  <c:v>98.992052999999999</c:v>
                </c:pt>
                <c:pt idx="813">
                  <c:v>98.993030000000005</c:v>
                </c:pt>
                <c:pt idx="814">
                  <c:v>98.994163</c:v>
                </c:pt>
                <c:pt idx="815">
                  <c:v>98.994640000000004</c:v>
                </c:pt>
                <c:pt idx="816">
                  <c:v>98.994229000000004</c:v>
                </c:pt>
                <c:pt idx="817">
                  <c:v>98.993717000000004</c:v>
                </c:pt>
                <c:pt idx="818">
                  <c:v>98.993869000000004</c:v>
                </c:pt>
                <c:pt idx="819">
                  <c:v>98.994410999999999</c:v>
                </c:pt>
                <c:pt idx="820">
                  <c:v>98.99504899999998</c:v>
                </c:pt>
                <c:pt idx="821">
                  <c:v>98.996221000000006</c:v>
                </c:pt>
                <c:pt idx="822">
                  <c:v>98.997934999999998</c:v>
                </c:pt>
                <c:pt idx="823">
                  <c:v>98.999770999999981</c:v>
                </c:pt>
                <c:pt idx="824">
                  <c:v>99.001867000000004</c:v>
                </c:pt>
                <c:pt idx="825">
                  <c:v>99.003921000000005</c:v>
                </c:pt>
                <c:pt idx="826">
                  <c:v>99.004988999999981</c:v>
                </c:pt>
                <c:pt idx="827">
                  <c:v>99.005305999999976</c:v>
                </c:pt>
                <c:pt idx="828">
                  <c:v>99.005769000000001</c:v>
                </c:pt>
                <c:pt idx="829">
                  <c:v>99.006219000000002</c:v>
                </c:pt>
                <c:pt idx="830">
                  <c:v>99.006412999999981</c:v>
                </c:pt>
                <c:pt idx="831">
                  <c:v>99.006934999999999</c:v>
                </c:pt>
                <c:pt idx="832">
                  <c:v>99.007990000000007</c:v>
                </c:pt>
                <c:pt idx="833">
                  <c:v>99.008840999999975</c:v>
                </c:pt>
                <c:pt idx="834">
                  <c:v>99.008787999999896</c:v>
                </c:pt>
                <c:pt idx="835">
                  <c:v>99.007837999999978</c:v>
                </c:pt>
                <c:pt idx="836">
                  <c:v>99.006469999999993</c:v>
                </c:pt>
                <c:pt idx="837">
                  <c:v>99.005185999999981</c:v>
                </c:pt>
                <c:pt idx="838">
                  <c:v>99.004230000000007</c:v>
                </c:pt>
                <c:pt idx="839">
                  <c:v>99.003334999999979</c:v>
                </c:pt>
                <c:pt idx="840">
                  <c:v>99.002030999999945</c:v>
                </c:pt>
                <c:pt idx="841">
                  <c:v>99.000366</c:v>
                </c:pt>
                <c:pt idx="842">
                  <c:v>98.998551000000006</c:v>
                </c:pt>
                <c:pt idx="843">
                  <c:v>98.996492000000003</c:v>
                </c:pt>
                <c:pt idx="844">
                  <c:v>98.994366999999997</c:v>
                </c:pt>
                <c:pt idx="845">
                  <c:v>98.992453999999995</c:v>
                </c:pt>
                <c:pt idx="846">
                  <c:v>98.990780000000001</c:v>
                </c:pt>
                <c:pt idx="847">
                  <c:v>98.989581000000001</c:v>
                </c:pt>
                <c:pt idx="848">
                  <c:v>98.988894999999999</c:v>
                </c:pt>
                <c:pt idx="849">
                  <c:v>98.988146</c:v>
                </c:pt>
                <c:pt idx="850">
                  <c:v>98.987065999999999</c:v>
                </c:pt>
                <c:pt idx="851">
                  <c:v>98.986181000000002</c:v>
                </c:pt>
                <c:pt idx="852">
                  <c:v>98.986192000000003</c:v>
                </c:pt>
                <c:pt idx="853">
                  <c:v>98.987351000000004</c:v>
                </c:pt>
                <c:pt idx="854">
                  <c:v>98.989457999999999</c:v>
                </c:pt>
                <c:pt idx="855">
                  <c:v>98.992231000000004</c:v>
                </c:pt>
                <c:pt idx="856">
                  <c:v>98.995298000000005</c:v>
                </c:pt>
                <c:pt idx="857">
                  <c:v>98.998529000000005</c:v>
                </c:pt>
                <c:pt idx="858">
                  <c:v>99.002978999999911</c:v>
                </c:pt>
                <c:pt idx="859">
                  <c:v>99.009910000000005</c:v>
                </c:pt>
                <c:pt idx="860">
                  <c:v>99.018958999999981</c:v>
                </c:pt>
                <c:pt idx="861">
                  <c:v>99.029358999999928</c:v>
                </c:pt>
                <c:pt idx="862">
                  <c:v>99.041820999999999</c:v>
                </c:pt>
                <c:pt idx="863">
                  <c:v>99.057514999999995</c:v>
                </c:pt>
                <c:pt idx="864">
                  <c:v>99.076600999999982</c:v>
                </c:pt>
                <c:pt idx="865">
                  <c:v>99.098174999999998</c:v>
                </c:pt>
                <c:pt idx="866">
                  <c:v>99.120958999999928</c:v>
                </c:pt>
                <c:pt idx="867">
                  <c:v>99.144227999999998</c:v>
                </c:pt>
                <c:pt idx="868">
                  <c:v>99.168000999999975</c:v>
                </c:pt>
                <c:pt idx="869">
                  <c:v>99.192266000000004</c:v>
                </c:pt>
                <c:pt idx="870">
                  <c:v>99.216185999999993</c:v>
                </c:pt>
                <c:pt idx="871">
                  <c:v>99.237635999999995</c:v>
                </c:pt>
                <c:pt idx="872">
                  <c:v>99.253810000000001</c:v>
                </c:pt>
                <c:pt idx="873">
                  <c:v>99.263339000000002</c:v>
                </c:pt>
                <c:pt idx="874">
                  <c:v>99.266941000000003</c:v>
                </c:pt>
                <c:pt idx="875">
                  <c:v>99.264739000000006</c:v>
                </c:pt>
                <c:pt idx="876">
                  <c:v>99.254009999999994</c:v>
                </c:pt>
                <c:pt idx="877">
                  <c:v>99.230458999999982</c:v>
                </c:pt>
                <c:pt idx="878">
                  <c:v>99.191125999999997</c:v>
                </c:pt>
                <c:pt idx="879">
                  <c:v>99.139107999999979</c:v>
                </c:pt>
                <c:pt idx="880">
                  <c:v>99.091286999999994</c:v>
                </c:pt>
                <c:pt idx="881">
                  <c:v>99.075603000000001</c:v>
                </c:pt>
                <c:pt idx="882">
                  <c:v>99.107975999999979</c:v>
                </c:pt>
                <c:pt idx="883">
                  <c:v>99.175802999999874</c:v>
                </c:pt>
                <c:pt idx="884">
                  <c:v>99.252030000000005</c:v>
                </c:pt>
                <c:pt idx="885">
                  <c:v>99.317021999999994</c:v>
                </c:pt>
                <c:pt idx="886">
                  <c:v>99.362679999999983</c:v>
                </c:pt>
                <c:pt idx="887">
                  <c:v>99.386165000000005</c:v>
                </c:pt>
                <c:pt idx="888">
                  <c:v>99.386120000000005</c:v>
                </c:pt>
                <c:pt idx="889">
                  <c:v>99.36333699999993</c:v>
                </c:pt>
                <c:pt idx="890">
                  <c:v>99.322041999999911</c:v>
                </c:pt>
                <c:pt idx="891">
                  <c:v>99.268287000000001</c:v>
                </c:pt>
                <c:pt idx="892">
                  <c:v>99.207910999999996</c:v>
                </c:pt>
                <c:pt idx="893">
                  <c:v>99.146493000000007</c:v>
                </c:pt>
                <c:pt idx="894">
                  <c:v>99.089213000000001</c:v>
                </c:pt>
                <c:pt idx="895">
                  <c:v>99.0398</c:v>
                </c:pt>
                <c:pt idx="896">
                  <c:v>99.000101999999998</c:v>
                </c:pt>
                <c:pt idx="897">
                  <c:v>98.970629000000002</c:v>
                </c:pt>
                <c:pt idx="898">
                  <c:v>98.950741999999977</c:v>
                </c:pt>
                <c:pt idx="899">
                  <c:v>98.938169000000002</c:v>
                </c:pt>
                <c:pt idx="900">
                  <c:v>98.929956000000004</c:v>
                </c:pt>
                <c:pt idx="901">
                  <c:v>98.924322000000004</c:v>
                </c:pt>
                <c:pt idx="902">
                  <c:v>98.920567000000005</c:v>
                </c:pt>
                <c:pt idx="903">
                  <c:v>98.918094999999994</c:v>
                </c:pt>
                <c:pt idx="904">
                  <c:v>98.916337999999982</c:v>
                </c:pt>
                <c:pt idx="905">
                  <c:v>98.914908999999994</c:v>
                </c:pt>
                <c:pt idx="906">
                  <c:v>98.913548000000006</c:v>
                </c:pt>
                <c:pt idx="907">
                  <c:v>98.911810000000003</c:v>
                </c:pt>
                <c:pt idx="908">
                  <c:v>98.909295</c:v>
                </c:pt>
                <c:pt idx="909">
                  <c:v>98.906531000000001</c:v>
                </c:pt>
                <c:pt idx="910">
                  <c:v>98.904323000000005</c:v>
                </c:pt>
                <c:pt idx="911">
                  <c:v>98.90236299999998</c:v>
                </c:pt>
                <c:pt idx="912">
                  <c:v>98.899930000000012</c:v>
                </c:pt>
                <c:pt idx="913">
                  <c:v>98.897068000000004</c:v>
                </c:pt>
                <c:pt idx="914">
                  <c:v>98.894254000000004</c:v>
                </c:pt>
                <c:pt idx="915">
                  <c:v>98.891750999999999</c:v>
                </c:pt>
                <c:pt idx="916">
                  <c:v>98.889395999999977</c:v>
                </c:pt>
                <c:pt idx="917">
                  <c:v>98.886850999999979</c:v>
                </c:pt>
                <c:pt idx="918">
                  <c:v>98.883807999999945</c:v>
                </c:pt>
                <c:pt idx="919">
                  <c:v>98.879920999999982</c:v>
                </c:pt>
                <c:pt idx="920">
                  <c:v>98.875467999999927</c:v>
                </c:pt>
                <c:pt idx="921">
                  <c:v>98.871453000000002</c:v>
                </c:pt>
                <c:pt idx="922">
                  <c:v>98.868250000000003</c:v>
                </c:pt>
                <c:pt idx="923">
                  <c:v>98.865264999999994</c:v>
                </c:pt>
                <c:pt idx="924">
                  <c:v>98.861912000000004</c:v>
                </c:pt>
                <c:pt idx="925">
                  <c:v>98.858303999999976</c:v>
                </c:pt>
                <c:pt idx="926">
                  <c:v>98.854999999999976</c:v>
                </c:pt>
                <c:pt idx="927">
                  <c:v>98.852005999999946</c:v>
                </c:pt>
                <c:pt idx="928">
                  <c:v>98.848663000000002</c:v>
                </c:pt>
                <c:pt idx="929">
                  <c:v>98.844571000000002</c:v>
                </c:pt>
                <c:pt idx="930">
                  <c:v>98.839969999999994</c:v>
                </c:pt>
                <c:pt idx="931">
                  <c:v>98.83557699999993</c:v>
                </c:pt>
                <c:pt idx="932">
                  <c:v>98.832034999999976</c:v>
                </c:pt>
                <c:pt idx="933">
                  <c:v>98.829047999999929</c:v>
                </c:pt>
                <c:pt idx="934">
                  <c:v>98.825691999999975</c:v>
                </c:pt>
                <c:pt idx="935">
                  <c:v>98.821736999999928</c:v>
                </c:pt>
                <c:pt idx="936">
                  <c:v>98.817672000000002</c:v>
                </c:pt>
                <c:pt idx="937">
                  <c:v>98.813824999999994</c:v>
                </c:pt>
                <c:pt idx="938">
                  <c:v>98.810102999999998</c:v>
                </c:pt>
                <c:pt idx="939">
                  <c:v>98.806087999999946</c:v>
                </c:pt>
                <c:pt idx="940">
                  <c:v>98.801424999999995</c:v>
                </c:pt>
                <c:pt idx="941">
                  <c:v>98.796226000000004</c:v>
                </c:pt>
                <c:pt idx="942">
                  <c:v>98.790925000000001</c:v>
                </c:pt>
                <c:pt idx="943">
                  <c:v>98.786039000000002</c:v>
                </c:pt>
                <c:pt idx="944">
                  <c:v>98.781692000000007</c:v>
                </c:pt>
                <c:pt idx="945">
                  <c:v>98.777319000000006</c:v>
                </c:pt>
                <c:pt idx="946">
                  <c:v>98.772567999999978</c:v>
                </c:pt>
                <c:pt idx="947">
                  <c:v>98.767726999999994</c:v>
                </c:pt>
                <c:pt idx="948">
                  <c:v>98.762951000000001</c:v>
                </c:pt>
                <c:pt idx="949">
                  <c:v>98.758216000000004</c:v>
                </c:pt>
                <c:pt idx="950">
                  <c:v>98.753816</c:v>
                </c:pt>
                <c:pt idx="951">
                  <c:v>98.75009</c:v>
                </c:pt>
                <c:pt idx="952">
                  <c:v>98.746869000000004</c:v>
                </c:pt>
                <c:pt idx="953">
                  <c:v>98.743864000000002</c:v>
                </c:pt>
                <c:pt idx="954">
                  <c:v>98.741189000000006</c:v>
                </c:pt>
                <c:pt idx="955">
                  <c:v>98.738843000000003</c:v>
                </c:pt>
                <c:pt idx="956">
                  <c:v>98.736528000000007</c:v>
                </c:pt>
                <c:pt idx="957">
                  <c:v>98.734185999999994</c:v>
                </c:pt>
                <c:pt idx="958">
                  <c:v>98.731976000000003</c:v>
                </c:pt>
                <c:pt idx="959">
                  <c:v>98.730230000000006</c:v>
                </c:pt>
                <c:pt idx="960">
                  <c:v>98.729293999999996</c:v>
                </c:pt>
                <c:pt idx="961">
                  <c:v>98.728864999999999</c:v>
                </c:pt>
                <c:pt idx="962">
                  <c:v>98.728187999999946</c:v>
                </c:pt>
                <c:pt idx="963">
                  <c:v>98.726841999999976</c:v>
                </c:pt>
                <c:pt idx="964">
                  <c:v>98.724853999999993</c:v>
                </c:pt>
                <c:pt idx="965">
                  <c:v>98.722814999999983</c:v>
                </c:pt>
                <c:pt idx="966">
                  <c:v>98.72149899999998</c:v>
                </c:pt>
                <c:pt idx="967">
                  <c:v>98.720849999999999</c:v>
                </c:pt>
                <c:pt idx="968">
                  <c:v>98.720327999999981</c:v>
                </c:pt>
                <c:pt idx="969">
                  <c:v>98.719748999999979</c:v>
                </c:pt>
                <c:pt idx="970">
                  <c:v>98.718941000000001</c:v>
                </c:pt>
                <c:pt idx="971">
                  <c:v>98.717697000000001</c:v>
                </c:pt>
                <c:pt idx="972">
                  <c:v>98.716277000000005</c:v>
                </c:pt>
                <c:pt idx="973">
                  <c:v>98.715258000000006</c:v>
                </c:pt>
                <c:pt idx="974">
                  <c:v>98.714820000000003</c:v>
                </c:pt>
                <c:pt idx="975">
                  <c:v>98.714635000000001</c:v>
                </c:pt>
                <c:pt idx="976">
                  <c:v>98.714459000000005</c:v>
                </c:pt>
                <c:pt idx="977">
                  <c:v>98.714095</c:v>
                </c:pt>
                <c:pt idx="978">
                  <c:v>98.713295000000002</c:v>
                </c:pt>
                <c:pt idx="979">
                  <c:v>98.712416000000005</c:v>
                </c:pt>
                <c:pt idx="980">
                  <c:v>98.711687999999995</c:v>
                </c:pt>
                <c:pt idx="981">
                  <c:v>98.710217</c:v>
                </c:pt>
                <c:pt idx="982">
                  <c:v>98.707532999999998</c:v>
                </c:pt>
                <c:pt idx="983">
                  <c:v>98.704562999999993</c:v>
                </c:pt>
                <c:pt idx="984">
                  <c:v>98.701806000000005</c:v>
                </c:pt>
                <c:pt idx="985">
                  <c:v>98.69853999999998</c:v>
                </c:pt>
                <c:pt idx="986">
                  <c:v>98.694230000000005</c:v>
                </c:pt>
                <c:pt idx="987">
                  <c:v>98.689394999999976</c:v>
                </c:pt>
                <c:pt idx="988">
                  <c:v>98.685086999999896</c:v>
                </c:pt>
                <c:pt idx="989">
                  <c:v>98.681843999999998</c:v>
                </c:pt>
                <c:pt idx="990">
                  <c:v>98.679142999999911</c:v>
                </c:pt>
                <c:pt idx="991">
                  <c:v>98.676213000000004</c:v>
                </c:pt>
                <c:pt idx="992">
                  <c:v>98.673083999999946</c:v>
                </c:pt>
                <c:pt idx="993">
                  <c:v>98.670280999999946</c:v>
                </c:pt>
                <c:pt idx="994">
                  <c:v>98.667870999999977</c:v>
                </c:pt>
                <c:pt idx="995">
                  <c:v>98.665424999999999</c:v>
                </c:pt>
                <c:pt idx="996">
                  <c:v>98.662730999999894</c:v>
                </c:pt>
                <c:pt idx="997">
                  <c:v>98.659802999999911</c:v>
                </c:pt>
                <c:pt idx="998">
                  <c:v>98.656307999999896</c:v>
                </c:pt>
                <c:pt idx="999">
                  <c:v>98.652080999999896</c:v>
                </c:pt>
                <c:pt idx="1000">
                  <c:v>98.647713999999993</c:v>
                </c:pt>
                <c:pt idx="1001">
                  <c:v>98.643423999999996</c:v>
                </c:pt>
                <c:pt idx="1002">
                  <c:v>98.638784999999928</c:v>
                </c:pt>
                <c:pt idx="1003">
                  <c:v>98.634076999999976</c:v>
                </c:pt>
                <c:pt idx="1004">
                  <c:v>98.629951999999946</c:v>
                </c:pt>
                <c:pt idx="1005">
                  <c:v>98.626185999999976</c:v>
                </c:pt>
                <c:pt idx="1006">
                  <c:v>98.622008999999892</c:v>
                </c:pt>
                <c:pt idx="1007">
                  <c:v>98.617339000000001</c:v>
                </c:pt>
                <c:pt idx="1008">
                  <c:v>98.613086999999979</c:v>
                </c:pt>
                <c:pt idx="1009">
                  <c:v>98.609617</c:v>
                </c:pt>
                <c:pt idx="1010">
                  <c:v>98.606070999999929</c:v>
                </c:pt>
                <c:pt idx="1011">
                  <c:v>98.602029000000002</c:v>
                </c:pt>
                <c:pt idx="1012">
                  <c:v>98.597695999999999</c:v>
                </c:pt>
                <c:pt idx="1013">
                  <c:v>98.592917</c:v>
                </c:pt>
                <c:pt idx="1014">
                  <c:v>98.588019000000003</c:v>
                </c:pt>
                <c:pt idx="1015">
                  <c:v>98.583745999999977</c:v>
                </c:pt>
                <c:pt idx="1016">
                  <c:v>98.579706999999928</c:v>
                </c:pt>
                <c:pt idx="1017">
                  <c:v>98.575083999999976</c:v>
                </c:pt>
                <c:pt idx="1018">
                  <c:v>98.569905000000006</c:v>
                </c:pt>
                <c:pt idx="1019">
                  <c:v>98.564375999999982</c:v>
                </c:pt>
                <c:pt idx="1020">
                  <c:v>98.558431999999911</c:v>
                </c:pt>
                <c:pt idx="1021">
                  <c:v>98.551955000000007</c:v>
                </c:pt>
                <c:pt idx="1022">
                  <c:v>98.544741999999999</c:v>
                </c:pt>
                <c:pt idx="1023">
                  <c:v>98.536973000000003</c:v>
                </c:pt>
                <c:pt idx="1024">
                  <c:v>98.529398999999927</c:v>
                </c:pt>
                <c:pt idx="1025">
                  <c:v>98.522721999999931</c:v>
                </c:pt>
                <c:pt idx="1026">
                  <c:v>98.517060000000001</c:v>
                </c:pt>
                <c:pt idx="1027">
                  <c:v>98.511750000000006</c:v>
                </c:pt>
                <c:pt idx="1028">
                  <c:v>98.505831999999927</c:v>
                </c:pt>
                <c:pt idx="1029">
                  <c:v>98.499194000000003</c:v>
                </c:pt>
                <c:pt idx="1030">
                  <c:v>98.492645999999993</c:v>
                </c:pt>
                <c:pt idx="1031">
                  <c:v>98.486562000000006</c:v>
                </c:pt>
                <c:pt idx="1032">
                  <c:v>98.480260000000001</c:v>
                </c:pt>
                <c:pt idx="1033">
                  <c:v>98.47313699999998</c:v>
                </c:pt>
                <c:pt idx="1034">
                  <c:v>98.465616999999995</c:v>
                </c:pt>
                <c:pt idx="1035">
                  <c:v>98.458602999999982</c:v>
                </c:pt>
                <c:pt idx="1036">
                  <c:v>98.452543000000006</c:v>
                </c:pt>
                <c:pt idx="1037">
                  <c:v>98.447202000000004</c:v>
                </c:pt>
                <c:pt idx="1038">
                  <c:v>98.441828999999998</c:v>
                </c:pt>
                <c:pt idx="1039">
                  <c:v>98.435486999999981</c:v>
                </c:pt>
                <c:pt idx="1040">
                  <c:v>98.427726000000007</c:v>
                </c:pt>
                <c:pt idx="1041">
                  <c:v>98.419089999999997</c:v>
                </c:pt>
                <c:pt idx="1042">
                  <c:v>98.410421999999997</c:v>
                </c:pt>
                <c:pt idx="1043">
                  <c:v>98.401815999999997</c:v>
                </c:pt>
                <c:pt idx="1044">
                  <c:v>98.393027000000004</c:v>
                </c:pt>
                <c:pt idx="1045">
                  <c:v>98.384473</c:v>
                </c:pt>
                <c:pt idx="1046">
                  <c:v>98.376712999999896</c:v>
                </c:pt>
                <c:pt idx="1047">
                  <c:v>98.369468999999981</c:v>
                </c:pt>
                <c:pt idx="1048">
                  <c:v>98.362069999999974</c:v>
                </c:pt>
                <c:pt idx="1049">
                  <c:v>98.354225</c:v>
                </c:pt>
                <c:pt idx="1050">
                  <c:v>98.346120999999997</c:v>
                </c:pt>
                <c:pt idx="1051">
                  <c:v>98.338107999999977</c:v>
                </c:pt>
                <c:pt idx="1052">
                  <c:v>98.330026000000004</c:v>
                </c:pt>
                <c:pt idx="1053">
                  <c:v>98.321143000000006</c:v>
                </c:pt>
                <c:pt idx="1054">
                  <c:v>98.310939000000005</c:v>
                </c:pt>
                <c:pt idx="1055">
                  <c:v>98.299794000000006</c:v>
                </c:pt>
                <c:pt idx="1056">
                  <c:v>98.288934999999981</c:v>
                </c:pt>
                <c:pt idx="1057">
                  <c:v>98.279170999999977</c:v>
                </c:pt>
                <c:pt idx="1058">
                  <c:v>98.27018099999998</c:v>
                </c:pt>
                <c:pt idx="1059">
                  <c:v>98.261630999999994</c:v>
                </c:pt>
                <c:pt idx="1060">
                  <c:v>98.253510000000006</c:v>
                </c:pt>
                <c:pt idx="1061">
                  <c:v>98.245660999999998</c:v>
                </c:pt>
                <c:pt idx="1062">
                  <c:v>98.238007999999979</c:v>
                </c:pt>
                <c:pt idx="1063">
                  <c:v>98.230375999999978</c:v>
                </c:pt>
                <c:pt idx="1064">
                  <c:v>98.222343999999978</c:v>
                </c:pt>
                <c:pt idx="1065">
                  <c:v>98.213539999999995</c:v>
                </c:pt>
                <c:pt idx="1066">
                  <c:v>98.203503999999995</c:v>
                </c:pt>
                <c:pt idx="1067">
                  <c:v>98.192017999999976</c:v>
                </c:pt>
                <c:pt idx="1068">
                  <c:v>98.179533999999975</c:v>
                </c:pt>
                <c:pt idx="1069">
                  <c:v>98.166751999999946</c:v>
                </c:pt>
                <c:pt idx="1070">
                  <c:v>98.154147999999978</c:v>
                </c:pt>
                <c:pt idx="1071">
                  <c:v>98.141784000000001</c:v>
                </c:pt>
                <c:pt idx="1072">
                  <c:v>98.129553000000001</c:v>
                </c:pt>
                <c:pt idx="1073">
                  <c:v>98.117490000000004</c:v>
                </c:pt>
                <c:pt idx="1074">
                  <c:v>98.10518699999993</c:v>
                </c:pt>
                <c:pt idx="1075">
                  <c:v>98.091730000000013</c:v>
                </c:pt>
                <c:pt idx="1076">
                  <c:v>98.076557999999977</c:v>
                </c:pt>
                <c:pt idx="1077">
                  <c:v>98.060004000000006</c:v>
                </c:pt>
                <c:pt idx="1078">
                  <c:v>98.043737999999976</c:v>
                </c:pt>
                <c:pt idx="1079">
                  <c:v>98.030073999999999</c:v>
                </c:pt>
                <c:pt idx="1080">
                  <c:v>98.019540000000006</c:v>
                </c:pt>
                <c:pt idx="1081">
                  <c:v>98.01057299999998</c:v>
                </c:pt>
                <c:pt idx="1082">
                  <c:v>98.001907000000003</c:v>
                </c:pt>
                <c:pt idx="1083">
                  <c:v>97.993519000000006</c:v>
                </c:pt>
                <c:pt idx="1084">
                  <c:v>97.985657000000003</c:v>
                </c:pt>
                <c:pt idx="1085">
                  <c:v>97.97856299999998</c:v>
                </c:pt>
                <c:pt idx="1086">
                  <c:v>97.972398999999896</c:v>
                </c:pt>
                <c:pt idx="1087">
                  <c:v>97.966396000000003</c:v>
                </c:pt>
                <c:pt idx="1088">
                  <c:v>97.958883</c:v>
                </c:pt>
                <c:pt idx="1089">
                  <c:v>97.949089999999998</c:v>
                </c:pt>
                <c:pt idx="1090">
                  <c:v>97.938216999999995</c:v>
                </c:pt>
                <c:pt idx="1091">
                  <c:v>97.927764999999994</c:v>
                </c:pt>
                <c:pt idx="1092">
                  <c:v>97.917595000000006</c:v>
                </c:pt>
                <c:pt idx="1093">
                  <c:v>97.906606999999994</c:v>
                </c:pt>
                <c:pt idx="1094">
                  <c:v>97.894417000000004</c:v>
                </c:pt>
                <c:pt idx="1095">
                  <c:v>97.881602999999998</c:v>
                </c:pt>
                <c:pt idx="1096">
                  <c:v>97.868446999999946</c:v>
                </c:pt>
                <c:pt idx="1097">
                  <c:v>97.854265999999996</c:v>
                </c:pt>
                <c:pt idx="1098">
                  <c:v>97.838605999999999</c:v>
                </c:pt>
                <c:pt idx="1099">
                  <c:v>97.821875999999946</c:v>
                </c:pt>
                <c:pt idx="1100">
                  <c:v>97.804214000000002</c:v>
                </c:pt>
                <c:pt idx="1101">
                  <c:v>97.784867000000006</c:v>
                </c:pt>
                <c:pt idx="1102">
                  <c:v>97.76276799999998</c:v>
                </c:pt>
                <c:pt idx="1103">
                  <c:v>97.737932000000001</c:v>
                </c:pt>
                <c:pt idx="1104">
                  <c:v>97.711858000000007</c:v>
                </c:pt>
                <c:pt idx="1105">
                  <c:v>97.685694999999981</c:v>
                </c:pt>
                <c:pt idx="1106">
                  <c:v>97.659225000000006</c:v>
                </c:pt>
                <c:pt idx="1107">
                  <c:v>97.632343999999947</c:v>
                </c:pt>
                <c:pt idx="1108">
                  <c:v>97.604849000000002</c:v>
                </c:pt>
                <c:pt idx="1109">
                  <c:v>97.57479499999998</c:v>
                </c:pt>
                <c:pt idx="1110">
                  <c:v>97.540244000000001</c:v>
                </c:pt>
                <c:pt idx="1111">
                  <c:v>97.502133000000001</c:v>
                </c:pt>
                <c:pt idx="1112">
                  <c:v>97.462664000000004</c:v>
                </c:pt>
                <c:pt idx="1113">
                  <c:v>97.421961999999994</c:v>
                </c:pt>
                <c:pt idx="1114">
                  <c:v>97.377905999999982</c:v>
                </c:pt>
                <c:pt idx="1115">
                  <c:v>97.329499999999982</c:v>
                </c:pt>
                <c:pt idx="1116">
                  <c:v>97.278567999999979</c:v>
                </c:pt>
                <c:pt idx="1117">
                  <c:v>97.227081999999982</c:v>
                </c:pt>
                <c:pt idx="1118">
                  <c:v>97.174844999999976</c:v>
                </c:pt>
                <c:pt idx="1119">
                  <c:v>97.120125000000002</c:v>
                </c:pt>
                <c:pt idx="1120">
                  <c:v>97.060697000000005</c:v>
                </c:pt>
                <c:pt idx="1121">
                  <c:v>96.995638999999983</c:v>
                </c:pt>
                <c:pt idx="1122">
                  <c:v>96.925910999999999</c:v>
                </c:pt>
                <c:pt idx="1123">
                  <c:v>96.852340999999896</c:v>
                </c:pt>
                <c:pt idx="1124">
                  <c:v>96.774306999999979</c:v>
                </c:pt>
                <c:pt idx="1125">
                  <c:v>96.690347999999929</c:v>
                </c:pt>
                <c:pt idx="1126">
                  <c:v>96.598151000000001</c:v>
                </c:pt>
                <c:pt idx="1127">
                  <c:v>96.494924999999995</c:v>
                </c:pt>
                <c:pt idx="1128">
                  <c:v>96.378441999999893</c:v>
                </c:pt>
                <c:pt idx="1129">
                  <c:v>96.246988000000002</c:v>
                </c:pt>
                <c:pt idx="1130">
                  <c:v>96.097601999999995</c:v>
                </c:pt>
                <c:pt idx="1131">
                  <c:v>95.925240000000002</c:v>
                </c:pt>
                <c:pt idx="1132">
                  <c:v>95.721442999999979</c:v>
                </c:pt>
                <c:pt idx="1133">
                  <c:v>95.470707999999945</c:v>
                </c:pt>
                <c:pt idx="1134">
                  <c:v>95.144076999999982</c:v>
                </c:pt>
                <c:pt idx="1135">
                  <c:v>94.695094999999981</c:v>
                </c:pt>
                <c:pt idx="1136">
                  <c:v>94.063080999999983</c:v>
                </c:pt>
                <c:pt idx="1137">
                  <c:v>93.189036999999928</c:v>
                </c:pt>
                <c:pt idx="1138">
                  <c:v>92.064819</c:v>
                </c:pt>
                <c:pt idx="1139">
                  <c:v>90.825944999999976</c:v>
                </c:pt>
                <c:pt idx="1140">
                  <c:v>89.765283999999994</c:v>
                </c:pt>
                <c:pt idx="1141">
                  <c:v>89.155355999999927</c:v>
                </c:pt>
                <c:pt idx="1142">
                  <c:v>89.055609000000004</c:v>
                </c:pt>
                <c:pt idx="1143">
                  <c:v>89.342067999999998</c:v>
                </c:pt>
                <c:pt idx="1144">
                  <c:v>89.854725000000002</c:v>
                </c:pt>
                <c:pt idx="1145">
                  <c:v>90.464543000000006</c:v>
                </c:pt>
                <c:pt idx="1146">
                  <c:v>91.072570999999911</c:v>
                </c:pt>
                <c:pt idx="1147">
                  <c:v>91.604613000000001</c:v>
                </c:pt>
                <c:pt idx="1148">
                  <c:v>92.009881999999976</c:v>
                </c:pt>
                <c:pt idx="1149">
                  <c:v>92.262636999999998</c:v>
                </c:pt>
                <c:pt idx="1150">
                  <c:v>92.372980999999896</c:v>
                </c:pt>
                <c:pt idx="1151">
                  <c:v>92.397986000000003</c:v>
                </c:pt>
                <c:pt idx="1152">
                  <c:v>92.424636000000007</c:v>
                </c:pt>
                <c:pt idx="1153">
                  <c:v>92.516897999999998</c:v>
                </c:pt>
                <c:pt idx="1154">
                  <c:v>92.674034999999947</c:v>
                </c:pt>
                <c:pt idx="1155">
                  <c:v>92.844367000000005</c:v>
                </c:pt>
                <c:pt idx="1156">
                  <c:v>92.972678999999928</c:v>
                </c:pt>
                <c:pt idx="1157">
                  <c:v>93.030933000000005</c:v>
                </c:pt>
                <c:pt idx="1158">
                  <c:v>93.017506999999995</c:v>
                </c:pt>
                <c:pt idx="1159">
                  <c:v>92.942941000000005</c:v>
                </c:pt>
                <c:pt idx="1160">
                  <c:v>92.819953999999996</c:v>
                </c:pt>
                <c:pt idx="1161">
                  <c:v>92.660286999999983</c:v>
                </c:pt>
                <c:pt idx="1162">
                  <c:v>92.473999000000006</c:v>
                </c:pt>
                <c:pt idx="1163">
                  <c:v>92.268728999999979</c:v>
                </c:pt>
                <c:pt idx="1164">
                  <c:v>92.048809000000006</c:v>
                </c:pt>
                <c:pt idx="1165">
                  <c:v>91.814988999999983</c:v>
                </c:pt>
                <c:pt idx="1166">
                  <c:v>91.564573999999993</c:v>
                </c:pt>
                <c:pt idx="1167">
                  <c:v>91.290093999999996</c:v>
                </c:pt>
                <c:pt idx="1168">
                  <c:v>90.976355999999981</c:v>
                </c:pt>
                <c:pt idx="1169">
                  <c:v>90.598984999999999</c:v>
                </c:pt>
                <c:pt idx="1170">
                  <c:v>90.120180999999945</c:v>
                </c:pt>
                <c:pt idx="1171">
                  <c:v>89.486471999999978</c:v>
                </c:pt>
                <c:pt idx="1172">
                  <c:v>88.648744999999977</c:v>
                </c:pt>
                <c:pt idx="1173">
                  <c:v>87.621454999999983</c:v>
                </c:pt>
                <c:pt idx="1174">
                  <c:v>86.535420000000002</c:v>
                </c:pt>
                <c:pt idx="1175">
                  <c:v>85.596570999999983</c:v>
                </c:pt>
                <c:pt idx="1176">
                  <c:v>84.959968000000003</c:v>
                </c:pt>
                <c:pt idx="1177">
                  <c:v>84.664674000000005</c:v>
                </c:pt>
                <c:pt idx="1178">
                  <c:v>84.67690099999993</c:v>
                </c:pt>
                <c:pt idx="1179">
                  <c:v>84.951701</c:v>
                </c:pt>
                <c:pt idx="1180">
                  <c:v>85.439353999999994</c:v>
                </c:pt>
                <c:pt idx="1181">
                  <c:v>86.079026999999982</c:v>
                </c:pt>
                <c:pt idx="1182">
                  <c:v>86.811243000000005</c:v>
                </c:pt>
                <c:pt idx="1183">
                  <c:v>87.593445000000003</c:v>
                </c:pt>
                <c:pt idx="1184">
                  <c:v>88.398514000000006</c:v>
                </c:pt>
                <c:pt idx="1185">
                  <c:v>89.197959999999995</c:v>
                </c:pt>
                <c:pt idx="1186">
                  <c:v>89.956766999999999</c:v>
                </c:pt>
                <c:pt idx="1187">
                  <c:v>90.641114999999999</c:v>
                </c:pt>
                <c:pt idx="1188">
                  <c:v>91.226927000000003</c:v>
                </c:pt>
                <c:pt idx="1189">
                  <c:v>91.698109000000002</c:v>
                </c:pt>
                <c:pt idx="1190">
                  <c:v>92.040257999999994</c:v>
                </c:pt>
                <c:pt idx="1191">
                  <c:v>92.240575000000007</c:v>
                </c:pt>
                <c:pt idx="1192">
                  <c:v>92.298481999999979</c:v>
                </c:pt>
                <c:pt idx="1193">
                  <c:v>92.240074000000007</c:v>
                </c:pt>
                <c:pt idx="1194">
                  <c:v>92.12805599999993</c:v>
                </c:pt>
                <c:pt idx="1195">
                  <c:v>92.048794000000001</c:v>
                </c:pt>
                <c:pt idx="1196">
                  <c:v>92.075473999999929</c:v>
                </c:pt>
                <c:pt idx="1197">
                  <c:v>92.235956999999999</c:v>
                </c:pt>
                <c:pt idx="1198">
                  <c:v>92.515709000000001</c:v>
                </c:pt>
                <c:pt idx="1199">
                  <c:v>92.883623</c:v>
                </c:pt>
                <c:pt idx="1200">
                  <c:v>93.308926999999983</c:v>
                </c:pt>
                <c:pt idx="1201">
                  <c:v>93.761078999999981</c:v>
                </c:pt>
                <c:pt idx="1202">
                  <c:v>94.209905000000006</c:v>
                </c:pt>
                <c:pt idx="1203">
                  <c:v>94.630550999999983</c:v>
                </c:pt>
                <c:pt idx="1204">
                  <c:v>95.007655999999997</c:v>
                </c:pt>
                <c:pt idx="1205">
                  <c:v>95.335338999999891</c:v>
                </c:pt>
                <c:pt idx="1206">
                  <c:v>95.615970999999931</c:v>
                </c:pt>
                <c:pt idx="1207">
                  <c:v>95.856153000000006</c:v>
                </c:pt>
                <c:pt idx="1208">
                  <c:v>96.060716999999983</c:v>
                </c:pt>
                <c:pt idx="1209">
                  <c:v>96.231862000000007</c:v>
                </c:pt>
                <c:pt idx="1210">
                  <c:v>96.373386999999894</c:v>
                </c:pt>
                <c:pt idx="1211">
                  <c:v>96.490829000000005</c:v>
                </c:pt>
                <c:pt idx="1212">
                  <c:v>96.588127999999998</c:v>
                </c:pt>
                <c:pt idx="1213">
                  <c:v>96.666083999999998</c:v>
                </c:pt>
                <c:pt idx="1214">
                  <c:v>96.721804000000006</c:v>
                </c:pt>
                <c:pt idx="1215">
                  <c:v>96.751343000000006</c:v>
                </c:pt>
                <c:pt idx="1216">
                  <c:v>96.754613000000006</c:v>
                </c:pt>
                <c:pt idx="1217">
                  <c:v>96.732981999999978</c:v>
                </c:pt>
                <c:pt idx="1218">
                  <c:v>96.685874999999896</c:v>
                </c:pt>
                <c:pt idx="1219">
                  <c:v>96.614806999999999</c:v>
                </c:pt>
                <c:pt idx="1220">
                  <c:v>96.52525</c:v>
                </c:pt>
                <c:pt idx="1221">
                  <c:v>96.424980000000005</c:v>
                </c:pt>
                <c:pt idx="1222">
                  <c:v>96.327033</c:v>
                </c:pt>
                <c:pt idx="1223">
                  <c:v>96.249332999999979</c:v>
                </c:pt>
                <c:pt idx="1224">
                  <c:v>96.205884999999981</c:v>
                </c:pt>
                <c:pt idx="1225">
                  <c:v>96.201531000000003</c:v>
                </c:pt>
                <c:pt idx="1226">
                  <c:v>96.235393999999999</c:v>
                </c:pt>
                <c:pt idx="1227">
                  <c:v>96.30341199999998</c:v>
                </c:pt>
                <c:pt idx="1228">
                  <c:v>96.395447999999931</c:v>
                </c:pt>
                <c:pt idx="1229">
                  <c:v>96.495610999999997</c:v>
                </c:pt>
                <c:pt idx="1230">
                  <c:v>96.589106999999998</c:v>
                </c:pt>
                <c:pt idx="1231">
                  <c:v>96.666738999999893</c:v>
                </c:pt>
                <c:pt idx="1232">
                  <c:v>96.725290000000001</c:v>
                </c:pt>
                <c:pt idx="1233">
                  <c:v>96.767571000000004</c:v>
                </c:pt>
                <c:pt idx="1234">
                  <c:v>96.799037999999982</c:v>
                </c:pt>
                <c:pt idx="1235">
                  <c:v>96.822402999999895</c:v>
                </c:pt>
                <c:pt idx="1236">
                  <c:v>96.837760000000003</c:v>
                </c:pt>
                <c:pt idx="1237">
                  <c:v>96.846868999999998</c:v>
                </c:pt>
                <c:pt idx="1238">
                  <c:v>96.855031999999895</c:v>
                </c:pt>
                <c:pt idx="1239">
                  <c:v>96.866197999999983</c:v>
                </c:pt>
                <c:pt idx="1240">
                  <c:v>96.877193000000005</c:v>
                </c:pt>
                <c:pt idx="1241">
                  <c:v>96.88204099999993</c:v>
                </c:pt>
                <c:pt idx="1242">
                  <c:v>96.880920000000003</c:v>
                </c:pt>
                <c:pt idx="1243">
                  <c:v>96.879000999999946</c:v>
                </c:pt>
                <c:pt idx="1244">
                  <c:v>96.878486999999893</c:v>
                </c:pt>
                <c:pt idx="1245">
                  <c:v>96.877144000000001</c:v>
                </c:pt>
                <c:pt idx="1246">
                  <c:v>96.873277999999928</c:v>
                </c:pt>
                <c:pt idx="1247">
                  <c:v>96.867067000000006</c:v>
                </c:pt>
                <c:pt idx="1248">
                  <c:v>96.858194999999981</c:v>
                </c:pt>
                <c:pt idx="1249">
                  <c:v>96.84666</c:v>
                </c:pt>
                <c:pt idx="1250">
                  <c:v>96.834692000000004</c:v>
                </c:pt>
                <c:pt idx="1251">
                  <c:v>96.825029999999984</c:v>
                </c:pt>
                <c:pt idx="1252">
                  <c:v>96.817530000000005</c:v>
                </c:pt>
                <c:pt idx="1253">
                  <c:v>96.808137999999929</c:v>
                </c:pt>
                <c:pt idx="1254">
                  <c:v>96.793083999999993</c:v>
                </c:pt>
                <c:pt idx="1255">
                  <c:v>96.774236999999999</c:v>
                </c:pt>
                <c:pt idx="1256">
                  <c:v>96.75800599999998</c:v>
                </c:pt>
                <c:pt idx="1257">
                  <c:v>96.749492000000004</c:v>
                </c:pt>
                <c:pt idx="1258">
                  <c:v>96.747384999999994</c:v>
                </c:pt>
                <c:pt idx="1259">
                  <c:v>96.743813000000003</c:v>
                </c:pt>
                <c:pt idx="1260">
                  <c:v>96.732560000000007</c:v>
                </c:pt>
                <c:pt idx="1261">
                  <c:v>96.715357999999981</c:v>
                </c:pt>
                <c:pt idx="1262">
                  <c:v>96.696213999999998</c:v>
                </c:pt>
                <c:pt idx="1263">
                  <c:v>96.677060999999981</c:v>
                </c:pt>
                <c:pt idx="1264">
                  <c:v>96.660006999999979</c:v>
                </c:pt>
                <c:pt idx="1265">
                  <c:v>96.645184999999998</c:v>
                </c:pt>
                <c:pt idx="1266">
                  <c:v>96.629941999999929</c:v>
                </c:pt>
                <c:pt idx="1267">
                  <c:v>96.614164000000002</c:v>
                </c:pt>
                <c:pt idx="1268">
                  <c:v>96.599741999999978</c:v>
                </c:pt>
                <c:pt idx="1269">
                  <c:v>96.586076999999946</c:v>
                </c:pt>
                <c:pt idx="1270">
                  <c:v>96.570665000000005</c:v>
                </c:pt>
                <c:pt idx="1271">
                  <c:v>96.551836999999978</c:v>
                </c:pt>
                <c:pt idx="1272">
                  <c:v>96.531131999999999</c:v>
                </c:pt>
                <c:pt idx="1273">
                  <c:v>96.512725000000003</c:v>
                </c:pt>
                <c:pt idx="1274">
                  <c:v>96.496902000000006</c:v>
                </c:pt>
                <c:pt idx="1275">
                  <c:v>96.478595999999982</c:v>
                </c:pt>
                <c:pt idx="1276">
                  <c:v>96.457311000000004</c:v>
                </c:pt>
                <c:pt idx="1277">
                  <c:v>96.439727000000005</c:v>
                </c:pt>
                <c:pt idx="1278">
                  <c:v>96.427074000000005</c:v>
                </c:pt>
                <c:pt idx="1279">
                  <c:v>96.410988000000003</c:v>
                </c:pt>
                <c:pt idx="1280">
                  <c:v>96.384454000000005</c:v>
                </c:pt>
                <c:pt idx="1281">
                  <c:v>96.347950999999995</c:v>
                </c:pt>
                <c:pt idx="1282">
                  <c:v>96.307168000000004</c:v>
                </c:pt>
                <c:pt idx="1283">
                  <c:v>96.269090000000006</c:v>
                </c:pt>
                <c:pt idx="1284">
                  <c:v>96.23653299999998</c:v>
                </c:pt>
                <c:pt idx="1285">
                  <c:v>96.207189</c:v>
                </c:pt>
                <c:pt idx="1286">
                  <c:v>96.178132999999875</c:v>
                </c:pt>
                <c:pt idx="1287">
                  <c:v>96.148296999999999</c:v>
                </c:pt>
                <c:pt idx="1288">
                  <c:v>96.118673999999999</c:v>
                </c:pt>
                <c:pt idx="1289">
                  <c:v>96.090935000000002</c:v>
                </c:pt>
                <c:pt idx="1290">
                  <c:v>96.063123000000004</c:v>
                </c:pt>
                <c:pt idx="1291">
                  <c:v>96.030625999999998</c:v>
                </c:pt>
                <c:pt idx="1292">
                  <c:v>95.993559000000005</c:v>
                </c:pt>
                <c:pt idx="1293">
                  <c:v>95.957019000000003</c:v>
                </c:pt>
                <c:pt idx="1294">
                  <c:v>95.924114000000003</c:v>
                </c:pt>
                <c:pt idx="1295">
                  <c:v>95.895454999999998</c:v>
                </c:pt>
                <c:pt idx="1296">
                  <c:v>95.87086799999993</c:v>
                </c:pt>
                <c:pt idx="1297">
                  <c:v>95.845346999999975</c:v>
                </c:pt>
                <c:pt idx="1298">
                  <c:v>95.811780999999982</c:v>
                </c:pt>
                <c:pt idx="1299">
                  <c:v>95.772045999999946</c:v>
                </c:pt>
                <c:pt idx="1300">
                  <c:v>95.734648000000007</c:v>
                </c:pt>
                <c:pt idx="1301">
                  <c:v>95.702698999999981</c:v>
                </c:pt>
                <c:pt idx="1302">
                  <c:v>95.673357999999865</c:v>
                </c:pt>
                <c:pt idx="1303">
                  <c:v>95.644017000000005</c:v>
                </c:pt>
                <c:pt idx="1304">
                  <c:v>95.613601000000003</c:v>
                </c:pt>
                <c:pt idx="1305">
                  <c:v>95.581947999999983</c:v>
                </c:pt>
                <c:pt idx="1306">
                  <c:v>95.549682000000004</c:v>
                </c:pt>
                <c:pt idx="1307">
                  <c:v>95.517613999999995</c:v>
                </c:pt>
                <c:pt idx="1308">
                  <c:v>95.485809000000003</c:v>
                </c:pt>
                <c:pt idx="1309">
                  <c:v>95.454171000000002</c:v>
                </c:pt>
                <c:pt idx="1310">
                  <c:v>95.422663</c:v>
                </c:pt>
                <c:pt idx="1311">
                  <c:v>95.390274000000005</c:v>
                </c:pt>
                <c:pt idx="1312">
                  <c:v>95.356392999999912</c:v>
                </c:pt>
                <c:pt idx="1313">
                  <c:v>95.32232699999993</c:v>
                </c:pt>
                <c:pt idx="1314">
                  <c:v>95.288666000000006</c:v>
                </c:pt>
                <c:pt idx="1315">
                  <c:v>95.254596000000006</c:v>
                </c:pt>
                <c:pt idx="1316">
                  <c:v>95.220465000000004</c:v>
                </c:pt>
                <c:pt idx="1317">
                  <c:v>95.187515000000005</c:v>
                </c:pt>
                <c:pt idx="1318">
                  <c:v>95.155797999999876</c:v>
                </c:pt>
                <c:pt idx="1319">
                  <c:v>95.124327999999977</c:v>
                </c:pt>
                <c:pt idx="1320">
                  <c:v>95.091841000000002</c:v>
                </c:pt>
                <c:pt idx="1321">
                  <c:v>95.057563999999999</c:v>
                </c:pt>
                <c:pt idx="1322">
                  <c:v>95.022233999999983</c:v>
                </c:pt>
                <c:pt idx="1323">
                  <c:v>94.987620000000007</c:v>
                </c:pt>
                <c:pt idx="1324">
                  <c:v>94.954723000000001</c:v>
                </c:pt>
                <c:pt idx="1325">
                  <c:v>94.923699999999997</c:v>
                </c:pt>
                <c:pt idx="1326">
                  <c:v>94.894206999999994</c:v>
                </c:pt>
                <c:pt idx="1327">
                  <c:v>94.865048999999928</c:v>
                </c:pt>
                <c:pt idx="1328">
                  <c:v>94.834973000000005</c:v>
                </c:pt>
                <c:pt idx="1329">
                  <c:v>94.803684000000004</c:v>
                </c:pt>
                <c:pt idx="1330">
                  <c:v>94.771817999999982</c:v>
                </c:pt>
                <c:pt idx="1331">
                  <c:v>94.740758999999983</c:v>
                </c:pt>
                <c:pt idx="1332">
                  <c:v>94.710870999999983</c:v>
                </c:pt>
                <c:pt idx="1333">
                  <c:v>94.681094999999999</c:v>
                </c:pt>
                <c:pt idx="1334">
                  <c:v>94.651675999999981</c:v>
                </c:pt>
                <c:pt idx="1335">
                  <c:v>94.623830999999896</c:v>
                </c:pt>
                <c:pt idx="1336">
                  <c:v>94.597577000000001</c:v>
                </c:pt>
                <c:pt idx="1337">
                  <c:v>94.574304999999981</c:v>
                </c:pt>
                <c:pt idx="1338">
                  <c:v>94.555630999999977</c:v>
                </c:pt>
                <c:pt idx="1339">
                  <c:v>94.536094000000006</c:v>
                </c:pt>
                <c:pt idx="1340">
                  <c:v>94.507850000000005</c:v>
                </c:pt>
                <c:pt idx="1341">
                  <c:v>94.473411999999982</c:v>
                </c:pt>
                <c:pt idx="1342">
                  <c:v>94.441186999999999</c:v>
                </c:pt>
                <c:pt idx="1343">
                  <c:v>94.414141999999998</c:v>
                </c:pt>
                <c:pt idx="1344">
                  <c:v>94.391917000000007</c:v>
                </c:pt>
                <c:pt idx="1345">
                  <c:v>94.374011999999979</c:v>
                </c:pt>
                <c:pt idx="1346">
                  <c:v>94.356355999999977</c:v>
                </c:pt>
                <c:pt idx="1347">
                  <c:v>94.334254999999999</c:v>
                </c:pt>
                <c:pt idx="1348">
                  <c:v>94.309477999999928</c:v>
                </c:pt>
                <c:pt idx="1349">
                  <c:v>94.287685999999994</c:v>
                </c:pt>
                <c:pt idx="1350">
                  <c:v>94.270026999999999</c:v>
                </c:pt>
                <c:pt idx="1351">
                  <c:v>94.252636999999979</c:v>
                </c:pt>
                <c:pt idx="1352">
                  <c:v>94.233564999999999</c:v>
                </c:pt>
                <c:pt idx="1353">
                  <c:v>94.214956000000001</c:v>
                </c:pt>
                <c:pt idx="1354">
                  <c:v>94.198256999999998</c:v>
                </c:pt>
                <c:pt idx="1355">
                  <c:v>94.182972999999876</c:v>
                </c:pt>
                <c:pt idx="1356">
                  <c:v>94.170149999999978</c:v>
                </c:pt>
                <c:pt idx="1357">
                  <c:v>94.162104999999983</c:v>
                </c:pt>
                <c:pt idx="1358">
                  <c:v>94.157105000000001</c:v>
                </c:pt>
                <c:pt idx="1359">
                  <c:v>94.148325999999983</c:v>
                </c:pt>
                <c:pt idx="1360">
                  <c:v>94.132082999999895</c:v>
                </c:pt>
                <c:pt idx="1361">
                  <c:v>94.112261000000004</c:v>
                </c:pt>
                <c:pt idx="1362">
                  <c:v>94.093698000000003</c:v>
                </c:pt>
                <c:pt idx="1363">
                  <c:v>94.078105999999977</c:v>
                </c:pt>
                <c:pt idx="1364">
                  <c:v>94.065669</c:v>
                </c:pt>
                <c:pt idx="1365">
                  <c:v>94.055330999999896</c:v>
                </c:pt>
                <c:pt idx="1366">
                  <c:v>94.045974000000001</c:v>
                </c:pt>
                <c:pt idx="1367">
                  <c:v>94.038697999999982</c:v>
                </c:pt>
                <c:pt idx="1368">
                  <c:v>94.035454999999999</c:v>
                </c:pt>
                <c:pt idx="1369">
                  <c:v>94.034627999999998</c:v>
                </c:pt>
                <c:pt idx="1370">
                  <c:v>94.030229000000006</c:v>
                </c:pt>
                <c:pt idx="1371">
                  <c:v>94.018341999999976</c:v>
                </c:pt>
                <c:pt idx="1372">
                  <c:v>94.001728999999983</c:v>
                </c:pt>
                <c:pt idx="1373">
                  <c:v>93.986559999999997</c:v>
                </c:pt>
                <c:pt idx="1374">
                  <c:v>93.978933999999981</c:v>
                </c:pt>
                <c:pt idx="1375">
                  <c:v>93.982361999999981</c:v>
                </c:pt>
                <c:pt idx="1376">
                  <c:v>93.991628000000006</c:v>
                </c:pt>
                <c:pt idx="1377">
                  <c:v>93.993498000000002</c:v>
                </c:pt>
                <c:pt idx="1378">
                  <c:v>93.980436999999981</c:v>
                </c:pt>
                <c:pt idx="1379">
                  <c:v>93.958494000000002</c:v>
                </c:pt>
                <c:pt idx="1380">
                  <c:v>93.938288</c:v>
                </c:pt>
                <c:pt idx="1381">
                  <c:v>93.924644999999998</c:v>
                </c:pt>
                <c:pt idx="1382">
                  <c:v>93.916388999999981</c:v>
                </c:pt>
                <c:pt idx="1383">
                  <c:v>93.910698999999994</c:v>
                </c:pt>
                <c:pt idx="1384">
                  <c:v>93.905690000000007</c:v>
                </c:pt>
                <c:pt idx="1385">
                  <c:v>93.901311000000007</c:v>
                </c:pt>
                <c:pt idx="1386">
                  <c:v>93.897660999999999</c:v>
                </c:pt>
                <c:pt idx="1387">
                  <c:v>93.892479999999978</c:v>
                </c:pt>
                <c:pt idx="1388">
                  <c:v>93.884123000000002</c:v>
                </c:pt>
                <c:pt idx="1389">
                  <c:v>93.875276999999912</c:v>
                </c:pt>
                <c:pt idx="1390">
                  <c:v>93.869853000000006</c:v>
                </c:pt>
                <c:pt idx="1391">
                  <c:v>93.869447999999977</c:v>
                </c:pt>
                <c:pt idx="1392">
                  <c:v>93.873079999999931</c:v>
                </c:pt>
                <c:pt idx="1393">
                  <c:v>93.876627999999982</c:v>
                </c:pt>
                <c:pt idx="1394">
                  <c:v>93.875239999999977</c:v>
                </c:pt>
                <c:pt idx="1395">
                  <c:v>93.869190000000003</c:v>
                </c:pt>
                <c:pt idx="1396">
                  <c:v>93.863176999999979</c:v>
                </c:pt>
                <c:pt idx="1397">
                  <c:v>93.860196000000002</c:v>
                </c:pt>
                <c:pt idx="1398">
                  <c:v>93.861622999999994</c:v>
                </c:pt>
                <c:pt idx="1399">
                  <c:v>93.867987999999983</c:v>
                </c:pt>
                <c:pt idx="1400">
                  <c:v>93.874696</c:v>
                </c:pt>
                <c:pt idx="1401">
                  <c:v>93.87631099999993</c:v>
                </c:pt>
                <c:pt idx="1402">
                  <c:v>93.875480999999894</c:v>
                </c:pt>
                <c:pt idx="1403">
                  <c:v>93.878333999999896</c:v>
                </c:pt>
                <c:pt idx="1404">
                  <c:v>93.885829999999984</c:v>
                </c:pt>
                <c:pt idx="1405">
                  <c:v>93.895612</c:v>
                </c:pt>
                <c:pt idx="1406">
                  <c:v>93.907088999999999</c:v>
                </c:pt>
                <c:pt idx="1407">
                  <c:v>93.92215299999998</c:v>
                </c:pt>
                <c:pt idx="1408">
                  <c:v>93.941434000000001</c:v>
                </c:pt>
                <c:pt idx="1409">
                  <c:v>93.959298000000004</c:v>
                </c:pt>
                <c:pt idx="1410">
                  <c:v>93.967707000000004</c:v>
                </c:pt>
                <c:pt idx="1411">
                  <c:v>93.967894999999999</c:v>
                </c:pt>
                <c:pt idx="1412">
                  <c:v>93.970107999999982</c:v>
                </c:pt>
                <c:pt idx="1413">
                  <c:v>93.980215999999999</c:v>
                </c:pt>
                <c:pt idx="1414">
                  <c:v>93.995711999999983</c:v>
                </c:pt>
                <c:pt idx="1415">
                  <c:v>94.012962000000002</c:v>
                </c:pt>
                <c:pt idx="1416">
                  <c:v>94.030930999999981</c:v>
                </c:pt>
                <c:pt idx="1417">
                  <c:v>94.049808999999982</c:v>
                </c:pt>
                <c:pt idx="1418">
                  <c:v>94.069812999999982</c:v>
                </c:pt>
                <c:pt idx="1419">
                  <c:v>94.093017000000003</c:v>
                </c:pt>
                <c:pt idx="1420">
                  <c:v>94.122470999999877</c:v>
                </c:pt>
                <c:pt idx="1421">
                  <c:v>94.15328599999998</c:v>
                </c:pt>
                <c:pt idx="1422">
                  <c:v>94.175186999999895</c:v>
                </c:pt>
                <c:pt idx="1423">
                  <c:v>94.190801999999977</c:v>
                </c:pt>
                <c:pt idx="1424">
                  <c:v>94.214256000000006</c:v>
                </c:pt>
                <c:pt idx="1425">
                  <c:v>94.247525999999993</c:v>
                </c:pt>
                <c:pt idx="1426">
                  <c:v>94.276443</c:v>
                </c:pt>
                <c:pt idx="1427">
                  <c:v>94.292901999999998</c:v>
                </c:pt>
                <c:pt idx="1428">
                  <c:v>94.305988999999911</c:v>
                </c:pt>
                <c:pt idx="1429">
                  <c:v>94.326405999999977</c:v>
                </c:pt>
                <c:pt idx="1430">
                  <c:v>94.353727999999975</c:v>
                </c:pt>
                <c:pt idx="1431">
                  <c:v>94.382929000000004</c:v>
                </c:pt>
                <c:pt idx="1432">
                  <c:v>94.411271999999997</c:v>
                </c:pt>
                <c:pt idx="1433">
                  <c:v>94.438237000000001</c:v>
                </c:pt>
                <c:pt idx="1434">
                  <c:v>94.466262999999998</c:v>
                </c:pt>
                <c:pt idx="1435">
                  <c:v>94.497844999999998</c:v>
                </c:pt>
                <c:pt idx="1436">
                  <c:v>94.531025999999997</c:v>
                </c:pt>
                <c:pt idx="1437">
                  <c:v>94.561949999999996</c:v>
                </c:pt>
                <c:pt idx="1438">
                  <c:v>94.590128000000007</c:v>
                </c:pt>
                <c:pt idx="1439">
                  <c:v>94.618854999999982</c:v>
                </c:pt>
                <c:pt idx="1440">
                  <c:v>94.650870999999896</c:v>
                </c:pt>
                <c:pt idx="1441">
                  <c:v>94.68485699999998</c:v>
                </c:pt>
                <c:pt idx="1442">
                  <c:v>94.719452000000004</c:v>
                </c:pt>
                <c:pt idx="1443">
                  <c:v>94.754703000000006</c:v>
                </c:pt>
                <c:pt idx="1444">
                  <c:v>94.786355999999998</c:v>
                </c:pt>
                <c:pt idx="1445">
                  <c:v>94.809893000000002</c:v>
                </c:pt>
                <c:pt idx="1446">
                  <c:v>94.830143000000007</c:v>
                </c:pt>
                <c:pt idx="1447">
                  <c:v>94.855910999999978</c:v>
                </c:pt>
                <c:pt idx="1448">
                  <c:v>94.890276</c:v>
                </c:pt>
                <c:pt idx="1449">
                  <c:v>94.929743000000002</c:v>
                </c:pt>
                <c:pt idx="1450">
                  <c:v>94.966098000000002</c:v>
                </c:pt>
                <c:pt idx="1451">
                  <c:v>94.992974000000004</c:v>
                </c:pt>
                <c:pt idx="1452">
                  <c:v>95.014757000000003</c:v>
                </c:pt>
                <c:pt idx="1453">
                  <c:v>95.040165999999999</c:v>
                </c:pt>
                <c:pt idx="1454">
                  <c:v>95.070684</c:v>
                </c:pt>
                <c:pt idx="1455">
                  <c:v>95.104086999999979</c:v>
                </c:pt>
                <c:pt idx="1456">
                  <c:v>95.140407999999979</c:v>
                </c:pt>
                <c:pt idx="1457">
                  <c:v>95.178386999999859</c:v>
                </c:pt>
                <c:pt idx="1458">
                  <c:v>95.217291000000003</c:v>
                </c:pt>
                <c:pt idx="1459">
                  <c:v>95.261381999999998</c:v>
                </c:pt>
                <c:pt idx="1460">
                  <c:v>95.310075999999981</c:v>
                </c:pt>
                <c:pt idx="1461">
                  <c:v>95.351254999999995</c:v>
                </c:pt>
                <c:pt idx="1462">
                  <c:v>95.378229999999974</c:v>
                </c:pt>
                <c:pt idx="1463">
                  <c:v>95.401224999999997</c:v>
                </c:pt>
                <c:pt idx="1464">
                  <c:v>95.433041000000003</c:v>
                </c:pt>
                <c:pt idx="1465">
                  <c:v>95.476371999999927</c:v>
                </c:pt>
                <c:pt idx="1466">
                  <c:v>95.527157000000003</c:v>
                </c:pt>
                <c:pt idx="1467">
                  <c:v>95.578826999999976</c:v>
                </c:pt>
                <c:pt idx="1468">
                  <c:v>95.625320999999929</c:v>
                </c:pt>
                <c:pt idx="1469">
                  <c:v>95.666983000000002</c:v>
                </c:pt>
                <c:pt idx="1470">
                  <c:v>95.710032999999981</c:v>
                </c:pt>
                <c:pt idx="1471">
                  <c:v>95.756306999999978</c:v>
                </c:pt>
                <c:pt idx="1472">
                  <c:v>95.801501000000002</c:v>
                </c:pt>
                <c:pt idx="1473">
                  <c:v>95.846193</c:v>
                </c:pt>
                <c:pt idx="1474">
                  <c:v>95.89676799999998</c:v>
                </c:pt>
                <c:pt idx="1475">
                  <c:v>95.953862000000001</c:v>
                </c:pt>
                <c:pt idx="1476">
                  <c:v>96.012174000000002</c:v>
                </c:pt>
                <c:pt idx="1477">
                  <c:v>96.071354999999983</c:v>
                </c:pt>
                <c:pt idx="1478">
                  <c:v>96.133403000000001</c:v>
                </c:pt>
                <c:pt idx="1479">
                  <c:v>96.190055999999998</c:v>
                </c:pt>
                <c:pt idx="1480">
                  <c:v>96.232648999999981</c:v>
                </c:pt>
                <c:pt idx="1481">
                  <c:v>96.270817999999977</c:v>
                </c:pt>
                <c:pt idx="1482">
                  <c:v>96.317295000000001</c:v>
                </c:pt>
                <c:pt idx="1483">
                  <c:v>96.367002999999983</c:v>
                </c:pt>
                <c:pt idx="1484">
                  <c:v>96.410909000000004</c:v>
                </c:pt>
                <c:pt idx="1485">
                  <c:v>96.450905000000006</c:v>
                </c:pt>
                <c:pt idx="1486">
                  <c:v>96.492647000000005</c:v>
                </c:pt>
                <c:pt idx="1487">
                  <c:v>96.540192000000005</c:v>
                </c:pt>
                <c:pt idx="1488">
                  <c:v>96.596149999999994</c:v>
                </c:pt>
                <c:pt idx="1489">
                  <c:v>96.657096999999979</c:v>
                </c:pt>
                <c:pt idx="1490">
                  <c:v>96.713853999999998</c:v>
                </c:pt>
                <c:pt idx="1491">
                  <c:v>96.760649000000001</c:v>
                </c:pt>
                <c:pt idx="1492">
                  <c:v>96.798623000000006</c:v>
                </c:pt>
                <c:pt idx="1493">
                  <c:v>96.831018</c:v>
                </c:pt>
                <c:pt idx="1494">
                  <c:v>96.862756999999945</c:v>
                </c:pt>
                <c:pt idx="1495">
                  <c:v>96.900334000000001</c:v>
                </c:pt>
                <c:pt idx="1496">
                  <c:v>96.942937999999998</c:v>
                </c:pt>
                <c:pt idx="1497">
                  <c:v>96.982570999999979</c:v>
                </c:pt>
                <c:pt idx="1498">
                  <c:v>97.021743000000001</c:v>
                </c:pt>
                <c:pt idx="1499">
                  <c:v>97.075106999999946</c:v>
                </c:pt>
                <c:pt idx="1500">
                  <c:v>97.144974000000005</c:v>
                </c:pt>
                <c:pt idx="1501">
                  <c:v>97.209918999999999</c:v>
                </c:pt>
                <c:pt idx="1502">
                  <c:v>97.249307999999999</c:v>
                </c:pt>
                <c:pt idx="1503">
                  <c:v>97.271524999999997</c:v>
                </c:pt>
                <c:pt idx="1504">
                  <c:v>97.298311999999981</c:v>
                </c:pt>
                <c:pt idx="1505">
                  <c:v>97.330769999999987</c:v>
                </c:pt>
                <c:pt idx="1506">
                  <c:v>97.359749999999977</c:v>
                </c:pt>
                <c:pt idx="1507">
                  <c:v>97.391164000000003</c:v>
                </c:pt>
                <c:pt idx="1508">
                  <c:v>97.434415999999999</c:v>
                </c:pt>
                <c:pt idx="1509">
                  <c:v>97.489694</c:v>
                </c:pt>
                <c:pt idx="1510">
                  <c:v>97.563391999999979</c:v>
                </c:pt>
                <c:pt idx="1511">
                  <c:v>97.663359</c:v>
                </c:pt>
                <c:pt idx="1512">
                  <c:v>97.758792999999912</c:v>
                </c:pt>
                <c:pt idx="1513">
                  <c:v>97.792385999999979</c:v>
                </c:pt>
                <c:pt idx="1514">
                  <c:v>97.762300999999979</c:v>
                </c:pt>
                <c:pt idx="1515">
                  <c:v>97.730624000000006</c:v>
                </c:pt>
                <c:pt idx="1516">
                  <c:v>97.737971000000002</c:v>
                </c:pt>
                <c:pt idx="1517">
                  <c:v>97.772771999999875</c:v>
                </c:pt>
                <c:pt idx="1518">
                  <c:v>97.813697000000005</c:v>
                </c:pt>
                <c:pt idx="1519">
                  <c:v>97.855868999999927</c:v>
                </c:pt>
                <c:pt idx="1520">
                  <c:v>97.910680999999997</c:v>
                </c:pt>
                <c:pt idx="1521">
                  <c:v>97.999934999999994</c:v>
                </c:pt>
                <c:pt idx="1522">
                  <c:v>98.118960999999999</c:v>
                </c:pt>
                <c:pt idx="1523">
                  <c:v>98.206136000000001</c:v>
                </c:pt>
                <c:pt idx="1524">
                  <c:v>98.213740999999999</c:v>
                </c:pt>
                <c:pt idx="1525">
                  <c:v>98.187338999999895</c:v>
                </c:pt>
                <c:pt idx="1526">
                  <c:v>98.193117999999998</c:v>
                </c:pt>
                <c:pt idx="1527">
                  <c:v>98.227283999999997</c:v>
                </c:pt>
                <c:pt idx="1528">
                  <c:v>98.258306999999945</c:v>
                </c:pt>
                <c:pt idx="1529">
                  <c:v>98.281886999999998</c:v>
                </c:pt>
                <c:pt idx="1530">
                  <c:v>98.304533000000006</c:v>
                </c:pt>
                <c:pt idx="1531">
                  <c:v>98.337334999999982</c:v>
                </c:pt>
                <c:pt idx="1532">
                  <c:v>98.407422999999994</c:v>
                </c:pt>
                <c:pt idx="1533">
                  <c:v>98.520658999999981</c:v>
                </c:pt>
                <c:pt idx="1534">
                  <c:v>98.628394999999927</c:v>
                </c:pt>
                <c:pt idx="1535">
                  <c:v>98.682790999999895</c:v>
                </c:pt>
                <c:pt idx="1536">
                  <c:v>98.694222999999994</c:v>
                </c:pt>
                <c:pt idx="1537">
                  <c:v>98.707662999999997</c:v>
                </c:pt>
                <c:pt idx="1538">
                  <c:v>98.757555999999994</c:v>
                </c:pt>
                <c:pt idx="1539">
                  <c:v>98.820549</c:v>
                </c:pt>
                <c:pt idx="1540">
                  <c:v>98.827494999999999</c:v>
                </c:pt>
                <c:pt idx="1541">
                  <c:v>98.782161000000002</c:v>
                </c:pt>
                <c:pt idx="1542">
                  <c:v>98.799199999999999</c:v>
                </c:pt>
                <c:pt idx="1543">
                  <c:v>98.960303999999994</c:v>
                </c:pt>
                <c:pt idx="1544">
                  <c:v>99.165276999999946</c:v>
                </c:pt>
                <c:pt idx="1545">
                  <c:v>99.215889000000004</c:v>
                </c:pt>
                <c:pt idx="1546">
                  <c:v>99.093275000000006</c:v>
                </c:pt>
                <c:pt idx="1547">
                  <c:v>98.960106999999994</c:v>
                </c:pt>
                <c:pt idx="1548">
                  <c:v>98.903632999999999</c:v>
                </c:pt>
                <c:pt idx="1549">
                  <c:v>98.897735999999981</c:v>
                </c:pt>
                <c:pt idx="1550">
                  <c:v>98.914435999999995</c:v>
                </c:pt>
                <c:pt idx="1551">
                  <c:v>98.95207199999993</c:v>
                </c:pt>
                <c:pt idx="1552">
                  <c:v>99.038077999999928</c:v>
                </c:pt>
                <c:pt idx="1553">
                  <c:v>99.216777999999977</c:v>
                </c:pt>
                <c:pt idx="1554">
                  <c:v>99.456280000000007</c:v>
                </c:pt>
                <c:pt idx="1555">
                  <c:v>99.599294999999998</c:v>
                </c:pt>
                <c:pt idx="1556">
                  <c:v>99.541106999999997</c:v>
                </c:pt>
                <c:pt idx="1557">
                  <c:v>99.402297000000004</c:v>
                </c:pt>
                <c:pt idx="1558">
                  <c:v>99.334235000000007</c:v>
                </c:pt>
                <c:pt idx="1559">
                  <c:v>99.306151999999983</c:v>
                </c:pt>
                <c:pt idx="1560">
                  <c:v>99.242840000000001</c:v>
                </c:pt>
                <c:pt idx="1561">
                  <c:v>99.175992999999892</c:v>
                </c:pt>
                <c:pt idx="1562">
                  <c:v>99.158163000000002</c:v>
                </c:pt>
                <c:pt idx="1563">
                  <c:v>99.207419000000002</c:v>
                </c:pt>
                <c:pt idx="1564">
                  <c:v>99.349113000000003</c:v>
                </c:pt>
                <c:pt idx="1565">
                  <c:v>99.557457999999983</c:v>
                </c:pt>
                <c:pt idx="1566">
                  <c:v>99.719264999999993</c:v>
                </c:pt>
                <c:pt idx="1567">
                  <c:v>99.798738999999927</c:v>
                </c:pt>
                <c:pt idx="1568">
                  <c:v>99.851383999999982</c:v>
                </c:pt>
                <c:pt idx="1569">
                  <c:v>99.821816999999982</c:v>
                </c:pt>
                <c:pt idx="1570">
                  <c:v>99.648625999999993</c:v>
                </c:pt>
                <c:pt idx="1571">
                  <c:v>99.447306999999995</c:v>
                </c:pt>
                <c:pt idx="1572">
                  <c:v>99.345331999999928</c:v>
                </c:pt>
                <c:pt idx="1573">
                  <c:v>99.378993999999977</c:v>
                </c:pt>
                <c:pt idx="1574">
                  <c:v>99.547869000000006</c:v>
                </c:pt>
                <c:pt idx="1575">
                  <c:v>99.749205000000003</c:v>
                </c:pt>
                <c:pt idx="1576">
                  <c:v>99.797471999999999</c:v>
                </c:pt>
                <c:pt idx="1577">
                  <c:v>99.657599000000005</c:v>
                </c:pt>
                <c:pt idx="1578">
                  <c:v>99.478776999999894</c:v>
                </c:pt>
                <c:pt idx="1579">
                  <c:v>99.377231999999978</c:v>
                </c:pt>
                <c:pt idx="1580">
                  <c:v>99.361650999999995</c:v>
                </c:pt>
                <c:pt idx="1581">
                  <c:v>99.400093999999996</c:v>
                </c:pt>
                <c:pt idx="1582">
                  <c:v>99.441142999999997</c:v>
                </c:pt>
                <c:pt idx="1583">
                  <c:v>99.440814000000003</c:v>
                </c:pt>
                <c:pt idx="1584">
                  <c:v>99.430826999999994</c:v>
                </c:pt>
                <c:pt idx="1585">
                  <c:v>99.490388999999979</c:v>
                </c:pt>
                <c:pt idx="1586">
                  <c:v>99.62909999999998</c:v>
                </c:pt>
                <c:pt idx="1587">
                  <c:v>99.741654999999994</c:v>
                </c:pt>
                <c:pt idx="1588">
                  <c:v>99.713170000000005</c:v>
                </c:pt>
                <c:pt idx="1589">
                  <c:v>99.573777999999876</c:v>
                </c:pt>
                <c:pt idx="1590">
                  <c:v>99.461020000000005</c:v>
                </c:pt>
                <c:pt idx="1591">
                  <c:v>99.442150999999996</c:v>
                </c:pt>
                <c:pt idx="1592">
                  <c:v>99.479140000000001</c:v>
                </c:pt>
                <c:pt idx="1593">
                  <c:v>99.520793999999981</c:v>
                </c:pt>
                <c:pt idx="1594">
                  <c:v>99.544083000000001</c:v>
                </c:pt>
                <c:pt idx="1595">
                  <c:v>99.545316999999983</c:v>
                </c:pt>
                <c:pt idx="1596">
                  <c:v>99.560586999999998</c:v>
                </c:pt>
                <c:pt idx="1597">
                  <c:v>99.647328999999999</c:v>
                </c:pt>
                <c:pt idx="1598">
                  <c:v>99.794584999999998</c:v>
                </c:pt>
                <c:pt idx="1599">
                  <c:v>99.910630000000026</c:v>
                </c:pt>
                <c:pt idx="1600">
                  <c:v>99.908767999999981</c:v>
                </c:pt>
                <c:pt idx="1601">
                  <c:v>99.795947999999981</c:v>
                </c:pt>
                <c:pt idx="1602">
                  <c:v>99.729397999999946</c:v>
                </c:pt>
                <c:pt idx="1603">
                  <c:v>99.872991999999911</c:v>
                </c:pt>
                <c:pt idx="1604">
                  <c:v>100.122608</c:v>
                </c:pt>
                <c:pt idx="1605">
                  <c:v>100.225346</c:v>
                </c:pt>
                <c:pt idx="1606">
                  <c:v>100.20340400000001</c:v>
                </c:pt>
                <c:pt idx="1607">
                  <c:v>100.215191</c:v>
                </c:pt>
                <c:pt idx="1608">
                  <c:v>100.174071</c:v>
                </c:pt>
                <c:pt idx="1609">
                  <c:v>99.961685000000003</c:v>
                </c:pt>
                <c:pt idx="1610">
                  <c:v>99.710290000000001</c:v>
                </c:pt>
                <c:pt idx="1611">
                  <c:v>99.578859999999978</c:v>
                </c:pt>
                <c:pt idx="1612">
                  <c:v>99.539261999999994</c:v>
                </c:pt>
                <c:pt idx="1613">
                  <c:v>99.503173000000004</c:v>
                </c:pt>
                <c:pt idx="1614">
                  <c:v>99.472681999999978</c:v>
                </c:pt>
                <c:pt idx="1615">
                  <c:v>99.482034999999982</c:v>
                </c:pt>
                <c:pt idx="1616">
                  <c:v>99.518221999999994</c:v>
                </c:pt>
                <c:pt idx="1617">
                  <c:v>99.540278000000001</c:v>
                </c:pt>
                <c:pt idx="1618">
                  <c:v>99.509830999999977</c:v>
                </c:pt>
                <c:pt idx="1619">
                  <c:v>99.435586999999998</c:v>
                </c:pt>
                <c:pt idx="1620">
                  <c:v>99.383940999999979</c:v>
                </c:pt>
                <c:pt idx="1621">
                  <c:v>99.39663299999998</c:v>
                </c:pt>
                <c:pt idx="1622">
                  <c:v>99.437247999999997</c:v>
                </c:pt>
                <c:pt idx="1623">
                  <c:v>99.446693999999994</c:v>
                </c:pt>
                <c:pt idx="1624">
                  <c:v>99.420841999999979</c:v>
                </c:pt>
                <c:pt idx="1625">
                  <c:v>99.393985999999998</c:v>
                </c:pt>
                <c:pt idx="1626">
                  <c:v>99.375015999999945</c:v>
                </c:pt>
                <c:pt idx="1627">
                  <c:v>99.35597499999993</c:v>
                </c:pt>
                <c:pt idx="1628">
                  <c:v>99.345390999999978</c:v>
                </c:pt>
                <c:pt idx="1629">
                  <c:v>99.361508000000001</c:v>
                </c:pt>
                <c:pt idx="1630">
                  <c:v>99.413596999999996</c:v>
                </c:pt>
                <c:pt idx="1631">
                  <c:v>99.49391</c:v>
                </c:pt>
                <c:pt idx="1632">
                  <c:v>99.610057999999981</c:v>
                </c:pt>
                <c:pt idx="1633">
                  <c:v>99.758577999999929</c:v>
                </c:pt>
                <c:pt idx="1634">
                  <c:v>99.842349999999982</c:v>
                </c:pt>
                <c:pt idx="1635">
                  <c:v>99.802531999999928</c:v>
                </c:pt>
                <c:pt idx="1636">
                  <c:v>99.729005999999998</c:v>
                </c:pt>
                <c:pt idx="1637">
                  <c:v>99.656345999999928</c:v>
                </c:pt>
                <c:pt idx="1638">
                  <c:v>99.54227299999998</c:v>
                </c:pt>
                <c:pt idx="1639">
                  <c:v>99.469721000000007</c:v>
                </c:pt>
                <c:pt idx="1640">
                  <c:v>99.555467999999976</c:v>
                </c:pt>
                <c:pt idx="1641">
                  <c:v>99.729495</c:v>
                </c:pt>
                <c:pt idx="1642">
                  <c:v>99.828854999999976</c:v>
                </c:pt>
                <c:pt idx="1643">
                  <c:v>99.837637000000001</c:v>
                </c:pt>
                <c:pt idx="1644">
                  <c:v>99.806773999999976</c:v>
                </c:pt>
                <c:pt idx="1645">
                  <c:v>99.708603999999994</c:v>
                </c:pt>
                <c:pt idx="1646">
                  <c:v>99.56838399999998</c:v>
                </c:pt>
                <c:pt idx="1647">
                  <c:v>99.481178999999983</c:v>
                </c:pt>
                <c:pt idx="1648">
                  <c:v>99.473793000000001</c:v>
                </c:pt>
                <c:pt idx="1649">
                  <c:v>99.518253000000001</c:v>
                </c:pt>
                <c:pt idx="1650">
                  <c:v>99.599929000000003</c:v>
                </c:pt>
                <c:pt idx="1651">
                  <c:v>99.729123999999999</c:v>
                </c:pt>
                <c:pt idx="1652">
                  <c:v>99.877336999999912</c:v>
                </c:pt>
                <c:pt idx="1653">
                  <c:v>99.927030999999999</c:v>
                </c:pt>
                <c:pt idx="1654">
                  <c:v>99.818859000000003</c:v>
                </c:pt>
                <c:pt idx="1655">
                  <c:v>99.651099000000002</c:v>
                </c:pt>
                <c:pt idx="1656">
                  <c:v>99.519787999999977</c:v>
                </c:pt>
                <c:pt idx="1657">
                  <c:v>99.446943000000005</c:v>
                </c:pt>
                <c:pt idx="1658">
                  <c:v>99.490263999999996</c:v>
                </c:pt>
                <c:pt idx="1659">
                  <c:v>99.745689999999996</c:v>
                </c:pt>
                <c:pt idx="1660">
                  <c:v>100.147474</c:v>
                </c:pt>
                <c:pt idx="1661">
                  <c:v>100.356843</c:v>
                </c:pt>
                <c:pt idx="1662">
                  <c:v>100.141525</c:v>
                </c:pt>
                <c:pt idx="1663">
                  <c:v>99.750439999999998</c:v>
                </c:pt>
                <c:pt idx="1664">
                  <c:v>99.52872799999993</c:v>
                </c:pt>
                <c:pt idx="1665">
                  <c:v>99.52149</c:v>
                </c:pt>
                <c:pt idx="1666">
                  <c:v>99.591226000000006</c:v>
                </c:pt>
                <c:pt idx="1667">
                  <c:v>99.644518000000005</c:v>
                </c:pt>
                <c:pt idx="1668">
                  <c:v>99.694907999999998</c:v>
                </c:pt>
                <c:pt idx="1669">
                  <c:v>99.748697000000007</c:v>
                </c:pt>
                <c:pt idx="1670">
                  <c:v>99.734883999999994</c:v>
                </c:pt>
                <c:pt idx="1671">
                  <c:v>99.633454999999998</c:v>
                </c:pt>
                <c:pt idx="1672">
                  <c:v>99.522094999999979</c:v>
                </c:pt>
                <c:pt idx="1673">
                  <c:v>99.470119999999994</c:v>
                </c:pt>
                <c:pt idx="1674">
                  <c:v>99.486464999999995</c:v>
                </c:pt>
                <c:pt idx="1675">
                  <c:v>99.529727999999977</c:v>
                </c:pt>
                <c:pt idx="1676">
                  <c:v>99.572524000000001</c:v>
                </c:pt>
                <c:pt idx="1677">
                  <c:v>99.609009</c:v>
                </c:pt>
                <c:pt idx="1678">
                  <c:v>99.601799</c:v>
                </c:pt>
                <c:pt idx="1679">
                  <c:v>99.55829199999998</c:v>
                </c:pt>
                <c:pt idx="1680">
                  <c:v>99.533499000000006</c:v>
                </c:pt>
                <c:pt idx="1681">
                  <c:v>99.505051999999978</c:v>
                </c:pt>
                <c:pt idx="1682">
                  <c:v>99.448995999999994</c:v>
                </c:pt>
                <c:pt idx="1683">
                  <c:v>99.439134999999993</c:v>
                </c:pt>
                <c:pt idx="1684">
                  <c:v>99.521896999999981</c:v>
                </c:pt>
                <c:pt idx="1685">
                  <c:v>99.637671999999981</c:v>
                </c:pt>
                <c:pt idx="1686">
                  <c:v>99.702106999999998</c:v>
                </c:pt>
                <c:pt idx="1687">
                  <c:v>99.668487999999911</c:v>
                </c:pt>
                <c:pt idx="1688">
                  <c:v>99.545648999999983</c:v>
                </c:pt>
                <c:pt idx="1689">
                  <c:v>99.404940999999994</c:v>
                </c:pt>
                <c:pt idx="1690">
                  <c:v>99.318579999999983</c:v>
                </c:pt>
                <c:pt idx="1691">
                  <c:v>99.297807000000006</c:v>
                </c:pt>
                <c:pt idx="1692">
                  <c:v>99.322654</c:v>
                </c:pt>
                <c:pt idx="1693">
                  <c:v>99.373094999999978</c:v>
                </c:pt>
                <c:pt idx="1694">
                  <c:v>99.413038</c:v>
                </c:pt>
                <c:pt idx="1695">
                  <c:v>99.411693999999997</c:v>
                </c:pt>
                <c:pt idx="1696">
                  <c:v>99.384173000000004</c:v>
                </c:pt>
                <c:pt idx="1697">
                  <c:v>99.362708999999896</c:v>
                </c:pt>
                <c:pt idx="1698">
                  <c:v>99.350053000000003</c:v>
                </c:pt>
                <c:pt idx="1699">
                  <c:v>99.339574999999982</c:v>
                </c:pt>
                <c:pt idx="1700">
                  <c:v>99.342784999999978</c:v>
                </c:pt>
                <c:pt idx="1701">
                  <c:v>99.358904999999979</c:v>
                </c:pt>
                <c:pt idx="1702">
                  <c:v>99.359078999999895</c:v>
                </c:pt>
                <c:pt idx="1703">
                  <c:v>99.331063</c:v>
                </c:pt>
                <c:pt idx="1704">
                  <c:v>99.299836999999982</c:v>
                </c:pt>
                <c:pt idx="1705">
                  <c:v>99.29119</c:v>
                </c:pt>
                <c:pt idx="1706">
                  <c:v>99.304551000000004</c:v>
                </c:pt>
                <c:pt idx="1707">
                  <c:v>99.319723999999994</c:v>
                </c:pt>
                <c:pt idx="1708">
                  <c:v>99.322535999999928</c:v>
                </c:pt>
                <c:pt idx="1709">
                  <c:v>99.320014999999998</c:v>
                </c:pt>
                <c:pt idx="1710">
                  <c:v>99.318657999999999</c:v>
                </c:pt>
                <c:pt idx="1711">
                  <c:v>99.309399999999982</c:v>
                </c:pt>
                <c:pt idx="1712">
                  <c:v>99.288964000000007</c:v>
                </c:pt>
                <c:pt idx="1713">
                  <c:v>99.269597000000005</c:v>
                </c:pt>
                <c:pt idx="1714">
                  <c:v>99.261301000000003</c:v>
                </c:pt>
                <c:pt idx="1715">
                  <c:v>99.261878999999979</c:v>
                </c:pt>
                <c:pt idx="1716">
                  <c:v>99.264065000000002</c:v>
                </c:pt>
                <c:pt idx="1717">
                  <c:v>99.262292000000002</c:v>
                </c:pt>
                <c:pt idx="1718">
                  <c:v>99.254647000000006</c:v>
                </c:pt>
                <c:pt idx="1719">
                  <c:v>99.245446999999999</c:v>
                </c:pt>
                <c:pt idx="1720">
                  <c:v>99.241326000000001</c:v>
                </c:pt>
                <c:pt idx="1721">
                  <c:v>99.242660999999998</c:v>
                </c:pt>
                <c:pt idx="1722">
                  <c:v>99.244829999999993</c:v>
                </c:pt>
                <c:pt idx="1723">
                  <c:v>99.244328999999993</c:v>
                </c:pt>
                <c:pt idx="1724">
                  <c:v>99.240319999999997</c:v>
                </c:pt>
                <c:pt idx="1725">
                  <c:v>99.234962999999993</c:v>
                </c:pt>
                <c:pt idx="1726">
                  <c:v>99.231752999999998</c:v>
                </c:pt>
                <c:pt idx="1727">
                  <c:v>99.231082999999998</c:v>
                </c:pt>
                <c:pt idx="1728">
                  <c:v>99.229975999999979</c:v>
                </c:pt>
                <c:pt idx="1729">
                  <c:v>99.226921000000004</c:v>
                </c:pt>
                <c:pt idx="1730">
                  <c:v>99.224401</c:v>
                </c:pt>
                <c:pt idx="1731">
                  <c:v>99.22510699999998</c:v>
                </c:pt>
                <c:pt idx="1732">
                  <c:v>99.227258000000006</c:v>
                </c:pt>
                <c:pt idx="1733">
                  <c:v>99.227079000000003</c:v>
                </c:pt>
                <c:pt idx="1734">
                  <c:v>99.224019999999996</c:v>
                </c:pt>
                <c:pt idx="1735">
                  <c:v>99.22028899999998</c:v>
                </c:pt>
                <c:pt idx="1736">
                  <c:v>99.217693999999995</c:v>
                </c:pt>
                <c:pt idx="1737">
                  <c:v>99.216125000000005</c:v>
                </c:pt>
                <c:pt idx="1738">
                  <c:v>99.214537000000007</c:v>
                </c:pt>
              </c:numCache>
            </c:numRef>
          </c:yVal>
          <c:smooth val="1"/>
        </c:ser>
        <c:ser>
          <c:idx val="2"/>
          <c:order val="2"/>
          <c:tx>
            <c:v>TMS</c:v>
          </c:tx>
          <c:marker>
            <c:symbol val="none"/>
          </c:marker>
          <c:xVal>
            <c:numRef>
              <c:f>IR!$A:$A</c:f>
              <c:numCache>
                <c:formatCode>General</c:formatCode>
                <c:ptCount val="1048576"/>
                <c:pt idx="0">
                  <c:v>649.90114399999948</c:v>
                </c:pt>
                <c:pt idx="1">
                  <c:v>651.82963400000006</c:v>
                </c:pt>
                <c:pt idx="2">
                  <c:v>653.75812399999938</c:v>
                </c:pt>
                <c:pt idx="3">
                  <c:v>655.68661499999996</c:v>
                </c:pt>
                <c:pt idx="4">
                  <c:v>657.61510499999997</c:v>
                </c:pt>
                <c:pt idx="5">
                  <c:v>659.54359499999998</c:v>
                </c:pt>
                <c:pt idx="6">
                  <c:v>661.47208499999999</c:v>
                </c:pt>
                <c:pt idx="7">
                  <c:v>663.400575</c:v>
                </c:pt>
                <c:pt idx="8">
                  <c:v>665.32906499999945</c:v>
                </c:pt>
                <c:pt idx="9">
                  <c:v>667.25755499999946</c:v>
                </c:pt>
                <c:pt idx="10">
                  <c:v>669.18604500000004</c:v>
                </c:pt>
                <c:pt idx="11">
                  <c:v>671.11453500000005</c:v>
                </c:pt>
                <c:pt idx="12">
                  <c:v>673.04302499999937</c:v>
                </c:pt>
                <c:pt idx="13">
                  <c:v>674.97151499999939</c:v>
                </c:pt>
                <c:pt idx="14">
                  <c:v>676.90000499999996</c:v>
                </c:pt>
                <c:pt idx="15">
                  <c:v>678.82849499999998</c:v>
                </c:pt>
                <c:pt idx="16">
                  <c:v>680.75698499999999</c:v>
                </c:pt>
                <c:pt idx="17">
                  <c:v>682.685475</c:v>
                </c:pt>
                <c:pt idx="18">
                  <c:v>684.61396500000001</c:v>
                </c:pt>
                <c:pt idx="19">
                  <c:v>686.54245499999945</c:v>
                </c:pt>
                <c:pt idx="20">
                  <c:v>688.47094500000003</c:v>
                </c:pt>
                <c:pt idx="21">
                  <c:v>690.39943500000004</c:v>
                </c:pt>
                <c:pt idx="22">
                  <c:v>692.32792499999914</c:v>
                </c:pt>
                <c:pt idx="23">
                  <c:v>694.25641499999938</c:v>
                </c:pt>
                <c:pt idx="24">
                  <c:v>696.18490499999996</c:v>
                </c:pt>
                <c:pt idx="25">
                  <c:v>698.11339499999997</c:v>
                </c:pt>
                <c:pt idx="26">
                  <c:v>700.04188499999998</c:v>
                </c:pt>
                <c:pt idx="27">
                  <c:v>701.97037599999999</c:v>
                </c:pt>
                <c:pt idx="28">
                  <c:v>703.898866</c:v>
                </c:pt>
                <c:pt idx="29">
                  <c:v>705.82735599999944</c:v>
                </c:pt>
                <c:pt idx="30">
                  <c:v>707.75584600000002</c:v>
                </c:pt>
                <c:pt idx="31">
                  <c:v>709.68433600000003</c:v>
                </c:pt>
                <c:pt idx="32">
                  <c:v>711.61282599999947</c:v>
                </c:pt>
                <c:pt idx="33">
                  <c:v>713.54131599999948</c:v>
                </c:pt>
                <c:pt idx="34">
                  <c:v>715.46980599999938</c:v>
                </c:pt>
                <c:pt idx="35">
                  <c:v>717.39829599999996</c:v>
                </c:pt>
                <c:pt idx="36">
                  <c:v>719.32678599999997</c:v>
                </c:pt>
                <c:pt idx="37">
                  <c:v>721.25527599999998</c:v>
                </c:pt>
                <c:pt idx="38">
                  <c:v>723.18376599999999</c:v>
                </c:pt>
                <c:pt idx="39">
                  <c:v>725.11225599999932</c:v>
                </c:pt>
                <c:pt idx="40">
                  <c:v>727.04074600000001</c:v>
                </c:pt>
                <c:pt idx="41">
                  <c:v>728.96923599999946</c:v>
                </c:pt>
                <c:pt idx="42">
                  <c:v>730.89772599999947</c:v>
                </c:pt>
                <c:pt idx="43">
                  <c:v>732.82621599999902</c:v>
                </c:pt>
                <c:pt idx="44">
                  <c:v>734.75470600000006</c:v>
                </c:pt>
                <c:pt idx="45">
                  <c:v>736.68319599999995</c:v>
                </c:pt>
                <c:pt idx="46">
                  <c:v>738.61168599999996</c:v>
                </c:pt>
                <c:pt idx="47">
                  <c:v>740.54017599999997</c:v>
                </c:pt>
                <c:pt idx="48">
                  <c:v>742.4686659999993</c:v>
                </c:pt>
                <c:pt idx="49">
                  <c:v>744.39715599999931</c:v>
                </c:pt>
                <c:pt idx="50">
                  <c:v>746.32564699999932</c:v>
                </c:pt>
                <c:pt idx="51">
                  <c:v>748.25413700000001</c:v>
                </c:pt>
                <c:pt idx="52">
                  <c:v>750.18262699999946</c:v>
                </c:pt>
                <c:pt idx="53">
                  <c:v>752.11111699999947</c:v>
                </c:pt>
                <c:pt idx="54">
                  <c:v>754.03960699999948</c:v>
                </c:pt>
                <c:pt idx="55">
                  <c:v>755.96809699999937</c:v>
                </c:pt>
                <c:pt idx="56">
                  <c:v>757.89658699999939</c:v>
                </c:pt>
                <c:pt idx="57">
                  <c:v>759.82507699999996</c:v>
                </c:pt>
                <c:pt idx="58">
                  <c:v>761.75356699999998</c:v>
                </c:pt>
                <c:pt idx="59">
                  <c:v>763.68205699999999</c:v>
                </c:pt>
                <c:pt idx="60">
                  <c:v>765.610547</c:v>
                </c:pt>
                <c:pt idx="61">
                  <c:v>767.53903700000001</c:v>
                </c:pt>
                <c:pt idx="62">
                  <c:v>769.46752699999888</c:v>
                </c:pt>
                <c:pt idx="63">
                  <c:v>771.39601699999946</c:v>
                </c:pt>
                <c:pt idx="64">
                  <c:v>773.32450699999947</c:v>
                </c:pt>
                <c:pt idx="65">
                  <c:v>775.25299699999948</c:v>
                </c:pt>
                <c:pt idx="66">
                  <c:v>777.18148699999995</c:v>
                </c:pt>
                <c:pt idx="67">
                  <c:v>779.10997699999996</c:v>
                </c:pt>
                <c:pt idx="68">
                  <c:v>781.03846699999997</c:v>
                </c:pt>
                <c:pt idx="69">
                  <c:v>782.9669569999993</c:v>
                </c:pt>
                <c:pt idx="70">
                  <c:v>784.89544699999999</c:v>
                </c:pt>
                <c:pt idx="71">
                  <c:v>786.823937</c:v>
                </c:pt>
                <c:pt idx="72">
                  <c:v>788.75242699999944</c:v>
                </c:pt>
                <c:pt idx="73">
                  <c:v>790.68091800000002</c:v>
                </c:pt>
                <c:pt idx="74">
                  <c:v>792.60940800000003</c:v>
                </c:pt>
                <c:pt idx="75">
                  <c:v>794.53789799999947</c:v>
                </c:pt>
                <c:pt idx="76">
                  <c:v>796.46638799999948</c:v>
                </c:pt>
                <c:pt idx="77">
                  <c:v>798.39487799999995</c:v>
                </c:pt>
                <c:pt idx="78">
                  <c:v>800.32336799999996</c:v>
                </c:pt>
                <c:pt idx="79">
                  <c:v>802.25185799999997</c:v>
                </c:pt>
                <c:pt idx="80">
                  <c:v>804.18034799999998</c:v>
                </c:pt>
                <c:pt idx="81">
                  <c:v>806.10883799999999</c:v>
                </c:pt>
                <c:pt idx="82">
                  <c:v>808.03732799999932</c:v>
                </c:pt>
                <c:pt idx="83">
                  <c:v>809.96581799999944</c:v>
                </c:pt>
                <c:pt idx="84">
                  <c:v>811.89430800000002</c:v>
                </c:pt>
                <c:pt idx="85">
                  <c:v>813.82279799999947</c:v>
                </c:pt>
                <c:pt idx="86">
                  <c:v>815.75128799999948</c:v>
                </c:pt>
                <c:pt idx="87">
                  <c:v>817.67977800000074</c:v>
                </c:pt>
                <c:pt idx="88">
                  <c:v>819.60826799999938</c:v>
                </c:pt>
                <c:pt idx="89">
                  <c:v>821.53675799999996</c:v>
                </c:pt>
                <c:pt idx="90">
                  <c:v>823.46524799999918</c:v>
                </c:pt>
                <c:pt idx="91">
                  <c:v>825.39373799999998</c:v>
                </c:pt>
                <c:pt idx="92">
                  <c:v>827.32222799999874</c:v>
                </c:pt>
                <c:pt idx="93">
                  <c:v>829.25071800000001</c:v>
                </c:pt>
                <c:pt idx="94">
                  <c:v>831.17920800000002</c:v>
                </c:pt>
                <c:pt idx="95">
                  <c:v>833.10769799999946</c:v>
                </c:pt>
                <c:pt idx="96">
                  <c:v>835.03618799999947</c:v>
                </c:pt>
                <c:pt idx="97">
                  <c:v>836.96467899999948</c:v>
                </c:pt>
                <c:pt idx="98">
                  <c:v>838.89316899999938</c:v>
                </c:pt>
                <c:pt idx="99">
                  <c:v>840.82165899999904</c:v>
                </c:pt>
                <c:pt idx="100">
                  <c:v>842.75014899999996</c:v>
                </c:pt>
                <c:pt idx="101">
                  <c:v>844.67863899999998</c:v>
                </c:pt>
                <c:pt idx="102">
                  <c:v>846.6071289999993</c:v>
                </c:pt>
                <c:pt idx="103">
                  <c:v>848.53561899999931</c:v>
                </c:pt>
                <c:pt idx="104">
                  <c:v>850.46410899999944</c:v>
                </c:pt>
                <c:pt idx="105">
                  <c:v>852.39259899999945</c:v>
                </c:pt>
                <c:pt idx="106">
                  <c:v>854.32108899999946</c:v>
                </c:pt>
                <c:pt idx="107">
                  <c:v>856.24957900000004</c:v>
                </c:pt>
                <c:pt idx="108">
                  <c:v>858.17806900000005</c:v>
                </c:pt>
                <c:pt idx="109">
                  <c:v>860.10655899999938</c:v>
                </c:pt>
                <c:pt idx="110">
                  <c:v>862.03504899999996</c:v>
                </c:pt>
                <c:pt idx="111">
                  <c:v>863.96353899999997</c:v>
                </c:pt>
                <c:pt idx="112">
                  <c:v>865.8920289999993</c:v>
                </c:pt>
                <c:pt idx="113">
                  <c:v>867.82051899999931</c:v>
                </c:pt>
                <c:pt idx="114">
                  <c:v>869.749009</c:v>
                </c:pt>
                <c:pt idx="115">
                  <c:v>871.67749900000001</c:v>
                </c:pt>
                <c:pt idx="116">
                  <c:v>873.60598900000002</c:v>
                </c:pt>
                <c:pt idx="117">
                  <c:v>875.53447900000003</c:v>
                </c:pt>
                <c:pt idx="118">
                  <c:v>877.46296899999902</c:v>
                </c:pt>
                <c:pt idx="119">
                  <c:v>879.39145899999949</c:v>
                </c:pt>
                <c:pt idx="120">
                  <c:v>881.31994999999938</c:v>
                </c:pt>
                <c:pt idx="121">
                  <c:v>883.24843999999996</c:v>
                </c:pt>
                <c:pt idx="122">
                  <c:v>885.17692999999997</c:v>
                </c:pt>
                <c:pt idx="123">
                  <c:v>887.10541999999998</c:v>
                </c:pt>
                <c:pt idx="124">
                  <c:v>889.03390999999999</c:v>
                </c:pt>
                <c:pt idx="125">
                  <c:v>890.96239999999932</c:v>
                </c:pt>
                <c:pt idx="126">
                  <c:v>892.89089000000001</c:v>
                </c:pt>
                <c:pt idx="127">
                  <c:v>894.81938000000002</c:v>
                </c:pt>
                <c:pt idx="128">
                  <c:v>896.74787000000003</c:v>
                </c:pt>
                <c:pt idx="129">
                  <c:v>898.67636000000005</c:v>
                </c:pt>
                <c:pt idx="130">
                  <c:v>900.60485000000006</c:v>
                </c:pt>
                <c:pt idx="131">
                  <c:v>902.53333999999995</c:v>
                </c:pt>
                <c:pt idx="132">
                  <c:v>904.46182999999917</c:v>
                </c:pt>
                <c:pt idx="133">
                  <c:v>906.39031999999997</c:v>
                </c:pt>
                <c:pt idx="134">
                  <c:v>908.31880999999998</c:v>
                </c:pt>
                <c:pt idx="135">
                  <c:v>910.2473</c:v>
                </c:pt>
                <c:pt idx="136">
                  <c:v>912.17579000000001</c:v>
                </c:pt>
                <c:pt idx="137">
                  <c:v>914.10428000000002</c:v>
                </c:pt>
                <c:pt idx="138">
                  <c:v>916.03277000000003</c:v>
                </c:pt>
                <c:pt idx="139">
                  <c:v>917.96125999999902</c:v>
                </c:pt>
                <c:pt idx="140">
                  <c:v>919.88975000000005</c:v>
                </c:pt>
                <c:pt idx="141">
                  <c:v>921.81823999999938</c:v>
                </c:pt>
                <c:pt idx="142">
                  <c:v>923.74672999999996</c:v>
                </c:pt>
                <c:pt idx="143">
                  <c:v>925.67521999999997</c:v>
                </c:pt>
                <c:pt idx="144">
                  <c:v>927.60371099999998</c:v>
                </c:pt>
                <c:pt idx="145">
                  <c:v>929.5322009999993</c:v>
                </c:pt>
                <c:pt idx="146">
                  <c:v>931.46069099999931</c:v>
                </c:pt>
                <c:pt idx="147">
                  <c:v>933.38918100000001</c:v>
                </c:pt>
                <c:pt idx="148">
                  <c:v>935.31767099999945</c:v>
                </c:pt>
                <c:pt idx="149">
                  <c:v>937.24616099999946</c:v>
                </c:pt>
                <c:pt idx="150">
                  <c:v>939.17465100000004</c:v>
                </c:pt>
                <c:pt idx="151">
                  <c:v>941.10314100000005</c:v>
                </c:pt>
                <c:pt idx="152">
                  <c:v>943.03163099999938</c:v>
                </c:pt>
                <c:pt idx="153">
                  <c:v>944.96012099999916</c:v>
                </c:pt>
                <c:pt idx="154">
                  <c:v>946.88861099999997</c:v>
                </c:pt>
                <c:pt idx="155">
                  <c:v>948.8171009999993</c:v>
                </c:pt>
                <c:pt idx="156">
                  <c:v>950.74559099999999</c:v>
                </c:pt>
                <c:pt idx="157">
                  <c:v>952.674081</c:v>
                </c:pt>
                <c:pt idx="158">
                  <c:v>954.60257100000001</c:v>
                </c:pt>
                <c:pt idx="159">
                  <c:v>956.53106099999945</c:v>
                </c:pt>
                <c:pt idx="160">
                  <c:v>958.45955099999946</c:v>
                </c:pt>
                <c:pt idx="161">
                  <c:v>960.38804100000004</c:v>
                </c:pt>
                <c:pt idx="162">
                  <c:v>962.31653099999949</c:v>
                </c:pt>
                <c:pt idx="163">
                  <c:v>964.24502099999938</c:v>
                </c:pt>
                <c:pt idx="164">
                  <c:v>966.17351099999996</c:v>
                </c:pt>
                <c:pt idx="165">
                  <c:v>968.10200099999997</c:v>
                </c:pt>
                <c:pt idx="166">
                  <c:v>970.03049099999998</c:v>
                </c:pt>
                <c:pt idx="167">
                  <c:v>971.95898199999999</c:v>
                </c:pt>
                <c:pt idx="168">
                  <c:v>973.887472</c:v>
                </c:pt>
                <c:pt idx="169">
                  <c:v>975.81596199999944</c:v>
                </c:pt>
                <c:pt idx="170">
                  <c:v>977.74445200000002</c:v>
                </c:pt>
                <c:pt idx="171">
                  <c:v>979.67294200000003</c:v>
                </c:pt>
                <c:pt idx="172">
                  <c:v>981.60143200000005</c:v>
                </c:pt>
                <c:pt idx="173">
                  <c:v>983.52992200000006</c:v>
                </c:pt>
                <c:pt idx="174">
                  <c:v>985.45841199999938</c:v>
                </c:pt>
                <c:pt idx="175">
                  <c:v>987.38690199999996</c:v>
                </c:pt>
                <c:pt idx="176">
                  <c:v>989.31539199999997</c:v>
                </c:pt>
                <c:pt idx="177">
                  <c:v>991.24388199999999</c:v>
                </c:pt>
                <c:pt idx="178">
                  <c:v>993.172372</c:v>
                </c:pt>
                <c:pt idx="179">
                  <c:v>995.10086200000001</c:v>
                </c:pt>
                <c:pt idx="180">
                  <c:v>997.02935200000002</c:v>
                </c:pt>
                <c:pt idx="181">
                  <c:v>998.95784199999946</c:v>
                </c:pt>
                <c:pt idx="182">
                  <c:v>1000.886332</c:v>
                </c:pt>
                <c:pt idx="183">
                  <c:v>1002.814822</c:v>
                </c:pt>
                <c:pt idx="184">
                  <c:v>1004.7433119999999</c:v>
                </c:pt>
                <c:pt idx="185">
                  <c:v>1006.671802</c:v>
                </c:pt>
                <c:pt idx="186">
                  <c:v>1008.600292</c:v>
                </c:pt>
                <c:pt idx="187">
                  <c:v>1010.528782</c:v>
                </c:pt>
                <c:pt idx="188">
                  <c:v>1012.457272</c:v>
                </c:pt>
                <c:pt idx="189">
                  <c:v>1014.385762</c:v>
                </c:pt>
                <c:pt idx="190">
                  <c:v>1016.314252</c:v>
                </c:pt>
                <c:pt idx="191">
                  <c:v>1018.242743</c:v>
                </c:pt>
                <c:pt idx="192">
                  <c:v>1020.171233</c:v>
                </c:pt>
                <c:pt idx="193">
                  <c:v>1022.099723</c:v>
                </c:pt>
                <c:pt idx="194">
                  <c:v>1024.0282130000001</c:v>
                </c:pt>
                <c:pt idx="195">
                  <c:v>1025.9567030000001</c:v>
                </c:pt>
                <c:pt idx="196">
                  <c:v>1027.8851930000001</c:v>
                </c:pt>
                <c:pt idx="197">
                  <c:v>1029.8136830000001</c:v>
                </c:pt>
                <c:pt idx="198">
                  <c:v>1031.7421730000001</c:v>
                </c:pt>
                <c:pt idx="199">
                  <c:v>1033.6706630000001</c:v>
                </c:pt>
                <c:pt idx="200">
                  <c:v>1035.5991529999999</c:v>
                </c:pt>
                <c:pt idx="201">
                  <c:v>1037.5276429999999</c:v>
                </c:pt>
                <c:pt idx="202">
                  <c:v>1039.4561329999999</c:v>
                </c:pt>
                <c:pt idx="203">
                  <c:v>1041.3846229999999</c:v>
                </c:pt>
                <c:pt idx="204">
                  <c:v>1043.3131129999999</c:v>
                </c:pt>
                <c:pt idx="205">
                  <c:v>1045.2416029999999</c:v>
                </c:pt>
                <c:pt idx="206">
                  <c:v>1047.170093</c:v>
                </c:pt>
                <c:pt idx="207">
                  <c:v>1049.098583</c:v>
                </c:pt>
                <c:pt idx="208">
                  <c:v>1051.027073</c:v>
                </c:pt>
                <c:pt idx="209">
                  <c:v>1052.955563</c:v>
                </c:pt>
                <c:pt idx="210">
                  <c:v>1054.884053</c:v>
                </c:pt>
                <c:pt idx="211">
                  <c:v>1056.812543</c:v>
                </c:pt>
                <c:pt idx="212">
                  <c:v>1058.741033</c:v>
                </c:pt>
                <c:pt idx="213">
                  <c:v>1060.669523</c:v>
                </c:pt>
                <c:pt idx="214">
                  <c:v>1062.5980139999999</c:v>
                </c:pt>
                <c:pt idx="215">
                  <c:v>1064.5265039999999</c:v>
                </c:pt>
                <c:pt idx="216">
                  <c:v>1066.4549939999999</c:v>
                </c:pt>
                <c:pt idx="217">
                  <c:v>1068.383484</c:v>
                </c:pt>
                <c:pt idx="218">
                  <c:v>1070.311974</c:v>
                </c:pt>
                <c:pt idx="219">
                  <c:v>1072.240464</c:v>
                </c:pt>
                <c:pt idx="220">
                  <c:v>1074.168954</c:v>
                </c:pt>
                <c:pt idx="221">
                  <c:v>1076.097444</c:v>
                </c:pt>
                <c:pt idx="222">
                  <c:v>1078.025934</c:v>
                </c:pt>
                <c:pt idx="223">
                  <c:v>1079.954424</c:v>
                </c:pt>
                <c:pt idx="224">
                  <c:v>1081.882914</c:v>
                </c:pt>
                <c:pt idx="225">
                  <c:v>1083.811404</c:v>
                </c:pt>
                <c:pt idx="226">
                  <c:v>1085.739894</c:v>
                </c:pt>
                <c:pt idx="227">
                  <c:v>1087.6683840000001</c:v>
                </c:pt>
                <c:pt idx="228">
                  <c:v>1089.5968740000001</c:v>
                </c:pt>
                <c:pt idx="229">
                  <c:v>1091.5253640000001</c:v>
                </c:pt>
                <c:pt idx="230">
                  <c:v>1093.4538540000001</c:v>
                </c:pt>
                <c:pt idx="231">
                  <c:v>1095.3823440000001</c:v>
                </c:pt>
                <c:pt idx="232">
                  <c:v>1097.3108340000001</c:v>
                </c:pt>
                <c:pt idx="233">
                  <c:v>1099.2393239999999</c:v>
                </c:pt>
                <c:pt idx="234">
                  <c:v>1101.1678139999999</c:v>
                </c:pt>
                <c:pt idx="235">
                  <c:v>1103.0963039999999</c:v>
                </c:pt>
                <c:pt idx="236">
                  <c:v>1105.0247939999999</c:v>
                </c:pt>
                <c:pt idx="237">
                  <c:v>1106.9532850000001</c:v>
                </c:pt>
                <c:pt idx="238">
                  <c:v>1108.8817750000001</c:v>
                </c:pt>
                <c:pt idx="239">
                  <c:v>1110.8102650000001</c:v>
                </c:pt>
                <c:pt idx="240">
                  <c:v>1112.7387550000001</c:v>
                </c:pt>
                <c:pt idx="241">
                  <c:v>1114.6672450000001</c:v>
                </c:pt>
                <c:pt idx="242">
                  <c:v>1116.5957350000001</c:v>
                </c:pt>
                <c:pt idx="243">
                  <c:v>1118.5242249999999</c:v>
                </c:pt>
                <c:pt idx="244">
                  <c:v>1120.4527149999999</c:v>
                </c:pt>
                <c:pt idx="245">
                  <c:v>1122.3812049999999</c:v>
                </c:pt>
                <c:pt idx="246">
                  <c:v>1124.3096949999999</c:v>
                </c:pt>
                <c:pt idx="247">
                  <c:v>1126.2381849999999</c:v>
                </c:pt>
                <c:pt idx="248">
                  <c:v>1128.1666749999999</c:v>
                </c:pt>
                <c:pt idx="249">
                  <c:v>1130.095165</c:v>
                </c:pt>
                <c:pt idx="250">
                  <c:v>1132.023655</c:v>
                </c:pt>
                <c:pt idx="251">
                  <c:v>1133.952145</c:v>
                </c:pt>
                <c:pt idx="252">
                  <c:v>1135.880635</c:v>
                </c:pt>
                <c:pt idx="253">
                  <c:v>1137.809125</c:v>
                </c:pt>
                <c:pt idx="254">
                  <c:v>1139.737615</c:v>
                </c:pt>
                <c:pt idx="255">
                  <c:v>1141.666105</c:v>
                </c:pt>
                <c:pt idx="256">
                  <c:v>1143.594595</c:v>
                </c:pt>
                <c:pt idx="257">
                  <c:v>1145.523085</c:v>
                </c:pt>
                <c:pt idx="258">
                  <c:v>1147.451575</c:v>
                </c:pt>
                <c:pt idx="259">
                  <c:v>1149.3800650000001</c:v>
                </c:pt>
                <c:pt idx="260">
                  <c:v>1151.3085550000001</c:v>
                </c:pt>
                <c:pt idx="261">
                  <c:v>1153.237046</c:v>
                </c:pt>
                <c:pt idx="262">
                  <c:v>1155.165536</c:v>
                </c:pt>
                <c:pt idx="263">
                  <c:v>1157.094026</c:v>
                </c:pt>
                <c:pt idx="264">
                  <c:v>1159.022516</c:v>
                </c:pt>
                <c:pt idx="265">
                  <c:v>1160.951006</c:v>
                </c:pt>
                <c:pt idx="266">
                  <c:v>1162.879496</c:v>
                </c:pt>
                <c:pt idx="267">
                  <c:v>1164.807986</c:v>
                </c:pt>
                <c:pt idx="268">
                  <c:v>1166.736476</c:v>
                </c:pt>
                <c:pt idx="269">
                  <c:v>1168.664966</c:v>
                </c:pt>
                <c:pt idx="270">
                  <c:v>1170.5934560000001</c:v>
                </c:pt>
                <c:pt idx="271">
                  <c:v>1172.5219460000001</c:v>
                </c:pt>
                <c:pt idx="272">
                  <c:v>1174.4504360000001</c:v>
                </c:pt>
                <c:pt idx="273">
                  <c:v>1176.3789260000001</c:v>
                </c:pt>
                <c:pt idx="274">
                  <c:v>1178.3074160000001</c:v>
                </c:pt>
                <c:pt idx="275">
                  <c:v>1180.2359060000001</c:v>
                </c:pt>
                <c:pt idx="276">
                  <c:v>1182.1643959999999</c:v>
                </c:pt>
                <c:pt idx="277">
                  <c:v>1184.0928859999999</c:v>
                </c:pt>
                <c:pt idx="278">
                  <c:v>1186.0213759999999</c:v>
                </c:pt>
                <c:pt idx="279">
                  <c:v>1187.9498659999999</c:v>
                </c:pt>
                <c:pt idx="280">
                  <c:v>1189.8783559999999</c:v>
                </c:pt>
                <c:pt idx="281">
                  <c:v>1191.806846</c:v>
                </c:pt>
                <c:pt idx="282">
                  <c:v>1193.735336</c:v>
                </c:pt>
                <c:pt idx="283">
                  <c:v>1195.663826</c:v>
                </c:pt>
                <c:pt idx="284">
                  <c:v>1197.5923170000001</c:v>
                </c:pt>
                <c:pt idx="285">
                  <c:v>1199.5208070000001</c:v>
                </c:pt>
                <c:pt idx="286">
                  <c:v>1201.4492969999999</c:v>
                </c:pt>
                <c:pt idx="287">
                  <c:v>1203.3777869999999</c:v>
                </c:pt>
                <c:pt idx="288">
                  <c:v>1205.3062769999999</c:v>
                </c:pt>
                <c:pt idx="289">
                  <c:v>1207.2347669999999</c:v>
                </c:pt>
                <c:pt idx="290">
                  <c:v>1209.1632569999999</c:v>
                </c:pt>
                <c:pt idx="291">
                  <c:v>1211.0917469999999</c:v>
                </c:pt>
                <c:pt idx="292">
                  <c:v>1213.020237</c:v>
                </c:pt>
                <c:pt idx="293">
                  <c:v>1214.948727</c:v>
                </c:pt>
                <c:pt idx="294">
                  <c:v>1216.877217</c:v>
                </c:pt>
                <c:pt idx="295">
                  <c:v>1218.805707</c:v>
                </c:pt>
                <c:pt idx="296">
                  <c:v>1220.734197</c:v>
                </c:pt>
                <c:pt idx="297">
                  <c:v>1222.662687</c:v>
                </c:pt>
                <c:pt idx="298">
                  <c:v>1224.591177</c:v>
                </c:pt>
                <c:pt idx="299">
                  <c:v>1226.519667</c:v>
                </c:pt>
                <c:pt idx="300">
                  <c:v>1228.448157</c:v>
                </c:pt>
                <c:pt idx="301">
                  <c:v>1230.376647</c:v>
                </c:pt>
                <c:pt idx="302">
                  <c:v>1232.3051370000001</c:v>
                </c:pt>
                <c:pt idx="303">
                  <c:v>1234.2336270000001</c:v>
                </c:pt>
                <c:pt idx="304">
                  <c:v>1236.1621170000001</c:v>
                </c:pt>
                <c:pt idx="305">
                  <c:v>1238.0906070000001</c:v>
                </c:pt>
                <c:pt idx="306">
                  <c:v>1240.0190970000001</c:v>
                </c:pt>
                <c:pt idx="307">
                  <c:v>1241.9475870000001</c:v>
                </c:pt>
                <c:pt idx="308">
                  <c:v>1243.876078</c:v>
                </c:pt>
                <c:pt idx="309">
                  <c:v>1245.804568</c:v>
                </c:pt>
                <c:pt idx="310">
                  <c:v>1247.733058</c:v>
                </c:pt>
                <c:pt idx="311">
                  <c:v>1249.661548</c:v>
                </c:pt>
                <c:pt idx="312">
                  <c:v>1251.590038</c:v>
                </c:pt>
                <c:pt idx="313">
                  <c:v>1253.5185280000001</c:v>
                </c:pt>
                <c:pt idx="314">
                  <c:v>1255.4470180000001</c:v>
                </c:pt>
                <c:pt idx="315">
                  <c:v>1257.3755080000001</c:v>
                </c:pt>
                <c:pt idx="316">
                  <c:v>1259.3039980000001</c:v>
                </c:pt>
                <c:pt idx="317">
                  <c:v>1261.2324880000001</c:v>
                </c:pt>
                <c:pt idx="318">
                  <c:v>1263.1609779999999</c:v>
                </c:pt>
                <c:pt idx="319">
                  <c:v>1265.0894679999999</c:v>
                </c:pt>
                <c:pt idx="320">
                  <c:v>1267.0179579999999</c:v>
                </c:pt>
                <c:pt idx="321">
                  <c:v>1268.9464479999999</c:v>
                </c:pt>
                <c:pt idx="322">
                  <c:v>1270.8749379999999</c:v>
                </c:pt>
                <c:pt idx="323">
                  <c:v>1272.8034279999999</c:v>
                </c:pt>
                <c:pt idx="324">
                  <c:v>1274.731918</c:v>
                </c:pt>
                <c:pt idx="325">
                  <c:v>1276.660408</c:v>
                </c:pt>
                <c:pt idx="326">
                  <c:v>1278.588898</c:v>
                </c:pt>
                <c:pt idx="327">
                  <c:v>1280.517388</c:v>
                </c:pt>
                <c:pt idx="328">
                  <c:v>1282.445878</c:v>
                </c:pt>
                <c:pt idx="329">
                  <c:v>1284.374368</c:v>
                </c:pt>
                <c:pt idx="330">
                  <c:v>1286.302858</c:v>
                </c:pt>
                <c:pt idx="331">
                  <c:v>1288.2313489999999</c:v>
                </c:pt>
                <c:pt idx="332">
                  <c:v>1290.1598389999999</c:v>
                </c:pt>
                <c:pt idx="333">
                  <c:v>1292.0883289999999</c:v>
                </c:pt>
                <c:pt idx="334">
                  <c:v>1294.0168189999999</c:v>
                </c:pt>
                <c:pt idx="335">
                  <c:v>1295.945309</c:v>
                </c:pt>
                <c:pt idx="336">
                  <c:v>1297.873799</c:v>
                </c:pt>
                <c:pt idx="337">
                  <c:v>1299.802289</c:v>
                </c:pt>
                <c:pt idx="338">
                  <c:v>1301.730779</c:v>
                </c:pt>
                <c:pt idx="339">
                  <c:v>1303.659269</c:v>
                </c:pt>
                <c:pt idx="340">
                  <c:v>1305.587759</c:v>
                </c:pt>
                <c:pt idx="341">
                  <c:v>1307.516249</c:v>
                </c:pt>
                <c:pt idx="342">
                  <c:v>1309.444739</c:v>
                </c:pt>
                <c:pt idx="343">
                  <c:v>1311.373229</c:v>
                </c:pt>
                <c:pt idx="344">
                  <c:v>1313.301719</c:v>
                </c:pt>
                <c:pt idx="345">
                  <c:v>1315.2302090000001</c:v>
                </c:pt>
                <c:pt idx="346">
                  <c:v>1317.1586990000001</c:v>
                </c:pt>
                <c:pt idx="347">
                  <c:v>1319.0871890000001</c:v>
                </c:pt>
                <c:pt idx="348">
                  <c:v>1321.0156790000001</c:v>
                </c:pt>
                <c:pt idx="349">
                  <c:v>1322.9441690000001</c:v>
                </c:pt>
                <c:pt idx="350">
                  <c:v>1324.8726590000001</c:v>
                </c:pt>
                <c:pt idx="351">
                  <c:v>1326.8011489999999</c:v>
                </c:pt>
                <c:pt idx="352">
                  <c:v>1328.7296389999999</c:v>
                </c:pt>
                <c:pt idx="353">
                  <c:v>1330.6581289999999</c:v>
                </c:pt>
                <c:pt idx="354">
                  <c:v>1332.5866189999999</c:v>
                </c:pt>
                <c:pt idx="355">
                  <c:v>1334.51511</c:v>
                </c:pt>
                <c:pt idx="356">
                  <c:v>1336.4436000000001</c:v>
                </c:pt>
                <c:pt idx="357">
                  <c:v>1338.3720900000001</c:v>
                </c:pt>
                <c:pt idx="358">
                  <c:v>1340.3005800000001</c:v>
                </c:pt>
                <c:pt idx="359">
                  <c:v>1342.2290700000001</c:v>
                </c:pt>
                <c:pt idx="360">
                  <c:v>1344.1575600000001</c:v>
                </c:pt>
                <c:pt idx="361">
                  <c:v>1346.0860499999999</c:v>
                </c:pt>
                <c:pt idx="362">
                  <c:v>1348.0145399999999</c:v>
                </c:pt>
                <c:pt idx="363">
                  <c:v>1349.9430299999999</c:v>
                </c:pt>
                <c:pt idx="364">
                  <c:v>1351.8715199999999</c:v>
                </c:pt>
                <c:pt idx="365">
                  <c:v>1353.8000099999999</c:v>
                </c:pt>
                <c:pt idx="366">
                  <c:v>1355.7284999999999</c:v>
                </c:pt>
                <c:pt idx="367">
                  <c:v>1357.65699</c:v>
                </c:pt>
                <c:pt idx="368">
                  <c:v>1359.58548</c:v>
                </c:pt>
                <c:pt idx="369">
                  <c:v>1361.51397</c:v>
                </c:pt>
                <c:pt idx="370">
                  <c:v>1363.44246</c:v>
                </c:pt>
                <c:pt idx="371">
                  <c:v>1365.37095</c:v>
                </c:pt>
                <c:pt idx="372">
                  <c:v>1367.29944</c:v>
                </c:pt>
                <c:pt idx="373">
                  <c:v>1369.22793</c:v>
                </c:pt>
                <c:pt idx="374">
                  <c:v>1371.15642</c:v>
                </c:pt>
                <c:pt idx="375">
                  <c:v>1373.08491</c:v>
                </c:pt>
                <c:pt idx="376">
                  <c:v>1375.0134</c:v>
                </c:pt>
                <c:pt idx="377">
                  <c:v>1376.9418900000001</c:v>
                </c:pt>
                <c:pt idx="378">
                  <c:v>1378.870381</c:v>
                </c:pt>
                <c:pt idx="379">
                  <c:v>1380.798871</c:v>
                </c:pt>
                <c:pt idx="380">
                  <c:v>1382.727361</c:v>
                </c:pt>
                <c:pt idx="381">
                  <c:v>1384.655851</c:v>
                </c:pt>
                <c:pt idx="382">
                  <c:v>1386.584341</c:v>
                </c:pt>
                <c:pt idx="383">
                  <c:v>1388.512831</c:v>
                </c:pt>
                <c:pt idx="384">
                  <c:v>1390.441321</c:v>
                </c:pt>
                <c:pt idx="385">
                  <c:v>1392.369811</c:v>
                </c:pt>
                <c:pt idx="386">
                  <c:v>1394.298301</c:v>
                </c:pt>
                <c:pt idx="387">
                  <c:v>1396.226791</c:v>
                </c:pt>
                <c:pt idx="388">
                  <c:v>1398.1552810000001</c:v>
                </c:pt>
                <c:pt idx="389">
                  <c:v>1400.0837710000001</c:v>
                </c:pt>
                <c:pt idx="390">
                  <c:v>1402.0122610000001</c:v>
                </c:pt>
                <c:pt idx="391">
                  <c:v>1403.9407510000001</c:v>
                </c:pt>
                <c:pt idx="392">
                  <c:v>1405.8692410000001</c:v>
                </c:pt>
                <c:pt idx="393">
                  <c:v>1407.7977310000001</c:v>
                </c:pt>
                <c:pt idx="394">
                  <c:v>1409.7262209999999</c:v>
                </c:pt>
                <c:pt idx="395">
                  <c:v>1411.6547109999999</c:v>
                </c:pt>
                <c:pt idx="396">
                  <c:v>1413.5832009999999</c:v>
                </c:pt>
                <c:pt idx="397">
                  <c:v>1415.5116909999999</c:v>
                </c:pt>
                <c:pt idx="398">
                  <c:v>1417.4401809999999</c:v>
                </c:pt>
                <c:pt idx="399">
                  <c:v>1419.3686709999999</c:v>
                </c:pt>
                <c:pt idx="400">
                  <c:v>1421.297161</c:v>
                </c:pt>
                <c:pt idx="401">
                  <c:v>1423.2256520000001</c:v>
                </c:pt>
                <c:pt idx="402">
                  <c:v>1425.1541420000001</c:v>
                </c:pt>
                <c:pt idx="403">
                  <c:v>1427.0826320000001</c:v>
                </c:pt>
                <c:pt idx="404">
                  <c:v>1429.0111219999999</c:v>
                </c:pt>
                <c:pt idx="405">
                  <c:v>1430.9396119999999</c:v>
                </c:pt>
                <c:pt idx="406">
                  <c:v>1432.8681019999999</c:v>
                </c:pt>
                <c:pt idx="407">
                  <c:v>1434.7965919999999</c:v>
                </c:pt>
                <c:pt idx="408">
                  <c:v>1436.7250819999999</c:v>
                </c:pt>
                <c:pt idx="409">
                  <c:v>1438.6535719999999</c:v>
                </c:pt>
                <c:pt idx="410">
                  <c:v>1440.582062</c:v>
                </c:pt>
                <c:pt idx="411">
                  <c:v>1442.510552</c:v>
                </c:pt>
                <c:pt idx="412">
                  <c:v>1444.439042</c:v>
                </c:pt>
                <c:pt idx="413">
                  <c:v>1446.367532</c:v>
                </c:pt>
                <c:pt idx="414">
                  <c:v>1448.296022</c:v>
                </c:pt>
                <c:pt idx="415">
                  <c:v>1450.224512</c:v>
                </c:pt>
                <c:pt idx="416">
                  <c:v>1452.153002</c:v>
                </c:pt>
                <c:pt idx="417">
                  <c:v>1454.081492</c:v>
                </c:pt>
                <c:pt idx="418">
                  <c:v>1456.009982</c:v>
                </c:pt>
                <c:pt idx="419">
                  <c:v>1457.938472</c:v>
                </c:pt>
                <c:pt idx="420">
                  <c:v>1459.8669620000001</c:v>
                </c:pt>
                <c:pt idx="421">
                  <c:v>1461.7954520000001</c:v>
                </c:pt>
                <c:pt idx="422">
                  <c:v>1463.7239420000001</c:v>
                </c:pt>
                <c:pt idx="423">
                  <c:v>1465.6524320000001</c:v>
                </c:pt>
                <c:pt idx="424">
                  <c:v>1467.5809220000001</c:v>
                </c:pt>
                <c:pt idx="425">
                  <c:v>1469.509413</c:v>
                </c:pt>
                <c:pt idx="426">
                  <c:v>1471.437903</c:v>
                </c:pt>
                <c:pt idx="427">
                  <c:v>1473.366393</c:v>
                </c:pt>
                <c:pt idx="428">
                  <c:v>1475.294883</c:v>
                </c:pt>
                <c:pt idx="429">
                  <c:v>1477.223373</c:v>
                </c:pt>
                <c:pt idx="430">
                  <c:v>1479.151863</c:v>
                </c:pt>
                <c:pt idx="431">
                  <c:v>1481.0803530000001</c:v>
                </c:pt>
                <c:pt idx="432">
                  <c:v>1483.0088430000001</c:v>
                </c:pt>
                <c:pt idx="433">
                  <c:v>1484.9373330000001</c:v>
                </c:pt>
                <c:pt idx="434">
                  <c:v>1486.8658230000001</c:v>
                </c:pt>
                <c:pt idx="435">
                  <c:v>1488.7943130000001</c:v>
                </c:pt>
                <c:pt idx="436">
                  <c:v>1490.7228030000001</c:v>
                </c:pt>
                <c:pt idx="437">
                  <c:v>1492.6512929999999</c:v>
                </c:pt>
                <c:pt idx="438">
                  <c:v>1494.5797829999999</c:v>
                </c:pt>
                <c:pt idx="439">
                  <c:v>1496.5082729999999</c:v>
                </c:pt>
                <c:pt idx="440">
                  <c:v>1498.4367629999999</c:v>
                </c:pt>
                <c:pt idx="441">
                  <c:v>1500.3652529999999</c:v>
                </c:pt>
                <c:pt idx="442">
                  <c:v>1502.2937429999999</c:v>
                </c:pt>
                <c:pt idx="443">
                  <c:v>1504.222233</c:v>
                </c:pt>
                <c:pt idx="444">
                  <c:v>1506.150723</c:v>
                </c:pt>
                <c:pt idx="445">
                  <c:v>1508.079213</c:v>
                </c:pt>
                <c:pt idx="446">
                  <c:v>1510.007703</c:v>
                </c:pt>
                <c:pt idx="447">
                  <c:v>1511.936193</c:v>
                </c:pt>
                <c:pt idx="448">
                  <c:v>1513.8646839999999</c:v>
                </c:pt>
                <c:pt idx="449">
                  <c:v>1515.7931739999999</c:v>
                </c:pt>
                <c:pt idx="450">
                  <c:v>1517.7216639999999</c:v>
                </c:pt>
                <c:pt idx="451">
                  <c:v>1519.6501539999999</c:v>
                </c:pt>
                <c:pt idx="452">
                  <c:v>1521.5786439999999</c:v>
                </c:pt>
                <c:pt idx="453">
                  <c:v>1523.507134</c:v>
                </c:pt>
                <c:pt idx="454">
                  <c:v>1525.435624</c:v>
                </c:pt>
                <c:pt idx="455">
                  <c:v>1527.364114</c:v>
                </c:pt>
                <c:pt idx="456">
                  <c:v>1529.292604</c:v>
                </c:pt>
                <c:pt idx="457">
                  <c:v>1531.221094</c:v>
                </c:pt>
                <c:pt idx="458">
                  <c:v>1533.149584</c:v>
                </c:pt>
                <c:pt idx="459">
                  <c:v>1535.078074</c:v>
                </c:pt>
                <c:pt idx="460">
                  <c:v>1537.006564</c:v>
                </c:pt>
                <c:pt idx="461">
                  <c:v>1538.935054</c:v>
                </c:pt>
                <c:pt idx="462">
                  <c:v>1540.863544</c:v>
                </c:pt>
                <c:pt idx="463">
                  <c:v>1542.7920340000001</c:v>
                </c:pt>
                <c:pt idx="464">
                  <c:v>1544.7205240000001</c:v>
                </c:pt>
                <c:pt idx="465">
                  <c:v>1546.6490140000001</c:v>
                </c:pt>
                <c:pt idx="466">
                  <c:v>1548.5775040000001</c:v>
                </c:pt>
                <c:pt idx="467">
                  <c:v>1550.5059940000001</c:v>
                </c:pt>
                <c:pt idx="468">
                  <c:v>1552.4344840000001</c:v>
                </c:pt>
                <c:pt idx="469">
                  <c:v>1554.3629739999999</c:v>
                </c:pt>
                <c:pt idx="470">
                  <c:v>1556.2914639999999</c:v>
                </c:pt>
                <c:pt idx="471">
                  <c:v>1558.2199539999999</c:v>
                </c:pt>
                <c:pt idx="472">
                  <c:v>1560.148445</c:v>
                </c:pt>
                <c:pt idx="473">
                  <c:v>1562.076935</c:v>
                </c:pt>
                <c:pt idx="474">
                  <c:v>1564.0054250000001</c:v>
                </c:pt>
                <c:pt idx="475">
                  <c:v>1565.9339150000001</c:v>
                </c:pt>
                <c:pt idx="476">
                  <c:v>1567.8624050000001</c:v>
                </c:pt>
                <c:pt idx="477">
                  <c:v>1569.7908950000001</c:v>
                </c:pt>
                <c:pt idx="478">
                  <c:v>1571.7193850000001</c:v>
                </c:pt>
                <c:pt idx="479">
                  <c:v>1573.6478750000001</c:v>
                </c:pt>
                <c:pt idx="480">
                  <c:v>1575.5763649999999</c:v>
                </c:pt>
                <c:pt idx="481">
                  <c:v>1577.5048549999999</c:v>
                </c:pt>
                <c:pt idx="482">
                  <c:v>1579.4333449999999</c:v>
                </c:pt>
                <c:pt idx="483">
                  <c:v>1581.3618349999999</c:v>
                </c:pt>
                <c:pt idx="484">
                  <c:v>1583.2903249999999</c:v>
                </c:pt>
                <c:pt idx="485">
                  <c:v>1585.2188149999999</c:v>
                </c:pt>
                <c:pt idx="486">
                  <c:v>1587.147305</c:v>
                </c:pt>
                <c:pt idx="487">
                  <c:v>1589.075795</c:v>
                </c:pt>
                <c:pt idx="488">
                  <c:v>1591.004285</c:v>
                </c:pt>
                <c:pt idx="489">
                  <c:v>1592.932775</c:v>
                </c:pt>
                <c:pt idx="490">
                  <c:v>1594.861265</c:v>
                </c:pt>
                <c:pt idx="491">
                  <c:v>1596.789755</c:v>
                </c:pt>
                <c:pt idx="492">
                  <c:v>1598.718245</c:v>
                </c:pt>
                <c:pt idx="493">
                  <c:v>1600.646735</c:v>
                </c:pt>
                <c:pt idx="494">
                  <c:v>1602.575225</c:v>
                </c:pt>
                <c:pt idx="495">
                  <c:v>1604.5037159999999</c:v>
                </c:pt>
                <c:pt idx="496">
                  <c:v>1606.432206</c:v>
                </c:pt>
                <c:pt idx="497">
                  <c:v>1608.360696</c:v>
                </c:pt>
                <c:pt idx="498">
                  <c:v>1610.289186</c:v>
                </c:pt>
                <c:pt idx="499">
                  <c:v>1612.217676</c:v>
                </c:pt>
                <c:pt idx="500">
                  <c:v>1614.146166</c:v>
                </c:pt>
                <c:pt idx="501">
                  <c:v>1616.074656</c:v>
                </c:pt>
                <c:pt idx="502">
                  <c:v>1618.003146</c:v>
                </c:pt>
                <c:pt idx="503">
                  <c:v>1619.931636</c:v>
                </c:pt>
                <c:pt idx="504">
                  <c:v>1621.860126</c:v>
                </c:pt>
                <c:pt idx="505">
                  <c:v>1623.788616</c:v>
                </c:pt>
                <c:pt idx="506">
                  <c:v>1625.7171060000001</c:v>
                </c:pt>
                <c:pt idx="507">
                  <c:v>1627.6455960000001</c:v>
                </c:pt>
                <c:pt idx="508">
                  <c:v>1629.5740860000001</c:v>
                </c:pt>
                <c:pt idx="509">
                  <c:v>1631.5025760000001</c:v>
                </c:pt>
                <c:pt idx="510">
                  <c:v>1633.4310660000001</c:v>
                </c:pt>
                <c:pt idx="511">
                  <c:v>1635.3595560000001</c:v>
                </c:pt>
                <c:pt idx="512">
                  <c:v>1637.2880459999999</c:v>
                </c:pt>
                <c:pt idx="513">
                  <c:v>1639.2165359999999</c:v>
                </c:pt>
                <c:pt idx="514">
                  <c:v>1641.1450259999999</c:v>
                </c:pt>
                <c:pt idx="515">
                  <c:v>1643.0735159999999</c:v>
                </c:pt>
                <c:pt idx="516">
                  <c:v>1645.0020059999999</c:v>
                </c:pt>
                <c:pt idx="517">
                  <c:v>1646.9304959999999</c:v>
                </c:pt>
                <c:pt idx="518">
                  <c:v>1648.858986</c:v>
                </c:pt>
                <c:pt idx="519">
                  <c:v>1650.7874770000001</c:v>
                </c:pt>
                <c:pt idx="520">
                  <c:v>1652.7159670000001</c:v>
                </c:pt>
                <c:pt idx="521">
                  <c:v>1654.6444570000001</c:v>
                </c:pt>
                <c:pt idx="522">
                  <c:v>1656.5729470000001</c:v>
                </c:pt>
                <c:pt idx="523">
                  <c:v>1658.5014369999999</c:v>
                </c:pt>
                <c:pt idx="524">
                  <c:v>1660.4299269999999</c:v>
                </c:pt>
                <c:pt idx="525">
                  <c:v>1662.3584169999999</c:v>
                </c:pt>
                <c:pt idx="526">
                  <c:v>1664.2869069999999</c:v>
                </c:pt>
                <c:pt idx="527">
                  <c:v>1666.2153969999999</c:v>
                </c:pt>
                <c:pt idx="528">
                  <c:v>1668.1438869999999</c:v>
                </c:pt>
                <c:pt idx="529">
                  <c:v>1670.072377</c:v>
                </c:pt>
                <c:pt idx="530">
                  <c:v>1672.000867</c:v>
                </c:pt>
                <c:pt idx="531">
                  <c:v>1673.929357</c:v>
                </c:pt>
                <c:pt idx="532">
                  <c:v>1675.857847</c:v>
                </c:pt>
                <c:pt idx="533">
                  <c:v>1677.786337</c:v>
                </c:pt>
                <c:pt idx="534">
                  <c:v>1679.714827</c:v>
                </c:pt>
                <c:pt idx="535">
                  <c:v>1681.643317</c:v>
                </c:pt>
                <c:pt idx="536">
                  <c:v>1683.571807</c:v>
                </c:pt>
                <c:pt idx="537">
                  <c:v>1685.500297</c:v>
                </c:pt>
                <c:pt idx="538">
                  <c:v>1687.4287870000001</c:v>
                </c:pt>
                <c:pt idx="539">
                  <c:v>1689.3572770000001</c:v>
                </c:pt>
                <c:pt idx="540">
                  <c:v>1691.2857670000001</c:v>
                </c:pt>
                <c:pt idx="541">
                  <c:v>1693.2142570000001</c:v>
                </c:pt>
                <c:pt idx="542">
                  <c:v>1695.142748</c:v>
                </c:pt>
                <c:pt idx="543">
                  <c:v>1697.071238</c:v>
                </c:pt>
                <c:pt idx="544">
                  <c:v>1698.999728</c:v>
                </c:pt>
                <c:pt idx="545">
                  <c:v>1700.928218</c:v>
                </c:pt>
                <c:pt idx="546">
                  <c:v>1702.856708</c:v>
                </c:pt>
                <c:pt idx="547">
                  <c:v>1704.785198</c:v>
                </c:pt>
                <c:pt idx="548">
                  <c:v>1706.713688</c:v>
                </c:pt>
                <c:pt idx="549">
                  <c:v>1708.6421780000001</c:v>
                </c:pt>
                <c:pt idx="550">
                  <c:v>1710.5706680000001</c:v>
                </c:pt>
                <c:pt idx="551">
                  <c:v>1712.4991580000001</c:v>
                </c:pt>
                <c:pt idx="552">
                  <c:v>1714.4276480000001</c:v>
                </c:pt>
                <c:pt idx="553">
                  <c:v>1716.3561380000001</c:v>
                </c:pt>
                <c:pt idx="554">
                  <c:v>1718.2846280000001</c:v>
                </c:pt>
                <c:pt idx="555">
                  <c:v>1720.2131179999999</c:v>
                </c:pt>
                <c:pt idx="556">
                  <c:v>1722.1416079999999</c:v>
                </c:pt>
                <c:pt idx="557">
                  <c:v>1724.0700979999999</c:v>
                </c:pt>
                <c:pt idx="558">
                  <c:v>1725.9985879999999</c:v>
                </c:pt>
                <c:pt idx="559">
                  <c:v>1727.9270779999999</c:v>
                </c:pt>
                <c:pt idx="560">
                  <c:v>1729.8555679999999</c:v>
                </c:pt>
                <c:pt idx="561">
                  <c:v>1731.784058</c:v>
                </c:pt>
                <c:pt idx="562">
                  <c:v>1733.712548</c:v>
                </c:pt>
                <c:pt idx="563">
                  <c:v>1735.641038</c:v>
                </c:pt>
                <c:pt idx="564">
                  <c:v>1737.569528</c:v>
                </c:pt>
                <c:pt idx="565">
                  <c:v>1739.4980190000001</c:v>
                </c:pt>
                <c:pt idx="566">
                  <c:v>1741.4265089999999</c:v>
                </c:pt>
                <c:pt idx="567">
                  <c:v>1743.3549989999999</c:v>
                </c:pt>
                <c:pt idx="568">
                  <c:v>1745.2834889999999</c:v>
                </c:pt>
                <c:pt idx="569">
                  <c:v>1747.2119789999999</c:v>
                </c:pt>
                <c:pt idx="570">
                  <c:v>1749.1404689999999</c:v>
                </c:pt>
                <c:pt idx="571">
                  <c:v>1751.0689589999999</c:v>
                </c:pt>
                <c:pt idx="572">
                  <c:v>1752.997449</c:v>
                </c:pt>
                <c:pt idx="573">
                  <c:v>1754.925939</c:v>
                </c:pt>
                <c:pt idx="574">
                  <c:v>1756.854429</c:v>
                </c:pt>
                <c:pt idx="575">
                  <c:v>1758.782919</c:v>
                </c:pt>
                <c:pt idx="576">
                  <c:v>1760.711409</c:v>
                </c:pt>
                <c:pt idx="577">
                  <c:v>1762.639899</c:v>
                </c:pt>
                <c:pt idx="578">
                  <c:v>1764.568389</c:v>
                </c:pt>
                <c:pt idx="579">
                  <c:v>1766.496879</c:v>
                </c:pt>
                <c:pt idx="580">
                  <c:v>1768.425369</c:v>
                </c:pt>
                <c:pt idx="581">
                  <c:v>1770.3538590000001</c:v>
                </c:pt>
                <c:pt idx="582">
                  <c:v>1772.2823490000001</c:v>
                </c:pt>
                <c:pt idx="583">
                  <c:v>1774.2108390000001</c:v>
                </c:pt>
                <c:pt idx="584">
                  <c:v>1776.1393290000001</c:v>
                </c:pt>
                <c:pt idx="585">
                  <c:v>1778.0678190000001</c:v>
                </c:pt>
                <c:pt idx="586">
                  <c:v>1779.9963090000001</c:v>
                </c:pt>
                <c:pt idx="587">
                  <c:v>1781.9247989999999</c:v>
                </c:pt>
                <c:pt idx="588">
                  <c:v>1783.8532889999999</c:v>
                </c:pt>
                <c:pt idx="589">
                  <c:v>1785.78178</c:v>
                </c:pt>
                <c:pt idx="590">
                  <c:v>1787.71027</c:v>
                </c:pt>
                <c:pt idx="591">
                  <c:v>1789.63876</c:v>
                </c:pt>
                <c:pt idx="592">
                  <c:v>1791.5672500000001</c:v>
                </c:pt>
                <c:pt idx="593">
                  <c:v>1793.4957400000001</c:v>
                </c:pt>
                <c:pt idx="594">
                  <c:v>1795.4242300000001</c:v>
                </c:pt>
                <c:pt idx="595">
                  <c:v>1797.3527200000001</c:v>
                </c:pt>
                <c:pt idx="596">
                  <c:v>1799.2812100000001</c:v>
                </c:pt>
                <c:pt idx="597">
                  <c:v>1801.2097000000001</c:v>
                </c:pt>
                <c:pt idx="598">
                  <c:v>1803.1381899999999</c:v>
                </c:pt>
                <c:pt idx="599">
                  <c:v>1805.0666799999999</c:v>
                </c:pt>
                <c:pt idx="600">
                  <c:v>1806.9951699999999</c:v>
                </c:pt>
                <c:pt idx="601">
                  <c:v>1808.9236599999999</c:v>
                </c:pt>
                <c:pt idx="602">
                  <c:v>1810.8521499999999</c:v>
                </c:pt>
                <c:pt idx="603">
                  <c:v>1812.7806399999999</c:v>
                </c:pt>
                <c:pt idx="604">
                  <c:v>1814.70913</c:v>
                </c:pt>
                <c:pt idx="605">
                  <c:v>1816.63762</c:v>
                </c:pt>
                <c:pt idx="606">
                  <c:v>1818.56611</c:v>
                </c:pt>
                <c:pt idx="607">
                  <c:v>1820.4946</c:v>
                </c:pt>
                <c:pt idx="608">
                  <c:v>1822.42309</c:v>
                </c:pt>
                <c:pt idx="609">
                  <c:v>1824.35158</c:v>
                </c:pt>
                <c:pt idx="610">
                  <c:v>1826.28007</c:v>
                </c:pt>
                <c:pt idx="611">
                  <c:v>1828.20856</c:v>
                </c:pt>
                <c:pt idx="612">
                  <c:v>1830.1370509999999</c:v>
                </c:pt>
                <c:pt idx="613">
                  <c:v>1832.0655409999999</c:v>
                </c:pt>
                <c:pt idx="614">
                  <c:v>1833.9940309999999</c:v>
                </c:pt>
                <c:pt idx="615">
                  <c:v>1835.922521</c:v>
                </c:pt>
                <c:pt idx="616">
                  <c:v>1837.851011</c:v>
                </c:pt>
                <c:pt idx="617">
                  <c:v>1839.779501</c:v>
                </c:pt>
                <c:pt idx="618">
                  <c:v>1841.707991</c:v>
                </c:pt>
                <c:pt idx="619">
                  <c:v>1843.636481</c:v>
                </c:pt>
                <c:pt idx="620">
                  <c:v>1845.564971</c:v>
                </c:pt>
                <c:pt idx="621">
                  <c:v>1847.493461</c:v>
                </c:pt>
                <c:pt idx="622">
                  <c:v>1849.421951</c:v>
                </c:pt>
                <c:pt idx="623">
                  <c:v>1851.350441</c:v>
                </c:pt>
                <c:pt idx="624">
                  <c:v>1853.2789310000001</c:v>
                </c:pt>
                <c:pt idx="625">
                  <c:v>1855.2074210000001</c:v>
                </c:pt>
                <c:pt idx="626">
                  <c:v>1857.1359110000001</c:v>
                </c:pt>
                <c:pt idx="627">
                  <c:v>1859.0644010000001</c:v>
                </c:pt>
                <c:pt idx="628">
                  <c:v>1860.9928910000001</c:v>
                </c:pt>
                <c:pt idx="629">
                  <c:v>1862.9213810000001</c:v>
                </c:pt>
                <c:pt idx="630">
                  <c:v>1864.8498709999999</c:v>
                </c:pt>
                <c:pt idx="631">
                  <c:v>1866.7783609999999</c:v>
                </c:pt>
                <c:pt idx="632">
                  <c:v>1868.7068509999999</c:v>
                </c:pt>
                <c:pt idx="633">
                  <c:v>1870.6353409999999</c:v>
                </c:pt>
                <c:pt idx="634">
                  <c:v>1872.5638309999999</c:v>
                </c:pt>
                <c:pt idx="635">
                  <c:v>1874.4923209999999</c:v>
                </c:pt>
                <c:pt idx="636">
                  <c:v>1876.4208120000001</c:v>
                </c:pt>
                <c:pt idx="637">
                  <c:v>1878.3493020000001</c:v>
                </c:pt>
                <c:pt idx="638">
                  <c:v>1880.2777920000001</c:v>
                </c:pt>
                <c:pt idx="639">
                  <c:v>1882.2062820000001</c:v>
                </c:pt>
                <c:pt idx="640">
                  <c:v>1884.1347720000001</c:v>
                </c:pt>
                <c:pt idx="641">
                  <c:v>1886.0632619999999</c:v>
                </c:pt>
                <c:pt idx="642">
                  <c:v>1887.9917519999999</c:v>
                </c:pt>
                <c:pt idx="643">
                  <c:v>1889.9202419999999</c:v>
                </c:pt>
                <c:pt idx="644">
                  <c:v>1891.8487319999999</c:v>
                </c:pt>
                <c:pt idx="645">
                  <c:v>1893.7772219999999</c:v>
                </c:pt>
                <c:pt idx="646">
                  <c:v>1895.7057119999999</c:v>
                </c:pt>
                <c:pt idx="647">
                  <c:v>1897.634202</c:v>
                </c:pt>
                <c:pt idx="648">
                  <c:v>1899.562692</c:v>
                </c:pt>
                <c:pt idx="649">
                  <c:v>1901.491182</c:v>
                </c:pt>
                <c:pt idx="650">
                  <c:v>1903.419672</c:v>
                </c:pt>
                <c:pt idx="651">
                  <c:v>1905.348162</c:v>
                </c:pt>
                <c:pt idx="652">
                  <c:v>1907.276652</c:v>
                </c:pt>
                <c:pt idx="653">
                  <c:v>1909.205142</c:v>
                </c:pt>
                <c:pt idx="654">
                  <c:v>1911.133632</c:v>
                </c:pt>
                <c:pt idx="655">
                  <c:v>1913.062122</c:v>
                </c:pt>
                <c:pt idx="656">
                  <c:v>1914.9906120000001</c:v>
                </c:pt>
                <c:pt idx="657">
                  <c:v>1916.9191020000001</c:v>
                </c:pt>
                <c:pt idx="658">
                  <c:v>1918.8475920000001</c:v>
                </c:pt>
                <c:pt idx="659">
                  <c:v>1920.776083</c:v>
                </c:pt>
                <c:pt idx="660">
                  <c:v>1922.704573</c:v>
                </c:pt>
                <c:pt idx="661">
                  <c:v>1924.633063</c:v>
                </c:pt>
                <c:pt idx="662">
                  <c:v>1926.561553</c:v>
                </c:pt>
                <c:pt idx="663">
                  <c:v>1928.490043</c:v>
                </c:pt>
                <c:pt idx="664">
                  <c:v>1930.418533</c:v>
                </c:pt>
                <c:pt idx="665">
                  <c:v>1932.347023</c:v>
                </c:pt>
                <c:pt idx="666">
                  <c:v>1934.275513</c:v>
                </c:pt>
                <c:pt idx="667">
                  <c:v>1936.2040030000001</c:v>
                </c:pt>
                <c:pt idx="668">
                  <c:v>1938.1324930000001</c:v>
                </c:pt>
                <c:pt idx="669">
                  <c:v>1940.0609830000001</c:v>
                </c:pt>
                <c:pt idx="670">
                  <c:v>1941.9894730000001</c:v>
                </c:pt>
                <c:pt idx="671">
                  <c:v>1943.9179630000001</c:v>
                </c:pt>
                <c:pt idx="672">
                  <c:v>1945.8464530000001</c:v>
                </c:pt>
                <c:pt idx="673">
                  <c:v>1947.7749429999999</c:v>
                </c:pt>
                <c:pt idx="674">
                  <c:v>1949.7034329999999</c:v>
                </c:pt>
                <c:pt idx="675">
                  <c:v>1951.6319229999999</c:v>
                </c:pt>
                <c:pt idx="676">
                  <c:v>1953.5604129999999</c:v>
                </c:pt>
                <c:pt idx="677">
                  <c:v>1955.4889029999999</c:v>
                </c:pt>
                <c:pt idx="678">
                  <c:v>1957.4173929999999</c:v>
                </c:pt>
                <c:pt idx="679">
                  <c:v>1959.345883</c:v>
                </c:pt>
                <c:pt idx="680">
                  <c:v>1961.274373</c:v>
                </c:pt>
                <c:pt idx="681">
                  <c:v>1963.202863</c:v>
                </c:pt>
                <c:pt idx="682">
                  <c:v>1965.131353</c:v>
                </c:pt>
                <c:pt idx="683">
                  <c:v>1967.0598440000001</c:v>
                </c:pt>
                <c:pt idx="684">
                  <c:v>1968.9883339999999</c:v>
                </c:pt>
                <c:pt idx="685">
                  <c:v>1970.9168239999999</c:v>
                </c:pt>
                <c:pt idx="686">
                  <c:v>1972.8453139999999</c:v>
                </c:pt>
                <c:pt idx="687">
                  <c:v>1974.7738039999999</c:v>
                </c:pt>
                <c:pt idx="688">
                  <c:v>1976.7022939999999</c:v>
                </c:pt>
                <c:pt idx="689">
                  <c:v>1978.6307839999999</c:v>
                </c:pt>
                <c:pt idx="690">
                  <c:v>1980.559274</c:v>
                </c:pt>
                <c:pt idx="691">
                  <c:v>1982.487764</c:v>
                </c:pt>
                <c:pt idx="692">
                  <c:v>1984.416254</c:v>
                </c:pt>
                <c:pt idx="693">
                  <c:v>1986.344744</c:v>
                </c:pt>
                <c:pt idx="694">
                  <c:v>1988.273234</c:v>
                </c:pt>
                <c:pt idx="695">
                  <c:v>1990.201724</c:v>
                </c:pt>
                <c:pt idx="696">
                  <c:v>1992.130214</c:v>
                </c:pt>
                <c:pt idx="697">
                  <c:v>1994.058704</c:v>
                </c:pt>
                <c:pt idx="698">
                  <c:v>1995.987194</c:v>
                </c:pt>
                <c:pt idx="699">
                  <c:v>1997.9156840000001</c:v>
                </c:pt>
                <c:pt idx="700">
                  <c:v>1999.8441740000001</c:v>
                </c:pt>
                <c:pt idx="701">
                  <c:v>2001.7726640000001</c:v>
                </c:pt>
                <c:pt idx="702">
                  <c:v>2003.7011540000001</c:v>
                </c:pt>
                <c:pt idx="703">
                  <c:v>2005.6296440000001</c:v>
                </c:pt>
                <c:pt idx="704">
                  <c:v>2007.5581340000001</c:v>
                </c:pt>
                <c:pt idx="705">
                  <c:v>2009.4866239999999</c:v>
                </c:pt>
                <c:pt idx="706">
                  <c:v>2011.415115</c:v>
                </c:pt>
                <c:pt idx="707">
                  <c:v>2013.343605</c:v>
                </c:pt>
                <c:pt idx="708">
                  <c:v>2015.272095</c:v>
                </c:pt>
                <c:pt idx="709">
                  <c:v>2017.200585</c:v>
                </c:pt>
                <c:pt idx="710">
                  <c:v>2019.1290750000001</c:v>
                </c:pt>
                <c:pt idx="711">
                  <c:v>2021.0575650000001</c:v>
                </c:pt>
                <c:pt idx="712">
                  <c:v>2022.9860550000001</c:v>
                </c:pt>
                <c:pt idx="713">
                  <c:v>2024.9145450000001</c:v>
                </c:pt>
                <c:pt idx="714">
                  <c:v>2026.8430350000001</c:v>
                </c:pt>
                <c:pt idx="715">
                  <c:v>2028.7715250000001</c:v>
                </c:pt>
                <c:pt idx="716">
                  <c:v>2030.7000149999999</c:v>
                </c:pt>
                <c:pt idx="717">
                  <c:v>2032.6285049999999</c:v>
                </c:pt>
                <c:pt idx="718">
                  <c:v>2034.5569949999999</c:v>
                </c:pt>
                <c:pt idx="719">
                  <c:v>2036.4854849999999</c:v>
                </c:pt>
                <c:pt idx="720">
                  <c:v>2038.4139749999999</c:v>
                </c:pt>
                <c:pt idx="721">
                  <c:v>2040.3424649999999</c:v>
                </c:pt>
                <c:pt idx="722">
                  <c:v>2042.270955</c:v>
                </c:pt>
                <c:pt idx="723">
                  <c:v>2044.199445</c:v>
                </c:pt>
                <c:pt idx="724">
                  <c:v>2046.127935</c:v>
                </c:pt>
                <c:pt idx="725">
                  <c:v>2048.0564250000002</c:v>
                </c:pt>
                <c:pt idx="726">
                  <c:v>2049.984915</c:v>
                </c:pt>
                <c:pt idx="727">
                  <c:v>2051.9134049999998</c:v>
                </c:pt>
                <c:pt idx="728">
                  <c:v>2053.841895</c:v>
                </c:pt>
                <c:pt idx="729">
                  <c:v>2055.7703860000001</c:v>
                </c:pt>
                <c:pt idx="730">
                  <c:v>2057.698875999999</c:v>
                </c:pt>
                <c:pt idx="731">
                  <c:v>2059.6273660000002</c:v>
                </c:pt>
                <c:pt idx="732">
                  <c:v>2061.5558559999999</c:v>
                </c:pt>
                <c:pt idx="733">
                  <c:v>2063.4843460000002</c:v>
                </c:pt>
                <c:pt idx="734">
                  <c:v>2065.412836</c:v>
                </c:pt>
                <c:pt idx="735">
                  <c:v>2067.3413260000002</c:v>
                </c:pt>
                <c:pt idx="736">
                  <c:v>2069.269816</c:v>
                </c:pt>
                <c:pt idx="737">
                  <c:v>2071.1983059999998</c:v>
                </c:pt>
                <c:pt idx="738">
                  <c:v>2073.126796</c:v>
                </c:pt>
                <c:pt idx="739">
                  <c:v>2075.0552859999998</c:v>
                </c:pt>
                <c:pt idx="740">
                  <c:v>2076.983776</c:v>
                </c:pt>
                <c:pt idx="741">
                  <c:v>2078.9122659999998</c:v>
                </c:pt>
                <c:pt idx="742">
                  <c:v>2080.8407560000001</c:v>
                </c:pt>
                <c:pt idx="743">
                  <c:v>2082.769245999998</c:v>
                </c:pt>
                <c:pt idx="744">
                  <c:v>2084.6977360000001</c:v>
                </c:pt>
                <c:pt idx="745">
                  <c:v>2086.626225999998</c:v>
                </c:pt>
                <c:pt idx="746">
                  <c:v>2088.5547160000001</c:v>
                </c:pt>
                <c:pt idx="747">
                  <c:v>2090.4832059999999</c:v>
                </c:pt>
                <c:pt idx="748">
                  <c:v>2092.4116960000001</c:v>
                </c:pt>
                <c:pt idx="749">
                  <c:v>2094.3401859999999</c:v>
                </c:pt>
                <c:pt idx="750">
                  <c:v>2096.2686760000001</c:v>
                </c:pt>
                <c:pt idx="751">
                  <c:v>2098.1971659999999</c:v>
                </c:pt>
                <c:pt idx="752">
                  <c:v>2100.1256560000002</c:v>
                </c:pt>
                <c:pt idx="753">
                  <c:v>2102.0541469999998</c:v>
                </c:pt>
                <c:pt idx="754">
                  <c:v>2103.9826370000001</c:v>
                </c:pt>
                <c:pt idx="755">
                  <c:v>2105.9111269999999</c:v>
                </c:pt>
                <c:pt idx="756">
                  <c:v>2107.8396170000001</c:v>
                </c:pt>
                <c:pt idx="757">
                  <c:v>2109.7681069999999</c:v>
                </c:pt>
                <c:pt idx="758">
                  <c:v>2111.6965970000001</c:v>
                </c:pt>
                <c:pt idx="759">
                  <c:v>2113.6250869999999</c:v>
                </c:pt>
                <c:pt idx="760">
                  <c:v>2115.5535770000001</c:v>
                </c:pt>
                <c:pt idx="761">
                  <c:v>2117.4820669999999</c:v>
                </c:pt>
                <c:pt idx="762">
                  <c:v>2119.4105570000002</c:v>
                </c:pt>
                <c:pt idx="763">
                  <c:v>2121.3390469999999</c:v>
                </c:pt>
                <c:pt idx="764">
                  <c:v>2123.2675370000002</c:v>
                </c:pt>
                <c:pt idx="765">
                  <c:v>2125.196027</c:v>
                </c:pt>
                <c:pt idx="766">
                  <c:v>2127.1245170000002</c:v>
                </c:pt>
                <c:pt idx="767">
                  <c:v>2129.053007</c:v>
                </c:pt>
                <c:pt idx="768">
                  <c:v>2130.9814970000002</c:v>
                </c:pt>
                <c:pt idx="769">
                  <c:v>2132.909987</c:v>
                </c:pt>
                <c:pt idx="770">
                  <c:v>2134.8384769999998</c:v>
                </c:pt>
                <c:pt idx="771">
                  <c:v>2136.766967</c:v>
                </c:pt>
                <c:pt idx="772">
                  <c:v>2138.6954569999998</c:v>
                </c:pt>
                <c:pt idx="773">
                  <c:v>2140.623947</c:v>
                </c:pt>
                <c:pt idx="774">
                  <c:v>2142.5524369999998</c:v>
                </c:pt>
                <c:pt idx="775">
                  <c:v>2144.4809270000001</c:v>
                </c:pt>
                <c:pt idx="776">
                  <c:v>2146.4094180000002</c:v>
                </c:pt>
                <c:pt idx="777">
                  <c:v>2148.337908</c:v>
                </c:pt>
                <c:pt idx="778">
                  <c:v>2150.2663980000002</c:v>
                </c:pt>
                <c:pt idx="779">
                  <c:v>2152.194888</c:v>
                </c:pt>
                <c:pt idx="780">
                  <c:v>2154.1233779999998</c:v>
                </c:pt>
                <c:pt idx="781">
                  <c:v>2156.051868</c:v>
                </c:pt>
                <c:pt idx="782">
                  <c:v>2157.9803579999998</c:v>
                </c:pt>
                <c:pt idx="783">
                  <c:v>2159.908848</c:v>
                </c:pt>
                <c:pt idx="784">
                  <c:v>2161.8373379999998</c:v>
                </c:pt>
                <c:pt idx="785">
                  <c:v>2163.7658280000001</c:v>
                </c:pt>
                <c:pt idx="786">
                  <c:v>2165.6943179999998</c:v>
                </c:pt>
                <c:pt idx="787">
                  <c:v>2167.6228080000001</c:v>
                </c:pt>
                <c:pt idx="788">
                  <c:v>2169.5512979999999</c:v>
                </c:pt>
                <c:pt idx="789">
                  <c:v>2171.4797880000001</c:v>
                </c:pt>
                <c:pt idx="790">
                  <c:v>2173.4082779999999</c:v>
                </c:pt>
                <c:pt idx="791">
                  <c:v>2175.3367680000001</c:v>
                </c:pt>
                <c:pt idx="792">
                  <c:v>2177.2652579999999</c:v>
                </c:pt>
                <c:pt idx="793">
                  <c:v>2179.1937480000001</c:v>
                </c:pt>
                <c:pt idx="794">
                  <c:v>2181.1222379999999</c:v>
                </c:pt>
                <c:pt idx="795">
                  <c:v>2183.0507280000002</c:v>
                </c:pt>
                <c:pt idx="796">
                  <c:v>2184.9792179999999</c:v>
                </c:pt>
                <c:pt idx="797">
                  <c:v>2186.9077080000002</c:v>
                </c:pt>
                <c:pt idx="798">
                  <c:v>2188.836198</c:v>
                </c:pt>
                <c:pt idx="799">
                  <c:v>2190.7646879999952</c:v>
                </c:pt>
                <c:pt idx="800">
                  <c:v>2192.6931789999999</c:v>
                </c:pt>
                <c:pt idx="801">
                  <c:v>2194.6216690000001</c:v>
                </c:pt>
                <c:pt idx="802">
                  <c:v>2196.5501589999999</c:v>
                </c:pt>
                <c:pt idx="803">
                  <c:v>2198.4786490000001</c:v>
                </c:pt>
                <c:pt idx="804">
                  <c:v>2200.4071389999999</c:v>
                </c:pt>
                <c:pt idx="805">
                  <c:v>2202.3356290000002</c:v>
                </c:pt>
                <c:pt idx="806">
                  <c:v>2204.2641189999999</c:v>
                </c:pt>
                <c:pt idx="807">
                  <c:v>2206.1926090000002</c:v>
                </c:pt>
                <c:pt idx="808">
                  <c:v>2208.121099</c:v>
                </c:pt>
                <c:pt idx="809">
                  <c:v>2210.0495890000002</c:v>
                </c:pt>
                <c:pt idx="810">
                  <c:v>2211.978079</c:v>
                </c:pt>
                <c:pt idx="811">
                  <c:v>2213.9065690000002</c:v>
                </c:pt>
                <c:pt idx="812">
                  <c:v>2215.835059</c:v>
                </c:pt>
                <c:pt idx="813">
                  <c:v>2217.7635489999998</c:v>
                </c:pt>
                <c:pt idx="814">
                  <c:v>2219.692039</c:v>
                </c:pt>
                <c:pt idx="815">
                  <c:v>2221.6205289999998</c:v>
                </c:pt>
                <c:pt idx="816">
                  <c:v>2223.549019</c:v>
                </c:pt>
                <c:pt idx="817">
                  <c:v>2225.4775089999998</c:v>
                </c:pt>
                <c:pt idx="818">
                  <c:v>2227.4059990000001</c:v>
                </c:pt>
                <c:pt idx="819">
                  <c:v>2229.3344889999998</c:v>
                </c:pt>
                <c:pt idx="820">
                  <c:v>2231.2629790000001</c:v>
                </c:pt>
                <c:pt idx="821">
                  <c:v>2233.1914689999999</c:v>
                </c:pt>
                <c:pt idx="822">
                  <c:v>2235.1199590000001</c:v>
                </c:pt>
                <c:pt idx="823">
                  <c:v>2237.048449999998</c:v>
                </c:pt>
                <c:pt idx="824">
                  <c:v>2238.97694</c:v>
                </c:pt>
                <c:pt idx="825">
                  <c:v>2240.9054299999998</c:v>
                </c:pt>
                <c:pt idx="826">
                  <c:v>2242.83392</c:v>
                </c:pt>
                <c:pt idx="827">
                  <c:v>2244.762409999998</c:v>
                </c:pt>
                <c:pt idx="828">
                  <c:v>2246.6909000000001</c:v>
                </c:pt>
                <c:pt idx="829">
                  <c:v>2248.6193899999998</c:v>
                </c:pt>
                <c:pt idx="830">
                  <c:v>2250.5478800000001</c:v>
                </c:pt>
                <c:pt idx="831">
                  <c:v>2252.4763699999999</c:v>
                </c:pt>
                <c:pt idx="832">
                  <c:v>2254.4048600000001</c:v>
                </c:pt>
                <c:pt idx="833">
                  <c:v>2256.3333499999999</c:v>
                </c:pt>
                <c:pt idx="834">
                  <c:v>2258.2618400000001</c:v>
                </c:pt>
                <c:pt idx="835">
                  <c:v>2260.1903299999999</c:v>
                </c:pt>
                <c:pt idx="836">
                  <c:v>2262.1188200000001</c:v>
                </c:pt>
                <c:pt idx="837">
                  <c:v>2264.0473099999999</c:v>
                </c:pt>
                <c:pt idx="838">
                  <c:v>2265.9758000000002</c:v>
                </c:pt>
                <c:pt idx="839">
                  <c:v>2267.904289999999</c:v>
                </c:pt>
                <c:pt idx="840">
                  <c:v>2269.8327800000002</c:v>
                </c:pt>
                <c:pt idx="841">
                  <c:v>2271.76127</c:v>
                </c:pt>
                <c:pt idx="842">
                  <c:v>2273.6897600000002</c:v>
                </c:pt>
                <c:pt idx="843">
                  <c:v>2275.61825</c:v>
                </c:pt>
                <c:pt idx="844">
                  <c:v>2277.5467400000002</c:v>
                </c:pt>
                <c:pt idx="845">
                  <c:v>2279.47523</c:v>
                </c:pt>
                <c:pt idx="846">
                  <c:v>2281.4037199999998</c:v>
                </c:pt>
                <c:pt idx="847">
                  <c:v>2283.3322109999999</c:v>
                </c:pt>
                <c:pt idx="848">
                  <c:v>2285.2607010000002</c:v>
                </c:pt>
                <c:pt idx="849">
                  <c:v>2287.1891909999999</c:v>
                </c:pt>
                <c:pt idx="850">
                  <c:v>2289.1176810000002</c:v>
                </c:pt>
                <c:pt idx="851">
                  <c:v>2291.046171</c:v>
                </c:pt>
                <c:pt idx="852">
                  <c:v>2292.9746610000002</c:v>
                </c:pt>
                <c:pt idx="853">
                  <c:v>2294.903151</c:v>
                </c:pt>
                <c:pt idx="854">
                  <c:v>2296.8316410000002</c:v>
                </c:pt>
                <c:pt idx="855">
                  <c:v>2298.760131</c:v>
                </c:pt>
                <c:pt idx="856">
                  <c:v>2300.688620999998</c:v>
                </c:pt>
                <c:pt idx="857">
                  <c:v>2302.617111</c:v>
                </c:pt>
                <c:pt idx="858">
                  <c:v>2304.5456009999998</c:v>
                </c:pt>
                <c:pt idx="859">
                  <c:v>2306.474091</c:v>
                </c:pt>
                <c:pt idx="860">
                  <c:v>2308.4025809999998</c:v>
                </c:pt>
                <c:pt idx="861">
                  <c:v>2310.3310710000001</c:v>
                </c:pt>
                <c:pt idx="862">
                  <c:v>2312.2595609999998</c:v>
                </c:pt>
                <c:pt idx="863">
                  <c:v>2314.1880510000001</c:v>
                </c:pt>
                <c:pt idx="864">
                  <c:v>2316.1165409999999</c:v>
                </c:pt>
                <c:pt idx="865">
                  <c:v>2318.0450310000001</c:v>
                </c:pt>
                <c:pt idx="866">
                  <c:v>2319.9735209999999</c:v>
                </c:pt>
                <c:pt idx="867">
                  <c:v>2321.9020110000001</c:v>
                </c:pt>
                <c:pt idx="868">
                  <c:v>2323.8305009999999</c:v>
                </c:pt>
                <c:pt idx="869">
                  <c:v>2325.7589910000002</c:v>
                </c:pt>
                <c:pt idx="870">
                  <c:v>2327.687481999998</c:v>
                </c:pt>
                <c:pt idx="871">
                  <c:v>2329.6159720000001</c:v>
                </c:pt>
                <c:pt idx="872">
                  <c:v>2331.544461999998</c:v>
                </c:pt>
                <c:pt idx="873">
                  <c:v>2333.4729520000001</c:v>
                </c:pt>
                <c:pt idx="874">
                  <c:v>2335.4014419999999</c:v>
                </c:pt>
                <c:pt idx="875">
                  <c:v>2337.3299320000001</c:v>
                </c:pt>
                <c:pt idx="876">
                  <c:v>2339.258421999999</c:v>
                </c:pt>
                <c:pt idx="877">
                  <c:v>2341.1869120000001</c:v>
                </c:pt>
                <c:pt idx="878">
                  <c:v>2343.1154019999999</c:v>
                </c:pt>
                <c:pt idx="879">
                  <c:v>2345.0438920000001</c:v>
                </c:pt>
                <c:pt idx="880">
                  <c:v>2346.9723819999999</c:v>
                </c:pt>
                <c:pt idx="881">
                  <c:v>2348.9008720000002</c:v>
                </c:pt>
                <c:pt idx="882">
                  <c:v>2350.8293619999999</c:v>
                </c:pt>
                <c:pt idx="883">
                  <c:v>2352.7578520000002</c:v>
                </c:pt>
                <c:pt idx="884">
                  <c:v>2354.686342</c:v>
                </c:pt>
                <c:pt idx="885">
                  <c:v>2356.6148320000002</c:v>
                </c:pt>
                <c:pt idx="886">
                  <c:v>2358.543322</c:v>
                </c:pt>
                <c:pt idx="887">
                  <c:v>2360.4718120000002</c:v>
                </c:pt>
                <c:pt idx="888">
                  <c:v>2362.400302</c:v>
                </c:pt>
                <c:pt idx="889">
                  <c:v>2364.3287919999998</c:v>
                </c:pt>
                <c:pt idx="890">
                  <c:v>2366.257282</c:v>
                </c:pt>
                <c:pt idx="891">
                  <c:v>2368.1857719999998</c:v>
                </c:pt>
                <c:pt idx="892">
                  <c:v>2370.1142620000001</c:v>
                </c:pt>
                <c:pt idx="893">
                  <c:v>2372.0427530000002</c:v>
                </c:pt>
                <c:pt idx="894">
                  <c:v>2373.971243</c:v>
                </c:pt>
                <c:pt idx="895">
                  <c:v>2375.8997330000002</c:v>
                </c:pt>
                <c:pt idx="896">
                  <c:v>2377.828223</c:v>
                </c:pt>
                <c:pt idx="897">
                  <c:v>2379.7567130000002</c:v>
                </c:pt>
                <c:pt idx="898">
                  <c:v>2381.685203</c:v>
                </c:pt>
                <c:pt idx="899">
                  <c:v>2383.6136929999998</c:v>
                </c:pt>
                <c:pt idx="900">
                  <c:v>2385.542183</c:v>
                </c:pt>
                <c:pt idx="901">
                  <c:v>2387.4706729999998</c:v>
                </c:pt>
                <c:pt idx="902">
                  <c:v>2389.399163</c:v>
                </c:pt>
                <c:pt idx="903">
                  <c:v>2391.3276529999998</c:v>
                </c:pt>
                <c:pt idx="904">
                  <c:v>2393.2561430000001</c:v>
                </c:pt>
                <c:pt idx="905">
                  <c:v>2395.1846329999998</c:v>
                </c:pt>
                <c:pt idx="906">
                  <c:v>2397.1131230000001</c:v>
                </c:pt>
                <c:pt idx="907">
                  <c:v>2399.0416129999999</c:v>
                </c:pt>
                <c:pt idx="908">
                  <c:v>2400.9701030000001</c:v>
                </c:pt>
                <c:pt idx="909">
                  <c:v>2402.8985929999999</c:v>
                </c:pt>
                <c:pt idx="910">
                  <c:v>2404.8270830000001</c:v>
                </c:pt>
                <c:pt idx="911">
                  <c:v>2406.7555729999999</c:v>
                </c:pt>
                <c:pt idx="912">
                  <c:v>2408.6840630000002</c:v>
                </c:pt>
                <c:pt idx="913">
                  <c:v>2410.6125529999999</c:v>
                </c:pt>
                <c:pt idx="914">
                  <c:v>2412.5410430000002</c:v>
                </c:pt>
                <c:pt idx="915">
                  <c:v>2414.469533</c:v>
                </c:pt>
                <c:pt idx="916">
                  <c:v>2416.3980230000002</c:v>
                </c:pt>
                <c:pt idx="917">
                  <c:v>2418.3265139999999</c:v>
                </c:pt>
                <c:pt idx="918">
                  <c:v>2420.2550040000001</c:v>
                </c:pt>
                <c:pt idx="919">
                  <c:v>2422.1834939999999</c:v>
                </c:pt>
                <c:pt idx="920">
                  <c:v>2424.1119840000001</c:v>
                </c:pt>
                <c:pt idx="921">
                  <c:v>2426.0404739999999</c:v>
                </c:pt>
                <c:pt idx="922">
                  <c:v>2427.9689640000001</c:v>
                </c:pt>
                <c:pt idx="923">
                  <c:v>2429.8974539999999</c:v>
                </c:pt>
                <c:pt idx="924">
                  <c:v>2431.8259440000002</c:v>
                </c:pt>
                <c:pt idx="925">
                  <c:v>2433.7544339999999</c:v>
                </c:pt>
                <c:pt idx="926">
                  <c:v>2435.6829240000002</c:v>
                </c:pt>
                <c:pt idx="927">
                  <c:v>2437.611414</c:v>
                </c:pt>
                <c:pt idx="928">
                  <c:v>2439.5399040000002</c:v>
                </c:pt>
                <c:pt idx="929">
                  <c:v>2441.468394</c:v>
                </c:pt>
                <c:pt idx="930">
                  <c:v>2443.3968839999998</c:v>
                </c:pt>
                <c:pt idx="931">
                  <c:v>2445.325374</c:v>
                </c:pt>
                <c:pt idx="932">
                  <c:v>2447.2538639999998</c:v>
                </c:pt>
                <c:pt idx="933">
                  <c:v>2449.182354</c:v>
                </c:pt>
                <c:pt idx="934">
                  <c:v>2451.1108439999998</c:v>
                </c:pt>
                <c:pt idx="935">
                  <c:v>2453.0393340000001</c:v>
                </c:pt>
                <c:pt idx="936">
                  <c:v>2454.9678239999998</c:v>
                </c:pt>
                <c:pt idx="937">
                  <c:v>2456.8963140000001</c:v>
                </c:pt>
                <c:pt idx="938">
                  <c:v>2458.8248039999999</c:v>
                </c:pt>
                <c:pt idx="939">
                  <c:v>2460.7532940000001</c:v>
                </c:pt>
                <c:pt idx="940">
                  <c:v>2462.6817850000002</c:v>
                </c:pt>
                <c:pt idx="941">
                  <c:v>2464.610275</c:v>
                </c:pt>
                <c:pt idx="942">
                  <c:v>2466.5387649999998</c:v>
                </c:pt>
                <c:pt idx="943">
                  <c:v>2468.467255</c:v>
                </c:pt>
                <c:pt idx="944">
                  <c:v>2470.3957449999998</c:v>
                </c:pt>
                <c:pt idx="945">
                  <c:v>2472.324235</c:v>
                </c:pt>
                <c:pt idx="946">
                  <c:v>2474.2527249999998</c:v>
                </c:pt>
                <c:pt idx="947">
                  <c:v>2476.1812150000001</c:v>
                </c:pt>
                <c:pt idx="948">
                  <c:v>2478.1097049999998</c:v>
                </c:pt>
                <c:pt idx="949">
                  <c:v>2480.0381950000001</c:v>
                </c:pt>
                <c:pt idx="950">
                  <c:v>2481.966684999999</c:v>
                </c:pt>
                <c:pt idx="951">
                  <c:v>2483.8951750000001</c:v>
                </c:pt>
                <c:pt idx="952">
                  <c:v>2485.8236649999999</c:v>
                </c:pt>
                <c:pt idx="953">
                  <c:v>2487.7521550000001</c:v>
                </c:pt>
                <c:pt idx="954">
                  <c:v>2489.680644999999</c:v>
                </c:pt>
                <c:pt idx="955">
                  <c:v>2491.6091350000002</c:v>
                </c:pt>
                <c:pt idx="956">
                  <c:v>2493.5376249999999</c:v>
                </c:pt>
                <c:pt idx="957">
                  <c:v>2495.4661150000002</c:v>
                </c:pt>
                <c:pt idx="958">
                  <c:v>2497.394605</c:v>
                </c:pt>
                <c:pt idx="959">
                  <c:v>2499.3230950000002</c:v>
                </c:pt>
                <c:pt idx="960">
                  <c:v>2501.251585</c:v>
                </c:pt>
                <c:pt idx="961">
                  <c:v>2503.1800750000002</c:v>
                </c:pt>
                <c:pt idx="962">
                  <c:v>2505.108565</c:v>
                </c:pt>
                <c:pt idx="963">
                  <c:v>2507.0370549999998</c:v>
                </c:pt>
                <c:pt idx="964">
                  <c:v>2508.9655459999999</c:v>
                </c:pt>
                <c:pt idx="965">
                  <c:v>2510.8940360000001</c:v>
                </c:pt>
                <c:pt idx="966">
                  <c:v>2512.8225259999999</c:v>
                </c:pt>
                <c:pt idx="967">
                  <c:v>2514.7510160000002</c:v>
                </c:pt>
                <c:pt idx="968">
                  <c:v>2516.6795059999999</c:v>
                </c:pt>
                <c:pt idx="969">
                  <c:v>2518.6079960000002</c:v>
                </c:pt>
                <c:pt idx="970">
                  <c:v>2520.536486</c:v>
                </c:pt>
                <c:pt idx="971">
                  <c:v>2522.4649760000002</c:v>
                </c:pt>
                <c:pt idx="972">
                  <c:v>2524.393466</c:v>
                </c:pt>
                <c:pt idx="973">
                  <c:v>2526.3219559999998</c:v>
                </c:pt>
                <c:pt idx="974">
                  <c:v>2528.250446</c:v>
                </c:pt>
                <c:pt idx="975">
                  <c:v>2530.1789359999998</c:v>
                </c:pt>
                <c:pt idx="976">
                  <c:v>2532.107426</c:v>
                </c:pt>
                <c:pt idx="977">
                  <c:v>2534.0359159999998</c:v>
                </c:pt>
                <c:pt idx="978">
                  <c:v>2535.9644060000001</c:v>
                </c:pt>
                <c:pt idx="979">
                  <c:v>2537.8928959999998</c:v>
                </c:pt>
                <c:pt idx="980">
                  <c:v>2539.8213860000001</c:v>
                </c:pt>
                <c:pt idx="981">
                  <c:v>2541.749875999998</c:v>
                </c:pt>
                <c:pt idx="982">
                  <c:v>2543.6783660000001</c:v>
                </c:pt>
                <c:pt idx="983">
                  <c:v>2545.606855999999</c:v>
                </c:pt>
                <c:pt idx="984">
                  <c:v>2547.5353460000001</c:v>
                </c:pt>
                <c:pt idx="985">
                  <c:v>2549.4638359999999</c:v>
                </c:pt>
                <c:pt idx="986">
                  <c:v>2551.3923260000001</c:v>
                </c:pt>
                <c:pt idx="987">
                  <c:v>2553.3208169999998</c:v>
                </c:pt>
                <c:pt idx="988">
                  <c:v>2555.249307</c:v>
                </c:pt>
                <c:pt idx="989">
                  <c:v>2557.1777969999998</c:v>
                </c:pt>
                <c:pt idx="990">
                  <c:v>2559.1062870000001</c:v>
                </c:pt>
                <c:pt idx="991">
                  <c:v>2561.0347769999998</c:v>
                </c:pt>
                <c:pt idx="992">
                  <c:v>2562.9632670000001</c:v>
                </c:pt>
                <c:pt idx="993">
                  <c:v>2564.8917569999999</c:v>
                </c:pt>
                <c:pt idx="994">
                  <c:v>2566.8202470000001</c:v>
                </c:pt>
                <c:pt idx="995">
                  <c:v>2568.7487369999999</c:v>
                </c:pt>
                <c:pt idx="996">
                  <c:v>2570.6772270000001</c:v>
                </c:pt>
                <c:pt idx="997">
                  <c:v>2572.6057169999999</c:v>
                </c:pt>
                <c:pt idx="998">
                  <c:v>2574.5342070000002</c:v>
                </c:pt>
                <c:pt idx="999">
                  <c:v>2576.4626969999999</c:v>
                </c:pt>
                <c:pt idx="1000">
                  <c:v>2578.3911870000002</c:v>
                </c:pt>
                <c:pt idx="1001">
                  <c:v>2580.319677</c:v>
                </c:pt>
                <c:pt idx="1002">
                  <c:v>2582.2481670000002</c:v>
                </c:pt>
                <c:pt idx="1003">
                  <c:v>2584.176657</c:v>
                </c:pt>
                <c:pt idx="1004">
                  <c:v>2586.1051470000002</c:v>
                </c:pt>
                <c:pt idx="1005">
                  <c:v>2588.033637</c:v>
                </c:pt>
                <c:pt idx="1006">
                  <c:v>2589.9621269999998</c:v>
                </c:pt>
                <c:pt idx="1007">
                  <c:v>2591.890617</c:v>
                </c:pt>
                <c:pt idx="1008">
                  <c:v>2593.8191069999998</c:v>
                </c:pt>
                <c:pt idx="1009">
                  <c:v>2595.747597</c:v>
                </c:pt>
                <c:pt idx="1010">
                  <c:v>2597.6760869999998</c:v>
                </c:pt>
                <c:pt idx="1011">
                  <c:v>2599.6045779999999</c:v>
                </c:pt>
                <c:pt idx="1012">
                  <c:v>2601.5330680000002</c:v>
                </c:pt>
                <c:pt idx="1013">
                  <c:v>2603.461558</c:v>
                </c:pt>
                <c:pt idx="1014">
                  <c:v>2605.3900480000002</c:v>
                </c:pt>
                <c:pt idx="1015">
                  <c:v>2607.318538</c:v>
                </c:pt>
                <c:pt idx="1016">
                  <c:v>2609.2470279999998</c:v>
                </c:pt>
                <c:pt idx="1017">
                  <c:v>2611.175518</c:v>
                </c:pt>
                <c:pt idx="1018">
                  <c:v>2613.1040079999998</c:v>
                </c:pt>
                <c:pt idx="1019">
                  <c:v>2615.032498</c:v>
                </c:pt>
                <c:pt idx="1020">
                  <c:v>2616.9609879999998</c:v>
                </c:pt>
                <c:pt idx="1021">
                  <c:v>2618.8894780000001</c:v>
                </c:pt>
                <c:pt idx="1022">
                  <c:v>2620.8179679999998</c:v>
                </c:pt>
                <c:pt idx="1023">
                  <c:v>2622.7464580000001</c:v>
                </c:pt>
                <c:pt idx="1024">
                  <c:v>2624.6749479999999</c:v>
                </c:pt>
                <c:pt idx="1025">
                  <c:v>2626.6034380000001</c:v>
                </c:pt>
                <c:pt idx="1026">
                  <c:v>2628.5319279999999</c:v>
                </c:pt>
                <c:pt idx="1027">
                  <c:v>2630.4604180000001</c:v>
                </c:pt>
                <c:pt idx="1028">
                  <c:v>2632.3889079999999</c:v>
                </c:pt>
                <c:pt idx="1029">
                  <c:v>2634.3173980000001</c:v>
                </c:pt>
                <c:pt idx="1030">
                  <c:v>2636.245887999999</c:v>
                </c:pt>
                <c:pt idx="1031">
                  <c:v>2638.1743780000002</c:v>
                </c:pt>
                <c:pt idx="1032">
                  <c:v>2640.102867999999</c:v>
                </c:pt>
                <c:pt idx="1033">
                  <c:v>2642.0313580000002</c:v>
                </c:pt>
                <c:pt idx="1034">
                  <c:v>2643.9598489999998</c:v>
                </c:pt>
                <c:pt idx="1035">
                  <c:v>2645.8883390000001</c:v>
                </c:pt>
                <c:pt idx="1036">
                  <c:v>2647.8168289999999</c:v>
                </c:pt>
                <c:pt idx="1037">
                  <c:v>2649.7453190000001</c:v>
                </c:pt>
                <c:pt idx="1038">
                  <c:v>2651.6738089999999</c:v>
                </c:pt>
                <c:pt idx="1039">
                  <c:v>2653.6022990000001</c:v>
                </c:pt>
                <c:pt idx="1040">
                  <c:v>2655.5307889999999</c:v>
                </c:pt>
                <c:pt idx="1041">
                  <c:v>2657.4592790000002</c:v>
                </c:pt>
                <c:pt idx="1042">
                  <c:v>2659.3877689999999</c:v>
                </c:pt>
                <c:pt idx="1043">
                  <c:v>2661.3162590000002</c:v>
                </c:pt>
                <c:pt idx="1044">
                  <c:v>2663.244749</c:v>
                </c:pt>
                <c:pt idx="1045">
                  <c:v>2665.1732390000002</c:v>
                </c:pt>
                <c:pt idx="1046">
                  <c:v>2667.101729</c:v>
                </c:pt>
                <c:pt idx="1047">
                  <c:v>2669.0302190000002</c:v>
                </c:pt>
                <c:pt idx="1048">
                  <c:v>2670.958709</c:v>
                </c:pt>
                <c:pt idx="1049">
                  <c:v>2672.8871989999998</c:v>
                </c:pt>
                <c:pt idx="1050">
                  <c:v>2674.815689</c:v>
                </c:pt>
                <c:pt idx="1051">
                  <c:v>2676.7441789999998</c:v>
                </c:pt>
                <c:pt idx="1052">
                  <c:v>2678.672669</c:v>
                </c:pt>
                <c:pt idx="1053">
                  <c:v>2680.6011589999998</c:v>
                </c:pt>
                <c:pt idx="1054">
                  <c:v>2682.5296490000001</c:v>
                </c:pt>
                <c:pt idx="1055">
                  <c:v>2684.4581389999998</c:v>
                </c:pt>
                <c:pt idx="1056">
                  <c:v>2686.3866290000001</c:v>
                </c:pt>
                <c:pt idx="1057">
                  <c:v>2688.3151200000002</c:v>
                </c:pt>
                <c:pt idx="1058">
                  <c:v>2690.24361</c:v>
                </c:pt>
                <c:pt idx="1059">
                  <c:v>2692.1720999999998</c:v>
                </c:pt>
                <c:pt idx="1060">
                  <c:v>2694.10059</c:v>
                </c:pt>
                <c:pt idx="1061">
                  <c:v>2696.0290799999998</c:v>
                </c:pt>
                <c:pt idx="1062">
                  <c:v>2697.95757</c:v>
                </c:pt>
                <c:pt idx="1063">
                  <c:v>2699.8860599999998</c:v>
                </c:pt>
                <c:pt idx="1064">
                  <c:v>2701.8145500000001</c:v>
                </c:pt>
                <c:pt idx="1065">
                  <c:v>2703.7430399999998</c:v>
                </c:pt>
                <c:pt idx="1066">
                  <c:v>2705.6715300000001</c:v>
                </c:pt>
                <c:pt idx="1067">
                  <c:v>2707.6000199999999</c:v>
                </c:pt>
                <c:pt idx="1068">
                  <c:v>2709.5285100000001</c:v>
                </c:pt>
                <c:pt idx="1069">
                  <c:v>2711.4569999999999</c:v>
                </c:pt>
                <c:pt idx="1070">
                  <c:v>2713.3854900000001</c:v>
                </c:pt>
                <c:pt idx="1071">
                  <c:v>2715.3139799999999</c:v>
                </c:pt>
                <c:pt idx="1072">
                  <c:v>2717.2424700000001</c:v>
                </c:pt>
                <c:pt idx="1073">
                  <c:v>2719.1709599999999</c:v>
                </c:pt>
                <c:pt idx="1074">
                  <c:v>2721.0994500000002</c:v>
                </c:pt>
                <c:pt idx="1075">
                  <c:v>2723.0279399999999</c:v>
                </c:pt>
                <c:pt idx="1076">
                  <c:v>2724.9564300000002</c:v>
                </c:pt>
                <c:pt idx="1077">
                  <c:v>2726.88492</c:v>
                </c:pt>
                <c:pt idx="1078">
                  <c:v>2728.8134100000002</c:v>
                </c:pt>
                <c:pt idx="1079">
                  <c:v>2730.7419</c:v>
                </c:pt>
                <c:pt idx="1080">
                  <c:v>2732.6703900000002</c:v>
                </c:pt>
                <c:pt idx="1081">
                  <c:v>2734.598880999999</c:v>
                </c:pt>
                <c:pt idx="1082">
                  <c:v>2736.5273710000001</c:v>
                </c:pt>
                <c:pt idx="1083">
                  <c:v>2738.4558609999999</c:v>
                </c:pt>
                <c:pt idx="1084">
                  <c:v>2740.3843510000002</c:v>
                </c:pt>
                <c:pt idx="1085">
                  <c:v>2742.3128409999999</c:v>
                </c:pt>
                <c:pt idx="1086">
                  <c:v>2744.2413310000002</c:v>
                </c:pt>
                <c:pt idx="1087">
                  <c:v>2746.169821</c:v>
                </c:pt>
                <c:pt idx="1088">
                  <c:v>2748.0983110000002</c:v>
                </c:pt>
                <c:pt idx="1089">
                  <c:v>2750.026801</c:v>
                </c:pt>
                <c:pt idx="1090">
                  <c:v>2751.9552910000002</c:v>
                </c:pt>
                <c:pt idx="1091">
                  <c:v>2753.883781</c:v>
                </c:pt>
                <c:pt idx="1092">
                  <c:v>2755.8122709999998</c:v>
                </c:pt>
                <c:pt idx="1093">
                  <c:v>2757.740761</c:v>
                </c:pt>
                <c:pt idx="1094">
                  <c:v>2759.6692509999998</c:v>
                </c:pt>
                <c:pt idx="1095">
                  <c:v>2761.597741</c:v>
                </c:pt>
                <c:pt idx="1096">
                  <c:v>2763.5262309999998</c:v>
                </c:pt>
                <c:pt idx="1097">
                  <c:v>2765.4547210000001</c:v>
                </c:pt>
                <c:pt idx="1098">
                  <c:v>2767.3832109999998</c:v>
                </c:pt>
                <c:pt idx="1099">
                  <c:v>2769.3117010000001</c:v>
                </c:pt>
                <c:pt idx="1100">
                  <c:v>2771.2401909999999</c:v>
                </c:pt>
                <c:pt idx="1101">
                  <c:v>2773.1686809999951</c:v>
                </c:pt>
                <c:pt idx="1102">
                  <c:v>2775.0971709999999</c:v>
                </c:pt>
                <c:pt idx="1103">
                  <c:v>2777.0256610000001</c:v>
                </c:pt>
                <c:pt idx="1104">
                  <c:v>2778.9541519999998</c:v>
                </c:pt>
                <c:pt idx="1105">
                  <c:v>2780.882642</c:v>
                </c:pt>
                <c:pt idx="1106">
                  <c:v>2782.8111319999998</c:v>
                </c:pt>
                <c:pt idx="1107">
                  <c:v>2784.7396220000001</c:v>
                </c:pt>
                <c:pt idx="1108">
                  <c:v>2786.6681119999998</c:v>
                </c:pt>
                <c:pt idx="1109">
                  <c:v>2788.5966020000001</c:v>
                </c:pt>
                <c:pt idx="1110">
                  <c:v>2790.5250919999999</c:v>
                </c:pt>
                <c:pt idx="1111">
                  <c:v>2792.4535820000001</c:v>
                </c:pt>
                <c:pt idx="1112">
                  <c:v>2794.3820719999999</c:v>
                </c:pt>
                <c:pt idx="1113">
                  <c:v>2796.3105620000001</c:v>
                </c:pt>
                <c:pt idx="1114">
                  <c:v>2798.2390519999999</c:v>
                </c:pt>
                <c:pt idx="1115">
                  <c:v>2800.1675420000001</c:v>
                </c:pt>
                <c:pt idx="1116">
                  <c:v>2802.0960319999999</c:v>
                </c:pt>
                <c:pt idx="1117">
                  <c:v>2804.0245220000002</c:v>
                </c:pt>
                <c:pt idx="1118">
                  <c:v>2805.9530119999999</c:v>
                </c:pt>
                <c:pt idx="1119">
                  <c:v>2807.8815020000002</c:v>
                </c:pt>
                <c:pt idx="1120">
                  <c:v>2809.809992</c:v>
                </c:pt>
                <c:pt idx="1121">
                  <c:v>2811.7384820000002</c:v>
                </c:pt>
                <c:pt idx="1122">
                  <c:v>2813.666972</c:v>
                </c:pt>
                <c:pt idx="1123">
                  <c:v>2815.5954620000002</c:v>
                </c:pt>
                <c:pt idx="1124">
                  <c:v>2817.523952</c:v>
                </c:pt>
                <c:pt idx="1125">
                  <c:v>2819.4524419999998</c:v>
                </c:pt>
                <c:pt idx="1126">
                  <c:v>2821.380932</c:v>
                </c:pt>
                <c:pt idx="1127">
                  <c:v>2823.3094219999998</c:v>
                </c:pt>
                <c:pt idx="1128">
                  <c:v>2825.2379129999999</c:v>
                </c:pt>
                <c:pt idx="1129">
                  <c:v>2827.1664030000002</c:v>
                </c:pt>
                <c:pt idx="1130">
                  <c:v>2829.094893</c:v>
                </c:pt>
                <c:pt idx="1131">
                  <c:v>2831.0233830000002</c:v>
                </c:pt>
                <c:pt idx="1132">
                  <c:v>2832.951873</c:v>
                </c:pt>
                <c:pt idx="1133">
                  <c:v>2834.8803630000002</c:v>
                </c:pt>
                <c:pt idx="1134">
                  <c:v>2836.808853</c:v>
                </c:pt>
                <c:pt idx="1135">
                  <c:v>2838.7373429999998</c:v>
                </c:pt>
                <c:pt idx="1136">
                  <c:v>2840.665833</c:v>
                </c:pt>
                <c:pt idx="1137">
                  <c:v>2842.5943229999998</c:v>
                </c:pt>
                <c:pt idx="1138">
                  <c:v>2844.522813</c:v>
                </c:pt>
                <c:pt idx="1139">
                  <c:v>2846.4513029999998</c:v>
                </c:pt>
                <c:pt idx="1140">
                  <c:v>2848.3797930000001</c:v>
                </c:pt>
                <c:pt idx="1141">
                  <c:v>2850.3082829999998</c:v>
                </c:pt>
                <c:pt idx="1142">
                  <c:v>2852.2367730000001</c:v>
                </c:pt>
                <c:pt idx="1143">
                  <c:v>2854.1652629999999</c:v>
                </c:pt>
                <c:pt idx="1144">
                  <c:v>2856.0937530000001</c:v>
                </c:pt>
                <c:pt idx="1145">
                  <c:v>2858.0222429999999</c:v>
                </c:pt>
                <c:pt idx="1146">
                  <c:v>2859.9507330000001</c:v>
                </c:pt>
                <c:pt idx="1147">
                  <c:v>2861.8792229999999</c:v>
                </c:pt>
                <c:pt idx="1148">
                  <c:v>2863.8077130000001</c:v>
                </c:pt>
                <c:pt idx="1149">
                  <c:v>2865.7362029999999</c:v>
                </c:pt>
                <c:pt idx="1150">
                  <c:v>2867.6646930000002</c:v>
                </c:pt>
                <c:pt idx="1151">
                  <c:v>2869.5931839999998</c:v>
                </c:pt>
                <c:pt idx="1152">
                  <c:v>2871.5216740000001</c:v>
                </c:pt>
                <c:pt idx="1153">
                  <c:v>2873.4501639999999</c:v>
                </c:pt>
                <c:pt idx="1154">
                  <c:v>2875.3786540000001</c:v>
                </c:pt>
                <c:pt idx="1155">
                  <c:v>2877.3071439999999</c:v>
                </c:pt>
                <c:pt idx="1156">
                  <c:v>2879.2356340000001</c:v>
                </c:pt>
                <c:pt idx="1157">
                  <c:v>2881.1641239999999</c:v>
                </c:pt>
                <c:pt idx="1158">
                  <c:v>2883.0926140000001</c:v>
                </c:pt>
                <c:pt idx="1159">
                  <c:v>2885.0211039999999</c:v>
                </c:pt>
                <c:pt idx="1160">
                  <c:v>2886.9495940000002</c:v>
                </c:pt>
                <c:pt idx="1161">
                  <c:v>2888.8780839999999</c:v>
                </c:pt>
                <c:pt idx="1162">
                  <c:v>2890.8065740000002</c:v>
                </c:pt>
                <c:pt idx="1163">
                  <c:v>2892.735064</c:v>
                </c:pt>
                <c:pt idx="1164">
                  <c:v>2894.6635540000002</c:v>
                </c:pt>
                <c:pt idx="1165">
                  <c:v>2896.592044</c:v>
                </c:pt>
                <c:pt idx="1166">
                  <c:v>2898.5205340000002</c:v>
                </c:pt>
                <c:pt idx="1167">
                  <c:v>2900.449024</c:v>
                </c:pt>
                <c:pt idx="1168">
                  <c:v>2902.3775139999998</c:v>
                </c:pt>
                <c:pt idx="1169">
                  <c:v>2904.306004</c:v>
                </c:pt>
                <c:pt idx="1170">
                  <c:v>2906.2344939999998</c:v>
                </c:pt>
                <c:pt idx="1171">
                  <c:v>2908.1629840000001</c:v>
                </c:pt>
                <c:pt idx="1172">
                  <c:v>2910.0914739999998</c:v>
                </c:pt>
                <c:pt idx="1173">
                  <c:v>2912.0199640000001</c:v>
                </c:pt>
                <c:pt idx="1174">
                  <c:v>2913.9484539999999</c:v>
                </c:pt>
                <c:pt idx="1175">
                  <c:v>2915.876945</c:v>
                </c:pt>
                <c:pt idx="1176">
                  <c:v>2917.8054350000002</c:v>
                </c:pt>
                <c:pt idx="1177">
                  <c:v>2919.733925</c:v>
                </c:pt>
                <c:pt idx="1178">
                  <c:v>2921.6624149999998</c:v>
                </c:pt>
                <c:pt idx="1179">
                  <c:v>2923.590905</c:v>
                </c:pt>
                <c:pt idx="1180">
                  <c:v>2925.5193949999998</c:v>
                </c:pt>
                <c:pt idx="1181">
                  <c:v>2927.447885</c:v>
                </c:pt>
                <c:pt idx="1182">
                  <c:v>2929.3763749999998</c:v>
                </c:pt>
                <c:pt idx="1183">
                  <c:v>2931.3048650000001</c:v>
                </c:pt>
                <c:pt idx="1184">
                  <c:v>2933.2333549999998</c:v>
                </c:pt>
                <c:pt idx="1185">
                  <c:v>2935.1618450000001</c:v>
                </c:pt>
                <c:pt idx="1186">
                  <c:v>2937.0903349999999</c:v>
                </c:pt>
                <c:pt idx="1187">
                  <c:v>2939.0188250000001</c:v>
                </c:pt>
                <c:pt idx="1188">
                  <c:v>2940.9473149999999</c:v>
                </c:pt>
                <c:pt idx="1189">
                  <c:v>2942.8758050000001</c:v>
                </c:pt>
                <c:pt idx="1190">
                  <c:v>2944.8042949999999</c:v>
                </c:pt>
                <c:pt idx="1191">
                  <c:v>2946.7327850000001</c:v>
                </c:pt>
                <c:pt idx="1192">
                  <c:v>2948.6612749999999</c:v>
                </c:pt>
                <c:pt idx="1193">
                  <c:v>2950.5897650000002</c:v>
                </c:pt>
                <c:pt idx="1194">
                  <c:v>2952.518255</c:v>
                </c:pt>
                <c:pt idx="1195">
                  <c:v>2954.4467450000002</c:v>
                </c:pt>
                <c:pt idx="1196">
                  <c:v>2956.375235</c:v>
                </c:pt>
                <c:pt idx="1197">
                  <c:v>2958.3037250000002</c:v>
                </c:pt>
                <c:pt idx="1198">
                  <c:v>2960.2322159999999</c:v>
                </c:pt>
                <c:pt idx="1199">
                  <c:v>2962.1607060000001</c:v>
                </c:pt>
                <c:pt idx="1200">
                  <c:v>2964.0891959999999</c:v>
                </c:pt>
                <c:pt idx="1201">
                  <c:v>2966.0176860000001</c:v>
                </c:pt>
                <c:pt idx="1202">
                  <c:v>2967.9461759999999</c:v>
                </c:pt>
                <c:pt idx="1203">
                  <c:v>2969.8746660000002</c:v>
                </c:pt>
                <c:pt idx="1204">
                  <c:v>2971.8031559999999</c:v>
                </c:pt>
                <c:pt idx="1205">
                  <c:v>2973.7316460000002</c:v>
                </c:pt>
                <c:pt idx="1206">
                  <c:v>2975.660136</c:v>
                </c:pt>
                <c:pt idx="1207">
                  <c:v>2977.5886260000002</c:v>
                </c:pt>
                <c:pt idx="1208">
                  <c:v>2979.517116</c:v>
                </c:pt>
                <c:pt idx="1209">
                  <c:v>2981.4456060000002</c:v>
                </c:pt>
                <c:pt idx="1210">
                  <c:v>2983.374096</c:v>
                </c:pt>
                <c:pt idx="1211">
                  <c:v>2985.3025859999998</c:v>
                </c:pt>
                <c:pt idx="1212">
                  <c:v>2987.231076</c:v>
                </c:pt>
                <c:pt idx="1213">
                  <c:v>2989.1595659999998</c:v>
                </c:pt>
                <c:pt idx="1214">
                  <c:v>2991.0880560000001</c:v>
                </c:pt>
                <c:pt idx="1215">
                  <c:v>2993.0165459999998</c:v>
                </c:pt>
                <c:pt idx="1216">
                  <c:v>2994.9450360000001</c:v>
                </c:pt>
                <c:pt idx="1217">
                  <c:v>2996.8735259999999</c:v>
                </c:pt>
                <c:pt idx="1218">
                  <c:v>2998.8020160000001</c:v>
                </c:pt>
                <c:pt idx="1219">
                  <c:v>3000.7305059999999</c:v>
                </c:pt>
                <c:pt idx="1220">
                  <c:v>3002.6589960000001</c:v>
                </c:pt>
                <c:pt idx="1221">
                  <c:v>3004.5874869999998</c:v>
                </c:pt>
                <c:pt idx="1222">
                  <c:v>3006.515977</c:v>
                </c:pt>
                <c:pt idx="1223">
                  <c:v>3008.4444669999998</c:v>
                </c:pt>
                <c:pt idx="1224">
                  <c:v>3010.372957</c:v>
                </c:pt>
                <c:pt idx="1225">
                  <c:v>3012.3014469999998</c:v>
                </c:pt>
                <c:pt idx="1226">
                  <c:v>3014.2299370000001</c:v>
                </c:pt>
                <c:pt idx="1227">
                  <c:v>3016.1584269999998</c:v>
                </c:pt>
                <c:pt idx="1228">
                  <c:v>3018.0869170000001</c:v>
                </c:pt>
                <c:pt idx="1229">
                  <c:v>3020.0154069999999</c:v>
                </c:pt>
                <c:pt idx="1230">
                  <c:v>3021.9438970000001</c:v>
                </c:pt>
                <c:pt idx="1231">
                  <c:v>3023.8723869999999</c:v>
                </c:pt>
                <c:pt idx="1232">
                  <c:v>3025.8008770000001</c:v>
                </c:pt>
                <c:pt idx="1233">
                  <c:v>3027.7293669999999</c:v>
                </c:pt>
                <c:pt idx="1234">
                  <c:v>3029.6578570000001</c:v>
                </c:pt>
                <c:pt idx="1235">
                  <c:v>3031.5863469999999</c:v>
                </c:pt>
                <c:pt idx="1236">
                  <c:v>3033.5148370000002</c:v>
                </c:pt>
                <c:pt idx="1237">
                  <c:v>3035.443327</c:v>
                </c:pt>
                <c:pt idx="1238">
                  <c:v>3037.3718170000002</c:v>
                </c:pt>
                <c:pt idx="1239">
                  <c:v>3039.300307</c:v>
                </c:pt>
                <c:pt idx="1240">
                  <c:v>3041.2287970000002</c:v>
                </c:pt>
                <c:pt idx="1241">
                  <c:v>3043.157287</c:v>
                </c:pt>
                <c:pt idx="1242">
                  <c:v>3045.0857769999998</c:v>
                </c:pt>
                <c:pt idx="1243">
                  <c:v>3047.014267</c:v>
                </c:pt>
                <c:pt idx="1244">
                  <c:v>3048.9427569999998</c:v>
                </c:pt>
                <c:pt idx="1245">
                  <c:v>3050.8712479999999</c:v>
                </c:pt>
                <c:pt idx="1246">
                  <c:v>3052.7997380000002</c:v>
                </c:pt>
                <c:pt idx="1247">
                  <c:v>3054.728227999999</c:v>
                </c:pt>
                <c:pt idx="1248">
                  <c:v>3056.6567180000002</c:v>
                </c:pt>
                <c:pt idx="1249">
                  <c:v>3058.585208</c:v>
                </c:pt>
                <c:pt idx="1250">
                  <c:v>3060.5136980000002</c:v>
                </c:pt>
                <c:pt idx="1251">
                  <c:v>3062.442188</c:v>
                </c:pt>
                <c:pt idx="1252">
                  <c:v>3064.3706780000002</c:v>
                </c:pt>
                <c:pt idx="1253">
                  <c:v>3066.299168</c:v>
                </c:pt>
                <c:pt idx="1254">
                  <c:v>3068.2276579999998</c:v>
                </c:pt>
                <c:pt idx="1255">
                  <c:v>3070.156148</c:v>
                </c:pt>
                <c:pt idx="1256">
                  <c:v>3072.0846379999998</c:v>
                </c:pt>
                <c:pt idx="1257">
                  <c:v>3074.0131280000001</c:v>
                </c:pt>
                <c:pt idx="1258">
                  <c:v>3075.9416179999998</c:v>
                </c:pt>
                <c:pt idx="1259">
                  <c:v>3077.8701080000001</c:v>
                </c:pt>
                <c:pt idx="1260">
                  <c:v>3079.7985979999999</c:v>
                </c:pt>
                <c:pt idx="1261">
                  <c:v>3081.7270880000001</c:v>
                </c:pt>
                <c:pt idx="1262">
                  <c:v>3083.6555779999999</c:v>
                </c:pt>
                <c:pt idx="1263">
                  <c:v>3085.5840680000001</c:v>
                </c:pt>
                <c:pt idx="1264">
                  <c:v>3087.5125579999999</c:v>
                </c:pt>
                <c:pt idx="1265">
                  <c:v>3089.4410480000001</c:v>
                </c:pt>
                <c:pt idx="1266">
                  <c:v>3091.3695379999999</c:v>
                </c:pt>
                <c:pt idx="1267">
                  <c:v>3093.2980280000002</c:v>
                </c:pt>
                <c:pt idx="1268">
                  <c:v>3095.2265189999998</c:v>
                </c:pt>
                <c:pt idx="1269">
                  <c:v>3097.1550090000001</c:v>
                </c:pt>
                <c:pt idx="1270">
                  <c:v>3099.0834989999998</c:v>
                </c:pt>
                <c:pt idx="1271">
                  <c:v>3101.0119890000001</c:v>
                </c:pt>
                <c:pt idx="1272">
                  <c:v>3102.9404789999999</c:v>
                </c:pt>
                <c:pt idx="1273">
                  <c:v>3104.8689690000001</c:v>
                </c:pt>
                <c:pt idx="1274">
                  <c:v>3106.7974589999999</c:v>
                </c:pt>
                <c:pt idx="1275">
                  <c:v>3108.7259490000001</c:v>
                </c:pt>
                <c:pt idx="1276">
                  <c:v>3110.6544389999999</c:v>
                </c:pt>
                <c:pt idx="1277">
                  <c:v>3112.5829290000001</c:v>
                </c:pt>
                <c:pt idx="1278">
                  <c:v>3114.5114189999999</c:v>
                </c:pt>
                <c:pt idx="1279">
                  <c:v>3116.4399090000002</c:v>
                </c:pt>
                <c:pt idx="1280">
                  <c:v>3118.368399</c:v>
                </c:pt>
                <c:pt idx="1281">
                  <c:v>3120.2968889999952</c:v>
                </c:pt>
                <c:pt idx="1282">
                  <c:v>3122.225379</c:v>
                </c:pt>
                <c:pt idx="1283">
                  <c:v>3124.1538690000002</c:v>
                </c:pt>
                <c:pt idx="1284">
                  <c:v>3126.082359</c:v>
                </c:pt>
                <c:pt idx="1285">
                  <c:v>3128.0108489999998</c:v>
                </c:pt>
                <c:pt idx="1286">
                  <c:v>3129.939339</c:v>
                </c:pt>
                <c:pt idx="1287">
                  <c:v>3131.8678289999998</c:v>
                </c:pt>
                <c:pt idx="1288">
                  <c:v>3133.796319</c:v>
                </c:pt>
                <c:pt idx="1289">
                  <c:v>3135.724808999998</c:v>
                </c:pt>
                <c:pt idx="1290">
                  <c:v>3137.6532990000001</c:v>
                </c:pt>
                <c:pt idx="1291">
                  <c:v>3139.5817889999998</c:v>
                </c:pt>
                <c:pt idx="1292">
                  <c:v>3141.51028</c:v>
                </c:pt>
                <c:pt idx="1293">
                  <c:v>3143.4387700000002</c:v>
                </c:pt>
                <c:pt idx="1294">
                  <c:v>3145.36726</c:v>
                </c:pt>
                <c:pt idx="1295">
                  <c:v>3147.2957500000002</c:v>
                </c:pt>
                <c:pt idx="1296">
                  <c:v>3149.22424</c:v>
                </c:pt>
                <c:pt idx="1297">
                  <c:v>3151.1527299999998</c:v>
                </c:pt>
                <c:pt idx="1298">
                  <c:v>3153.08122</c:v>
                </c:pt>
                <c:pt idx="1299">
                  <c:v>3155.0097099999998</c:v>
                </c:pt>
                <c:pt idx="1300">
                  <c:v>3156.9382000000001</c:v>
                </c:pt>
                <c:pt idx="1301">
                  <c:v>3158.866689999998</c:v>
                </c:pt>
                <c:pt idx="1302">
                  <c:v>3160.7951800000001</c:v>
                </c:pt>
                <c:pt idx="1303">
                  <c:v>3162.723669999998</c:v>
                </c:pt>
                <c:pt idx="1304">
                  <c:v>3164.6521600000001</c:v>
                </c:pt>
                <c:pt idx="1305">
                  <c:v>3166.580649999999</c:v>
                </c:pt>
                <c:pt idx="1306">
                  <c:v>3168.5091400000001</c:v>
                </c:pt>
                <c:pt idx="1307">
                  <c:v>3170.4376299999999</c:v>
                </c:pt>
                <c:pt idx="1308">
                  <c:v>3172.3661200000001</c:v>
                </c:pt>
                <c:pt idx="1309">
                  <c:v>3174.294609999999</c:v>
                </c:pt>
                <c:pt idx="1310">
                  <c:v>3176.2231000000002</c:v>
                </c:pt>
                <c:pt idx="1311">
                  <c:v>3178.1515899999999</c:v>
                </c:pt>
                <c:pt idx="1312">
                  <c:v>3180.0800800000002</c:v>
                </c:pt>
                <c:pt idx="1313">
                  <c:v>3182.00857</c:v>
                </c:pt>
                <c:pt idx="1314">
                  <c:v>3183.9370600000002</c:v>
                </c:pt>
                <c:pt idx="1315">
                  <c:v>3185.8655509999999</c:v>
                </c:pt>
                <c:pt idx="1316">
                  <c:v>3187.7940410000001</c:v>
                </c:pt>
                <c:pt idx="1317">
                  <c:v>3189.7225309999999</c:v>
                </c:pt>
                <c:pt idx="1318">
                  <c:v>3191.6510210000001</c:v>
                </c:pt>
                <c:pt idx="1319">
                  <c:v>3193.5795109999999</c:v>
                </c:pt>
                <c:pt idx="1320">
                  <c:v>3195.5080010000001</c:v>
                </c:pt>
                <c:pt idx="1321">
                  <c:v>3197.4364909999999</c:v>
                </c:pt>
                <c:pt idx="1322">
                  <c:v>3199.3649810000002</c:v>
                </c:pt>
                <c:pt idx="1323">
                  <c:v>3201.293471</c:v>
                </c:pt>
                <c:pt idx="1324">
                  <c:v>3203.2219610000002</c:v>
                </c:pt>
                <c:pt idx="1325">
                  <c:v>3205.150451</c:v>
                </c:pt>
                <c:pt idx="1326">
                  <c:v>3207.0789410000002</c:v>
                </c:pt>
                <c:pt idx="1327">
                  <c:v>3209.007431</c:v>
                </c:pt>
                <c:pt idx="1328">
                  <c:v>3210.9359209999998</c:v>
                </c:pt>
                <c:pt idx="1329">
                  <c:v>3212.864411</c:v>
                </c:pt>
                <c:pt idx="1330">
                  <c:v>3214.7929009999998</c:v>
                </c:pt>
                <c:pt idx="1331">
                  <c:v>3216.721391</c:v>
                </c:pt>
                <c:pt idx="1332">
                  <c:v>3218.649880999998</c:v>
                </c:pt>
                <c:pt idx="1333">
                  <c:v>3220.5783710000001</c:v>
                </c:pt>
                <c:pt idx="1334">
                  <c:v>3222.506860999998</c:v>
                </c:pt>
                <c:pt idx="1335">
                  <c:v>3224.4353510000001</c:v>
                </c:pt>
                <c:pt idx="1336">
                  <c:v>3226.3638409999999</c:v>
                </c:pt>
                <c:pt idx="1337">
                  <c:v>3228.2923310000001</c:v>
                </c:pt>
                <c:pt idx="1338">
                  <c:v>3230.220820999999</c:v>
                </c:pt>
                <c:pt idx="1339">
                  <c:v>3232.149312</c:v>
                </c:pt>
                <c:pt idx="1340">
                  <c:v>3234.0778019999998</c:v>
                </c:pt>
                <c:pt idx="1341">
                  <c:v>3236.006292</c:v>
                </c:pt>
                <c:pt idx="1342">
                  <c:v>3237.9347819999998</c:v>
                </c:pt>
                <c:pt idx="1343">
                  <c:v>3239.8632720000001</c:v>
                </c:pt>
                <c:pt idx="1344">
                  <c:v>3241.7917619999998</c:v>
                </c:pt>
                <c:pt idx="1345">
                  <c:v>3243.7202520000001</c:v>
                </c:pt>
                <c:pt idx="1346">
                  <c:v>3245.648741999998</c:v>
                </c:pt>
                <c:pt idx="1347">
                  <c:v>3247.5772320000001</c:v>
                </c:pt>
                <c:pt idx="1348">
                  <c:v>3249.5057219999999</c:v>
                </c:pt>
                <c:pt idx="1349">
                  <c:v>3251.4342120000001</c:v>
                </c:pt>
                <c:pt idx="1350">
                  <c:v>3253.3627019999999</c:v>
                </c:pt>
                <c:pt idx="1351">
                  <c:v>3255.2911920000001</c:v>
                </c:pt>
                <c:pt idx="1352">
                  <c:v>3257.219681999999</c:v>
                </c:pt>
                <c:pt idx="1353">
                  <c:v>3259.1481720000002</c:v>
                </c:pt>
                <c:pt idx="1354">
                  <c:v>3261.076661999999</c:v>
                </c:pt>
                <c:pt idx="1355">
                  <c:v>3263.0051520000002</c:v>
                </c:pt>
                <c:pt idx="1356">
                  <c:v>3264.933642</c:v>
                </c:pt>
                <c:pt idx="1357">
                  <c:v>3266.8621320000002</c:v>
                </c:pt>
                <c:pt idx="1358">
                  <c:v>3268.790622</c:v>
                </c:pt>
                <c:pt idx="1359">
                  <c:v>3270.7191120000002</c:v>
                </c:pt>
                <c:pt idx="1360">
                  <c:v>3272.647602</c:v>
                </c:pt>
                <c:pt idx="1361">
                  <c:v>3274.5760919999998</c:v>
                </c:pt>
                <c:pt idx="1362">
                  <c:v>3276.5045829999999</c:v>
                </c:pt>
                <c:pt idx="1363">
                  <c:v>3278.4330730000001</c:v>
                </c:pt>
                <c:pt idx="1364">
                  <c:v>3280.3615629999999</c:v>
                </c:pt>
                <c:pt idx="1365">
                  <c:v>3282.2900530000002</c:v>
                </c:pt>
                <c:pt idx="1366">
                  <c:v>3284.218543</c:v>
                </c:pt>
                <c:pt idx="1367">
                  <c:v>3286.1470330000002</c:v>
                </c:pt>
                <c:pt idx="1368">
                  <c:v>3288.075523</c:v>
                </c:pt>
                <c:pt idx="1369">
                  <c:v>3290.0040130000002</c:v>
                </c:pt>
                <c:pt idx="1370">
                  <c:v>3291.932503</c:v>
                </c:pt>
                <c:pt idx="1371">
                  <c:v>3293.8609929999998</c:v>
                </c:pt>
                <c:pt idx="1372">
                  <c:v>3295.789483</c:v>
                </c:pt>
                <c:pt idx="1373">
                  <c:v>3297.7179729999998</c:v>
                </c:pt>
                <c:pt idx="1374">
                  <c:v>3299.646463</c:v>
                </c:pt>
                <c:pt idx="1375">
                  <c:v>3301.5749529999998</c:v>
                </c:pt>
                <c:pt idx="1376">
                  <c:v>3303.5034430000001</c:v>
                </c:pt>
                <c:pt idx="1377">
                  <c:v>3305.4319329999998</c:v>
                </c:pt>
                <c:pt idx="1378">
                  <c:v>3307.3604230000001</c:v>
                </c:pt>
                <c:pt idx="1379">
                  <c:v>3309.2889129999999</c:v>
                </c:pt>
                <c:pt idx="1380">
                  <c:v>3311.2174030000001</c:v>
                </c:pt>
                <c:pt idx="1381">
                  <c:v>3313.1458929999999</c:v>
                </c:pt>
                <c:pt idx="1382">
                  <c:v>3315.0743830000001</c:v>
                </c:pt>
                <c:pt idx="1383">
                  <c:v>3317.0028729999999</c:v>
                </c:pt>
                <c:pt idx="1384">
                  <c:v>3318.9313630000001</c:v>
                </c:pt>
                <c:pt idx="1385">
                  <c:v>3320.8598539999998</c:v>
                </c:pt>
                <c:pt idx="1386">
                  <c:v>3322.7883440000001</c:v>
                </c:pt>
                <c:pt idx="1387">
                  <c:v>3324.7168339999998</c:v>
                </c:pt>
                <c:pt idx="1388">
                  <c:v>3326.6453240000001</c:v>
                </c:pt>
                <c:pt idx="1389">
                  <c:v>3328.5738139999999</c:v>
                </c:pt>
                <c:pt idx="1390">
                  <c:v>3330.5023040000001</c:v>
                </c:pt>
                <c:pt idx="1391">
                  <c:v>3332.4307939999999</c:v>
                </c:pt>
                <c:pt idx="1392">
                  <c:v>3334.3592840000001</c:v>
                </c:pt>
                <c:pt idx="1393">
                  <c:v>3336.2877739999999</c:v>
                </c:pt>
                <c:pt idx="1394">
                  <c:v>3338.2162640000001</c:v>
                </c:pt>
                <c:pt idx="1395">
                  <c:v>3340.1447539999999</c:v>
                </c:pt>
                <c:pt idx="1396">
                  <c:v>3342.0732440000002</c:v>
                </c:pt>
                <c:pt idx="1397">
                  <c:v>3344.0017339999999</c:v>
                </c:pt>
                <c:pt idx="1398">
                  <c:v>3345.9302240000002</c:v>
                </c:pt>
                <c:pt idx="1399">
                  <c:v>3347.858714</c:v>
                </c:pt>
                <c:pt idx="1400">
                  <c:v>3349.7872040000002</c:v>
                </c:pt>
                <c:pt idx="1401">
                  <c:v>3351.715694</c:v>
                </c:pt>
                <c:pt idx="1402">
                  <c:v>3353.6441840000002</c:v>
                </c:pt>
                <c:pt idx="1403">
                  <c:v>3355.572674</c:v>
                </c:pt>
                <c:pt idx="1404">
                  <c:v>3357.5011639999998</c:v>
                </c:pt>
                <c:pt idx="1405">
                  <c:v>3359.429654</c:v>
                </c:pt>
                <c:pt idx="1406">
                  <c:v>3361.3581439999998</c:v>
                </c:pt>
                <c:pt idx="1407">
                  <c:v>3363.286634</c:v>
                </c:pt>
                <c:pt idx="1408">
                  <c:v>3365.2151239999998</c:v>
                </c:pt>
                <c:pt idx="1409">
                  <c:v>3367.143615</c:v>
                </c:pt>
                <c:pt idx="1410">
                  <c:v>3369.0721050000002</c:v>
                </c:pt>
                <c:pt idx="1411">
                  <c:v>3371.000595</c:v>
                </c:pt>
                <c:pt idx="1412">
                  <c:v>3372.9290850000002</c:v>
                </c:pt>
                <c:pt idx="1413">
                  <c:v>3374.857575</c:v>
                </c:pt>
                <c:pt idx="1414">
                  <c:v>3376.786064999998</c:v>
                </c:pt>
                <c:pt idx="1415">
                  <c:v>3378.714555</c:v>
                </c:pt>
                <c:pt idx="1416">
                  <c:v>3380.6430449999998</c:v>
                </c:pt>
                <c:pt idx="1417">
                  <c:v>3382.571535</c:v>
                </c:pt>
                <c:pt idx="1418">
                  <c:v>3384.5000249999998</c:v>
                </c:pt>
                <c:pt idx="1419">
                  <c:v>3386.4285150000001</c:v>
                </c:pt>
                <c:pt idx="1420">
                  <c:v>3388.3570049999998</c:v>
                </c:pt>
                <c:pt idx="1421">
                  <c:v>3390.2854950000001</c:v>
                </c:pt>
                <c:pt idx="1422">
                  <c:v>3392.2139849999999</c:v>
                </c:pt>
                <c:pt idx="1423">
                  <c:v>3394.1424750000001</c:v>
                </c:pt>
                <c:pt idx="1424">
                  <c:v>3396.0709649999999</c:v>
                </c:pt>
                <c:pt idx="1425">
                  <c:v>3397.9994550000001</c:v>
                </c:pt>
                <c:pt idx="1426">
                  <c:v>3399.9279449999999</c:v>
                </c:pt>
                <c:pt idx="1427">
                  <c:v>3401.8564350000001</c:v>
                </c:pt>
                <c:pt idx="1428">
                  <c:v>3403.784924999999</c:v>
                </c:pt>
                <c:pt idx="1429">
                  <c:v>3405.7134150000002</c:v>
                </c:pt>
                <c:pt idx="1430">
                  <c:v>3407.641905</c:v>
                </c:pt>
                <c:pt idx="1431">
                  <c:v>3409.5703950000002</c:v>
                </c:pt>
                <c:pt idx="1432">
                  <c:v>3411.498885999998</c:v>
                </c:pt>
                <c:pt idx="1433">
                  <c:v>3413.4273760000001</c:v>
                </c:pt>
                <c:pt idx="1434">
                  <c:v>3415.3558659999999</c:v>
                </c:pt>
                <c:pt idx="1435">
                  <c:v>3417.2843560000001</c:v>
                </c:pt>
                <c:pt idx="1436">
                  <c:v>3419.212845999999</c:v>
                </c:pt>
                <c:pt idx="1437">
                  <c:v>3421.1413360000001</c:v>
                </c:pt>
                <c:pt idx="1438">
                  <c:v>3423.069825999999</c:v>
                </c:pt>
                <c:pt idx="1439">
                  <c:v>3424.9983160000002</c:v>
                </c:pt>
                <c:pt idx="1440">
                  <c:v>3426.926805999999</c:v>
                </c:pt>
                <c:pt idx="1441">
                  <c:v>3428.8552960000002</c:v>
                </c:pt>
                <c:pt idx="1442">
                  <c:v>3430.783786</c:v>
                </c:pt>
                <c:pt idx="1443">
                  <c:v>3432.7122760000002</c:v>
                </c:pt>
                <c:pt idx="1444">
                  <c:v>3434.640766</c:v>
                </c:pt>
                <c:pt idx="1445">
                  <c:v>3436.5692560000002</c:v>
                </c:pt>
                <c:pt idx="1446">
                  <c:v>3438.497746</c:v>
                </c:pt>
                <c:pt idx="1447">
                  <c:v>3440.4262359999998</c:v>
                </c:pt>
                <c:pt idx="1448">
                  <c:v>3442.354726</c:v>
                </c:pt>
                <c:pt idx="1449">
                  <c:v>3444.2832159999998</c:v>
                </c:pt>
                <c:pt idx="1450">
                  <c:v>3446.211706</c:v>
                </c:pt>
                <c:pt idx="1451">
                  <c:v>3448.1401959999998</c:v>
                </c:pt>
                <c:pt idx="1452">
                  <c:v>3450.0686860000001</c:v>
                </c:pt>
                <c:pt idx="1453">
                  <c:v>3451.9971759999999</c:v>
                </c:pt>
                <c:pt idx="1454">
                  <c:v>3453.9256660000001</c:v>
                </c:pt>
                <c:pt idx="1455">
                  <c:v>3455.8541559999999</c:v>
                </c:pt>
                <c:pt idx="1456">
                  <c:v>3457.782647</c:v>
                </c:pt>
                <c:pt idx="1457">
                  <c:v>3459.7111369999998</c:v>
                </c:pt>
                <c:pt idx="1458">
                  <c:v>3461.639627</c:v>
                </c:pt>
                <c:pt idx="1459">
                  <c:v>3463.5681169999998</c:v>
                </c:pt>
                <c:pt idx="1460">
                  <c:v>3465.496607</c:v>
                </c:pt>
                <c:pt idx="1461">
                  <c:v>3467.4250969999998</c:v>
                </c:pt>
                <c:pt idx="1462">
                  <c:v>3469.3535870000001</c:v>
                </c:pt>
                <c:pt idx="1463">
                  <c:v>3471.2820769999998</c:v>
                </c:pt>
                <c:pt idx="1464">
                  <c:v>3473.2105670000001</c:v>
                </c:pt>
                <c:pt idx="1465">
                  <c:v>3475.1390569999999</c:v>
                </c:pt>
                <c:pt idx="1466">
                  <c:v>3477.0675470000001</c:v>
                </c:pt>
                <c:pt idx="1467">
                  <c:v>3478.9960369999999</c:v>
                </c:pt>
                <c:pt idx="1468">
                  <c:v>3480.9245270000001</c:v>
                </c:pt>
                <c:pt idx="1469">
                  <c:v>3482.8530169999999</c:v>
                </c:pt>
                <c:pt idx="1470">
                  <c:v>3484.7815070000001</c:v>
                </c:pt>
                <c:pt idx="1471">
                  <c:v>3486.7099969999999</c:v>
                </c:pt>
                <c:pt idx="1472">
                  <c:v>3488.6384870000002</c:v>
                </c:pt>
                <c:pt idx="1473">
                  <c:v>3490.566977</c:v>
                </c:pt>
                <c:pt idx="1474">
                  <c:v>3492.4954670000002</c:v>
                </c:pt>
                <c:pt idx="1475">
                  <c:v>3494.423957</c:v>
                </c:pt>
                <c:pt idx="1476">
                  <c:v>3496.3524470000002</c:v>
                </c:pt>
                <c:pt idx="1477">
                  <c:v>3498.280937</c:v>
                </c:pt>
                <c:pt idx="1478">
                  <c:v>3500.2094269999998</c:v>
                </c:pt>
                <c:pt idx="1479">
                  <c:v>3502.1379179999999</c:v>
                </c:pt>
                <c:pt idx="1480">
                  <c:v>3504.0664080000001</c:v>
                </c:pt>
                <c:pt idx="1481">
                  <c:v>3505.9948979999999</c:v>
                </c:pt>
                <c:pt idx="1482">
                  <c:v>3507.9233880000002</c:v>
                </c:pt>
                <c:pt idx="1483">
                  <c:v>3509.8518779999999</c:v>
                </c:pt>
                <c:pt idx="1484">
                  <c:v>3511.7803680000002</c:v>
                </c:pt>
                <c:pt idx="1485">
                  <c:v>3513.708858</c:v>
                </c:pt>
                <c:pt idx="1486">
                  <c:v>3515.6373480000002</c:v>
                </c:pt>
                <c:pt idx="1487">
                  <c:v>3517.565838</c:v>
                </c:pt>
                <c:pt idx="1488">
                  <c:v>3519.4943280000002</c:v>
                </c:pt>
                <c:pt idx="1489">
                  <c:v>3521.422818</c:v>
                </c:pt>
                <c:pt idx="1490">
                  <c:v>3523.3513079999998</c:v>
                </c:pt>
                <c:pt idx="1491">
                  <c:v>3525.279798</c:v>
                </c:pt>
                <c:pt idx="1492">
                  <c:v>3527.208287999998</c:v>
                </c:pt>
                <c:pt idx="1493">
                  <c:v>3529.136778</c:v>
                </c:pt>
                <c:pt idx="1494">
                  <c:v>3531.0652679999998</c:v>
                </c:pt>
                <c:pt idx="1495">
                  <c:v>3532.9937580000001</c:v>
                </c:pt>
                <c:pt idx="1496">
                  <c:v>3534.9222479999999</c:v>
                </c:pt>
                <c:pt idx="1497">
                  <c:v>3536.8507380000001</c:v>
                </c:pt>
                <c:pt idx="1498">
                  <c:v>3538.7792279999999</c:v>
                </c:pt>
                <c:pt idx="1499">
                  <c:v>3540.7077180000001</c:v>
                </c:pt>
                <c:pt idx="1500">
                  <c:v>3542.6362079999999</c:v>
                </c:pt>
                <c:pt idx="1501">
                  <c:v>3544.5646980000001</c:v>
                </c:pt>
                <c:pt idx="1502">
                  <c:v>3546.4931889999998</c:v>
                </c:pt>
                <c:pt idx="1503">
                  <c:v>3548.421679</c:v>
                </c:pt>
                <c:pt idx="1504">
                  <c:v>3550.3501689999998</c:v>
                </c:pt>
                <c:pt idx="1505">
                  <c:v>3552.2786590000001</c:v>
                </c:pt>
                <c:pt idx="1506">
                  <c:v>3554.2071489999998</c:v>
                </c:pt>
                <c:pt idx="1507">
                  <c:v>3556.1356390000001</c:v>
                </c:pt>
                <c:pt idx="1508">
                  <c:v>3558.0641289999999</c:v>
                </c:pt>
                <c:pt idx="1509">
                  <c:v>3559.9926190000001</c:v>
                </c:pt>
                <c:pt idx="1510">
                  <c:v>3561.9211089999999</c:v>
                </c:pt>
                <c:pt idx="1511">
                  <c:v>3563.8495990000001</c:v>
                </c:pt>
                <c:pt idx="1512">
                  <c:v>3565.778088999999</c:v>
                </c:pt>
                <c:pt idx="1513">
                  <c:v>3567.7065790000001</c:v>
                </c:pt>
                <c:pt idx="1514">
                  <c:v>3569.6350689999999</c:v>
                </c:pt>
                <c:pt idx="1515">
                  <c:v>3571.5635590000002</c:v>
                </c:pt>
                <c:pt idx="1516">
                  <c:v>3573.492049</c:v>
                </c:pt>
                <c:pt idx="1517">
                  <c:v>3575.4205390000002</c:v>
                </c:pt>
                <c:pt idx="1518">
                  <c:v>3577.349029</c:v>
                </c:pt>
                <c:pt idx="1519">
                  <c:v>3579.2775190000002</c:v>
                </c:pt>
                <c:pt idx="1520">
                  <c:v>3581.206009</c:v>
                </c:pt>
                <c:pt idx="1521">
                  <c:v>3583.1344989999998</c:v>
                </c:pt>
                <c:pt idx="1522">
                  <c:v>3585.062989</c:v>
                </c:pt>
                <c:pt idx="1523">
                  <c:v>3586.9914789999998</c:v>
                </c:pt>
                <c:pt idx="1524">
                  <c:v>3588.919969</c:v>
                </c:pt>
                <c:pt idx="1525">
                  <c:v>3590.8484589999998</c:v>
                </c:pt>
                <c:pt idx="1526">
                  <c:v>3592.776949999999</c:v>
                </c:pt>
                <c:pt idx="1527">
                  <c:v>3594.7054400000002</c:v>
                </c:pt>
                <c:pt idx="1528">
                  <c:v>3596.63393</c:v>
                </c:pt>
                <c:pt idx="1529">
                  <c:v>3598.5624200000002</c:v>
                </c:pt>
                <c:pt idx="1530">
                  <c:v>3600.49091</c:v>
                </c:pt>
                <c:pt idx="1531">
                  <c:v>3602.4194000000002</c:v>
                </c:pt>
                <c:pt idx="1532">
                  <c:v>3604.34789</c:v>
                </c:pt>
                <c:pt idx="1533">
                  <c:v>3606.2763799999998</c:v>
                </c:pt>
                <c:pt idx="1534">
                  <c:v>3608.20487</c:v>
                </c:pt>
                <c:pt idx="1535">
                  <c:v>3610.1333599999998</c:v>
                </c:pt>
                <c:pt idx="1536">
                  <c:v>3612.06185</c:v>
                </c:pt>
                <c:pt idx="1537">
                  <c:v>3613.9903399999998</c:v>
                </c:pt>
                <c:pt idx="1538">
                  <c:v>3615.9188300000001</c:v>
                </c:pt>
                <c:pt idx="1539">
                  <c:v>3617.8473199999999</c:v>
                </c:pt>
                <c:pt idx="1540">
                  <c:v>3619.7758100000001</c:v>
                </c:pt>
                <c:pt idx="1541">
                  <c:v>3621.704299999999</c:v>
                </c:pt>
                <c:pt idx="1542">
                  <c:v>3623.6327900000001</c:v>
                </c:pt>
                <c:pt idx="1543">
                  <c:v>3625.5612799999999</c:v>
                </c:pt>
                <c:pt idx="1544">
                  <c:v>3627.4897700000001</c:v>
                </c:pt>
                <c:pt idx="1545">
                  <c:v>3629.4182599999999</c:v>
                </c:pt>
                <c:pt idx="1546">
                  <c:v>3631.3467500000002</c:v>
                </c:pt>
                <c:pt idx="1547">
                  <c:v>3633.2752399999999</c:v>
                </c:pt>
                <c:pt idx="1548">
                  <c:v>3635.2037300000002</c:v>
                </c:pt>
                <c:pt idx="1549">
                  <c:v>3637.1322209999998</c:v>
                </c:pt>
                <c:pt idx="1550">
                  <c:v>3639.0607110000001</c:v>
                </c:pt>
                <c:pt idx="1551">
                  <c:v>3640.9892009999999</c:v>
                </c:pt>
                <c:pt idx="1552">
                  <c:v>3642.9176910000001</c:v>
                </c:pt>
                <c:pt idx="1553">
                  <c:v>3644.8461809999999</c:v>
                </c:pt>
                <c:pt idx="1554">
                  <c:v>3646.7746710000001</c:v>
                </c:pt>
                <c:pt idx="1555">
                  <c:v>3648.7031609999999</c:v>
                </c:pt>
                <c:pt idx="1556">
                  <c:v>3650.6316510000001</c:v>
                </c:pt>
                <c:pt idx="1557">
                  <c:v>3652.5601409999999</c:v>
                </c:pt>
                <c:pt idx="1558">
                  <c:v>3654.4886310000002</c:v>
                </c:pt>
                <c:pt idx="1559">
                  <c:v>3656.417121</c:v>
                </c:pt>
                <c:pt idx="1560">
                  <c:v>3658.3456110000002</c:v>
                </c:pt>
                <c:pt idx="1561">
                  <c:v>3660.274101</c:v>
                </c:pt>
                <c:pt idx="1562">
                  <c:v>3662.2025910000002</c:v>
                </c:pt>
                <c:pt idx="1563">
                  <c:v>3664.131081</c:v>
                </c:pt>
                <c:pt idx="1564">
                  <c:v>3666.0595709999998</c:v>
                </c:pt>
                <c:pt idx="1565">
                  <c:v>3667.988061</c:v>
                </c:pt>
                <c:pt idx="1566">
                  <c:v>3669.9165509999998</c:v>
                </c:pt>
                <c:pt idx="1567">
                  <c:v>3671.845041</c:v>
                </c:pt>
                <c:pt idx="1568">
                  <c:v>3673.7735309999998</c:v>
                </c:pt>
                <c:pt idx="1569">
                  <c:v>3675.7020210000001</c:v>
                </c:pt>
                <c:pt idx="1570">
                  <c:v>3677.6305109999998</c:v>
                </c:pt>
                <c:pt idx="1571">
                  <c:v>3679.5590010000001</c:v>
                </c:pt>
                <c:pt idx="1572">
                  <c:v>3681.4874909999999</c:v>
                </c:pt>
                <c:pt idx="1573">
                  <c:v>3683.415982</c:v>
                </c:pt>
                <c:pt idx="1574">
                  <c:v>3685.3444720000002</c:v>
                </c:pt>
                <c:pt idx="1575">
                  <c:v>3687.272962</c:v>
                </c:pt>
                <c:pt idx="1576">
                  <c:v>3689.2014519999998</c:v>
                </c:pt>
                <c:pt idx="1577">
                  <c:v>3691.129942</c:v>
                </c:pt>
                <c:pt idx="1578">
                  <c:v>3693.0584319999998</c:v>
                </c:pt>
                <c:pt idx="1579">
                  <c:v>3694.986922</c:v>
                </c:pt>
                <c:pt idx="1580">
                  <c:v>3696.9154119999998</c:v>
                </c:pt>
                <c:pt idx="1581">
                  <c:v>3698.8439020000001</c:v>
                </c:pt>
                <c:pt idx="1582">
                  <c:v>3700.7723919999999</c:v>
                </c:pt>
                <c:pt idx="1583">
                  <c:v>3702.7008820000001</c:v>
                </c:pt>
                <c:pt idx="1584">
                  <c:v>3704.6293719999999</c:v>
                </c:pt>
                <c:pt idx="1585">
                  <c:v>3706.5578620000001</c:v>
                </c:pt>
                <c:pt idx="1586">
                  <c:v>3708.4863519999999</c:v>
                </c:pt>
                <c:pt idx="1587">
                  <c:v>3710.4148420000001</c:v>
                </c:pt>
                <c:pt idx="1588">
                  <c:v>3712.3433319999999</c:v>
                </c:pt>
                <c:pt idx="1589">
                  <c:v>3714.2718220000002</c:v>
                </c:pt>
                <c:pt idx="1590">
                  <c:v>3716.2003119999999</c:v>
                </c:pt>
                <c:pt idx="1591">
                  <c:v>3718.1288020000002</c:v>
                </c:pt>
                <c:pt idx="1592">
                  <c:v>3720.057292</c:v>
                </c:pt>
                <c:pt idx="1593">
                  <c:v>3721.9857820000002</c:v>
                </c:pt>
                <c:pt idx="1594">
                  <c:v>3723.914272</c:v>
                </c:pt>
                <c:pt idx="1595">
                  <c:v>3725.8427620000002</c:v>
                </c:pt>
                <c:pt idx="1596">
                  <c:v>3727.7712529999999</c:v>
                </c:pt>
                <c:pt idx="1597">
                  <c:v>3729.6997430000001</c:v>
                </c:pt>
                <c:pt idx="1598">
                  <c:v>3731.6282329999999</c:v>
                </c:pt>
                <c:pt idx="1599">
                  <c:v>3733.5567230000001</c:v>
                </c:pt>
                <c:pt idx="1600">
                  <c:v>3735.4852129999999</c:v>
                </c:pt>
                <c:pt idx="1601">
                  <c:v>3737.4137030000002</c:v>
                </c:pt>
                <c:pt idx="1602">
                  <c:v>3739.342193</c:v>
                </c:pt>
                <c:pt idx="1603">
                  <c:v>3741.2706830000002</c:v>
                </c:pt>
                <c:pt idx="1604">
                  <c:v>3743.199173</c:v>
                </c:pt>
                <c:pt idx="1605">
                  <c:v>3745.1276630000002</c:v>
                </c:pt>
                <c:pt idx="1606">
                  <c:v>3747.056153</c:v>
                </c:pt>
                <c:pt idx="1607">
                  <c:v>3748.9846429999998</c:v>
                </c:pt>
                <c:pt idx="1608">
                  <c:v>3750.913133</c:v>
                </c:pt>
                <c:pt idx="1609">
                  <c:v>3752.8416229999998</c:v>
                </c:pt>
                <c:pt idx="1610">
                  <c:v>3754.770113</c:v>
                </c:pt>
                <c:pt idx="1611">
                  <c:v>3756.6986029999998</c:v>
                </c:pt>
                <c:pt idx="1612">
                  <c:v>3758.6270930000001</c:v>
                </c:pt>
                <c:pt idx="1613">
                  <c:v>3760.5555829999998</c:v>
                </c:pt>
                <c:pt idx="1614">
                  <c:v>3762.4840730000001</c:v>
                </c:pt>
                <c:pt idx="1615">
                  <c:v>3764.4125629999999</c:v>
                </c:pt>
                <c:pt idx="1616">
                  <c:v>3766.3410530000001</c:v>
                </c:pt>
                <c:pt idx="1617">
                  <c:v>3768.2695429999999</c:v>
                </c:pt>
                <c:pt idx="1618">
                  <c:v>3770.1980330000001</c:v>
                </c:pt>
                <c:pt idx="1619">
                  <c:v>3772.1265229999999</c:v>
                </c:pt>
                <c:pt idx="1620">
                  <c:v>3774.055014</c:v>
                </c:pt>
                <c:pt idx="1621">
                  <c:v>3775.9835039999998</c:v>
                </c:pt>
                <c:pt idx="1622">
                  <c:v>3777.911994</c:v>
                </c:pt>
                <c:pt idx="1623">
                  <c:v>3779.8404839999998</c:v>
                </c:pt>
                <c:pt idx="1624">
                  <c:v>3781.7689740000001</c:v>
                </c:pt>
                <c:pt idx="1625">
                  <c:v>3783.6974639999999</c:v>
                </c:pt>
                <c:pt idx="1626">
                  <c:v>3785.6259540000001</c:v>
                </c:pt>
                <c:pt idx="1627">
                  <c:v>3787.5544439999999</c:v>
                </c:pt>
                <c:pt idx="1628">
                  <c:v>3789.4829340000001</c:v>
                </c:pt>
                <c:pt idx="1629">
                  <c:v>3791.4114239999999</c:v>
                </c:pt>
                <c:pt idx="1630">
                  <c:v>3793.3399140000001</c:v>
                </c:pt>
                <c:pt idx="1631">
                  <c:v>3795.268403999999</c:v>
                </c:pt>
                <c:pt idx="1632">
                  <c:v>3797.1968940000002</c:v>
                </c:pt>
                <c:pt idx="1633">
                  <c:v>3799.1253839999999</c:v>
                </c:pt>
                <c:pt idx="1634">
                  <c:v>3801.0538740000002</c:v>
                </c:pt>
                <c:pt idx="1635">
                  <c:v>3802.982364</c:v>
                </c:pt>
                <c:pt idx="1636">
                  <c:v>3804.9108540000002</c:v>
                </c:pt>
                <c:pt idx="1637">
                  <c:v>3806.839344</c:v>
                </c:pt>
                <c:pt idx="1638">
                  <c:v>3808.7678340000002</c:v>
                </c:pt>
                <c:pt idx="1639">
                  <c:v>3810.696324</c:v>
                </c:pt>
                <c:pt idx="1640">
                  <c:v>3812.6248139999998</c:v>
                </c:pt>
                <c:pt idx="1641">
                  <c:v>3814.553304</c:v>
                </c:pt>
                <c:pt idx="1642">
                  <c:v>3816.4817939999998</c:v>
                </c:pt>
                <c:pt idx="1643">
                  <c:v>3818.4102849999999</c:v>
                </c:pt>
                <c:pt idx="1644">
                  <c:v>3820.3387750000002</c:v>
                </c:pt>
                <c:pt idx="1645">
                  <c:v>3822.267264999999</c:v>
                </c:pt>
                <c:pt idx="1646">
                  <c:v>3824.1957550000002</c:v>
                </c:pt>
                <c:pt idx="1647">
                  <c:v>3826.124245</c:v>
                </c:pt>
                <c:pt idx="1648">
                  <c:v>3828.0527350000002</c:v>
                </c:pt>
                <c:pt idx="1649">
                  <c:v>3829.981225</c:v>
                </c:pt>
                <c:pt idx="1650">
                  <c:v>3831.9097149999998</c:v>
                </c:pt>
                <c:pt idx="1651">
                  <c:v>3833.838205</c:v>
                </c:pt>
                <c:pt idx="1652">
                  <c:v>3835.766694999998</c:v>
                </c:pt>
                <c:pt idx="1653">
                  <c:v>3837.695185</c:v>
                </c:pt>
                <c:pt idx="1654">
                  <c:v>3839.6236749999998</c:v>
                </c:pt>
                <c:pt idx="1655">
                  <c:v>3841.5521650000001</c:v>
                </c:pt>
                <c:pt idx="1656">
                  <c:v>3843.4806549999998</c:v>
                </c:pt>
                <c:pt idx="1657">
                  <c:v>3845.4091450000001</c:v>
                </c:pt>
                <c:pt idx="1658">
                  <c:v>3847.3376349999999</c:v>
                </c:pt>
                <c:pt idx="1659">
                  <c:v>3849.2661250000001</c:v>
                </c:pt>
                <c:pt idx="1660">
                  <c:v>3851.1946149999999</c:v>
                </c:pt>
                <c:pt idx="1661">
                  <c:v>3853.1231050000001</c:v>
                </c:pt>
                <c:pt idx="1662">
                  <c:v>3855.0515949999999</c:v>
                </c:pt>
                <c:pt idx="1663">
                  <c:v>3856.9800850000001</c:v>
                </c:pt>
                <c:pt idx="1664">
                  <c:v>3858.9085749999999</c:v>
                </c:pt>
                <c:pt idx="1665">
                  <c:v>3860.8370650000002</c:v>
                </c:pt>
                <c:pt idx="1666">
                  <c:v>3862.7655559999998</c:v>
                </c:pt>
                <c:pt idx="1667">
                  <c:v>3864.6940460000001</c:v>
                </c:pt>
                <c:pt idx="1668">
                  <c:v>3866.6225359999999</c:v>
                </c:pt>
                <c:pt idx="1669">
                  <c:v>3868.5510260000001</c:v>
                </c:pt>
                <c:pt idx="1670">
                  <c:v>3870.4795159999999</c:v>
                </c:pt>
                <c:pt idx="1671">
                  <c:v>3872.4080060000001</c:v>
                </c:pt>
                <c:pt idx="1672">
                  <c:v>3874.3364959999999</c:v>
                </c:pt>
                <c:pt idx="1673">
                  <c:v>3876.2649860000001</c:v>
                </c:pt>
                <c:pt idx="1674">
                  <c:v>3878.1934759999999</c:v>
                </c:pt>
                <c:pt idx="1675">
                  <c:v>3880.1219660000002</c:v>
                </c:pt>
                <c:pt idx="1676">
                  <c:v>3882.0504559999999</c:v>
                </c:pt>
                <c:pt idx="1677">
                  <c:v>3883.9789460000002</c:v>
                </c:pt>
                <c:pt idx="1678">
                  <c:v>3885.907436</c:v>
                </c:pt>
                <c:pt idx="1679">
                  <c:v>3887.8359260000002</c:v>
                </c:pt>
                <c:pt idx="1680">
                  <c:v>3889.764416</c:v>
                </c:pt>
                <c:pt idx="1681">
                  <c:v>3891.6929060000002</c:v>
                </c:pt>
                <c:pt idx="1682">
                  <c:v>3893.621396</c:v>
                </c:pt>
                <c:pt idx="1683">
                  <c:v>3895.549885999998</c:v>
                </c:pt>
                <c:pt idx="1684">
                  <c:v>3897.478376</c:v>
                </c:pt>
                <c:pt idx="1685">
                  <c:v>3899.406865999998</c:v>
                </c:pt>
                <c:pt idx="1686">
                  <c:v>3901.335356</c:v>
                </c:pt>
                <c:pt idx="1687">
                  <c:v>3903.263845999998</c:v>
                </c:pt>
                <c:pt idx="1688">
                  <c:v>3905.1923360000001</c:v>
                </c:pt>
                <c:pt idx="1689">
                  <c:v>3907.120825999998</c:v>
                </c:pt>
                <c:pt idx="1690">
                  <c:v>3909.049317</c:v>
                </c:pt>
                <c:pt idx="1691">
                  <c:v>3910.9778070000002</c:v>
                </c:pt>
                <c:pt idx="1692">
                  <c:v>3912.906297</c:v>
                </c:pt>
                <c:pt idx="1693">
                  <c:v>3914.8347869999998</c:v>
                </c:pt>
                <c:pt idx="1694">
                  <c:v>3916.763277</c:v>
                </c:pt>
                <c:pt idx="1695">
                  <c:v>3918.6917669999998</c:v>
                </c:pt>
                <c:pt idx="1696">
                  <c:v>3920.620257</c:v>
                </c:pt>
                <c:pt idx="1697">
                  <c:v>3922.5487469999998</c:v>
                </c:pt>
                <c:pt idx="1698">
                  <c:v>3924.4772370000001</c:v>
                </c:pt>
                <c:pt idx="1699">
                  <c:v>3926.4057269999998</c:v>
                </c:pt>
                <c:pt idx="1700">
                  <c:v>3928.3342170000001</c:v>
                </c:pt>
                <c:pt idx="1701">
                  <c:v>3930.2627069999999</c:v>
                </c:pt>
                <c:pt idx="1702">
                  <c:v>3932.1911970000001</c:v>
                </c:pt>
                <c:pt idx="1703">
                  <c:v>3934.1196869999999</c:v>
                </c:pt>
                <c:pt idx="1704">
                  <c:v>3936.0481770000001</c:v>
                </c:pt>
                <c:pt idx="1705">
                  <c:v>3937.9766669999999</c:v>
                </c:pt>
                <c:pt idx="1706">
                  <c:v>3939.9051570000001</c:v>
                </c:pt>
                <c:pt idx="1707">
                  <c:v>3941.8336469999999</c:v>
                </c:pt>
                <c:pt idx="1708">
                  <c:v>3943.7621370000002</c:v>
                </c:pt>
                <c:pt idx="1709">
                  <c:v>3945.6906269999999</c:v>
                </c:pt>
                <c:pt idx="1710">
                  <c:v>3947.6191170000002</c:v>
                </c:pt>
                <c:pt idx="1711">
                  <c:v>3949.547607</c:v>
                </c:pt>
                <c:pt idx="1712">
                  <c:v>3951.4760970000002</c:v>
                </c:pt>
                <c:pt idx="1713">
                  <c:v>3953.4045879999999</c:v>
                </c:pt>
                <c:pt idx="1714">
                  <c:v>3955.3330780000001</c:v>
                </c:pt>
                <c:pt idx="1715">
                  <c:v>3957.2615679999999</c:v>
                </c:pt>
                <c:pt idx="1716">
                  <c:v>3959.1900580000001</c:v>
                </c:pt>
                <c:pt idx="1717">
                  <c:v>3961.1185479999999</c:v>
                </c:pt>
                <c:pt idx="1718">
                  <c:v>3963.0470380000002</c:v>
                </c:pt>
                <c:pt idx="1719">
                  <c:v>3964.9755279999999</c:v>
                </c:pt>
                <c:pt idx="1720">
                  <c:v>3966.9040180000002</c:v>
                </c:pt>
                <c:pt idx="1721">
                  <c:v>3968.832508</c:v>
                </c:pt>
                <c:pt idx="1722">
                  <c:v>3970.7609980000002</c:v>
                </c:pt>
                <c:pt idx="1723">
                  <c:v>3972.689488</c:v>
                </c:pt>
                <c:pt idx="1724">
                  <c:v>3974.6179780000002</c:v>
                </c:pt>
                <c:pt idx="1725">
                  <c:v>3976.546468</c:v>
                </c:pt>
                <c:pt idx="1726">
                  <c:v>3978.4749579999998</c:v>
                </c:pt>
                <c:pt idx="1727">
                  <c:v>3980.403448</c:v>
                </c:pt>
                <c:pt idx="1728">
                  <c:v>3982.3319379999998</c:v>
                </c:pt>
                <c:pt idx="1729">
                  <c:v>3984.260428</c:v>
                </c:pt>
                <c:pt idx="1730">
                  <c:v>3986.1889179999998</c:v>
                </c:pt>
                <c:pt idx="1731">
                  <c:v>3988.1174080000001</c:v>
                </c:pt>
                <c:pt idx="1732">
                  <c:v>3990.0458979999999</c:v>
                </c:pt>
                <c:pt idx="1733">
                  <c:v>3991.9743880000001</c:v>
                </c:pt>
                <c:pt idx="1734">
                  <c:v>3993.9028779999999</c:v>
                </c:pt>
                <c:pt idx="1735">
                  <c:v>3995.8313680000001</c:v>
                </c:pt>
                <c:pt idx="1736">
                  <c:v>3997.7598579999999</c:v>
                </c:pt>
                <c:pt idx="1737">
                  <c:v>3999.688349</c:v>
                </c:pt>
                <c:pt idx="1738">
                  <c:v>4001.6168389999998</c:v>
                </c:pt>
              </c:numCache>
            </c:numRef>
          </c:xVal>
          <c:yVal>
            <c:numRef>
              <c:f>IR!$D:$D</c:f>
              <c:numCache>
                <c:formatCode>General</c:formatCode>
                <c:ptCount val="1048576"/>
                <c:pt idx="0">
                  <c:v>97.578569999999985</c:v>
                </c:pt>
                <c:pt idx="1">
                  <c:v>97.587530000000001</c:v>
                </c:pt>
                <c:pt idx="2">
                  <c:v>97.595470000000006</c:v>
                </c:pt>
                <c:pt idx="3">
                  <c:v>97.602902999999927</c:v>
                </c:pt>
                <c:pt idx="4">
                  <c:v>97.609782999999865</c:v>
                </c:pt>
                <c:pt idx="5">
                  <c:v>97.617266999999998</c:v>
                </c:pt>
                <c:pt idx="6">
                  <c:v>97.622282999999896</c:v>
                </c:pt>
                <c:pt idx="7">
                  <c:v>97.625411999999912</c:v>
                </c:pt>
                <c:pt idx="8">
                  <c:v>97.636825999999999</c:v>
                </c:pt>
                <c:pt idx="9">
                  <c:v>97.654219999999995</c:v>
                </c:pt>
                <c:pt idx="10">
                  <c:v>97.660516000000001</c:v>
                </c:pt>
                <c:pt idx="11">
                  <c:v>97.652637999999897</c:v>
                </c:pt>
                <c:pt idx="12">
                  <c:v>97.64272099999998</c:v>
                </c:pt>
                <c:pt idx="13">
                  <c:v>97.637347999999946</c:v>
                </c:pt>
                <c:pt idx="14">
                  <c:v>97.635274999999979</c:v>
                </c:pt>
                <c:pt idx="15">
                  <c:v>97.633980999999977</c:v>
                </c:pt>
                <c:pt idx="16">
                  <c:v>97.632540999999947</c:v>
                </c:pt>
                <c:pt idx="17">
                  <c:v>97.633256000000003</c:v>
                </c:pt>
                <c:pt idx="18">
                  <c:v>97.637870999999976</c:v>
                </c:pt>
                <c:pt idx="19">
                  <c:v>97.643876999999947</c:v>
                </c:pt>
                <c:pt idx="20">
                  <c:v>97.65031699999993</c:v>
                </c:pt>
                <c:pt idx="21">
                  <c:v>97.659166999999982</c:v>
                </c:pt>
                <c:pt idx="22">
                  <c:v>97.667375999999976</c:v>
                </c:pt>
                <c:pt idx="23">
                  <c:v>97.669600000000003</c:v>
                </c:pt>
                <c:pt idx="24">
                  <c:v>97.666967999999983</c:v>
                </c:pt>
                <c:pt idx="25">
                  <c:v>97.664431999999977</c:v>
                </c:pt>
                <c:pt idx="26">
                  <c:v>97.665826999999979</c:v>
                </c:pt>
                <c:pt idx="27">
                  <c:v>97.672608999999895</c:v>
                </c:pt>
                <c:pt idx="28">
                  <c:v>97.682322999999911</c:v>
                </c:pt>
                <c:pt idx="29">
                  <c:v>97.691919999999996</c:v>
                </c:pt>
                <c:pt idx="30">
                  <c:v>97.701317000000003</c:v>
                </c:pt>
                <c:pt idx="31">
                  <c:v>97.709829999999997</c:v>
                </c:pt>
                <c:pt idx="32">
                  <c:v>97.715249</c:v>
                </c:pt>
                <c:pt idx="33">
                  <c:v>97.718086</c:v>
                </c:pt>
                <c:pt idx="34">
                  <c:v>97.721279999999993</c:v>
                </c:pt>
                <c:pt idx="35">
                  <c:v>97.726234000000005</c:v>
                </c:pt>
                <c:pt idx="36">
                  <c:v>97.732253999999998</c:v>
                </c:pt>
                <c:pt idx="37">
                  <c:v>97.738951</c:v>
                </c:pt>
                <c:pt idx="38">
                  <c:v>97.746965000000003</c:v>
                </c:pt>
                <c:pt idx="39">
                  <c:v>97.755795999999975</c:v>
                </c:pt>
                <c:pt idx="40">
                  <c:v>97.763073000000006</c:v>
                </c:pt>
                <c:pt idx="41">
                  <c:v>97.767498000000003</c:v>
                </c:pt>
                <c:pt idx="42">
                  <c:v>97.770431999999929</c:v>
                </c:pt>
                <c:pt idx="43">
                  <c:v>97.773748999999896</c:v>
                </c:pt>
                <c:pt idx="44">
                  <c:v>97.778520999999998</c:v>
                </c:pt>
                <c:pt idx="45">
                  <c:v>97.784453999999997</c:v>
                </c:pt>
                <c:pt idx="46">
                  <c:v>97.78935199999998</c:v>
                </c:pt>
                <c:pt idx="47">
                  <c:v>97.791899000000001</c:v>
                </c:pt>
                <c:pt idx="48">
                  <c:v>97.794077000000001</c:v>
                </c:pt>
                <c:pt idx="49">
                  <c:v>97.799695</c:v>
                </c:pt>
                <c:pt idx="50">
                  <c:v>97.811848999999981</c:v>
                </c:pt>
                <c:pt idx="51">
                  <c:v>97.828286999999946</c:v>
                </c:pt>
                <c:pt idx="52">
                  <c:v>97.840823999999998</c:v>
                </c:pt>
                <c:pt idx="53">
                  <c:v>97.845370999999929</c:v>
                </c:pt>
                <c:pt idx="54">
                  <c:v>97.846913999999998</c:v>
                </c:pt>
                <c:pt idx="55">
                  <c:v>97.850955999999982</c:v>
                </c:pt>
                <c:pt idx="56">
                  <c:v>97.857353000000003</c:v>
                </c:pt>
                <c:pt idx="57">
                  <c:v>97.863340999999977</c:v>
                </c:pt>
                <c:pt idx="58">
                  <c:v>97.867598000000001</c:v>
                </c:pt>
                <c:pt idx="59">
                  <c:v>97.87015599999998</c:v>
                </c:pt>
                <c:pt idx="60">
                  <c:v>97.871375999999927</c:v>
                </c:pt>
                <c:pt idx="61">
                  <c:v>97.872241999999929</c:v>
                </c:pt>
                <c:pt idx="62">
                  <c:v>97.873035999999928</c:v>
                </c:pt>
                <c:pt idx="63">
                  <c:v>97.873614000000003</c:v>
                </c:pt>
                <c:pt idx="64">
                  <c:v>97.875925999999978</c:v>
                </c:pt>
                <c:pt idx="65">
                  <c:v>97.881389999999982</c:v>
                </c:pt>
                <c:pt idx="66">
                  <c:v>97.887394999999998</c:v>
                </c:pt>
                <c:pt idx="67">
                  <c:v>97.889724999999999</c:v>
                </c:pt>
                <c:pt idx="68">
                  <c:v>97.887327999999982</c:v>
                </c:pt>
                <c:pt idx="69">
                  <c:v>97.884459000000007</c:v>
                </c:pt>
                <c:pt idx="70">
                  <c:v>97.886474999999976</c:v>
                </c:pt>
                <c:pt idx="71">
                  <c:v>97.893460000000005</c:v>
                </c:pt>
                <c:pt idx="72">
                  <c:v>97.901391000000004</c:v>
                </c:pt>
                <c:pt idx="73">
                  <c:v>97.907494999999997</c:v>
                </c:pt>
                <c:pt idx="74">
                  <c:v>97.911739999999995</c:v>
                </c:pt>
                <c:pt idx="75">
                  <c:v>97.916473999999994</c:v>
                </c:pt>
                <c:pt idx="76">
                  <c:v>97.924287000000007</c:v>
                </c:pt>
                <c:pt idx="77">
                  <c:v>97.934526000000005</c:v>
                </c:pt>
                <c:pt idx="78">
                  <c:v>97.945651999999995</c:v>
                </c:pt>
                <c:pt idx="79">
                  <c:v>97.958478999999912</c:v>
                </c:pt>
                <c:pt idx="80">
                  <c:v>97.972713999999982</c:v>
                </c:pt>
                <c:pt idx="81">
                  <c:v>97.985473999999982</c:v>
                </c:pt>
                <c:pt idx="82">
                  <c:v>97.995248000000004</c:v>
                </c:pt>
                <c:pt idx="83">
                  <c:v>98.003405999999998</c:v>
                </c:pt>
                <c:pt idx="84">
                  <c:v>98.011915000000002</c:v>
                </c:pt>
                <c:pt idx="85">
                  <c:v>98.02249399999998</c:v>
                </c:pt>
                <c:pt idx="86">
                  <c:v>98.035946999999979</c:v>
                </c:pt>
                <c:pt idx="87">
                  <c:v>98.049305000000004</c:v>
                </c:pt>
                <c:pt idx="88">
                  <c:v>98.059439999999981</c:v>
                </c:pt>
                <c:pt idx="89">
                  <c:v>98.068747999999928</c:v>
                </c:pt>
                <c:pt idx="90">
                  <c:v>98.079121000000001</c:v>
                </c:pt>
                <c:pt idx="91">
                  <c:v>98.087867000000003</c:v>
                </c:pt>
                <c:pt idx="92">
                  <c:v>98.094595999999996</c:v>
                </c:pt>
                <c:pt idx="93">
                  <c:v>98.102270999999931</c:v>
                </c:pt>
                <c:pt idx="94">
                  <c:v>98.111688000000001</c:v>
                </c:pt>
                <c:pt idx="95">
                  <c:v>98.121034999999978</c:v>
                </c:pt>
                <c:pt idx="96">
                  <c:v>98.129287999999946</c:v>
                </c:pt>
                <c:pt idx="97">
                  <c:v>98.137271999999982</c:v>
                </c:pt>
                <c:pt idx="98">
                  <c:v>98.146033000000003</c:v>
                </c:pt>
                <c:pt idx="99">
                  <c:v>98.157024000000007</c:v>
                </c:pt>
                <c:pt idx="100">
                  <c:v>98.172099999999929</c:v>
                </c:pt>
                <c:pt idx="101">
                  <c:v>98.188697999999945</c:v>
                </c:pt>
                <c:pt idx="102">
                  <c:v>98.20057199999998</c:v>
                </c:pt>
                <c:pt idx="103">
                  <c:v>98.207536000000005</c:v>
                </c:pt>
                <c:pt idx="104">
                  <c:v>98.21531899999998</c:v>
                </c:pt>
                <c:pt idx="105">
                  <c:v>98.225514000000004</c:v>
                </c:pt>
                <c:pt idx="106">
                  <c:v>98.235875999999976</c:v>
                </c:pt>
                <c:pt idx="107">
                  <c:v>98.246174999999994</c:v>
                </c:pt>
                <c:pt idx="108">
                  <c:v>98.257688000000002</c:v>
                </c:pt>
                <c:pt idx="109">
                  <c:v>98.272784999999928</c:v>
                </c:pt>
                <c:pt idx="110">
                  <c:v>98.293903999999998</c:v>
                </c:pt>
                <c:pt idx="111">
                  <c:v>98.318836999999945</c:v>
                </c:pt>
                <c:pt idx="112">
                  <c:v>98.341774999999998</c:v>
                </c:pt>
                <c:pt idx="113">
                  <c:v>98.360196999999999</c:v>
                </c:pt>
                <c:pt idx="114">
                  <c:v>98.376338999999874</c:v>
                </c:pt>
                <c:pt idx="115">
                  <c:v>98.391834000000003</c:v>
                </c:pt>
                <c:pt idx="116">
                  <c:v>98.405617000000007</c:v>
                </c:pt>
                <c:pt idx="117">
                  <c:v>98.417238999999995</c:v>
                </c:pt>
                <c:pt idx="118">
                  <c:v>98.42630699999998</c:v>
                </c:pt>
                <c:pt idx="119">
                  <c:v>98.430301999999998</c:v>
                </c:pt>
                <c:pt idx="120">
                  <c:v>98.428933999999998</c:v>
                </c:pt>
                <c:pt idx="121">
                  <c:v>98.427047999999999</c:v>
                </c:pt>
                <c:pt idx="122">
                  <c:v>98.428606000000002</c:v>
                </c:pt>
                <c:pt idx="123">
                  <c:v>98.431901999999994</c:v>
                </c:pt>
                <c:pt idx="124">
                  <c:v>98.432875999999979</c:v>
                </c:pt>
                <c:pt idx="125">
                  <c:v>98.429409000000007</c:v>
                </c:pt>
                <c:pt idx="126">
                  <c:v>98.423350999999982</c:v>
                </c:pt>
                <c:pt idx="127">
                  <c:v>98.419516999999999</c:v>
                </c:pt>
                <c:pt idx="128">
                  <c:v>98.419445999999994</c:v>
                </c:pt>
                <c:pt idx="129">
                  <c:v>98.419516999999999</c:v>
                </c:pt>
                <c:pt idx="130">
                  <c:v>98.417878000000002</c:v>
                </c:pt>
                <c:pt idx="131">
                  <c:v>98.416274999999999</c:v>
                </c:pt>
                <c:pt idx="132">
                  <c:v>98.415023000000005</c:v>
                </c:pt>
                <c:pt idx="133">
                  <c:v>98.413517999999996</c:v>
                </c:pt>
                <c:pt idx="134">
                  <c:v>98.412969000000004</c:v>
                </c:pt>
                <c:pt idx="135">
                  <c:v>98.413728000000006</c:v>
                </c:pt>
                <c:pt idx="136">
                  <c:v>98.414533000000006</c:v>
                </c:pt>
                <c:pt idx="137">
                  <c:v>98.415419</c:v>
                </c:pt>
                <c:pt idx="138">
                  <c:v>98.416685000000001</c:v>
                </c:pt>
                <c:pt idx="139">
                  <c:v>98.417719000000005</c:v>
                </c:pt>
                <c:pt idx="140">
                  <c:v>98.419010999999998</c:v>
                </c:pt>
                <c:pt idx="141">
                  <c:v>98.420505000000006</c:v>
                </c:pt>
                <c:pt idx="142">
                  <c:v>98.420083000000005</c:v>
                </c:pt>
                <c:pt idx="143">
                  <c:v>98.416915000000003</c:v>
                </c:pt>
                <c:pt idx="144">
                  <c:v>98.411619999999999</c:v>
                </c:pt>
                <c:pt idx="145">
                  <c:v>98.403823000000003</c:v>
                </c:pt>
                <c:pt idx="146">
                  <c:v>98.393187999999981</c:v>
                </c:pt>
                <c:pt idx="147">
                  <c:v>98.381469999999993</c:v>
                </c:pt>
                <c:pt idx="148">
                  <c:v>98.371827999999979</c:v>
                </c:pt>
                <c:pt idx="149">
                  <c:v>98.365208999999979</c:v>
                </c:pt>
                <c:pt idx="150">
                  <c:v>98.360228000000006</c:v>
                </c:pt>
                <c:pt idx="151">
                  <c:v>98.356117999999981</c:v>
                </c:pt>
                <c:pt idx="152">
                  <c:v>98.351123999999999</c:v>
                </c:pt>
                <c:pt idx="153">
                  <c:v>98.342996999999983</c:v>
                </c:pt>
                <c:pt idx="154">
                  <c:v>98.333540999999983</c:v>
                </c:pt>
                <c:pt idx="155">
                  <c:v>98.326605000000001</c:v>
                </c:pt>
                <c:pt idx="156">
                  <c:v>98.322752999999892</c:v>
                </c:pt>
                <c:pt idx="157">
                  <c:v>98.31872199999998</c:v>
                </c:pt>
                <c:pt idx="158">
                  <c:v>98.311554999999998</c:v>
                </c:pt>
                <c:pt idx="159">
                  <c:v>98.303927999999999</c:v>
                </c:pt>
                <c:pt idx="160">
                  <c:v>98.301727999999983</c:v>
                </c:pt>
                <c:pt idx="161">
                  <c:v>98.305010999999979</c:v>
                </c:pt>
                <c:pt idx="162">
                  <c:v>98.308471999999895</c:v>
                </c:pt>
                <c:pt idx="163">
                  <c:v>98.310319000000007</c:v>
                </c:pt>
                <c:pt idx="164">
                  <c:v>98.312825000000004</c:v>
                </c:pt>
                <c:pt idx="165">
                  <c:v>98.315430999999975</c:v>
                </c:pt>
                <c:pt idx="166">
                  <c:v>98.313930999999982</c:v>
                </c:pt>
                <c:pt idx="167">
                  <c:v>98.307184000000007</c:v>
                </c:pt>
                <c:pt idx="168">
                  <c:v>98.299342999999979</c:v>
                </c:pt>
                <c:pt idx="169">
                  <c:v>98.293937</c:v>
                </c:pt>
                <c:pt idx="170">
                  <c:v>98.289990000000003</c:v>
                </c:pt>
                <c:pt idx="171">
                  <c:v>98.284180000000006</c:v>
                </c:pt>
                <c:pt idx="172">
                  <c:v>98.274834999999982</c:v>
                </c:pt>
                <c:pt idx="173">
                  <c:v>98.263795000000002</c:v>
                </c:pt>
                <c:pt idx="174">
                  <c:v>98.253519999999995</c:v>
                </c:pt>
                <c:pt idx="175">
                  <c:v>98.243690999999998</c:v>
                </c:pt>
                <c:pt idx="176">
                  <c:v>98.232885999999979</c:v>
                </c:pt>
                <c:pt idx="177">
                  <c:v>98.221984000000006</c:v>
                </c:pt>
                <c:pt idx="178">
                  <c:v>98.211939999999998</c:v>
                </c:pt>
                <c:pt idx="179">
                  <c:v>98.199591999999981</c:v>
                </c:pt>
                <c:pt idx="180">
                  <c:v>98.182061999999945</c:v>
                </c:pt>
                <c:pt idx="181">
                  <c:v>98.163529999999994</c:v>
                </c:pt>
                <c:pt idx="182">
                  <c:v>98.149969999999996</c:v>
                </c:pt>
                <c:pt idx="183">
                  <c:v>98.140286000000003</c:v>
                </c:pt>
                <c:pt idx="184">
                  <c:v>98.12993599999993</c:v>
                </c:pt>
                <c:pt idx="185">
                  <c:v>98.117531</c:v>
                </c:pt>
                <c:pt idx="186">
                  <c:v>98.102755999999928</c:v>
                </c:pt>
                <c:pt idx="187">
                  <c:v>98.085614000000007</c:v>
                </c:pt>
                <c:pt idx="188">
                  <c:v>98.068268000000003</c:v>
                </c:pt>
                <c:pt idx="189">
                  <c:v>98.052351999999928</c:v>
                </c:pt>
                <c:pt idx="190">
                  <c:v>98.037818999999999</c:v>
                </c:pt>
                <c:pt idx="191">
                  <c:v>98.023949000000002</c:v>
                </c:pt>
                <c:pt idx="192">
                  <c:v>98.008487999999929</c:v>
                </c:pt>
                <c:pt idx="193">
                  <c:v>97.990387999999982</c:v>
                </c:pt>
                <c:pt idx="194">
                  <c:v>97.972009</c:v>
                </c:pt>
                <c:pt idx="195">
                  <c:v>97.954683000000003</c:v>
                </c:pt>
                <c:pt idx="196">
                  <c:v>97.937004000000002</c:v>
                </c:pt>
                <c:pt idx="197">
                  <c:v>97.918370999999979</c:v>
                </c:pt>
                <c:pt idx="198">
                  <c:v>97.899511000000004</c:v>
                </c:pt>
                <c:pt idx="199">
                  <c:v>97.882154999999983</c:v>
                </c:pt>
                <c:pt idx="200">
                  <c:v>97.868617999999998</c:v>
                </c:pt>
                <c:pt idx="201">
                  <c:v>97.857456999999982</c:v>
                </c:pt>
                <c:pt idx="202">
                  <c:v>97.844064000000003</c:v>
                </c:pt>
                <c:pt idx="203">
                  <c:v>97.82755299999998</c:v>
                </c:pt>
                <c:pt idx="204">
                  <c:v>97.809545999999983</c:v>
                </c:pt>
                <c:pt idx="205">
                  <c:v>97.789374999999978</c:v>
                </c:pt>
                <c:pt idx="206">
                  <c:v>97.767061999999996</c:v>
                </c:pt>
                <c:pt idx="207">
                  <c:v>97.744928000000002</c:v>
                </c:pt>
                <c:pt idx="208">
                  <c:v>97.72298499999998</c:v>
                </c:pt>
                <c:pt idx="209">
                  <c:v>97.698769999999982</c:v>
                </c:pt>
                <c:pt idx="210">
                  <c:v>97.672516999999928</c:v>
                </c:pt>
                <c:pt idx="211">
                  <c:v>97.647925999999998</c:v>
                </c:pt>
                <c:pt idx="212">
                  <c:v>97.627529999999993</c:v>
                </c:pt>
                <c:pt idx="213">
                  <c:v>97.610840999999979</c:v>
                </c:pt>
                <c:pt idx="214">
                  <c:v>97.595733999999979</c:v>
                </c:pt>
                <c:pt idx="215">
                  <c:v>97.580273000000005</c:v>
                </c:pt>
                <c:pt idx="216">
                  <c:v>97.565196999999998</c:v>
                </c:pt>
                <c:pt idx="217">
                  <c:v>97.552445999999946</c:v>
                </c:pt>
                <c:pt idx="218">
                  <c:v>97.541415999999998</c:v>
                </c:pt>
                <c:pt idx="219">
                  <c:v>97.530809000000005</c:v>
                </c:pt>
                <c:pt idx="220">
                  <c:v>97.520612</c:v>
                </c:pt>
                <c:pt idx="221">
                  <c:v>97.510696999999993</c:v>
                </c:pt>
                <c:pt idx="222">
                  <c:v>97.501501000000005</c:v>
                </c:pt>
                <c:pt idx="223">
                  <c:v>97.493943000000002</c:v>
                </c:pt>
                <c:pt idx="224">
                  <c:v>97.485980999999981</c:v>
                </c:pt>
                <c:pt idx="225">
                  <c:v>97.474198000000001</c:v>
                </c:pt>
                <c:pt idx="226">
                  <c:v>97.460419999999999</c:v>
                </c:pt>
                <c:pt idx="227">
                  <c:v>97.449145999999999</c:v>
                </c:pt>
                <c:pt idx="228">
                  <c:v>97.439825999999996</c:v>
                </c:pt>
                <c:pt idx="229">
                  <c:v>97.430700999999999</c:v>
                </c:pt>
                <c:pt idx="230">
                  <c:v>97.424361000000005</c:v>
                </c:pt>
                <c:pt idx="231">
                  <c:v>97.423015000000007</c:v>
                </c:pt>
                <c:pt idx="232">
                  <c:v>97.424957000000006</c:v>
                </c:pt>
                <c:pt idx="233">
                  <c:v>97.428013000000007</c:v>
                </c:pt>
                <c:pt idx="234">
                  <c:v>97.433205000000001</c:v>
                </c:pt>
                <c:pt idx="235">
                  <c:v>97.443458000000007</c:v>
                </c:pt>
                <c:pt idx="236">
                  <c:v>97.459601000000006</c:v>
                </c:pt>
                <c:pt idx="237">
                  <c:v>97.481120000000004</c:v>
                </c:pt>
                <c:pt idx="238">
                  <c:v>97.509437999999946</c:v>
                </c:pt>
                <c:pt idx="239">
                  <c:v>97.545992999999982</c:v>
                </c:pt>
                <c:pt idx="240">
                  <c:v>97.588194000000001</c:v>
                </c:pt>
                <c:pt idx="241">
                  <c:v>97.630303999999981</c:v>
                </c:pt>
                <c:pt idx="242">
                  <c:v>97.667757999999978</c:v>
                </c:pt>
                <c:pt idx="243">
                  <c:v>97.698897999999929</c:v>
                </c:pt>
                <c:pt idx="244">
                  <c:v>97.723979999999983</c:v>
                </c:pt>
                <c:pt idx="245">
                  <c:v>97.744624999999999</c:v>
                </c:pt>
                <c:pt idx="246">
                  <c:v>97.762107999999998</c:v>
                </c:pt>
                <c:pt idx="247">
                  <c:v>97.775165000000001</c:v>
                </c:pt>
                <c:pt idx="248">
                  <c:v>97.78275499999998</c:v>
                </c:pt>
                <c:pt idx="249">
                  <c:v>97.787865999999994</c:v>
                </c:pt>
                <c:pt idx="250">
                  <c:v>97.793770999999978</c:v>
                </c:pt>
                <c:pt idx="251">
                  <c:v>97.79827899999998</c:v>
                </c:pt>
                <c:pt idx="252">
                  <c:v>97.797387999999998</c:v>
                </c:pt>
                <c:pt idx="253">
                  <c:v>97.792703000000003</c:v>
                </c:pt>
                <c:pt idx="254">
                  <c:v>97.789844000000002</c:v>
                </c:pt>
                <c:pt idx="255">
                  <c:v>97.791453000000004</c:v>
                </c:pt>
                <c:pt idx="256">
                  <c:v>97.794955999999999</c:v>
                </c:pt>
                <c:pt idx="257">
                  <c:v>97.796323000000001</c:v>
                </c:pt>
                <c:pt idx="258">
                  <c:v>97.795148999999981</c:v>
                </c:pt>
                <c:pt idx="259">
                  <c:v>97.794088000000002</c:v>
                </c:pt>
                <c:pt idx="260">
                  <c:v>97.793701999999982</c:v>
                </c:pt>
                <c:pt idx="261">
                  <c:v>97.792373999999981</c:v>
                </c:pt>
                <c:pt idx="262">
                  <c:v>97.790456000000006</c:v>
                </c:pt>
                <c:pt idx="263">
                  <c:v>97.789530000000013</c:v>
                </c:pt>
                <c:pt idx="264">
                  <c:v>97.788737999999896</c:v>
                </c:pt>
                <c:pt idx="265">
                  <c:v>97.786015000000006</c:v>
                </c:pt>
                <c:pt idx="266">
                  <c:v>97.781193999999999</c:v>
                </c:pt>
                <c:pt idx="267">
                  <c:v>97.775029000000004</c:v>
                </c:pt>
                <c:pt idx="268">
                  <c:v>97.767842000000002</c:v>
                </c:pt>
                <c:pt idx="269">
                  <c:v>97.760360000000006</c:v>
                </c:pt>
                <c:pt idx="270">
                  <c:v>97.752656000000002</c:v>
                </c:pt>
                <c:pt idx="271">
                  <c:v>97.743430000000004</c:v>
                </c:pt>
                <c:pt idx="272">
                  <c:v>97.733170999999999</c:v>
                </c:pt>
                <c:pt idx="273">
                  <c:v>97.724430999999981</c:v>
                </c:pt>
                <c:pt idx="274">
                  <c:v>97.717543000000006</c:v>
                </c:pt>
                <c:pt idx="275">
                  <c:v>97.710464000000002</c:v>
                </c:pt>
                <c:pt idx="276">
                  <c:v>97.702270000000013</c:v>
                </c:pt>
                <c:pt idx="277">
                  <c:v>97.693183000000005</c:v>
                </c:pt>
                <c:pt idx="278">
                  <c:v>97.682436999999865</c:v>
                </c:pt>
                <c:pt idx="279">
                  <c:v>97.669481999999945</c:v>
                </c:pt>
                <c:pt idx="280">
                  <c:v>97.656351999999927</c:v>
                </c:pt>
                <c:pt idx="281">
                  <c:v>97.645465999999999</c:v>
                </c:pt>
                <c:pt idx="282">
                  <c:v>97.635737999999876</c:v>
                </c:pt>
                <c:pt idx="283">
                  <c:v>97.623716999999928</c:v>
                </c:pt>
                <c:pt idx="284">
                  <c:v>97.608630999999946</c:v>
                </c:pt>
                <c:pt idx="285">
                  <c:v>97.593717999999981</c:v>
                </c:pt>
                <c:pt idx="286">
                  <c:v>97.580714</c:v>
                </c:pt>
                <c:pt idx="287">
                  <c:v>97.567194999999998</c:v>
                </c:pt>
                <c:pt idx="288">
                  <c:v>97.551303000000004</c:v>
                </c:pt>
                <c:pt idx="289">
                  <c:v>97.53434799999998</c:v>
                </c:pt>
                <c:pt idx="290">
                  <c:v>97.518422999999999</c:v>
                </c:pt>
                <c:pt idx="291">
                  <c:v>97.504005000000006</c:v>
                </c:pt>
                <c:pt idx="292">
                  <c:v>97.489576999999983</c:v>
                </c:pt>
                <c:pt idx="293">
                  <c:v>97.473779999999977</c:v>
                </c:pt>
                <c:pt idx="294">
                  <c:v>97.456592999999998</c:v>
                </c:pt>
                <c:pt idx="295">
                  <c:v>97.438305999999983</c:v>
                </c:pt>
                <c:pt idx="296">
                  <c:v>97.419773000000006</c:v>
                </c:pt>
                <c:pt idx="297">
                  <c:v>97.402066000000005</c:v>
                </c:pt>
                <c:pt idx="298">
                  <c:v>97.384602000000001</c:v>
                </c:pt>
                <c:pt idx="299">
                  <c:v>97.366190000000003</c:v>
                </c:pt>
                <c:pt idx="300">
                  <c:v>97.347026999999997</c:v>
                </c:pt>
                <c:pt idx="301">
                  <c:v>97.327703999999983</c:v>
                </c:pt>
                <c:pt idx="302">
                  <c:v>97.308050999999978</c:v>
                </c:pt>
                <c:pt idx="303">
                  <c:v>97.287761000000003</c:v>
                </c:pt>
                <c:pt idx="304">
                  <c:v>97.267297999999997</c:v>
                </c:pt>
                <c:pt idx="305">
                  <c:v>97.247971000000007</c:v>
                </c:pt>
                <c:pt idx="306">
                  <c:v>97.230549999999994</c:v>
                </c:pt>
                <c:pt idx="307">
                  <c:v>97.214405999999997</c:v>
                </c:pt>
                <c:pt idx="308">
                  <c:v>97.198228</c:v>
                </c:pt>
                <c:pt idx="309">
                  <c:v>97.180926999999983</c:v>
                </c:pt>
                <c:pt idx="310">
                  <c:v>97.162619000000007</c:v>
                </c:pt>
                <c:pt idx="311">
                  <c:v>97.144874999999999</c:v>
                </c:pt>
                <c:pt idx="312">
                  <c:v>97.129764999999978</c:v>
                </c:pt>
                <c:pt idx="313">
                  <c:v>97.118999000000002</c:v>
                </c:pt>
                <c:pt idx="314">
                  <c:v>97.112364999999983</c:v>
                </c:pt>
                <c:pt idx="315">
                  <c:v>97.107106000000002</c:v>
                </c:pt>
                <c:pt idx="316">
                  <c:v>97.100284000000002</c:v>
                </c:pt>
                <c:pt idx="317">
                  <c:v>97.090288999999999</c:v>
                </c:pt>
                <c:pt idx="318">
                  <c:v>97.076689000000002</c:v>
                </c:pt>
                <c:pt idx="319">
                  <c:v>97.060652000000005</c:v>
                </c:pt>
                <c:pt idx="320">
                  <c:v>97.043265000000005</c:v>
                </c:pt>
                <c:pt idx="321">
                  <c:v>97.02343399999998</c:v>
                </c:pt>
                <c:pt idx="322">
                  <c:v>97.000062</c:v>
                </c:pt>
                <c:pt idx="323">
                  <c:v>96.974070999999981</c:v>
                </c:pt>
                <c:pt idx="324">
                  <c:v>96.946197999999995</c:v>
                </c:pt>
                <c:pt idx="325">
                  <c:v>96.915957000000006</c:v>
                </c:pt>
                <c:pt idx="326">
                  <c:v>96.883348999999896</c:v>
                </c:pt>
                <c:pt idx="327">
                  <c:v>96.84974099999998</c:v>
                </c:pt>
                <c:pt idx="328">
                  <c:v>96.816829999999996</c:v>
                </c:pt>
                <c:pt idx="329">
                  <c:v>96.784165999999999</c:v>
                </c:pt>
                <c:pt idx="330">
                  <c:v>96.748794000000004</c:v>
                </c:pt>
                <c:pt idx="331">
                  <c:v>96.709466000000006</c:v>
                </c:pt>
                <c:pt idx="332">
                  <c:v>96.667791999999977</c:v>
                </c:pt>
                <c:pt idx="333">
                  <c:v>96.624884999999978</c:v>
                </c:pt>
                <c:pt idx="334">
                  <c:v>96.581807999999981</c:v>
                </c:pt>
                <c:pt idx="335">
                  <c:v>96.540674999999993</c:v>
                </c:pt>
                <c:pt idx="336">
                  <c:v>96.501544999999993</c:v>
                </c:pt>
                <c:pt idx="337">
                  <c:v>96.463078999999979</c:v>
                </c:pt>
                <c:pt idx="338">
                  <c:v>96.425274000000002</c:v>
                </c:pt>
                <c:pt idx="339">
                  <c:v>96.387921000000006</c:v>
                </c:pt>
                <c:pt idx="340">
                  <c:v>96.349743000000004</c:v>
                </c:pt>
                <c:pt idx="341">
                  <c:v>96.309414000000004</c:v>
                </c:pt>
                <c:pt idx="342">
                  <c:v>96.26599299999998</c:v>
                </c:pt>
                <c:pt idx="343">
                  <c:v>96.219916999999995</c:v>
                </c:pt>
                <c:pt idx="344">
                  <c:v>96.172287999999895</c:v>
                </c:pt>
                <c:pt idx="345">
                  <c:v>96.123850999999945</c:v>
                </c:pt>
                <c:pt idx="346">
                  <c:v>96.075320999999946</c:v>
                </c:pt>
                <c:pt idx="347">
                  <c:v>96.025914999999998</c:v>
                </c:pt>
                <c:pt idx="348">
                  <c:v>95.972783999999976</c:v>
                </c:pt>
                <c:pt idx="349">
                  <c:v>95.914315000000002</c:v>
                </c:pt>
                <c:pt idx="350">
                  <c:v>95.851474999999979</c:v>
                </c:pt>
                <c:pt idx="351">
                  <c:v>95.786073999999999</c:v>
                </c:pt>
                <c:pt idx="352">
                  <c:v>95.720388999999912</c:v>
                </c:pt>
                <c:pt idx="353">
                  <c:v>95.657027999999983</c:v>
                </c:pt>
                <c:pt idx="354">
                  <c:v>95.597813000000002</c:v>
                </c:pt>
                <c:pt idx="355">
                  <c:v>95.54379299999998</c:v>
                </c:pt>
                <c:pt idx="356">
                  <c:v>95.494361999999995</c:v>
                </c:pt>
                <c:pt idx="357">
                  <c:v>95.445594999999997</c:v>
                </c:pt>
                <c:pt idx="358">
                  <c:v>95.39284499999998</c:v>
                </c:pt>
                <c:pt idx="359">
                  <c:v>95.336304999999982</c:v>
                </c:pt>
                <c:pt idx="360">
                  <c:v>95.281115</c:v>
                </c:pt>
                <c:pt idx="361">
                  <c:v>95.232186999999982</c:v>
                </c:pt>
                <c:pt idx="362">
                  <c:v>95.191781999999947</c:v>
                </c:pt>
                <c:pt idx="363">
                  <c:v>95.161468999999983</c:v>
                </c:pt>
                <c:pt idx="364">
                  <c:v>95.14300799999998</c:v>
                </c:pt>
                <c:pt idx="365">
                  <c:v>95.136310999999978</c:v>
                </c:pt>
                <c:pt idx="366">
                  <c:v>95.138881999999896</c:v>
                </c:pt>
                <c:pt idx="367">
                  <c:v>95.148420000000002</c:v>
                </c:pt>
                <c:pt idx="368">
                  <c:v>95.162699000000003</c:v>
                </c:pt>
                <c:pt idx="369">
                  <c:v>95.176485999999912</c:v>
                </c:pt>
                <c:pt idx="370">
                  <c:v>95.18438699999993</c:v>
                </c:pt>
                <c:pt idx="371">
                  <c:v>95.187832999999927</c:v>
                </c:pt>
                <c:pt idx="372">
                  <c:v>95.192851999999945</c:v>
                </c:pt>
                <c:pt idx="373">
                  <c:v>95.202309</c:v>
                </c:pt>
                <c:pt idx="374">
                  <c:v>95.216102000000006</c:v>
                </c:pt>
                <c:pt idx="375">
                  <c:v>95.233165999999997</c:v>
                </c:pt>
                <c:pt idx="376">
                  <c:v>95.25023299999998</c:v>
                </c:pt>
                <c:pt idx="377">
                  <c:v>95.265327999999982</c:v>
                </c:pt>
                <c:pt idx="378">
                  <c:v>95.280719000000005</c:v>
                </c:pt>
                <c:pt idx="379">
                  <c:v>95.299695999999997</c:v>
                </c:pt>
                <c:pt idx="380">
                  <c:v>95.325748999999874</c:v>
                </c:pt>
                <c:pt idx="381">
                  <c:v>95.360703000000001</c:v>
                </c:pt>
                <c:pt idx="382">
                  <c:v>95.398606999999998</c:v>
                </c:pt>
                <c:pt idx="383">
                  <c:v>95.431428999999994</c:v>
                </c:pt>
                <c:pt idx="384">
                  <c:v>95.463130000000007</c:v>
                </c:pt>
                <c:pt idx="385">
                  <c:v>95.503005999999999</c:v>
                </c:pt>
                <c:pt idx="386">
                  <c:v>95.548152000000002</c:v>
                </c:pt>
                <c:pt idx="387">
                  <c:v>95.588766999999976</c:v>
                </c:pt>
                <c:pt idx="388">
                  <c:v>95.622566999999975</c:v>
                </c:pt>
                <c:pt idx="389">
                  <c:v>95.653693000000004</c:v>
                </c:pt>
                <c:pt idx="390">
                  <c:v>95.687667000000005</c:v>
                </c:pt>
                <c:pt idx="391">
                  <c:v>95.726478999999927</c:v>
                </c:pt>
                <c:pt idx="392">
                  <c:v>95.765821000000003</c:v>
                </c:pt>
                <c:pt idx="393">
                  <c:v>95.803279000000003</c:v>
                </c:pt>
                <c:pt idx="394">
                  <c:v>95.841793999999993</c:v>
                </c:pt>
                <c:pt idx="395">
                  <c:v>95.883345999999946</c:v>
                </c:pt>
                <c:pt idx="396">
                  <c:v>95.930334999999999</c:v>
                </c:pt>
                <c:pt idx="397">
                  <c:v>95.987737999999979</c:v>
                </c:pt>
                <c:pt idx="398">
                  <c:v>96.051698000000002</c:v>
                </c:pt>
                <c:pt idx="399">
                  <c:v>96.104980999999981</c:v>
                </c:pt>
                <c:pt idx="400">
                  <c:v>96.139244000000005</c:v>
                </c:pt>
                <c:pt idx="401">
                  <c:v>96.167456999999999</c:v>
                </c:pt>
                <c:pt idx="402">
                  <c:v>96.203851999999998</c:v>
                </c:pt>
                <c:pt idx="403">
                  <c:v>96.251479000000003</c:v>
                </c:pt>
                <c:pt idx="404">
                  <c:v>96.307531999999981</c:v>
                </c:pt>
                <c:pt idx="405">
                  <c:v>96.369163999999998</c:v>
                </c:pt>
                <c:pt idx="406">
                  <c:v>96.439650999999998</c:v>
                </c:pt>
                <c:pt idx="407">
                  <c:v>96.519312999999983</c:v>
                </c:pt>
                <c:pt idx="408">
                  <c:v>96.591333000000006</c:v>
                </c:pt>
                <c:pt idx="409">
                  <c:v>96.642904000000001</c:v>
                </c:pt>
                <c:pt idx="410">
                  <c:v>96.687866</c:v>
                </c:pt>
                <c:pt idx="411">
                  <c:v>96.74503</c:v>
                </c:pt>
                <c:pt idx="412">
                  <c:v>96.816834</c:v>
                </c:pt>
                <c:pt idx="413">
                  <c:v>96.893150000000006</c:v>
                </c:pt>
                <c:pt idx="414">
                  <c:v>96.961377999999982</c:v>
                </c:pt>
                <c:pt idx="415">
                  <c:v>97.020218</c:v>
                </c:pt>
                <c:pt idx="416">
                  <c:v>97.085496999999975</c:v>
                </c:pt>
                <c:pt idx="417">
                  <c:v>97.169415999999998</c:v>
                </c:pt>
                <c:pt idx="418">
                  <c:v>97.250429999999994</c:v>
                </c:pt>
                <c:pt idx="419">
                  <c:v>97.289274000000006</c:v>
                </c:pt>
                <c:pt idx="420">
                  <c:v>97.289615999999995</c:v>
                </c:pt>
                <c:pt idx="421">
                  <c:v>97.292806999999982</c:v>
                </c:pt>
                <c:pt idx="422">
                  <c:v>97.311819</c:v>
                </c:pt>
                <c:pt idx="423">
                  <c:v>97.326459999999983</c:v>
                </c:pt>
                <c:pt idx="424">
                  <c:v>97.331517000000005</c:v>
                </c:pt>
                <c:pt idx="425">
                  <c:v>97.343434999999999</c:v>
                </c:pt>
                <c:pt idx="426">
                  <c:v>97.361675000000005</c:v>
                </c:pt>
                <c:pt idx="427">
                  <c:v>97.362004999999982</c:v>
                </c:pt>
                <c:pt idx="428">
                  <c:v>97.333933999999999</c:v>
                </c:pt>
                <c:pt idx="429">
                  <c:v>97.293040000000005</c:v>
                </c:pt>
                <c:pt idx="430">
                  <c:v>97.254451000000003</c:v>
                </c:pt>
                <c:pt idx="431">
                  <c:v>97.220756999999978</c:v>
                </c:pt>
                <c:pt idx="432">
                  <c:v>97.191730000000007</c:v>
                </c:pt>
                <c:pt idx="433">
                  <c:v>97.169043000000002</c:v>
                </c:pt>
                <c:pt idx="434">
                  <c:v>97.149468999999982</c:v>
                </c:pt>
                <c:pt idx="435">
                  <c:v>97.120796999999897</c:v>
                </c:pt>
                <c:pt idx="436">
                  <c:v>97.075195999999977</c:v>
                </c:pt>
                <c:pt idx="437">
                  <c:v>97.02504399999998</c:v>
                </c:pt>
                <c:pt idx="438">
                  <c:v>96.985151000000002</c:v>
                </c:pt>
                <c:pt idx="439">
                  <c:v>96.945672000000002</c:v>
                </c:pt>
                <c:pt idx="440">
                  <c:v>96.889325999999983</c:v>
                </c:pt>
                <c:pt idx="441">
                  <c:v>96.825520999999981</c:v>
                </c:pt>
                <c:pt idx="442">
                  <c:v>96.783913999999996</c:v>
                </c:pt>
                <c:pt idx="443">
                  <c:v>96.772092999999927</c:v>
                </c:pt>
                <c:pt idx="444">
                  <c:v>96.749370000000013</c:v>
                </c:pt>
                <c:pt idx="445">
                  <c:v>96.675236999999896</c:v>
                </c:pt>
                <c:pt idx="446">
                  <c:v>96.570116999999982</c:v>
                </c:pt>
                <c:pt idx="447">
                  <c:v>96.476435999999978</c:v>
                </c:pt>
                <c:pt idx="448">
                  <c:v>96.404978999999983</c:v>
                </c:pt>
                <c:pt idx="449">
                  <c:v>96.347891000000004</c:v>
                </c:pt>
                <c:pt idx="450">
                  <c:v>96.300599000000005</c:v>
                </c:pt>
                <c:pt idx="451">
                  <c:v>96.254114999999999</c:v>
                </c:pt>
                <c:pt idx="452">
                  <c:v>96.187724000000003</c:v>
                </c:pt>
                <c:pt idx="453">
                  <c:v>96.092262000000005</c:v>
                </c:pt>
                <c:pt idx="454">
                  <c:v>95.982581999999979</c:v>
                </c:pt>
                <c:pt idx="455">
                  <c:v>95.874463000000006</c:v>
                </c:pt>
                <c:pt idx="456">
                  <c:v>95.776274999999998</c:v>
                </c:pt>
                <c:pt idx="457">
                  <c:v>95.690773999999976</c:v>
                </c:pt>
                <c:pt idx="458">
                  <c:v>95.609224999999995</c:v>
                </c:pt>
                <c:pt idx="459">
                  <c:v>95.532518999999979</c:v>
                </c:pt>
                <c:pt idx="460">
                  <c:v>95.477540000000005</c:v>
                </c:pt>
                <c:pt idx="461">
                  <c:v>95.429579000000004</c:v>
                </c:pt>
                <c:pt idx="462">
                  <c:v>95.342587999999978</c:v>
                </c:pt>
                <c:pt idx="463">
                  <c:v>95.208906999999982</c:v>
                </c:pt>
                <c:pt idx="464">
                  <c:v>95.06344799999998</c:v>
                </c:pt>
                <c:pt idx="465">
                  <c:v>94.933136000000005</c:v>
                </c:pt>
                <c:pt idx="466">
                  <c:v>94.826133999999982</c:v>
                </c:pt>
                <c:pt idx="467">
                  <c:v>94.741626999999994</c:v>
                </c:pt>
                <c:pt idx="468">
                  <c:v>94.675868999999892</c:v>
                </c:pt>
                <c:pt idx="469">
                  <c:v>94.631690000000006</c:v>
                </c:pt>
                <c:pt idx="470">
                  <c:v>94.611211999999995</c:v>
                </c:pt>
                <c:pt idx="471">
                  <c:v>94.583100999999999</c:v>
                </c:pt>
                <c:pt idx="472">
                  <c:v>94.502277999999976</c:v>
                </c:pt>
                <c:pt idx="473">
                  <c:v>94.386944999999983</c:v>
                </c:pt>
                <c:pt idx="474">
                  <c:v>94.298627999999994</c:v>
                </c:pt>
                <c:pt idx="475">
                  <c:v>94.261062999999993</c:v>
                </c:pt>
                <c:pt idx="476">
                  <c:v>94.255694000000005</c:v>
                </c:pt>
                <c:pt idx="477">
                  <c:v>94.258973999999981</c:v>
                </c:pt>
                <c:pt idx="478">
                  <c:v>94.270617999999999</c:v>
                </c:pt>
                <c:pt idx="479">
                  <c:v>94.306972999999928</c:v>
                </c:pt>
                <c:pt idx="480">
                  <c:v>94.357141999999982</c:v>
                </c:pt>
                <c:pt idx="481">
                  <c:v>94.389876999999927</c:v>
                </c:pt>
                <c:pt idx="482">
                  <c:v>94.410307000000003</c:v>
                </c:pt>
                <c:pt idx="483">
                  <c:v>94.447849000000005</c:v>
                </c:pt>
                <c:pt idx="484">
                  <c:v>94.509699999999995</c:v>
                </c:pt>
                <c:pt idx="485">
                  <c:v>94.586420000000004</c:v>
                </c:pt>
                <c:pt idx="486">
                  <c:v>94.671271999999931</c:v>
                </c:pt>
                <c:pt idx="487">
                  <c:v>94.761623999999998</c:v>
                </c:pt>
                <c:pt idx="488">
                  <c:v>94.857026000000005</c:v>
                </c:pt>
                <c:pt idx="489">
                  <c:v>94.956243999999998</c:v>
                </c:pt>
                <c:pt idx="490">
                  <c:v>95.057147000000001</c:v>
                </c:pt>
                <c:pt idx="491">
                  <c:v>95.159569000000005</c:v>
                </c:pt>
                <c:pt idx="492">
                  <c:v>95.264358999999999</c:v>
                </c:pt>
                <c:pt idx="493">
                  <c:v>95.370983999999979</c:v>
                </c:pt>
                <c:pt idx="494">
                  <c:v>95.478300000000004</c:v>
                </c:pt>
                <c:pt idx="495">
                  <c:v>95.586122000000003</c:v>
                </c:pt>
                <c:pt idx="496">
                  <c:v>95.694664000000003</c:v>
                </c:pt>
                <c:pt idx="497">
                  <c:v>95.803197999999981</c:v>
                </c:pt>
                <c:pt idx="498">
                  <c:v>95.913189000000003</c:v>
                </c:pt>
                <c:pt idx="499">
                  <c:v>96.033641000000003</c:v>
                </c:pt>
                <c:pt idx="500">
                  <c:v>96.170388999999872</c:v>
                </c:pt>
                <c:pt idx="501">
                  <c:v>96.303061</c:v>
                </c:pt>
                <c:pt idx="502">
                  <c:v>96.404233000000005</c:v>
                </c:pt>
                <c:pt idx="503">
                  <c:v>96.485283999999993</c:v>
                </c:pt>
                <c:pt idx="504">
                  <c:v>96.573220000000006</c:v>
                </c:pt>
                <c:pt idx="505">
                  <c:v>96.664401999999981</c:v>
                </c:pt>
                <c:pt idx="506">
                  <c:v>96.744107</c:v>
                </c:pt>
                <c:pt idx="507">
                  <c:v>96.813495000000003</c:v>
                </c:pt>
                <c:pt idx="508">
                  <c:v>96.881676999999982</c:v>
                </c:pt>
                <c:pt idx="509">
                  <c:v>96.961350999999993</c:v>
                </c:pt>
                <c:pt idx="510">
                  <c:v>97.055157999999977</c:v>
                </c:pt>
                <c:pt idx="511">
                  <c:v>97.134957999999983</c:v>
                </c:pt>
                <c:pt idx="512">
                  <c:v>97.174496999999946</c:v>
                </c:pt>
                <c:pt idx="513">
                  <c:v>97.193924999999993</c:v>
                </c:pt>
                <c:pt idx="514">
                  <c:v>97.232512999999983</c:v>
                </c:pt>
                <c:pt idx="515">
                  <c:v>97.305336999999895</c:v>
                </c:pt>
                <c:pt idx="516">
                  <c:v>97.395578999999927</c:v>
                </c:pt>
                <c:pt idx="517">
                  <c:v>97.477350999999999</c:v>
                </c:pt>
                <c:pt idx="518">
                  <c:v>97.562594000000004</c:v>
                </c:pt>
                <c:pt idx="519">
                  <c:v>97.678666999999976</c:v>
                </c:pt>
                <c:pt idx="520">
                  <c:v>97.784923000000006</c:v>
                </c:pt>
                <c:pt idx="521">
                  <c:v>97.81809699999998</c:v>
                </c:pt>
                <c:pt idx="522">
                  <c:v>97.810232999999982</c:v>
                </c:pt>
                <c:pt idx="523">
                  <c:v>97.833017999999981</c:v>
                </c:pt>
                <c:pt idx="524">
                  <c:v>97.896380999999977</c:v>
                </c:pt>
                <c:pt idx="525">
                  <c:v>97.967903000000007</c:v>
                </c:pt>
                <c:pt idx="526">
                  <c:v>98.030479</c:v>
                </c:pt>
                <c:pt idx="527">
                  <c:v>98.094762000000003</c:v>
                </c:pt>
                <c:pt idx="528">
                  <c:v>98.165346999999912</c:v>
                </c:pt>
                <c:pt idx="529">
                  <c:v>98.226850999999982</c:v>
                </c:pt>
                <c:pt idx="530">
                  <c:v>98.276269999999997</c:v>
                </c:pt>
                <c:pt idx="531">
                  <c:v>98.322977999999893</c:v>
                </c:pt>
                <c:pt idx="532">
                  <c:v>98.360568000000001</c:v>
                </c:pt>
                <c:pt idx="533">
                  <c:v>98.387576999999979</c:v>
                </c:pt>
                <c:pt idx="534">
                  <c:v>98.430203000000006</c:v>
                </c:pt>
                <c:pt idx="535">
                  <c:v>98.504962000000006</c:v>
                </c:pt>
                <c:pt idx="536">
                  <c:v>98.576284000000001</c:v>
                </c:pt>
                <c:pt idx="537">
                  <c:v>98.592885999999979</c:v>
                </c:pt>
                <c:pt idx="538">
                  <c:v>98.56603699999998</c:v>
                </c:pt>
                <c:pt idx="539">
                  <c:v>98.548730000000006</c:v>
                </c:pt>
                <c:pt idx="540">
                  <c:v>98.568834999999979</c:v>
                </c:pt>
                <c:pt idx="541">
                  <c:v>98.62394399999998</c:v>
                </c:pt>
                <c:pt idx="542">
                  <c:v>98.690669</c:v>
                </c:pt>
                <c:pt idx="543">
                  <c:v>98.743089999999995</c:v>
                </c:pt>
                <c:pt idx="544">
                  <c:v>98.771945000000002</c:v>
                </c:pt>
                <c:pt idx="545">
                  <c:v>98.770296999999999</c:v>
                </c:pt>
                <c:pt idx="546">
                  <c:v>98.745596000000006</c:v>
                </c:pt>
                <c:pt idx="547">
                  <c:v>98.726180999999983</c:v>
                </c:pt>
                <c:pt idx="548">
                  <c:v>98.721494000000007</c:v>
                </c:pt>
                <c:pt idx="549">
                  <c:v>98.724322999999998</c:v>
                </c:pt>
                <c:pt idx="550">
                  <c:v>98.739752999999979</c:v>
                </c:pt>
                <c:pt idx="551">
                  <c:v>98.778092999999927</c:v>
                </c:pt>
                <c:pt idx="552">
                  <c:v>98.836455999999998</c:v>
                </c:pt>
                <c:pt idx="553">
                  <c:v>98.887181999999981</c:v>
                </c:pt>
                <c:pt idx="554">
                  <c:v>98.896247000000002</c:v>
                </c:pt>
                <c:pt idx="555">
                  <c:v>98.870681999999945</c:v>
                </c:pt>
                <c:pt idx="556">
                  <c:v>98.849057999999999</c:v>
                </c:pt>
                <c:pt idx="557">
                  <c:v>98.848056</c:v>
                </c:pt>
                <c:pt idx="558">
                  <c:v>98.86010899999998</c:v>
                </c:pt>
                <c:pt idx="559">
                  <c:v>98.882511999999977</c:v>
                </c:pt>
                <c:pt idx="560">
                  <c:v>98.923105000000007</c:v>
                </c:pt>
                <c:pt idx="561">
                  <c:v>98.978420999999983</c:v>
                </c:pt>
                <c:pt idx="562">
                  <c:v>99.014224999999996</c:v>
                </c:pt>
                <c:pt idx="563">
                  <c:v>99.005253999999994</c:v>
                </c:pt>
                <c:pt idx="564">
                  <c:v>98.978878999999893</c:v>
                </c:pt>
                <c:pt idx="565">
                  <c:v>98.966295000000002</c:v>
                </c:pt>
                <c:pt idx="566">
                  <c:v>98.96293799999998</c:v>
                </c:pt>
                <c:pt idx="567">
                  <c:v>98.961445999999995</c:v>
                </c:pt>
                <c:pt idx="568">
                  <c:v>98.968419999999995</c:v>
                </c:pt>
                <c:pt idx="569">
                  <c:v>98.987849999999995</c:v>
                </c:pt>
                <c:pt idx="570">
                  <c:v>99.011187000000007</c:v>
                </c:pt>
                <c:pt idx="571">
                  <c:v>99.021991</c:v>
                </c:pt>
                <c:pt idx="572">
                  <c:v>99.017632000000006</c:v>
                </c:pt>
                <c:pt idx="573">
                  <c:v>99.014384000000007</c:v>
                </c:pt>
                <c:pt idx="574">
                  <c:v>99.022824</c:v>
                </c:pt>
                <c:pt idx="575">
                  <c:v>99.041045999999994</c:v>
                </c:pt>
                <c:pt idx="576">
                  <c:v>99.062995999999998</c:v>
                </c:pt>
                <c:pt idx="577">
                  <c:v>99.081439000000003</c:v>
                </c:pt>
                <c:pt idx="578">
                  <c:v>99.099121999999994</c:v>
                </c:pt>
                <c:pt idx="579">
                  <c:v>99.127101999999979</c:v>
                </c:pt>
                <c:pt idx="580">
                  <c:v>99.167474999999982</c:v>
                </c:pt>
                <c:pt idx="581">
                  <c:v>99.210015999999996</c:v>
                </c:pt>
                <c:pt idx="582">
                  <c:v>99.236386999999979</c:v>
                </c:pt>
                <c:pt idx="583">
                  <c:v>99.237271000000007</c:v>
                </c:pt>
                <c:pt idx="584">
                  <c:v>99.229979</c:v>
                </c:pt>
                <c:pt idx="585">
                  <c:v>99.235101</c:v>
                </c:pt>
                <c:pt idx="586">
                  <c:v>99.251023000000004</c:v>
                </c:pt>
                <c:pt idx="587">
                  <c:v>99.267213999999996</c:v>
                </c:pt>
                <c:pt idx="588">
                  <c:v>99.279695000000004</c:v>
                </c:pt>
                <c:pt idx="589">
                  <c:v>99.289537999999979</c:v>
                </c:pt>
                <c:pt idx="590">
                  <c:v>99.302830999999927</c:v>
                </c:pt>
                <c:pt idx="591">
                  <c:v>99.324709999999982</c:v>
                </c:pt>
                <c:pt idx="592">
                  <c:v>99.344758999999982</c:v>
                </c:pt>
                <c:pt idx="593">
                  <c:v>99.347055999999995</c:v>
                </c:pt>
                <c:pt idx="594">
                  <c:v>99.336551</c:v>
                </c:pt>
                <c:pt idx="595">
                  <c:v>99.330904000000004</c:v>
                </c:pt>
                <c:pt idx="596">
                  <c:v>99.333511999999999</c:v>
                </c:pt>
                <c:pt idx="597">
                  <c:v>99.334756999999982</c:v>
                </c:pt>
                <c:pt idx="598">
                  <c:v>99.330134000000001</c:v>
                </c:pt>
                <c:pt idx="599">
                  <c:v>99.324506</c:v>
                </c:pt>
                <c:pt idx="600">
                  <c:v>99.323056999999977</c:v>
                </c:pt>
                <c:pt idx="601">
                  <c:v>99.324681999999981</c:v>
                </c:pt>
                <c:pt idx="602">
                  <c:v>99.324309999999983</c:v>
                </c:pt>
                <c:pt idx="603">
                  <c:v>99.319964999999996</c:v>
                </c:pt>
                <c:pt idx="604">
                  <c:v>99.314830999999998</c:v>
                </c:pt>
                <c:pt idx="605">
                  <c:v>99.311700000000002</c:v>
                </c:pt>
                <c:pt idx="606">
                  <c:v>99.310114999999996</c:v>
                </c:pt>
                <c:pt idx="607">
                  <c:v>99.310676999999998</c:v>
                </c:pt>
                <c:pt idx="608">
                  <c:v>99.315465000000003</c:v>
                </c:pt>
                <c:pt idx="609">
                  <c:v>99.322339999999912</c:v>
                </c:pt>
                <c:pt idx="610">
                  <c:v>99.327151999999998</c:v>
                </c:pt>
                <c:pt idx="611">
                  <c:v>99.328311999999912</c:v>
                </c:pt>
                <c:pt idx="612">
                  <c:v>99.322959999999981</c:v>
                </c:pt>
                <c:pt idx="613">
                  <c:v>99.310530999999983</c:v>
                </c:pt>
                <c:pt idx="614">
                  <c:v>99.298817</c:v>
                </c:pt>
                <c:pt idx="615">
                  <c:v>99.293801000000002</c:v>
                </c:pt>
                <c:pt idx="616">
                  <c:v>99.293841</c:v>
                </c:pt>
                <c:pt idx="617">
                  <c:v>99.299881999999982</c:v>
                </c:pt>
                <c:pt idx="618">
                  <c:v>99.313590000000005</c:v>
                </c:pt>
                <c:pt idx="619">
                  <c:v>99.323067999999978</c:v>
                </c:pt>
                <c:pt idx="620">
                  <c:v>99.314194999999998</c:v>
                </c:pt>
                <c:pt idx="621">
                  <c:v>99.29383799999998</c:v>
                </c:pt>
                <c:pt idx="622">
                  <c:v>99.277827000000002</c:v>
                </c:pt>
                <c:pt idx="623">
                  <c:v>99.269452000000001</c:v>
                </c:pt>
                <c:pt idx="624">
                  <c:v>99.264629999999997</c:v>
                </c:pt>
                <c:pt idx="625">
                  <c:v>99.261688000000007</c:v>
                </c:pt>
                <c:pt idx="626">
                  <c:v>99.259979999999999</c:v>
                </c:pt>
                <c:pt idx="627">
                  <c:v>99.257893999999993</c:v>
                </c:pt>
                <c:pt idx="628">
                  <c:v>99.255044999999981</c:v>
                </c:pt>
                <c:pt idx="629">
                  <c:v>99.254231000000004</c:v>
                </c:pt>
                <c:pt idx="630">
                  <c:v>99.25913199999998</c:v>
                </c:pt>
                <c:pt idx="631">
                  <c:v>99.267645999999999</c:v>
                </c:pt>
                <c:pt idx="632">
                  <c:v>99.269924000000003</c:v>
                </c:pt>
                <c:pt idx="633">
                  <c:v>99.260553999999999</c:v>
                </c:pt>
                <c:pt idx="634">
                  <c:v>99.247097999999994</c:v>
                </c:pt>
                <c:pt idx="635">
                  <c:v>99.238202000000001</c:v>
                </c:pt>
                <c:pt idx="636">
                  <c:v>99.233611999999994</c:v>
                </c:pt>
                <c:pt idx="637">
                  <c:v>99.229830999999976</c:v>
                </c:pt>
                <c:pt idx="638">
                  <c:v>99.226017999999982</c:v>
                </c:pt>
                <c:pt idx="639">
                  <c:v>99.223075999999978</c:v>
                </c:pt>
                <c:pt idx="640">
                  <c:v>99.221650999999994</c:v>
                </c:pt>
                <c:pt idx="641">
                  <c:v>99.222097999999946</c:v>
                </c:pt>
                <c:pt idx="642">
                  <c:v>99.223441999999977</c:v>
                </c:pt>
                <c:pt idx="643">
                  <c:v>99.222409999999982</c:v>
                </c:pt>
                <c:pt idx="644">
                  <c:v>99.217538000000005</c:v>
                </c:pt>
                <c:pt idx="645">
                  <c:v>99.211144000000004</c:v>
                </c:pt>
                <c:pt idx="646">
                  <c:v>99.205222000000006</c:v>
                </c:pt>
                <c:pt idx="647">
                  <c:v>99.200435999999982</c:v>
                </c:pt>
                <c:pt idx="648">
                  <c:v>99.197552999999999</c:v>
                </c:pt>
                <c:pt idx="649">
                  <c:v>99.196100000000001</c:v>
                </c:pt>
                <c:pt idx="650">
                  <c:v>99.194303000000005</c:v>
                </c:pt>
                <c:pt idx="651">
                  <c:v>99.191642000000002</c:v>
                </c:pt>
                <c:pt idx="652">
                  <c:v>99.188949999999977</c:v>
                </c:pt>
                <c:pt idx="653">
                  <c:v>99.186010999999979</c:v>
                </c:pt>
                <c:pt idx="654">
                  <c:v>99.182175999999927</c:v>
                </c:pt>
                <c:pt idx="655">
                  <c:v>99.179785999999893</c:v>
                </c:pt>
                <c:pt idx="656">
                  <c:v>99.182150999999976</c:v>
                </c:pt>
                <c:pt idx="657">
                  <c:v>99.186154000000002</c:v>
                </c:pt>
                <c:pt idx="658">
                  <c:v>99.184816999999981</c:v>
                </c:pt>
                <c:pt idx="659">
                  <c:v>99.178254999999979</c:v>
                </c:pt>
                <c:pt idx="660">
                  <c:v>99.171383999999946</c:v>
                </c:pt>
                <c:pt idx="661">
                  <c:v>99.165084999999976</c:v>
                </c:pt>
                <c:pt idx="662">
                  <c:v>99.158745999999894</c:v>
                </c:pt>
                <c:pt idx="663">
                  <c:v>99.153793999999976</c:v>
                </c:pt>
                <c:pt idx="664">
                  <c:v>99.15085999999998</c:v>
                </c:pt>
                <c:pt idx="665">
                  <c:v>99.148732999999865</c:v>
                </c:pt>
                <c:pt idx="666">
                  <c:v>99.146310999999983</c:v>
                </c:pt>
                <c:pt idx="667">
                  <c:v>99.144015999999993</c:v>
                </c:pt>
                <c:pt idx="668">
                  <c:v>99.143502999999981</c:v>
                </c:pt>
                <c:pt idx="669">
                  <c:v>99.145156</c:v>
                </c:pt>
                <c:pt idx="670">
                  <c:v>99.145591999999979</c:v>
                </c:pt>
                <c:pt idx="671">
                  <c:v>99.141095000000007</c:v>
                </c:pt>
                <c:pt idx="672">
                  <c:v>99.13344499999998</c:v>
                </c:pt>
                <c:pt idx="673">
                  <c:v>99.127001999999976</c:v>
                </c:pt>
                <c:pt idx="674">
                  <c:v>99.122526999999977</c:v>
                </c:pt>
                <c:pt idx="675">
                  <c:v>99.118668999999983</c:v>
                </c:pt>
                <c:pt idx="676">
                  <c:v>99.115133</c:v>
                </c:pt>
                <c:pt idx="677">
                  <c:v>99.111902000000001</c:v>
                </c:pt>
                <c:pt idx="678">
                  <c:v>99.108913000000001</c:v>
                </c:pt>
                <c:pt idx="679">
                  <c:v>99.10643099999993</c:v>
                </c:pt>
                <c:pt idx="680">
                  <c:v>99.104190000000003</c:v>
                </c:pt>
                <c:pt idx="681">
                  <c:v>99.101680000000002</c:v>
                </c:pt>
                <c:pt idx="682">
                  <c:v>99.099016000000006</c:v>
                </c:pt>
                <c:pt idx="683">
                  <c:v>99.09633599999998</c:v>
                </c:pt>
                <c:pt idx="684">
                  <c:v>99.093684999999994</c:v>
                </c:pt>
                <c:pt idx="685">
                  <c:v>99.091267000000002</c:v>
                </c:pt>
                <c:pt idx="686">
                  <c:v>99.088605000000001</c:v>
                </c:pt>
                <c:pt idx="687">
                  <c:v>99.084770999999975</c:v>
                </c:pt>
                <c:pt idx="688">
                  <c:v>99.080089999999998</c:v>
                </c:pt>
                <c:pt idx="689">
                  <c:v>99.076151999999979</c:v>
                </c:pt>
                <c:pt idx="690">
                  <c:v>99.07357099999993</c:v>
                </c:pt>
                <c:pt idx="691">
                  <c:v>99.071304999999981</c:v>
                </c:pt>
                <c:pt idx="692">
                  <c:v>99.068806999999978</c:v>
                </c:pt>
                <c:pt idx="693">
                  <c:v>99.066765000000004</c:v>
                </c:pt>
                <c:pt idx="694">
                  <c:v>99.065385999999975</c:v>
                </c:pt>
                <c:pt idx="695">
                  <c:v>99.063526999999993</c:v>
                </c:pt>
                <c:pt idx="696">
                  <c:v>99.059843999999998</c:v>
                </c:pt>
                <c:pt idx="697">
                  <c:v>99.054767999999981</c:v>
                </c:pt>
                <c:pt idx="698">
                  <c:v>99.050044</c:v>
                </c:pt>
                <c:pt idx="699">
                  <c:v>99.046119000000004</c:v>
                </c:pt>
                <c:pt idx="700">
                  <c:v>99.042361</c:v>
                </c:pt>
                <c:pt idx="701">
                  <c:v>99.038813000000005</c:v>
                </c:pt>
                <c:pt idx="702">
                  <c:v>99.035562999999982</c:v>
                </c:pt>
                <c:pt idx="703">
                  <c:v>99.03230499999998</c:v>
                </c:pt>
                <c:pt idx="704">
                  <c:v>99.029184000000001</c:v>
                </c:pt>
                <c:pt idx="705">
                  <c:v>99.026297999999983</c:v>
                </c:pt>
                <c:pt idx="706">
                  <c:v>99.023204000000007</c:v>
                </c:pt>
                <c:pt idx="707">
                  <c:v>99.020054000000002</c:v>
                </c:pt>
                <c:pt idx="708">
                  <c:v>99.017424000000005</c:v>
                </c:pt>
                <c:pt idx="709">
                  <c:v>99.014493000000002</c:v>
                </c:pt>
                <c:pt idx="710">
                  <c:v>99.010047</c:v>
                </c:pt>
                <c:pt idx="711">
                  <c:v>99.004827000000006</c:v>
                </c:pt>
                <c:pt idx="712">
                  <c:v>99.000219000000001</c:v>
                </c:pt>
                <c:pt idx="713">
                  <c:v>98.996246999999997</c:v>
                </c:pt>
                <c:pt idx="714">
                  <c:v>98.992549999999994</c:v>
                </c:pt>
                <c:pt idx="715">
                  <c:v>98.989189999999994</c:v>
                </c:pt>
                <c:pt idx="716">
                  <c:v>98.986092999999983</c:v>
                </c:pt>
                <c:pt idx="717">
                  <c:v>98.983006000000003</c:v>
                </c:pt>
                <c:pt idx="718">
                  <c:v>98.97971699999998</c:v>
                </c:pt>
                <c:pt idx="719">
                  <c:v>98.976194000000007</c:v>
                </c:pt>
                <c:pt idx="720">
                  <c:v>98.97280199999993</c:v>
                </c:pt>
                <c:pt idx="721">
                  <c:v>98.969701999999998</c:v>
                </c:pt>
                <c:pt idx="722">
                  <c:v>98.966303999999994</c:v>
                </c:pt>
                <c:pt idx="723">
                  <c:v>98.962159999999997</c:v>
                </c:pt>
                <c:pt idx="724">
                  <c:v>98.957713999999996</c:v>
                </c:pt>
                <c:pt idx="725">
                  <c:v>98.953642000000002</c:v>
                </c:pt>
                <c:pt idx="726">
                  <c:v>98.950091999999998</c:v>
                </c:pt>
                <c:pt idx="727">
                  <c:v>98.946714999999998</c:v>
                </c:pt>
                <c:pt idx="728">
                  <c:v>98.943149000000005</c:v>
                </c:pt>
                <c:pt idx="729">
                  <c:v>98.939571000000001</c:v>
                </c:pt>
                <c:pt idx="730">
                  <c:v>98.936453</c:v>
                </c:pt>
                <c:pt idx="731">
                  <c:v>98.933678999999998</c:v>
                </c:pt>
                <c:pt idx="732">
                  <c:v>98.930706999999998</c:v>
                </c:pt>
                <c:pt idx="733">
                  <c:v>98.927485000000004</c:v>
                </c:pt>
                <c:pt idx="734">
                  <c:v>98.924267999999998</c:v>
                </c:pt>
                <c:pt idx="735">
                  <c:v>98.921097000000003</c:v>
                </c:pt>
                <c:pt idx="736">
                  <c:v>98.91798</c:v>
                </c:pt>
                <c:pt idx="737">
                  <c:v>98.914625999999998</c:v>
                </c:pt>
                <c:pt idx="738">
                  <c:v>98.910414000000003</c:v>
                </c:pt>
                <c:pt idx="739">
                  <c:v>98.905522000000005</c:v>
                </c:pt>
                <c:pt idx="740">
                  <c:v>98.900976</c:v>
                </c:pt>
                <c:pt idx="741">
                  <c:v>98.897138999999981</c:v>
                </c:pt>
                <c:pt idx="742">
                  <c:v>98.893355999999983</c:v>
                </c:pt>
                <c:pt idx="743">
                  <c:v>98.889123999999995</c:v>
                </c:pt>
                <c:pt idx="744">
                  <c:v>98.884780999999975</c:v>
                </c:pt>
                <c:pt idx="745">
                  <c:v>98.881069999999994</c:v>
                </c:pt>
                <c:pt idx="746">
                  <c:v>98.878298999999927</c:v>
                </c:pt>
                <c:pt idx="747">
                  <c:v>98.875839999999911</c:v>
                </c:pt>
                <c:pt idx="748">
                  <c:v>98.872757999999891</c:v>
                </c:pt>
                <c:pt idx="749">
                  <c:v>98.869065000000006</c:v>
                </c:pt>
                <c:pt idx="750">
                  <c:v>98.865553000000006</c:v>
                </c:pt>
                <c:pt idx="751">
                  <c:v>98.862335999999928</c:v>
                </c:pt>
                <c:pt idx="752">
                  <c:v>98.858921999999978</c:v>
                </c:pt>
                <c:pt idx="753">
                  <c:v>98.855270999999931</c:v>
                </c:pt>
                <c:pt idx="754">
                  <c:v>98.851557</c:v>
                </c:pt>
                <c:pt idx="755">
                  <c:v>98.847913000000005</c:v>
                </c:pt>
                <c:pt idx="756">
                  <c:v>98.844762000000003</c:v>
                </c:pt>
                <c:pt idx="757">
                  <c:v>98.842142999999979</c:v>
                </c:pt>
                <c:pt idx="758">
                  <c:v>98.839196999999999</c:v>
                </c:pt>
                <c:pt idx="759">
                  <c:v>98.835364999999982</c:v>
                </c:pt>
                <c:pt idx="760">
                  <c:v>98.831320000000005</c:v>
                </c:pt>
                <c:pt idx="761">
                  <c:v>98.827810999999983</c:v>
                </c:pt>
                <c:pt idx="762">
                  <c:v>98.824697</c:v>
                </c:pt>
                <c:pt idx="763">
                  <c:v>98.821719999999999</c:v>
                </c:pt>
                <c:pt idx="764">
                  <c:v>98.818869000000007</c:v>
                </c:pt>
                <c:pt idx="765">
                  <c:v>98.816062000000002</c:v>
                </c:pt>
                <c:pt idx="766">
                  <c:v>98.813435999999982</c:v>
                </c:pt>
                <c:pt idx="767">
                  <c:v>98.811158000000006</c:v>
                </c:pt>
                <c:pt idx="768">
                  <c:v>98.808977999999911</c:v>
                </c:pt>
                <c:pt idx="769">
                  <c:v>98.806625999999994</c:v>
                </c:pt>
                <c:pt idx="770">
                  <c:v>98.803916999999998</c:v>
                </c:pt>
                <c:pt idx="771">
                  <c:v>98.800433999999981</c:v>
                </c:pt>
                <c:pt idx="772">
                  <c:v>98.796125000000004</c:v>
                </c:pt>
                <c:pt idx="773">
                  <c:v>98.79203099999998</c:v>
                </c:pt>
                <c:pt idx="774">
                  <c:v>98.789179000000004</c:v>
                </c:pt>
                <c:pt idx="775">
                  <c:v>98.786927000000006</c:v>
                </c:pt>
                <c:pt idx="776">
                  <c:v>98.784007000000003</c:v>
                </c:pt>
                <c:pt idx="777">
                  <c:v>98.780462</c:v>
                </c:pt>
                <c:pt idx="778">
                  <c:v>98.777079000000001</c:v>
                </c:pt>
                <c:pt idx="779">
                  <c:v>98.774101000000002</c:v>
                </c:pt>
                <c:pt idx="780">
                  <c:v>98.77149799999998</c:v>
                </c:pt>
                <c:pt idx="781">
                  <c:v>98.769309000000007</c:v>
                </c:pt>
                <c:pt idx="782">
                  <c:v>98.767232000000007</c:v>
                </c:pt>
                <c:pt idx="783">
                  <c:v>98.764993000000004</c:v>
                </c:pt>
                <c:pt idx="784">
                  <c:v>98.762866000000002</c:v>
                </c:pt>
                <c:pt idx="785">
                  <c:v>98.760631000000004</c:v>
                </c:pt>
                <c:pt idx="786">
                  <c:v>98.757542999999998</c:v>
                </c:pt>
                <c:pt idx="787">
                  <c:v>98.754007000000001</c:v>
                </c:pt>
                <c:pt idx="788">
                  <c:v>98.750957</c:v>
                </c:pt>
                <c:pt idx="789">
                  <c:v>98.748251999999994</c:v>
                </c:pt>
                <c:pt idx="790">
                  <c:v>98.745549999999994</c:v>
                </c:pt>
                <c:pt idx="791">
                  <c:v>98.743056999999993</c:v>
                </c:pt>
                <c:pt idx="792">
                  <c:v>98.740875000000003</c:v>
                </c:pt>
                <c:pt idx="793">
                  <c:v>98.738894000000002</c:v>
                </c:pt>
                <c:pt idx="794">
                  <c:v>98.736868999999999</c:v>
                </c:pt>
                <c:pt idx="795">
                  <c:v>98.734380999999999</c:v>
                </c:pt>
                <c:pt idx="796">
                  <c:v>98.731364999999997</c:v>
                </c:pt>
                <c:pt idx="797">
                  <c:v>98.728380999999928</c:v>
                </c:pt>
                <c:pt idx="798">
                  <c:v>98.725962999999979</c:v>
                </c:pt>
                <c:pt idx="799">
                  <c:v>98.723870000000005</c:v>
                </c:pt>
                <c:pt idx="800">
                  <c:v>98.721477999999976</c:v>
                </c:pt>
                <c:pt idx="801">
                  <c:v>98.718777999999929</c:v>
                </c:pt>
                <c:pt idx="802">
                  <c:v>98.716241999999994</c:v>
                </c:pt>
                <c:pt idx="803">
                  <c:v>98.714054000000004</c:v>
                </c:pt>
                <c:pt idx="804">
                  <c:v>98.712080999999998</c:v>
                </c:pt>
                <c:pt idx="805">
                  <c:v>98.710397999999998</c:v>
                </c:pt>
                <c:pt idx="806">
                  <c:v>98.709309000000005</c:v>
                </c:pt>
                <c:pt idx="807">
                  <c:v>98.708613</c:v>
                </c:pt>
                <c:pt idx="808">
                  <c:v>98.707377999999977</c:v>
                </c:pt>
                <c:pt idx="809">
                  <c:v>98.704994999999997</c:v>
                </c:pt>
                <c:pt idx="810">
                  <c:v>98.702084999999983</c:v>
                </c:pt>
                <c:pt idx="811">
                  <c:v>98.69979799999993</c:v>
                </c:pt>
                <c:pt idx="812">
                  <c:v>98.698431999999912</c:v>
                </c:pt>
                <c:pt idx="813">
                  <c:v>98.697344000000001</c:v>
                </c:pt>
                <c:pt idx="814">
                  <c:v>98.696028999999982</c:v>
                </c:pt>
                <c:pt idx="815">
                  <c:v>98.694519</c:v>
                </c:pt>
                <c:pt idx="816">
                  <c:v>98.692844999999977</c:v>
                </c:pt>
                <c:pt idx="817">
                  <c:v>98.690748999999911</c:v>
                </c:pt>
                <c:pt idx="818">
                  <c:v>98.688185999999931</c:v>
                </c:pt>
                <c:pt idx="819">
                  <c:v>98.685620999999998</c:v>
                </c:pt>
                <c:pt idx="820">
                  <c:v>98.683419999999998</c:v>
                </c:pt>
                <c:pt idx="821">
                  <c:v>98.681697</c:v>
                </c:pt>
                <c:pt idx="822">
                  <c:v>98.680888999999866</c:v>
                </c:pt>
                <c:pt idx="823">
                  <c:v>98.681174999999982</c:v>
                </c:pt>
                <c:pt idx="824">
                  <c:v>98.681391999999946</c:v>
                </c:pt>
                <c:pt idx="825">
                  <c:v>98.680275999999978</c:v>
                </c:pt>
                <c:pt idx="826">
                  <c:v>98.678395999999893</c:v>
                </c:pt>
                <c:pt idx="827">
                  <c:v>98.677017999999975</c:v>
                </c:pt>
                <c:pt idx="828">
                  <c:v>98.676025999999979</c:v>
                </c:pt>
                <c:pt idx="829">
                  <c:v>98.674490999999946</c:v>
                </c:pt>
                <c:pt idx="830">
                  <c:v>98.672357999999875</c:v>
                </c:pt>
                <c:pt idx="831">
                  <c:v>98.670510999999976</c:v>
                </c:pt>
                <c:pt idx="832">
                  <c:v>98.669369000000003</c:v>
                </c:pt>
                <c:pt idx="833">
                  <c:v>98.668343999999976</c:v>
                </c:pt>
                <c:pt idx="834">
                  <c:v>98.667037999999977</c:v>
                </c:pt>
                <c:pt idx="835">
                  <c:v>98.665690999999981</c:v>
                </c:pt>
                <c:pt idx="836">
                  <c:v>98.664074999999983</c:v>
                </c:pt>
                <c:pt idx="837">
                  <c:v>98.661757999999978</c:v>
                </c:pt>
                <c:pt idx="838">
                  <c:v>98.659636999999975</c:v>
                </c:pt>
                <c:pt idx="839">
                  <c:v>98.658952999999912</c:v>
                </c:pt>
                <c:pt idx="840">
                  <c:v>98.659051999999946</c:v>
                </c:pt>
                <c:pt idx="841">
                  <c:v>98.658417999999926</c:v>
                </c:pt>
                <c:pt idx="842">
                  <c:v>98.656953999999999</c:v>
                </c:pt>
                <c:pt idx="843">
                  <c:v>98.655298999999928</c:v>
                </c:pt>
                <c:pt idx="844">
                  <c:v>98.653551999999976</c:v>
                </c:pt>
                <c:pt idx="845">
                  <c:v>98.651674</c:v>
                </c:pt>
                <c:pt idx="846">
                  <c:v>98.649751999999978</c:v>
                </c:pt>
                <c:pt idx="847">
                  <c:v>98.647930000000002</c:v>
                </c:pt>
                <c:pt idx="848">
                  <c:v>98.646686000000003</c:v>
                </c:pt>
                <c:pt idx="849">
                  <c:v>98.646595000000005</c:v>
                </c:pt>
                <c:pt idx="850">
                  <c:v>98.647424000000001</c:v>
                </c:pt>
                <c:pt idx="851">
                  <c:v>98.648086999999975</c:v>
                </c:pt>
                <c:pt idx="852">
                  <c:v>98.648106999999982</c:v>
                </c:pt>
                <c:pt idx="853">
                  <c:v>98.648358999999928</c:v>
                </c:pt>
                <c:pt idx="854">
                  <c:v>98.649799999999999</c:v>
                </c:pt>
                <c:pt idx="855">
                  <c:v>98.652497999999895</c:v>
                </c:pt>
                <c:pt idx="856">
                  <c:v>98.656318999999911</c:v>
                </c:pt>
                <c:pt idx="857">
                  <c:v>98.661518999999998</c:v>
                </c:pt>
                <c:pt idx="858">
                  <c:v>98.668389999999945</c:v>
                </c:pt>
                <c:pt idx="859">
                  <c:v>98.677047999999928</c:v>
                </c:pt>
                <c:pt idx="860">
                  <c:v>98.687906999999981</c:v>
                </c:pt>
                <c:pt idx="861">
                  <c:v>98.701766000000006</c:v>
                </c:pt>
                <c:pt idx="862">
                  <c:v>98.719082999999998</c:v>
                </c:pt>
                <c:pt idx="863">
                  <c:v>98.739945000000006</c:v>
                </c:pt>
                <c:pt idx="864">
                  <c:v>98.764713999999998</c:v>
                </c:pt>
                <c:pt idx="865">
                  <c:v>98.793473000000006</c:v>
                </c:pt>
                <c:pt idx="866">
                  <c:v>98.825456999999929</c:v>
                </c:pt>
                <c:pt idx="867">
                  <c:v>98.859679</c:v>
                </c:pt>
                <c:pt idx="868">
                  <c:v>98.894992999999999</c:v>
                </c:pt>
                <c:pt idx="869">
                  <c:v>98.930104999999998</c:v>
                </c:pt>
                <c:pt idx="870">
                  <c:v>98.964091999999994</c:v>
                </c:pt>
                <c:pt idx="871">
                  <c:v>98.995424999999997</c:v>
                </c:pt>
                <c:pt idx="872">
                  <c:v>99.021371999999928</c:v>
                </c:pt>
                <c:pt idx="873">
                  <c:v>99.039445999999998</c:v>
                </c:pt>
                <c:pt idx="874">
                  <c:v>99.047944999999999</c:v>
                </c:pt>
                <c:pt idx="875">
                  <c:v>99.045199999999994</c:v>
                </c:pt>
                <c:pt idx="876">
                  <c:v>99.02852</c:v>
                </c:pt>
                <c:pt idx="877">
                  <c:v>98.993465999999998</c:v>
                </c:pt>
                <c:pt idx="878">
                  <c:v>98.936249000000004</c:v>
                </c:pt>
                <c:pt idx="879">
                  <c:v>98.861327000000003</c:v>
                </c:pt>
                <c:pt idx="880">
                  <c:v>98.792535999999998</c:v>
                </c:pt>
                <c:pt idx="881">
                  <c:v>98.769216999999998</c:v>
                </c:pt>
                <c:pt idx="882">
                  <c:v>98.813518000000002</c:v>
                </c:pt>
                <c:pt idx="883">
                  <c:v>98.906783000000004</c:v>
                </c:pt>
                <c:pt idx="884">
                  <c:v>99.010568000000006</c:v>
                </c:pt>
                <c:pt idx="885">
                  <c:v>99.098495</c:v>
                </c:pt>
                <c:pt idx="886">
                  <c:v>99.160263</c:v>
                </c:pt>
                <c:pt idx="887">
                  <c:v>99.191726000000003</c:v>
                </c:pt>
                <c:pt idx="888">
                  <c:v>99.19137199999993</c:v>
                </c:pt>
                <c:pt idx="889">
                  <c:v>99.161162000000004</c:v>
                </c:pt>
                <c:pt idx="890">
                  <c:v>99.105897999999911</c:v>
                </c:pt>
                <c:pt idx="891">
                  <c:v>99.031857000000002</c:v>
                </c:pt>
                <c:pt idx="892">
                  <c:v>98.946928999999997</c:v>
                </c:pt>
                <c:pt idx="893">
                  <c:v>98.860123000000002</c:v>
                </c:pt>
                <c:pt idx="894">
                  <c:v>98.779263999999998</c:v>
                </c:pt>
                <c:pt idx="895">
                  <c:v>98.709513000000001</c:v>
                </c:pt>
                <c:pt idx="896">
                  <c:v>98.653274999999979</c:v>
                </c:pt>
                <c:pt idx="897">
                  <c:v>98.610821999999999</c:v>
                </c:pt>
                <c:pt idx="898">
                  <c:v>98.581316999999999</c:v>
                </c:pt>
                <c:pt idx="899">
                  <c:v>98.562798999999927</c:v>
                </c:pt>
                <c:pt idx="900">
                  <c:v>98.552098999999927</c:v>
                </c:pt>
                <c:pt idx="901">
                  <c:v>98.545983000000007</c:v>
                </c:pt>
                <c:pt idx="902">
                  <c:v>98.541944999999998</c:v>
                </c:pt>
                <c:pt idx="903">
                  <c:v>98.538434999999978</c:v>
                </c:pt>
                <c:pt idx="904">
                  <c:v>98.535034999999979</c:v>
                </c:pt>
                <c:pt idx="905">
                  <c:v>98.532038999999912</c:v>
                </c:pt>
                <c:pt idx="906">
                  <c:v>98.529780999999929</c:v>
                </c:pt>
                <c:pt idx="907">
                  <c:v>98.528253000000007</c:v>
                </c:pt>
                <c:pt idx="908">
                  <c:v>98.526837999999927</c:v>
                </c:pt>
                <c:pt idx="909">
                  <c:v>98.52476799999998</c:v>
                </c:pt>
                <c:pt idx="910">
                  <c:v>98.522255000000001</c:v>
                </c:pt>
                <c:pt idx="911">
                  <c:v>98.520141999999979</c:v>
                </c:pt>
                <c:pt idx="912">
                  <c:v>98.518297000000004</c:v>
                </c:pt>
                <c:pt idx="913">
                  <c:v>98.515991</c:v>
                </c:pt>
                <c:pt idx="914">
                  <c:v>98.513395000000003</c:v>
                </c:pt>
                <c:pt idx="915">
                  <c:v>98.511015</c:v>
                </c:pt>
                <c:pt idx="916">
                  <c:v>98.508476999999928</c:v>
                </c:pt>
                <c:pt idx="917">
                  <c:v>98.505341999999928</c:v>
                </c:pt>
                <c:pt idx="918">
                  <c:v>98.502277999999976</c:v>
                </c:pt>
                <c:pt idx="919">
                  <c:v>98.500163000000001</c:v>
                </c:pt>
                <c:pt idx="920">
                  <c:v>98.498731999999976</c:v>
                </c:pt>
                <c:pt idx="921">
                  <c:v>98.496996999999993</c:v>
                </c:pt>
                <c:pt idx="922">
                  <c:v>98.494418999999994</c:v>
                </c:pt>
                <c:pt idx="923">
                  <c:v>98.491299999999995</c:v>
                </c:pt>
                <c:pt idx="924">
                  <c:v>98.488236999999998</c:v>
                </c:pt>
                <c:pt idx="925">
                  <c:v>98.485349999999983</c:v>
                </c:pt>
                <c:pt idx="926">
                  <c:v>98.482523</c:v>
                </c:pt>
                <c:pt idx="927">
                  <c:v>98.48013899999998</c:v>
                </c:pt>
                <c:pt idx="928">
                  <c:v>98.478621000000004</c:v>
                </c:pt>
                <c:pt idx="929">
                  <c:v>98.477456000000004</c:v>
                </c:pt>
                <c:pt idx="930">
                  <c:v>98.475702999999896</c:v>
                </c:pt>
                <c:pt idx="931">
                  <c:v>98.473236</c:v>
                </c:pt>
                <c:pt idx="932">
                  <c:v>98.470573999999999</c:v>
                </c:pt>
                <c:pt idx="933">
                  <c:v>98.467825000000005</c:v>
                </c:pt>
                <c:pt idx="934">
                  <c:v>98.464766999999995</c:v>
                </c:pt>
                <c:pt idx="935">
                  <c:v>98.461622000000006</c:v>
                </c:pt>
                <c:pt idx="936">
                  <c:v>98.458957999999981</c:v>
                </c:pt>
                <c:pt idx="937">
                  <c:v>98.457007000000004</c:v>
                </c:pt>
                <c:pt idx="938">
                  <c:v>98.45534799999993</c:v>
                </c:pt>
                <c:pt idx="939">
                  <c:v>98.453373999999982</c:v>
                </c:pt>
                <c:pt idx="940">
                  <c:v>98.450895000000003</c:v>
                </c:pt>
                <c:pt idx="941">
                  <c:v>98.447929000000002</c:v>
                </c:pt>
                <c:pt idx="942">
                  <c:v>98.444548999999995</c:v>
                </c:pt>
                <c:pt idx="943">
                  <c:v>98.441367</c:v>
                </c:pt>
                <c:pt idx="944">
                  <c:v>98.439010999999994</c:v>
                </c:pt>
                <c:pt idx="945">
                  <c:v>98.437057999999993</c:v>
                </c:pt>
                <c:pt idx="946">
                  <c:v>98.434511999999998</c:v>
                </c:pt>
                <c:pt idx="947">
                  <c:v>98.431011999999996</c:v>
                </c:pt>
                <c:pt idx="948">
                  <c:v>98.427310000000006</c:v>
                </c:pt>
                <c:pt idx="949">
                  <c:v>98.424535000000006</c:v>
                </c:pt>
                <c:pt idx="950">
                  <c:v>98.422550000000001</c:v>
                </c:pt>
                <c:pt idx="951">
                  <c:v>98.420035999999982</c:v>
                </c:pt>
                <c:pt idx="952">
                  <c:v>98.416653999999994</c:v>
                </c:pt>
                <c:pt idx="953">
                  <c:v>98.413560000000004</c:v>
                </c:pt>
                <c:pt idx="954">
                  <c:v>98.411460000000005</c:v>
                </c:pt>
                <c:pt idx="955">
                  <c:v>98.409514999999999</c:v>
                </c:pt>
                <c:pt idx="956">
                  <c:v>98.406586000000004</c:v>
                </c:pt>
                <c:pt idx="957">
                  <c:v>98.402841999999978</c:v>
                </c:pt>
                <c:pt idx="958">
                  <c:v>98.399471999999946</c:v>
                </c:pt>
                <c:pt idx="959">
                  <c:v>98.396984000000003</c:v>
                </c:pt>
                <c:pt idx="960">
                  <c:v>98.394623999999993</c:v>
                </c:pt>
                <c:pt idx="961">
                  <c:v>98.391461000000007</c:v>
                </c:pt>
                <c:pt idx="962">
                  <c:v>98.387609999999995</c:v>
                </c:pt>
                <c:pt idx="963">
                  <c:v>98.384174000000002</c:v>
                </c:pt>
                <c:pt idx="964">
                  <c:v>98.381556000000003</c:v>
                </c:pt>
                <c:pt idx="965">
                  <c:v>98.378978999999873</c:v>
                </c:pt>
                <c:pt idx="966">
                  <c:v>98.376221000000001</c:v>
                </c:pt>
                <c:pt idx="967">
                  <c:v>98.373761999999928</c:v>
                </c:pt>
                <c:pt idx="968">
                  <c:v>98.371417999999977</c:v>
                </c:pt>
                <c:pt idx="969">
                  <c:v>98.368624999999994</c:v>
                </c:pt>
                <c:pt idx="970">
                  <c:v>98.365241999999981</c:v>
                </c:pt>
                <c:pt idx="971">
                  <c:v>98.361484000000004</c:v>
                </c:pt>
                <c:pt idx="972">
                  <c:v>98.357719000000003</c:v>
                </c:pt>
                <c:pt idx="973">
                  <c:v>98.354134000000002</c:v>
                </c:pt>
                <c:pt idx="974">
                  <c:v>98.350586999999976</c:v>
                </c:pt>
                <c:pt idx="975">
                  <c:v>98.34697199999998</c:v>
                </c:pt>
                <c:pt idx="976">
                  <c:v>98.343283999999997</c:v>
                </c:pt>
                <c:pt idx="977">
                  <c:v>98.339552999999981</c:v>
                </c:pt>
                <c:pt idx="978">
                  <c:v>98.33584399999998</c:v>
                </c:pt>
                <c:pt idx="979">
                  <c:v>98.331950000000006</c:v>
                </c:pt>
                <c:pt idx="980">
                  <c:v>98.327724000000003</c:v>
                </c:pt>
                <c:pt idx="981">
                  <c:v>98.32353999999998</c:v>
                </c:pt>
                <c:pt idx="982">
                  <c:v>98.319570999999982</c:v>
                </c:pt>
                <c:pt idx="983">
                  <c:v>98.315645000000004</c:v>
                </c:pt>
                <c:pt idx="984">
                  <c:v>98.311952000000005</c:v>
                </c:pt>
                <c:pt idx="985">
                  <c:v>98.308662999999981</c:v>
                </c:pt>
                <c:pt idx="986">
                  <c:v>98.305413999999999</c:v>
                </c:pt>
                <c:pt idx="987">
                  <c:v>98.301766999999998</c:v>
                </c:pt>
                <c:pt idx="988">
                  <c:v>98.297612999999998</c:v>
                </c:pt>
                <c:pt idx="989">
                  <c:v>98.293226000000004</c:v>
                </c:pt>
                <c:pt idx="990">
                  <c:v>98.288949000000002</c:v>
                </c:pt>
                <c:pt idx="991">
                  <c:v>98.284889000000007</c:v>
                </c:pt>
                <c:pt idx="992">
                  <c:v>98.281175000000005</c:v>
                </c:pt>
                <c:pt idx="993">
                  <c:v>98.277717999999979</c:v>
                </c:pt>
                <c:pt idx="994">
                  <c:v>98.273817999999977</c:v>
                </c:pt>
                <c:pt idx="995">
                  <c:v>98.269293000000005</c:v>
                </c:pt>
                <c:pt idx="996">
                  <c:v>98.265000999999998</c:v>
                </c:pt>
                <c:pt idx="997">
                  <c:v>98.261279000000002</c:v>
                </c:pt>
                <c:pt idx="998">
                  <c:v>98.257561999999993</c:v>
                </c:pt>
                <c:pt idx="999">
                  <c:v>98.253659999999996</c:v>
                </c:pt>
                <c:pt idx="1000">
                  <c:v>98.249745000000004</c:v>
                </c:pt>
                <c:pt idx="1001">
                  <c:v>98.245741999999979</c:v>
                </c:pt>
                <c:pt idx="1002">
                  <c:v>98.241743</c:v>
                </c:pt>
                <c:pt idx="1003">
                  <c:v>98.238077999999931</c:v>
                </c:pt>
                <c:pt idx="1004">
                  <c:v>98.234685999999996</c:v>
                </c:pt>
                <c:pt idx="1005">
                  <c:v>98.231223</c:v>
                </c:pt>
                <c:pt idx="1006">
                  <c:v>98.227535000000003</c:v>
                </c:pt>
                <c:pt idx="1007">
                  <c:v>98.223602</c:v>
                </c:pt>
                <c:pt idx="1008">
                  <c:v>98.21942</c:v>
                </c:pt>
                <c:pt idx="1009">
                  <c:v>98.215114</c:v>
                </c:pt>
                <c:pt idx="1010">
                  <c:v>98.211061999999998</c:v>
                </c:pt>
                <c:pt idx="1011">
                  <c:v>98.207605000000001</c:v>
                </c:pt>
                <c:pt idx="1012">
                  <c:v>98.20434299999998</c:v>
                </c:pt>
                <c:pt idx="1013">
                  <c:v>98.200384999999983</c:v>
                </c:pt>
                <c:pt idx="1014">
                  <c:v>98.195765999999978</c:v>
                </c:pt>
                <c:pt idx="1015">
                  <c:v>98.191489000000004</c:v>
                </c:pt>
                <c:pt idx="1016">
                  <c:v>98.187914000000006</c:v>
                </c:pt>
                <c:pt idx="1017">
                  <c:v>98.184466999999998</c:v>
                </c:pt>
                <c:pt idx="1018">
                  <c:v>98.180599000000001</c:v>
                </c:pt>
                <c:pt idx="1019">
                  <c:v>98.176151999999945</c:v>
                </c:pt>
                <c:pt idx="1020">
                  <c:v>98.171477999999865</c:v>
                </c:pt>
                <c:pt idx="1021">
                  <c:v>98.167125999999996</c:v>
                </c:pt>
                <c:pt idx="1022">
                  <c:v>98.162965999999983</c:v>
                </c:pt>
                <c:pt idx="1023">
                  <c:v>98.158366999999927</c:v>
                </c:pt>
                <c:pt idx="1024">
                  <c:v>98.153236999999976</c:v>
                </c:pt>
                <c:pt idx="1025">
                  <c:v>98.148038999999912</c:v>
                </c:pt>
                <c:pt idx="1026">
                  <c:v>98.143077999999946</c:v>
                </c:pt>
                <c:pt idx="1027">
                  <c:v>98.13847999999993</c:v>
                </c:pt>
                <c:pt idx="1028">
                  <c:v>98.134237999999982</c:v>
                </c:pt>
                <c:pt idx="1029">
                  <c:v>98.129956999999976</c:v>
                </c:pt>
                <c:pt idx="1030">
                  <c:v>98.124983</c:v>
                </c:pt>
                <c:pt idx="1031">
                  <c:v>98.119</c:v>
                </c:pt>
                <c:pt idx="1032">
                  <c:v>98.112583000000001</c:v>
                </c:pt>
                <c:pt idx="1033">
                  <c:v>98.106553000000005</c:v>
                </c:pt>
                <c:pt idx="1034">
                  <c:v>98.100926000000001</c:v>
                </c:pt>
                <c:pt idx="1035">
                  <c:v>98.095489999999998</c:v>
                </c:pt>
                <c:pt idx="1036">
                  <c:v>98.090241000000006</c:v>
                </c:pt>
                <c:pt idx="1037">
                  <c:v>98.084836999999979</c:v>
                </c:pt>
                <c:pt idx="1038">
                  <c:v>98.079045999999977</c:v>
                </c:pt>
                <c:pt idx="1039">
                  <c:v>98.07329</c:v>
                </c:pt>
                <c:pt idx="1040">
                  <c:v>98.068145999999999</c:v>
                </c:pt>
                <c:pt idx="1041">
                  <c:v>98.063597999999999</c:v>
                </c:pt>
                <c:pt idx="1042">
                  <c:v>98.058725999999979</c:v>
                </c:pt>
                <c:pt idx="1043">
                  <c:v>98.052826999999979</c:v>
                </c:pt>
                <c:pt idx="1044">
                  <c:v>98.046468000000004</c:v>
                </c:pt>
                <c:pt idx="1045">
                  <c:v>98.040284</c:v>
                </c:pt>
                <c:pt idx="1046">
                  <c:v>98.034205999999998</c:v>
                </c:pt>
                <c:pt idx="1047">
                  <c:v>98.028588999999911</c:v>
                </c:pt>
                <c:pt idx="1048">
                  <c:v>98.023914000000005</c:v>
                </c:pt>
                <c:pt idx="1049">
                  <c:v>98.019498999999982</c:v>
                </c:pt>
                <c:pt idx="1050">
                  <c:v>98.014212000000001</c:v>
                </c:pt>
                <c:pt idx="1051">
                  <c:v>98.007897</c:v>
                </c:pt>
                <c:pt idx="1052">
                  <c:v>98.001401000000001</c:v>
                </c:pt>
                <c:pt idx="1053">
                  <c:v>97.995491000000001</c:v>
                </c:pt>
                <c:pt idx="1054">
                  <c:v>97.989953</c:v>
                </c:pt>
                <c:pt idx="1055">
                  <c:v>97.984212999999997</c:v>
                </c:pt>
                <c:pt idx="1056">
                  <c:v>97.978231999999977</c:v>
                </c:pt>
                <c:pt idx="1057">
                  <c:v>97.972247999999979</c:v>
                </c:pt>
                <c:pt idx="1058">
                  <c:v>97.966476999999998</c:v>
                </c:pt>
                <c:pt idx="1059">
                  <c:v>97.961129</c:v>
                </c:pt>
                <c:pt idx="1060">
                  <c:v>97.956024999999997</c:v>
                </c:pt>
                <c:pt idx="1061">
                  <c:v>97.950738999999928</c:v>
                </c:pt>
                <c:pt idx="1062">
                  <c:v>97.945228</c:v>
                </c:pt>
                <c:pt idx="1063">
                  <c:v>97.939583999999996</c:v>
                </c:pt>
                <c:pt idx="1064">
                  <c:v>97.933634999999995</c:v>
                </c:pt>
                <c:pt idx="1065">
                  <c:v>97.927533999999994</c:v>
                </c:pt>
                <c:pt idx="1066">
                  <c:v>97.921767000000003</c:v>
                </c:pt>
                <c:pt idx="1067">
                  <c:v>97.916426000000001</c:v>
                </c:pt>
                <c:pt idx="1068">
                  <c:v>97.911264000000003</c:v>
                </c:pt>
                <c:pt idx="1069">
                  <c:v>97.906176000000002</c:v>
                </c:pt>
                <c:pt idx="1070">
                  <c:v>97.901257999999999</c:v>
                </c:pt>
                <c:pt idx="1071">
                  <c:v>97.896547999999981</c:v>
                </c:pt>
                <c:pt idx="1072">
                  <c:v>97.891829000000001</c:v>
                </c:pt>
                <c:pt idx="1073">
                  <c:v>97.886842999999928</c:v>
                </c:pt>
                <c:pt idx="1074">
                  <c:v>97.881674000000004</c:v>
                </c:pt>
                <c:pt idx="1075">
                  <c:v>97.876624000000007</c:v>
                </c:pt>
                <c:pt idx="1076">
                  <c:v>97.871382999999895</c:v>
                </c:pt>
                <c:pt idx="1077">
                  <c:v>97.865260000000006</c:v>
                </c:pt>
                <c:pt idx="1078">
                  <c:v>97.858544999999978</c:v>
                </c:pt>
                <c:pt idx="1079">
                  <c:v>97.852151999999975</c:v>
                </c:pt>
                <c:pt idx="1080">
                  <c:v>97.846269000000007</c:v>
                </c:pt>
                <c:pt idx="1081">
                  <c:v>97.840655999999996</c:v>
                </c:pt>
                <c:pt idx="1082">
                  <c:v>97.835217999999998</c:v>
                </c:pt>
                <c:pt idx="1083">
                  <c:v>97.829935999999975</c:v>
                </c:pt>
                <c:pt idx="1084">
                  <c:v>97.824793999999983</c:v>
                </c:pt>
                <c:pt idx="1085">
                  <c:v>97.819643999999997</c:v>
                </c:pt>
                <c:pt idx="1086">
                  <c:v>97.81434299999998</c:v>
                </c:pt>
                <c:pt idx="1087">
                  <c:v>97.808966999999981</c:v>
                </c:pt>
                <c:pt idx="1088">
                  <c:v>97.80344599999998</c:v>
                </c:pt>
                <c:pt idx="1089">
                  <c:v>97.797649000000007</c:v>
                </c:pt>
                <c:pt idx="1090">
                  <c:v>97.791737999999981</c:v>
                </c:pt>
                <c:pt idx="1091">
                  <c:v>97.785814000000002</c:v>
                </c:pt>
                <c:pt idx="1092">
                  <c:v>97.779798999999912</c:v>
                </c:pt>
                <c:pt idx="1093">
                  <c:v>97.773938999999928</c:v>
                </c:pt>
                <c:pt idx="1094">
                  <c:v>97.768564999999995</c:v>
                </c:pt>
                <c:pt idx="1095">
                  <c:v>97.763523000000006</c:v>
                </c:pt>
                <c:pt idx="1096">
                  <c:v>97.758606</c:v>
                </c:pt>
                <c:pt idx="1097">
                  <c:v>97.754045000000005</c:v>
                </c:pt>
                <c:pt idx="1098">
                  <c:v>97.749865999999997</c:v>
                </c:pt>
                <c:pt idx="1099">
                  <c:v>97.745638</c:v>
                </c:pt>
                <c:pt idx="1100">
                  <c:v>97.741206000000005</c:v>
                </c:pt>
                <c:pt idx="1101">
                  <c:v>97.736575000000002</c:v>
                </c:pt>
                <c:pt idx="1102">
                  <c:v>97.731198000000006</c:v>
                </c:pt>
                <c:pt idx="1103">
                  <c:v>97.724895000000004</c:v>
                </c:pt>
                <c:pt idx="1104">
                  <c:v>97.718733999999998</c:v>
                </c:pt>
                <c:pt idx="1105">
                  <c:v>97.713592000000006</c:v>
                </c:pt>
                <c:pt idx="1106">
                  <c:v>97.709086999999982</c:v>
                </c:pt>
                <c:pt idx="1107">
                  <c:v>97.704922999999994</c:v>
                </c:pt>
                <c:pt idx="1108">
                  <c:v>97.701065</c:v>
                </c:pt>
                <c:pt idx="1109">
                  <c:v>97.696522000000002</c:v>
                </c:pt>
                <c:pt idx="1110">
                  <c:v>97.690611000000004</c:v>
                </c:pt>
                <c:pt idx="1111">
                  <c:v>97.684569999999994</c:v>
                </c:pt>
                <c:pt idx="1112">
                  <c:v>97.679737999999858</c:v>
                </c:pt>
                <c:pt idx="1113">
                  <c:v>97.675590999999912</c:v>
                </c:pt>
                <c:pt idx="1114">
                  <c:v>97.67084999999993</c:v>
                </c:pt>
                <c:pt idx="1115">
                  <c:v>97.665253000000007</c:v>
                </c:pt>
                <c:pt idx="1116">
                  <c:v>97.659278999999927</c:v>
                </c:pt>
                <c:pt idx="1117">
                  <c:v>97.653315999999975</c:v>
                </c:pt>
                <c:pt idx="1118">
                  <c:v>97.647823000000002</c:v>
                </c:pt>
                <c:pt idx="1119">
                  <c:v>97.642985999999979</c:v>
                </c:pt>
                <c:pt idx="1120">
                  <c:v>97.638134999999977</c:v>
                </c:pt>
                <c:pt idx="1121">
                  <c:v>97.632609000000002</c:v>
                </c:pt>
                <c:pt idx="1122">
                  <c:v>97.62634499999993</c:v>
                </c:pt>
                <c:pt idx="1123">
                  <c:v>97.619693999999996</c:v>
                </c:pt>
                <c:pt idx="1124">
                  <c:v>97.613405</c:v>
                </c:pt>
                <c:pt idx="1125">
                  <c:v>97.607845999999981</c:v>
                </c:pt>
                <c:pt idx="1126">
                  <c:v>97.602372999999872</c:v>
                </c:pt>
                <c:pt idx="1127">
                  <c:v>97.596256999999994</c:v>
                </c:pt>
                <c:pt idx="1128">
                  <c:v>97.589528000000001</c:v>
                </c:pt>
                <c:pt idx="1129">
                  <c:v>97.582986999999946</c:v>
                </c:pt>
                <c:pt idx="1130">
                  <c:v>97.577396999999976</c:v>
                </c:pt>
                <c:pt idx="1131">
                  <c:v>97.572579999999945</c:v>
                </c:pt>
                <c:pt idx="1132">
                  <c:v>97.568019000000007</c:v>
                </c:pt>
                <c:pt idx="1133">
                  <c:v>97.564031999999983</c:v>
                </c:pt>
                <c:pt idx="1134">
                  <c:v>97.560694999999996</c:v>
                </c:pt>
                <c:pt idx="1135">
                  <c:v>97.556766999999979</c:v>
                </c:pt>
                <c:pt idx="1136">
                  <c:v>97.552230999999978</c:v>
                </c:pt>
                <c:pt idx="1137">
                  <c:v>97.54957899999998</c:v>
                </c:pt>
                <c:pt idx="1138">
                  <c:v>97.549936000000002</c:v>
                </c:pt>
                <c:pt idx="1139">
                  <c:v>97.550947999999977</c:v>
                </c:pt>
                <c:pt idx="1140">
                  <c:v>97.549442999999982</c:v>
                </c:pt>
                <c:pt idx="1141">
                  <c:v>97.543902000000003</c:v>
                </c:pt>
                <c:pt idx="1142">
                  <c:v>97.534640999999993</c:v>
                </c:pt>
                <c:pt idx="1143">
                  <c:v>97.523060999999998</c:v>
                </c:pt>
                <c:pt idx="1144">
                  <c:v>97.510499999999993</c:v>
                </c:pt>
                <c:pt idx="1145">
                  <c:v>97.497517999999999</c:v>
                </c:pt>
                <c:pt idx="1146">
                  <c:v>97.484245000000001</c:v>
                </c:pt>
                <c:pt idx="1147">
                  <c:v>97.471172999999979</c:v>
                </c:pt>
                <c:pt idx="1148">
                  <c:v>97.458930999999978</c:v>
                </c:pt>
                <c:pt idx="1149">
                  <c:v>97.447952999999998</c:v>
                </c:pt>
                <c:pt idx="1150">
                  <c:v>97.438902999999982</c:v>
                </c:pt>
                <c:pt idx="1151">
                  <c:v>97.432370000000006</c:v>
                </c:pt>
                <c:pt idx="1152">
                  <c:v>97.427178999999981</c:v>
                </c:pt>
                <c:pt idx="1153">
                  <c:v>97.420513999999997</c:v>
                </c:pt>
                <c:pt idx="1154">
                  <c:v>97.411270000000002</c:v>
                </c:pt>
                <c:pt idx="1155">
                  <c:v>97.401680999999996</c:v>
                </c:pt>
                <c:pt idx="1156">
                  <c:v>97.393958999999981</c:v>
                </c:pt>
                <c:pt idx="1157">
                  <c:v>97.387799000000001</c:v>
                </c:pt>
                <c:pt idx="1158">
                  <c:v>97.382024999999999</c:v>
                </c:pt>
                <c:pt idx="1159">
                  <c:v>97.376277999999928</c:v>
                </c:pt>
                <c:pt idx="1160">
                  <c:v>97.370735999999894</c:v>
                </c:pt>
                <c:pt idx="1161">
                  <c:v>97.365609000000006</c:v>
                </c:pt>
                <c:pt idx="1162">
                  <c:v>97.361142000000001</c:v>
                </c:pt>
                <c:pt idx="1163">
                  <c:v>97.357192999999981</c:v>
                </c:pt>
                <c:pt idx="1164">
                  <c:v>97.352419999999981</c:v>
                </c:pt>
                <c:pt idx="1165">
                  <c:v>97.345839999999981</c:v>
                </c:pt>
                <c:pt idx="1166">
                  <c:v>97.338716999999946</c:v>
                </c:pt>
                <c:pt idx="1167">
                  <c:v>97.332746999999927</c:v>
                </c:pt>
                <c:pt idx="1168">
                  <c:v>97.327804</c:v>
                </c:pt>
                <c:pt idx="1169">
                  <c:v>97.323105999999981</c:v>
                </c:pt>
                <c:pt idx="1170">
                  <c:v>97.319108999999983</c:v>
                </c:pt>
                <c:pt idx="1171">
                  <c:v>97.318004999999999</c:v>
                </c:pt>
                <c:pt idx="1172">
                  <c:v>97.322190999999975</c:v>
                </c:pt>
                <c:pt idx="1173">
                  <c:v>97.330754999999982</c:v>
                </c:pt>
                <c:pt idx="1174">
                  <c:v>97.338575999999946</c:v>
                </c:pt>
                <c:pt idx="1175">
                  <c:v>97.341330000000013</c:v>
                </c:pt>
                <c:pt idx="1176">
                  <c:v>97.339287999999982</c:v>
                </c:pt>
                <c:pt idx="1177">
                  <c:v>97.334564</c:v>
                </c:pt>
                <c:pt idx="1178">
                  <c:v>97.32749699999998</c:v>
                </c:pt>
                <c:pt idx="1179">
                  <c:v>97.317666000000003</c:v>
                </c:pt>
                <c:pt idx="1180">
                  <c:v>97.306281999999982</c:v>
                </c:pt>
                <c:pt idx="1181">
                  <c:v>97.295053999999993</c:v>
                </c:pt>
                <c:pt idx="1182">
                  <c:v>97.283705999999981</c:v>
                </c:pt>
                <c:pt idx="1183">
                  <c:v>97.271592999999982</c:v>
                </c:pt>
                <c:pt idx="1184">
                  <c:v>97.259876999999946</c:v>
                </c:pt>
                <c:pt idx="1185">
                  <c:v>97.249634999999998</c:v>
                </c:pt>
                <c:pt idx="1186">
                  <c:v>97.240306000000004</c:v>
                </c:pt>
                <c:pt idx="1187">
                  <c:v>97.231673999999998</c:v>
                </c:pt>
                <c:pt idx="1188">
                  <c:v>97.224521999999993</c:v>
                </c:pt>
                <c:pt idx="1189">
                  <c:v>97.218260999999998</c:v>
                </c:pt>
                <c:pt idx="1190">
                  <c:v>97.210864999999998</c:v>
                </c:pt>
                <c:pt idx="1191">
                  <c:v>97.202017999999981</c:v>
                </c:pt>
                <c:pt idx="1192">
                  <c:v>97.193647999999982</c:v>
                </c:pt>
                <c:pt idx="1193">
                  <c:v>97.186714999999978</c:v>
                </c:pt>
                <c:pt idx="1194">
                  <c:v>97.179475999999894</c:v>
                </c:pt>
                <c:pt idx="1195">
                  <c:v>97.170547999999911</c:v>
                </c:pt>
                <c:pt idx="1196">
                  <c:v>97.161418999999981</c:v>
                </c:pt>
                <c:pt idx="1197">
                  <c:v>97.153531999999927</c:v>
                </c:pt>
                <c:pt idx="1198">
                  <c:v>97.145859000000002</c:v>
                </c:pt>
                <c:pt idx="1199">
                  <c:v>97.137146000000001</c:v>
                </c:pt>
                <c:pt idx="1200">
                  <c:v>97.127731999999895</c:v>
                </c:pt>
                <c:pt idx="1201">
                  <c:v>97.118803999999983</c:v>
                </c:pt>
                <c:pt idx="1202">
                  <c:v>97.111356999999998</c:v>
                </c:pt>
                <c:pt idx="1203">
                  <c:v>97.105634999999978</c:v>
                </c:pt>
                <c:pt idx="1204">
                  <c:v>97.100928999999979</c:v>
                </c:pt>
                <c:pt idx="1205">
                  <c:v>97.096273999999994</c:v>
                </c:pt>
                <c:pt idx="1206">
                  <c:v>97.091303999999994</c:v>
                </c:pt>
                <c:pt idx="1207">
                  <c:v>97.086045999999982</c:v>
                </c:pt>
                <c:pt idx="1208">
                  <c:v>97.080037999999931</c:v>
                </c:pt>
                <c:pt idx="1209">
                  <c:v>97.072493999999978</c:v>
                </c:pt>
                <c:pt idx="1210">
                  <c:v>97.063233999999994</c:v>
                </c:pt>
                <c:pt idx="1211">
                  <c:v>97.052821999999978</c:v>
                </c:pt>
                <c:pt idx="1212">
                  <c:v>97.042130999999998</c:v>
                </c:pt>
                <c:pt idx="1213">
                  <c:v>97.031910999999994</c:v>
                </c:pt>
                <c:pt idx="1214">
                  <c:v>97.021395999999982</c:v>
                </c:pt>
                <c:pt idx="1215">
                  <c:v>97.008836999999929</c:v>
                </c:pt>
                <c:pt idx="1216">
                  <c:v>96.994508999999994</c:v>
                </c:pt>
                <c:pt idx="1217">
                  <c:v>96.980165</c:v>
                </c:pt>
                <c:pt idx="1218">
                  <c:v>96.966155000000001</c:v>
                </c:pt>
                <c:pt idx="1219">
                  <c:v>96.952184000000003</c:v>
                </c:pt>
                <c:pt idx="1220">
                  <c:v>96.938468</c:v>
                </c:pt>
                <c:pt idx="1221">
                  <c:v>96.925268000000003</c:v>
                </c:pt>
                <c:pt idx="1222">
                  <c:v>96.913498000000004</c:v>
                </c:pt>
                <c:pt idx="1223">
                  <c:v>96.904640000000001</c:v>
                </c:pt>
                <c:pt idx="1224">
                  <c:v>96.897882999999979</c:v>
                </c:pt>
                <c:pt idx="1225">
                  <c:v>96.889311999999975</c:v>
                </c:pt>
                <c:pt idx="1226">
                  <c:v>96.875988999999876</c:v>
                </c:pt>
                <c:pt idx="1227">
                  <c:v>96.859243000000006</c:v>
                </c:pt>
                <c:pt idx="1228">
                  <c:v>96.842416</c:v>
                </c:pt>
                <c:pt idx="1229">
                  <c:v>96.827651000000003</c:v>
                </c:pt>
                <c:pt idx="1230">
                  <c:v>96.815244000000007</c:v>
                </c:pt>
                <c:pt idx="1231">
                  <c:v>96.803950999999998</c:v>
                </c:pt>
                <c:pt idx="1232">
                  <c:v>96.792381999999947</c:v>
                </c:pt>
                <c:pt idx="1233">
                  <c:v>96.781124000000005</c:v>
                </c:pt>
                <c:pt idx="1234">
                  <c:v>96.771730999999946</c:v>
                </c:pt>
                <c:pt idx="1235">
                  <c:v>96.763851000000003</c:v>
                </c:pt>
                <c:pt idx="1236">
                  <c:v>96.754951000000005</c:v>
                </c:pt>
                <c:pt idx="1237">
                  <c:v>96.743705000000006</c:v>
                </c:pt>
                <c:pt idx="1238">
                  <c:v>96.732320000000001</c:v>
                </c:pt>
                <c:pt idx="1239">
                  <c:v>96.723095999999998</c:v>
                </c:pt>
                <c:pt idx="1240">
                  <c:v>96.714257000000003</c:v>
                </c:pt>
                <c:pt idx="1241">
                  <c:v>96.702599000000006</c:v>
                </c:pt>
                <c:pt idx="1242">
                  <c:v>96.688263000000006</c:v>
                </c:pt>
                <c:pt idx="1243">
                  <c:v>96.67418499999998</c:v>
                </c:pt>
                <c:pt idx="1244">
                  <c:v>96.661994000000007</c:v>
                </c:pt>
                <c:pt idx="1245">
                  <c:v>96.650978999999893</c:v>
                </c:pt>
                <c:pt idx="1246">
                  <c:v>96.640145000000004</c:v>
                </c:pt>
                <c:pt idx="1247">
                  <c:v>96.628799999999927</c:v>
                </c:pt>
                <c:pt idx="1248">
                  <c:v>96.616618000000003</c:v>
                </c:pt>
                <c:pt idx="1249">
                  <c:v>96.604690000000005</c:v>
                </c:pt>
                <c:pt idx="1250">
                  <c:v>96.594307999999998</c:v>
                </c:pt>
                <c:pt idx="1251">
                  <c:v>96.585439999999977</c:v>
                </c:pt>
                <c:pt idx="1252">
                  <c:v>96.577106999999998</c:v>
                </c:pt>
                <c:pt idx="1253">
                  <c:v>96.567676000000006</c:v>
                </c:pt>
                <c:pt idx="1254">
                  <c:v>96.556035999999978</c:v>
                </c:pt>
                <c:pt idx="1255">
                  <c:v>96.543600999999995</c:v>
                </c:pt>
                <c:pt idx="1256">
                  <c:v>96.533385999999979</c:v>
                </c:pt>
                <c:pt idx="1257">
                  <c:v>96.527309000000002</c:v>
                </c:pt>
                <c:pt idx="1258">
                  <c:v>96.523803000000001</c:v>
                </c:pt>
                <c:pt idx="1259">
                  <c:v>96.517842000000002</c:v>
                </c:pt>
                <c:pt idx="1260">
                  <c:v>96.506133000000005</c:v>
                </c:pt>
                <c:pt idx="1261">
                  <c:v>96.490966999999998</c:v>
                </c:pt>
                <c:pt idx="1262">
                  <c:v>96.475746999999927</c:v>
                </c:pt>
                <c:pt idx="1263">
                  <c:v>96.461198999999993</c:v>
                </c:pt>
                <c:pt idx="1264">
                  <c:v>96.447378</c:v>
                </c:pt>
                <c:pt idx="1265">
                  <c:v>96.434524999999994</c:v>
                </c:pt>
                <c:pt idx="1266">
                  <c:v>96.422569999999993</c:v>
                </c:pt>
                <c:pt idx="1267">
                  <c:v>96.411886999999993</c:v>
                </c:pt>
                <c:pt idx="1268">
                  <c:v>96.402809000000005</c:v>
                </c:pt>
                <c:pt idx="1269">
                  <c:v>96.394818999999998</c:v>
                </c:pt>
                <c:pt idx="1270">
                  <c:v>96.386623</c:v>
                </c:pt>
                <c:pt idx="1271">
                  <c:v>96.377010999999982</c:v>
                </c:pt>
                <c:pt idx="1272">
                  <c:v>96.366711999999978</c:v>
                </c:pt>
                <c:pt idx="1273">
                  <c:v>96.358059999999981</c:v>
                </c:pt>
                <c:pt idx="1274">
                  <c:v>96.351374999999976</c:v>
                </c:pt>
                <c:pt idx="1275">
                  <c:v>96.344553000000005</c:v>
                </c:pt>
                <c:pt idx="1276">
                  <c:v>96.337746999999979</c:v>
                </c:pt>
                <c:pt idx="1277">
                  <c:v>96.334310000000002</c:v>
                </c:pt>
                <c:pt idx="1278">
                  <c:v>96.334451000000001</c:v>
                </c:pt>
                <c:pt idx="1279">
                  <c:v>96.333207999999999</c:v>
                </c:pt>
                <c:pt idx="1280">
                  <c:v>96.326355999999976</c:v>
                </c:pt>
                <c:pt idx="1281">
                  <c:v>96.313858999999979</c:v>
                </c:pt>
                <c:pt idx="1282">
                  <c:v>96.298913999999996</c:v>
                </c:pt>
                <c:pt idx="1283">
                  <c:v>96.285961</c:v>
                </c:pt>
                <c:pt idx="1284">
                  <c:v>96.277107999999998</c:v>
                </c:pt>
                <c:pt idx="1285">
                  <c:v>96.271076999999977</c:v>
                </c:pt>
                <c:pt idx="1286">
                  <c:v>96.26581299999998</c:v>
                </c:pt>
                <c:pt idx="1287">
                  <c:v>96.260306</c:v>
                </c:pt>
                <c:pt idx="1288">
                  <c:v>96.255287999999979</c:v>
                </c:pt>
                <c:pt idx="1289">
                  <c:v>96.252327999999977</c:v>
                </c:pt>
                <c:pt idx="1290">
                  <c:v>96.250467</c:v>
                </c:pt>
                <c:pt idx="1291">
                  <c:v>96.246374000000003</c:v>
                </c:pt>
                <c:pt idx="1292">
                  <c:v>96.239559</c:v>
                </c:pt>
                <c:pt idx="1293">
                  <c:v>96.233327000000003</c:v>
                </c:pt>
                <c:pt idx="1294">
                  <c:v>96.229838999999927</c:v>
                </c:pt>
                <c:pt idx="1295">
                  <c:v>96.229405</c:v>
                </c:pt>
                <c:pt idx="1296">
                  <c:v>96.232196000000002</c:v>
                </c:pt>
                <c:pt idx="1297">
                  <c:v>96.235093000000006</c:v>
                </c:pt>
                <c:pt idx="1298">
                  <c:v>96.232900999999998</c:v>
                </c:pt>
                <c:pt idx="1299">
                  <c:v>96.226339999999979</c:v>
                </c:pt>
                <c:pt idx="1300">
                  <c:v>96.220828999999981</c:v>
                </c:pt>
                <c:pt idx="1301">
                  <c:v>96.218344999999999</c:v>
                </c:pt>
                <c:pt idx="1302">
                  <c:v>96.217343</c:v>
                </c:pt>
                <c:pt idx="1303">
                  <c:v>96.217074999999994</c:v>
                </c:pt>
                <c:pt idx="1304">
                  <c:v>96.217845999999994</c:v>
                </c:pt>
                <c:pt idx="1305">
                  <c:v>96.219429000000005</c:v>
                </c:pt>
                <c:pt idx="1306">
                  <c:v>96.221041999999983</c:v>
                </c:pt>
                <c:pt idx="1307">
                  <c:v>96.222732999999891</c:v>
                </c:pt>
                <c:pt idx="1308">
                  <c:v>96.225611999999998</c:v>
                </c:pt>
                <c:pt idx="1309">
                  <c:v>96.230181000000002</c:v>
                </c:pt>
                <c:pt idx="1310">
                  <c:v>96.235692</c:v>
                </c:pt>
                <c:pt idx="1311">
                  <c:v>96.241350999999995</c:v>
                </c:pt>
                <c:pt idx="1312">
                  <c:v>96.246712000000002</c:v>
                </c:pt>
                <c:pt idx="1313">
                  <c:v>96.251268999999994</c:v>
                </c:pt>
                <c:pt idx="1314">
                  <c:v>96.255004</c:v>
                </c:pt>
                <c:pt idx="1315">
                  <c:v>96.258970000000005</c:v>
                </c:pt>
                <c:pt idx="1316">
                  <c:v>96.264266000000006</c:v>
                </c:pt>
                <c:pt idx="1317">
                  <c:v>96.27072699999998</c:v>
                </c:pt>
                <c:pt idx="1318">
                  <c:v>96.277310999999983</c:v>
                </c:pt>
                <c:pt idx="1319">
                  <c:v>96.283268000000007</c:v>
                </c:pt>
                <c:pt idx="1320">
                  <c:v>96.288716999999977</c:v>
                </c:pt>
                <c:pt idx="1321">
                  <c:v>96.294464000000005</c:v>
                </c:pt>
                <c:pt idx="1322">
                  <c:v>96.300901999999979</c:v>
                </c:pt>
                <c:pt idx="1323">
                  <c:v>96.307586000000001</c:v>
                </c:pt>
                <c:pt idx="1324">
                  <c:v>96.314080000000004</c:v>
                </c:pt>
                <c:pt idx="1325">
                  <c:v>96.320130000000006</c:v>
                </c:pt>
                <c:pt idx="1326">
                  <c:v>96.325547999999927</c:v>
                </c:pt>
                <c:pt idx="1327">
                  <c:v>96.330623000000003</c:v>
                </c:pt>
                <c:pt idx="1328">
                  <c:v>96.335504999999998</c:v>
                </c:pt>
                <c:pt idx="1329">
                  <c:v>96.339507999999981</c:v>
                </c:pt>
                <c:pt idx="1330">
                  <c:v>96.342517000000001</c:v>
                </c:pt>
                <c:pt idx="1331">
                  <c:v>96.345688999999979</c:v>
                </c:pt>
                <c:pt idx="1332">
                  <c:v>96.349260999999998</c:v>
                </c:pt>
                <c:pt idx="1333">
                  <c:v>96.35199799999998</c:v>
                </c:pt>
                <c:pt idx="1334">
                  <c:v>96.353799999999978</c:v>
                </c:pt>
                <c:pt idx="1335">
                  <c:v>96.356122999999982</c:v>
                </c:pt>
                <c:pt idx="1336">
                  <c:v>96.359680999999981</c:v>
                </c:pt>
                <c:pt idx="1337">
                  <c:v>96.364328999999998</c:v>
                </c:pt>
                <c:pt idx="1338">
                  <c:v>96.370249000000001</c:v>
                </c:pt>
                <c:pt idx="1339">
                  <c:v>96.376346999999896</c:v>
                </c:pt>
                <c:pt idx="1340">
                  <c:v>96.380143000000004</c:v>
                </c:pt>
                <c:pt idx="1341">
                  <c:v>96.381814000000006</c:v>
                </c:pt>
                <c:pt idx="1342">
                  <c:v>96.384212000000005</c:v>
                </c:pt>
                <c:pt idx="1343">
                  <c:v>96.388640999999978</c:v>
                </c:pt>
                <c:pt idx="1344">
                  <c:v>96.394750999999999</c:v>
                </c:pt>
                <c:pt idx="1345">
                  <c:v>96.401937000000004</c:v>
                </c:pt>
                <c:pt idx="1346">
                  <c:v>96.408287000000001</c:v>
                </c:pt>
                <c:pt idx="1347">
                  <c:v>96.412150999999994</c:v>
                </c:pt>
                <c:pt idx="1348">
                  <c:v>96.415233000000001</c:v>
                </c:pt>
                <c:pt idx="1349">
                  <c:v>96.420552000000001</c:v>
                </c:pt>
                <c:pt idx="1350">
                  <c:v>96.428426000000002</c:v>
                </c:pt>
                <c:pt idx="1351">
                  <c:v>96.436373000000003</c:v>
                </c:pt>
                <c:pt idx="1352">
                  <c:v>96.442149000000001</c:v>
                </c:pt>
                <c:pt idx="1353">
                  <c:v>96.446206000000004</c:v>
                </c:pt>
                <c:pt idx="1354">
                  <c:v>96.450722999999982</c:v>
                </c:pt>
                <c:pt idx="1355">
                  <c:v>96.457003999999998</c:v>
                </c:pt>
                <c:pt idx="1356">
                  <c:v>96.465153999999998</c:v>
                </c:pt>
                <c:pt idx="1357">
                  <c:v>96.474875999999981</c:v>
                </c:pt>
                <c:pt idx="1358">
                  <c:v>96.484893999999997</c:v>
                </c:pt>
                <c:pt idx="1359">
                  <c:v>96.492775999999978</c:v>
                </c:pt>
                <c:pt idx="1360">
                  <c:v>96.497459000000006</c:v>
                </c:pt>
                <c:pt idx="1361">
                  <c:v>96.500648999999981</c:v>
                </c:pt>
                <c:pt idx="1362">
                  <c:v>96.504407999999998</c:v>
                </c:pt>
                <c:pt idx="1363">
                  <c:v>96.509461000000002</c:v>
                </c:pt>
                <c:pt idx="1364">
                  <c:v>96.515470999999977</c:v>
                </c:pt>
                <c:pt idx="1365">
                  <c:v>96.521089000000003</c:v>
                </c:pt>
                <c:pt idx="1366">
                  <c:v>96.525807999999927</c:v>
                </c:pt>
                <c:pt idx="1367">
                  <c:v>96.531783000000004</c:v>
                </c:pt>
                <c:pt idx="1368">
                  <c:v>96.540925999999999</c:v>
                </c:pt>
                <c:pt idx="1369">
                  <c:v>96.551057</c:v>
                </c:pt>
                <c:pt idx="1370">
                  <c:v>96.558371999999892</c:v>
                </c:pt>
                <c:pt idx="1371">
                  <c:v>96.562927000000002</c:v>
                </c:pt>
                <c:pt idx="1372">
                  <c:v>96.568173000000002</c:v>
                </c:pt>
                <c:pt idx="1373">
                  <c:v>96.576609000000005</c:v>
                </c:pt>
                <c:pt idx="1374">
                  <c:v>96.589037999999945</c:v>
                </c:pt>
                <c:pt idx="1375">
                  <c:v>96.605294000000001</c:v>
                </c:pt>
                <c:pt idx="1376">
                  <c:v>96.622569999999982</c:v>
                </c:pt>
                <c:pt idx="1377">
                  <c:v>96.635651999999979</c:v>
                </c:pt>
                <c:pt idx="1378">
                  <c:v>96.64228199999998</c:v>
                </c:pt>
                <c:pt idx="1379">
                  <c:v>96.645779999999945</c:v>
                </c:pt>
                <c:pt idx="1380">
                  <c:v>96.65031699999993</c:v>
                </c:pt>
                <c:pt idx="1381">
                  <c:v>96.657223999999999</c:v>
                </c:pt>
                <c:pt idx="1382">
                  <c:v>96.666593000000006</c:v>
                </c:pt>
                <c:pt idx="1383">
                  <c:v>96.678281999999896</c:v>
                </c:pt>
                <c:pt idx="1384">
                  <c:v>96.691041999999982</c:v>
                </c:pt>
                <c:pt idx="1385">
                  <c:v>96.703321000000003</c:v>
                </c:pt>
                <c:pt idx="1386">
                  <c:v>96.714757000000006</c:v>
                </c:pt>
                <c:pt idx="1387">
                  <c:v>96.725687999999977</c:v>
                </c:pt>
                <c:pt idx="1388">
                  <c:v>96.736444000000006</c:v>
                </c:pt>
                <c:pt idx="1389">
                  <c:v>96.747280000000003</c:v>
                </c:pt>
                <c:pt idx="1390">
                  <c:v>96.758095999999981</c:v>
                </c:pt>
                <c:pt idx="1391">
                  <c:v>96.769074000000003</c:v>
                </c:pt>
                <c:pt idx="1392">
                  <c:v>96.781153000000003</c:v>
                </c:pt>
                <c:pt idx="1393">
                  <c:v>96.793924000000004</c:v>
                </c:pt>
                <c:pt idx="1394">
                  <c:v>96.804952</c:v>
                </c:pt>
                <c:pt idx="1395">
                  <c:v>96.812845999999979</c:v>
                </c:pt>
                <c:pt idx="1396">
                  <c:v>96.818937999999946</c:v>
                </c:pt>
                <c:pt idx="1397">
                  <c:v>96.825369999999978</c:v>
                </c:pt>
                <c:pt idx="1398">
                  <c:v>96.83345199999998</c:v>
                </c:pt>
                <c:pt idx="1399">
                  <c:v>96.842759999999998</c:v>
                </c:pt>
                <c:pt idx="1400">
                  <c:v>96.85069</c:v>
                </c:pt>
                <c:pt idx="1401">
                  <c:v>96.855277999999927</c:v>
                </c:pt>
                <c:pt idx="1402">
                  <c:v>96.858557999999945</c:v>
                </c:pt>
                <c:pt idx="1403">
                  <c:v>96.863841999999977</c:v>
                </c:pt>
                <c:pt idx="1404">
                  <c:v>96.870996999999946</c:v>
                </c:pt>
                <c:pt idx="1405">
                  <c:v>96.877216000000004</c:v>
                </c:pt>
                <c:pt idx="1406">
                  <c:v>96.88158</c:v>
                </c:pt>
                <c:pt idx="1407">
                  <c:v>96.88643699999993</c:v>
                </c:pt>
                <c:pt idx="1408">
                  <c:v>96.893265999999997</c:v>
                </c:pt>
                <c:pt idx="1409">
                  <c:v>96.899232999999981</c:v>
                </c:pt>
                <c:pt idx="1410">
                  <c:v>96.900806000000003</c:v>
                </c:pt>
                <c:pt idx="1411">
                  <c:v>96.899270000000001</c:v>
                </c:pt>
                <c:pt idx="1412">
                  <c:v>96.899270000000001</c:v>
                </c:pt>
                <c:pt idx="1413">
                  <c:v>96.902276000000001</c:v>
                </c:pt>
                <c:pt idx="1414">
                  <c:v>96.905735999999976</c:v>
                </c:pt>
                <c:pt idx="1415">
                  <c:v>96.908465000000007</c:v>
                </c:pt>
                <c:pt idx="1416">
                  <c:v>96.912042999999983</c:v>
                </c:pt>
                <c:pt idx="1417">
                  <c:v>96.917248999999998</c:v>
                </c:pt>
                <c:pt idx="1418">
                  <c:v>96.923529000000002</c:v>
                </c:pt>
                <c:pt idx="1419">
                  <c:v>96.931289000000007</c:v>
                </c:pt>
                <c:pt idx="1420">
                  <c:v>96.941272999999995</c:v>
                </c:pt>
                <c:pt idx="1421">
                  <c:v>96.951187000000004</c:v>
                </c:pt>
                <c:pt idx="1422">
                  <c:v>96.957527999999996</c:v>
                </c:pt>
                <c:pt idx="1423">
                  <c:v>96.961833999999996</c:v>
                </c:pt>
                <c:pt idx="1424">
                  <c:v>96.969078999999979</c:v>
                </c:pt>
                <c:pt idx="1425">
                  <c:v>96.979701999999946</c:v>
                </c:pt>
                <c:pt idx="1426">
                  <c:v>96.989481999999981</c:v>
                </c:pt>
                <c:pt idx="1427">
                  <c:v>96.996272000000005</c:v>
                </c:pt>
                <c:pt idx="1428">
                  <c:v>97.002613999999994</c:v>
                </c:pt>
                <c:pt idx="1429">
                  <c:v>97.011454999999998</c:v>
                </c:pt>
                <c:pt idx="1430">
                  <c:v>97.02275599999993</c:v>
                </c:pt>
                <c:pt idx="1431">
                  <c:v>97.034932999999981</c:v>
                </c:pt>
                <c:pt idx="1432">
                  <c:v>97.046789000000004</c:v>
                </c:pt>
                <c:pt idx="1433">
                  <c:v>97.058131999999929</c:v>
                </c:pt>
                <c:pt idx="1434">
                  <c:v>97.070244000000002</c:v>
                </c:pt>
                <c:pt idx="1435">
                  <c:v>97.084153000000001</c:v>
                </c:pt>
                <c:pt idx="1436">
                  <c:v>97.098804999999999</c:v>
                </c:pt>
                <c:pt idx="1437">
                  <c:v>97.112308999999911</c:v>
                </c:pt>
                <c:pt idx="1438">
                  <c:v>97.124469000000005</c:v>
                </c:pt>
                <c:pt idx="1439">
                  <c:v>97.136920000000003</c:v>
                </c:pt>
                <c:pt idx="1440">
                  <c:v>97.150621999999998</c:v>
                </c:pt>
                <c:pt idx="1441">
                  <c:v>97.164568000000003</c:v>
                </c:pt>
                <c:pt idx="1442">
                  <c:v>97.178411999999895</c:v>
                </c:pt>
                <c:pt idx="1443">
                  <c:v>97.193044</c:v>
                </c:pt>
                <c:pt idx="1444">
                  <c:v>97.207228000000001</c:v>
                </c:pt>
                <c:pt idx="1445">
                  <c:v>97.218241000000006</c:v>
                </c:pt>
                <c:pt idx="1446">
                  <c:v>97.227042999999981</c:v>
                </c:pt>
                <c:pt idx="1447">
                  <c:v>97.237590999999995</c:v>
                </c:pt>
                <c:pt idx="1448">
                  <c:v>97.251285999999993</c:v>
                </c:pt>
                <c:pt idx="1449">
                  <c:v>97.266300999999999</c:v>
                </c:pt>
                <c:pt idx="1450">
                  <c:v>97.280269000000004</c:v>
                </c:pt>
                <c:pt idx="1451">
                  <c:v>97.291214999999994</c:v>
                </c:pt>
                <c:pt idx="1452">
                  <c:v>97.299182000000002</c:v>
                </c:pt>
                <c:pt idx="1453">
                  <c:v>97.306689000000006</c:v>
                </c:pt>
                <c:pt idx="1454">
                  <c:v>97.315927000000002</c:v>
                </c:pt>
                <c:pt idx="1455">
                  <c:v>97.326633000000001</c:v>
                </c:pt>
                <c:pt idx="1456">
                  <c:v>97.337045000000003</c:v>
                </c:pt>
                <c:pt idx="1457">
                  <c:v>97.346048999999979</c:v>
                </c:pt>
                <c:pt idx="1458">
                  <c:v>97.354325000000003</c:v>
                </c:pt>
                <c:pt idx="1459">
                  <c:v>97.363226999999995</c:v>
                </c:pt>
                <c:pt idx="1460">
                  <c:v>97.372512999999927</c:v>
                </c:pt>
                <c:pt idx="1461">
                  <c:v>97.379590999999976</c:v>
                </c:pt>
                <c:pt idx="1462">
                  <c:v>97.383197999999979</c:v>
                </c:pt>
                <c:pt idx="1463">
                  <c:v>97.385921999999979</c:v>
                </c:pt>
                <c:pt idx="1464">
                  <c:v>97.390074999999982</c:v>
                </c:pt>
                <c:pt idx="1465">
                  <c:v>97.39536099999998</c:v>
                </c:pt>
                <c:pt idx="1466">
                  <c:v>97.402336999999946</c:v>
                </c:pt>
                <c:pt idx="1467">
                  <c:v>97.411044000000004</c:v>
                </c:pt>
                <c:pt idx="1468">
                  <c:v>97.417602000000002</c:v>
                </c:pt>
                <c:pt idx="1469">
                  <c:v>97.419033999999996</c:v>
                </c:pt>
                <c:pt idx="1470">
                  <c:v>97.417935999999997</c:v>
                </c:pt>
                <c:pt idx="1471">
                  <c:v>97.417268000000007</c:v>
                </c:pt>
                <c:pt idx="1472">
                  <c:v>97.415818999999999</c:v>
                </c:pt>
                <c:pt idx="1473">
                  <c:v>97.412944999999993</c:v>
                </c:pt>
                <c:pt idx="1474">
                  <c:v>97.412173999999993</c:v>
                </c:pt>
                <c:pt idx="1475">
                  <c:v>97.415114000000003</c:v>
                </c:pt>
                <c:pt idx="1476">
                  <c:v>97.418450000000007</c:v>
                </c:pt>
                <c:pt idx="1477">
                  <c:v>97.420878999999928</c:v>
                </c:pt>
                <c:pt idx="1478">
                  <c:v>97.424092999999999</c:v>
                </c:pt>
                <c:pt idx="1479">
                  <c:v>97.42530799999993</c:v>
                </c:pt>
                <c:pt idx="1480">
                  <c:v>97.420983000000007</c:v>
                </c:pt>
                <c:pt idx="1481">
                  <c:v>97.415785</c:v>
                </c:pt>
                <c:pt idx="1482">
                  <c:v>97.415535000000006</c:v>
                </c:pt>
                <c:pt idx="1483">
                  <c:v>97.417319000000006</c:v>
                </c:pt>
                <c:pt idx="1484">
                  <c:v>97.416244000000006</c:v>
                </c:pt>
                <c:pt idx="1485">
                  <c:v>97.413938000000002</c:v>
                </c:pt>
                <c:pt idx="1486">
                  <c:v>97.414617000000007</c:v>
                </c:pt>
                <c:pt idx="1487">
                  <c:v>97.419234000000003</c:v>
                </c:pt>
                <c:pt idx="1488">
                  <c:v>97.427145999999993</c:v>
                </c:pt>
                <c:pt idx="1489">
                  <c:v>97.437766999999994</c:v>
                </c:pt>
                <c:pt idx="1490">
                  <c:v>97.448955999999995</c:v>
                </c:pt>
                <c:pt idx="1491">
                  <c:v>97.458254999999994</c:v>
                </c:pt>
                <c:pt idx="1492">
                  <c:v>97.464425000000006</c:v>
                </c:pt>
                <c:pt idx="1493">
                  <c:v>97.466828000000007</c:v>
                </c:pt>
                <c:pt idx="1494">
                  <c:v>97.468350000000001</c:v>
                </c:pt>
                <c:pt idx="1495">
                  <c:v>97.474729999999994</c:v>
                </c:pt>
                <c:pt idx="1496">
                  <c:v>97.486137999999983</c:v>
                </c:pt>
                <c:pt idx="1497">
                  <c:v>97.496958000000006</c:v>
                </c:pt>
                <c:pt idx="1498">
                  <c:v>97.506545000000003</c:v>
                </c:pt>
                <c:pt idx="1499">
                  <c:v>97.520549000000003</c:v>
                </c:pt>
                <c:pt idx="1500">
                  <c:v>97.540548000000001</c:v>
                </c:pt>
                <c:pt idx="1501">
                  <c:v>97.559573</c:v>
                </c:pt>
                <c:pt idx="1502">
                  <c:v>97.570850999999976</c:v>
                </c:pt>
                <c:pt idx="1503">
                  <c:v>97.577477999999928</c:v>
                </c:pt>
                <c:pt idx="1504">
                  <c:v>97.586715999999981</c:v>
                </c:pt>
                <c:pt idx="1505">
                  <c:v>97.597791000000001</c:v>
                </c:pt>
                <c:pt idx="1506">
                  <c:v>97.60659099999998</c:v>
                </c:pt>
                <c:pt idx="1507">
                  <c:v>97.61597699999993</c:v>
                </c:pt>
                <c:pt idx="1508">
                  <c:v>97.630520000000004</c:v>
                </c:pt>
                <c:pt idx="1509">
                  <c:v>97.649980999999983</c:v>
                </c:pt>
                <c:pt idx="1510">
                  <c:v>97.676321999999928</c:v>
                </c:pt>
                <c:pt idx="1511">
                  <c:v>97.713488999999981</c:v>
                </c:pt>
                <c:pt idx="1512">
                  <c:v>97.750471999999945</c:v>
                </c:pt>
                <c:pt idx="1513">
                  <c:v>97.764273000000003</c:v>
                </c:pt>
                <c:pt idx="1514">
                  <c:v>97.752949999999998</c:v>
                </c:pt>
                <c:pt idx="1515">
                  <c:v>97.740763999999999</c:v>
                </c:pt>
                <c:pt idx="1516">
                  <c:v>97.744563999999997</c:v>
                </c:pt>
                <c:pt idx="1517">
                  <c:v>97.760019999999997</c:v>
                </c:pt>
                <c:pt idx="1518">
                  <c:v>97.778237999999931</c:v>
                </c:pt>
                <c:pt idx="1519">
                  <c:v>97.796796000000001</c:v>
                </c:pt>
                <c:pt idx="1520">
                  <c:v>97.819733999999983</c:v>
                </c:pt>
                <c:pt idx="1521">
                  <c:v>97.855329999999981</c:v>
                </c:pt>
                <c:pt idx="1522">
                  <c:v>97.902638999999979</c:v>
                </c:pt>
                <c:pt idx="1523">
                  <c:v>97.939582000000001</c:v>
                </c:pt>
                <c:pt idx="1524">
                  <c:v>97.948192000000006</c:v>
                </c:pt>
                <c:pt idx="1525">
                  <c:v>97.943794999999994</c:v>
                </c:pt>
                <c:pt idx="1526">
                  <c:v>97.950107000000003</c:v>
                </c:pt>
                <c:pt idx="1527">
                  <c:v>97.966800000000006</c:v>
                </c:pt>
                <c:pt idx="1528">
                  <c:v>97.983867000000004</c:v>
                </c:pt>
                <c:pt idx="1529">
                  <c:v>97.999818000000005</c:v>
                </c:pt>
                <c:pt idx="1530">
                  <c:v>98.015430999999978</c:v>
                </c:pt>
                <c:pt idx="1531">
                  <c:v>98.033421000000004</c:v>
                </c:pt>
                <c:pt idx="1532">
                  <c:v>98.064436999999998</c:v>
                </c:pt>
                <c:pt idx="1533">
                  <c:v>98.112099999999998</c:v>
                </c:pt>
                <c:pt idx="1534">
                  <c:v>98.158664999999999</c:v>
                </c:pt>
                <c:pt idx="1535">
                  <c:v>98.185513</c:v>
                </c:pt>
                <c:pt idx="1536">
                  <c:v>98.196309999999983</c:v>
                </c:pt>
                <c:pt idx="1537">
                  <c:v>98.208956999999998</c:v>
                </c:pt>
                <c:pt idx="1538">
                  <c:v>98.237249000000006</c:v>
                </c:pt>
                <c:pt idx="1539">
                  <c:v>98.271896999999981</c:v>
                </c:pt>
                <c:pt idx="1540">
                  <c:v>98.286018999999982</c:v>
                </c:pt>
                <c:pt idx="1541">
                  <c:v>98.280107000000001</c:v>
                </c:pt>
                <c:pt idx="1542">
                  <c:v>98.296643000000003</c:v>
                </c:pt>
                <c:pt idx="1543">
                  <c:v>98.367050000000006</c:v>
                </c:pt>
                <c:pt idx="1544">
                  <c:v>98.454502000000005</c:v>
                </c:pt>
                <c:pt idx="1545">
                  <c:v>98.483564999999999</c:v>
                </c:pt>
                <c:pt idx="1546">
                  <c:v>98.445044999999993</c:v>
                </c:pt>
                <c:pt idx="1547">
                  <c:v>98.400979000000007</c:v>
                </c:pt>
                <c:pt idx="1548">
                  <c:v>98.387409000000005</c:v>
                </c:pt>
                <c:pt idx="1549">
                  <c:v>98.394370999999978</c:v>
                </c:pt>
                <c:pt idx="1550">
                  <c:v>98.408957999999998</c:v>
                </c:pt>
                <c:pt idx="1551">
                  <c:v>98.430380999999983</c:v>
                </c:pt>
                <c:pt idx="1552">
                  <c:v>98.470933000000002</c:v>
                </c:pt>
                <c:pt idx="1553">
                  <c:v>98.547895999999994</c:v>
                </c:pt>
                <c:pt idx="1554">
                  <c:v>98.647428000000005</c:v>
                </c:pt>
                <c:pt idx="1555">
                  <c:v>98.708436999999975</c:v>
                </c:pt>
                <c:pt idx="1556">
                  <c:v>98.691480999999982</c:v>
                </c:pt>
                <c:pt idx="1557">
                  <c:v>98.643073999999999</c:v>
                </c:pt>
                <c:pt idx="1558">
                  <c:v>98.621857999999946</c:v>
                </c:pt>
                <c:pt idx="1559">
                  <c:v>98.616388999999927</c:v>
                </c:pt>
                <c:pt idx="1560">
                  <c:v>98.597587000000004</c:v>
                </c:pt>
                <c:pt idx="1561">
                  <c:v>98.576880999999929</c:v>
                </c:pt>
                <c:pt idx="1562">
                  <c:v>98.573442999999912</c:v>
                </c:pt>
                <c:pt idx="1563">
                  <c:v>98.593721000000002</c:v>
                </c:pt>
                <c:pt idx="1564">
                  <c:v>98.647898999999981</c:v>
                </c:pt>
                <c:pt idx="1565">
                  <c:v>98.727249</c:v>
                </c:pt>
                <c:pt idx="1566">
                  <c:v>98.789395999999982</c:v>
                </c:pt>
                <c:pt idx="1567">
                  <c:v>98.819577999999979</c:v>
                </c:pt>
                <c:pt idx="1568">
                  <c:v>98.837631000000002</c:v>
                </c:pt>
                <c:pt idx="1569">
                  <c:v>98.824126000000007</c:v>
                </c:pt>
                <c:pt idx="1570">
                  <c:v>98.757142999999999</c:v>
                </c:pt>
                <c:pt idx="1571">
                  <c:v>98.679255999999981</c:v>
                </c:pt>
                <c:pt idx="1572">
                  <c:v>98.637851999999981</c:v>
                </c:pt>
                <c:pt idx="1573">
                  <c:v>98.647036999999983</c:v>
                </c:pt>
                <c:pt idx="1574">
                  <c:v>98.707947000000004</c:v>
                </c:pt>
                <c:pt idx="1575">
                  <c:v>98.781897999999998</c:v>
                </c:pt>
                <c:pt idx="1576">
                  <c:v>98.797584999999998</c:v>
                </c:pt>
                <c:pt idx="1577">
                  <c:v>98.741063999999994</c:v>
                </c:pt>
                <c:pt idx="1578">
                  <c:v>98.669355999999979</c:v>
                </c:pt>
                <c:pt idx="1579">
                  <c:v>98.627501999999978</c:v>
                </c:pt>
                <c:pt idx="1580">
                  <c:v>98.619039999999998</c:v>
                </c:pt>
                <c:pt idx="1581">
                  <c:v>98.631753000000003</c:v>
                </c:pt>
                <c:pt idx="1582">
                  <c:v>98.645735999999928</c:v>
                </c:pt>
                <c:pt idx="1583">
                  <c:v>98.643648999999982</c:v>
                </c:pt>
                <c:pt idx="1584">
                  <c:v>98.63670399999998</c:v>
                </c:pt>
                <c:pt idx="1585">
                  <c:v>98.654671999999977</c:v>
                </c:pt>
                <c:pt idx="1586">
                  <c:v>98.70223799999998</c:v>
                </c:pt>
                <c:pt idx="1587">
                  <c:v>98.740689000000003</c:v>
                </c:pt>
                <c:pt idx="1588">
                  <c:v>98.726553999999993</c:v>
                </c:pt>
                <c:pt idx="1589">
                  <c:v>98.670795999999896</c:v>
                </c:pt>
                <c:pt idx="1590">
                  <c:v>98.625759999999929</c:v>
                </c:pt>
                <c:pt idx="1591">
                  <c:v>98.616809000000003</c:v>
                </c:pt>
                <c:pt idx="1592">
                  <c:v>98.628608999999912</c:v>
                </c:pt>
                <c:pt idx="1593">
                  <c:v>98.641722999999999</c:v>
                </c:pt>
                <c:pt idx="1594">
                  <c:v>98.648268000000002</c:v>
                </c:pt>
                <c:pt idx="1595">
                  <c:v>98.646964999999994</c:v>
                </c:pt>
                <c:pt idx="1596">
                  <c:v>98.650187999999929</c:v>
                </c:pt>
                <c:pt idx="1597">
                  <c:v>98.678736999999856</c:v>
                </c:pt>
                <c:pt idx="1598">
                  <c:v>98.729116000000005</c:v>
                </c:pt>
                <c:pt idx="1599">
                  <c:v>98.768099000000007</c:v>
                </c:pt>
                <c:pt idx="1600">
                  <c:v>98.764008000000004</c:v>
                </c:pt>
                <c:pt idx="1601">
                  <c:v>98.718935999999999</c:v>
                </c:pt>
                <c:pt idx="1602">
                  <c:v>98.691703000000004</c:v>
                </c:pt>
                <c:pt idx="1603">
                  <c:v>98.745604999999998</c:v>
                </c:pt>
                <c:pt idx="1604">
                  <c:v>98.84007099999998</c:v>
                </c:pt>
                <c:pt idx="1605">
                  <c:v>98.876321999999931</c:v>
                </c:pt>
                <c:pt idx="1606">
                  <c:v>98.862409999999983</c:v>
                </c:pt>
                <c:pt idx="1607">
                  <c:v>98.861017000000004</c:v>
                </c:pt>
                <c:pt idx="1608">
                  <c:v>98.841341</c:v>
                </c:pt>
                <c:pt idx="1609">
                  <c:v>98.757355000000004</c:v>
                </c:pt>
                <c:pt idx="1610">
                  <c:v>98.656863000000001</c:v>
                </c:pt>
                <c:pt idx="1611">
                  <c:v>98.601484999999983</c:v>
                </c:pt>
                <c:pt idx="1612">
                  <c:v>98.583382999999927</c:v>
                </c:pt>
                <c:pt idx="1613">
                  <c:v>98.568404000000001</c:v>
                </c:pt>
                <c:pt idx="1614">
                  <c:v>98.554512000000003</c:v>
                </c:pt>
                <c:pt idx="1615">
                  <c:v>98.554759000000004</c:v>
                </c:pt>
                <c:pt idx="1616">
                  <c:v>98.565989999999999</c:v>
                </c:pt>
                <c:pt idx="1617">
                  <c:v>98.572507999999928</c:v>
                </c:pt>
                <c:pt idx="1618">
                  <c:v>98.558978999999894</c:v>
                </c:pt>
                <c:pt idx="1619">
                  <c:v>98.528526999999983</c:v>
                </c:pt>
                <c:pt idx="1620">
                  <c:v>98.506073000000001</c:v>
                </c:pt>
                <c:pt idx="1621">
                  <c:v>98.507949999999994</c:v>
                </c:pt>
                <c:pt idx="1622">
                  <c:v>98.521366</c:v>
                </c:pt>
                <c:pt idx="1623">
                  <c:v>98.523977999999929</c:v>
                </c:pt>
                <c:pt idx="1624">
                  <c:v>98.513059999999996</c:v>
                </c:pt>
                <c:pt idx="1625">
                  <c:v>98.500218000000004</c:v>
                </c:pt>
                <c:pt idx="1626">
                  <c:v>98.488977999999946</c:v>
                </c:pt>
                <c:pt idx="1627">
                  <c:v>98.478157999999979</c:v>
                </c:pt>
                <c:pt idx="1628">
                  <c:v>98.471768999999981</c:v>
                </c:pt>
                <c:pt idx="1629">
                  <c:v>98.475660000000005</c:v>
                </c:pt>
                <c:pt idx="1630">
                  <c:v>98.492857000000001</c:v>
                </c:pt>
                <c:pt idx="1631">
                  <c:v>98.521289999999993</c:v>
                </c:pt>
                <c:pt idx="1632">
                  <c:v>98.564521999999997</c:v>
                </c:pt>
                <c:pt idx="1633">
                  <c:v>98.62058399999998</c:v>
                </c:pt>
                <c:pt idx="1634">
                  <c:v>98.651334999999946</c:v>
                </c:pt>
                <c:pt idx="1635">
                  <c:v>98.634015000000005</c:v>
                </c:pt>
                <c:pt idx="1636">
                  <c:v>98.60330699999993</c:v>
                </c:pt>
                <c:pt idx="1637">
                  <c:v>98.573171999999929</c:v>
                </c:pt>
                <c:pt idx="1638">
                  <c:v>98.527276999999998</c:v>
                </c:pt>
                <c:pt idx="1639">
                  <c:v>98.496886000000003</c:v>
                </c:pt>
                <c:pt idx="1640">
                  <c:v>98.527530999999982</c:v>
                </c:pt>
                <c:pt idx="1641">
                  <c:v>98.592300999999978</c:v>
                </c:pt>
                <c:pt idx="1642">
                  <c:v>98.627211000000003</c:v>
                </c:pt>
                <c:pt idx="1643">
                  <c:v>98.626142999999928</c:v>
                </c:pt>
                <c:pt idx="1644">
                  <c:v>98.61094199999998</c:v>
                </c:pt>
                <c:pt idx="1645">
                  <c:v>98.571896999999979</c:v>
                </c:pt>
                <c:pt idx="1646">
                  <c:v>98.516940000000005</c:v>
                </c:pt>
                <c:pt idx="1647">
                  <c:v>98.481789000000006</c:v>
                </c:pt>
                <c:pt idx="1648">
                  <c:v>98.477273999999994</c:v>
                </c:pt>
                <c:pt idx="1649">
                  <c:v>98.492477999999977</c:v>
                </c:pt>
                <c:pt idx="1650">
                  <c:v>98.521179000000004</c:v>
                </c:pt>
                <c:pt idx="1651">
                  <c:v>98.568254999999994</c:v>
                </c:pt>
                <c:pt idx="1652">
                  <c:v>98.62441699999998</c:v>
                </c:pt>
                <c:pt idx="1653">
                  <c:v>98.643713000000005</c:v>
                </c:pt>
                <c:pt idx="1654">
                  <c:v>98.600884999999977</c:v>
                </c:pt>
                <c:pt idx="1655">
                  <c:v>98.532961999999998</c:v>
                </c:pt>
                <c:pt idx="1656">
                  <c:v>98.478166000000002</c:v>
                </c:pt>
                <c:pt idx="1657">
                  <c:v>98.446211000000005</c:v>
                </c:pt>
                <c:pt idx="1658">
                  <c:v>98.460052000000005</c:v>
                </c:pt>
                <c:pt idx="1659">
                  <c:v>98.556720999999982</c:v>
                </c:pt>
                <c:pt idx="1660">
                  <c:v>98.709757999999979</c:v>
                </c:pt>
                <c:pt idx="1661">
                  <c:v>98.789147999999983</c:v>
                </c:pt>
                <c:pt idx="1662">
                  <c:v>98.706467000000004</c:v>
                </c:pt>
                <c:pt idx="1663">
                  <c:v>98.554349000000002</c:v>
                </c:pt>
                <c:pt idx="1664">
                  <c:v>98.465793000000005</c:v>
                </c:pt>
                <c:pt idx="1665">
                  <c:v>98.459789000000001</c:v>
                </c:pt>
                <c:pt idx="1666">
                  <c:v>98.483366000000004</c:v>
                </c:pt>
                <c:pt idx="1667">
                  <c:v>98.501069000000001</c:v>
                </c:pt>
                <c:pt idx="1668">
                  <c:v>98.518859000000006</c:v>
                </c:pt>
                <c:pt idx="1669">
                  <c:v>98.539113</c:v>
                </c:pt>
                <c:pt idx="1670">
                  <c:v>98.533399000000003</c:v>
                </c:pt>
                <c:pt idx="1671">
                  <c:v>98.492929000000004</c:v>
                </c:pt>
                <c:pt idx="1672">
                  <c:v>98.447801999999996</c:v>
                </c:pt>
                <c:pt idx="1673">
                  <c:v>98.42542899999998</c:v>
                </c:pt>
                <c:pt idx="1674">
                  <c:v>98.429341999999977</c:v>
                </c:pt>
                <c:pt idx="1675">
                  <c:v>98.443415000000002</c:v>
                </c:pt>
                <c:pt idx="1676">
                  <c:v>98.457110999999998</c:v>
                </c:pt>
                <c:pt idx="1677">
                  <c:v>98.468886999999981</c:v>
                </c:pt>
                <c:pt idx="1678">
                  <c:v>98.465120999999996</c:v>
                </c:pt>
                <c:pt idx="1679">
                  <c:v>98.447999999999993</c:v>
                </c:pt>
                <c:pt idx="1680">
                  <c:v>98.437830000000005</c:v>
                </c:pt>
                <c:pt idx="1681">
                  <c:v>98.425931999999946</c:v>
                </c:pt>
                <c:pt idx="1682">
                  <c:v>98.402553999999995</c:v>
                </c:pt>
                <c:pt idx="1683">
                  <c:v>98.395751999999931</c:v>
                </c:pt>
                <c:pt idx="1684">
                  <c:v>98.424170000000004</c:v>
                </c:pt>
                <c:pt idx="1685">
                  <c:v>98.465862000000001</c:v>
                </c:pt>
                <c:pt idx="1686">
                  <c:v>98.489151000000007</c:v>
                </c:pt>
                <c:pt idx="1687">
                  <c:v>98.476118</c:v>
                </c:pt>
                <c:pt idx="1688">
                  <c:v>98.429182999999981</c:v>
                </c:pt>
                <c:pt idx="1689">
                  <c:v>98.374383999999978</c:v>
                </c:pt>
                <c:pt idx="1690">
                  <c:v>98.338829000000004</c:v>
                </c:pt>
                <c:pt idx="1691">
                  <c:v>98.327605000000005</c:v>
                </c:pt>
                <c:pt idx="1692">
                  <c:v>98.334537999999981</c:v>
                </c:pt>
                <c:pt idx="1693">
                  <c:v>98.352569000000003</c:v>
                </c:pt>
                <c:pt idx="1694">
                  <c:v>98.366769000000005</c:v>
                </c:pt>
                <c:pt idx="1695">
                  <c:v>98.363710999999981</c:v>
                </c:pt>
                <c:pt idx="1696">
                  <c:v>98.349583999999993</c:v>
                </c:pt>
                <c:pt idx="1697">
                  <c:v>98.339116000000004</c:v>
                </c:pt>
                <c:pt idx="1698">
                  <c:v>98.333911000000001</c:v>
                </c:pt>
                <c:pt idx="1699">
                  <c:v>98.329231999999976</c:v>
                </c:pt>
                <c:pt idx="1700">
                  <c:v>98.32814699999993</c:v>
                </c:pt>
                <c:pt idx="1701">
                  <c:v>98.331211999999994</c:v>
                </c:pt>
                <c:pt idx="1702">
                  <c:v>98.328468999999927</c:v>
                </c:pt>
                <c:pt idx="1703">
                  <c:v>98.315769000000003</c:v>
                </c:pt>
                <c:pt idx="1704">
                  <c:v>98.302730999999895</c:v>
                </c:pt>
                <c:pt idx="1705">
                  <c:v>98.298565999999994</c:v>
                </c:pt>
                <c:pt idx="1706">
                  <c:v>98.302374999999927</c:v>
                </c:pt>
                <c:pt idx="1707">
                  <c:v>98.306417999999979</c:v>
                </c:pt>
                <c:pt idx="1708">
                  <c:v>98.305903000000001</c:v>
                </c:pt>
                <c:pt idx="1709">
                  <c:v>98.304176999999981</c:v>
                </c:pt>
                <c:pt idx="1710">
                  <c:v>98.303076999999931</c:v>
                </c:pt>
                <c:pt idx="1711">
                  <c:v>98.298134000000005</c:v>
                </c:pt>
                <c:pt idx="1712">
                  <c:v>98.288477999999927</c:v>
                </c:pt>
                <c:pt idx="1713">
                  <c:v>98.27924299999998</c:v>
                </c:pt>
                <c:pt idx="1714">
                  <c:v>98.274325000000005</c:v>
                </c:pt>
                <c:pt idx="1715">
                  <c:v>98.273262000000003</c:v>
                </c:pt>
                <c:pt idx="1716">
                  <c:v>98.272863999999998</c:v>
                </c:pt>
                <c:pt idx="1717">
                  <c:v>98.270425000000003</c:v>
                </c:pt>
                <c:pt idx="1718">
                  <c:v>98.265822999999983</c:v>
                </c:pt>
                <c:pt idx="1719">
                  <c:v>98.261178000000001</c:v>
                </c:pt>
                <c:pt idx="1720">
                  <c:v>98.258617000000001</c:v>
                </c:pt>
                <c:pt idx="1721">
                  <c:v>98.258028999999979</c:v>
                </c:pt>
                <c:pt idx="1722">
                  <c:v>98.257946000000004</c:v>
                </c:pt>
                <c:pt idx="1723">
                  <c:v>98.257470999999981</c:v>
                </c:pt>
                <c:pt idx="1724">
                  <c:v>98.256145000000004</c:v>
                </c:pt>
                <c:pt idx="1725">
                  <c:v>98.253895</c:v>
                </c:pt>
                <c:pt idx="1726">
                  <c:v>98.251213000000007</c:v>
                </c:pt>
                <c:pt idx="1727">
                  <c:v>98.248394000000005</c:v>
                </c:pt>
                <c:pt idx="1728">
                  <c:v>98.245461000000006</c:v>
                </c:pt>
                <c:pt idx="1729">
                  <c:v>98.242580000000004</c:v>
                </c:pt>
                <c:pt idx="1730">
                  <c:v>98.240193000000005</c:v>
                </c:pt>
                <c:pt idx="1731">
                  <c:v>98.239070000000012</c:v>
                </c:pt>
                <c:pt idx="1732">
                  <c:v>98.239129000000005</c:v>
                </c:pt>
                <c:pt idx="1733">
                  <c:v>98.238717999999977</c:v>
                </c:pt>
                <c:pt idx="1734">
                  <c:v>98.236383000000004</c:v>
                </c:pt>
                <c:pt idx="1735">
                  <c:v>98.232658000000001</c:v>
                </c:pt>
                <c:pt idx="1736">
                  <c:v>98.229220999999995</c:v>
                </c:pt>
                <c:pt idx="1737">
                  <c:v>98.226391999999976</c:v>
                </c:pt>
                <c:pt idx="1738">
                  <c:v>98.223317999999978</c:v>
                </c:pt>
              </c:numCache>
            </c:numRef>
          </c:yVal>
          <c:smooth val="1"/>
        </c:ser>
        <c:dLbls>
          <c:showLegendKey val="0"/>
          <c:showVal val="0"/>
          <c:showCatName val="0"/>
          <c:showSerName val="0"/>
          <c:showPercent val="0"/>
          <c:showBubbleSize val="0"/>
        </c:dLbls>
        <c:axId val="76495104"/>
        <c:axId val="76497280"/>
      </c:scatterChart>
      <c:valAx>
        <c:axId val="76495104"/>
        <c:scaling>
          <c:orientation val="maxMin"/>
          <c:max val="4000"/>
          <c:min val="600"/>
        </c:scaling>
        <c:delete val="0"/>
        <c:axPos val="b"/>
        <c:majorGridlines/>
        <c:title>
          <c:tx>
            <c:rich>
              <a:bodyPr/>
              <a:lstStyle/>
              <a:p>
                <a:pPr>
                  <a:defRPr/>
                </a:pPr>
                <a:r>
                  <a:rPr lang="en-US" baseline="0"/>
                  <a:t>cm</a:t>
                </a:r>
                <a:r>
                  <a:rPr lang="en-US" baseline="30000"/>
                  <a:t>-1</a:t>
                </a:r>
              </a:p>
            </c:rich>
          </c:tx>
          <c:layout/>
          <c:overlay val="0"/>
        </c:title>
        <c:numFmt formatCode="General" sourceLinked="1"/>
        <c:majorTickMark val="out"/>
        <c:minorTickMark val="none"/>
        <c:tickLblPos val="nextTo"/>
        <c:txPr>
          <a:bodyPr/>
          <a:lstStyle/>
          <a:p>
            <a:pPr>
              <a:defRPr sz="1800" baseline="0"/>
            </a:pPr>
            <a:endParaRPr lang="en-US"/>
          </a:p>
        </c:txPr>
        <c:crossAx val="76497280"/>
        <c:crosses val="autoZero"/>
        <c:crossBetween val="midCat"/>
        <c:majorUnit val="500"/>
      </c:valAx>
      <c:valAx>
        <c:axId val="76497280"/>
        <c:scaling>
          <c:orientation val="minMax"/>
          <c:min val="84"/>
        </c:scaling>
        <c:delete val="0"/>
        <c:axPos val="r"/>
        <c:majorGridlines>
          <c:spPr>
            <a:ln>
              <a:noFill/>
            </a:ln>
          </c:spPr>
        </c:majorGridlines>
        <c:title>
          <c:tx>
            <c:rich>
              <a:bodyPr rot="-5400000" vert="horz"/>
              <a:lstStyle/>
              <a:p>
                <a:pPr>
                  <a:defRPr/>
                </a:pPr>
                <a:r>
                  <a:rPr lang="en-US"/>
                  <a:t>Transmittance %</a:t>
                </a:r>
              </a:p>
            </c:rich>
          </c:tx>
          <c:layout/>
          <c:overlay val="0"/>
        </c:title>
        <c:numFmt formatCode="General" sourceLinked="1"/>
        <c:majorTickMark val="out"/>
        <c:minorTickMark val="none"/>
        <c:tickLblPos val="nextTo"/>
        <c:txPr>
          <a:bodyPr/>
          <a:lstStyle/>
          <a:p>
            <a:pPr>
              <a:defRPr sz="1800" baseline="0"/>
            </a:pPr>
            <a:endParaRPr lang="en-US"/>
          </a:p>
        </c:txPr>
        <c:crossAx val="76495104"/>
        <c:crosses val="autoZero"/>
        <c:crossBetween val="midCat"/>
      </c:valAx>
    </c:plotArea>
    <c:legend>
      <c:legendPos val="r"/>
      <c:layout/>
      <c:overlay val="0"/>
    </c:legend>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8542311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68460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9183278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26759194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5BD790A-85F4-49F2-881C-B4D1E51CD637}" type="datetimeFigureOut">
              <a:rPr lang="en-US" smtClean="0"/>
              <a:t>6/1/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5853916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5BD790A-85F4-49F2-881C-B4D1E51CD637}" type="datetimeFigureOut">
              <a:rPr lang="en-US" smtClean="0"/>
              <a:t>6/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14721845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5BD790A-85F4-49F2-881C-B4D1E51CD637}" type="datetimeFigureOut">
              <a:rPr lang="en-US" smtClean="0"/>
              <a:t>6/1/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196952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5BD790A-85F4-49F2-881C-B4D1E51CD637}" type="datetimeFigureOut">
              <a:rPr lang="en-US" smtClean="0"/>
              <a:t>6/1/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28240593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5BD790A-85F4-49F2-881C-B4D1E51CD637}" type="datetimeFigureOut">
              <a:rPr lang="en-US" smtClean="0"/>
              <a:t>6/1/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26595495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5BD790A-85F4-49F2-881C-B4D1E51CD637}" type="datetimeFigureOut">
              <a:rPr lang="en-US" smtClean="0"/>
              <a:t>6/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7363311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5BD790A-85F4-49F2-881C-B4D1E51CD637}" type="datetimeFigureOut">
              <a:rPr lang="en-US" smtClean="0"/>
              <a:t>6/1/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98F558-CAEE-4935-854F-D0929B35F482}" type="slidenum">
              <a:rPr lang="en-US" smtClean="0"/>
              <a:t>‹#›</a:t>
            </a:fld>
            <a:endParaRPr lang="en-US"/>
          </a:p>
        </p:txBody>
      </p:sp>
    </p:spTree>
    <p:extLst>
      <p:ext uri="{BB962C8B-B14F-4D97-AF65-F5344CB8AC3E}">
        <p14:creationId xmlns:p14="http://schemas.microsoft.com/office/powerpoint/2010/main" val="36566604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5BD790A-85F4-49F2-881C-B4D1E51CD637}" type="datetimeFigureOut">
              <a:rPr lang="en-US" smtClean="0"/>
              <a:t>6/1/201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398F558-CAEE-4935-854F-D0929B35F482}" type="slidenum">
              <a:rPr lang="en-US" smtClean="0"/>
              <a:t>‹#›</a:t>
            </a:fld>
            <a:endParaRPr lang="en-US"/>
          </a:p>
        </p:txBody>
      </p:sp>
    </p:spTree>
    <p:extLst>
      <p:ext uri="{BB962C8B-B14F-4D97-AF65-F5344CB8AC3E}">
        <p14:creationId xmlns:p14="http://schemas.microsoft.com/office/powerpoint/2010/main" val="25929731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chart" Target="../charts/chart3.xml"/><Relationship Id="rId5" Type="http://schemas.openxmlformats.org/officeDocument/2006/relationships/chart" Target="../charts/char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p:cNvGrpSpPr/>
          <p:nvPr/>
        </p:nvGrpSpPr>
        <p:grpSpPr>
          <a:xfrm>
            <a:off x="0" y="-76200"/>
            <a:ext cx="9144000" cy="7086600"/>
            <a:chOff x="0" y="-76200"/>
            <a:chExt cx="9144000" cy="7086600"/>
          </a:xfrm>
        </p:grpSpPr>
        <p:grpSp>
          <p:nvGrpSpPr>
            <p:cNvPr id="3" name="Group 2"/>
            <p:cNvGrpSpPr/>
            <p:nvPr/>
          </p:nvGrpSpPr>
          <p:grpSpPr>
            <a:xfrm>
              <a:off x="0" y="-76200"/>
              <a:ext cx="9116842" cy="7086600"/>
              <a:chOff x="0" y="-76200"/>
              <a:chExt cx="9116842" cy="7086600"/>
            </a:xfrm>
          </p:grpSpPr>
          <p:pic>
            <p:nvPicPr>
              <p:cNvPr id="8" name="Picture 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553200" y="4320046"/>
                <a:ext cx="2563642" cy="2294243"/>
              </a:xfrm>
              <a:prstGeom prst="rect">
                <a:avLst/>
              </a:prstGeom>
              <a:noFill/>
              <a:extLst>
                <a:ext uri="{909E8E84-426E-40DD-AFC4-6F175D3DCCD1}">
                  <a14:hiddenFill xmlns:a14="http://schemas.microsoft.com/office/drawing/2010/main">
                    <a:solidFill>
                      <a:srgbClr val="FFFFFF"/>
                    </a:solidFill>
                  </a14:hiddenFill>
                </a:ext>
              </a:extLst>
            </p:spPr>
          </p:pic>
          <p:graphicFrame>
            <p:nvGraphicFramePr>
              <p:cNvPr id="4" name="Chart 3"/>
              <p:cNvGraphicFramePr>
                <a:graphicFrameLocks/>
              </p:cNvGraphicFramePr>
              <p:nvPr>
                <p:extLst>
                  <p:ext uri="{D42A27DB-BD31-4B8C-83A1-F6EECF244321}">
                    <p14:modId xmlns:p14="http://schemas.microsoft.com/office/powerpoint/2010/main" val="2432444756"/>
                  </p:ext>
                </p:extLst>
              </p:nvPr>
            </p:nvGraphicFramePr>
            <p:xfrm>
              <a:off x="1" y="-76200"/>
              <a:ext cx="3505200" cy="1981200"/>
            </p:xfrm>
            <a:graphic>
              <a:graphicData uri="http://schemas.openxmlformats.org/drawingml/2006/chart">
                <c:chart xmlns:c="http://schemas.openxmlformats.org/drawingml/2006/chart" xmlns:r="http://schemas.openxmlformats.org/officeDocument/2006/relationships" r:id="rId3"/>
              </a:graphicData>
            </a:graphic>
          </p:graphicFrame>
          <p:pic>
            <p:nvPicPr>
              <p:cNvPr id="5" name="Picture 4"/>
              <p:cNvPicPr>
                <a:picLocks noChangeAspect="1" noChangeArrowheads="1"/>
              </p:cNvPicPr>
              <p:nvPr/>
            </p:nvPicPr>
            <p:blipFill>
              <a:blip r:embed="rId4" cstate="print"/>
              <a:srcRect/>
              <a:stretch>
                <a:fillRect/>
              </a:stretch>
            </p:blipFill>
            <p:spPr bwMode="auto">
              <a:xfrm>
                <a:off x="4056300" y="381000"/>
                <a:ext cx="4856981" cy="3733800"/>
              </a:xfrm>
              <a:prstGeom prst="rect">
                <a:avLst/>
              </a:prstGeom>
              <a:noFill/>
            </p:spPr>
          </p:pic>
          <p:graphicFrame>
            <p:nvGraphicFramePr>
              <p:cNvPr id="6" name="Chart 5"/>
              <p:cNvGraphicFramePr>
                <a:graphicFrameLocks/>
              </p:cNvGraphicFramePr>
              <p:nvPr>
                <p:extLst>
                  <p:ext uri="{D42A27DB-BD31-4B8C-83A1-F6EECF244321}">
                    <p14:modId xmlns:p14="http://schemas.microsoft.com/office/powerpoint/2010/main" val="2091677082"/>
                  </p:ext>
                </p:extLst>
              </p:nvPr>
            </p:nvGraphicFramePr>
            <p:xfrm>
              <a:off x="0" y="1658294"/>
              <a:ext cx="3505200" cy="2286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Chart 6"/>
              <p:cNvGraphicFramePr>
                <a:graphicFrameLocks/>
              </p:cNvGraphicFramePr>
              <p:nvPr>
                <p:extLst>
                  <p:ext uri="{D42A27DB-BD31-4B8C-83A1-F6EECF244321}">
                    <p14:modId xmlns:p14="http://schemas.microsoft.com/office/powerpoint/2010/main" val="2405059018"/>
                  </p:ext>
                </p:extLst>
              </p:nvPr>
            </p:nvGraphicFramePr>
            <p:xfrm>
              <a:off x="11317" y="4175760"/>
              <a:ext cx="6585860" cy="2834640"/>
            </p:xfrm>
            <a:graphic>
              <a:graphicData uri="http://schemas.openxmlformats.org/drawingml/2006/chart">
                <c:chart xmlns:c="http://schemas.openxmlformats.org/drawingml/2006/chart" xmlns:r="http://schemas.openxmlformats.org/officeDocument/2006/relationships" r:id="rId6"/>
              </a:graphicData>
            </a:graphic>
          </p:graphicFrame>
          <p:sp>
            <p:nvSpPr>
              <p:cNvPr id="9" name="TextBox 8"/>
              <p:cNvSpPr txBox="1"/>
              <p:nvPr/>
            </p:nvSpPr>
            <p:spPr>
              <a:xfrm>
                <a:off x="4706842" y="65637"/>
                <a:ext cx="3141758" cy="369332"/>
              </a:xfrm>
              <a:prstGeom prst="rect">
                <a:avLst/>
              </a:prstGeom>
              <a:noFill/>
            </p:spPr>
            <p:txBody>
              <a:bodyPr wrap="none" rtlCol="0">
                <a:spAutoFit/>
              </a:bodyPr>
              <a:lstStyle/>
              <a:p>
                <a:r>
                  <a:rPr lang="en-US" b="1" dirty="0" smtClean="0"/>
                  <a:t>Nano Particle Tracking Analysis</a:t>
                </a:r>
              </a:p>
            </p:txBody>
          </p:sp>
          <p:sp>
            <p:nvSpPr>
              <p:cNvPr id="10" name="TextBox 9"/>
              <p:cNvSpPr txBox="1"/>
              <p:nvPr/>
            </p:nvSpPr>
            <p:spPr>
              <a:xfrm>
                <a:off x="5715000" y="1600200"/>
                <a:ext cx="1449436" cy="646331"/>
              </a:xfrm>
              <a:prstGeom prst="rect">
                <a:avLst/>
              </a:prstGeom>
              <a:noFill/>
            </p:spPr>
            <p:txBody>
              <a:bodyPr wrap="none" rtlCol="0">
                <a:spAutoFit/>
              </a:bodyPr>
              <a:lstStyle/>
              <a:p>
                <a:r>
                  <a:rPr lang="en-US" dirty="0" smtClean="0">
                    <a:solidFill>
                      <a:srgbClr val="FF0000"/>
                    </a:solidFill>
                  </a:rPr>
                  <a:t>Mean: 92nm</a:t>
                </a:r>
              </a:p>
              <a:p>
                <a:r>
                  <a:rPr lang="en-US" dirty="0" smtClean="0">
                    <a:solidFill>
                      <a:srgbClr val="FF0000"/>
                    </a:solidFill>
                  </a:rPr>
                  <a:t>Mode:  81nm</a:t>
                </a:r>
                <a:endParaRPr lang="en-US" dirty="0">
                  <a:solidFill>
                    <a:srgbClr val="FF0000"/>
                  </a:solidFill>
                </a:endParaRPr>
              </a:p>
            </p:txBody>
          </p:sp>
          <p:sp>
            <p:nvSpPr>
              <p:cNvPr id="11" name="TextBox 10"/>
              <p:cNvSpPr txBox="1"/>
              <p:nvPr/>
            </p:nvSpPr>
            <p:spPr>
              <a:xfrm>
                <a:off x="76200" y="87868"/>
                <a:ext cx="324128" cy="369332"/>
              </a:xfrm>
              <a:prstGeom prst="rect">
                <a:avLst/>
              </a:prstGeom>
              <a:noFill/>
            </p:spPr>
            <p:txBody>
              <a:bodyPr wrap="none" rtlCol="0">
                <a:spAutoFit/>
              </a:bodyPr>
              <a:lstStyle/>
              <a:p>
                <a:r>
                  <a:rPr lang="en-US" b="1" dirty="0" smtClean="0"/>
                  <a:t>A</a:t>
                </a:r>
                <a:endParaRPr lang="en-US" b="1" dirty="0"/>
              </a:p>
            </p:txBody>
          </p:sp>
          <p:sp>
            <p:nvSpPr>
              <p:cNvPr id="13" name="TextBox 12"/>
              <p:cNvSpPr txBox="1"/>
              <p:nvPr/>
            </p:nvSpPr>
            <p:spPr>
              <a:xfrm>
                <a:off x="4011035" y="11668"/>
                <a:ext cx="314510" cy="369332"/>
              </a:xfrm>
              <a:prstGeom prst="rect">
                <a:avLst/>
              </a:prstGeom>
              <a:noFill/>
            </p:spPr>
            <p:txBody>
              <a:bodyPr wrap="none" rtlCol="0">
                <a:spAutoFit/>
              </a:bodyPr>
              <a:lstStyle/>
              <a:p>
                <a:r>
                  <a:rPr lang="en-US" b="1" dirty="0"/>
                  <a:t>B</a:t>
                </a:r>
              </a:p>
            </p:txBody>
          </p:sp>
          <p:sp>
            <p:nvSpPr>
              <p:cNvPr id="15" name="TextBox 14"/>
              <p:cNvSpPr txBox="1"/>
              <p:nvPr/>
            </p:nvSpPr>
            <p:spPr>
              <a:xfrm>
                <a:off x="5277" y="4175760"/>
                <a:ext cx="306494" cy="369332"/>
              </a:xfrm>
              <a:prstGeom prst="rect">
                <a:avLst/>
              </a:prstGeom>
              <a:noFill/>
            </p:spPr>
            <p:txBody>
              <a:bodyPr wrap="none" rtlCol="0">
                <a:spAutoFit/>
              </a:bodyPr>
              <a:lstStyle/>
              <a:p>
                <a:r>
                  <a:rPr lang="en-US" b="1" dirty="0"/>
                  <a:t>C</a:t>
                </a:r>
              </a:p>
            </p:txBody>
          </p:sp>
          <p:sp>
            <p:nvSpPr>
              <p:cNvPr id="2" name="TextBox 1"/>
              <p:cNvSpPr txBox="1"/>
              <p:nvPr/>
            </p:nvSpPr>
            <p:spPr>
              <a:xfrm>
                <a:off x="2980853" y="852407"/>
                <a:ext cx="840295" cy="492443"/>
              </a:xfrm>
              <a:prstGeom prst="rect">
                <a:avLst/>
              </a:prstGeom>
              <a:solidFill>
                <a:schemeClr val="bg1"/>
              </a:solidFill>
            </p:spPr>
            <p:txBody>
              <a:bodyPr wrap="none" rtlCol="0">
                <a:spAutoFit/>
              </a:bodyPr>
              <a:lstStyle/>
              <a:p>
                <a:r>
                  <a:rPr lang="en-US" sz="1300" dirty="0" smtClean="0"/>
                  <a:t>ATCA</a:t>
                </a:r>
              </a:p>
              <a:p>
                <a:r>
                  <a:rPr lang="en-US" sz="1300" dirty="0" smtClean="0"/>
                  <a:t>Liposome</a:t>
                </a:r>
              </a:p>
            </p:txBody>
          </p:sp>
          <p:sp>
            <p:nvSpPr>
              <p:cNvPr id="14" name="TextBox 13"/>
              <p:cNvSpPr txBox="1"/>
              <p:nvPr/>
            </p:nvSpPr>
            <p:spPr>
              <a:xfrm>
                <a:off x="2966683" y="2745144"/>
                <a:ext cx="840295" cy="492443"/>
              </a:xfrm>
              <a:prstGeom prst="rect">
                <a:avLst/>
              </a:prstGeom>
              <a:solidFill>
                <a:schemeClr val="bg1"/>
              </a:solidFill>
            </p:spPr>
            <p:txBody>
              <a:bodyPr wrap="none" rtlCol="0">
                <a:spAutoFit/>
              </a:bodyPr>
              <a:lstStyle/>
              <a:p>
                <a:r>
                  <a:rPr lang="en-US" sz="1300" dirty="0" smtClean="0"/>
                  <a:t>ATCA</a:t>
                </a:r>
              </a:p>
              <a:p>
                <a:r>
                  <a:rPr lang="en-US" sz="1300" dirty="0" smtClean="0"/>
                  <a:t>Liposome</a:t>
                </a:r>
              </a:p>
            </p:txBody>
          </p:sp>
          <p:sp>
            <p:nvSpPr>
              <p:cNvPr id="16" name="TextBox 15"/>
              <p:cNvSpPr txBox="1"/>
              <p:nvPr/>
            </p:nvSpPr>
            <p:spPr>
              <a:xfrm>
                <a:off x="5942485" y="5227116"/>
                <a:ext cx="840295" cy="692497"/>
              </a:xfrm>
              <a:prstGeom prst="rect">
                <a:avLst/>
              </a:prstGeom>
              <a:solidFill>
                <a:schemeClr val="bg1"/>
              </a:solidFill>
            </p:spPr>
            <p:txBody>
              <a:bodyPr wrap="none" rtlCol="0">
                <a:spAutoFit/>
              </a:bodyPr>
              <a:lstStyle/>
              <a:p>
                <a:r>
                  <a:rPr lang="en-US" sz="1300" dirty="0" smtClean="0"/>
                  <a:t>Liposome</a:t>
                </a:r>
              </a:p>
              <a:p>
                <a:r>
                  <a:rPr lang="en-US" sz="1300" dirty="0" smtClean="0"/>
                  <a:t>ATCA</a:t>
                </a:r>
              </a:p>
              <a:p>
                <a:r>
                  <a:rPr lang="en-US" sz="1300" dirty="0" smtClean="0"/>
                  <a:t>TMS</a:t>
                </a:r>
              </a:p>
            </p:txBody>
          </p:sp>
        </p:grpSp>
        <p:sp>
          <p:nvSpPr>
            <p:cNvPr id="17" name="Rectangle 16"/>
            <p:cNvSpPr/>
            <p:nvPr/>
          </p:nvSpPr>
          <p:spPr>
            <a:xfrm>
              <a:off x="38766" y="27158"/>
              <a:ext cx="3829328" cy="414860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4011035" y="24835"/>
              <a:ext cx="4954628" cy="415092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p:cNvCxnSpPr/>
            <p:nvPr/>
          </p:nvCxnSpPr>
          <p:spPr>
            <a:xfrm>
              <a:off x="0" y="4249094"/>
              <a:ext cx="9144000" cy="0"/>
            </a:xfrm>
            <a:prstGeom prst="line">
              <a:avLst/>
            </a:prstGeom>
            <a:ln w="28575"/>
          </p:spPr>
          <p:style>
            <a:lnRef idx="1">
              <a:schemeClr val="dk1"/>
            </a:lnRef>
            <a:fillRef idx="0">
              <a:schemeClr val="dk1"/>
            </a:fillRef>
            <a:effectRef idx="0">
              <a:schemeClr val="dk1"/>
            </a:effectRef>
            <a:fontRef idx="minor">
              <a:schemeClr val="tx1"/>
            </a:fontRef>
          </p:style>
        </p:cxnSp>
      </p:grpSp>
      <p:sp>
        <p:nvSpPr>
          <p:cNvPr id="19" name="TextBox 18"/>
          <p:cNvSpPr txBox="1"/>
          <p:nvPr/>
        </p:nvSpPr>
        <p:spPr>
          <a:xfrm>
            <a:off x="408983" y="3745468"/>
            <a:ext cx="2562817" cy="369332"/>
          </a:xfrm>
          <a:prstGeom prst="rect">
            <a:avLst/>
          </a:prstGeom>
          <a:noFill/>
        </p:spPr>
        <p:txBody>
          <a:bodyPr wrap="none" rtlCol="0">
            <a:spAutoFit/>
          </a:bodyPr>
          <a:lstStyle/>
          <a:p>
            <a:r>
              <a:rPr lang="en-US" b="1" dirty="0" err="1" smtClean="0"/>
              <a:t>Relaxivity</a:t>
            </a:r>
            <a:r>
              <a:rPr lang="en-US" b="1" dirty="0" smtClean="0"/>
              <a:t>: </a:t>
            </a:r>
            <a:r>
              <a:rPr lang="en-US" dirty="0" smtClean="0"/>
              <a:t>r</a:t>
            </a:r>
            <a:r>
              <a:rPr lang="en-US" baseline="-25000" dirty="0" smtClean="0"/>
              <a:t>1</a:t>
            </a:r>
            <a:r>
              <a:rPr lang="en-US" dirty="0" smtClean="0"/>
              <a:t>: 75 </a:t>
            </a:r>
            <a:r>
              <a:rPr lang="en-US" dirty="0"/>
              <a:t>mM</a:t>
            </a:r>
            <a:r>
              <a:rPr lang="en-US" baseline="30000" dirty="0"/>
              <a:t>-1</a:t>
            </a:r>
            <a:r>
              <a:rPr lang="en-US" dirty="0"/>
              <a:t>s</a:t>
            </a:r>
            <a:r>
              <a:rPr lang="en-US" baseline="30000" dirty="0"/>
              <a:t>-1</a:t>
            </a:r>
            <a:r>
              <a:rPr lang="en-US" b="1" dirty="0" smtClean="0"/>
              <a:t> </a:t>
            </a:r>
            <a:endParaRPr lang="en-US" b="1" dirty="0"/>
          </a:p>
        </p:txBody>
      </p:sp>
    </p:spTree>
    <p:extLst>
      <p:ext uri="{BB962C8B-B14F-4D97-AF65-F5344CB8AC3E}">
        <p14:creationId xmlns:p14="http://schemas.microsoft.com/office/powerpoint/2010/main" val="243201285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76200" y="139005"/>
            <a:ext cx="8991600" cy="3600986"/>
          </a:xfrm>
          <a:prstGeom prst="rect">
            <a:avLst/>
          </a:prstGeom>
        </p:spPr>
        <p:txBody>
          <a:bodyPr wrap="square">
            <a:spAutoFit/>
          </a:bodyPr>
          <a:lstStyle/>
          <a:p>
            <a:r>
              <a:rPr lang="en-US" sz="1200" b="1" dirty="0" smtClean="0"/>
              <a:t>Additional File 2:</a:t>
            </a:r>
          </a:p>
          <a:p>
            <a:endParaRPr lang="en-US" sz="1200" b="1" dirty="0"/>
          </a:p>
          <a:p>
            <a:r>
              <a:rPr lang="en-US" sz="1200" b="1" dirty="0" smtClean="0"/>
              <a:t>A. DLS, zeta potential, and </a:t>
            </a:r>
            <a:r>
              <a:rPr lang="en-US" sz="1200" b="1" dirty="0" err="1" smtClean="0"/>
              <a:t>relaxivity</a:t>
            </a:r>
            <a:r>
              <a:rPr lang="en-US" sz="1200" b="1" dirty="0" smtClean="0"/>
              <a:t> of liposome control and ATCA. </a:t>
            </a:r>
            <a:r>
              <a:rPr lang="en-US" sz="1200" dirty="0" smtClean="0"/>
              <a:t>ATCA (black) and liposome control (grey) were diluted 1:100,000 and either subjected directly for analysis, </a:t>
            </a:r>
            <a:r>
              <a:rPr lang="en-US" sz="1200" dirty="0" err="1" smtClean="0"/>
              <a:t>vortexed</a:t>
            </a:r>
            <a:r>
              <a:rPr lang="en-US" sz="1200" dirty="0" smtClean="0"/>
              <a:t>, or </a:t>
            </a:r>
            <a:r>
              <a:rPr lang="en-US" sz="1200" dirty="0" err="1" smtClean="0"/>
              <a:t>sonicated</a:t>
            </a:r>
            <a:r>
              <a:rPr lang="en-US" sz="1200" dirty="0" smtClean="0"/>
              <a:t> and </a:t>
            </a:r>
            <a:r>
              <a:rPr lang="en-US" sz="1200" dirty="0" err="1" smtClean="0"/>
              <a:t>vortexed</a:t>
            </a:r>
            <a:r>
              <a:rPr lang="en-US" sz="1200" dirty="0" smtClean="0"/>
              <a:t> to reduce agglomeration. </a:t>
            </a:r>
            <a:r>
              <a:rPr lang="en-US" sz="1200" dirty="0"/>
              <a:t>Dynamic light scattering (DLS) and zeta potential values (</a:t>
            </a:r>
            <a:r>
              <a:rPr lang="en-US" sz="1200" dirty="0" err="1"/>
              <a:t>Zetatrac</a:t>
            </a:r>
            <a:r>
              <a:rPr lang="en-US" sz="1200" dirty="0"/>
              <a:t>, </a:t>
            </a:r>
            <a:r>
              <a:rPr lang="en-US" sz="1200" dirty="0" err="1"/>
              <a:t>Microtrac</a:t>
            </a:r>
            <a:r>
              <a:rPr lang="en-US" sz="1200" dirty="0"/>
              <a:t> Instrument) were used to assess the physical characteristics of the nanoparticle conjugates in solution. The size distribution profile of ATCA and control (no CD36 ligands) are 0.1565 </a:t>
            </a:r>
            <a:r>
              <a:rPr lang="en-US" sz="1200" dirty="0" err="1"/>
              <a:t>μm</a:t>
            </a:r>
            <a:r>
              <a:rPr lang="en-US" sz="1200" dirty="0"/>
              <a:t> and 0.1172 </a:t>
            </a:r>
            <a:r>
              <a:rPr lang="en-US" sz="1200" dirty="0" err="1"/>
              <a:t>μm</a:t>
            </a:r>
            <a:r>
              <a:rPr lang="en-US" sz="1200" dirty="0"/>
              <a:t>, respectively while the zeta potential </a:t>
            </a:r>
            <a:r>
              <a:rPr lang="en-US" sz="1200" dirty="0" smtClean="0"/>
              <a:t>was       -39.02 </a:t>
            </a:r>
            <a:r>
              <a:rPr lang="en-US" sz="1200" dirty="0"/>
              <a:t>and -25.50 mV suggesting that the ATCA are extremely stable. The size distribution and zeta potential did not significantly change after vigorous </a:t>
            </a:r>
            <a:r>
              <a:rPr lang="en-US" sz="1200" dirty="0" err="1"/>
              <a:t>vortexing</a:t>
            </a:r>
            <a:r>
              <a:rPr lang="en-US" sz="1200" dirty="0"/>
              <a:t> </a:t>
            </a:r>
            <a:r>
              <a:rPr lang="en-US" sz="1200"/>
              <a:t>or </a:t>
            </a:r>
            <a:r>
              <a:rPr lang="en-US" sz="1200" smtClean="0"/>
              <a:t>sonication. </a:t>
            </a:r>
            <a:r>
              <a:rPr lang="en-US" sz="1200" dirty="0"/>
              <a:t>The </a:t>
            </a:r>
            <a:r>
              <a:rPr lang="en-US" sz="1200" dirty="0" err="1"/>
              <a:t>relaxivity</a:t>
            </a:r>
            <a:r>
              <a:rPr lang="en-US" sz="1200" dirty="0"/>
              <a:t> r</a:t>
            </a:r>
            <a:r>
              <a:rPr lang="en-US" sz="1200" baseline="-25000" dirty="0"/>
              <a:t>1</a:t>
            </a:r>
            <a:r>
              <a:rPr lang="en-US" sz="1200" dirty="0"/>
              <a:t> of ATCA was calculated by a </a:t>
            </a:r>
            <a:r>
              <a:rPr lang="en-US" sz="1200" dirty="0" err="1"/>
              <a:t>benchtop</a:t>
            </a:r>
            <a:r>
              <a:rPr lang="en-US" sz="1200" dirty="0"/>
              <a:t> </a:t>
            </a:r>
            <a:r>
              <a:rPr lang="en-US" sz="1200" dirty="0" err="1"/>
              <a:t>relaxometer</a:t>
            </a:r>
            <a:r>
              <a:rPr lang="en-US" sz="1200" dirty="0"/>
              <a:t> and determined to be 75 mM</a:t>
            </a:r>
            <a:r>
              <a:rPr lang="en-US" sz="1200" baseline="30000" dirty="0"/>
              <a:t>-1</a:t>
            </a:r>
            <a:r>
              <a:rPr lang="en-US" sz="1200" dirty="0"/>
              <a:t>s</a:t>
            </a:r>
            <a:r>
              <a:rPr lang="en-US" sz="1200" baseline="30000" dirty="0"/>
              <a:t>-1</a:t>
            </a:r>
            <a:r>
              <a:rPr lang="en-US" sz="1200" dirty="0" smtClean="0"/>
              <a:t>  </a:t>
            </a:r>
            <a:r>
              <a:rPr lang="en-US" sz="1200" b="1" dirty="0"/>
              <a:t>B</a:t>
            </a:r>
            <a:r>
              <a:rPr lang="en-US" sz="1200" b="1" dirty="0" smtClean="0"/>
              <a:t>. </a:t>
            </a:r>
            <a:r>
              <a:rPr lang="en-US" sz="1200" b="1" dirty="0" err="1" smtClean="0"/>
              <a:t>Nanosight</a:t>
            </a:r>
            <a:r>
              <a:rPr lang="en-US" sz="1200" b="1" dirty="0" smtClean="0"/>
              <a:t> nanoparticle tracking of ATCA. </a:t>
            </a:r>
            <a:r>
              <a:rPr lang="en-US" sz="1200" dirty="0" smtClean="0"/>
              <a:t>ATCA was diluted as above and particle size distribution was measured (10</a:t>
            </a:r>
            <a:r>
              <a:rPr lang="en-US" sz="1200" baseline="30000" dirty="0" smtClean="0"/>
              <a:t>6</a:t>
            </a:r>
            <a:r>
              <a:rPr lang="en-US" sz="1200" dirty="0" smtClean="0"/>
              <a:t> particles/ml) for 90 seconds. The </a:t>
            </a:r>
            <a:r>
              <a:rPr lang="en-US" sz="1200" dirty="0" err="1"/>
              <a:t>N</a:t>
            </a:r>
            <a:r>
              <a:rPr lang="en-US" sz="1200" dirty="0" err="1" smtClean="0"/>
              <a:t>anosight</a:t>
            </a:r>
            <a:r>
              <a:rPr lang="en-US" sz="1200" dirty="0" smtClean="0"/>
              <a:t> nanoparticle tracking analysis </a:t>
            </a:r>
            <a:r>
              <a:rPr lang="en-US" sz="1200" dirty="0"/>
              <a:t>instrument was </a:t>
            </a:r>
            <a:r>
              <a:rPr lang="en-US" sz="1200" dirty="0" smtClean="0"/>
              <a:t>used </a:t>
            </a:r>
            <a:r>
              <a:rPr lang="en-US" sz="1200" dirty="0"/>
              <a:t>and revealed a mean particle size of 0.092 µm. The smaller size distribution for the </a:t>
            </a:r>
            <a:r>
              <a:rPr lang="en-US" sz="1200" dirty="0" err="1"/>
              <a:t>N</a:t>
            </a:r>
            <a:r>
              <a:rPr lang="en-US" sz="1200" dirty="0" err="1" smtClean="0"/>
              <a:t>anosight</a:t>
            </a:r>
            <a:r>
              <a:rPr lang="en-US" sz="1200" dirty="0" smtClean="0"/>
              <a:t> </a:t>
            </a:r>
            <a:r>
              <a:rPr lang="en-US" sz="1200" dirty="0"/>
              <a:t>is a result of individualized particle distribution of size, whereas DLS results are volume based distribution of size. </a:t>
            </a:r>
            <a:r>
              <a:rPr lang="en-US" sz="1200" dirty="0" smtClean="0"/>
              <a:t>Volume based distribution </a:t>
            </a:r>
            <a:r>
              <a:rPr lang="en-US" sz="1200" dirty="0"/>
              <a:t>results in larger particle size due to </a:t>
            </a:r>
            <a:r>
              <a:rPr lang="en-US" sz="1200" dirty="0" smtClean="0"/>
              <a:t>the fact that larger particles have </a:t>
            </a:r>
            <a:r>
              <a:rPr lang="en-US" sz="1200" dirty="0"/>
              <a:t>higher </a:t>
            </a:r>
            <a:r>
              <a:rPr lang="en-US" sz="1200" dirty="0" smtClean="0"/>
              <a:t>volumes and thus </a:t>
            </a:r>
            <a:r>
              <a:rPr lang="en-US" sz="1200" dirty="0"/>
              <a:t>heavily </a:t>
            </a:r>
            <a:r>
              <a:rPr lang="en-US" sz="1200" dirty="0" smtClean="0"/>
              <a:t>influences </a:t>
            </a:r>
            <a:r>
              <a:rPr lang="en-US" sz="1200" dirty="0"/>
              <a:t>mean measurements. </a:t>
            </a:r>
            <a:r>
              <a:rPr lang="en-US" sz="1200" b="1" dirty="0"/>
              <a:t>C</a:t>
            </a:r>
            <a:r>
              <a:rPr lang="en-US" sz="1200" b="1" dirty="0" smtClean="0"/>
              <a:t>. FTIR analysis of ATCA. </a:t>
            </a:r>
            <a:r>
              <a:rPr lang="en-US" sz="1200" dirty="0"/>
              <a:t>Fourier transform infrared spectroscopy </a:t>
            </a:r>
            <a:r>
              <a:rPr lang="en-US" sz="1200" dirty="0" smtClean="0"/>
              <a:t>(FTIR) spectrum of TMS (green), Liposome control (red), and ATCA (black).  </a:t>
            </a:r>
            <a:r>
              <a:rPr lang="en-US" sz="1200" dirty="0"/>
              <a:t>T</a:t>
            </a:r>
            <a:r>
              <a:rPr lang="en-US" sz="1200" dirty="0" smtClean="0"/>
              <a:t>he presence of TMS inside the liposome was verified by the following peaks at 1093 (C-N), 1361 (N-O), 1571 (N-O), and 3149 (O-H) cm</a:t>
            </a:r>
            <a:r>
              <a:rPr lang="en-US" sz="1200" baseline="30000" dirty="0" smtClean="0"/>
              <a:t>-1</a:t>
            </a:r>
            <a:r>
              <a:rPr lang="en-US" sz="1200" dirty="0" smtClean="0"/>
              <a:t>. </a:t>
            </a:r>
            <a:r>
              <a:rPr lang="en-US" sz="1200" dirty="0"/>
              <a:t>In the ATCA sample the peak at 1361 cm</a:t>
            </a:r>
            <a:r>
              <a:rPr lang="en-US" sz="1200" baseline="30000" dirty="0"/>
              <a:t>-1</a:t>
            </a:r>
            <a:r>
              <a:rPr lang="en-US" sz="1200" dirty="0"/>
              <a:t> is broadened by the C-N bond. The N-O peak </a:t>
            </a:r>
            <a:r>
              <a:rPr lang="en-US" sz="1200" dirty="0" smtClean="0"/>
              <a:t>broadens </a:t>
            </a:r>
            <a:r>
              <a:rPr lang="en-US" sz="1200" dirty="0"/>
              <a:t>the peak around 1400 cm</a:t>
            </a:r>
            <a:r>
              <a:rPr lang="en-US" sz="1200" baseline="30000" dirty="0"/>
              <a:t>-1</a:t>
            </a:r>
            <a:r>
              <a:rPr lang="en-US" sz="1200" dirty="0"/>
              <a:t>.  The 1571 cm</a:t>
            </a:r>
            <a:r>
              <a:rPr lang="en-US" sz="1200" baseline="30000" dirty="0"/>
              <a:t>-1</a:t>
            </a:r>
            <a:r>
              <a:rPr lang="en-US" sz="1200" dirty="0"/>
              <a:t> peak shows that a new bond type is present that did not exist in the liposome.  The O-H bond of the TMS slightly shifts the alcohol absorption peak to the right and broadens its appearance. Next, the presence of PAPC conjugated to the liposome was proven by the peaks at 1090 (PO</a:t>
            </a:r>
            <a:r>
              <a:rPr lang="en-US" sz="1200" baseline="-25000" dirty="0"/>
              <a:t>2</a:t>
            </a:r>
            <a:r>
              <a:rPr lang="en-US" sz="1200" baseline="30000" dirty="0"/>
              <a:t>-</a:t>
            </a:r>
            <a:r>
              <a:rPr lang="en-US" sz="1200" dirty="0"/>
              <a:t>) and 823 (P-O-C) as previously described. In the case the P-O-C bond the sharp peak at 823 cm</a:t>
            </a:r>
            <a:r>
              <a:rPr lang="en-US" sz="1200" baseline="30000" dirty="0"/>
              <a:t>-1 </a:t>
            </a:r>
            <a:r>
              <a:rPr lang="en-US" sz="1200" dirty="0"/>
              <a:t>was broadened and for the PO</a:t>
            </a:r>
            <a:r>
              <a:rPr lang="en-US" sz="1200" baseline="-25000" dirty="0"/>
              <a:t>2</a:t>
            </a:r>
            <a:r>
              <a:rPr lang="en-US" sz="1200" baseline="30000" dirty="0"/>
              <a:t>- </a:t>
            </a:r>
            <a:r>
              <a:rPr lang="en-US" sz="1200" dirty="0"/>
              <a:t> a shoulder was formed at 1090 cm</a:t>
            </a:r>
            <a:r>
              <a:rPr lang="en-US" sz="1200" baseline="30000" dirty="0"/>
              <a:t>-1 </a:t>
            </a:r>
            <a:r>
              <a:rPr lang="en-US" sz="1200" dirty="0"/>
              <a:t>.</a:t>
            </a:r>
          </a:p>
        </p:txBody>
      </p:sp>
    </p:spTree>
    <p:extLst>
      <p:ext uri="{BB962C8B-B14F-4D97-AF65-F5344CB8AC3E}">
        <p14:creationId xmlns:p14="http://schemas.microsoft.com/office/powerpoint/2010/main" val="265106854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7</TotalTime>
  <Words>475</Words>
  <Application>Microsoft Office PowerPoint</Application>
  <PresentationFormat>On-screen Show (4:3)</PresentationFormat>
  <Paragraphs>23</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UNC Greensboro</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lkepley</dc:creator>
  <cp:lastModifiedBy>clkepley</cp:lastModifiedBy>
  <cp:revision>16</cp:revision>
  <dcterms:created xsi:type="dcterms:W3CDTF">2012-05-22T19:58:55Z</dcterms:created>
  <dcterms:modified xsi:type="dcterms:W3CDTF">2012-06-01T15:52:04Z</dcterms:modified>
</cp:coreProperties>
</file>